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22776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851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355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7082" y="1355149"/>
            <a:ext cx="5293599" cy="2882806"/>
          </a:xfrm>
        </p:spPr>
        <p:txBody>
          <a:bodyPr anchor="b"/>
          <a:lstStyle>
            <a:lvl1pPr algn="ctr">
              <a:defRPr sz="408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8471" y="4349128"/>
            <a:ext cx="4670822" cy="1999179"/>
          </a:xfrm>
        </p:spPr>
        <p:txBody>
          <a:bodyPr/>
          <a:lstStyle>
            <a:lvl1pPr marL="0" indent="0" algn="ctr">
              <a:buNone/>
              <a:defRPr sz="1635"/>
            </a:lvl1pPr>
            <a:lvl2pPr marL="311399" indent="0" algn="ctr">
              <a:buNone/>
              <a:defRPr sz="1362"/>
            </a:lvl2pPr>
            <a:lvl3pPr marL="622798" indent="0" algn="ctr">
              <a:buNone/>
              <a:defRPr sz="1226"/>
            </a:lvl3pPr>
            <a:lvl4pPr marL="934197" indent="0" algn="ctr">
              <a:buNone/>
              <a:defRPr sz="1090"/>
            </a:lvl4pPr>
            <a:lvl5pPr marL="1245596" indent="0" algn="ctr">
              <a:buNone/>
              <a:defRPr sz="1090"/>
            </a:lvl5pPr>
            <a:lvl6pPr marL="1556995" indent="0" algn="ctr">
              <a:buNone/>
              <a:defRPr sz="1090"/>
            </a:lvl6pPr>
            <a:lvl7pPr marL="1868394" indent="0" algn="ctr">
              <a:buNone/>
              <a:defRPr sz="1090"/>
            </a:lvl7pPr>
            <a:lvl8pPr marL="2179792" indent="0" algn="ctr">
              <a:buNone/>
              <a:defRPr sz="1090"/>
            </a:lvl8pPr>
            <a:lvl9pPr marL="2491191" indent="0" algn="ctr">
              <a:buNone/>
              <a:defRPr sz="109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5040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8173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56743" y="440855"/>
            <a:ext cx="1342861" cy="7017256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8159" y="440855"/>
            <a:ext cx="3950737" cy="7017256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6456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8722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915" y="2064352"/>
            <a:ext cx="5371446" cy="3444416"/>
          </a:xfrm>
        </p:spPr>
        <p:txBody>
          <a:bodyPr anchor="b"/>
          <a:lstStyle>
            <a:lvl1pPr>
              <a:defRPr sz="408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915" y="5541353"/>
            <a:ext cx="5371446" cy="1811337"/>
          </a:xfrm>
        </p:spPr>
        <p:txBody>
          <a:bodyPr/>
          <a:lstStyle>
            <a:lvl1pPr marL="0" indent="0">
              <a:buNone/>
              <a:defRPr sz="1635">
                <a:solidFill>
                  <a:schemeClr val="tx1"/>
                </a:solidFill>
              </a:defRPr>
            </a:lvl1pPr>
            <a:lvl2pPr marL="311399" indent="0">
              <a:buNone/>
              <a:defRPr sz="1362">
                <a:solidFill>
                  <a:schemeClr val="tx1">
                    <a:tint val="75000"/>
                  </a:schemeClr>
                </a:solidFill>
              </a:defRPr>
            </a:lvl2pPr>
            <a:lvl3pPr marL="622798" indent="0">
              <a:buNone/>
              <a:defRPr sz="1226">
                <a:solidFill>
                  <a:schemeClr val="tx1">
                    <a:tint val="75000"/>
                  </a:schemeClr>
                </a:solidFill>
              </a:defRPr>
            </a:lvl3pPr>
            <a:lvl4pPr marL="934197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4pPr>
            <a:lvl5pPr marL="1245596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5pPr>
            <a:lvl6pPr marL="1556995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6pPr>
            <a:lvl7pPr marL="1868394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7pPr>
            <a:lvl8pPr marL="2179792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8pPr>
            <a:lvl9pPr marL="2491191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0078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8159" y="2204273"/>
            <a:ext cx="2646799" cy="525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52805" y="2204273"/>
            <a:ext cx="2646799" cy="525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2880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440856"/>
            <a:ext cx="5371446" cy="160049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971" y="2029849"/>
            <a:ext cx="2634635" cy="994797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971" y="3024646"/>
            <a:ext cx="2634635" cy="444879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52806" y="2029849"/>
            <a:ext cx="2647610" cy="994797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52806" y="3024646"/>
            <a:ext cx="2647610" cy="444879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7069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2150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5132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7"/>
            <a:ext cx="2008616" cy="1932093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7610" y="1192226"/>
            <a:ext cx="3152805" cy="5884451"/>
          </a:xfrm>
        </p:spPr>
        <p:txBody>
          <a:bodyPr/>
          <a:lstStyle>
            <a:lvl1pPr>
              <a:defRPr sz="2180"/>
            </a:lvl1pPr>
            <a:lvl2pPr>
              <a:defRPr sz="1907"/>
            </a:lvl2pPr>
            <a:lvl3pPr>
              <a:defRPr sz="1635"/>
            </a:lvl3pPr>
            <a:lvl4pPr>
              <a:defRPr sz="1362"/>
            </a:lvl4pPr>
            <a:lvl5pPr>
              <a:defRPr sz="1362"/>
            </a:lvl5pPr>
            <a:lvl6pPr>
              <a:defRPr sz="1362"/>
            </a:lvl6pPr>
            <a:lvl7pPr>
              <a:defRPr sz="1362"/>
            </a:lvl7pPr>
            <a:lvl8pPr>
              <a:defRPr sz="1362"/>
            </a:lvl8pPr>
            <a:lvl9pPr>
              <a:defRPr sz="1362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0"/>
            <a:ext cx="2008616" cy="4602140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788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7"/>
            <a:ext cx="2008616" cy="1932093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7610" y="1192226"/>
            <a:ext cx="3152805" cy="5884451"/>
          </a:xfrm>
        </p:spPr>
        <p:txBody>
          <a:bodyPr anchor="t"/>
          <a:lstStyle>
            <a:lvl1pPr marL="0" indent="0">
              <a:buNone/>
              <a:defRPr sz="2180"/>
            </a:lvl1pPr>
            <a:lvl2pPr marL="311399" indent="0">
              <a:buNone/>
              <a:defRPr sz="1907"/>
            </a:lvl2pPr>
            <a:lvl3pPr marL="622798" indent="0">
              <a:buNone/>
              <a:defRPr sz="1635"/>
            </a:lvl3pPr>
            <a:lvl4pPr marL="934197" indent="0">
              <a:buNone/>
              <a:defRPr sz="1362"/>
            </a:lvl4pPr>
            <a:lvl5pPr marL="1245596" indent="0">
              <a:buNone/>
              <a:defRPr sz="1362"/>
            </a:lvl5pPr>
            <a:lvl6pPr marL="1556995" indent="0">
              <a:buNone/>
              <a:defRPr sz="1362"/>
            </a:lvl6pPr>
            <a:lvl7pPr marL="1868394" indent="0">
              <a:buNone/>
              <a:defRPr sz="1362"/>
            </a:lvl7pPr>
            <a:lvl8pPr marL="2179792" indent="0">
              <a:buNone/>
              <a:defRPr sz="1362"/>
            </a:lvl8pPr>
            <a:lvl9pPr marL="2491191" indent="0">
              <a:buNone/>
              <a:defRPr sz="1362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0"/>
            <a:ext cx="2008616" cy="4602140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4947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8159" y="440856"/>
            <a:ext cx="5371446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159" y="2204273"/>
            <a:ext cx="5371446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8159" y="7674706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E77FBC-A8AA-4A70-A103-82E6F882323B}" type="datetimeFigureOut">
              <a:rPr lang="fr-FR" smtClean="0"/>
              <a:t>08/0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62947" y="7674706"/>
            <a:ext cx="210187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8357" y="7674706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A8D54-70A8-4F77-A015-D7280F5EA6B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1090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22798" rtl="0" eaLnBrk="1" latinLnBrk="0" hangingPunct="1">
        <a:lnSpc>
          <a:spcPct val="90000"/>
        </a:lnSpc>
        <a:spcBef>
          <a:spcPct val="0"/>
        </a:spcBef>
        <a:buNone/>
        <a:defRPr sz="29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699" indent="-155699" algn="l" defTabSz="622798" rtl="0" eaLnBrk="1" latinLnBrk="0" hangingPunct="1">
        <a:lnSpc>
          <a:spcPct val="90000"/>
        </a:lnSpc>
        <a:spcBef>
          <a:spcPts val="681"/>
        </a:spcBef>
        <a:buFont typeface="Arial" panose="020B0604020202020204" pitchFamily="34" charset="0"/>
        <a:buChar char="•"/>
        <a:defRPr sz="1907" kern="1200">
          <a:solidFill>
            <a:schemeClr val="tx1"/>
          </a:solidFill>
          <a:latin typeface="+mn-lt"/>
          <a:ea typeface="+mn-ea"/>
          <a:cs typeface="+mn-cs"/>
        </a:defRPr>
      </a:lvl1pPr>
      <a:lvl2pPr marL="467098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635" kern="1200">
          <a:solidFill>
            <a:schemeClr val="tx1"/>
          </a:solidFill>
          <a:latin typeface="+mn-lt"/>
          <a:ea typeface="+mn-ea"/>
          <a:cs typeface="+mn-cs"/>
        </a:defRPr>
      </a:lvl2pPr>
      <a:lvl3pPr marL="778497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362" kern="1200">
          <a:solidFill>
            <a:schemeClr val="tx1"/>
          </a:solidFill>
          <a:latin typeface="+mn-lt"/>
          <a:ea typeface="+mn-ea"/>
          <a:cs typeface="+mn-cs"/>
        </a:defRPr>
      </a:lvl3pPr>
      <a:lvl4pPr marL="1089896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401295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712694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2024093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335492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646891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1pPr>
      <a:lvl2pPr marL="311399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2pPr>
      <a:lvl3pPr marL="622798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3pPr>
      <a:lvl4pPr marL="934197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245596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556995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1868394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179792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491191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143532" y="7055799"/>
            <a:ext cx="1503619" cy="713609"/>
            <a:chOff x="198042" y="5197590"/>
            <a:chExt cx="1503619" cy="713609"/>
          </a:xfrm>
        </p:grpSpPr>
        <p:sp>
          <p:nvSpPr>
            <p:cNvPr id="3" name="Ellipse 2"/>
            <p:cNvSpPr>
              <a:spLocks noChangeAspect="1"/>
            </p:cNvSpPr>
            <p:nvPr/>
          </p:nvSpPr>
          <p:spPr>
            <a:xfrm>
              <a:off x="198042" y="5722294"/>
              <a:ext cx="100811" cy="100811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</a:defPPr>
              <a:lvl1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1pPr>
              <a:lvl2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2pPr>
              <a:lvl3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3pPr>
              <a:lvl4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4pPr>
              <a:lvl5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5pPr>
              <a:lvl6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6pPr>
              <a:lvl7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7pPr>
              <a:lvl8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8pPr>
              <a:lvl9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4" name="Ellipse 3"/>
            <p:cNvSpPr>
              <a:spLocks noChangeAspect="1"/>
            </p:cNvSpPr>
            <p:nvPr/>
          </p:nvSpPr>
          <p:spPr>
            <a:xfrm>
              <a:off x="198042" y="5378017"/>
              <a:ext cx="100811" cy="100811"/>
            </a:xfrm>
            <a:prstGeom prst="ellipse">
              <a:avLst/>
            </a:prstGeom>
            <a:solidFill>
              <a:srgbClr val="FFA500"/>
            </a:solidFill>
            <a:ln>
              <a:solidFill>
                <a:srgbClr val="FFA5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</a:defPPr>
              <a:lvl1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1pPr>
              <a:lvl2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2pPr>
              <a:lvl3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3pPr>
              <a:lvl4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4pPr>
              <a:lvl5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5pPr>
              <a:lvl6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6pPr>
              <a:lvl7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7pPr>
              <a:lvl8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8pPr>
              <a:lvl9pPr marR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 sz="1400" b="0" i="0" u="none" strike="noStrike" cap="none" baseline="0">
                  <a:solidFill>
                    <a:schemeClr val="lt1"/>
                  </a:solidFill>
                  <a:latin typeface="+mn-lt"/>
                  <a:ea typeface="+mn-ea"/>
                  <a:cs typeface="+mn-cs"/>
                  <a:sym typeface="Arial"/>
                  <a:rtl val="0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251520" y="5197590"/>
              <a:ext cx="145014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Marker </a:t>
              </a:r>
              <a:r>
                <a:rPr lang="en-US" sz="1200" dirty="0" smtClean="0"/>
                <a:t>density </a:t>
              </a:r>
            </a:p>
            <a:p>
              <a:r>
                <a:rPr lang="en-US" sz="1200" dirty="0" smtClean="0"/>
                <a:t>along chromosomes</a:t>
              </a:r>
              <a:endParaRPr lang="en-US" sz="1200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253720" y="5634200"/>
              <a:ext cx="10054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Gene density</a:t>
              </a:r>
              <a:endParaRPr lang="en-US" sz="1200" dirty="0"/>
            </a:p>
          </p:txBody>
        </p:sp>
      </p:grpSp>
      <p:grpSp>
        <p:nvGrpSpPr>
          <p:cNvPr id="435" name="Groupe 434"/>
          <p:cNvGrpSpPr/>
          <p:nvPr/>
        </p:nvGrpSpPr>
        <p:grpSpPr>
          <a:xfrm>
            <a:off x="-14453" y="3565178"/>
            <a:ext cx="6132654" cy="4186751"/>
            <a:chOff x="-520075" y="-1429694"/>
            <a:chExt cx="8303326" cy="5668665"/>
          </a:xfrm>
        </p:grpSpPr>
        <p:grpSp>
          <p:nvGrpSpPr>
            <p:cNvPr id="7" name="Groupe 6"/>
            <p:cNvGrpSpPr/>
            <p:nvPr/>
          </p:nvGrpSpPr>
          <p:grpSpPr>
            <a:xfrm>
              <a:off x="-520075" y="-1429694"/>
              <a:ext cx="8303326" cy="5668665"/>
              <a:chOff x="517146" y="764704"/>
              <a:chExt cx="8303326" cy="5668665"/>
            </a:xfrm>
          </p:grpSpPr>
          <p:sp>
            <p:nvSpPr>
              <p:cNvPr id="8" name="Freeform 106"/>
              <p:cNvSpPr>
                <a:spLocks/>
              </p:cNvSpPr>
              <p:nvPr/>
            </p:nvSpPr>
            <p:spPr bwMode="auto">
              <a:xfrm rot="5400000" flipV="1">
                <a:off x="5714168" y="2645847"/>
                <a:ext cx="3341708" cy="190317"/>
              </a:xfrm>
              <a:custGeom>
                <a:avLst/>
                <a:gdLst>
                  <a:gd name="T0" fmla="*/ 156 w 5410"/>
                  <a:gd name="T1" fmla="*/ 183 h 284"/>
                  <a:gd name="T2" fmla="*/ 331 w 5410"/>
                  <a:gd name="T3" fmla="*/ 75 h 284"/>
                  <a:gd name="T4" fmla="*/ 505 w 5410"/>
                  <a:gd name="T5" fmla="*/ 44 h 284"/>
                  <a:gd name="T6" fmla="*/ 680 w 5410"/>
                  <a:gd name="T7" fmla="*/ 65 h 284"/>
                  <a:gd name="T8" fmla="*/ 853 w 5410"/>
                  <a:gd name="T9" fmla="*/ 188 h 284"/>
                  <a:gd name="T10" fmla="*/ 1028 w 5410"/>
                  <a:gd name="T11" fmla="*/ 36 h 284"/>
                  <a:gd name="T12" fmla="*/ 1202 w 5410"/>
                  <a:gd name="T13" fmla="*/ 131 h 284"/>
                  <a:gd name="T14" fmla="*/ 1377 w 5410"/>
                  <a:gd name="T15" fmla="*/ 125 h 284"/>
                  <a:gd name="T16" fmla="*/ 1552 w 5410"/>
                  <a:gd name="T17" fmla="*/ 284 h 284"/>
                  <a:gd name="T18" fmla="*/ 1727 w 5410"/>
                  <a:gd name="T19" fmla="*/ 198 h 284"/>
                  <a:gd name="T20" fmla="*/ 1901 w 5410"/>
                  <a:gd name="T21" fmla="*/ 134 h 284"/>
                  <a:gd name="T22" fmla="*/ 2076 w 5410"/>
                  <a:gd name="T23" fmla="*/ 109 h 284"/>
                  <a:gd name="T24" fmla="*/ 2249 w 5410"/>
                  <a:gd name="T25" fmla="*/ 267 h 284"/>
                  <a:gd name="T26" fmla="*/ 2424 w 5410"/>
                  <a:gd name="T27" fmla="*/ 244 h 284"/>
                  <a:gd name="T28" fmla="*/ 2598 w 5410"/>
                  <a:gd name="T29" fmla="*/ 261 h 284"/>
                  <a:gd name="T30" fmla="*/ 2773 w 5410"/>
                  <a:gd name="T31" fmla="*/ 284 h 284"/>
                  <a:gd name="T32" fmla="*/ 2948 w 5410"/>
                  <a:gd name="T33" fmla="*/ 265 h 284"/>
                  <a:gd name="T34" fmla="*/ 3123 w 5410"/>
                  <a:gd name="T35" fmla="*/ 146 h 284"/>
                  <a:gd name="T36" fmla="*/ 3297 w 5410"/>
                  <a:gd name="T37" fmla="*/ 138 h 284"/>
                  <a:gd name="T38" fmla="*/ 3470 w 5410"/>
                  <a:gd name="T39" fmla="*/ 267 h 284"/>
                  <a:gd name="T40" fmla="*/ 3645 w 5410"/>
                  <a:gd name="T41" fmla="*/ 192 h 284"/>
                  <a:gd name="T42" fmla="*/ 3820 w 5410"/>
                  <a:gd name="T43" fmla="*/ 161 h 284"/>
                  <a:gd name="T44" fmla="*/ 3994 w 5410"/>
                  <a:gd name="T45" fmla="*/ 77 h 284"/>
                  <a:gd name="T46" fmla="*/ 4169 w 5410"/>
                  <a:gd name="T47" fmla="*/ 104 h 284"/>
                  <a:gd name="T48" fmla="*/ 4344 w 5410"/>
                  <a:gd name="T49" fmla="*/ 85 h 284"/>
                  <a:gd name="T50" fmla="*/ 4519 w 5410"/>
                  <a:gd name="T51" fmla="*/ 108 h 284"/>
                  <a:gd name="T52" fmla="*/ 4691 w 5410"/>
                  <a:gd name="T53" fmla="*/ 125 h 284"/>
                  <a:gd name="T54" fmla="*/ 4866 w 5410"/>
                  <a:gd name="T55" fmla="*/ 36 h 284"/>
                  <a:gd name="T56" fmla="*/ 5041 w 5410"/>
                  <a:gd name="T57" fmla="*/ 165 h 284"/>
                  <a:gd name="T58" fmla="*/ 5216 w 5410"/>
                  <a:gd name="T59" fmla="*/ 42 h 284"/>
                  <a:gd name="T60" fmla="*/ 5390 w 5410"/>
                  <a:gd name="T61" fmla="*/ 200 h 284"/>
                  <a:gd name="T62" fmla="*/ 5273 w 5410"/>
                  <a:gd name="T63" fmla="*/ 284 h 284"/>
                  <a:gd name="T64" fmla="*/ 5098 w 5410"/>
                  <a:gd name="T65" fmla="*/ 284 h 284"/>
                  <a:gd name="T66" fmla="*/ 4926 w 5410"/>
                  <a:gd name="T67" fmla="*/ 284 h 284"/>
                  <a:gd name="T68" fmla="*/ 4751 w 5410"/>
                  <a:gd name="T69" fmla="*/ 284 h 284"/>
                  <a:gd name="T70" fmla="*/ 4576 w 5410"/>
                  <a:gd name="T71" fmla="*/ 284 h 284"/>
                  <a:gd name="T72" fmla="*/ 4401 w 5410"/>
                  <a:gd name="T73" fmla="*/ 284 h 284"/>
                  <a:gd name="T74" fmla="*/ 4227 w 5410"/>
                  <a:gd name="T75" fmla="*/ 284 h 284"/>
                  <a:gd name="T76" fmla="*/ 4052 w 5410"/>
                  <a:gd name="T77" fmla="*/ 284 h 284"/>
                  <a:gd name="T78" fmla="*/ 3877 w 5410"/>
                  <a:gd name="T79" fmla="*/ 284 h 284"/>
                  <a:gd name="T80" fmla="*/ 3704 w 5410"/>
                  <a:gd name="T81" fmla="*/ 284 h 284"/>
                  <a:gd name="T82" fmla="*/ 3530 w 5410"/>
                  <a:gd name="T83" fmla="*/ 284 h 284"/>
                  <a:gd name="T84" fmla="*/ 3355 w 5410"/>
                  <a:gd name="T85" fmla="*/ 284 h 284"/>
                  <a:gd name="T86" fmla="*/ 3180 w 5410"/>
                  <a:gd name="T87" fmla="*/ 284 h 284"/>
                  <a:gd name="T88" fmla="*/ 3006 w 5410"/>
                  <a:gd name="T89" fmla="*/ 284 h 284"/>
                  <a:gd name="T90" fmla="*/ 2831 w 5410"/>
                  <a:gd name="T91" fmla="*/ 284 h 284"/>
                  <a:gd name="T92" fmla="*/ 2656 w 5410"/>
                  <a:gd name="T93" fmla="*/ 284 h 284"/>
                  <a:gd name="T94" fmla="*/ 2483 w 5410"/>
                  <a:gd name="T95" fmla="*/ 284 h 284"/>
                  <a:gd name="T96" fmla="*/ 2308 w 5410"/>
                  <a:gd name="T97" fmla="*/ 284 h 284"/>
                  <a:gd name="T98" fmla="*/ 2134 w 5410"/>
                  <a:gd name="T99" fmla="*/ 284 h 284"/>
                  <a:gd name="T100" fmla="*/ 1959 w 5410"/>
                  <a:gd name="T101" fmla="*/ 284 h 284"/>
                  <a:gd name="T102" fmla="*/ 1784 w 5410"/>
                  <a:gd name="T103" fmla="*/ 284 h 284"/>
                  <a:gd name="T104" fmla="*/ 1610 w 5410"/>
                  <a:gd name="T105" fmla="*/ 284 h 284"/>
                  <a:gd name="T106" fmla="*/ 1435 w 5410"/>
                  <a:gd name="T107" fmla="*/ 284 h 284"/>
                  <a:gd name="T108" fmla="*/ 1262 w 5410"/>
                  <a:gd name="T109" fmla="*/ 284 h 284"/>
                  <a:gd name="T110" fmla="*/ 1087 w 5410"/>
                  <a:gd name="T111" fmla="*/ 284 h 284"/>
                  <a:gd name="T112" fmla="*/ 913 w 5410"/>
                  <a:gd name="T113" fmla="*/ 284 h 284"/>
                  <a:gd name="T114" fmla="*/ 738 w 5410"/>
                  <a:gd name="T115" fmla="*/ 284 h 284"/>
                  <a:gd name="T116" fmla="*/ 563 w 5410"/>
                  <a:gd name="T117" fmla="*/ 284 h 284"/>
                  <a:gd name="T118" fmla="*/ 388 w 5410"/>
                  <a:gd name="T119" fmla="*/ 284 h 284"/>
                  <a:gd name="T120" fmla="*/ 214 w 5410"/>
                  <a:gd name="T121" fmla="*/ 284 h 284"/>
                  <a:gd name="T122" fmla="*/ 39 w 5410"/>
                  <a:gd name="T123" fmla="*/ 284 h 2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</a:cxnLst>
                <a:rect l="0" t="0" r="r" b="b"/>
                <a:pathLst>
                  <a:path w="5410" h="284">
                    <a:moveTo>
                      <a:pt x="0" y="90"/>
                    </a:moveTo>
                    <a:lnTo>
                      <a:pt x="20" y="38"/>
                    </a:lnTo>
                    <a:lnTo>
                      <a:pt x="39" y="127"/>
                    </a:lnTo>
                    <a:lnTo>
                      <a:pt x="60" y="65"/>
                    </a:lnTo>
                    <a:lnTo>
                      <a:pt x="79" y="21"/>
                    </a:lnTo>
                    <a:lnTo>
                      <a:pt x="98" y="86"/>
                    </a:lnTo>
                    <a:lnTo>
                      <a:pt x="118" y="123"/>
                    </a:lnTo>
                    <a:lnTo>
                      <a:pt x="137" y="31"/>
                    </a:lnTo>
                    <a:lnTo>
                      <a:pt x="156" y="183"/>
                    </a:lnTo>
                    <a:lnTo>
                      <a:pt x="175" y="60"/>
                    </a:lnTo>
                    <a:lnTo>
                      <a:pt x="194" y="100"/>
                    </a:lnTo>
                    <a:lnTo>
                      <a:pt x="214" y="109"/>
                    </a:lnTo>
                    <a:lnTo>
                      <a:pt x="233" y="73"/>
                    </a:lnTo>
                    <a:lnTo>
                      <a:pt x="254" y="0"/>
                    </a:lnTo>
                    <a:lnTo>
                      <a:pt x="273" y="144"/>
                    </a:lnTo>
                    <a:lnTo>
                      <a:pt x="292" y="184"/>
                    </a:lnTo>
                    <a:lnTo>
                      <a:pt x="312" y="146"/>
                    </a:lnTo>
                    <a:lnTo>
                      <a:pt x="331" y="75"/>
                    </a:lnTo>
                    <a:lnTo>
                      <a:pt x="350" y="194"/>
                    </a:lnTo>
                    <a:lnTo>
                      <a:pt x="369" y="202"/>
                    </a:lnTo>
                    <a:lnTo>
                      <a:pt x="388" y="190"/>
                    </a:lnTo>
                    <a:lnTo>
                      <a:pt x="408" y="167"/>
                    </a:lnTo>
                    <a:lnTo>
                      <a:pt x="427" y="96"/>
                    </a:lnTo>
                    <a:lnTo>
                      <a:pt x="446" y="31"/>
                    </a:lnTo>
                    <a:lnTo>
                      <a:pt x="467" y="92"/>
                    </a:lnTo>
                    <a:lnTo>
                      <a:pt x="486" y="79"/>
                    </a:lnTo>
                    <a:lnTo>
                      <a:pt x="505" y="44"/>
                    </a:lnTo>
                    <a:lnTo>
                      <a:pt x="525" y="111"/>
                    </a:lnTo>
                    <a:lnTo>
                      <a:pt x="544" y="69"/>
                    </a:lnTo>
                    <a:lnTo>
                      <a:pt x="563" y="183"/>
                    </a:lnTo>
                    <a:lnTo>
                      <a:pt x="582" y="183"/>
                    </a:lnTo>
                    <a:lnTo>
                      <a:pt x="601" y="150"/>
                    </a:lnTo>
                    <a:lnTo>
                      <a:pt x="621" y="48"/>
                    </a:lnTo>
                    <a:lnTo>
                      <a:pt x="640" y="215"/>
                    </a:lnTo>
                    <a:lnTo>
                      <a:pt x="661" y="38"/>
                    </a:lnTo>
                    <a:lnTo>
                      <a:pt x="680" y="65"/>
                    </a:lnTo>
                    <a:lnTo>
                      <a:pt x="699" y="123"/>
                    </a:lnTo>
                    <a:lnTo>
                      <a:pt x="719" y="27"/>
                    </a:lnTo>
                    <a:lnTo>
                      <a:pt x="738" y="134"/>
                    </a:lnTo>
                    <a:lnTo>
                      <a:pt x="757" y="133"/>
                    </a:lnTo>
                    <a:lnTo>
                      <a:pt x="776" y="127"/>
                    </a:lnTo>
                    <a:lnTo>
                      <a:pt x="795" y="119"/>
                    </a:lnTo>
                    <a:lnTo>
                      <a:pt x="815" y="183"/>
                    </a:lnTo>
                    <a:lnTo>
                      <a:pt x="834" y="192"/>
                    </a:lnTo>
                    <a:lnTo>
                      <a:pt x="853" y="188"/>
                    </a:lnTo>
                    <a:lnTo>
                      <a:pt x="874" y="163"/>
                    </a:lnTo>
                    <a:lnTo>
                      <a:pt x="893" y="211"/>
                    </a:lnTo>
                    <a:lnTo>
                      <a:pt x="913" y="81"/>
                    </a:lnTo>
                    <a:lnTo>
                      <a:pt x="932" y="67"/>
                    </a:lnTo>
                    <a:lnTo>
                      <a:pt x="951" y="188"/>
                    </a:lnTo>
                    <a:lnTo>
                      <a:pt x="970" y="48"/>
                    </a:lnTo>
                    <a:lnTo>
                      <a:pt x="989" y="156"/>
                    </a:lnTo>
                    <a:lnTo>
                      <a:pt x="1009" y="109"/>
                    </a:lnTo>
                    <a:lnTo>
                      <a:pt x="1028" y="36"/>
                    </a:lnTo>
                    <a:lnTo>
                      <a:pt x="1047" y="85"/>
                    </a:lnTo>
                    <a:lnTo>
                      <a:pt x="1068" y="146"/>
                    </a:lnTo>
                    <a:lnTo>
                      <a:pt x="1087" y="71"/>
                    </a:lnTo>
                    <a:lnTo>
                      <a:pt x="1106" y="96"/>
                    </a:lnTo>
                    <a:lnTo>
                      <a:pt x="1126" y="127"/>
                    </a:lnTo>
                    <a:lnTo>
                      <a:pt x="1145" y="158"/>
                    </a:lnTo>
                    <a:lnTo>
                      <a:pt x="1164" y="73"/>
                    </a:lnTo>
                    <a:lnTo>
                      <a:pt x="1183" y="92"/>
                    </a:lnTo>
                    <a:lnTo>
                      <a:pt x="1202" y="131"/>
                    </a:lnTo>
                    <a:lnTo>
                      <a:pt x="1222" y="131"/>
                    </a:lnTo>
                    <a:lnTo>
                      <a:pt x="1241" y="142"/>
                    </a:lnTo>
                    <a:lnTo>
                      <a:pt x="1262" y="165"/>
                    </a:lnTo>
                    <a:lnTo>
                      <a:pt x="1281" y="50"/>
                    </a:lnTo>
                    <a:lnTo>
                      <a:pt x="1300" y="125"/>
                    </a:lnTo>
                    <a:lnTo>
                      <a:pt x="1320" y="217"/>
                    </a:lnTo>
                    <a:lnTo>
                      <a:pt x="1339" y="102"/>
                    </a:lnTo>
                    <a:lnTo>
                      <a:pt x="1358" y="86"/>
                    </a:lnTo>
                    <a:lnTo>
                      <a:pt x="1377" y="125"/>
                    </a:lnTo>
                    <a:lnTo>
                      <a:pt x="1396" y="61"/>
                    </a:lnTo>
                    <a:lnTo>
                      <a:pt x="1416" y="238"/>
                    </a:lnTo>
                    <a:lnTo>
                      <a:pt x="1435" y="236"/>
                    </a:lnTo>
                    <a:lnTo>
                      <a:pt x="1454" y="246"/>
                    </a:lnTo>
                    <a:lnTo>
                      <a:pt x="1475" y="267"/>
                    </a:lnTo>
                    <a:lnTo>
                      <a:pt x="1494" y="273"/>
                    </a:lnTo>
                    <a:lnTo>
                      <a:pt x="1514" y="279"/>
                    </a:lnTo>
                    <a:lnTo>
                      <a:pt x="1533" y="284"/>
                    </a:lnTo>
                    <a:lnTo>
                      <a:pt x="1552" y="284"/>
                    </a:lnTo>
                    <a:lnTo>
                      <a:pt x="1571" y="284"/>
                    </a:lnTo>
                    <a:lnTo>
                      <a:pt x="1590" y="284"/>
                    </a:lnTo>
                    <a:lnTo>
                      <a:pt x="1610" y="284"/>
                    </a:lnTo>
                    <a:lnTo>
                      <a:pt x="1629" y="284"/>
                    </a:lnTo>
                    <a:lnTo>
                      <a:pt x="1648" y="246"/>
                    </a:lnTo>
                    <a:lnTo>
                      <a:pt x="1669" y="75"/>
                    </a:lnTo>
                    <a:lnTo>
                      <a:pt x="1688" y="254"/>
                    </a:lnTo>
                    <a:lnTo>
                      <a:pt x="1707" y="284"/>
                    </a:lnTo>
                    <a:lnTo>
                      <a:pt x="1727" y="198"/>
                    </a:lnTo>
                    <a:lnTo>
                      <a:pt x="1746" y="173"/>
                    </a:lnTo>
                    <a:lnTo>
                      <a:pt x="1765" y="156"/>
                    </a:lnTo>
                    <a:lnTo>
                      <a:pt x="1784" y="200"/>
                    </a:lnTo>
                    <a:lnTo>
                      <a:pt x="1803" y="169"/>
                    </a:lnTo>
                    <a:lnTo>
                      <a:pt x="1823" y="192"/>
                    </a:lnTo>
                    <a:lnTo>
                      <a:pt x="1842" y="252"/>
                    </a:lnTo>
                    <a:lnTo>
                      <a:pt x="1861" y="234"/>
                    </a:lnTo>
                    <a:lnTo>
                      <a:pt x="1882" y="73"/>
                    </a:lnTo>
                    <a:lnTo>
                      <a:pt x="1901" y="134"/>
                    </a:lnTo>
                    <a:lnTo>
                      <a:pt x="1921" y="154"/>
                    </a:lnTo>
                    <a:lnTo>
                      <a:pt x="1940" y="227"/>
                    </a:lnTo>
                    <a:lnTo>
                      <a:pt x="1959" y="256"/>
                    </a:lnTo>
                    <a:lnTo>
                      <a:pt x="1978" y="215"/>
                    </a:lnTo>
                    <a:lnTo>
                      <a:pt x="1997" y="259"/>
                    </a:lnTo>
                    <a:lnTo>
                      <a:pt x="2017" y="269"/>
                    </a:lnTo>
                    <a:lnTo>
                      <a:pt x="2036" y="284"/>
                    </a:lnTo>
                    <a:lnTo>
                      <a:pt x="2055" y="271"/>
                    </a:lnTo>
                    <a:lnTo>
                      <a:pt x="2076" y="109"/>
                    </a:lnTo>
                    <a:lnTo>
                      <a:pt x="2095" y="117"/>
                    </a:lnTo>
                    <a:lnTo>
                      <a:pt x="2115" y="271"/>
                    </a:lnTo>
                    <a:lnTo>
                      <a:pt x="2134" y="240"/>
                    </a:lnTo>
                    <a:lnTo>
                      <a:pt x="2153" y="263"/>
                    </a:lnTo>
                    <a:lnTo>
                      <a:pt x="2172" y="279"/>
                    </a:lnTo>
                    <a:lnTo>
                      <a:pt x="2191" y="219"/>
                    </a:lnTo>
                    <a:lnTo>
                      <a:pt x="2211" y="252"/>
                    </a:lnTo>
                    <a:lnTo>
                      <a:pt x="2230" y="284"/>
                    </a:lnTo>
                    <a:lnTo>
                      <a:pt x="2249" y="267"/>
                    </a:lnTo>
                    <a:lnTo>
                      <a:pt x="2268" y="250"/>
                    </a:lnTo>
                    <a:lnTo>
                      <a:pt x="2289" y="277"/>
                    </a:lnTo>
                    <a:lnTo>
                      <a:pt x="2308" y="284"/>
                    </a:lnTo>
                    <a:lnTo>
                      <a:pt x="2328" y="284"/>
                    </a:lnTo>
                    <a:lnTo>
                      <a:pt x="2347" y="273"/>
                    </a:lnTo>
                    <a:lnTo>
                      <a:pt x="2366" y="284"/>
                    </a:lnTo>
                    <a:lnTo>
                      <a:pt x="2385" y="277"/>
                    </a:lnTo>
                    <a:lnTo>
                      <a:pt x="2404" y="284"/>
                    </a:lnTo>
                    <a:lnTo>
                      <a:pt x="2424" y="244"/>
                    </a:lnTo>
                    <a:lnTo>
                      <a:pt x="2443" y="175"/>
                    </a:lnTo>
                    <a:lnTo>
                      <a:pt x="2462" y="221"/>
                    </a:lnTo>
                    <a:lnTo>
                      <a:pt x="2483" y="213"/>
                    </a:lnTo>
                    <a:lnTo>
                      <a:pt x="2502" y="207"/>
                    </a:lnTo>
                    <a:lnTo>
                      <a:pt x="2522" y="284"/>
                    </a:lnTo>
                    <a:lnTo>
                      <a:pt x="2541" y="284"/>
                    </a:lnTo>
                    <a:lnTo>
                      <a:pt x="2560" y="284"/>
                    </a:lnTo>
                    <a:lnTo>
                      <a:pt x="2579" y="284"/>
                    </a:lnTo>
                    <a:lnTo>
                      <a:pt x="2598" y="261"/>
                    </a:lnTo>
                    <a:lnTo>
                      <a:pt x="2618" y="284"/>
                    </a:lnTo>
                    <a:lnTo>
                      <a:pt x="2637" y="238"/>
                    </a:lnTo>
                    <a:lnTo>
                      <a:pt x="2656" y="284"/>
                    </a:lnTo>
                    <a:lnTo>
                      <a:pt x="2675" y="284"/>
                    </a:lnTo>
                    <a:lnTo>
                      <a:pt x="2696" y="252"/>
                    </a:lnTo>
                    <a:lnTo>
                      <a:pt x="2716" y="261"/>
                    </a:lnTo>
                    <a:lnTo>
                      <a:pt x="2735" y="284"/>
                    </a:lnTo>
                    <a:lnTo>
                      <a:pt x="2754" y="284"/>
                    </a:lnTo>
                    <a:lnTo>
                      <a:pt x="2773" y="284"/>
                    </a:lnTo>
                    <a:lnTo>
                      <a:pt x="2792" y="271"/>
                    </a:lnTo>
                    <a:lnTo>
                      <a:pt x="2812" y="269"/>
                    </a:lnTo>
                    <a:lnTo>
                      <a:pt x="2831" y="284"/>
                    </a:lnTo>
                    <a:lnTo>
                      <a:pt x="2850" y="259"/>
                    </a:lnTo>
                    <a:lnTo>
                      <a:pt x="2869" y="213"/>
                    </a:lnTo>
                    <a:lnTo>
                      <a:pt x="2890" y="273"/>
                    </a:lnTo>
                    <a:lnTo>
                      <a:pt x="2909" y="240"/>
                    </a:lnTo>
                    <a:lnTo>
                      <a:pt x="2929" y="279"/>
                    </a:lnTo>
                    <a:lnTo>
                      <a:pt x="2948" y="265"/>
                    </a:lnTo>
                    <a:lnTo>
                      <a:pt x="2967" y="284"/>
                    </a:lnTo>
                    <a:lnTo>
                      <a:pt x="2986" y="281"/>
                    </a:lnTo>
                    <a:lnTo>
                      <a:pt x="3006" y="277"/>
                    </a:lnTo>
                    <a:lnTo>
                      <a:pt x="3025" y="227"/>
                    </a:lnTo>
                    <a:lnTo>
                      <a:pt x="3044" y="284"/>
                    </a:lnTo>
                    <a:lnTo>
                      <a:pt x="3063" y="238"/>
                    </a:lnTo>
                    <a:lnTo>
                      <a:pt x="3082" y="257"/>
                    </a:lnTo>
                    <a:lnTo>
                      <a:pt x="3103" y="136"/>
                    </a:lnTo>
                    <a:lnTo>
                      <a:pt x="3123" y="146"/>
                    </a:lnTo>
                    <a:lnTo>
                      <a:pt x="3142" y="209"/>
                    </a:lnTo>
                    <a:lnTo>
                      <a:pt x="3161" y="250"/>
                    </a:lnTo>
                    <a:lnTo>
                      <a:pt x="3180" y="115"/>
                    </a:lnTo>
                    <a:lnTo>
                      <a:pt x="3199" y="184"/>
                    </a:lnTo>
                    <a:lnTo>
                      <a:pt x="3219" y="167"/>
                    </a:lnTo>
                    <a:lnTo>
                      <a:pt x="3238" y="202"/>
                    </a:lnTo>
                    <a:lnTo>
                      <a:pt x="3257" y="227"/>
                    </a:lnTo>
                    <a:lnTo>
                      <a:pt x="3276" y="215"/>
                    </a:lnTo>
                    <a:lnTo>
                      <a:pt x="3297" y="138"/>
                    </a:lnTo>
                    <a:lnTo>
                      <a:pt x="3317" y="271"/>
                    </a:lnTo>
                    <a:lnTo>
                      <a:pt x="3336" y="234"/>
                    </a:lnTo>
                    <a:lnTo>
                      <a:pt x="3355" y="232"/>
                    </a:lnTo>
                    <a:lnTo>
                      <a:pt x="3374" y="223"/>
                    </a:lnTo>
                    <a:lnTo>
                      <a:pt x="3393" y="207"/>
                    </a:lnTo>
                    <a:lnTo>
                      <a:pt x="3413" y="204"/>
                    </a:lnTo>
                    <a:lnTo>
                      <a:pt x="3432" y="129"/>
                    </a:lnTo>
                    <a:lnTo>
                      <a:pt x="3451" y="192"/>
                    </a:lnTo>
                    <a:lnTo>
                      <a:pt x="3470" y="267"/>
                    </a:lnTo>
                    <a:lnTo>
                      <a:pt x="3489" y="284"/>
                    </a:lnTo>
                    <a:lnTo>
                      <a:pt x="3510" y="261"/>
                    </a:lnTo>
                    <a:lnTo>
                      <a:pt x="3530" y="257"/>
                    </a:lnTo>
                    <a:lnTo>
                      <a:pt x="3549" y="284"/>
                    </a:lnTo>
                    <a:lnTo>
                      <a:pt x="3568" y="284"/>
                    </a:lnTo>
                    <a:lnTo>
                      <a:pt x="3587" y="275"/>
                    </a:lnTo>
                    <a:lnTo>
                      <a:pt x="3607" y="219"/>
                    </a:lnTo>
                    <a:lnTo>
                      <a:pt x="3626" y="121"/>
                    </a:lnTo>
                    <a:lnTo>
                      <a:pt x="3645" y="192"/>
                    </a:lnTo>
                    <a:lnTo>
                      <a:pt x="3664" y="196"/>
                    </a:lnTo>
                    <a:lnTo>
                      <a:pt x="3683" y="67"/>
                    </a:lnTo>
                    <a:lnTo>
                      <a:pt x="3704" y="192"/>
                    </a:lnTo>
                    <a:lnTo>
                      <a:pt x="3724" y="231"/>
                    </a:lnTo>
                    <a:lnTo>
                      <a:pt x="3743" y="200"/>
                    </a:lnTo>
                    <a:lnTo>
                      <a:pt x="3762" y="175"/>
                    </a:lnTo>
                    <a:lnTo>
                      <a:pt x="3781" y="138"/>
                    </a:lnTo>
                    <a:lnTo>
                      <a:pt x="3800" y="104"/>
                    </a:lnTo>
                    <a:lnTo>
                      <a:pt x="3820" y="161"/>
                    </a:lnTo>
                    <a:lnTo>
                      <a:pt x="3839" y="282"/>
                    </a:lnTo>
                    <a:lnTo>
                      <a:pt x="3858" y="284"/>
                    </a:lnTo>
                    <a:lnTo>
                      <a:pt x="3877" y="281"/>
                    </a:lnTo>
                    <a:lnTo>
                      <a:pt x="3896" y="204"/>
                    </a:lnTo>
                    <a:lnTo>
                      <a:pt x="3918" y="240"/>
                    </a:lnTo>
                    <a:lnTo>
                      <a:pt x="3937" y="198"/>
                    </a:lnTo>
                    <a:lnTo>
                      <a:pt x="3956" y="134"/>
                    </a:lnTo>
                    <a:lnTo>
                      <a:pt x="3975" y="181"/>
                    </a:lnTo>
                    <a:lnTo>
                      <a:pt x="3994" y="77"/>
                    </a:lnTo>
                    <a:lnTo>
                      <a:pt x="4014" y="171"/>
                    </a:lnTo>
                    <a:lnTo>
                      <a:pt x="4033" y="113"/>
                    </a:lnTo>
                    <a:lnTo>
                      <a:pt x="4052" y="113"/>
                    </a:lnTo>
                    <a:lnTo>
                      <a:pt x="4071" y="234"/>
                    </a:lnTo>
                    <a:lnTo>
                      <a:pt x="4090" y="146"/>
                    </a:lnTo>
                    <a:lnTo>
                      <a:pt x="4111" y="54"/>
                    </a:lnTo>
                    <a:lnTo>
                      <a:pt x="4131" y="159"/>
                    </a:lnTo>
                    <a:lnTo>
                      <a:pt x="4150" y="109"/>
                    </a:lnTo>
                    <a:lnTo>
                      <a:pt x="4169" y="104"/>
                    </a:lnTo>
                    <a:lnTo>
                      <a:pt x="4188" y="136"/>
                    </a:lnTo>
                    <a:lnTo>
                      <a:pt x="4208" y="148"/>
                    </a:lnTo>
                    <a:lnTo>
                      <a:pt x="4227" y="156"/>
                    </a:lnTo>
                    <a:lnTo>
                      <a:pt x="4246" y="77"/>
                    </a:lnTo>
                    <a:lnTo>
                      <a:pt x="4265" y="100"/>
                    </a:lnTo>
                    <a:lnTo>
                      <a:pt x="4284" y="73"/>
                    </a:lnTo>
                    <a:lnTo>
                      <a:pt x="4305" y="67"/>
                    </a:lnTo>
                    <a:lnTo>
                      <a:pt x="4325" y="133"/>
                    </a:lnTo>
                    <a:lnTo>
                      <a:pt x="4344" y="85"/>
                    </a:lnTo>
                    <a:lnTo>
                      <a:pt x="4363" y="121"/>
                    </a:lnTo>
                    <a:lnTo>
                      <a:pt x="4382" y="29"/>
                    </a:lnTo>
                    <a:lnTo>
                      <a:pt x="4401" y="121"/>
                    </a:lnTo>
                    <a:lnTo>
                      <a:pt x="4421" y="134"/>
                    </a:lnTo>
                    <a:lnTo>
                      <a:pt x="4440" y="121"/>
                    </a:lnTo>
                    <a:lnTo>
                      <a:pt x="4459" y="129"/>
                    </a:lnTo>
                    <a:lnTo>
                      <a:pt x="4478" y="133"/>
                    </a:lnTo>
                    <a:lnTo>
                      <a:pt x="4497" y="86"/>
                    </a:lnTo>
                    <a:lnTo>
                      <a:pt x="4519" y="108"/>
                    </a:lnTo>
                    <a:lnTo>
                      <a:pt x="4538" y="115"/>
                    </a:lnTo>
                    <a:lnTo>
                      <a:pt x="4557" y="109"/>
                    </a:lnTo>
                    <a:lnTo>
                      <a:pt x="4576" y="42"/>
                    </a:lnTo>
                    <a:lnTo>
                      <a:pt x="4595" y="209"/>
                    </a:lnTo>
                    <a:lnTo>
                      <a:pt x="4615" y="38"/>
                    </a:lnTo>
                    <a:lnTo>
                      <a:pt x="4634" y="90"/>
                    </a:lnTo>
                    <a:lnTo>
                      <a:pt x="4653" y="175"/>
                    </a:lnTo>
                    <a:lnTo>
                      <a:pt x="4672" y="63"/>
                    </a:lnTo>
                    <a:lnTo>
                      <a:pt x="4691" y="125"/>
                    </a:lnTo>
                    <a:lnTo>
                      <a:pt x="4712" y="90"/>
                    </a:lnTo>
                    <a:lnTo>
                      <a:pt x="4732" y="75"/>
                    </a:lnTo>
                    <a:lnTo>
                      <a:pt x="4751" y="142"/>
                    </a:lnTo>
                    <a:lnTo>
                      <a:pt x="4770" y="106"/>
                    </a:lnTo>
                    <a:lnTo>
                      <a:pt x="4789" y="123"/>
                    </a:lnTo>
                    <a:lnTo>
                      <a:pt x="4809" y="146"/>
                    </a:lnTo>
                    <a:lnTo>
                      <a:pt x="4828" y="61"/>
                    </a:lnTo>
                    <a:lnTo>
                      <a:pt x="4847" y="46"/>
                    </a:lnTo>
                    <a:lnTo>
                      <a:pt x="4866" y="36"/>
                    </a:lnTo>
                    <a:lnTo>
                      <a:pt x="4885" y="133"/>
                    </a:lnTo>
                    <a:lnTo>
                      <a:pt x="4905" y="113"/>
                    </a:lnTo>
                    <a:lnTo>
                      <a:pt x="4926" y="123"/>
                    </a:lnTo>
                    <a:lnTo>
                      <a:pt x="4945" y="67"/>
                    </a:lnTo>
                    <a:lnTo>
                      <a:pt x="4964" y="50"/>
                    </a:lnTo>
                    <a:lnTo>
                      <a:pt x="4983" y="113"/>
                    </a:lnTo>
                    <a:lnTo>
                      <a:pt x="5002" y="98"/>
                    </a:lnTo>
                    <a:lnTo>
                      <a:pt x="5022" y="169"/>
                    </a:lnTo>
                    <a:lnTo>
                      <a:pt x="5041" y="165"/>
                    </a:lnTo>
                    <a:lnTo>
                      <a:pt x="5060" y="77"/>
                    </a:lnTo>
                    <a:lnTo>
                      <a:pt x="5079" y="60"/>
                    </a:lnTo>
                    <a:lnTo>
                      <a:pt x="5098" y="96"/>
                    </a:lnTo>
                    <a:lnTo>
                      <a:pt x="5120" y="102"/>
                    </a:lnTo>
                    <a:lnTo>
                      <a:pt x="5139" y="77"/>
                    </a:lnTo>
                    <a:lnTo>
                      <a:pt x="5158" y="88"/>
                    </a:lnTo>
                    <a:lnTo>
                      <a:pt x="5177" y="106"/>
                    </a:lnTo>
                    <a:lnTo>
                      <a:pt x="5196" y="102"/>
                    </a:lnTo>
                    <a:lnTo>
                      <a:pt x="5216" y="42"/>
                    </a:lnTo>
                    <a:lnTo>
                      <a:pt x="5235" y="106"/>
                    </a:lnTo>
                    <a:lnTo>
                      <a:pt x="5254" y="46"/>
                    </a:lnTo>
                    <a:lnTo>
                      <a:pt x="5273" y="136"/>
                    </a:lnTo>
                    <a:lnTo>
                      <a:pt x="5292" y="75"/>
                    </a:lnTo>
                    <a:lnTo>
                      <a:pt x="5312" y="133"/>
                    </a:lnTo>
                    <a:lnTo>
                      <a:pt x="5333" y="119"/>
                    </a:lnTo>
                    <a:lnTo>
                      <a:pt x="5352" y="167"/>
                    </a:lnTo>
                    <a:lnTo>
                      <a:pt x="5371" y="142"/>
                    </a:lnTo>
                    <a:lnTo>
                      <a:pt x="5390" y="200"/>
                    </a:lnTo>
                    <a:lnTo>
                      <a:pt x="5410" y="223"/>
                    </a:lnTo>
                    <a:lnTo>
                      <a:pt x="5410" y="284"/>
                    </a:lnTo>
                    <a:lnTo>
                      <a:pt x="5390" y="284"/>
                    </a:lnTo>
                    <a:lnTo>
                      <a:pt x="5371" y="284"/>
                    </a:lnTo>
                    <a:lnTo>
                      <a:pt x="5352" y="284"/>
                    </a:lnTo>
                    <a:lnTo>
                      <a:pt x="5333" y="284"/>
                    </a:lnTo>
                    <a:lnTo>
                      <a:pt x="5312" y="284"/>
                    </a:lnTo>
                    <a:lnTo>
                      <a:pt x="5292" y="284"/>
                    </a:lnTo>
                    <a:lnTo>
                      <a:pt x="5273" y="284"/>
                    </a:lnTo>
                    <a:lnTo>
                      <a:pt x="5254" y="284"/>
                    </a:lnTo>
                    <a:lnTo>
                      <a:pt x="5235" y="284"/>
                    </a:lnTo>
                    <a:lnTo>
                      <a:pt x="5216" y="284"/>
                    </a:lnTo>
                    <a:lnTo>
                      <a:pt x="5196" y="284"/>
                    </a:lnTo>
                    <a:lnTo>
                      <a:pt x="5177" y="284"/>
                    </a:lnTo>
                    <a:lnTo>
                      <a:pt x="5158" y="284"/>
                    </a:lnTo>
                    <a:lnTo>
                      <a:pt x="5139" y="284"/>
                    </a:lnTo>
                    <a:lnTo>
                      <a:pt x="5120" y="284"/>
                    </a:lnTo>
                    <a:lnTo>
                      <a:pt x="5098" y="284"/>
                    </a:lnTo>
                    <a:lnTo>
                      <a:pt x="5079" y="284"/>
                    </a:lnTo>
                    <a:lnTo>
                      <a:pt x="5060" y="284"/>
                    </a:lnTo>
                    <a:lnTo>
                      <a:pt x="5041" y="284"/>
                    </a:lnTo>
                    <a:lnTo>
                      <a:pt x="5022" y="284"/>
                    </a:lnTo>
                    <a:lnTo>
                      <a:pt x="5002" y="284"/>
                    </a:lnTo>
                    <a:lnTo>
                      <a:pt x="4983" y="284"/>
                    </a:lnTo>
                    <a:lnTo>
                      <a:pt x="4964" y="284"/>
                    </a:lnTo>
                    <a:lnTo>
                      <a:pt x="4945" y="284"/>
                    </a:lnTo>
                    <a:lnTo>
                      <a:pt x="4926" y="284"/>
                    </a:lnTo>
                    <a:lnTo>
                      <a:pt x="4905" y="284"/>
                    </a:lnTo>
                    <a:lnTo>
                      <a:pt x="4885" y="284"/>
                    </a:lnTo>
                    <a:lnTo>
                      <a:pt x="4866" y="284"/>
                    </a:lnTo>
                    <a:lnTo>
                      <a:pt x="4847" y="284"/>
                    </a:lnTo>
                    <a:lnTo>
                      <a:pt x="4828" y="284"/>
                    </a:lnTo>
                    <a:lnTo>
                      <a:pt x="4809" y="284"/>
                    </a:lnTo>
                    <a:lnTo>
                      <a:pt x="4789" y="284"/>
                    </a:lnTo>
                    <a:lnTo>
                      <a:pt x="4770" y="284"/>
                    </a:lnTo>
                    <a:lnTo>
                      <a:pt x="4751" y="284"/>
                    </a:lnTo>
                    <a:lnTo>
                      <a:pt x="4732" y="284"/>
                    </a:lnTo>
                    <a:lnTo>
                      <a:pt x="4712" y="284"/>
                    </a:lnTo>
                    <a:lnTo>
                      <a:pt x="4691" y="284"/>
                    </a:lnTo>
                    <a:lnTo>
                      <a:pt x="4672" y="284"/>
                    </a:lnTo>
                    <a:lnTo>
                      <a:pt x="4653" y="284"/>
                    </a:lnTo>
                    <a:lnTo>
                      <a:pt x="4634" y="284"/>
                    </a:lnTo>
                    <a:lnTo>
                      <a:pt x="4615" y="284"/>
                    </a:lnTo>
                    <a:lnTo>
                      <a:pt x="4595" y="284"/>
                    </a:lnTo>
                    <a:lnTo>
                      <a:pt x="4576" y="284"/>
                    </a:lnTo>
                    <a:lnTo>
                      <a:pt x="4557" y="284"/>
                    </a:lnTo>
                    <a:lnTo>
                      <a:pt x="4538" y="284"/>
                    </a:lnTo>
                    <a:lnTo>
                      <a:pt x="4519" y="284"/>
                    </a:lnTo>
                    <a:lnTo>
                      <a:pt x="4497" y="284"/>
                    </a:lnTo>
                    <a:lnTo>
                      <a:pt x="4478" y="284"/>
                    </a:lnTo>
                    <a:lnTo>
                      <a:pt x="4459" y="284"/>
                    </a:lnTo>
                    <a:lnTo>
                      <a:pt x="4440" y="284"/>
                    </a:lnTo>
                    <a:lnTo>
                      <a:pt x="4421" y="284"/>
                    </a:lnTo>
                    <a:lnTo>
                      <a:pt x="4401" y="284"/>
                    </a:lnTo>
                    <a:lnTo>
                      <a:pt x="4382" y="284"/>
                    </a:lnTo>
                    <a:lnTo>
                      <a:pt x="4363" y="284"/>
                    </a:lnTo>
                    <a:lnTo>
                      <a:pt x="4344" y="284"/>
                    </a:lnTo>
                    <a:lnTo>
                      <a:pt x="4325" y="284"/>
                    </a:lnTo>
                    <a:lnTo>
                      <a:pt x="4305" y="284"/>
                    </a:lnTo>
                    <a:lnTo>
                      <a:pt x="4284" y="284"/>
                    </a:lnTo>
                    <a:lnTo>
                      <a:pt x="4265" y="284"/>
                    </a:lnTo>
                    <a:lnTo>
                      <a:pt x="4246" y="284"/>
                    </a:lnTo>
                    <a:lnTo>
                      <a:pt x="4227" y="284"/>
                    </a:lnTo>
                    <a:lnTo>
                      <a:pt x="4208" y="284"/>
                    </a:lnTo>
                    <a:lnTo>
                      <a:pt x="4188" y="284"/>
                    </a:lnTo>
                    <a:lnTo>
                      <a:pt x="4169" y="284"/>
                    </a:lnTo>
                    <a:lnTo>
                      <a:pt x="4150" y="284"/>
                    </a:lnTo>
                    <a:lnTo>
                      <a:pt x="4131" y="284"/>
                    </a:lnTo>
                    <a:lnTo>
                      <a:pt x="4111" y="284"/>
                    </a:lnTo>
                    <a:lnTo>
                      <a:pt x="4090" y="284"/>
                    </a:lnTo>
                    <a:lnTo>
                      <a:pt x="4071" y="284"/>
                    </a:lnTo>
                    <a:lnTo>
                      <a:pt x="4052" y="284"/>
                    </a:lnTo>
                    <a:lnTo>
                      <a:pt x="4033" y="284"/>
                    </a:lnTo>
                    <a:lnTo>
                      <a:pt x="4014" y="284"/>
                    </a:lnTo>
                    <a:lnTo>
                      <a:pt x="3994" y="284"/>
                    </a:lnTo>
                    <a:lnTo>
                      <a:pt x="3975" y="284"/>
                    </a:lnTo>
                    <a:lnTo>
                      <a:pt x="3956" y="284"/>
                    </a:lnTo>
                    <a:lnTo>
                      <a:pt x="3937" y="284"/>
                    </a:lnTo>
                    <a:lnTo>
                      <a:pt x="3918" y="284"/>
                    </a:lnTo>
                    <a:lnTo>
                      <a:pt x="3896" y="284"/>
                    </a:lnTo>
                    <a:lnTo>
                      <a:pt x="3877" y="284"/>
                    </a:lnTo>
                    <a:lnTo>
                      <a:pt x="3858" y="284"/>
                    </a:lnTo>
                    <a:lnTo>
                      <a:pt x="3839" y="284"/>
                    </a:lnTo>
                    <a:lnTo>
                      <a:pt x="3820" y="284"/>
                    </a:lnTo>
                    <a:lnTo>
                      <a:pt x="3800" y="284"/>
                    </a:lnTo>
                    <a:lnTo>
                      <a:pt x="3781" y="284"/>
                    </a:lnTo>
                    <a:lnTo>
                      <a:pt x="3762" y="284"/>
                    </a:lnTo>
                    <a:lnTo>
                      <a:pt x="3743" y="284"/>
                    </a:lnTo>
                    <a:lnTo>
                      <a:pt x="3724" y="284"/>
                    </a:lnTo>
                    <a:lnTo>
                      <a:pt x="3704" y="284"/>
                    </a:lnTo>
                    <a:lnTo>
                      <a:pt x="3683" y="284"/>
                    </a:lnTo>
                    <a:lnTo>
                      <a:pt x="3664" y="284"/>
                    </a:lnTo>
                    <a:lnTo>
                      <a:pt x="3645" y="284"/>
                    </a:lnTo>
                    <a:lnTo>
                      <a:pt x="3626" y="284"/>
                    </a:lnTo>
                    <a:lnTo>
                      <a:pt x="3607" y="284"/>
                    </a:lnTo>
                    <a:lnTo>
                      <a:pt x="3587" y="284"/>
                    </a:lnTo>
                    <a:lnTo>
                      <a:pt x="3568" y="284"/>
                    </a:lnTo>
                    <a:lnTo>
                      <a:pt x="3549" y="284"/>
                    </a:lnTo>
                    <a:lnTo>
                      <a:pt x="3530" y="284"/>
                    </a:lnTo>
                    <a:lnTo>
                      <a:pt x="3510" y="284"/>
                    </a:lnTo>
                    <a:lnTo>
                      <a:pt x="3489" y="284"/>
                    </a:lnTo>
                    <a:lnTo>
                      <a:pt x="3470" y="284"/>
                    </a:lnTo>
                    <a:lnTo>
                      <a:pt x="3451" y="284"/>
                    </a:lnTo>
                    <a:lnTo>
                      <a:pt x="3432" y="284"/>
                    </a:lnTo>
                    <a:lnTo>
                      <a:pt x="3413" y="284"/>
                    </a:lnTo>
                    <a:lnTo>
                      <a:pt x="3393" y="284"/>
                    </a:lnTo>
                    <a:lnTo>
                      <a:pt x="3374" y="284"/>
                    </a:lnTo>
                    <a:lnTo>
                      <a:pt x="3355" y="284"/>
                    </a:lnTo>
                    <a:lnTo>
                      <a:pt x="3336" y="284"/>
                    </a:lnTo>
                    <a:lnTo>
                      <a:pt x="3317" y="284"/>
                    </a:lnTo>
                    <a:lnTo>
                      <a:pt x="3297" y="284"/>
                    </a:lnTo>
                    <a:lnTo>
                      <a:pt x="3276" y="284"/>
                    </a:lnTo>
                    <a:lnTo>
                      <a:pt x="3257" y="284"/>
                    </a:lnTo>
                    <a:lnTo>
                      <a:pt x="3238" y="284"/>
                    </a:lnTo>
                    <a:lnTo>
                      <a:pt x="3219" y="284"/>
                    </a:lnTo>
                    <a:lnTo>
                      <a:pt x="3199" y="284"/>
                    </a:lnTo>
                    <a:lnTo>
                      <a:pt x="3180" y="284"/>
                    </a:lnTo>
                    <a:lnTo>
                      <a:pt x="3161" y="284"/>
                    </a:lnTo>
                    <a:lnTo>
                      <a:pt x="3142" y="284"/>
                    </a:lnTo>
                    <a:lnTo>
                      <a:pt x="3123" y="284"/>
                    </a:lnTo>
                    <a:lnTo>
                      <a:pt x="3103" y="284"/>
                    </a:lnTo>
                    <a:lnTo>
                      <a:pt x="3082" y="284"/>
                    </a:lnTo>
                    <a:lnTo>
                      <a:pt x="3063" y="284"/>
                    </a:lnTo>
                    <a:lnTo>
                      <a:pt x="3044" y="284"/>
                    </a:lnTo>
                    <a:lnTo>
                      <a:pt x="3025" y="284"/>
                    </a:lnTo>
                    <a:lnTo>
                      <a:pt x="3006" y="284"/>
                    </a:lnTo>
                    <a:lnTo>
                      <a:pt x="2986" y="284"/>
                    </a:lnTo>
                    <a:lnTo>
                      <a:pt x="2967" y="284"/>
                    </a:lnTo>
                    <a:lnTo>
                      <a:pt x="2948" y="284"/>
                    </a:lnTo>
                    <a:lnTo>
                      <a:pt x="2929" y="284"/>
                    </a:lnTo>
                    <a:lnTo>
                      <a:pt x="2909" y="284"/>
                    </a:lnTo>
                    <a:lnTo>
                      <a:pt x="2890" y="284"/>
                    </a:lnTo>
                    <a:lnTo>
                      <a:pt x="2869" y="284"/>
                    </a:lnTo>
                    <a:lnTo>
                      <a:pt x="2850" y="284"/>
                    </a:lnTo>
                    <a:lnTo>
                      <a:pt x="2831" y="284"/>
                    </a:lnTo>
                    <a:lnTo>
                      <a:pt x="2812" y="284"/>
                    </a:lnTo>
                    <a:lnTo>
                      <a:pt x="2792" y="284"/>
                    </a:lnTo>
                    <a:lnTo>
                      <a:pt x="2773" y="284"/>
                    </a:lnTo>
                    <a:lnTo>
                      <a:pt x="2754" y="284"/>
                    </a:lnTo>
                    <a:lnTo>
                      <a:pt x="2735" y="284"/>
                    </a:lnTo>
                    <a:lnTo>
                      <a:pt x="2716" y="284"/>
                    </a:lnTo>
                    <a:lnTo>
                      <a:pt x="2696" y="284"/>
                    </a:lnTo>
                    <a:lnTo>
                      <a:pt x="2675" y="284"/>
                    </a:lnTo>
                    <a:lnTo>
                      <a:pt x="2656" y="284"/>
                    </a:lnTo>
                    <a:lnTo>
                      <a:pt x="2637" y="284"/>
                    </a:lnTo>
                    <a:lnTo>
                      <a:pt x="2618" y="284"/>
                    </a:lnTo>
                    <a:lnTo>
                      <a:pt x="2598" y="284"/>
                    </a:lnTo>
                    <a:lnTo>
                      <a:pt x="2579" y="284"/>
                    </a:lnTo>
                    <a:lnTo>
                      <a:pt x="2560" y="284"/>
                    </a:lnTo>
                    <a:lnTo>
                      <a:pt x="2541" y="284"/>
                    </a:lnTo>
                    <a:lnTo>
                      <a:pt x="2522" y="284"/>
                    </a:lnTo>
                    <a:lnTo>
                      <a:pt x="2502" y="284"/>
                    </a:lnTo>
                    <a:lnTo>
                      <a:pt x="2483" y="284"/>
                    </a:lnTo>
                    <a:lnTo>
                      <a:pt x="2462" y="284"/>
                    </a:lnTo>
                    <a:lnTo>
                      <a:pt x="2443" y="284"/>
                    </a:lnTo>
                    <a:lnTo>
                      <a:pt x="2424" y="284"/>
                    </a:lnTo>
                    <a:lnTo>
                      <a:pt x="2404" y="284"/>
                    </a:lnTo>
                    <a:lnTo>
                      <a:pt x="2385" y="284"/>
                    </a:lnTo>
                    <a:lnTo>
                      <a:pt x="2366" y="284"/>
                    </a:lnTo>
                    <a:lnTo>
                      <a:pt x="2347" y="284"/>
                    </a:lnTo>
                    <a:lnTo>
                      <a:pt x="2328" y="284"/>
                    </a:lnTo>
                    <a:lnTo>
                      <a:pt x="2308" y="284"/>
                    </a:lnTo>
                    <a:lnTo>
                      <a:pt x="2289" y="284"/>
                    </a:lnTo>
                    <a:lnTo>
                      <a:pt x="2268" y="284"/>
                    </a:lnTo>
                    <a:lnTo>
                      <a:pt x="2249" y="284"/>
                    </a:lnTo>
                    <a:lnTo>
                      <a:pt x="2230" y="284"/>
                    </a:lnTo>
                    <a:lnTo>
                      <a:pt x="2211" y="284"/>
                    </a:lnTo>
                    <a:lnTo>
                      <a:pt x="2191" y="284"/>
                    </a:lnTo>
                    <a:lnTo>
                      <a:pt x="2172" y="284"/>
                    </a:lnTo>
                    <a:lnTo>
                      <a:pt x="2153" y="284"/>
                    </a:lnTo>
                    <a:lnTo>
                      <a:pt x="2134" y="284"/>
                    </a:lnTo>
                    <a:lnTo>
                      <a:pt x="2115" y="284"/>
                    </a:lnTo>
                    <a:lnTo>
                      <a:pt x="2095" y="284"/>
                    </a:lnTo>
                    <a:lnTo>
                      <a:pt x="2076" y="284"/>
                    </a:lnTo>
                    <a:lnTo>
                      <a:pt x="2055" y="284"/>
                    </a:lnTo>
                    <a:lnTo>
                      <a:pt x="2036" y="284"/>
                    </a:lnTo>
                    <a:lnTo>
                      <a:pt x="2017" y="284"/>
                    </a:lnTo>
                    <a:lnTo>
                      <a:pt x="1997" y="284"/>
                    </a:lnTo>
                    <a:lnTo>
                      <a:pt x="1978" y="284"/>
                    </a:lnTo>
                    <a:lnTo>
                      <a:pt x="1959" y="284"/>
                    </a:lnTo>
                    <a:lnTo>
                      <a:pt x="1940" y="284"/>
                    </a:lnTo>
                    <a:lnTo>
                      <a:pt x="1921" y="284"/>
                    </a:lnTo>
                    <a:lnTo>
                      <a:pt x="1901" y="284"/>
                    </a:lnTo>
                    <a:lnTo>
                      <a:pt x="1882" y="284"/>
                    </a:lnTo>
                    <a:lnTo>
                      <a:pt x="1861" y="284"/>
                    </a:lnTo>
                    <a:lnTo>
                      <a:pt x="1842" y="284"/>
                    </a:lnTo>
                    <a:lnTo>
                      <a:pt x="1823" y="284"/>
                    </a:lnTo>
                    <a:lnTo>
                      <a:pt x="1803" y="284"/>
                    </a:lnTo>
                    <a:lnTo>
                      <a:pt x="1784" y="284"/>
                    </a:lnTo>
                    <a:lnTo>
                      <a:pt x="1765" y="284"/>
                    </a:lnTo>
                    <a:lnTo>
                      <a:pt x="1746" y="284"/>
                    </a:lnTo>
                    <a:lnTo>
                      <a:pt x="1727" y="284"/>
                    </a:lnTo>
                    <a:lnTo>
                      <a:pt x="1707" y="284"/>
                    </a:lnTo>
                    <a:lnTo>
                      <a:pt x="1688" y="284"/>
                    </a:lnTo>
                    <a:lnTo>
                      <a:pt x="1669" y="284"/>
                    </a:lnTo>
                    <a:lnTo>
                      <a:pt x="1648" y="284"/>
                    </a:lnTo>
                    <a:lnTo>
                      <a:pt x="1629" y="284"/>
                    </a:lnTo>
                    <a:lnTo>
                      <a:pt x="1610" y="284"/>
                    </a:lnTo>
                    <a:lnTo>
                      <a:pt x="1590" y="284"/>
                    </a:lnTo>
                    <a:lnTo>
                      <a:pt x="1571" y="284"/>
                    </a:lnTo>
                    <a:lnTo>
                      <a:pt x="1552" y="284"/>
                    </a:lnTo>
                    <a:lnTo>
                      <a:pt x="1533" y="284"/>
                    </a:lnTo>
                    <a:lnTo>
                      <a:pt x="1514" y="284"/>
                    </a:lnTo>
                    <a:lnTo>
                      <a:pt x="1494" y="284"/>
                    </a:lnTo>
                    <a:lnTo>
                      <a:pt x="1475" y="284"/>
                    </a:lnTo>
                    <a:lnTo>
                      <a:pt x="1454" y="284"/>
                    </a:lnTo>
                    <a:lnTo>
                      <a:pt x="1435" y="284"/>
                    </a:lnTo>
                    <a:lnTo>
                      <a:pt x="1416" y="284"/>
                    </a:lnTo>
                    <a:lnTo>
                      <a:pt x="1396" y="284"/>
                    </a:lnTo>
                    <a:lnTo>
                      <a:pt x="1377" y="284"/>
                    </a:lnTo>
                    <a:lnTo>
                      <a:pt x="1358" y="284"/>
                    </a:lnTo>
                    <a:lnTo>
                      <a:pt x="1339" y="284"/>
                    </a:lnTo>
                    <a:lnTo>
                      <a:pt x="1320" y="284"/>
                    </a:lnTo>
                    <a:lnTo>
                      <a:pt x="1300" y="284"/>
                    </a:lnTo>
                    <a:lnTo>
                      <a:pt x="1281" y="284"/>
                    </a:lnTo>
                    <a:lnTo>
                      <a:pt x="1262" y="284"/>
                    </a:lnTo>
                    <a:lnTo>
                      <a:pt x="1241" y="284"/>
                    </a:lnTo>
                    <a:lnTo>
                      <a:pt x="1222" y="284"/>
                    </a:lnTo>
                    <a:lnTo>
                      <a:pt x="1202" y="284"/>
                    </a:lnTo>
                    <a:lnTo>
                      <a:pt x="1183" y="284"/>
                    </a:lnTo>
                    <a:lnTo>
                      <a:pt x="1164" y="284"/>
                    </a:lnTo>
                    <a:lnTo>
                      <a:pt x="1145" y="284"/>
                    </a:lnTo>
                    <a:lnTo>
                      <a:pt x="1126" y="284"/>
                    </a:lnTo>
                    <a:lnTo>
                      <a:pt x="1106" y="284"/>
                    </a:lnTo>
                    <a:lnTo>
                      <a:pt x="1087" y="284"/>
                    </a:lnTo>
                    <a:lnTo>
                      <a:pt x="1068" y="284"/>
                    </a:lnTo>
                    <a:lnTo>
                      <a:pt x="1047" y="284"/>
                    </a:lnTo>
                    <a:lnTo>
                      <a:pt x="1028" y="284"/>
                    </a:lnTo>
                    <a:lnTo>
                      <a:pt x="1009" y="284"/>
                    </a:lnTo>
                    <a:lnTo>
                      <a:pt x="989" y="284"/>
                    </a:lnTo>
                    <a:lnTo>
                      <a:pt x="970" y="284"/>
                    </a:lnTo>
                    <a:lnTo>
                      <a:pt x="951" y="284"/>
                    </a:lnTo>
                    <a:lnTo>
                      <a:pt x="932" y="284"/>
                    </a:lnTo>
                    <a:lnTo>
                      <a:pt x="913" y="284"/>
                    </a:lnTo>
                    <a:lnTo>
                      <a:pt x="893" y="284"/>
                    </a:lnTo>
                    <a:lnTo>
                      <a:pt x="874" y="284"/>
                    </a:lnTo>
                    <a:lnTo>
                      <a:pt x="853" y="284"/>
                    </a:lnTo>
                    <a:lnTo>
                      <a:pt x="834" y="284"/>
                    </a:lnTo>
                    <a:lnTo>
                      <a:pt x="815" y="284"/>
                    </a:lnTo>
                    <a:lnTo>
                      <a:pt x="795" y="284"/>
                    </a:lnTo>
                    <a:lnTo>
                      <a:pt x="776" y="284"/>
                    </a:lnTo>
                    <a:lnTo>
                      <a:pt x="757" y="284"/>
                    </a:lnTo>
                    <a:lnTo>
                      <a:pt x="738" y="284"/>
                    </a:lnTo>
                    <a:lnTo>
                      <a:pt x="719" y="284"/>
                    </a:lnTo>
                    <a:lnTo>
                      <a:pt x="699" y="284"/>
                    </a:lnTo>
                    <a:lnTo>
                      <a:pt x="680" y="284"/>
                    </a:lnTo>
                    <a:lnTo>
                      <a:pt x="661" y="284"/>
                    </a:lnTo>
                    <a:lnTo>
                      <a:pt x="640" y="284"/>
                    </a:lnTo>
                    <a:lnTo>
                      <a:pt x="621" y="284"/>
                    </a:lnTo>
                    <a:lnTo>
                      <a:pt x="601" y="284"/>
                    </a:lnTo>
                    <a:lnTo>
                      <a:pt x="582" y="284"/>
                    </a:lnTo>
                    <a:lnTo>
                      <a:pt x="563" y="284"/>
                    </a:lnTo>
                    <a:lnTo>
                      <a:pt x="544" y="284"/>
                    </a:lnTo>
                    <a:lnTo>
                      <a:pt x="525" y="284"/>
                    </a:lnTo>
                    <a:lnTo>
                      <a:pt x="505" y="284"/>
                    </a:lnTo>
                    <a:lnTo>
                      <a:pt x="486" y="284"/>
                    </a:lnTo>
                    <a:lnTo>
                      <a:pt x="467" y="284"/>
                    </a:lnTo>
                    <a:lnTo>
                      <a:pt x="446" y="284"/>
                    </a:lnTo>
                    <a:lnTo>
                      <a:pt x="427" y="284"/>
                    </a:lnTo>
                    <a:lnTo>
                      <a:pt x="408" y="284"/>
                    </a:lnTo>
                    <a:lnTo>
                      <a:pt x="388" y="284"/>
                    </a:lnTo>
                    <a:lnTo>
                      <a:pt x="369" y="284"/>
                    </a:lnTo>
                    <a:lnTo>
                      <a:pt x="350" y="284"/>
                    </a:lnTo>
                    <a:lnTo>
                      <a:pt x="331" y="284"/>
                    </a:lnTo>
                    <a:lnTo>
                      <a:pt x="312" y="284"/>
                    </a:lnTo>
                    <a:lnTo>
                      <a:pt x="292" y="284"/>
                    </a:lnTo>
                    <a:lnTo>
                      <a:pt x="273" y="284"/>
                    </a:lnTo>
                    <a:lnTo>
                      <a:pt x="254" y="284"/>
                    </a:lnTo>
                    <a:lnTo>
                      <a:pt x="233" y="284"/>
                    </a:lnTo>
                    <a:lnTo>
                      <a:pt x="214" y="284"/>
                    </a:lnTo>
                    <a:lnTo>
                      <a:pt x="194" y="284"/>
                    </a:lnTo>
                    <a:lnTo>
                      <a:pt x="175" y="284"/>
                    </a:lnTo>
                    <a:lnTo>
                      <a:pt x="156" y="284"/>
                    </a:lnTo>
                    <a:lnTo>
                      <a:pt x="137" y="284"/>
                    </a:lnTo>
                    <a:lnTo>
                      <a:pt x="118" y="284"/>
                    </a:lnTo>
                    <a:lnTo>
                      <a:pt x="98" y="284"/>
                    </a:lnTo>
                    <a:lnTo>
                      <a:pt x="79" y="284"/>
                    </a:lnTo>
                    <a:lnTo>
                      <a:pt x="60" y="284"/>
                    </a:lnTo>
                    <a:lnTo>
                      <a:pt x="39" y="284"/>
                    </a:lnTo>
                    <a:lnTo>
                      <a:pt x="20" y="284"/>
                    </a:lnTo>
                    <a:lnTo>
                      <a:pt x="0" y="284"/>
                    </a:lnTo>
                    <a:lnTo>
                      <a:pt x="0" y="90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9" name="Freeform 97"/>
              <p:cNvSpPr>
                <a:spLocks/>
              </p:cNvSpPr>
              <p:nvPr/>
            </p:nvSpPr>
            <p:spPr bwMode="auto">
              <a:xfrm rot="5400000" flipV="1">
                <a:off x="4482991" y="3231744"/>
                <a:ext cx="4495156" cy="179670"/>
              </a:xfrm>
              <a:custGeom>
                <a:avLst/>
                <a:gdLst>
                  <a:gd name="T0" fmla="*/ 160 w 5410"/>
                  <a:gd name="T1" fmla="*/ 269 h 269"/>
                  <a:gd name="T2" fmla="*/ 333 w 5410"/>
                  <a:gd name="T3" fmla="*/ 262 h 269"/>
                  <a:gd name="T4" fmla="*/ 504 w 5410"/>
                  <a:gd name="T5" fmla="*/ 269 h 269"/>
                  <a:gd name="T6" fmla="*/ 676 w 5410"/>
                  <a:gd name="T7" fmla="*/ 194 h 269"/>
                  <a:gd name="T8" fmla="*/ 849 w 5410"/>
                  <a:gd name="T9" fmla="*/ 252 h 269"/>
                  <a:gd name="T10" fmla="*/ 1022 w 5410"/>
                  <a:gd name="T11" fmla="*/ 242 h 269"/>
                  <a:gd name="T12" fmla="*/ 1195 w 5410"/>
                  <a:gd name="T13" fmla="*/ 252 h 269"/>
                  <a:gd name="T14" fmla="*/ 1368 w 5410"/>
                  <a:gd name="T15" fmla="*/ 256 h 269"/>
                  <a:gd name="T16" fmla="*/ 1540 w 5410"/>
                  <a:gd name="T17" fmla="*/ 269 h 269"/>
                  <a:gd name="T18" fmla="*/ 1713 w 5410"/>
                  <a:gd name="T19" fmla="*/ 250 h 269"/>
                  <a:gd name="T20" fmla="*/ 1886 w 5410"/>
                  <a:gd name="T21" fmla="*/ 229 h 269"/>
                  <a:gd name="T22" fmla="*/ 2059 w 5410"/>
                  <a:gd name="T23" fmla="*/ 158 h 269"/>
                  <a:gd name="T24" fmla="*/ 2230 w 5410"/>
                  <a:gd name="T25" fmla="*/ 137 h 269"/>
                  <a:gd name="T26" fmla="*/ 2403 w 5410"/>
                  <a:gd name="T27" fmla="*/ 219 h 269"/>
                  <a:gd name="T28" fmla="*/ 2575 w 5410"/>
                  <a:gd name="T29" fmla="*/ 262 h 269"/>
                  <a:gd name="T30" fmla="*/ 2748 w 5410"/>
                  <a:gd name="T31" fmla="*/ 256 h 269"/>
                  <a:gd name="T32" fmla="*/ 2921 w 5410"/>
                  <a:gd name="T33" fmla="*/ 173 h 269"/>
                  <a:gd name="T34" fmla="*/ 3094 w 5410"/>
                  <a:gd name="T35" fmla="*/ 91 h 269"/>
                  <a:gd name="T36" fmla="*/ 3267 w 5410"/>
                  <a:gd name="T37" fmla="*/ 96 h 269"/>
                  <a:gd name="T38" fmla="*/ 3439 w 5410"/>
                  <a:gd name="T39" fmla="*/ 237 h 269"/>
                  <a:gd name="T40" fmla="*/ 3612 w 5410"/>
                  <a:gd name="T41" fmla="*/ 85 h 269"/>
                  <a:gd name="T42" fmla="*/ 3783 w 5410"/>
                  <a:gd name="T43" fmla="*/ 96 h 269"/>
                  <a:gd name="T44" fmla="*/ 3956 w 5410"/>
                  <a:gd name="T45" fmla="*/ 56 h 269"/>
                  <a:gd name="T46" fmla="*/ 4129 w 5410"/>
                  <a:gd name="T47" fmla="*/ 89 h 269"/>
                  <a:gd name="T48" fmla="*/ 4302 w 5410"/>
                  <a:gd name="T49" fmla="*/ 43 h 269"/>
                  <a:gd name="T50" fmla="*/ 4474 w 5410"/>
                  <a:gd name="T51" fmla="*/ 60 h 269"/>
                  <a:gd name="T52" fmla="*/ 4647 w 5410"/>
                  <a:gd name="T53" fmla="*/ 102 h 269"/>
                  <a:gd name="T54" fmla="*/ 4820 w 5410"/>
                  <a:gd name="T55" fmla="*/ 68 h 269"/>
                  <a:gd name="T56" fmla="*/ 4993 w 5410"/>
                  <a:gd name="T57" fmla="*/ 77 h 269"/>
                  <a:gd name="T58" fmla="*/ 5166 w 5410"/>
                  <a:gd name="T59" fmla="*/ 89 h 269"/>
                  <a:gd name="T60" fmla="*/ 5337 w 5410"/>
                  <a:gd name="T61" fmla="*/ 23 h 269"/>
                  <a:gd name="T62" fmla="*/ 5323 w 5410"/>
                  <a:gd name="T63" fmla="*/ 269 h 269"/>
                  <a:gd name="T64" fmla="*/ 5150 w 5410"/>
                  <a:gd name="T65" fmla="*/ 269 h 269"/>
                  <a:gd name="T66" fmla="*/ 4977 w 5410"/>
                  <a:gd name="T67" fmla="*/ 269 h 269"/>
                  <a:gd name="T68" fmla="*/ 4805 w 5410"/>
                  <a:gd name="T69" fmla="*/ 269 h 269"/>
                  <a:gd name="T70" fmla="*/ 4632 w 5410"/>
                  <a:gd name="T71" fmla="*/ 269 h 269"/>
                  <a:gd name="T72" fmla="*/ 4461 w 5410"/>
                  <a:gd name="T73" fmla="*/ 269 h 269"/>
                  <a:gd name="T74" fmla="*/ 4288 w 5410"/>
                  <a:gd name="T75" fmla="*/ 269 h 269"/>
                  <a:gd name="T76" fmla="*/ 4115 w 5410"/>
                  <a:gd name="T77" fmla="*/ 269 h 269"/>
                  <a:gd name="T78" fmla="*/ 3943 w 5410"/>
                  <a:gd name="T79" fmla="*/ 269 h 269"/>
                  <a:gd name="T80" fmla="*/ 3770 w 5410"/>
                  <a:gd name="T81" fmla="*/ 269 h 269"/>
                  <a:gd name="T82" fmla="*/ 3597 w 5410"/>
                  <a:gd name="T83" fmla="*/ 269 h 269"/>
                  <a:gd name="T84" fmla="*/ 3424 w 5410"/>
                  <a:gd name="T85" fmla="*/ 269 h 269"/>
                  <a:gd name="T86" fmla="*/ 3251 w 5410"/>
                  <a:gd name="T87" fmla="*/ 269 h 269"/>
                  <a:gd name="T88" fmla="*/ 3078 w 5410"/>
                  <a:gd name="T89" fmla="*/ 269 h 269"/>
                  <a:gd name="T90" fmla="*/ 2906 w 5410"/>
                  <a:gd name="T91" fmla="*/ 269 h 269"/>
                  <a:gd name="T92" fmla="*/ 2735 w 5410"/>
                  <a:gd name="T93" fmla="*/ 269 h 269"/>
                  <a:gd name="T94" fmla="*/ 2562 w 5410"/>
                  <a:gd name="T95" fmla="*/ 269 h 269"/>
                  <a:gd name="T96" fmla="*/ 2389 w 5410"/>
                  <a:gd name="T97" fmla="*/ 269 h 269"/>
                  <a:gd name="T98" fmla="*/ 2216 w 5410"/>
                  <a:gd name="T99" fmla="*/ 269 h 269"/>
                  <a:gd name="T100" fmla="*/ 2044 w 5410"/>
                  <a:gd name="T101" fmla="*/ 269 h 269"/>
                  <a:gd name="T102" fmla="*/ 1871 w 5410"/>
                  <a:gd name="T103" fmla="*/ 269 h 269"/>
                  <a:gd name="T104" fmla="*/ 1698 w 5410"/>
                  <a:gd name="T105" fmla="*/ 269 h 269"/>
                  <a:gd name="T106" fmla="*/ 1525 w 5410"/>
                  <a:gd name="T107" fmla="*/ 269 h 269"/>
                  <a:gd name="T108" fmla="*/ 1352 w 5410"/>
                  <a:gd name="T109" fmla="*/ 269 h 269"/>
                  <a:gd name="T110" fmla="*/ 1181 w 5410"/>
                  <a:gd name="T111" fmla="*/ 269 h 269"/>
                  <a:gd name="T112" fmla="*/ 1009 w 5410"/>
                  <a:gd name="T113" fmla="*/ 269 h 269"/>
                  <a:gd name="T114" fmla="*/ 836 w 5410"/>
                  <a:gd name="T115" fmla="*/ 269 h 269"/>
                  <a:gd name="T116" fmla="*/ 663 w 5410"/>
                  <a:gd name="T117" fmla="*/ 269 h 269"/>
                  <a:gd name="T118" fmla="*/ 490 w 5410"/>
                  <a:gd name="T119" fmla="*/ 269 h 269"/>
                  <a:gd name="T120" fmla="*/ 317 w 5410"/>
                  <a:gd name="T121" fmla="*/ 269 h 269"/>
                  <a:gd name="T122" fmla="*/ 145 w 5410"/>
                  <a:gd name="T123" fmla="*/ 269 h 2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</a:cxnLst>
                <a:rect l="0" t="0" r="r" b="b"/>
                <a:pathLst>
                  <a:path w="5410" h="269">
                    <a:moveTo>
                      <a:pt x="0" y="269"/>
                    </a:moveTo>
                    <a:lnTo>
                      <a:pt x="16" y="262"/>
                    </a:lnTo>
                    <a:lnTo>
                      <a:pt x="29" y="269"/>
                    </a:lnTo>
                    <a:lnTo>
                      <a:pt x="45" y="269"/>
                    </a:lnTo>
                    <a:lnTo>
                      <a:pt x="58" y="269"/>
                    </a:lnTo>
                    <a:lnTo>
                      <a:pt x="73" y="246"/>
                    </a:lnTo>
                    <a:lnTo>
                      <a:pt x="87" y="239"/>
                    </a:lnTo>
                    <a:lnTo>
                      <a:pt x="102" y="237"/>
                    </a:lnTo>
                    <a:lnTo>
                      <a:pt x="116" y="269"/>
                    </a:lnTo>
                    <a:lnTo>
                      <a:pt x="131" y="256"/>
                    </a:lnTo>
                    <a:lnTo>
                      <a:pt x="145" y="260"/>
                    </a:lnTo>
                    <a:lnTo>
                      <a:pt x="160" y="269"/>
                    </a:lnTo>
                    <a:lnTo>
                      <a:pt x="173" y="198"/>
                    </a:lnTo>
                    <a:lnTo>
                      <a:pt x="189" y="200"/>
                    </a:lnTo>
                    <a:lnTo>
                      <a:pt x="202" y="168"/>
                    </a:lnTo>
                    <a:lnTo>
                      <a:pt x="217" y="150"/>
                    </a:lnTo>
                    <a:lnTo>
                      <a:pt x="231" y="150"/>
                    </a:lnTo>
                    <a:lnTo>
                      <a:pt x="246" y="179"/>
                    </a:lnTo>
                    <a:lnTo>
                      <a:pt x="260" y="183"/>
                    </a:lnTo>
                    <a:lnTo>
                      <a:pt x="275" y="206"/>
                    </a:lnTo>
                    <a:lnTo>
                      <a:pt x="289" y="266"/>
                    </a:lnTo>
                    <a:lnTo>
                      <a:pt x="304" y="264"/>
                    </a:lnTo>
                    <a:lnTo>
                      <a:pt x="317" y="269"/>
                    </a:lnTo>
                    <a:lnTo>
                      <a:pt x="333" y="262"/>
                    </a:lnTo>
                    <a:lnTo>
                      <a:pt x="346" y="241"/>
                    </a:lnTo>
                    <a:lnTo>
                      <a:pt x="361" y="269"/>
                    </a:lnTo>
                    <a:lnTo>
                      <a:pt x="375" y="252"/>
                    </a:lnTo>
                    <a:lnTo>
                      <a:pt x="390" y="269"/>
                    </a:lnTo>
                    <a:lnTo>
                      <a:pt x="404" y="269"/>
                    </a:lnTo>
                    <a:lnTo>
                      <a:pt x="419" y="269"/>
                    </a:lnTo>
                    <a:lnTo>
                      <a:pt x="433" y="260"/>
                    </a:lnTo>
                    <a:lnTo>
                      <a:pt x="448" y="269"/>
                    </a:lnTo>
                    <a:lnTo>
                      <a:pt x="461" y="269"/>
                    </a:lnTo>
                    <a:lnTo>
                      <a:pt x="475" y="269"/>
                    </a:lnTo>
                    <a:lnTo>
                      <a:pt x="490" y="260"/>
                    </a:lnTo>
                    <a:lnTo>
                      <a:pt x="504" y="269"/>
                    </a:lnTo>
                    <a:lnTo>
                      <a:pt x="519" y="264"/>
                    </a:lnTo>
                    <a:lnTo>
                      <a:pt x="532" y="214"/>
                    </a:lnTo>
                    <a:lnTo>
                      <a:pt x="548" y="108"/>
                    </a:lnTo>
                    <a:lnTo>
                      <a:pt x="561" y="144"/>
                    </a:lnTo>
                    <a:lnTo>
                      <a:pt x="577" y="143"/>
                    </a:lnTo>
                    <a:lnTo>
                      <a:pt x="590" y="246"/>
                    </a:lnTo>
                    <a:lnTo>
                      <a:pt x="605" y="221"/>
                    </a:lnTo>
                    <a:lnTo>
                      <a:pt x="619" y="202"/>
                    </a:lnTo>
                    <a:lnTo>
                      <a:pt x="634" y="252"/>
                    </a:lnTo>
                    <a:lnTo>
                      <a:pt x="648" y="239"/>
                    </a:lnTo>
                    <a:lnTo>
                      <a:pt x="663" y="210"/>
                    </a:lnTo>
                    <a:lnTo>
                      <a:pt x="676" y="194"/>
                    </a:lnTo>
                    <a:lnTo>
                      <a:pt x="692" y="239"/>
                    </a:lnTo>
                    <a:lnTo>
                      <a:pt x="705" y="241"/>
                    </a:lnTo>
                    <a:lnTo>
                      <a:pt x="721" y="183"/>
                    </a:lnTo>
                    <a:lnTo>
                      <a:pt x="734" y="256"/>
                    </a:lnTo>
                    <a:lnTo>
                      <a:pt x="749" y="194"/>
                    </a:lnTo>
                    <a:lnTo>
                      <a:pt x="763" y="241"/>
                    </a:lnTo>
                    <a:lnTo>
                      <a:pt x="778" y="231"/>
                    </a:lnTo>
                    <a:lnTo>
                      <a:pt x="792" y="235"/>
                    </a:lnTo>
                    <a:lnTo>
                      <a:pt x="807" y="269"/>
                    </a:lnTo>
                    <a:lnTo>
                      <a:pt x="820" y="269"/>
                    </a:lnTo>
                    <a:lnTo>
                      <a:pt x="836" y="269"/>
                    </a:lnTo>
                    <a:lnTo>
                      <a:pt x="849" y="252"/>
                    </a:lnTo>
                    <a:lnTo>
                      <a:pt x="865" y="269"/>
                    </a:lnTo>
                    <a:lnTo>
                      <a:pt x="878" y="266"/>
                    </a:lnTo>
                    <a:lnTo>
                      <a:pt x="893" y="248"/>
                    </a:lnTo>
                    <a:lnTo>
                      <a:pt x="907" y="269"/>
                    </a:lnTo>
                    <a:lnTo>
                      <a:pt x="922" y="235"/>
                    </a:lnTo>
                    <a:lnTo>
                      <a:pt x="936" y="269"/>
                    </a:lnTo>
                    <a:lnTo>
                      <a:pt x="951" y="269"/>
                    </a:lnTo>
                    <a:lnTo>
                      <a:pt x="964" y="250"/>
                    </a:lnTo>
                    <a:lnTo>
                      <a:pt x="980" y="267"/>
                    </a:lnTo>
                    <a:lnTo>
                      <a:pt x="993" y="269"/>
                    </a:lnTo>
                    <a:lnTo>
                      <a:pt x="1009" y="269"/>
                    </a:lnTo>
                    <a:lnTo>
                      <a:pt x="1022" y="242"/>
                    </a:lnTo>
                    <a:lnTo>
                      <a:pt x="1037" y="254"/>
                    </a:lnTo>
                    <a:lnTo>
                      <a:pt x="1051" y="264"/>
                    </a:lnTo>
                    <a:lnTo>
                      <a:pt x="1066" y="202"/>
                    </a:lnTo>
                    <a:lnTo>
                      <a:pt x="1080" y="219"/>
                    </a:lnTo>
                    <a:lnTo>
                      <a:pt x="1095" y="231"/>
                    </a:lnTo>
                    <a:lnTo>
                      <a:pt x="1108" y="225"/>
                    </a:lnTo>
                    <a:lnTo>
                      <a:pt x="1124" y="262"/>
                    </a:lnTo>
                    <a:lnTo>
                      <a:pt x="1137" y="168"/>
                    </a:lnTo>
                    <a:lnTo>
                      <a:pt x="1153" y="241"/>
                    </a:lnTo>
                    <a:lnTo>
                      <a:pt x="1166" y="269"/>
                    </a:lnTo>
                    <a:lnTo>
                      <a:pt x="1181" y="269"/>
                    </a:lnTo>
                    <a:lnTo>
                      <a:pt x="1195" y="252"/>
                    </a:lnTo>
                    <a:lnTo>
                      <a:pt x="1210" y="269"/>
                    </a:lnTo>
                    <a:lnTo>
                      <a:pt x="1224" y="260"/>
                    </a:lnTo>
                    <a:lnTo>
                      <a:pt x="1239" y="269"/>
                    </a:lnTo>
                    <a:lnTo>
                      <a:pt x="1252" y="266"/>
                    </a:lnTo>
                    <a:lnTo>
                      <a:pt x="1268" y="269"/>
                    </a:lnTo>
                    <a:lnTo>
                      <a:pt x="1281" y="269"/>
                    </a:lnTo>
                    <a:lnTo>
                      <a:pt x="1295" y="267"/>
                    </a:lnTo>
                    <a:lnTo>
                      <a:pt x="1310" y="254"/>
                    </a:lnTo>
                    <a:lnTo>
                      <a:pt x="1323" y="229"/>
                    </a:lnTo>
                    <a:lnTo>
                      <a:pt x="1339" y="239"/>
                    </a:lnTo>
                    <a:lnTo>
                      <a:pt x="1352" y="237"/>
                    </a:lnTo>
                    <a:lnTo>
                      <a:pt x="1368" y="256"/>
                    </a:lnTo>
                    <a:lnTo>
                      <a:pt x="1381" y="231"/>
                    </a:lnTo>
                    <a:lnTo>
                      <a:pt x="1396" y="221"/>
                    </a:lnTo>
                    <a:lnTo>
                      <a:pt x="1410" y="267"/>
                    </a:lnTo>
                    <a:lnTo>
                      <a:pt x="1425" y="206"/>
                    </a:lnTo>
                    <a:lnTo>
                      <a:pt x="1439" y="225"/>
                    </a:lnTo>
                    <a:lnTo>
                      <a:pt x="1454" y="246"/>
                    </a:lnTo>
                    <a:lnTo>
                      <a:pt x="1467" y="269"/>
                    </a:lnTo>
                    <a:lnTo>
                      <a:pt x="1483" y="269"/>
                    </a:lnTo>
                    <a:lnTo>
                      <a:pt x="1496" y="269"/>
                    </a:lnTo>
                    <a:lnTo>
                      <a:pt x="1512" y="264"/>
                    </a:lnTo>
                    <a:lnTo>
                      <a:pt x="1525" y="267"/>
                    </a:lnTo>
                    <a:lnTo>
                      <a:pt x="1540" y="269"/>
                    </a:lnTo>
                    <a:lnTo>
                      <a:pt x="1554" y="269"/>
                    </a:lnTo>
                    <a:lnTo>
                      <a:pt x="1569" y="266"/>
                    </a:lnTo>
                    <a:lnTo>
                      <a:pt x="1583" y="269"/>
                    </a:lnTo>
                    <a:lnTo>
                      <a:pt x="1598" y="252"/>
                    </a:lnTo>
                    <a:lnTo>
                      <a:pt x="1611" y="264"/>
                    </a:lnTo>
                    <a:lnTo>
                      <a:pt x="1627" y="231"/>
                    </a:lnTo>
                    <a:lnTo>
                      <a:pt x="1640" y="229"/>
                    </a:lnTo>
                    <a:lnTo>
                      <a:pt x="1656" y="262"/>
                    </a:lnTo>
                    <a:lnTo>
                      <a:pt x="1669" y="206"/>
                    </a:lnTo>
                    <a:lnTo>
                      <a:pt x="1684" y="250"/>
                    </a:lnTo>
                    <a:lnTo>
                      <a:pt x="1698" y="267"/>
                    </a:lnTo>
                    <a:lnTo>
                      <a:pt x="1713" y="250"/>
                    </a:lnTo>
                    <a:lnTo>
                      <a:pt x="1727" y="269"/>
                    </a:lnTo>
                    <a:lnTo>
                      <a:pt x="1742" y="269"/>
                    </a:lnTo>
                    <a:lnTo>
                      <a:pt x="1755" y="269"/>
                    </a:lnTo>
                    <a:lnTo>
                      <a:pt x="1771" y="269"/>
                    </a:lnTo>
                    <a:lnTo>
                      <a:pt x="1784" y="269"/>
                    </a:lnTo>
                    <a:lnTo>
                      <a:pt x="1800" y="254"/>
                    </a:lnTo>
                    <a:lnTo>
                      <a:pt x="1813" y="269"/>
                    </a:lnTo>
                    <a:lnTo>
                      <a:pt x="1828" y="269"/>
                    </a:lnTo>
                    <a:lnTo>
                      <a:pt x="1842" y="262"/>
                    </a:lnTo>
                    <a:lnTo>
                      <a:pt x="1857" y="269"/>
                    </a:lnTo>
                    <a:lnTo>
                      <a:pt x="1871" y="223"/>
                    </a:lnTo>
                    <a:lnTo>
                      <a:pt x="1886" y="229"/>
                    </a:lnTo>
                    <a:lnTo>
                      <a:pt x="1900" y="269"/>
                    </a:lnTo>
                    <a:lnTo>
                      <a:pt x="1915" y="246"/>
                    </a:lnTo>
                    <a:lnTo>
                      <a:pt x="1928" y="194"/>
                    </a:lnTo>
                    <a:lnTo>
                      <a:pt x="1944" y="266"/>
                    </a:lnTo>
                    <a:lnTo>
                      <a:pt x="1957" y="216"/>
                    </a:lnTo>
                    <a:lnTo>
                      <a:pt x="1972" y="262"/>
                    </a:lnTo>
                    <a:lnTo>
                      <a:pt x="1986" y="269"/>
                    </a:lnTo>
                    <a:lnTo>
                      <a:pt x="2001" y="200"/>
                    </a:lnTo>
                    <a:lnTo>
                      <a:pt x="2015" y="227"/>
                    </a:lnTo>
                    <a:lnTo>
                      <a:pt x="2030" y="266"/>
                    </a:lnTo>
                    <a:lnTo>
                      <a:pt x="2044" y="146"/>
                    </a:lnTo>
                    <a:lnTo>
                      <a:pt x="2059" y="158"/>
                    </a:lnTo>
                    <a:lnTo>
                      <a:pt x="2072" y="144"/>
                    </a:lnTo>
                    <a:lnTo>
                      <a:pt x="2088" y="227"/>
                    </a:lnTo>
                    <a:lnTo>
                      <a:pt x="2101" y="121"/>
                    </a:lnTo>
                    <a:lnTo>
                      <a:pt x="2115" y="183"/>
                    </a:lnTo>
                    <a:lnTo>
                      <a:pt x="2130" y="210"/>
                    </a:lnTo>
                    <a:lnTo>
                      <a:pt x="2143" y="133"/>
                    </a:lnTo>
                    <a:lnTo>
                      <a:pt x="2159" y="183"/>
                    </a:lnTo>
                    <a:lnTo>
                      <a:pt x="2172" y="183"/>
                    </a:lnTo>
                    <a:lnTo>
                      <a:pt x="2188" y="183"/>
                    </a:lnTo>
                    <a:lnTo>
                      <a:pt x="2201" y="181"/>
                    </a:lnTo>
                    <a:lnTo>
                      <a:pt x="2216" y="94"/>
                    </a:lnTo>
                    <a:lnTo>
                      <a:pt x="2230" y="137"/>
                    </a:lnTo>
                    <a:lnTo>
                      <a:pt x="2245" y="256"/>
                    </a:lnTo>
                    <a:lnTo>
                      <a:pt x="2259" y="200"/>
                    </a:lnTo>
                    <a:lnTo>
                      <a:pt x="2274" y="96"/>
                    </a:lnTo>
                    <a:lnTo>
                      <a:pt x="2287" y="217"/>
                    </a:lnTo>
                    <a:lnTo>
                      <a:pt x="2303" y="269"/>
                    </a:lnTo>
                    <a:lnTo>
                      <a:pt x="2316" y="262"/>
                    </a:lnTo>
                    <a:lnTo>
                      <a:pt x="2332" y="267"/>
                    </a:lnTo>
                    <a:lnTo>
                      <a:pt x="2345" y="223"/>
                    </a:lnTo>
                    <a:lnTo>
                      <a:pt x="2360" y="200"/>
                    </a:lnTo>
                    <a:lnTo>
                      <a:pt x="2374" y="229"/>
                    </a:lnTo>
                    <a:lnTo>
                      <a:pt x="2389" y="269"/>
                    </a:lnTo>
                    <a:lnTo>
                      <a:pt x="2403" y="219"/>
                    </a:lnTo>
                    <a:lnTo>
                      <a:pt x="2418" y="241"/>
                    </a:lnTo>
                    <a:lnTo>
                      <a:pt x="2431" y="166"/>
                    </a:lnTo>
                    <a:lnTo>
                      <a:pt x="2447" y="242"/>
                    </a:lnTo>
                    <a:lnTo>
                      <a:pt x="2460" y="127"/>
                    </a:lnTo>
                    <a:lnTo>
                      <a:pt x="2476" y="148"/>
                    </a:lnTo>
                    <a:lnTo>
                      <a:pt x="2489" y="194"/>
                    </a:lnTo>
                    <a:lnTo>
                      <a:pt x="2504" y="148"/>
                    </a:lnTo>
                    <a:lnTo>
                      <a:pt x="2518" y="239"/>
                    </a:lnTo>
                    <a:lnTo>
                      <a:pt x="2533" y="258"/>
                    </a:lnTo>
                    <a:lnTo>
                      <a:pt x="2547" y="196"/>
                    </a:lnTo>
                    <a:lnTo>
                      <a:pt x="2562" y="269"/>
                    </a:lnTo>
                    <a:lnTo>
                      <a:pt x="2575" y="262"/>
                    </a:lnTo>
                    <a:lnTo>
                      <a:pt x="2591" y="269"/>
                    </a:lnTo>
                    <a:lnTo>
                      <a:pt x="2604" y="269"/>
                    </a:lnTo>
                    <a:lnTo>
                      <a:pt x="2620" y="254"/>
                    </a:lnTo>
                    <a:lnTo>
                      <a:pt x="2633" y="267"/>
                    </a:lnTo>
                    <a:lnTo>
                      <a:pt x="2648" y="254"/>
                    </a:lnTo>
                    <a:lnTo>
                      <a:pt x="2662" y="239"/>
                    </a:lnTo>
                    <a:lnTo>
                      <a:pt x="2677" y="267"/>
                    </a:lnTo>
                    <a:lnTo>
                      <a:pt x="2691" y="269"/>
                    </a:lnTo>
                    <a:lnTo>
                      <a:pt x="2706" y="269"/>
                    </a:lnTo>
                    <a:lnTo>
                      <a:pt x="2719" y="185"/>
                    </a:lnTo>
                    <a:lnTo>
                      <a:pt x="2735" y="227"/>
                    </a:lnTo>
                    <a:lnTo>
                      <a:pt x="2748" y="256"/>
                    </a:lnTo>
                    <a:lnTo>
                      <a:pt x="2764" y="269"/>
                    </a:lnTo>
                    <a:lnTo>
                      <a:pt x="2777" y="221"/>
                    </a:lnTo>
                    <a:lnTo>
                      <a:pt x="2792" y="267"/>
                    </a:lnTo>
                    <a:lnTo>
                      <a:pt x="2806" y="260"/>
                    </a:lnTo>
                    <a:lnTo>
                      <a:pt x="2821" y="227"/>
                    </a:lnTo>
                    <a:lnTo>
                      <a:pt x="2835" y="266"/>
                    </a:lnTo>
                    <a:lnTo>
                      <a:pt x="2850" y="244"/>
                    </a:lnTo>
                    <a:lnTo>
                      <a:pt x="2863" y="266"/>
                    </a:lnTo>
                    <a:lnTo>
                      <a:pt x="2879" y="204"/>
                    </a:lnTo>
                    <a:lnTo>
                      <a:pt x="2892" y="235"/>
                    </a:lnTo>
                    <a:lnTo>
                      <a:pt x="2906" y="258"/>
                    </a:lnTo>
                    <a:lnTo>
                      <a:pt x="2921" y="173"/>
                    </a:lnTo>
                    <a:lnTo>
                      <a:pt x="2934" y="208"/>
                    </a:lnTo>
                    <a:lnTo>
                      <a:pt x="2950" y="223"/>
                    </a:lnTo>
                    <a:lnTo>
                      <a:pt x="2963" y="269"/>
                    </a:lnTo>
                    <a:lnTo>
                      <a:pt x="2979" y="264"/>
                    </a:lnTo>
                    <a:lnTo>
                      <a:pt x="2992" y="262"/>
                    </a:lnTo>
                    <a:lnTo>
                      <a:pt x="3007" y="269"/>
                    </a:lnTo>
                    <a:lnTo>
                      <a:pt x="3021" y="269"/>
                    </a:lnTo>
                    <a:lnTo>
                      <a:pt x="3036" y="269"/>
                    </a:lnTo>
                    <a:lnTo>
                      <a:pt x="3050" y="269"/>
                    </a:lnTo>
                    <a:lnTo>
                      <a:pt x="3065" y="108"/>
                    </a:lnTo>
                    <a:lnTo>
                      <a:pt x="3078" y="102"/>
                    </a:lnTo>
                    <a:lnTo>
                      <a:pt x="3094" y="91"/>
                    </a:lnTo>
                    <a:lnTo>
                      <a:pt x="3107" y="200"/>
                    </a:lnTo>
                    <a:lnTo>
                      <a:pt x="3123" y="206"/>
                    </a:lnTo>
                    <a:lnTo>
                      <a:pt x="3136" y="81"/>
                    </a:lnTo>
                    <a:lnTo>
                      <a:pt x="3151" y="204"/>
                    </a:lnTo>
                    <a:lnTo>
                      <a:pt x="3165" y="110"/>
                    </a:lnTo>
                    <a:lnTo>
                      <a:pt x="3180" y="119"/>
                    </a:lnTo>
                    <a:lnTo>
                      <a:pt x="3194" y="192"/>
                    </a:lnTo>
                    <a:lnTo>
                      <a:pt x="3209" y="10"/>
                    </a:lnTo>
                    <a:lnTo>
                      <a:pt x="3222" y="225"/>
                    </a:lnTo>
                    <a:lnTo>
                      <a:pt x="3238" y="219"/>
                    </a:lnTo>
                    <a:lnTo>
                      <a:pt x="3251" y="264"/>
                    </a:lnTo>
                    <a:lnTo>
                      <a:pt x="3267" y="96"/>
                    </a:lnTo>
                    <a:lnTo>
                      <a:pt x="3280" y="116"/>
                    </a:lnTo>
                    <a:lnTo>
                      <a:pt x="3295" y="50"/>
                    </a:lnTo>
                    <a:lnTo>
                      <a:pt x="3309" y="89"/>
                    </a:lnTo>
                    <a:lnTo>
                      <a:pt x="3324" y="116"/>
                    </a:lnTo>
                    <a:lnTo>
                      <a:pt x="3338" y="89"/>
                    </a:lnTo>
                    <a:lnTo>
                      <a:pt x="3353" y="108"/>
                    </a:lnTo>
                    <a:lnTo>
                      <a:pt x="3366" y="46"/>
                    </a:lnTo>
                    <a:lnTo>
                      <a:pt x="3382" y="118"/>
                    </a:lnTo>
                    <a:lnTo>
                      <a:pt x="3395" y="56"/>
                    </a:lnTo>
                    <a:lnTo>
                      <a:pt x="3411" y="141"/>
                    </a:lnTo>
                    <a:lnTo>
                      <a:pt x="3424" y="204"/>
                    </a:lnTo>
                    <a:lnTo>
                      <a:pt x="3439" y="237"/>
                    </a:lnTo>
                    <a:lnTo>
                      <a:pt x="3453" y="68"/>
                    </a:lnTo>
                    <a:lnTo>
                      <a:pt x="3468" y="31"/>
                    </a:lnTo>
                    <a:lnTo>
                      <a:pt x="3482" y="77"/>
                    </a:lnTo>
                    <a:lnTo>
                      <a:pt x="3497" y="91"/>
                    </a:lnTo>
                    <a:lnTo>
                      <a:pt x="3510" y="114"/>
                    </a:lnTo>
                    <a:lnTo>
                      <a:pt x="3526" y="146"/>
                    </a:lnTo>
                    <a:lnTo>
                      <a:pt x="3539" y="29"/>
                    </a:lnTo>
                    <a:lnTo>
                      <a:pt x="3555" y="43"/>
                    </a:lnTo>
                    <a:lnTo>
                      <a:pt x="3568" y="54"/>
                    </a:lnTo>
                    <a:lnTo>
                      <a:pt x="3583" y="156"/>
                    </a:lnTo>
                    <a:lnTo>
                      <a:pt x="3597" y="98"/>
                    </a:lnTo>
                    <a:lnTo>
                      <a:pt x="3612" y="85"/>
                    </a:lnTo>
                    <a:lnTo>
                      <a:pt x="3626" y="4"/>
                    </a:lnTo>
                    <a:lnTo>
                      <a:pt x="3641" y="96"/>
                    </a:lnTo>
                    <a:lnTo>
                      <a:pt x="3655" y="121"/>
                    </a:lnTo>
                    <a:lnTo>
                      <a:pt x="3670" y="119"/>
                    </a:lnTo>
                    <a:lnTo>
                      <a:pt x="3683" y="18"/>
                    </a:lnTo>
                    <a:lnTo>
                      <a:pt x="3699" y="139"/>
                    </a:lnTo>
                    <a:lnTo>
                      <a:pt x="3712" y="98"/>
                    </a:lnTo>
                    <a:lnTo>
                      <a:pt x="3726" y="68"/>
                    </a:lnTo>
                    <a:lnTo>
                      <a:pt x="3741" y="135"/>
                    </a:lnTo>
                    <a:lnTo>
                      <a:pt x="3754" y="16"/>
                    </a:lnTo>
                    <a:lnTo>
                      <a:pt x="3770" y="71"/>
                    </a:lnTo>
                    <a:lnTo>
                      <a:pt x="3783" y="96"/>
                    </a:lnTo>
                    <a:lnTo>
                      <a:pt x="3799" y="71"/>
                    </a:lnTo>
                    <a:lnTo>
                      <a:pt x="3812" y="58"/>
                    </a:lnTo>
                    <a:lnTo>
                      <a:pt x="3827" y="121"/>
                    </a:lnTo>
                    <a:lnTo>
                      <a:pt x="3841" y="75"/>
                    </a:lnTo>
                    <a:lnTo>
                      <a:pt x="3856" y="96"/>
                    </a:lnTo>
                    <a:lnTo>
                      <a:pt x="3870" y="108"/>
                    </a:lnTo>
                    <a:lnTo>
                      <a:pt x="3885" y="71"/>
                    </a:lnTo>
                    <a:lnTo>
                      <a:pt x="3898" y="58"/>
                    </a:lnTo>
                    <a:lnTo>
                      <a:pt x="3914" y="8"/>
                    </a:lnTo>
                    <a:lnTo>
                      <a:pt x="3927" y="94"/>
                    </a:lnTo>
                    <a:lnTo>
                      <a:pt x="3943" y="58"/>
                    </a:lnTo>
                    <a:lnTo>
                      <a:pt x="3956" y="56"/>
                    </a:lnTo>
                    <a:lnTo>
                      <a:pt x="3971" y="93"/>
                    </a:lnTo>
                    <a:lnTo>
                      <a:pt x="3985" y="89"/>
                    </a:lnTo>
                    <a:lnTo>
                      <a:pt x="4000" y="41"/>
                    </a:lnTo>
                    <a:lnTo>
                      <a:pt x="4014" y="66"/>
                    </a:lnTo>
                    <a:lnTo>
                      <a:pt x="4029" y="94"/>
                    </a:lnTo>
                    <a:lnTo>
                      <a:pt x="4042" y="27"/>
                    </a:lnTo>
                    <a:lnTo>
                      <a:pt x="4058" y="45"/>
                    </a:lnTo>
                    <a:lnTo>
                      <a:pt x="4071" y="77"/>
                    </a:lnTo>
                    <a:lnTo>
                      <a:pt x="4087" y="212"/>
                    </a:lnTo>
                    <a:lnTo>
                      <a:pt x="4100" y="93"/>
                    </a:lnTo>
                    <a:lnTo>
                      <a:pt x="4115" y="29"/>
                    </a:lnTo>
                    <a:lnTo>
                      <a:pt x="4129" y="89"/>
                    </a:lnTo>
                    <a:lnTo>
                      <a:pt x="4144" y="10"/>
                    </a:lnTo>
                    <a:lnTo>
                      <a:pt x="4158" y="94"/>
                    </a:lnTo>
                    <a:lnTo>
                      <a:pt x="4173" y="108"/>
                    </a:lnTo>
                    <a:lnTo>
                      <a:pt x="4186" y="123"/>
                    </a:lnTo>
                    <a:lnTo>
                      <a:pt x="4202" y="37"/>
                    </a:lnTo>
                    <a:lnTo>
                      <a:pt x="4215" y="106"/>
                    </a:lnTo>
                    <a:lnTo>
                      <a:pt x="4231" y="137"/>
                    </a:lnTo>
                    <a:lnTo>
                      <a:pt x="4244" y="116"/>
                    </a:lnTo>
                    <a:lnTo>
                      <a:pt x="4259" y="48"/>
                    </a:lnTo>
                    <a:lnTo>
                      <a:pt x="4273" y="54"/>
                    </a:lnTo>
                    <a:lnTo>
                      <a:pt x="4288" y="127"/>
                    </a:lnTo>
                    <a:lnTo>
                      <a:pt x="4302" y="43"/>
                    </a:lnTo>
                    <a:lnTo>
                      <a:pt x="4317" y="83"/>
                    </a:lnTo>
                    <a:lnTo>
                      <a:pt x="4330" y="64"/>
                    </a:lnTo>
                    <a:lnTo>
                      <a:pt x="4346" y="121"/>
                    </a:lnTo>
                    <a:lnTo>
                      <a:pt x="4359" y="39"/>
                    </a:lnTo>
                    <a:lnTo>
                      <a:pt x="4375" y="106"/>
                    </a:lnTo>
                    <a:lnTo>
                      <a:pt x="4388" y="73"/>
                    </a:lnTo>
                    <a:lnTo>
                      <a:pt x="4403" y="98"/>
                    </a:lnTo>
                    <a:lnTo>
                      <a:pt x="4417" y="114"/>
                    </a:lnTo>
                    <a:lnTo>
                      <a:pt x="4432" y="96"/>
                    </a:lnTo>
                    <a:lnTo>
                      <a:pt x="4446" y="20"/>
                    </a:lnTo>
                    <a:lnTo>
                      <a:pt x="4461" y="70"/>
                    </a:lnTo>
                    <a:lnTo>
                      <a:pt x="4474" y="60"/>
                    </a:lnTo>
                    <a:lnTo>
                      <a:pt x="4490" y="79"/>
                    </a:lnTo>
                    <a:lnTo>
                      <a:pt x="4503" y="54"/>
                    </a:lnTo>
                    <a:lnTo>
                      <a:pt x="4519" y="87"/>
                    </a:lnTo>
                    <a:lnTo>
                      <a:pt x="4532" y="96"/>
                    </a:lnTo>
                    <a:lnTo>
                      <a:pt x="4545" y="0"/>
                    </a:lnTo>
                    <a:lnTo>
                      <a:pt x="4561" y="45"/>
                    </a:lnTo>
                    <a:lnTo>
                      <a:pt x="4574" y="106"/>
                    </a:lnTo>
                    <a:lnTo>
                      <a:pt x="4590" y="2"/>
                    </a:lnTo>
                    <a:lnTo>
                      <a:pt x="4603" y="85"/>
                    </a:lnTo>
                    <a:lnTo>
                      <a:pt x="4618" y="2"/>
                    </a:lnTo>
                    <a:lnTo>
                      <a:pt x="4632" y="37"/>
                    </a:lnTo>
                    <a:lnTo>
                      <a:pt x="4647" y="102"/>
                    </a:lnTo>
                    <a:lnTo>
                      <a:pt x="4661" y="89"/>
                    </a:lnTo>
                    <a:lnTo>
                      <a:pt x="4676" y="73"/>
                    </a:lnTo>
                    <a:lnTo>
                      <a:pt x="4689" y="118"/>
                    </a:lnTo>
                    <a:lnTo>
                      <a:pt x="4705" y="89"/>
                    </a:lnTo>
                    <a:lnTo>
                      <a:pt x="4718" y="214"/>
                    </a:lnTo>
                    <a:lnTo>
                      <a:pt x="4734" y="208"/>
                    </a:lnTo>
                    <a:lnTo>
                      <a:pt x="4747" y="137"/>
                    </a:lnTo>
                    <a:lnTo>
                      <a:pt x="4762" y="70"/>
                    </a:lnTo>
                    <a:lnTo>
                      <a:pt x="4776" y="58"/>
                    </a:lnTo>
                    <a:lnTo>
                      <a:pt x="4791" y="79"/>
                    </a:lnTo>
                    <a:lnTo>
                      <a:pt x="4805" y="68"/>
                    </a:lnTo>
                    <a:lnTo>
                      <a:pt x="4820" y="68"/>
                    </a:lnTo>
                    <a:lnTo>
                      <a:pt x="4833" y="58"/>
                    </a:lnTo>
                    <a:lnTo>
                      <a:pt x="4849" y="68"/>
                    </a:lnTo>
                    <a:lnTo>
                      <a:pt x="4862" y="114"/>
                    </a:lnTo>
                    <a:lnTo>
                      <a:pt x="4878" y="58"/>
                    </a:lnTo>
                    <a:lnTo>
                      <a:pt x="4891" y="89"/>
                    </a:lnTo>
                    <a:lnTo>
                      <a:pt x="4906" y="52"/>
                    </a:lnTo>
                    <a:lnTo>
                      <a:pt x="4920" y="79"/>
                    </a:lnTo>
                    <a:lnTo>
                      <a:pt x="4935" y="73"/>
                    </a:lnTo>
                    <a:lnTo>
                      <a:pt x="4949" y="94"/>
                    </a:lnTo>
                    <a:lnTo>
                      <a:pt x="4964" y="168"/>
                    </a:lnTo>
                    <a:lnTo>
                      <a:pt x="4977" y="45"/>
                    </a:lnTo>
                    <a:lnTo>
                      <a:pt x="4993" y="77"/>
                    </a:lnTo>
                    <a:lnTo>
                      <a:pt x="5006" y="106"/>
                    </a:lnTo>
                    <a:lnTo>
                      <a:pt x="5022" y="98"/>
                    </a:lnTo>
                    <a:lnTo>
                      <a:pt x="5035" y="106"/>
                    </a:lnTo>
                    <a:lnTo>
                      <a:pt x="5050" y="114"/>
                    </a:lnTo>
                    <a:lnTo>
                      <a:pt x="5064" y="43"/>
                    </a:lnTo>
                    <a:lnTo>
                      <a:pt x="5079" y="164"/>
                    </a:lnTo>
                    <a:lnTo>
                      <a:pt x="5093" y="133"/>
                    </a:lnTo>
                    <a:lnTo>
                      <a:pt x="5108" y="66"/>
                    </a:lnTo>
                    <a:lnTo>
                      <a:pt x="5121" y="118"/>
                    </a:lnTo>
                    <a:lnTo>
                      <a:pt x="5137" y="54"/>
                    </a:lnTo>
                    <a:lnTo>
                      <a:pt x="5150" y="100"/>
                    </a:lnTo>
                    <a:lnTo>
                      <a:pt x="5166" y="89"/>
                    </a:lnTo>
                    <a:lnTo>
                      <a:pt x="5179" y="41"/>
                    </a:lnTo>
                    <a:lnTo>
                      <a:pt x="5194" y="70"/>
                    </a:lnTo>
                    <a:lnTo>
                      <a:pt x="5208" y="37"/>
                    </a:lnTo>
                    <a:lnTo>
                      <a:pt x="5223" y="160"/>
                    </a:lnTo>
                    <a:lnTo>
                      <a:pt x="5237" y="150"/>
                    </a:lnTo>
                    <a:lnTo>
                      <a:pt x="5252" y="206"/>
                    </a:lnTo>
                    <a:lnTo>
                      <a:pt x="5265" y="125"/>
                    </a:lnTo>
                    <a:lnTo>
                      <a:pt x="5281" y="177"/>
                    </a:lnTo>
                    <a:lnTo>
                      <a:pt x="5294" y="256"/>
                    </a:lnTo>
                    <a:lnTo>
                      <a:pt x="5310" y="108"/>
                    </a:lnTo>
                    <a:lnTo>
                      <a:pt x="5323" y="143"/>
                    </a:lnTo>
                    <a:lnTo>
                      <a:pt x="5337" y="23"/>
                    </a:lnTo>
                    <a:lnTo>
                      <a:pt x="5352" y="87"/>
                    </a:lnTo>
                    <a:lnTo>
                      <a:pt x="5365" y="81"/>
                    </a:lnTo>
                    <a:lnTo>
                      <a:pt x="5381" y="14"/>
                    </a:lnTo>
                    <a:lnTo>
                      <a:pt x="5394" y="85"/>
                    </a:lnTo>
                    <a:lnTo>
                      <a:pt x="5410" y="144"/>
                    </a:lnTo>
                    <a:lnTo>
                      <a:pt x="5410" y="269"/>
                    </a:lnTo>
                    <a:lnTo>
                      <a:pt x="5394" y="269"/>
                    </a:lnTo>
                    <a:lnTo>
                      <a:pt x="5381" y="269"/>
                    </a:lnTo>
                    <a:lnTo>
                      <a:pt x="5365" y="269"/>
                    </a:lnTo>
                    <a:lnTo>
                      <a:pt x="5352" y="269"/>
                    </a:lnTo>
                    <a:lnTo>
                      <a:pt x="5337" y="269"/>
                    </a:lnTo>
                    <a:lnTo>
                      <a:pt x="5323" y="269"/>
                    </a:lnTo>
                    <a:lnTo>
                      <a:pt x="5310" y="269"/>
                    </a:lnTo>
                    <a:lnTo>
                      <a:pt x="5294" y="269"/>
                    </a:lnTo>
                    <a:lnTo>
                      <a:pt x="5281" y="269"/>
                    </a:lnTo>
                    <a:lnTo>
                      <a:pt x="5265" y="269"/>
                    </a:lnTo>
                    <a:lnTo>
                      <a:pt x="5252" y="269"/>
                    </a:lnTo>
                    <a:lnTo>
                      <a:pt x="5237" y="269"/>
                    </a:lnTo>
                    <a:lnTo>
                      <a:pt x="5223" y="269"/>
                    </a:lnTo>
                    <a:lnTo>
                      <a:pt x="5208" y="269"/>
                    </a:lnTo>
                    <a:lnTo>
                      <a:pt x="5194" y="269"/>
                    </a:lnTo>
                    <a:lnTo>
                      <a:pt x="5179" y="269"/>
                    </a:lnTo>
                    <a:lnTo>
                      <a:pt x="5166" y="269"/>
                    </a:lnTo>
                    <a:lnTo>
                      <a:pt x="5150" y="269"/>
                    </a:lnTo>
                    <a:lnTo>
                      <a:pt x="5137" y="269"/>
                    </a:lnTo>
                    <a:lnTo>
                      <a:pt x="5121" y="269"/>
                    </a:lnTo>
                    <a:lnTo>
                      <a:pt x="5108" y="269"/>
                    </a:lnTo>
                    <a:lnTo>
                      <a:pt x="5093" y="269"/>
                    </a:lnTo>
                    <a:lnTo>
                      <a:pt x="5079" y="269"/>
                    </a:lnTo>
                    <a:lnTo>
                      <a:pt x="5064" y="269"/>
                    </a:lnTo>
                    <a:lnTo>
                      <a:pt x="5050" y="269"/>
                    </a:lnTo>
                    <a:lnTo>
                      <a:pt x="5035" y="269"/>
                    </a:lnTo>
                    <a:lnTo>
                      <a:pt x="5022" y="269"/>
                    </a:lnTo>
                    <a:lnTo>
                      <a:pt x="5006" y="269"/>
                    </a:lnTo>
                    <a:lnTo>
                      <a:pt x="4993" y="269"/>
                    </a:lnTo>
                    <a:lnTo>
                      <a:pt x="4977" y="269"/>
                    </a:lnTo>
                    <a:lnTo>
                      <a:pt x="4964" y="269"/>
                    </a:lnTo>
                    <a:lnTo>
                      <a:pt x="4949" y="269"/>
                    </a:lnTo>
                    <a:lnTo>
                      <a:pt x="4935" y="269"/>
                    </a:lnTo>
                    <a:lnTo>
                      <a:pt x="4920" y="269"/>
                    </a:lnTo>
                    <a:lnTo>
                      <a:pt x="4906" y="269"/>
                    </a:lnTo>
                    <a:lnTo>
                      <a:pt x="4891" y="269"/>
                    </a:lnTo>
                    <a:lnTo>
                      <a:pt x="4878" y="269"/>
                    </a:lnTo>
                    <a:lnTo>
                      <a:pt x="4862" y="269"/>
                    </a:lnTo>
                    <a:lnTo>
                      <a:pt x="4849" y="269"/>
                    </a:lnTo>
                    <a:lnTo>
                      <a:pt x="4833" y="269"/>
                    </a:lnTo>
                    <a:lnTo>
                      <a:pt x="4820" y="269"/>
                    </a:lnTo>
                    <a:lnTo>
                      <a:pt x="4805" y="269"/>
                    </a:lnTo>
                    <a:lnTo>
                      <a:pt x="4791" y="269"/>
                    </a:lnTo>
                    <a:lnTo>
                      <a:pt x="4776" y="269"/>
                    </a:lnTo>
                    <a:lnTo>
                      <a:pt x="4762" y="269"/>
                    </a:lnTo>
                    <a:lnTo>
                      <a:pt x="4747" y="269"/>
                    </a:lnTo>
                    <a:lnTo>
                      <a:pt x="4734" y="269"/>
                    </a:lnTo>
                    <a:lnTo>
                      <a:pt x="4718" y="269"/>
                    </a:lnTo>
                    <a:lnTo>
                      <a:pt x="4705" y="269"/>
                    </a:lnTo>
                    <a:lnTo>
                      <a:pt x="4689" y="269"/>
                    </a:lnTo>
                    <a:lnTo>
                      <a:pt x="4676" y="269"/>
                    </a:lnTo>
                    <a:lnTo>
                      <a:pt x="4661" y="269"/>
                    </a:lnTo>
                    <a:lnTo>
                      <a:pt x="4647" y="269"/>
                    </a:lnTo>
                    <a:lnTo>
                      <a:pt x="4632" y="269"/>
                    </a:lnTo>
                    <a:lnTo>
                      <a:pt x="4618" y="269"/>
                    </a:lnTo>
                    <a:lnTo>
                      <a:pt x="4603" y="269"/>
                    </a:lnTo>
                    <a:lnTo>
                      <a:pt x="4590" y="269"/>
                    </a:lnTo>
                    <a:lnTo>
                      <a:pt x="4574" y="269"/>
                    </a:lnTo>
                    <a:lnTo>
                      <a:pt x="4561" y="269"/>
                    </a:lnTo>
                    <a:lnTo>
                      <a:pt x="4545" y="269"/>
                    </a:lnTo>
                    <a:lnTo>
                      <a:pt x="4532" y="269"/>
                    </a:lnTo>
                    <a:lnTo>
                      <a:pt x="4519" y="269"/>
                    </a:lnTo>
                    <a:lnTo>
                      <a:pt x="4503" y="269"/>
                    </a:lnTo>
                    <a:lnTo>
                      <a:pt x="4490" y="269"/>
                    </a:lnTo>
                    <a:lnTo>
                      <a:pt x="4474" y="269"/>
                    </a:lnTo>
                    <a:lnTo>
                      <a:pt x="4461" y="269"/>
                    </a:lnTo>
                    <a:lnTo>
                      <a:pt x="4446" y="269"/>
                    </a:lnTo>
                    <a:lnTo>
                      <a:pt x="4432" y="269"/>
                    </a:lnTo>
                    <a:lnTo>
                      <a:pt x="4417" y="269"/>
                    </a:lnTo>
                    <a:lnTo>
                      <a:pt x="4403" y="269"/>
                    </a:lnTo>
                    <a:lnTo>
                      <a:pt x="4388" y="269"/>
                    </a:lnTo>
                    <a:lnTo>
                      <a:pt x="4375" y="269"/>
                    </a:lnTo>
                    <a:lnTo>
                      <a:pt x="4359" y="269"/>
                    </a:lnTo>
                    <a:lnTo>
                      <a:pt x="4346" y="269"/>
                    </a:lnTo>
                    <a:lnTo>
                      <a:pt x="4330" y="269"/>
                    </a:lnTo>
                    <a:lnTo>
                      <a:pt x="4317" y="269"/>
                    </a:lnTo>
                    <a:lnTo>
                      <a:pt x="4302" y="269"/>
                    </a:lnTo>
                    <a:lnTo>
                      <a:pt x="4288" y="269"/>
                    </a:lnTo>
                    <a:lnTo>
                      <a:pt x="4273" y="269"/>
                    </a:lnTo>
                    <a:lnTo>
                      <a:pt x="4259" y="269"/>
                    </a:lnTo>
                    <a:lnTo>
                      <a:pt x="4244" y="269"/>
                    </a:lnTo>
                    <a:lnTo>
                      <a:pt x="4231" y="269"/>
                    </a:lnTo>
                    <a:lnTo>
                      <a:pt x="4215" y="269"/>
                    </a:lnTo>
                    <a:lnTo>
                      <a:pt x="4202" y="269"/>
                    </a:lnTo>
                    <a:lnTo>
                      <a:pt x="4186" y="269"/>
                    </a:lnTo>
                    <a:lnTo>
                      <a:pt x="4173" y="269"/>
                    </a:lnTo>
                    <a:lnTo>
                      <a:pt x="4158" y="269"/>
                    </a:lnTo>
                    <a:lnTo>
                      <a:pt x="4144" y="269"/>
                    </a:lnTo>
                    <a:lnTo>
                      <a:pt x="4129" y="269"/>
                    </a:lnTo>
                    <a:lnTo>
                      <a:pt x="4115" y="269"/>
                    </a:lnTo>
                    <a:lnTo>
                      <a:pt x="4100" y="269"/>
                    </a:lnTo>
                    <a:lnTo>
                      <a:pt x="4087" y="269"/>
                    </a:lnTo>
                    <a:lnTo>
                      <a:pt x="4071" y="269"/>
                    </a:lnTo>
                    <a:lnTo>
                      <a:pt x="4058" y="269"/>
                    </a:lnTo>
                    <a:lnTo>
                      <a:pt x="4042" y="269"/>
                    </a:lnTo>
                    <a:lnTo>
                      <a:pt x="4029" y="269"/>
                    </a:lnTo>
                    <a:lnTo>
                      <a:pt x="4014" y="269"/>
                    </a:lnTo>
                    <a:lnTo>
                      <a:pt x="4000" y="269"/>
                    </a:lnTo>
                    <a:lnTo>
                      <a:pt x="3985" y="269"/>
                    </a:lnTo>
                    <a:lnTo>
                      <a:pt x="3971" y="269"/>
                    </a:lnTo>
                    <a:lnTo>
                      <a:pt x="3956" y="269"/>
                    </a:lnTo>
                    <a:lnTo>
                      <a:pt x="3943" y="269"/>
                    </a:lnTo>
                    <a:lnTo>
                      <a:pt x="3927" y="269"/>
                    </a:lnTo>
                    <a:lnTo>
                      <a:pt x="3914" y="269"/>
                    </a:lnTo>
                    <a:lnTo>
                      <a:pt x="3898" y="269"/>
                    </a:lnTo>
                    <a:lnTo>
                      <a:pt x="3885" y="269"/>
                    </a:lnTo>
                    <a:lnTo>
                      <a:pt x="3870" y="269"/>
                    </a:lnTo>
                    <a:lnTo>
                      <a:pt x="3856" y="269"/>
                    </a:lnTo>
                    <a:lnTo>
                      <a:pt x="3841" y="269"/>
                    </a:lnTo>
                    <a:lnTo>
                      <a:pt x="3827" y="269"/>
                    </a:lnTo>
                    <a:lnTo>
                      <a:pt x="3812" y="269"/>
                    </a:lnTo>
                    <a:lnTo>
                      <a:pt x="3799" y="269"/>
                    </a:lnTo>
                    <a:lnTo>
                      <a:pt x="3783" y="269"/>
                    </a:lnTo>
                    <a:lnTo>
                      <a:pt x="3770" y="269"/>
                    </a:lnTo>
                    <a:lnTo>
                      <a:pt x="3754" y="269"/>
                    </a:lnTo>
                    <a:lnTo>
                      <a:pt x="3741" y="269"/>
                    </a:lnTo>
                    <a:lnTo>
                      <a:pt x="3726" y="269"/>
                    </a:lnTo>
                    <a:lnTo>
                      <a:pt x="3712" y="269"/>
                    </a:lnTo>
                    <a:lnTo>
                      <a:pt x="3699" y="269"/>
                    </a:lnTo>
                    <a:lnTo>
                      <a:pt x="3683" y="269"/>
                    </a:lnTo>
                    <a:lnTo>
                      <a:pt x="3670" y="269"/>
                    </a:lnTo>
                    <a:lnTo>
                      <a:pt x="3655" y="269"/>
                    </a:lnTo>
                    <a:lnTo>
                      <a:pt x="3641" y="269"/>
                    </a:lnTo>
                    <a:lnTo>
                      <a:pt x="3626" y="269"/>
                    </a:lnTo>
                    <a:lnTo>
                      <a:pt x="3612" y="269"/>
                    </a:lnTo>
                    <a:lnTo>
                      <a:pt x="3597" y="269"/>
                    </a:lnTo>
                    <a:lnTo>
                      <a:pt x="3583" y="269"/>
                    </a:lnTo>
                    <a:lnTo>
                      <a:pt x="3568" y="269"/>
                    </a:lnTo>
                    <a:lnTo>
                      <a:pt x="3555" y="269"/>
                    </a:lnTo>
                    <a:lnTo>
                      <a:pt x="3539" y="269"/>
                    </a:lnTo>
                    <a:lnTo>
                      <a:pt x="3526" y="269"/>
                    </a:lnTo>
                    <a:lnTo>
                      <a:pt x="3510" y="269"/>
                    </a:lnTo>
                    <a:lnTo>
                      <a:pt x="3497" y="269"/>
                    </a:lnTo>
                    <a:lnTo>
                      <a:pt x="3482" y="269"/>
                    </a:lnTo>
                    <a:lnTo>
                      <a:pt x="3468" y="269"/>
                    </a:lnTo>
                    <a:lnTo>
                      <a:pt x="3453" y="269"/>
                    </a:lnTo>
                    <a:lnTo>
                      <a:pt x="3439" y="269"/>
                    </a:lnTo>
                    <a:lnTo>
                      <a:pt x="3424" y="269"/>
                    </a:lnTo>
                    <a:lnTo>
                      <a:pt x="3411" y="269"/>
                    </a:lnTo>
                    <a:lnTo>
                      <a:pt x="3395" y="269"/>
                    </a:lnTo>
                    <a:lnTo>
                      <a:pt x="3382" y="269"/>
                    </a:lnTo>
                    <a:lnTo>
                      <a:pt x="3366" y="269"/>
                    </a:lnTo>
                    <a:lnTo>
                      <a:pt x="3353" y="269"/>
                    </a:lnTo>
                    <a:lnTo>
                      <a:pt x="3338" y="269"/>
                    </a:lnTo>
                    <a:lnTo>
                      <a:pt x="3324" y="269"/>
                    </a:lnTo>
                    <a:lnTo>
                      <a:pt x="3309" y="269"/>
                    </a:lnTo>
                    <a:lnTo>
                      <a:pt x="3295" y="269"/>
                    </a:lnTo>
                    <a:lnTo>
                      <a:pt x="3280" y="269"/>
                    </a:lnTo>
                    <a:lnTo>
                      <a:pt x="3267" y="269"/>
                    </a:lnTo>
                    <a:lnTo>
                      <a:pt x="3251" y="269"/>
                    </a:lnTo>
                    <a:lnTo>
                      <a:pt x="3238" y="269"/>
                    </a:lnTo>
                    <a:lnTo>
                      <a:pt x="3222" y="269"/>
                    </a:lnTo>
                    <a:lnTo>
                      <a:pt x="3209" y="269"/>
                    </a:lnTo>
                    <a:lnTo>
                      <a:pt x="3194" y="269"/>
                    </a:lnTo>
                    <a:lnTo>
                      <a:pt x="3180" y="269"/>
                    </a:lnTo>
                    <a:lnTo>
                      <a:pt x="3165" y="269"/>
                    </a:lnTo>
                    <a:lnTo>
                      <a:pt x="3151" y="269"/>
                    </a:lnTo>
                    <a:lnTo>
                      <a:pt x="3136" y="269"/>
                    </a:lnTo>
                    <a:lnTo>
                      <a:pt x="3123" y="269"/>
                    </a:lnTo>
                    <a:lnTo>
                      <a:pt x="3107" y="269"/>
                    </a:lnTo>
                    <a:lnTo>
                      <a:pt x="3094" y="269"/>
                    </a:lnTo>
                    <a:lnTo>
                      <a:pt x="3078" y="269"/>
                    </a:lnTo>
                    <a:lnTo>
                      <a:pt x="3065" y="269"/>
                    </a:lnTo>
                    <a:lnTo>
                      <a:pt x="3050" y="269"/>
                    </a:lnTo>
                    <a:lnTo>
                      <a:pt x="3036" y="269"/>
                    </a:lnTo>
                    <a:lnTo>
                      <a:pt x="3021" y="269"/>
                    </a:lnTo>
                    <a:lnTo>
                      <a:pt x="3007" y="269"/>
                    </a:lnTo>
                    <a:lnTo>
                      <a:pt x="2992" y="269"/>
                    </a:lnTo>
                    <a:lnTo>
                      <a:pt x="2979" y="269"/>
                    </a:lnTo>
                    <a:lnTo>
                      <a:pt x="2963" y="269"/>
                    </a:lnTo>
                    <a:lnTo>
                      <a:pt x="2950" y="269"/>
                    </a:lnTo>
                    <a:lnTo>
                      <a:pt x="2934" y="269"/>
                    </a:lnTo>
                    <a:lnTo>
                      <a:pt x="2921" y="269"/>
                    </a:lnTo>
                    <a:lnTo>
                      <a:pt x="2906" y="269"/>
                    </a:lnTo>
                    <a:lnTo>
                      <a:pt x="2892" y="269"/>
                    </a:lnTo>
                    <a:lnTo>
                      <a:pt x="2879" y="269"/>
                    </a:lnTo>
                    <a:lnTo>
                      <a:pt x="2863" y="269"/>
                    </a:lnTo>
                    <a:lnTo>
                      <a:pt x="2850" y="269"/>
                    </a:lnTo>
                    <a:lnTo>
                      <a:pt x="2835" y="269"/>
                    </a:lnTo>
                    <a:lnTo>
                      <a:pt x="2821" y="269"/>
                    </a:lnTo>
                    <a:lnTo>
                      <a:pt x="2806" y="269"/>
                    </a:lnTo>
                    <a:lnTo>
                      <a:pt x="2792" y="269"/>
                    </a:lnTo>
                    <a:lnTo>
                      <a:pt x="2777" y="269"/>
                    </a:lnTo>
                    <a:lnTo>
                      <a:pt x="2764" y="269"/>
                    </a:lnTo>
                    <a:lnTo>
                      <a:pt x="2748" y="269"/>
                    </a:lnTo>
                    <a:lnTo>
                      <a:pt x="2735" y="269"/>
                    </a:lnTo>
                    <a:lnTo>
                      <a:pt x="2719" y="269"/>
                    </a:lnTo>
                    <a:lnTo>
                      <a:pt x="2706" y="269"/>
                    </a:lnTo>
                    <a:lnTo>
                      <a:pt x="2691" y="269"/>
                    </a:lnTo>
                    <a:lnTo>
                      <a:pt x="2677" y="269"/>
                    </a:lnTo>
                    <a:lnTo>
                      <a:pt x="2662" y="269"/>
                    </a:lnTo>
                    <a:lnTo>
                      <a:pt x="2648" y="269"/>
                    </a:lnTo>
                    <a:lnTo>
                      <a:pt x="2633" y="269"/>
                    </a:lnTo>
                    <a:lnTo>
                      <a:pt x="2620" y="269"/>
                    </a:lnTo>
                    <a:lnTo>
                      <a:pt x="2604" y="269"/>
                    </a:lnTo>
                    <a:lnTo>
                      <a:pt x="2591" y="269"/>
                    </a:lnTo>
                    <a:lnTo>
                      <a:pt x="2575" y="269"/>
                    </a:lnTo>
                    <a:lnTo>
                      <a:pt x="2562" y="269"/>
                    </a:lnTo>
                    <a:lnTo>
                      <a:pt x="2547" y="269"/>
                    </a:lnTo>
                    <a:lnTo>
                      <a:pt x="2533" y="269"/>
                    </a:lnTo>
                    <a:lnTo>
                      <a:pt x="2518" y="269"/>
                    </a:lnTo>
                    <a:lnTo>
                      <a:pt x="2504" y="269"/>
                    </a:lnTo>
                    <a:lnTo>
                      <a:pt x="2489" y="269"/>
                    </a:lnTo>
                    <a:lnTo>
                      <a:pt x="2476" y="269"/>
                    </a:lnTo>
                    <a:lnTo>
                      <a:pt x="2460" y="269"/>
                    </a:lnTo>
                    <a:lnTo>
                      <a:pt x="2447" y="269"/>
                    </a:lnTo>
                    <a:lnTo>
                      <a:pt x="2431" y="269"/>
                    </a:lnTo>
                    <a:lnTo>
                      <a:pt x="2418" y="269"/>
                    </a:lnTo>
                    <a:lnTo>
                      <a:pt x="2403" y="269"/>
                    </a:lnTo>
                    <a:lnTo>
                      <a:pt x="2389" y="269"/>
                    </a:lnTo>
                    <a:lnTo>
                      <a:pt x="2374" y="269"/>
                    </a:lnTo>
                    <a:lnTo>
                      <a:pt x="2360" y="269"/>
                    </a:lnTo>
                    <a:lnTo>
                      <a:pt x="2345" y="269"/>
                    </a:lnTo>
                    <a:lnTo>
                      <a:pt x="2332" y="269"/>
                    </a:lnTo>
                    <a:lnTo>
                      <a:pt x="2316" y="269"/>
                    </a:lnTo>
                    <a:lnTo>
                      <a:pt x="2303" y="269"/>
                    </a:lnTo>
                    <a:lnTo>
                      <a:pt x="2287" y="269"/>
                    </a:lnTo>
                    <a:lnTo>
                      <a:pt x="2274" y="269"/>
                    </a:lnTo>
                    <a:lnTo>
                      <a:pt x="2259" y="269"/>
                    </a:lnTo>
                    <a:lnTo>
                      <a:pt x="2245" y="269"/>
                    </a:lnTo>
                    <a:lnTo>
                      <a:pt x="2230" y="269"/>
                    </a:lnTo>
                    <a:lnTo>
                      <a:pt x="2216" y="269"/>
                    </a:lnTo>
                    <a:lnTo>
                      <a:pt x="2201" y="269"/>
                    </a:lnTo>
                    <a:lnTo>
                      <a:pt x="2188" y="269"/>
                    </a:lnTo>
                    <a:lnTo>
                      <a:pt x="2172" y="269"/>
                    </a:lnTo>
                    <a:lnTo>
                      <a:pt x="2159" y="269"/>
                    </a:lnTo>
                    <a:lnTo>
                      <a:pt x="2143" y="269"/>
                    </a:lnTo>
                    <a:lnTo>
                      <a:pt x="2130" y="269"/>
                    </a:lnTo>
                    <a:lnTo>
                      <a:pt x="2115" y="269"/>
                    </a:lnTo>
                    <a:lnTo>
                      <a:pt x="2101" y="269"/>
                    </a:lnTo>
                    <a:lnTo>
                      <a:pt x="2088" y="269"/>
                    </a:lnTo>
                    <a:lnTo>
                      <a:pt x="2072" y="269"/>
                    </a:lnTo>
                    <a:lnTo>
                      <a:pt x="2059" y="269"/>
                    </a:lnTo>
                    <a:lnTo>
                      <a:pt x="2044" y="269"/>
                    </a:lnTo>
                    <a:lnTo>
                      <a:pt x="2030" y="269"/>
                    </a:lnTo>
                    <a:lnTo>
                      <a:pt x="2015" y="269"/>
                    </a:lnTo>
                    <a:lnTo>
                      <a:pt x="2001" y="269"/>
                    </a:lnTo>
                    <a:lnTo>
                      <a:pt x="1986" y="269"/>
                    </a:lnTo>
                    <a:lnTo>
                      <a:pt x="1972" y="269"/>
                    </a:lnTo>
                    <a:lnTo>
                      <a:pt x="1957" y="269"/>
                    </a:lnTo>
                    <a:lnTo>
                      <a:pt x="1944" y="269"/>
                    </a:lnTo>
                    <a:lnTo>
                      <a:pt x="1928" y="269"/>
                    </a:lnTo>
                    <a:lnTo>
                      <a:pt x="1915" y="269"/>
                    </a:lnTo>
                    <a:lnTo>
                      <a:pt x="1900" y="269"/>
                    </a:lnTo>
                    <a:lnTo>
                      <a:pt x="1886" y="269"/>
                    </a:lnTo>
                    <a:lnTo>
                      <a:pt x="1871" y="269"/>
                    </a:lnTo>
                    <a:lnTo>
                      <a:pt x="1857" y="269"/>
                    </a:lnTo>
                    <a:lnTo>
                      <a:pt x="1842" y="269"/>
                    </a:lnTo>
                    <a:lnTo>
                      <a:pt x="1828" y="269"/>
                    </a:lnTo>
                    <a:lnTo>
                      <a:pt x="1813" y="269"/>
                    </a:lnTo>
                    <a:lnTo>
                      <a:pt x="1800" y="269"/>
                    </a:lnTo>
                    <a:lnTo>
                      <a:pt x="1784" y="269"/>
                    </a:lnTo>
                    <a:lnTo>
                      <a:pt x="1771" y="269"/>
                    </a:lnTo>
                    <a:lnTo>
                      <a:pt x="1755" y="269"/>
                    </a:lnTo>
                    <a:lnTo>
                      <a:pt x="1742" y="269"/>
                    </a:lnTo>
                    <a:lnTo>
                      <a:pt x="1727" y="269"/>
                    </a:lnTo>
                    <a:lnTo>
                      <a:pt x="1713" y="269"/>
                    </a:lnTo>
                    <a:lnTo>
                      <a:pt x="1698" y="269"/>
                    </a:lnTo>
                    <a:lnTo>
                      <a:pt x="1684" y="269"/>
                    </a:lnTo>
                    <a:lnTo>
                      <a:pt x="1669" y="269"/>
                    </a:lnTo>
                    <a:lnTo>
                      <a:pt x="1656" y="269"/>
                    </a:lnTo>
                    <a:lnTo>
                      <a:pt x="1640" y="269"/>
                    </a:lnTo>
                    <a:lnTo>
                      <a:pt x="1627" y="269"/>
                    </a:lnTo>
                    <a:lnTo>
                      <a:pt x="1611" y="269"/>
                    </a:lnTo>
                    <a:lnTo>
                      <a:pt x="1598" y="269"/>
                    </a:lnTo>
                    <a:lnTo>
                      <a:pt x="1583" y="269"/>
                    </a:lnTo>
                    <a:lnTo>
                      <a:pt x="1569" y="269"/>
                    </a:lnTo>
                    <a:lnTo>
                      <a:pt x="1554" y="269"/>
                    </a:lnTo>
                    <a:lnTo>
                      <a:pt x="1540" y="269"/>
                    </a:lnTo>
                    <a:lnTo>
                      <a:pt x="1525" y="269"/>
                    </a:lnTo>
                    <a:lnTo>
                      <a:pt x="1512" y="269"/>
                    </a:lnTo>
                    <a:lnTo>
                      <a:pt x="1496" y="269"/>
                    </a:lnTo>
                    <a:lnTo>
                      <a:pt x="1483" y="269"/>
                    </a:lnTo>
                    <a:lnTo>
                      <a:pt x="1467" y="269"/>
                    </a:lnTo>
                    <a:lnTo>
                      <a:pt x="1454" y="269"/>
                    </a:lnTo>
                    <a:lnTo>
                      <a:pt x="1439" y="269"/>
                    </a:lnTo>
                    <a:lnTo>
                      <a:pt x="1425" y="269"/>
                    </a:lnTo>
                    <a:lnTo>
                      <a:pt x="1410" y="269"/>
                    </a:lnTo>
                    <a:lnTo>
                      <a:pt x="1396" y="269"/>
                    </a:lnTo>
                    <a:lnTo>
                      <a:pt x="1381" y="269"/>
                    </a:lnTo>
                    <a:lnTo>
                      <a:pt x="1368" y="269"/>
                    </a:lnTo>
                    <a:lnTo>
                      <a:pt x="1352" y="269"/>
                    </a:lnTo>
                    <a:lnTo>
                      <a:pt x="1339" y="269"/>
                    </a:lnTo>
                    <a:lnTo>
                      <a:pt x="1323" y="269"/>
                    </a:lnTo>
                    <a:lnTo>
                      <a:pt x="1310" y="269"/>
                    </a:lnTo>
                    <a:lnTo>
                      <a:pt x="1295" y="269"/>
                    </a:lnTo>
                    <a:lnTo>
                      <a:pt x="1281" y="269"/>
                    </a:lnTo>
                    <a:lnTo>
                      <a:pt x="1268" y="269"/>
                    </a:lnTo>
                    <a:lnTo>
                      <a:pt x="1252" y="269"/>
                    </a:lnTo>
                    <a:lnTo>
                      <a:pt x="1239" y="269"/>
                    </a:lnTo>
                    <a:lnTo>
                      <a:pt x="1224" y="269"/>
                    </a:lnTo>
                    <a:lnTo>
                      <a:pt x="1210" y="269"/>
                    </a:lnTo>
                    <a:lnTo>
                      <a:pt x="1195" y="269"/>
                    </a:lnTo>
                    <a:lnTo>
                      <a:pt x="1181" y="269"/>
                    </a:lnTo>
                    <a:lnTo>
                      <a:pt x="1166" y="269"/>
                    </a:lnTo>
                    <a:lnTo>
                      <a:pt x="1153" y="269"/>
                    </a:lnTo>
                    <a:lnTo>
                      <a:pt x="1137" y="269"/>
                    </a:lnTo>
                    <a:lnTo>
                      <a:pt x="1124" y="269"/>
                    </a:lnTo>
                    <a:lnTo>
                      <a:pt x="1108" y="269"/>
                    </a:lnTo>
                    <a:lnTo>
                      <a:pt x="1095" y="269"/>
                    </a:lnTo>
                    <a:lnTo>
                      <a:pt x="1080" y="269"/>
                    </a:lnTo>
                    <a:lnTo>
                      <a:pt x="1066" y="269"/>
                    </a:lnTo>
                    <a:lnTo>
                      <a:pt x="1051" y="269"/>
                    </a:lnTo>
                    <a:lnTo>
                      <a:pt x="1037" y="269"/>
                    </a:lnTo>
                    <a:lnTo>
                      <a:pt x="1022" y="269"/>
                    </a:lnTo>
                    <a:lnTo>
                      <a:pt x="1009" y="269"/>
                    </a:lnTo>
                    <a:lnTo>
                      <a:pt x="993" y="269"/>
                    </a:lnTo>
                    <a:lnTo>
                      <a:pt x="980" y="269"/>
                    </a:lnTo>
                    <a:lnTo>
                      <a:pt x="964" y="269"/>
                    </a:lnTo>
                    <a:lnTo>
                      <a:pt x="951" y="269"/>
                    </a:lnTo>
                    <a:lnTo>
                      <a:pt x="936" y="269"/>
                    </a:lnTo>
                    <a:lnTo>
                      <a:pt x="922" y="269"/>
                    </a:lnTo>
                    <a:lnTo>
                      <a:pt x="907" y="269"/>
                    </a:lnTo>
                    <a:lnTo>
                      <a:pt x="893" y="269"/>
                    </a:lnTo>
                    <a:lnTo>
                      <a:pt x="878" y="269"/>
                    </a:lnTo>
                    <a:lnTo>
                      <a:pt x="865" y="269"/>
                    </a:lnTo>
                    <a:lnTo>
                      <a:pt x="849" y="269"/>
                    </a:lnTo>
                    <a:lnTo>
                      <a:pt x="836" y="269"/>
                    </a:lnTo>
                    <a:lnTo>
                      <a:pt x="820" y="269"/>
                    </a:lnTo>
                    <a:lnTo>
                      <a:pt x="807" y="269"/>
                    </a:lnTo>
                    <a:lnTo>
                      <a:pt x="792" y="269"/>
                    </a:lnTo>
                    <a:lnTo>
                      <a:pt x="778" y="269"/>
                    </a:lnTo>
                    <a:lnTo>
                      <a:pt x="763" y="269"/>
                    </a:lnTo>
                    <a:lnTo>
                      <a:pt x="749" y="269"/>
                    </a:lnTo>
                    <a:lnTo>
                      <a:pt x="734" y="269"/>
                    </a:lnTo>
                    <a:lnTo>
                      <a:pt x="721" y="269"/>
                    </a:lnTo>
                    <a:lnTo>
                      <a:pt x="705" y="269"/>
                    </a:lnTo>
                    <a:lnTo>
                      <a:pt x="692" y="269"/>
                    </a:lnTo>
                    <a:lnTo>
                      <a:pt x="676" y="269"/>
                    </a:lnTo>
                    <a:lnTo>
                      <a:pt x="663" y="269"/>
                    </a:lnTo>
                    <a:lnTo>
                      <a:pt x="648" y="269"/>
                    </a:lnTo>
                    <a:lnTo>
                      <a:pt x="634" y="269"/>
                    </a:lnTo>
                    <a:lnTo>
                      <a:pt x="619" y="269"/>
                    </a:lnTo>
                    <a:lnTo>
                      <a:pt x="605" y="269"/>
                    </a:lnTo>
                    <a:lnTo>
                      <a:pt x="590" y="269"/>
                    </a:lnTo>
                    <a:lnTo>
                      <a:pt x="577" y="269"/>
                    </a:lnTo>
                    <a:lnTo>
                      <a:pt x="561" y="269"/>
                    </a:lnTo>
                    <a:lnTo>
                      <a:pt x="548" y="269"/>
                    </a:lnTo>
                    <a:lnTo>
                      <a:pt x="532" y="269"/>
                    </a:lnTo>
                    <a:lnTo>
                      <a:pt x="519" y="269"/>
                    </a:lnTo>
                    <a:lnTo>
                      <a:pt x="504" y="269"/>
                    </a:lnTo>
                    <a:lnTo>
                      <a:pt x="490" y="269"/>
                    </a:lnTo>
                    <a:lnTo>
                      <a:pt x="475" y="269"/>
                    </a:lnTo>
                    <a:lnTo>
                      <a:pt x="461" y="269"/>
                    </a:lnTo>
                    <a:lnTo>
                      <a:pt x="448" y="269"/>
                    </a:lnTo>
                    <a:lnTo>
                      <a:pt x="433" y="269"/>
                    </a:lnTo>
                    <a:lnTo>
                      <a:pt x="419" y="269"/>
                    </a:lnTo>
                    <a:lnTo>
                      <a:pt x="404" y="269"/>
                    </a:lnTo>
                    <a:lnTo>
                      <a:pt x="390" y="269"/>
                    </a:lnTo>
                    <a:lnTo>
                      <a:pt x="375" y="269"/>
                    </a:lnTo>
                    <a:lnTo>
                      <a:pt x="361" y="269"/>
                    </a:lnTo>
                    <a:lnTo>
                      <a:pt x="346" y="269"/>
                    </a:lnTo>
                    <a:lnTo>
                      <a:pt x="333" y="269"/>
                    </a:lnTo>
                    <a:lnTo>
                      <a:pt x="317" y="269"/>
                    </a:lnTo>
                    <a:lnTo>
                      <a:pt x="304" y="269"/>
                    </a:lnTo>
                    <a:lnTo>
                      <a:pt x="289" y="269"/>
                    </a:lnTo>
                    <a:lnTo>
                      <a:pt x="275" y="269"/>
                    </a:lnTo>
                    <a:lnTo>
                      <a:pt x="260" y="269"/>
                    </a:lnTo>
                    <a:lnTo>
                      <a:pt x="246" y="269"/>
                    </a:lnTo>
                    <a:lnTo>
                      <a:pt x="231" y="269"/>
                    </a:lnTo>
                    <a:lnTo>
                      <a:pt x="217" y="269"/>
                    </a:lnTo>
                    <a:lnTo>
                      <a:pt x="202" y="269"/>
                    </a:lnTo>
                    <a:lnTo>
                      <a:pt x="189" y="269"/>
                    </a:lnTo>
                    <a:lnTo>
                      <a:pt x="173" y="269"/>
                    </a:lnTo>
                    <a:lnTo>
                      <a:pt x="160" y="269"/>
                    </a:lnTo>
                    <a:lnTo>
                      <a:pt x="145" y="269"/>
                    </a:lnTo>
                    <a:lnTo>
                      <a:pt x="131" y="269"/>
                    </a:lnTo>
                    <a:lnTo>
                      <a:pt x="116" y="269"/>
                    </a:lnTo>
                    <a:lnTo>
                      <a:pt x="102" y="269"/>
                    </a:lnTo>
                    <a:lnTo>
                      <a:pt x="87" y="269"/>
                    </a:lnTo>
                    <a:lnTo>
                      <a:pt x="73" y="269"/>
                    </a:lnTo>
                    <a:lnTo>
                      <a:pt x="58" y="269"/>
                    </a:lnTo>
                    <a:lnTo>
                      <a:pt x="45" y="269"/>
                    </a:lnTo>
                    <a:lnTo>
                      <a:pt x="29" y="269"/>
                    </a:lnTo>
                    <a:lnTo>
                      <a:pt x="16" y="269"/>
                    </a:lnTo>
                    <a:lnTo>
                      <a:pt x="0" y="269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0" name="Freeform 88"/>
              <p:cNvSpPr>
                <a:spLocks/>
              </p:cNvSpPr>
              <p:nvPr/>
            </p:nvSpPr>
            <p:spPr bwMode="auto">
              <a:xfrm rot="5400000" flipV="1">
                <a:off x="3596159" y="3447792"/>
                <a:ext cx="4934092" cy="188985"/>
              </a:xfrm>
              <a:custGeom>
                <a:avLst/>
                <a:gdLst>
                  <a:gd name="T0" fmla="*/ 158 w 5410"/>
                  <a:gd name="T1" fmla="*/ 81 h 282"/>
                  <a:gd name="T2" fmla="*/ 329 w 5410"/>
                  <a:gd name="T3" fmla="*/ 67 h 282"/>
                  <a:gd name="T4" fmla="*/ 498 w 5410"/>
                  <a:gd name="T5" fmla="*/ 71 h 282"/>
                  <a:gd name="T6" fmla="*/ 669 w 5410"/>
                  <a:gd name="T7" fmla="*/ 2 h 282"/>
                  <a:gd name="T8" fmla="*/ 840 w 5410"/>
                  <a:gd name="T9" fmla="*/ 194 h 282"/>
                  <a:gd name="T10" fmla="*/ 1009 w 5410"/>
                  <a:gd name="T11" fmla="*/ 157 h 282"/>
                  <a:gd name="T12" fmla="*/ 1179 w 5410"/>
                  <a:gd name="T13" fmla="*/ 100 h 282"/>
                  <a:gd name="T14" fmla="*/ 1350 w 5410"/>
                  <a:gd name="T15" fmla="*/ 98 h 282"/>
                  <a:gd name="T16" fmla="*/ 1519 w 5410"/>
                  <a:gd name="T17" fmla="*/ 169 h 282"/>
                  <a:gd name="T18" fmla="*/ 1690 w 5410"/>
                  <a:gd name="T19" fmla="*/ 104 h 282"/>
                  <a:gd name="T20" fmla="*/ 1861 w 5410"/>
                  <a:gd name="T21" fmla="*/ 282 h 282"/>
                  <a:gd name="T22" fmla="*/ 2030 w 5410"/>
                  <a:gd name="T23" fmla="*/ 252 h 282"/>
                  <a:gd name="T24" fmla="*/ 2201 w 5410"/>
                  <a:gd name="T25" fmla="*/ 282 h 282"/>
                  <a:gd name="T26" fmla="*/ 2372 w 5410"/>
                  <a:gd name="T27" fmla="*/ 277 h 282"/>
                  <a:gd name="T28" fmla="*/ 2541 w 5410"/>
                  <a:gd name="T29" fmla="*/ 179 h 282"/>
                  <a:gd name="T30" fmla="*/ 2712 w 5410"/>
                  <a:gd name="T31" fmla="*/ 282 h 282"/>
                  <a:gd name="T32" fmla="*/ 2883 w 5410"/>
                  <a:gd name="T33" fmla="*/ 282 h 282"/>
                  <a:gd name="T34" fmla="*/ 3052 w 5410"/>
                  <a:gd name="T35" fmla="*/ 263 h 282"/>
                  <a:gd name="T36" fmla="*/ 3222 w 5410"/>
                  <a:gd name="T37" fmla="*/ 282 h 282"/>
                  <a:gd name="T38" fmla="*/ 3393 w 5410"/>
                  <a:gd name="T39" fmla="*/ 254 h 282"/>
                  <a:gd name="T40" fmla="*/ 3562 w 5410"/>
                  <a:gd name="T41" fmla="*/ 257 h 282"/>
                  <a:gd name="T42" fmla="*/ 3733 w 5410"/>
                  <a:gd name="T43" fmla="*/ 282 h 282"/>
                  <a:gd name="T44" fmla="*/ 3904 w 5410"/>
                  <a:gd name="T45" fmla="*/ 229 h 282"/>
                  <a:gd name="T46" fmla="*/ 4073 w 5410"/>
                  <a:gd name="T47" fmla="*/ 282 h 282"/>
                  <a:gd name="T48" fmla="*/ 4244 w 5410"/>
                  <a:gd name="T49" fmla="*/ 198 h 282"/>
                  <a:gd name="T50" fmla="*/ 4415 w 5410"/>
                  <a:gd name="T51" fmla="*/ 221 h 282"/>
                  <a:gd name="T52" fmla="*/ 4584 w 5410"/>
                  <a:gd name="T53" fmla="*/ 156 h 282"/>
                  <a:gd name="T54" fmla="*/ 4755 w 5410"/>
                  <a:gd name="T55" fmla="*/ 71 h 282"/>
                  <a:gd name="T56" fmla="*/ 4926 w 5410"/>
                  <a:gd name="T57" fmla="*/ 96 h 282"/>
                  <a:gd name="T58" fmla="*/ 5095 w 5410"/>
                  <a:gd name="T59" fmla="*/ 129 h 282"/>
                  <a:gd name="T60" fmla="*/ 5265 w 5410"/>
                  <a:gd name="T61" fmla="*/ 146 h 282"/>
                  <a:gd name="T62" fmla="*/ 5396 w 5410"/>
                  <a:gd name="T63" fmla="*/ 282 h 282"/>
                  <a:gd name="T64" fmla="*/ 5225 w 5410"/>
                  <a:gd name="T65" fmla="*/ 282 h 282"/>
                  <a:gd name="T66" fmla="*/ 5056 w 5410"/>
                  <a:gd name="T67" fmla="*/ 282 h 282"/>
                  <a:gd name="T68" fmla="*/ 4885 w 5410"/>
                  <a:gd name="T69" fmla="*/ 282 h 282"/>
                  <a:gd name="T70" fmla="*/ 4714 w 5410"/>
                  <a:gd name="T71" fmla="*/ 282 h 282"/>
                  <a:gd name="T72" fmla="*/ 4545 w 5410"/>
                  <a:gd name="T73" fmla="*/ 282 h 282"/>
                  <a:gd name="T74" fmla="*/ 4375 w 5410"/>
                  <a:gd name="T75" fmla="*/ 282 h 282"/>
                  <a:gd name="T76" fmla="*/ 4206 w 5410"/>
                  <a:gd name="T77" fmla="*/ 282 h 282"/>
                  <a:gd name="T78" fmla="*/ 4035 w 5410"/>
                  <a:gd name="T79" fmla="*/ 282 h 282"/>
                  <a:gd name="T80" fmla="*/ 3864 w 5410"/>
                  <a:gd name="T81" fmla="*/ 282 h 282"/>
                  <a:gd name="T82" fmla="*/ 3695 w 5410"/>
                  <a:gd name="T83" fmla="*/ 282 h 282"/>
                  <a:gd name="T84" fmla="*/ 3524 w 5410"/>
                  <a:gd name="T85" fmla="*/ 282 h 282"/>
                  <a:gd name="T86" fmla="*/ 3353 w 5410"/>
                  <a:gd name="T87" fmla="*/ 282 h 282"/>
                  <a:gd name="T88" fmla="*/ 3184 w 5410"/>
                  <a:gd name="T89" fmla="*/ 282 h 282"/>
                  <a:gd name="T90" fmla="*/ 3013 w 5410"/>
                  <a:gd name="T91" fmla="*/ 282 h 282"/>
                  <a:gd name="T92" fmla="*/ 2842 w 5410"/>
                  <a:gd name="T93" fmla="*/ 282 h 282"/>
                  <a:gd name="T94" fmla="*/ 2673 w 5410"/>
                  <a:gd name="T95" fmla="*/ 282 h 282"/>
                  <a:gd name="T96" fmla="*/ 2502 w 5410"/>
                  <a:gd name="T97" fmla="*/ 282 h 282"/>
                  <a:gd name="T98" fmla="*/ 2332 w 5410"/>
                  <a:gd name="T99" fmla="*/ 282 h 282"/>
                  <a:gd name="T100" fmla="*/ 2163 w 5410"/>
                  <a:gd name="T101" fmla="*/ 282 h 282"/>
                  <a:gd name="T102" fmla="*/ 1992 w 5410"/>
                  <a:gd name="T103" fmla="*/ 282 h 282"/>
                  <a:gd name="T104" fmla="*/ 1821 w 5410"/>
                  <a:gd name="T105" fmla="*/ 282 h 282"/>
                  <a:gd name="T106" fmla="*/ 1652 w 5410"/>
                  <a:gd name="T107" fmla="*/ 282 h 282"/>
                  <a:gd name="T108" fmla="*/ 1481 w 5410"/>
                  <a:gd name="T109" fmla="*/ 282 h 282"/>
                  <a:gd name="T110" fmla="*/ 1310 w 5410"/>
                  <a:gd name="T111" fmla="*/ 282 h 282"/>
                  <a:gd name="T112" fmla="*/ 1141 w 5410"/>
                  <a:gd name="T113" fmla="*/ 282 h 282"/>
                  <a:gd name="T114" fmla="*/ 970 w 5410"/>
                  <a:gd name="T115" fmla="*/ 282 h 282"/>
                  <a:gd name="T116" fmla="*/ 799 w 5410"/>
                  <a:gd name="T117" fmla="*/ 282 h 282"/>
                  <a:gd name="T118" fmla="*/ 630 w 5410"/>
                  <a:gd name="T119" fmla="*/ 282 h 282"/>
                  <a:gd name="T120" fmla="*/ 459 w 5410"/>
                  <a:gd name="T121" fmla="*/ 282 h 282"/>
                  <a:gd name="T122" fmla="*/ 289 w 5410"/>
                  <a:gd name="T123" fmla="*/ 282 h 282"/>
                  <a:gd name="T124" fmla="*/ 120 w 5410"/>
                  <a:gd name="T125" fmla="*/ 282 h 2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5410" h="282">
                    <a:moveTo>
                      <a:pt x="0" y="167"/>
                    </a:moveTo>
                    <a:lnTo>
                      <a:pt x="14" y="161"/>
                    </a:lnTo>
                    <a:lnTo>
                      <a:pt x="27" y="119"/>
                    </a:lnTo>
                    <a:lnTo>
                      <a:pt x="41" y="106"/>
                    </a:lnTo>
                    <a:lnTo>
                      <a:pt x="54" y="109"/>
                    </a:lnTo>
                    <a:lnTo>
                      <a:pt x="66" y="83"/>
                    </a:lnTo>
                    <a:lnTo>
                      <a:pt x="79" y="67"/>
                    </a:lnTo>
                    <a:lnTo>
                      <a:pt x="93" y="59"/>
                    </a:lnTo>
                    <a:lnTo>
                      <a:pt x="106" y="121"/>
                    </a:lnTo>
                    <a:lnTo>
                      <a:pt x="120" y="123"/>
                    </a:lnTo>
                    <a:lnTo>
                      <a:pt x="131" y="173"/>
                    </a:lnTo>
                    <a:lnTo>
                      <a:pt x="145" y="65"/>
                    </a:lnTo>
                    <a:lnTo>
                      <a:pt x="158" y="81"/>
                    </a:lnTo>
                    <a:lnTo>
                      <a:pt x="171" y="71"/>
                    </a:lnTo>
                    <a:lnTo>
                      <a:pt x="185" y="100"/>
                    </a:lnTo>
                    <a:lnTo>
                      <a:pt x="198" y="48"/>
                    </a:lnTo>
                    <a:lnTo>
                      <a:pt x="210" y="84"/>
                    </a:lnTo>
                    <a:lnTo>
                      <a:pt x="223" y="83"/>
                    </a:lnTo>
                    <a:lnTo>
                      <a:pt x="237" y="131"/>
                    </a:lnTo>
                    <a:lnTo>
                      <a:pt x="250" y="79"/>
                    </a:lnTo>
                    <a:lnTo>
                      <a:pt x="264" y="71"/>
                    </a:lnTo>
                    <a:lnTo>
                      <a:pt x="277" y="56"/>
                    </a:lnTo>
                    <a:lnTo>
                      <a:pt x="289" y="88"/>
                    </a:lnTo>
                    <a:lnTo>
                      <a:pt x="302" y="125"/>
                    </a:lnTo>
                    <a:lnTo>
                      <a:pt x="315" y="11"/>
                    </a:lnTo>
                    <a:lnTo>
                      <a:pt x="329" y="67"/>
                    </a:lnTo>
                    <a:lnTo>
                      <a:pt x="342" y="44"/>
                    </a:lnTo>
                    <a:lnTo>
                      <a:pt x="354" y="132"/>
                    </a:lnTo>
                    <a:lnTo>
                      <a:pt x="367" y="31"/>
                    </a:lnTo>
                    <a:lnTo>
                      <a:pt x="381" y="67"/>
                    </a:lnTo>
                    <a:lnTo>
                      <a:pt x="394" y="17"/>
                    </a:lnTo>
                    <a:lnTo>
                      <a:pt x="408" y="96"/>
                    </a:lnTo>
                    <a:lnTo>
                      <a:pt x="421" y="84"/>
                    </a:lnTo>
                    <a:lnTo>
                      <a:pt x="433" y="63"/>
                    </a:lnTo>
                    <a:lnTo>
                      <a:pt x="446" y="83"/>
                    </a:lnTo>
                    <a:lnTo>
                      <a:pt x="459" y="65"/>
                    </a:lnTo>
                    <a:lnTo>
                      <a:pt x="473" y="106"/>
                    </a:lnTo>
                    <a:lnTo>
                      <a:pt x="486" y="83"/>
                    </a:lnTo>
                    <a:lnTo>
                      <a:pt x="498" y="71"/>
                    </a:lnTo>
                    <a:lnTo>
                      <a:pt x="511" y="131"/>
                    </a:lnTo>
                    <a:lnTo>
                      <a:pt x="525" y="123"/>
                    </a:lnTo>
                    <a:lnTo>
                      <a:pt x="538" y="65"/>
                    </a:lnTo>
                    <a:lnTo>
                      <a:pt x="552" y="33"/>
                    </a:lnTo>
                    <a:lnTo>
                      <a:pt x="565" y="77"/>
                    </a:lnTo>
                    <a:lnTo>
                      <a:pt x="577" y="77"/>
                    </a:lnTo>
                    <a:lnTo>
                      <a:pt x="590" y="8"/>
                    </a:lnTo>
                    <a:lnTo>
                      <a:pt x="603" y="4"/>
                    </a:lnTo>
                    <a:lnTo>
                      <a:pt x="617" y="148"/>
                    </a:lnTo>
                    <a:lnTo>
                      <a:pt x="630" y="9"/>
                    </a:lnTo>
                    <a:lnTo>
                      <a:pt x="642" y="44"/>
                    </a:lnTo>
                    <a:lnTo>
                      <a:pt x="655" y="71"/>
                    </a:lnTo>
                    <a:lnTo>
                      <a:pt x="669" y="2"/>
                    </a:lnTo>
                    <a:lnTo>
                      <a:pt x="682" y="73"/>
                    </a:lnTo>
                    <a:lnTo>
                      <a:pt x="696" y="58"/>
                    </a:lnTo>
                    <a:lnTo>
                      <a:pt x="709" y="56"/>
                    </a:lnTo>
                    <a:lnTo>
                      <a:pt x="721" y="71"/>
                    </a:lnTo>
                    <a:lnTo>
                      <a:pt x="734" y="52"/>
                    </a:lnTo>
                    <a:lnTo>
                      <a:pt x="747" y="109"/>
                    </a:lnTo>
                    <a:lnTo>
                      <a:pt x="761" y="77"/>
                    </a:lnTo>
                    <a:lnTo>
                      <a:pt x="774" y="156"/>
                    </a:lnTo>
                    <a:lnTo>
                      <a:pt x="786" y="77"/>
                    </a:lnTo>
                    <a:lnTo>
                      <a:pt x="799" y="102"/>
                    </a:lnTo>
                    <a:lnTo>
                      <a:pt x="813" y="127"/>
                    </a:lnTo>
                    <a:lnTo>
                      <a:pt x="826" y="86"/>
                    </a:lnTo>
                    <a:lnTo>
                      <a:pt x="840" y="194"/>
                    </a:lnTo>
                    <a:lnTo>
                      <a:pt x="853" y="277"/>
                    </a:lnTo>
                    <a:lnTo>
                      <a:pt x="865" y="250"/>
                    </a:lnTo>
                    <a:lnTo>
                      <a:pt x="878" y="77"/>
                    </a:lnTo>
                    <a:lnTo>
                      <a:pt x="891" y="0"/>
                    </a:lnTo>
                    <a:lnTo>
                      <a:pt x="905" y="86"/>
                    </a:lnTo>
                    <a:lnTo>
                      <a:pt x="918" y="102"/>
                    </a:lnTo>
                    <a:lnTo>
                      <a:pt x="932" y="88"/>
                    </a:lnTo>
                    <a:lnTo>
                      <a:pt x="943" y="34"/>
                    </a:lnTo>
                    <a:lnTo>
                      <a:pt x="957" y="63"/>
                    </a:lnTo>
                    <a:lnTo>
                      <a:pt x="970" y="69"/>
                    </a:lnTo>
                    <a:lnTo>
                      <a:pt x="984" y="88"/>
                    </a:lnTo>
                    <a:lnTo>
                      <a:pt x="997" y="123"/>
                    </a:lnTo>
                    <a:lnTo>
                      <a:pt x="1009" y="157"/>
                    </a:lnTo>
                    <a:lnTo>
                      <a:pt x="1022" y="131"/>
                    </a:lnTo>
                    <a:lnTo>
                      <a:pt x="1035" y="140"/>
                    </a:lnTo>
                    <a:lnTo>
                      <a:pt x="1049" y="125"/>
                    </a:lnTo>
                    <a:lnTo>
                      <a:pt x="1062" y="81"/>
                    </a:lnTo>
                    <a:lnTo>
                      <a:pt x="1076" y="129"/>
                    </a:lnTo>
                    <a:lnTo>
                      <a:pt x="1087" y="34"/>
                    </a:lnTo>
                    <a:lnTo>
                      <a:pt x="1101" y="104"/>
                    </a:lnTo>
                    <a:lnTo>
                      <a:pt x="1114" y="127"/>
                    </a:lnTo>
                    <a:lnTo>
                      <a:pt x="1128" y="67"/>
                    </a:lnTo>
                    <a:lnTo>
                      <a:pt x="1141" y="104"/>
                    </a:lnTo>
                    <a:lnTo>
                      <a:pt x="1153" y="161"/>
                    </a:lnTo>
                    <a:lnTo>
                      <a:pt x="1166" y="115"/>
                    </a:lnTo>
                    <a:lnTo>
                      <a:pt x="1179" y="100"/>
                    </a:lnTo>
                    <a:lnTo>
                      <a:pt x="1193" y="84"/>
                    </a:lnTo>
                    <a:lnTo>
                      <a:pt x="1206" y="71"/>
                    </a:lnTo>
                    <a:lnTo>
                      <a:pt x="1220" y="171"/>
                    </a:lnTo>
                    <a:lnTo>
                      <a:pt x="1231" y="98"/>
                    </a:lnTo>
                    <a:lnTo>
                      <a:pt x="1245" y="52"/>
                    </a:lnTo>
                    <a:lnTo>
                      <a:pt x="1258" y="163"/>
                    </a:lnTo>
                    <a:lnTo>
                      <a:pt x="1272" y="100"/>
                    </a:lnTo>
                    <a:lnTo>
                      <a:pt x="1285" y="83"/>
                    </a:lnTo>
                    <a:lnTo>
                      <a:pt x="1297" y="90"/>
                    </a:lnTo>
                    <a:lnTo>
                      <a:pt x="1310" y="163"/>
                    </a:lnTo>
                    <a:lnTo>
                      <a:pt x="1323" y="121"/>
                    </a:lnTo>
                    <a:lnTo>
                      <a:pt x="1337" y="129"/>
                    </a:lnTo>
                    <a:lnTo>
                      <a:pt x="1350" y="98"/>
                    </a:lnTo>
                    <a:lnTo>
                      <a:pt x="1364" y="154"/>
                    </a:lnTo>
                    <a:lnTo>
                      <a:pt x="1375" y="92"/>
                    </a:lnTo>
                    <a:lnTo>
                      <a:pt x="1389" y="136"/>
                    </a:lnTo>
                    <a:lnTo>
                      <a:pt x="1402" y="207"/>
                    </a:lnTo>
                    <a:lnTo>
                      <a:pt x="1416" y="131"/>
                    </a:lnTo>
                    <a:lnTo>
                      <a:pt x="1429" y="90"/>
                    </a:lnTo>
                    <a:lnTo>
                      <a:pt x="1441" y="171"/>
                    </a:lnTo>
                    <a:lnTo>
                      <a:pt x="1454" y="58"/>
                    </a:lnTo>
                    <a:lnTo>
                      <a:pt x="1467" y="190"/>
                    </a:lnTo>
                    <a:lnTo>
                      <a:pt x="1481" y="154"/>
                    </a:lnTo>
                    <a:lnTo>
                      <a:pt x="1494" y="123"/>
                    </a:lnTo>
                    <a:lnTo>
                      <a:pt x="1508" y="157"/>
                    </a:lnTo>
                    <a:lnTo>
                      <a:pt x="1519" y="169"/>
                    </a:lnTo>
                    <a:lnTo>
                      <a:pt x="1533" y="138"/>
                    </a:lnTo>
                    <a:lnTo>
                      <a:pt x="1546" y="44"/>
                    </a:lnTo>
                    <a:lnTo>
                      <a:pt x="1560" y="234"/>
                    </a:lnTo>
                    <a:lnTo>
                      <a:pt x="1573" y="136"/>
                    </a:lnTo>
                    <a:lnTo>
                      <a:pt x="1587" y="167"/>
                    </a:lnTo>
                    <a:lnTo>
                      <a:pt x="1598" y="157"/>
                    </a:lnTo>
                    <a:lnTo>
                      <a:pt x="1611" y="94"/>
                    </a:lnTo>
                    <a:lnTo>
                      <a:pt x="1625" y="204"/>
                    </a:lnTo>
                    <a:lnTo>
                      <a:pt x="1638" y="179"/>
                    </a:lnTo>
                    <a:lnTo>
                      <a:pt x="1652" y="169"/>
                    </a:lnTo>
                    <a:lnTo>
                      <a:pt x="1663" y="127"/>
                    </a:lnTo>
                    <a:lnTo>
                      <a:pt x="1677" y="171"/>
                    </a:lnTo>
                    <a:lnTo>
                      <a:pt x="1690" y="104"/>
                    </a:lnTo>
                    <a:lnTo>
                      <a:pt x="1704" y="150"/>
                    </a:lnTo>
                    <a:lnTo>
                      <a:pt x="1717" y="156"/>
                    </a:lnTo>
                    <a:lnTo>
                      <a:pt x="1731" y="115"/>
                    </a:lnTo>
                    <a:lnTo>
                      <a:pt x="1742" y="244"/>
                    </a:lnTo>
                    <a:lnTo>
                      <a:pt x="1755" y="207"/>
                    </a:lnTo>
                    <a:lnTo>
                      <a:pt x="1769" y="263"/>
                    </a:lnTo>
                    <a:lnTo>
                      <a:pt x="1782" y="282"/>
                    </a:lnTo>
                    <a:lnTo>
                      <a:pt x="1796" y="279"/>
                    </a:lnTo>
                    <a:lnTo>
                      <a:pt x="1807" y="282"/>
                    </a:lnTo>
                    <a:lnTo>
                      <a:pt x="1821" y="282"/>
                    </a:lnTo>
                    <a:lnTo>
                      <a:pt x="1834" y="282"/>
                    </a:lnTo>
                    <a:lnTo>
                      <a:pt x="1848" y="282"/>
                    </a:lnTo>
                    <a:lnTo>
                      <a:pt x="1861" y="282"/>
                    </a:lnTo>
                    <a:lnTo>
                      <a:pt x="1875" y="282"/>
                    </a:lnTo>
                    <a:lnTo>
                      <a:pt x="1886" y="282"/>
                    </a:lnTo>
                    <a:lnTo>
                      <a:pt x="1900" y="282"/>
                    </a:lnTo>
                    <a:lnTo>
                      <a:pt x="1913" y="246"/>
                    </a:lnTo>
                    <a:lnTo>
                      <a:pt x="1926" y="282"/>
                    </a:lnTo>
                    <a:lnTo>
                      <a:pt x="1940" y="282"/>
                    </a:lnTo>
                    <a:lnTo>
                      <a:pt x="1951" y="261"/>
                    </a:lnTo>
                    <a:lnTo>
                      <a:pt x="1965" y="280"/>
                    </a:lnTo>
                    <a:lnTo>
                      <a:pt x="1978" y="271"/>
                    </a:lnTo>
                    <a:lnTo>
                      <a:pt x="1992" y="271"/>
                    </a:lnTo>
                    <a:lnTo>
                      <a:pt x="2005" y="269"/>
                    </a:lnTo>
                    <a:lnTo>
                      <a:pt x="2019" y="263"/>
                    </a:lnTo>
                    <a:lnTo>
                      <a:pt x="2030" y="252"/>
                    </a:lnTo>
                    <a:lnTo>
                      <a:pt x="2044" y="265"/>
                    </a:lnTo>
                    <a:lnTo>
                      <a:pt x="2057" y="275"/>
                    </a:lnTo>
                    <a:lnTo>
                      <a:pt x="2070" y="275"/>
                    </a:lnTo>
                    <a:lnTo>
                      <a:pt x="2084" y="269"/>
                    </a:lnTo>
                    <a:lnTo>
                      <a:pt x="2095" y="282"/>
                    </a:lnTo>
                    <a:lnTo>
                      <a:pt x="2109" y="273"/>
                    </a:lnTo>
                    <a:lnTo>
                      <a:pt x="2122" y="282"/>
                    </a:lnTo>
                    <a:lnTo>
                      <a:pt x="2136" y="265"/>
                    </a:lnTo>
                    <a:lnTo>
                      <a:pt x="2149" y="282"/>
                    </a:lnTo>
                    <a:lnTo>
                      <a:pt x="2163" y="282"/>
                    </a:lnTo>
                    <a:lnTo>
                      <a:pt x="2174" y="282"/>
                    </a:lnTo>
                    <a:lnTo>
                      <a:pt x="2188" y="282"/>
                    </a:lnTo>
                    <a:lnTo>
                      <a:pt x="2201" y="282"/>
                    </a:lnTo>
                    <a:lnTo>
                      <a:pt x="2214" y="275"/>
                    </a:lnTo>
                    <a:lnTo>
                      <a:pt x="2228" y="273"/>
                    </a:lnTo>
                    <a:lnTo>
                      <a:pt x="2241" y="282"/>
                    </a:lnTo>
                    <a:lnTo>
                      <a:pt x="2253" y="242"/>
                    </a:lnTo>
                    <a:lnTo>
                      <a:pt x="2266" y="282"/>
                    </a:lnTo>
                    <a:lnTo>
                      <a:pt x="2280" y="229"/>
                    </a:lnTo>
                    <a:lnTo>
                      <a:pt x="2293" y="242"/>
                    </a:lnTo>
                    <a:lnTo>
                      <a:pt x="2307" y="277"/>
                    </a:lnTo>
                    <a:lnTo>
                      <a:pt x="2318" y="275"/>
                    </a:lnTo>
                    <a:lnTo>
                      <a:pt x="2332" y="242"/>
                    </a:lnTo>
                    <a:lnTo>
                      <a:pt x="2345" y="144"/>
                    </a:lnTo>
                    <a:lnTo>
                      <a:pt x="2358" y="263"/>
                    </a:lnTo>
                    <a:lnTo>
                      <a:pt x="2372" y="277"/>
                    </a:lnTo>
                    <a:lnTo>
                      <a:pt x="2385" y="213"/>
                    </a:lnTo>
                    <a:lnTo>
                      <a:pt x="2397" y="280"/>
                    </a:lnTo>
                    <a:lnTo>
                      <a:pt x="2410" y="282"/>
                    </a:lnTo>
                    <a:lnTo>
                      <a:pt x="2424" y="273"/>
                    </a:lnTo>
                    <a:lnTo>
                      <a:pt x="2437" y="269"/>
                    </a:lnTo>
                    <a:lnTo>
                      <a:pt x="2451" y="223"/>
                    </a:lnTo>
                    <a:lnTo>
                      <a:pt x="2462" y="275"/>
                    </a:lnTo>
                    <a:lnTo>
                      <a:pt x="2476" y="261"/>
                    </a:lnTo>
                    <a:lnTo>
                      <a:pt x="2489" y="280"/>
                    </a:lnTo>
                    <a:lnTo>
                      <a:pt x="2502" y="242"/>
                    </a:lnTo>
                    <a:lnTo>
                      <a:pt x="2516" y="182"/>
                    </a:lnTo>
                    <a:lnTo>
                      <a:pt x="2529" y="254"/>
                    </a:lnTo>
                    <a:lnTo>
                      <a:pt x="2541" y="179"/>
                    </a:lnTo>
                    <a:lnTo>
                      <a:pt x="2554" y="244"/>
                    </a:lnTo>
                    <a:lnTo>
                      <a:pt x="2568" y="217"/>
                    </a:lnTo>
                    <a:lnTo>
                      <a:pt x="2581" y="271"/>
                    </a:lnTo>
                    <a:lnTo>
                      <a:pt x="2595" y="282"/>
                    </a:lnTo>
                    <a:lnTo>
                      <a:pt x="2606" y="236"/>
                    </a:lnTo>
                    <a:lnTo>
                      <a:pt x="2620" y="275"/>
                    </a:lnTo>
                    <a:lnTo>
                      <a:pt x="2633" y="282"/>
                    </a:lnTo>
                    <a:lnTo>
                      <a:pt x="2646" y="282"/>
                    </a:lnTo>
                    <a:lnTo>
                      <a:pt x="2660" y="282"/>
                    </a:lnTo>
                    <a:lnTo>
                      <a:pt x="2673" y="282"/>
                    </a:lnTo>
                    <a:lnTo>
                      <a:pt x="2685" y="282"/>
                    </a:lnTo>
                    <a:lnTo>
                      <a:pt x="2698" y="282"/>
                    </a:lnTo>
                    <a:lnTo>
                      <a:pt x="2712" y="282"/>
                    </a:lnTo>
                    <a:lnTo>
                      <a:pt x="2725" y="282"/>
                    </a:lnTo>
                    <a:lnTo>
                      <a:pt x="2739" y="282"/>
                    </a:lnTo>
                    <a:lnTo>
                      <a:pt x="2750" y="277"/>
                    </a:lnTo>
                    <a:lnTo>
                      <a:pt x="2764" y="282"/>
                    </a:lnTo>
                    <a:lnTo>
                      <a:pt x="2777" y="280"/>
                    </a:lnTo>
                    <a:lnTo>
                      <a:pt x="2790" y="261"/>
                    </a:lnTo>
                    <a:lnTo>
                      <a:pt x="2804" y="282"/>
                    </a:lnTo>
                    <a:lnTo>
                      <a:pt x="2817" y="255"/>
                    </a:lnTo>
                    <a:lnTo>
                      <a:pt x="2829" y="277"/>
                    </a:lnTo>
                    <a:lnTo>
                      <a:pt x="2842" y="282"/>
                    </a:lnTo>
                    <a:lnTo>
                      <a:pt x="2856" y="279"/>
                    </a:lnTo>
                    <a:lnTo>
                      <a:pt x="2869" y="282"/>
                    </a:lnTo>
                    <a:lnTo>
                      <a:pt x="2883" y="282"/>
                    </a:lnTo>
                    <a:lnTo>
                      <a:pt x="2896" y="282"/>
                    </a:lnTo>
                    <a:lnTo>
                      <a:pt x="2908" y="282"/>
                    </a:lnTo>
                    <a:lnTo>
                      <a:pt x="2921" y="271"/>
                    </a:lnTo>
                    <a:lnTo>
                      <a:pt x="2934" y="282"/>
                    </a:lnTo>
                    <a:lnTo>
                      <a:pt x="2948" y="282"/>
                    </a:lnTo>
                    <a:lnTo>
                      <a:pt x="2961" y="271"/>
                    </a:lnTo>
                    <a:lnTo>
                      <a:pt x="2973" y="282"/>
                    </a:lnTo>
                    <a:lnTo>
                      <a:pt x="2986" y="259"/>
                    </a:lnTo>
                    <a:lnTo>
                      <a:pt x="3000" y="282"/>
                    </a:lnTo>
                    <a:lnTo>
                      <a:pt x="3013" y="282"/>
                    </a:lnTo>
                    <a:lnTo>
                      <a:pt x="3027" y="265"/>
                    </a:lnTo>
                    <a:lnTo>
                      <a:pt x="3040" y="261"/>
                    </a:lnTo>
                    <a:lnTo>
                      <a:pt x="3052" y="263"/>
                    </a:lnTo>
                    <a:lnTo>
                      <a:pt x="3065" y="275"/>
                    </a:lnTo>
                    <a:lnTo>
                      <a:pt x="3078" y="277"/>
                    </a:lnTo>
                    <a:lnTo>
                      <a:pt x="3092" y="234"/>
                    </a:lnTo>
                    <a:lnTo>
                      <a:pt x="3105" y="277"/>
                    </a:lnTo>
                    <a:lnTo>
                      <a:pt x="3117" y="234"/>
                    </a:lnTo>
                    <a:lnTo>
                      <a:pt x="3130" y="282"/>
                    </a:lnTo>
                    <a:lnTo>
                      <a:pt x="3144" y="225"/>
                    </a:lnTo>
                    <a:lnTo>
                      <a:pt x="3157" y="250"/>
                    </a:lnTo>
                    <a:lnTo>
                      <a:pt x="3171" y="282"/>
                    </a:lnTo>
                    <a:lnTo>
                      <a:pt x="3184" y="282"/>
                    </a:lnTo>
                    <a:lnTo>
                      <a:pt x="3196" y="282"/>
                    </a:lnTo>
                    <a:lnTo>
                      <a:pt x="3209" y="280"/>
                    </a:lnTo>
                    <a:lnTo>
                      <a:pt x="3222" y="282"/>
                    </a:lnTo>
                    <a:lnTo>
                      <a:pt x="3236" y="282"/>
                    </a:lnTo>
                    <a:lnTo>
                      <a:pt x="3249" y="213"/>
                    </a:lnTo>
                    <a:lnTo>
                      <a:pt x="3261" y="250"/>
                    </a:lnTo>
                    <a:lnTo>
                      <a:pt x="3274" y="279"/>
                    </a:lnTo>
                    <a:lnTo>
                      <a:pt x="3288" y="267"/>
                    </a:lnTo>
                    <a:lnTo>
                      <a:pt x="3301" y="282"/>
                    </a:lnTo>
                    <a:lnTo>
                      <a:pt x="3315" y="277"/>
                    </a:lnTo>
                    <a:lnTo>
                      <a:pt x="3328" y="282"/>
                    </a:lnTo>
                    <a:lnTo>
                      <a:pt x="3340" y="279"/>
                    </a:lnTo>
                    <a:lnTo>
                      <a:pt x="3353" y="263"/>
                    </a:lnTo>
                    <a:lnTo>
                      <a:pt x="3366" y="282"/>
                    </a:lnTo>
                    <a:lnTo>
                      <a:pt x="3380" y="280"/>
                    </a:lnTo>
                    <a:lnTo>
                      <a:pt x="3393" y="254"/>
                    </a:lnTo>
                    <a:lnTo>
                      <a:pt x="3405" y="238"/>
                    </a:lnTo>
                    <a:lnTo>
                      <a:pt x="3418" y="213"/>
                    </a:lnTo>
                    <a:lnTo>
                      <a:pt x="3432" y="282"/>
                    </a:lnTo>
                    <a:lnTo>
                      <a:pt x="3445" y="282"/>
                    </a:lnTo>
                    <a:lnTo>
                      <a:pt x="3459" y="267"/>
                    </a:lnTo>
                    <a:lnTo>
                      <a:pt x="3472" y="234"/>
                    </a:lnTo>
                    <a:lnTo>
                      <a:pt x="3484" y="196"/>
                    </a:lnTo>
                    <a:lnTo>
                      <a:pt x="3497" y="265"/>
                    </a:lnTo>
                    <a:lnTo>
                      <a:pt x="3510" y="230"/>
                    </a:lnTo>
                    <a:lnTo>
                      <a:pt x="3524" y="252"/>
                    </a:lnTo>
                    <a:lnTo>
                      <a:pt x="3537" y="282"/>
                    </a:lnTo>
                    <a:lnTo>
                      <a:pt x="3551" y="238"/>
                    </a:lnTo>
                    <a:lnTo>
                      <a:pt x="3562" y="257"/>
                    </a:lnTo>
                    <a:lnTo>
                      <a:pt x="3576" y="277"/>
                    </a:lnTo>
                    <a:lnTo>
                      <a:pt x="3589" y="265"/>
                    </a:lnTo>
                    <a:lnTo>
                      <a:pt x="3603" y="282"/>
                    </a:lnTo>
                    <a:lnTo>
                      <a:pt x="3616" y="282"/>
                    </a:lnTo>
                    <a:lnTo>
                      <a:pt x="3628" y="250"/>
                    </a:lnTo>
                    <a:lnTo>
                      <a:pt x="3641" y="282"/>
                    </a:lnTo>
                    <a:lnTo>
                      <a:pt x="3655" y="225"/>
                    </a:lnTo>
                    <a:lnTo>
                      <a:pt x="3668" y="279"/>
                    </a:lnTo>
                    <a:lnTo>
                      <a:pt x="3681" y="275"/>
                    </a:lnTo>
                    <a:lnTo>
                      <a:pt x="3695" y="280"/>
                    </a:lnTo>
                    <a:lnTo>
                      <a:pt x="3706" y="282"/>
                    </a:lnTo>
                    <a:lnTo>
                      <a:pt x="3720" y="269"/>
                    </a:lnTo>
                    <a:lnTo>
                      <a:pt x="3733" y="282"/>
                    </a:lnTo>
                    <a:lnTo>
                      <a:pt x="3747" y="282"/>
                    </a:lnTo>
                    <a:lnTo>
                      <a:pt x="3760" y="282"/>
                    </a:lnTo>
                    <a:lnTo>
                      <a:pt x="3772" y="234"/>
                    </a:lnTo>
                    <a:lnTo>
                      <a:pt x="3785" y="236"/>
                    </a:lnTo>
                    <a:lnTo>
                      <a:pt x="3799" y="136"/>
                    </a:lnTo>
                    <a:lnTo>
                      <a:pt x="3812" y="261"/>
                    </a:lnTo>
                    <a:lnTo>
                      <a:pt x="3825" y="259"/>
                    </a:lnTo>
                    <a:lnTo>
                      <a:pt x="3839" y="188"/>
                    </a:lnTo>
                    <a:lnTo>
                      <a:pt x="3850" y="242"/>
                    </a:lnTo>
                    <a:lnTo>
                      <a:pt x="3864" y="236"/>
                    </a:lnTo>
                    <a:lnTo>
                      <a:pt x="3877" y="217"/>
                    </a:lnTo>
                    <a:lnTo>
                      <a:pt x="3891" y="242"/>
                    </a:lnTo>
                    <a:lnTo>
                      <a:pt x="3904" y="229"/>
                    </a:lnTo>
                    <a:lnTo>
                      <a:pt x="3916" y="225"/>
                    </a:lnTo>
                    <a:lnTo>
                      <a:pt x="3929" y="263"/>
                    </a:lnTo>
                    <a:lnTo>
                      <a:pt x="3943" y="229"/>
                    </a:lnTo>
                    <a:lnTo>
                      <a:pt x="3956" y="250"/>
                    </a:lnTo>
                    <a:lnTo>
                      <a:pt x="3969" y="242"/>
                    </a:lnTo>
                    <a:lnTo>
                      <a:pt x="3983" y="282"/>
                    </a:lnTo>
                    <a:lnTo>
                      <a:pt x="3994" y="282"/>
                    </a:lnTo>
                    <a:lnTo>
                      <a:pt x="4008" y="282"/>
                    </a:lnTo>
                    <a:lnTo>
                      <a:pt x="4021" y="282"/>
                    </a:lnTo>
                    <a:lnTo>
                      <a:pt x="4035" y="277"/>
                    </a:lnTo>
                    <a:lnTo>
                      <a:pt x="4048" y="282"/>
                    </a:lnTo>
                    <a:lnTo>
                      <a:pt x="4060" y="242"/>
                    </a:lnTo>
                    <a:lnTo>
                      <a:pt x="4073" y="282"/>
                    </a:lnTo>
                    <a:lnTo>
                      <a:pt x="4087" y="282"/>
                    </a:lnTo>
                    <a:lnTo>
                      <a:pt x="4100" y="240"/>
                    </a:lnTo>
                    <a:lnTo>
                      <a:pt x="4113" y="244"/>
                    </a:lnTo>
                    <a:lnTo>
                      <a:pt x="4127" y="257"/>
                    </a:lnTo>
                    <a:lnTo>
                      <a:pt x="4138" y="261"/>
                    </a:lnTo>
                    <a:lnTo>
                      <a:pt x="4152" y="252"/>
                    </a:lnTo>
                    <a:lnTo>
                      <a:pt x="4165" y="200"/>
                    </a:lnTo>
                    <a:lnTo>
                      <a:pt x="4179" y="267"/>
                    </a:lnTo>
                    <a:lnTo>
                      <a:pt x="4192" y="246"/>
                    </a:lnTo>
                    <a:lnTo>
                      <a:pt x="4206" y="244"/>
                    </a:lnTo>
                    <a:lnTo>
                      <a:pt x="4217" y="236"/>
                    </a:lnTo>
                    <a:lnTo>
                      <a:pt x="4231" y="229"/>
                    </a:lnTo>
                    <a:lnTo>
                      <a:pt x="4244" y="198"/>
                    </a:lnTo>
                    <a:lnTo>
                      <a:pt x="4257" y="219"/>
                    </a:lnTo>
                    <a:lnTo>
                      <a:pt x="4271" y="282"/>
                    </a:lnTo>
                    <a:lnTo>
                      <a:pt x="4282" y="255"/>
                    </a:lnTo>
                    <a:lnTo>
                      <a:pt x="4296" y="204"/>
                    </a:lnTo>
                    <a:lnTo>
                      <a:pt x="4309" y="282"/>
                    </a:lnTo>
                    <a:lnTo>
                      <a:pt x="4323" y="238"/>
                    </a:lnTo>
                    <a:lnTo>
                      <a:pt x="4336" y="282"/>
                    </a:lnTo>
                    <a:lnTo>
                      <a:pt x="4350" y="282"/>
                    </a:lnTo>
                    <a:lnTo>
                      <a:pt x="4361" y="282"/>
                    </a:lnTo>
                    <a:lnTo>
                      <a:pt x="4375" y="277"/>
                    </a:lnTo>
                    <a:lnTo>
                      <a:pt x="4388" y="244"/>
                    </a:lnTo>
                    <a:lnTo>
                      <a:pt x="4401" y="242"/>
                    </a:lnTo>
                    <a:lnTo>
                      <a:pt x="4415" y="221"/>
                    </a:lnTo>
                    <a:lnTo>
                      <a:pt x="4426" y="205"/>
                    </a:lnTo>
                    <a:lnTo>
                      <a:pt x="4440" y="190"/>
                    </a:lnTo>
                    <a:lnTo>
                      <a:pt x="4453" y="134"/>
                    </a:lnTo>
                    <a:lnTo>
                      <a:pt x="4467" y="117"/>
                    </a:lnTo>
                    <a:lnTo>
                      <a:pt x="4480" y="221"/>
                    </a:lnTo>
                    <a:lnTo>
                      <a:pt x="4494" y="188"/>
                    </a:lnTo>
                    <a:lnTo>
                      <a:pt x="4505" y="182"/>
                    </a:lnTo>
                    <a:lnTo>
                      <a:pt x="4519" y="184"/>
                    </a:lnTo>
                    <a:lnTo>
                      <a:pt x="4532" y="196"/>
                    </a:lnTo>
                    <a:lnTo>
                      <a:pt x="4545" y="129"/>
                    </a:lnTo>
                    <a:lnTo>
                      <a:pt x="4559" y="132"/>
                    </a:lnTo>
                    <a:lnTo>
                      <a:pt x="4570" y="106"/>
                    </a:lnTo>
                    <a:lnTo>
                      <a:pt x="4584" y="156"/>
                    </a:lnTo>
                    <a:lnTo>
                      <a:pt x="4597" y="107"/>
                    </a:lnTo>
                    <a:lnTo>
                      <a:pt x="4611" y="156"/>
                    </a:lnTo>
                    <a:lnTo>
                      <a:pt x="4624" y="109"/>
                    </a:lnTo>
                    <a:lnTo>
                      <a:pt x="4638" y="109"/>
                    </a:lnTo>
                    <a:lnTo>
                      <a:pt x="4649" y="119"/>
                    </a:lnTo>
                    <a:lnTo>
                      <a:pt x="4663" y="148"/>
                    </a:lnTo>
                    <a:lnTo>
                      <a:pt x="4676" y="131"/>
                    </a:lnTo>
                    <a:lnTo>
                      <a:pt x="4689" y="159"/>
                    </a:lnTo>
                    <a:lnTo>
                      <a:pt x="4703" y="67"/>
                    </a:lnTo>
                    <a:lnTo>
                      <a:pt x="4714" y="119"/>
                    </a:lnTo>
                    <a:lnTo>
                      <a:pt x="4728" y="182"/>
                    </a:lnTo>
                    <a:lnTo>
                      <a:pt x="4741" y="131"/>
                    </a:lnTo>
                    <a:lnTo>
                      <a:pt x="4755" y="71"/>
                    </a:lnTo>
                    <a:lnTo>
                      <a:pt x="4768" y="148"/>
                    </a:lnTo>
                    <a:lnTo>
                      <a:pt x="4782" y="104"/>
                    </a:lnTo>
                    <a:lnTo>
                      <a:pt x="4793" y="146"/>
                    </a:lnTo>
                    <a:lnTo>
                      <a:pt x="4807" y="196"/>
                    </a:lnTo>
                    <a:lnTo>
                      <a:pt x="4820" y="167"/>
                    </a:lnTo>
                    <a:lnTo>
                      <a:pt x="4833" y="129"/>
                    </a:lnTo>
                    <a:lnTo>
                      <a:pt x="4847" y="161"/>
                    </a:lnTo>
                    <a:lnTo>
                      <a:pt x="4860" y="144"/>
                    </a:lnTo>
                    <a:lnTo>
                      <a:pt x="4872" y="146"/>
                    </a:lnTo>
                    <a:lnTo>
                      <a:pt x="4885" y="194"/>
                    </a:lnTo>
                    <a:lnTo>
                      <a:pt x="4899" y="79"/>
                    </a:lnTo>
                    <a:lnTo>
                      <a:pt x="4912" y="152"/>
                    </a:lnTo>
                    <a:lnTo>
                      <a:pt x="4926" y="96"/>
                    </a:lnTo>
                    <a:lnTo>
                      <a:pt x="4937" y="227"/>
                    </a:lnTo>
                    <a:lnTo>
                      <a:pt x="4951" y="48"/>
                    </a:lnTo>
                    <a:lnTo>
                      <a:pt x="4964" y="77"/>
                    </a:lnTo>
                    <a:lnTo>
                      <a:pt x="4977" y="221"/>
                    </a:lnTo>
                    <a:lnTo>
                      <a:pt x="4991" y="138"/>
                    </a:lnTo>
                    <a:lnTo>
                      <a:pt x="5004" y="167"/>
                    </a:lnTo>
                    <a:lnTo>
                      <a:pt x="5016" y="202"/>
                    </a:lnTo>
                    <a:lnTo>
                      <a:pt x="5029" y="161"/>
                    </a:lnTo>
                    <a:lnTo>
                      <a:pt x="5043" y="134"/>
                    </a:lnTo>
                    <a:lnTo>
                      <a:pt x="5056" y="144"/>
                    </a:lnTo>
                    <a:lnTo>
                      <a:pt x="5070" y="167"/>
                    </a:lnTo>
                    <a:lnTo>
                      <a:pt x="5081" y="182"/>
                    </a:lnTo>
                    <a:lnTo>
                      <a:pt x="5095" y="129"/>
                    </a:lnTo>
                    <a:lnTo>
                      <a:pt x="5108" y="131"/>
                    </a:lnTo>
                    <a:lnTo>
                      <a:pt x="5121" y="111"/>
                    </a:lnTo>
                    <a:lnTo>
                      <a:pt x="5135" y="150"/>
                    </a:lnTo>
                    <a:lnTo>
                      <a:pt x="5148" y="173"/>
                    </a:lnTo>
                    <a:lnTo>
                      <a:pt x="5160" y="73"/>
                    </a:lnTo>
                    <a:lnTo>
                      <a:pt x="5173" y="117"/>
                    </a:lnTo>
                    <a:lnTo>
                      <a:pt x="5187" y="127"/>
                    </a:lnTo>
                    <a:lnTo>
                      <a:pt x="5200" y="111"/>
                    </a:lnTo>
                    <a:lnTo>
                      <a:pt x="5214" y="113"/>
                    </a:lnTo>
                    <a:lnTo>
                      <a:pt x="5225" y="142"/>
                    </a:lnTo>
                    <a:lnTo>
                      <a:pt x="5239" y="67"/>
                    </a:lnTo>
                    <a:lnTo>
                      <a:pt x="5252" y="113"/>
                    </a:lnTo>
                    <a:lnTo>
                      <a:pt x="5265" y="146"/>
                    </a:lnTo>
                    <a:lnTo>
                      <a:pt x="5279" y="83"/>
                    </a:lnTo>
                    <a:lnTo>
                      <a:pt x="5292" y="106"/>
                    </a:lnTo>
                    <a:lnTo>
                      <a:pt x="5304" y="181"/>
                    </a:lnTo>
                    <a:lnTo>
                      <a:pt x="5317" y="182"/>
                    </a:lnTo>
                    <a:lnTo>
                      <a:pt x="5331" y="50"/>
                    </a:lnTo>
                    <a:lnTo>
                      <a:pt x="5344" y="86"/>
                    </a:lnTo>
                    <a:lnTo>
                      <a:pt x="5358" y="113"/>
                    </a:lnTo>
                    <a:lnTo>
                      <a:pt x="5369" y="98"/>
                    </a:lnTo>
                    <a:lnTo>
                      <a:pt x="5383" y="109"/>
                    </a:lnTo>
                    <a:lnTo>
                      <a:pt x="5396" y="56"/>
                    </a:lnTo>
                    <a:lnTo>
                      <a:pt x="5410" y="154"/>
                    </a:lnTo>
                    <a:lnTo>
                      <a:pt x="5410" y="282"/>
                    </a:lnTo>
                    <a:lnTo>
                      <a:pt x="5396" y="282"/>
                    </a:lnTo>
                    <a:lnTo>
                      <a:pt x="5383" y="282"/>
                    </a:lnTo>
                    <a:lnTo>
                      <a:pt x="5369" y="282"/>
                    </a:lnTo>
                    <a:lnTo>
                      <a:pt x="5358" y="282"/>
                    </a:lnTo>
                    <a:lnTo>
                      <a:pt x="5344" y="282"/>
                    </a:lnTo>
                    <a:lnTo>
                      <a:pt x="5331" y="282"/>
                    </a:lnTo>
                    <a:lnTo>
                      <a:pt x="5317" y="282"/>
                    </a:lnTo>
                    <a:lnTo>
                      <a:pt x="5304" y="282"/>
                    </a:lnTo>
                    <a:lnTo>
                      <a:pt x="5292" y="282"/>
                    </a:lnTo>
                    <a:lnTo>
                      <a:pt x="5279" y="282"/>
                    </a:lnTo>
                    <a:lnTo>
                      <a:pt x="5265" y="282"/>
                    </a:lnTo>
                    <a:lnTo>
                      <a:pt x="5252" y="282"/>
                    </a:lnTo>
                    <a:lnTo>
                      <a:pt x="5239" y="282"/>
                    </a:lnTo>
                    <a:lnTo>
                      <a:pt x="5225" y="282"/>
                    </a:lnTo>
                    <a:lnTo>
                      <a:pt x="5214" y="282"/>
                    </a:lnTo>
                    <a:lnTo>
                      <a:pt x="5200" y="282"/>
                    </a:lnTo>
                    <a:lnTo>
                      <a:pt x="5187" y="282"/>
                    </a:lnTo>
                    <a:lnTo>
                      <a:pt x="5173" y="282"/>
                    </a:lnTo>
                    <a:lnTo>
                      <a:pt x="5160" y="282"/>
                    </a:lnTo>
                    <a:lnTo>
                      <a:pt x="5148" y="282"/>
                    </a:lnTo>
                    <a:lnTo>
                      <a:pt x="5135" y="282"/>
                    </a:lnTo>
                    <a:lnTo>
                      <a:pt x="5121" y="282"/>
                    </a:lnTo>
                    <a:lnTo>
                      <a:pt x="5108" y="282"/>
                    </a:lnTo>
                    <a:lnTo>
                      <a:pt x="5095" y="282"/>
                    </a:lnTo>
                    <a:lnTo>
                      <a:pt x="5081" y="282"/>
                    </a:lnTo>
                    <a:lnTo>
                      <a:pt x="5070" y="282"/>
                    </a:lnTo>
                    <a:lnTo>
                      <a:pt x="5056" y="282"/>
                    </a:lnTo>
                    <a:lnTo>
                      <a:pt x="5043" y="282"/>
                    </a:lnTo>
                    <a:lnTo>
                      <a:pt x="5029" y="282"/>
                    </a:lnTo>
                    <a:lnTo>
                      <a:pt x="5016" y="282"/>
                    </a:lnTo>
                    <a:lnTo>
                      <a:pt x="5004" y="282"/>
                    </a:lnTo>
                    <a:lnTo>
                      <a:pt x="4991" y="282"/>
                    </a:lnTo>
                    <a:lnTo>
                      <a:pt x="4977" y="282"/>
                    </a:lnTo>
                    <a:lnTo>
                      <a:pt x="4964" y="282"/>
                    </a:lnTo>
                    <a:lnTo>
                      <a:pt x="4951" y="282"/>
                    </a:lnTo>
                    <a:lnTo>
                      <a:pt x="4937" y="282"/>
                    </a:lnTo>
                    <a:lnTo>
                      <a:pt x="4926" y="282"/>
                    </a:lnTo>
                    <a:lnTo>
                      <a:pt x="4912" y="282"/>
                    </a:lnTo>
                    <a:lnTo>
                      <a:pt x="4899" y="282"/>
                    </a:lnTo>
                    <a:lnTo>
                      <a:pt x="4885" y="282"/>
                    </a:lnTo>
                    <a:lnTo>
                      <a:pt x="4872" y="282"/>
                    </a:lnTo>
                    <a:lnTo>
                      <a:pt x="4860" y="282"/>
                    </a:lnTo>
                    <a:lnTo>
                      <a:pt x="4847" y="282"/>
                    </a:lnTo>
                    <a:lnTo>
                      <a:pt x="4833" y="282"/>
                    </a:lnTo>
                    <a:lnTo>
                      <a:pt x="4820" y="282"/>
                    </a:lnTo>
                    <a:lnTo>
                      <a:pt x="4807" y="282"/>
                    </a:lnTo>
                    <a:lnTo>
                      <a:pt x="4793" y="282"/>
                    </a:lnTo>
                    <a:lnTo>
                      <a:pt x="4782" y="282"/>
                    </a:lnTo>
                    <a:lnTo>
                      <a:pt x="4768" y="282"/>
                    </a:lnTo>
                    <a:lnTo>
                      <a:pt x="4755" y="282"/>
                    </a:lnTo>
                    <a:lnTo>
                      <a:pt x="4741" y="282"/>
                    </a:lnTo>
                    <a:lnTo>
                      <a:pt x="4728" y="282"/>
                    </a:lnTo>
                    <a:lnTo>
                      <a:pt x="4714" y="282"/>
                    </a:lnTo>
                    <a:lnTo>
                      <a:pt x="4703" y="282"/>
                    </a:lnTo>
                    <a:lnTo>
                      <a:pt x="4689" y="282"/>
                    </a:lnTo>
                    <a:lnTo>
                      <a:pt x="4676" y="282"/>
                    </a:lnTo>
                    <a:lnTo>
                      <a:pt x="4663" y="282"/>
                    </a:lnTo>
                    <a:lnTo>
                      <a:pt x="4649" y="282"/>
                    </a:lnTo>
                    <a:lnTo>
                      <a:pt x="4638" y="282"/>
                    </a:lnTo>
                    <a:lnTo>
                      <a:pt x="4624" y="282"/>
                    </a:lnTo>
                    <a:lnTo>
                      <a:pt x="4611" y="282"/>
                    </a:lnTo>
                    <a:lnTo>
                      <a:pt x="4597" y="282"/>
                    </a:lnTo>
                    <a:lnTo>
                      <a:pt x="4584" y="282"/>
                    </a:lnTo>
                    <a:lnTo>
                      <a:pt x="4570" y="282"/>
                    </a:lnTo>
                    <a:lnTo>
                      <a:pt x="4559" y="282"/>
                    </a:lnTo>
                    <a:lnTo>
                      <a:pt x="4545" y="282"/>
                    </a:lnTo>
                    <a:lnTo>
                      <a:pt x="4532" y="282"/>
                    </a:lnTo>
                    <a:lnTo>
                      <a:pt x="4519" y="282"/>
                    </a:lnTo>
                    <a:lnTo>
                      <a:pt x="4505" y="282"/>
                    </a:lnTo>
                    <a:lnTo>
                      <a:pt x="4494" y="282"/>
                    </a:lnTo>
                    <a:lnTo>
                      <a:pt x="4480" y="282"/>
                    </a:lnTo>
                    <a:lnTo>
                      <a:pt x="4467" y="282"/>
                    </a:lnTo>
                    <a:lnTo>
                      <a:pt x="4453" y="282"/>
                    </a:lnTo>
                    <a:lnTo>
                      <a:pt x="4440" y="282"/>
                    </a:lnTo>
                    <a:lnTo>
                      <a:pt x="4426" y="282"/>
                    </a:lnTo>
                    <a:lnTo>
                      <a:pt x="4415" y="282"/>
                    </a:lnTo>
                    <a:lnTo>
                      <a:pt x="4401" y="282"/>
                    </a:lnTo>
                    <a:lnTo>
                      <a:pt x="4388" y="282"/>
                    </a:lnTo>
                    <a:lnTo>
                      <a:pt x="4375" y="282"/>
                    </a:lnTo>
                    <a:lnTo>
                      <a:pt x="4361" y="282"/>
                    </a:lnTo>
                    <a:lnTo>
                      <a:pt x="4350" y="282"/>
                    </a:lnTo>
                    <a:lnTo>
                      <a:pt x="4336" y="282"/>
                    </a:lnTo>
                    <a:lnTo>
                      <a:pt x="4323" y="282"/>
                    </a:lnTo>
                    <a:lnTo>
                      <a:pt x="4309" y="282"/>
                    </a:lnTo>
                    <a:lnTo>
                      <a:pt x="4296" y="282"/>
                    </a:lnTo>
                    <a:lnTo>
                      <a:pt x="4282" y="282"/>
                    </a:lnTo>
                    <a:lnTo>
                      <a:pt x="4271" y="282"/>
                    </a:lnTo>
                    <a:lnTo>
                      <a:pt x="4257" y="282"/>
                    </a:lnTo>
                    <a:lnTo>
                      <a:pt x="4244" y="282"/>
                    </a:lnTo>
                    <a:lnTo>
                      <a:pt x="4231" y="282"/>
                    </a:lnTo>
                    <a:lnTo>
                      <a:pt x="4217" y="282"/>
                    </a:lnTo>
                    <a:lnTo>
                      <a:pt x="4206" y="282"/>
                    </a:lnTo>
                    <a:lnTo>
                      <a:pt x="4192" y="282"/>
                    </a:lnTo>
                    <a:lnTo>
                      <a:pt x="4179" y="282"/>
                    </a:lnTo>
                    <a:lnTo>
                      <a:pt x="4165" y="282"/>
                    </a:lnTo>
                    <a:lnTo>
                      <a:pt x="4152" y="282"/>
                    </a:lnTo>
                    <a:lnTo>
                      <a:pt x="4138" y="282"/>
                    </a:lnTo>
                    <a:lnTo>
                      <a:pt x="4127" y="282"/>
                    </a:lnTo>
                    <a:lnTo>
                      <a:pt x="4113" y="282"/>
                    </a:lnTo>
                    <a:lnTo>
                      <a:pt x="4100" y="282"/>
                    </a:lnTo>
                    <a:lnTo>
                      <a:pt x="4087" y="282"/>
                    </a:lnTo>
                    <a:lnTo>
                      <a:pt x="4073" y="282"/>
                    </a:lnTo>
                    <a:lnTo>
                      <a:pt x="4060" y="282"/>
                    </a:lnTo>
                    <a:lnTo>
                      <a:pt x="4048" y="282"/>
                    </a:lnTo>
                    <a:lnTo>
                      <a:pt x="4035" y="282"/>
                    </a:lnTo>
                    <a:lnTo>
                      <a:pt x="4021" y="282"/>
                    </a:lnTo>
                    <a:lnTo>
                      <a:pt x="4008" y="282"/>
                    </a:lnTo>
                    <a:lnTo>
                      <a:pt x="3994" y="282"/>
                    </a:lnTo>
                    <a:lnTo>
                      <a:pt x="3983" y="282"/>
                    </a:lnTo>
                    <a:lnTo>
                      <a:pt x="3969" y="282"/>
                    </a:lnTo>
                    <a:lnTo>
                      <a:pt x="3956" y="282"/>
                    </a:lnTo>
                    <a:lnTo>
                      <a:pt x="3943" y="282"/>
                    </a:lnTo>
                    <a:lnTo>
                      <a:pt x="3929" y="282"/>
                    </a:lnTo>
                    <a:lnTo>
                      <a:pt x="3916" y="282"/>
                    </a:lnTo>
                    <a:lnTo>
                      <a:pt x="3904" y="282"/>
                    </a:lnTo>
                    <a:lnTo>
                      <a:pt x="3891" y="282"/>
                    </a:lnTo>
                    <a:lnTo>
                      <a:pt x="3877" y="282"/>
                    </a:lnTo>
                    <a:lnTo>
                      <a:pt x="3864" y="282"/>
                    </a:lnTo>
                    <a:lnTo>
                      <a:pt x="3850" y="282"/>
                    </a:lnTo>
                    <a:lnTo>
                      <a:pt x="3839" y="282"/>
                    </a:lnTo>
                    <a:lnTo>
                      <a:pt x="3825" y="282"/>
                    </a:lnTo>
                    <a:lnTo>
                      <a:pt x="3812" y="282"/>
                    </a:lnTo>
                    <a:lnTo>
                      <a:pt x="3799" y="282"/>
                    </a:lnTo>
                    <a:lnTo>
                      <a:pt x="3785" y="282"/>
                    </a:lnTo>
                    <a:lnTo>
                      <a:pt x="3772" y="282"/>
                    </a:lnTo>
                    <a:lnTo>
                      <a:pt x="3760" y="282"/>
                    </a:lnTo>
                    <a:lnTo>
                      <a:pt x="3747" y="282"/>
                    </a:lnTo>
                    <a:lnTo>
                      <a:pt x="3733" y="282"/>
                    </a:lnTo>
                    <a:lnTo>
                      <a:pt x="3720" y="282"/>
                    </a:lnTo>
                    <a:lnTo>
                      <a:pt x="3706" y="282"/>
                    </a:lnTo>
                    <a:lnTo>
                      <a:pt x="3695" y="282"/>
                    </a:lnTo>
                    <a:lnTo>
                      <a:pt x="3681" y="282"/>
                    </a:lnTo>
                    <a:lnTo>
                      <a:pt x="3668" y="282"/>
                    </a:lnTo>
                    <a:lnTo>
                      <a:pt x="3655" y="282"/>
                    </a:lnTo>
                    <a:lnTo>
                      <a:pt x="3641" y="282"/>
                    </a:lnTo>
                    <a:lnTo>
                      <a:pt x="3628" y="282"/>
                    </a:lnTo>
                    <a:lnTo>
                      <a:pt x="3616" y="282"/>
                    </a:lnTo>
                    <a:lnTo>
                      <a:pt x="3603" y="282"/>
                    </a:lnTo>
                    <a:lnTo>
                      <a:pt x="3589" y="282"/>
                    </a:lnTo>
                    <a:lnTo>
                      <a:pt x="3576" y="282"/>
                    </a:lnTo>
                    <a:lnTo>
                      <a:pt x="3562" y="282"/>
                    </a:lnTo>
                    <a:lnTo>
                      <a:pt x="3551" y="282"/>
                    </a:lnTo>
                    <a:lnTo>
                      <a:pt x="3537" y="282"/>
                    </a:lnTo>
                    <a:lnTo>
                      <a:pt x="3524" y="282"/>
                    </a:lnTo>
                    <a:lnTo>
                      <a:pt x="3510" y="282"/>
                    </a:lnTo>
                    <a:lnTo>
                      <a:pt x="3497" y="282"/>
                    </a:lnTo>
                    <a:lnTo>
                      <a:pt x="3484" y="282"/>
                    </a:lnTo>
                    <a:lnTo>
                      <a:pt x="3472" y="282"/>
                    </a:lnTo>
                    <a:lnTo>
                      <a:pt x="3459" y="282"/>
                    </a:lnTo>
                    <a:lnTo>
                      <a:pt x="3445" y="282"/>
                    </a:lnTo>
                    <a:lnTo>
                      <a:pt x="3432" y="282"/>
                    </a:lnTo>
                    <a:lnTo>
                      <a:pt x="3418" y="282"/>
                    </a:lnTo>
                    <a:lnTo>
                      <a:pt x="3405" y="282"/>
                    </a:lnTo>
                    <a:lnTo>
                      <a:pt x="3393" y="282"/>
                    </a:lnTo>
                    <a:lnTo>
                      <a:pt x="3380" y="282"/>
                    </a:lnTo>
                    <a:lnTo>
                      <a:pt x="3366" y="282"/>
                    </a:lnTo>
                    <a:lnTo>
                      <a:pt x="3353" y="282"/>
                    </a:lnTo>
                    <a:lnTo>
                      <a:pt x="3340" y="282"/>
                    </a:lnTo>
                    <a:lnTo>
                      <a:pt x="3328" y="282"/>
                    </a:lnTo>
                    <a:lnTo>
                      <a:pt x="3315" y="282"/>
                    </a:lnTo>
                    <a:lnTo>
                      <a:pt x="3301" y="282"/>
                    </a:lnTo>
                    <a:lnTo>
                      <a:pt x="3288" y="282"/>
                    </a:lnTo>
                    <a:lnTo>
                      <a:pt x="3274" y="282"/>
                    </a:lnTo>
                    <a:lnTo>
                      <a:pt x="3261" y="282"/>
                    </a:lnTo>
                    <a:lnTo>
                      <a:pt x="3249" y="282"/>
                    </a:lnTo>
                    <a:lnTo>
                      <a:pt x="3236" y="282"/>
                    </a:lnTo>
                    <a:lnTo>
                      <a:pt x="3222" y="282"/>
                    </a:lnTo>
                    <a:lnTo>
                      <a:pt x="3209" y="282"/>
                    </a:lnTo>
                    <a:lnTo>
                      <a:pt x="3196" y="282"/>
                    </a:lnTo>
                    <a:lnTo>
                      <a:pt x="3184" y="282"/>
                    </a:lnTo>
                    <a:lnTo>
                      <a:pt x="3171" y="282"/>
                    </a:lnTo>
                    <a:lnTo>
                      <a:pt x="3157" y="282"/>
                    </a:lnTo>
                    <a:lnTo>
                      <a:pt x="3144" y="282"/>
                    </a:lnTo>
                    <a:lnTo>
                      <a:pt x="3130" y="282"/>
                    </a:lnTo>
                    <a:lnTo>
                      <a:pt x="3117" y="282"/>
                    </a:lnTo>
                    <a:lnTo>
                      <a:pt x="3105" y="282"/>
                    </a:lnTo>
                    <a:lnTo>
                      <a:pt x="3092" y="282"/>
                    </a:lnTo>
                    <a:lnTo>
                      <a:pt x="3078" y="282"/>
                    </a:lnTo>
                    <a:lnTo>
                      <a:pt x="3065" y="282"/>
                    </a:lnTo>
                    <a:lnTo>
                      <a:pt x="3052" y="282"/>
                    </a:lnTo>
                    <a:lnTo>
                      <a:pt x="3040" y="282"/>
                    </a:lnTo>
                    <a:lnTo>
                      <a:pt x="3027" y="282"/>
                    </a:lnTo>
                    <a:lnTo>
                      <a:pt x="3013" y="282"/>
                    </a:lnTo>
                    <a:lnTo>
                      <a:pt x="3000" y="282"/>
                    </a:lnTo>
                    <a:lnTo>
                      <a:pt x="2986" y="282"/>
                    </a:lnTo>
                    <a:lnTo>
                      <a:pt x="2973" y="282"/>
                    </a:lnTo>
                    <a:lnTo>
                      <a:pt x="2961" y="282"/>
                    </a:lnTo>
                    <a:lnTo>
                      <a:pt x="2948" y="282"/>
                    </a:lnTo>
                    <a:lnTo>
                      <a:pt x="2934" y="282"/>
                    </a:lnTo>
                    <a:lnTo>
                      <a:pt x="2921" y="282"/>
                    </a:lnTo>
                    <a:lnTo>
                      <a:pt x="2908" y="282"/>
                    </a:lnTo>
                    <a:lnTo>
                      <a:pt x="2896" y="282"/>
                    </a:lnTo>
                    <a:lnTo>
                      <a:pt x="2883" y="282"/>
                    </a:lnTo>
                    <a:lnTo>
                      <a:pt x="2869" y="282"/>
                    </a:lnTo>
                    <a:lnTo>
                      <a:pt x="2856" y="282"/>
                    </a:lnTo>
                    <a:lnTo>
                      <a:pt x="2842" y="282"/>
                    </a:lnTo>
                    <a:lnTo>
                      <a:pt x="2829" y="282"/>
                    </a:lnTo>
                    <a:lnTo>
                      <a:pt x="2817" y="282"/>
                    </a:lnTo>
                    <a:lnTo>
                      <a:pt x="2804" y="282"/>
                    </a:lnTo>
                    <a:lnTo>
                      <a:pt x="2790" y="282"/>
                    </a:lnTo>
                    <a:lnTo>
                      <a:pt x="2777" y="282"/>
                    </a:lnTo>
                    <a:lnTo>
                      <a:pt x="2764" y="282"/>
                    </a:lnTo>
                    <a:lnTo>
                      <a:pt x="2750" y="282"/>
                    </a:lnTo>
                    <a:lnTo>
                      <a:pt x="2739" y="282"/>
                    </a:lnTo>
                    <a:lnTo>
                      <a:pt x="2725" y="282"/>
                    </a:lnTo>
                    <a:lnTo>
                      <a:pt x="2712" y="282"/>
                    </a:lnTo>
                    <a:lnTo>
                      <a:pt x="2698" y="282"/>
                    </a:lnTo>
                    <a:lnTo>
                      <a:pt x="2685" y="282"/>
                    </a:lnTo>
                    <a:lnTo>
                      <a:pt x="2673" y="282"/>
                    </a:lnTo>
                    <a:lnTo>
                      <a:pt x="2660" y="282"/>
                    </a:lnTo>
                    <a:lnTo>
                      <a:pt x="2646" y="282"/>
                    </a:lnTo>
                    <a:lnTo>
                      <a:pt x="2633" y="282"/>
                    </a:lnTo>
                    <a:lnTo>
                      <a:pt x="2620" y="282"/>
                    </a:lnTo>
                    <a:lnTo>
                      <a:pt x="2606" y="282"/>
                    </a:lnTo>
                    <a:lnTo>
                      <a:pt x="2595" y="282"/>
                    </a:lnTo>
                    <a:lnTo>
                      <a:pt x="2581" y="282"/>
                    </a:lnTo>
                    <a:lnTo>
                      <a:pt x="2568" y="282"/>
                    </a:lnTo>
                    <a:lnTo>
                      <a:pt x="2554" y="282"/>
                    </a:lnTo>
                    <a:lnTo>
                      <a:pt x="2541" y="282"/>
                    </a:lnTo>
                    <a:lnTo>
                      <a:pt x="2529" y="282"/>
                    </a:lnTo>
                    <a:lnTo>
                      <a:pt x="2516" y="282"/>
                    </a:lnTo>
                    <a:lnTo>
                      <a:pt x="2502" y="282"/>
                    </a:lnTo>
                    <a:lnTo>
                      <a:pt x="2489" y="282"/>
                    </a:lnTo>
                    <a:lnTo>
                      <a:pt x="2476" y="282"/>
                    </a:lnTo>
                    <a:lnTo>
                      <a:pt x="2462" y="282"/>
                    </a:lnTo>
                    <a:lnTo>
                      <a:pt x="2451" y="282"/>
                    </a:lnTo>
                    <a:lnTo>
                      <a:pt x="2437" y="282"/>
                    </a:lnTo>
                    <a:lnTo>
                      <a:pt x="2424" y="282"/>
                    </a:lnTo>
                    <a:lnTo>
                      <a:pt x="2410" y="282"/>
                    </a:lnTo>
                    <a:lnTo>
                      <a:pt x="2397" y="282"/>
                    </a:lnTo>
                    <a:lnTo>
                      <a:pt x="2385" y="282"/>
                    </a:lnTo>
                    <a:lnTo>
                      <a:pt x="2372" y="282"/>
                    </a:lnTo>
                    <a:lnTo>
                      <a:pt x="2358" y="282"/>
                    </a:lnTo>
                    <a:lnTo>
                      <a:pt x="2345" y="282"/>
                    </a:lnTo>
                    <a:lnTo>
                      <a:pt x="2332" y="282"/>
                    </a:lnTo>
                    <a:lnTo>
                      <a:pt x="2318" y="282"/>
                    </a:lnTo>
                    <a:lnTo>
                      <a:pt x="2307" y="282"/>
                    </a:lnTo>
                    <a:lnTo>
                      <a:pt x="2293" y="282"/>
                    </a:lnTo>
                    <a:lnTo>
                      <a:pt x="2280" y="282"/>
                    </a:lnTo>
                    <a:lnTo>
                      <a:pt x="2266" y="282"/>
                    </a:lnTo>
                    <a:lnTo>
                      <a:pt x="2253" y="282"/>
                    </a:lnTo>
                    <a:lnTo>
                      <a:pt x="2241" y="282"/>
                    </a:lnTo>
                    <a:lnTo>
                      <a:pt x="2228" y="282"/>
                    </a:lnTo>
                    <a:lnTo>
                      <a:pt x="2214" y="282"/>
                    </a:lnTo>
                    <a:lnTo>
                      <a:pt x="2201" y="282"/>
                    </a:lnTo>
                    <a:lnTo>
                      <a:pt x="2188" y="282"/>
                    </a:lnTo>
                    <a:lnTo>
                      <a:pt x="2174" y="282"/>
                    </a:lnTo>
                    <a:lnTo>
                      <a:pt x="2163" y="282"/>
                    </a:lnTo>
                    <a:lnTo>
                      <a:pt x="2149" y="282"/>
                    </a:lnTo>
                    <a:lnTo>
                      <a:pt x="2136" y="282"/>
                    </a:lnTo>
                    <a:lnTo>
                      <a:pt x="2122" y="282"/>
                    </a:lnTo>
                    <a:lnTo>
                      <a:pt x="2109" y="282"/>
                    </a:lnTo>
                    <a:lnTo>
                      <a:pt x="2095" y="282"/>
                    </a:lnTo>
                    <a:lnTo>
                      <a:pt x="2084" y="282"/>
                    </a:lnTo>
                    <a:lnTo>
                      <a:pt x="2070" y="282"/>
                    </a:lnTo>
                    <a:lnTo>
                      <a:pt x="2057" y="282"/>
                    </a:lnTo>
                    <a:lnTo>
                      <a:pt x="2044" y="282"/>
                    </a:lnTo>
                    <a:lnTo>
                      <a:pt x="2030" y="282"/>
                    </a:lnTo>
                    <a:lnTo>
                      <a:pt x="2019" y="282"/>
                    </a:lnTo>
                    <a:lnTo>
                      <a:pt x="2005" y="282"/>
                    </a:lnTo>
                    <a:lnTo>
                      <a:pt x="1992" y="282"/>
                    </a:lnTo>
                    <a:lnTo>
                      <a:pt x="1978" y="282"/>
                    </a:lnTo>
                    <a:lnTo>
                      <a:pt x="1965" y="282"/>
                    </a:lnTo>
                    <a:lnTo>
                      <a:pt x="1951" y="282"/>
                    </a:lnTo>
                    <a:lnTo>
                      <a:pt x="1940" y="282"/>
                    </a:lnTo>
                    <a:lnTo>
                      <a:pt x="1926" y="282"/>
                    </a:lnTo>
                    <a:lnTo>
                      <a:pt x="1913" y="282"/>
                    </a:lnTo>
                    <a:lnTo>
                      <a:pt x="1900" y="282"/>
                    </a:lnTo>
                    <a:lnTo>
                      <a:pt x="1886" y="282"/>
                    </a:lnTo>
                    <a:lnTo>
                      <a:pt x="1875" y="282"/>
                    </a:lnTo>
                    <a:lnTo>
                      <a:pt x="1861" y="282"/>
                    </a:lnTo>
                    <a:lnTo>
                      <a:pt x="1848" y="282"/>
                    </a:lnTo>
                    <a:lnTo>
                      <a:pt x="1834" y="282"/>
                    </a:lnTo>
                    <a:lnTo>
                      <a:pt x="1821" y="282"/>
                    </a:lnTo>
                    <a:lnTo>
                      <a:pt x="1807" y="282"/>
                    </a:lnTo>
                    <a:lnTo>
                      <a:pt x="1796" y="282"/>
                    </a:lnTo>
                    <a:lnTo>
                      <a:pt x="1782" y="282"/>
                    </a:lnTo>
                    <a:lnTo>
                      <a:pt x="1769" y="282"/>
                    </a:lnTo>
                    <a:lnTo>
                      <a:pt x="1755" y="282"/>
                    </a:lnTo>
                    <a:lnTo>
                      <a:pt x="1742" y="282"/>
                    </a:lnTo>
                    <a:lnTo>
                      <a:pt x="1731" y="282"/>
                    </a:lnTo>
                    <a:lnTo>
                      <a:pt x="1717" y="282"/>
                    </a:lnTo>
                    <a:lnTo>
                      <a:pt x="1704" y="282"/>
                    </a:lnTo>
                    <a:lnTo>
                      <a:pt x="1690" y="282"/>
                    </a:lnTo>
                    <a:lnTo>
                      <a:pt x="1677" y="282"/>
                    </a:lnTo>
                    <a:lnTo>
                      <a:pt x="1663" y="282"/>
                    </a:lnTo>
                    <a:lnTo>
                      <a:pt x="1652" y="282"/>
                    </a:lnTo>
                    <a:lnTo>
                      <a:pt x="1638" y="282"/>
                    </a:lnTo>
                    <a:lnTo>
                      <a:pt x="1625" y="282"/>
                    </a:lnTo>
                    <a:lnTo>
                      <a:pt x="1611" y="282"/>
                    </a:lnTo>
                    <a:lnTo>
                      <a:pt x="1598" y="282"/>
                    </a:lnTo>
                    <a:lnTo>
                      <a:pt x="1587" y="282"/>
                    </a:lnTo>
                    <a:lnTo>
                      <a:pt x="1573" y="282"/>
                    </a:lnTo>
                    <a:lnTo>
                      <a:pt x="1560" y="282"/>
                    </a:lnTo>
                    <a:lnTo>
                      <a:pt x="1546" y="282"/>
                    </a:lnTo>
                    <a:lnTo>
                      <a:pt x="1533" y="282"/>
                    </a:lnTo>
                    <a:lnTo>
                      <a:pt x="1519" y="282"/>
                    </a:lnTo>
                    <a:lnTo>
                      <a:pt x="1508" y="282"/>
                    </a:lnTo>
                    <a:lnTo>
                      <a:pt x="1494" y="282"/>
                    </a:lnTo>
                    <a:lnTo>
                      <a:pt x="1481" y="282"/>
                    </a:lnTo>
                    <a:lnTo>
                      <a:pt x="1467" y="282"/>
                    </a:lnTo>
                    <a:lnTo>
                      <a:pt x="1454" y="282"/>
                    </a:lnTo>
                    <a:lnTo>
                      <a:pt x="1441" y="282"/>
                    </a:lnTo>
                    <a:lnTo>
                      <a:pt x="1429" y="282"/>
                    </a:lnTo>
                    <a:lnTo>
                      <a:pt x="1416" y="282"/>
                    </a:lnTo>
                    <a:lnTo>
                      <a:pt x="1402" y="282"/>
                    </a:lnTo>
                    <a:lnTo>
                      <a:pt x="1389" y="282"/>
                    </a:lnTo>
                    <a:lnTo>
                      <a:pt x="1375" y="282"/>
                    </a:lnTo>
                    <a:lnTo>
                      <a:pt x="1364" y="282"/>
                    </a:lnTo>
                    <a:lnTo>
                      <a:pt x="1350" y="282"/>
                    </a:lnTo>
                    <a:lnTo>
                      <a:pt x="1337" y="282"/>
                    </a:lnTo>
                    <a:lnTo>
                      <a:pt x="1323" y="282"/>
                    </a:lnTo>
                    <a:lnTo>
                      <a:pt x="1310" y="282"/>
                    </a:lnTo>
                    <a:lnTo>
                      <a:pt x="1297" y="282"/>
                    </a:lnTo>
                    <a:lnTo>
                      <a:pt x="1285" y="282"/>
                    </a:lnTo>
                    <a:lnTo>
                      <a:pt x="1272" y="282"/>
                    </a:lnTo>
                    <a:lnTo>
                      <a:pt x="1258" y="282"/>
                    </a:lnTo>
                    <a:lnTo>
                      <a:pt x="1245" y="282"/>
                    </a:lnTo>
                    <a:lnTo>
                      <a:pt x="1231" y="282"/>
                    </a:lnTo>
                    <a:lnTo>
                      <a:pt x="1220" y="282"/>
                    </a:lnTo>
                    <a:lnTo>
                      <a:pt x="1206" y="282"/>
                    </a:lnTo>
                    <a:lnTo>
                      <a:pt x="1193" y="282"/>
                    </a:lnTo>
                    <a:lnTo>
                      <a:pt x="1179" y="282"/>
                    </a:lnTo>
                    <a:lnTo>
                      <a:pt x="1166" y="282"/>
                    </a:lnTo>
                    <a:lnTo>
                      <a:pt x="1153" y="282"/>
                    </a:lnTo>
                    <a:lnTo>
                      <a:pt x="1141" y="282"/>
                    </a:lnTo>
                    <a:lnTo>
                      <a:pt x="1128" y="282"/>
                    </a:lnTo>
                    <a:lnTo>
                      <a:pt x="1114" y="282"/>
                    </a:lnTo>
                    <a:lnTo>
                      <a:pt x="1101" y="282"/>
                    </a:lnTo>
                    <a:lnTo>
                      <a:pt x="1087" y="282"/>
                    </a:lnTo>
                    <a:lnTo>
                      <a:pt x="1076" y="282"/>
                    </a:lnTo>
                    <a:lnTo>
                      <a:pt x="1062" y="282"/>
                    </a:lnTo>
                    <a:lnTo>
                      <a:pt x="1049" y="282"/>
                    </a:lnTo>
                    <a:lnTo>
                      <a:pt x="1035" y="282"/>
                    </a:lnTo>
                    <a:lnTo>
                      <a:pt x="1022" y="282"/>
                    </a:lnTo>
                    <a:lnTo>
                      <a:pt x="1009" y="282"/>
                    </a:lnTo>
                    <a:lnTo>
                      <a:pt x="997" y="282"/>
                    </a:lnTo>
                    <a:lnTo>
                      <a:pt x="984" y="282"/>
                    </a:lnTo>
                    <a:lnTo>
                      <a:pt x="970" y="282"/>
                    </a:lnTo>
                    <a:lnTo>
                      <a:pt x="957" y="282"/>
                    </a:lnTo>
                    <a:lnTo>
                      <a:pt x="943" y="282"/>
                    </a:lnTo>
                    <a:lnTo>
                      <a:pt x="932" y="282"/>
                    </a:lnTo>
                    <a:lnTo>
                      <a:pt x="918" y="282"/>
                    </a:lnTo>
                    <a:lnTo>
                      <a:pt x="905" y="282"/>
                    </a:lnTo>
                    <a:lnTo>
                      <a:pt x="891" y="282"/>
                    </a:lnTo>
                    <a:lnTo>
                      <a:pt x="878" y="282"/>
                    </a:lnTo>
                    <a:lnTo>
                      <a:pt x="865" y="282"/>
                    </a:lnTo>
                    <a:lnTo>
                      <a:pt x="853" y="282"/>
                    </a:lnTo>
                    <a:lnTo>
                      <a:pt x="840" y="282"/>
                    </a:lnTo>
                    <a:lnTo>
                      <a:pt x="826" y="282"/>
                    </a:lnTo>
                    <a:lnTo>
                      <a:pt x="813" y="282"/>
                    </a:lnTo>
                    <a:lnTo>
                      <a:pt x="799" y="282"/>
                    </a:lnTo>
                    <a:lnTo>
                      <a:pt x="786" y="282"/>
                    </a:lnTo>
                    <a:lnTo>
                      <a:pt x="774" y="282"/>
                    </a:lnTo>
                    <a:lnTo>
                      <a:pt x="761" y="282"/>
                    </a:lnTo>
                    <a:lnTo>
                      <a:pt x="747" y="282"/>
                    </a:lnTo>
                    <a:lnTo>
                      <a:pt x="734" y="282"/>
                    </a:lnTo>
                    <a:lnTo>
                      <a:pt x="721" y="282"/>
                    </a:lnTo>
                    <a:lnTo>
                      <a:pt x="709" y="282"/>
                    </a:lnTo>
                    <a:lnTo>
                      <a:pt x="696" y="282"/>
                    </a:lnTo>
                    <a:lnTo>
                      <a:pt x="682" y="282"/>
                    </a:lnTo>
                    <a:lnTo>
                      <a:pt x="669" y="282"/>
                    </a:lnTo>
                    <a:lnTo>
                      <a:pt x="655" y="282"/>
                    </a:lnTo>
                    <a:lnTo>
                      <a:pt x="642" y="282"/>
                    </a:lnTo>
                    <a:lnTo>
                      <a:pt x="630" y="282"/>
                    </a:lnTo>
                    <a:lnTo>
                      <a:pt x="617" y="282"/>
                    </a:lnTo>
                    <a:lnTo>
                      <a:pt x="603" y="282"/>
                    </a:lnTo>
                    <a:lnTo>
                      <a:pt x="590" y="282"/>
                    </a:lnTo>
                    <a:lnTo>
                      <a:pt x="577" y="282"/>
                    </a:lnTo>
                    <a:lnTo>
                      <a:pt x="565" y="282"/>
                    </a:lnTo>
                    <a:lnTo>
                      <a:pt x="552" y="282"/>
                    </a:lnTo>
                    <a:lnTo>
                      <a:pt x="538" y="282"/>
                    </a:lnTo>
                    <a:lnTo>
                      <a:pt x="525" y="282"/>
                    </a:lnTo>
                    <a:lnTo>
                      <a:pt x="511" y="282"/>
                    </a:lnTo>
                    <a:lnTo>
                      <a:pt x="498" y="282"/>
                    </a:lnTo>
                    <a:lnTo>
                      <a:pt x="486" y="282"/>
                    </a:lnTo>
                    <a:lnTo>
                      <a:pt x="473" y="282"/>
                    </a:lnTo>
                    <a:lnTo>
                      <a:pt x="459" y="282"/>
                    </a:lnTo>
                    <a:lnTo>
                      <a:pt x="446" y="282"/>
                    </a:lnTo>
                    <a:lnTo>
                      <a:pt x="433" y="282"/>
                    </a:lnTo>
                    <a:lnTo>
                      <a:pt x="421" y="282"/>
                    </a:lnTo>
                    <a:lnTo>
                      <a:pt x="408" y="282"/>
                    </a:lnTo>
                    <a:lnTo>
                      <a:pt x="394" y="282"/>
                    </a:lnTo>
                    <a:lnTo>
                      <a:pt x="381" y="282"/>
                    </a:lnTo>
                    <a:lnTo>
                      <a:pt x="367" y="282"/>
                    </a:lnTo>
                    <a:lnTo>
                      <a:pt x="354" y="282"/>
                    </a:lnTo>
                    <a:lnTo>
                      <a:pt x="342" y="282"/>
                    </a:lnTo>
                    <a:lnTo>
                      <a:pt x="329" y="282"/>
                    </a:lnTo>
                    <a:lnTo>
                      <a:pt x="315" y="282"/>
                    </a:lnTo>
                    <a:lnTo>
                      <a:pt x="302" y="282"/>
                    </a:lnTo>
                    <a:lnTo>
                      <a:pt x="289" y="282"/>
                    </a:lnTo>
                    <a:lnTo>
                      <a:pt x="277" y="282"/>
                    </a:lnTo>
                    <a:lnTo>
                      <a:pt x="264" y="282"/>
                    </a:lnTo>
                    <a:lnTo>
                      <a:pt x="250" y="282"/>
                    </a:lnTo>
                    <a:lnTo>
                      <a:pt x="237" y="282"/>
                    </a:lnTo>
                    <a:lnTo>
                      <a:pt x="223" y="282"/>
                    </a:lnTo>
                    <a:lnTo>
                      <a:pt x="210" y="282"/>
                    </a:lnTo>
                    <a:lnTo>
                      <a:pt x="198" y="282"/>
                    </a:lnTo>
                    <a:lnTo>
                      <a:pt x="185" y="282"/>
                    </a:lnTo>
                    <a:lnTo>
                      <a:pt x="171" y="282"/>
                    </a:lnTo>
                    <a:lnTo>
                      <a:pt x="158" y="282"/>
                    </a:lnTo>
                    <a:lnTo>
                      <a:pt x="145" y="282"/>
                    </a:lnTo>
                    <a:lnTo>
                      <a:pt x="131" y="282"/>
                    </a:lnTo>
                    <a:lnTo>
                      <a:pt x="120" y="282"/>
                    </a:lnTo>
                    <a:lnTo>
                      <a:pt x="106" y="282"/>
                    </a:lnTo>
                    <a:lnTo>
                      <a:pt x="93" y="282"/>
                    </a:lnTo>
                    <a:lnTo>
                      <a:pt x="79" y="282"/>
                    </a:lnTo>
                    <a:lnTo>
                      <a:pt x="66" y="282"/>
                    </a:lnTo>
                    <a:lnTo>
                      <a:pt x="54" y="282"/>
                    </a:lnTo>
                    <a:lnTo>
                      <a:pt x="41" y="282"/>
                    </a:lnTo>
                    <a:lnTo>
                      <a:pt x="27" y="282"/>
                    </a:lnTo>
                    <a:lnTo>
                      <a:pt x="14" y="282"/>
                    </a:lnTo>
                    <a:lnTo>
                      <a:pt x="0" y="282"/>
                    </a:lnTo>
                    <a:lnTo>
                      <a:pt x="0" y="167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1" name="Freeform 79"/>
              <p:cNvSpPr>
                <a:spLocks/>
              </p:cNvSpPr>
              <p:nvPr/>
            </p:nvSpPr>
            <p:spPr bwMode="auto">
              <a:xfrm rot="5400000" flipV="1">
                <a:off x="2673898" y="3650676"/>
                <a:ext cx="5365752" cy="199634"/>
              </a:xfrm>
              <a:custGeom>
                <a:avLst/>
                <a:gdLst>
                  <a:gd name="T0" fmla="*/ 169 w 5410"/>
                  <a:gd name="T1" fmla="*/ 98 h 299"/>
                  <a:gd name="T2" fmla="*/ 352 w 5410"/>
                  <a:gd name="T3" fmla="*/ 111 h 299"/>
                  <a:gd name="T4" fmla="*/ 532 w 5410"/>
                  <a:gd name="T5" fmla="*/ 32 h 299"/>
                  <a:gd name="T6" fmla="*/ 713 w 5410"/>
                  <a:gd name="T7" fmla="*/ 194 h 299"/>
                  <a:gd name="T8" fmla="*/ 895 w 5410"/>
                  <a:gd name="T9" fmla="*/ 217 h 299"/>
                  <a:gd name="T10" fmla="*/ 1076 w 5410"/>
                  <a:gd name="T11" fmla="*/ 165 h 299"/>
                  <a:gd name="T12" fmla="*/ 1256 w 5410"/>
                  <a:gd name="T13" fmla="*/ 61 h 299"/>
                  <a:gd name="T14" fmla="*/ 1437 w 5410"/>
                  <a:gd name="T15" fmla="*/ 299 h 299"/>
                  <a:gd name="T16" fmla="*/ 1619 w 5410"/>
                  <a:gd name="T17" fmla="*/ 299 h 299"/>
                  <a:gd name="T18" fmla="*/ 1800 w 5410"/>
                  <a:gd name="T19" fmla="*/ 192 h 299"/>
                  <a:gd name="T20" fmla="*/ 1980 w 5410"/>
                  <a:gd name="T21" fmla="*/ 299 h 299"/>
                  <a:gd name="T22" fmla="*/ 2163 w 5410"/>
                  <a:gd name="T23" fmla="*/ 276 h 299"/>
                  <a:gd name="T24" fmla="*/ 2343 w 5410"/>
                  <a:gd name="T25" fmla="*/ 299 h 299"/>
                  <a:gd name="T26" fmla="*/ 2524 w 5410"/>
                  <a:gd name="T27" fmla="*/ 232 h 299"/>
                  <a:gd name="T28" fmla="*/ 2706 w 5410"/>
                  <a:gd name="T29" fmla="*/ 296 h 299"/>
                  <a:gd name="T30" fmla="*/ 2886 w 5410"/>
                  <a:gd name="T31" fmla="*/ 288 h 299"/>
                  <a:gd name="T32" fmla="*/ 3067 w 5410"/>
                  <a:gd name="T33" fmla="*/ 299 h 299"/>
                  <a:gd name="T34" fmla="*/ 3249 w 5410"/>
                  <a:gd name="T35" fmla="*/ 253 h 299"/>
                  <a:gd name="T36" fmla="*/ 3430 w 5410"/>
                  <a:gd name="T37" fmla="*/ 292 h 299"/>
                  <a:gd name="T38" fmla="*/ 3610 w 5410"/>
                  <a:gd name="T39" fmla="*/ 297 h 299"/>
                  <a:gd name="T40" fmla="*/ 3791 w 5410"/>
                  <a:gd name="T41" fmla="*/ 290 h 299"/>
                  <a:gd name="T42" fmla="*/ 3973 w 5410"/>
                  <a:gd name="T43" fmla="*/ 194 h 299"/>
                  <a:gd name="T44" fmla="*/ 4154 w 5410"/>
                  <a:gd name="T45" fmla="*/ 169 h 299"/>
                  <a:gd name="T46" fmla="*/ 4334 w 5410"/>
                  <a:gd name="T47" fmla="*/ 94 h 299"/>
                  <a:gd name="T48" fmla="*/ 4517 w 5410"/>
                  <a:gd name="T49" fmla="*/ 130 h 299"/>
                  <a:gd name="T50" fmla="*/ 4697 w 5410"/>
                  <a:gd name="T51" fmla="*/ 136 h 299"/>
                  <a:gd name="T52" fmla="*/ 4878 w 5410"/>
                  <a:gd name="T53" fmla="*/ 67 h 299"/>
                  <a:gd name="T54" fmla="*/ 5060 w 5410"/>
                  <a:gd name="T55" fmla="*/ 144 h 299"/>
                  <a:gd name="T56" fmla="*/ 5241 w 5410"/>
                  <a:gd name="T57" fmla="*/ 124 h 299"/>
                  <a:gd name="T58" fmla="*/ 5410 w 5410"/>
                  <a:gd name="T59" fmla="*/ 299 h 299"/>
                  <a:gd name="T60" fmla="*/ 5229 w 5410"/>
                  <a:gd name="T61" fmla="*/ 299 h 299"/>
                  <a:gd name="T62" fmla="*/ 5047 w 5410"/>
                  <a:gd name="T63" fmla="*/ 299 h 299"/>
                  <a:gd name="T64" fmla="*/ 4866 w 5410"/>
                  <a:gd name="T65" fmla="*/ 299 h 299"/>
                  <a:gd name="T66" fmla="*/ 4686 w 5410"/>
                  <a:gd name="T67" fmla="*/ 299 h 299"/>
                  <a:gd name="T68" fmla="*/ 4503 w 5410"/>
                  <a:gd name="T69" fmla="*/ 299 h 299"/>
                  <a:gd name="T70" fmla="*/ 4323 w 5410"/>
                  <a:gd name="T71" fmla="*/ 299 h 299"/>
                  <a:gd name="T72" fmla="*/ 4142 w 5410"/>
                  <a:gd name="T73" fmla="*/ 299 h 299"/>
                  <a:gd name="T74" fmla="*/ 3960 w 5410"/>
                  <a:gd name="T75" fmla="*/ 299 h 299"/>
                  <a:gd name="T76" fmla="*/ 3779 w 5410"/>
                  <a:gd name="T77" fmla="*/ 299 h 299"/>
                  <a:gd name="T78" fmla="*/ 3599 w 5410"/>
                  <a:gd name="T79" fmla="*/ 299 h 299"/>
                  <a:gd name="T80" fmla="*/ 3418 w 5410"/>
                  <a:gd name="T81" fmla="*/ 299 h 299"/>
                  <a:gd name="T82" fmla="*/ 3236 w 5410"/>
                  <a:gd name="T83" fmla="*/ 299 h 299"/>
                  <a:gd name="T84" fmla="*/ 3055 w 5410"/>
                  <a:gd name="T85" fmla="*/ 299 h 299"/>
                  <a:gd name="T86" fmla="*/ 2875 w 5410"/>
                  <a:gd name="T87" fmla="*/ 299 h 299"/>
                  <a:gd name="T88" fmla="*/ 2693 w 5410"/>
                  <a:gd name="T89" fmla="*/ 299 h 299"/>
                  <a:gd name="T90" fmla="*/ 2512 w 5410"/>
                  <a:gd name="T91" fmla="*/ 299 h 299"/>
                  <a:gd name="T92" fmla="*/ 2332 w 5410"/>
                  <a:gd name="T93" fmla="*/ 299 h 299"/>
                  <a:gd name="T94" fmla="*/ 2149 w 5410"/>
                  <a:gd name="T95" fmla="*/ 299 h 299"/>
                  <a:gd name="T96" fmla="*/ 1969 w 5410"/>
                  <a:gd name="T97" fmla="*/ 299 h 299"/>
                  <a:gd name="T98" fmla="*/ 1788 w 5410"/>
                  <a:gd name="T99" fmla="*/ 299 h 299"/>
                  <a:gd name="T100" fmla="*/ 1606 w 5410"/>
                  <a:gd name="T101" fmla="*/ 299 h 299"/>
                  <a:gd name="T102" fmla="*/ 1425 w 5410"/>
                  <a:gd name="T103" fmla="*/ 299 h 299"/>
                  <a:gd name="T104" fmla="*/ 1245 w 5410"/>
                  <a:gd name="T105" fmla="*/ 299 h 299"/>
                  <a:gd name="T106" fmla="*/ 1064 w 5410"/>
                  <a:gd name="T107" fmla="*/ 299 h 299"/>
                  <a:gd name="T108" fmla="*/ 882 w 5410"/>
                  <a:gd name="T109" fmla="*/ 299 h 299"/>
                  <a:gd name="T110" fmla="*/ 701 w 5410"/>
                  <a:gd name="T111" fmla="*/ 299 h 299"/>
                  <a:gd name="T112" fmla="*/ 521 w 5410"/>
                  <a:gd name="T113" fmla="*/ 299 h 299"/>
                  <a:gd name="T114" fmla="*/ 338 w 5410"/>
                  <a:gd name="T115" fmla="*/ 299 h 299"/>
                  <a:gd name="T116" fmla="*/ 158 w 5410"/>
                  <a:gd name="T117" fmla="*/ 299 h 2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</a:cxnLst>
                <a:rect l="0" t="0" r="r" b="b"/>
                <a:pathLst>
                  <a:path w="5410" h="299">
                    <a:moveTo>
                      <a:pt x="0" y="211"/>
                    </a:moveTo>
                    <a:lnTo>
                      <a:pt x="14" y="123"/>
                    </a:lnTo>
                    <a:lnTo>
                      <a:pt x="25" y="149"/>
                    </a:lnTo>
                    <a:lnTo>
                      <a:pt x="37" y="126"/>
                    </a:lnTo>
                    <a:lnTo>
                      <a:pt x="48" y="121"/>
                    </a:lnTo>
                    <a:lnTo>
                      <a:pt x="62" y="130"/>
                    </a:lnTo>
                    <a:lnTo>
                      <a:pt x="73" y="171"/>
                    </a:lnTo>
                    <a:lnTo>
                      <a:pt x="85" y="136"/>
                    </a:lnTo>
                    <a:lnTo>
                      <a:pt x="98" y="138"/>
                    </a:lnTo>
                    <a:lnTo>
                      <a:pt x="110" y="190"/>
                    </a:lnTo>
                    <a:lnTo>
                      <a:pt x="121" y="69"/>
                    </a:lnTo>
                    <a:lnTo>
                      <a:pt x="133" y="121"/>
                    </a:lnTo>
                    <a:lnTo>
                      <a:pt x="146" y="161"/>
                    </a:lnTo>
                    <a:lnTo>
                      <a:pt x="158" y="151"/>
                    </a:lnTo>
                    <a:lnTo>
                      <a:pt x="169" y="98"/>
                    </a:lnTo>
                    <a:lnTo>
                      <a:pt x="183" y="84"/>
                    </a:lnTo>
                    <a:lnTo>
                      <a:pt x="194" y="109"/>
                    </a:lnTo>
                    <a:lnTo>
                      <a:pt x="206" y="144"/>
                    </a:lnTo>
                    <a:lnTo>
                      <a:pt x="217" y="96"/>
                    </a:lnTo>
                    <a:lnTo>
                      <a:pt x="231" y="101"/>
                    </a:lnTo>
                    <a:lnTo>
                      <a:pt x="242" y="224"/>
                    </a:lnTo>
                    <a:lnTo>
                      <a:pt x="254" y="82"/>
                    </a:lnTo>
                    <a:lnTo>
                      <a:pt x="267" y="71"/>
                    </a:lnTo>
                    <a:lnTo>
                      <a:pt x="279" y="84"/>
                    </a:lnTo>
                    <a:lnTo>
                      <a:pt x="290" y="169"/>
                    </a:lnTo>
                    <a:lnTo>
                      <a:pt x="302" y="57"/>
                    </a:lnTo>
                    <a:lnTo>
                      <a:pt x="315" y="48"/>
                    </a:lnTo>
                    <a:lnTo>
                      <a:pt x="327" y="73"/>
                    </a:lnTo>
                    <a:lnTo>
                      <a:pt x="338" y="50"/>
                    </a:lnTo>
                    <a:lnTo>
                      <a:pt x="352" y="111"/>
                    </a:lnTo>
                    <a:lnTo>
                      <a:pt x="363" y="63"/>
                    </a:lnTo>
                    <a:lnTo>
                      <a:pt x="375" y="73"/>
                    </a:lnTo>
                    <a:lnTo>
                      <a:pt x="386" y="86"/>
                    </a:lnTo>
                    <a:lnTo>
                      <a:pt x="400" y="124"/>
                    </a:lnTo>
                    <a:lnTo>
                      <a:pt x="411" y="76"/>
                    </a:lnTo>
                    <a:lnTo>
                      <a:pt x="423" y="149"/>
                    </a:lnTo>
                    <a:lnTo>
                      <a:pt x="436" y="0"/>
                    </a:lnTo>
                    <a:lnTo>
                      <a:pt x="448" y="76"/>
                    </a:lnTo>
                    <a:lnTo>
                      <a:pt x="459" y="101"/>
                    </a:lnTo>
                    <a:lnTo>
                      <a:pt x="471" y="174"/>
                    </a:lnTo>
                    <a:lnTo>
                      <a:pt x="484" y="88"/>
                    </a:lnTo>
                    <a:lnTo>
                      <a:pt x="496" y="121"/>
                    </a:lnTo>
                    <a:lnTo>
                      <a:pt x="507" y="53"/>
                    </a:lnTo>
                    <a:lnTo>
                      <a:pt x="521" y="75"/>
                    </a:lnTo>
                    <a:lnTo>
                      <a:pt x="532" y="32"/>
                    </a:lnTo>
                    <a:lnTo>
                      <a:pt x="544" y="123"/>
                    </a:lnTo>
                    <a:lnTo>
                      <a:pt x="555" y="38"/>
                    </a:lnTo>
                    <a:lnTo>
                      <a:pt x="569" y="88"/>
                    </a:lnTo>
                    <a:lnTo>
                      <a:pt x="580" y="78"/>
                    </a:lnTo>
                    <a:lnTo>
                      <a:pt x="592" y="178"/>
                    </a:lnTo>
                    <a:lnTo>
                      <a:pt x="605" y="86"/>
                    </a:lnTo>
                    <a:lnTo>
                      <a:pt x="617" y="76"/>
                    </a:lnTo>
                    <a:lnTo>
                      <a:pt x="628" y="165"/>
                    </a:lnTo>
                    <a:lnTo>
                      <a:pt x="642" y="130"/>
                    </a:lnTo>
                    <a:lnTo>
                      <a:pt x="653" y="119"/>
                    </a:lnTo>
                    <a:lnTo>
                      <a:pt x="665" y="115"/>
                    </a:lnTo>
                    <a:lnTo>
                      <a:pt x="676" y="84"/>
                    </a:lnTo>
                    <a:lnTo>
                      <a:pt x="690" y="155"/>
                    </a:lnTo>
                    <a:lnTo>
                      <a:pt x="701" y="128"/>
                    </a:lnTo>
                    <a:lnTo>
                      <a:pt x="713" y="194"/>
                    </a:lnTo>
                    <a:lnTo>
                      <a:pt x="726" y="94"/>
                    </a:lnTo>
                    <a:lnTo>
                      <a:pt x="738" y="86"/>
                    </a:lnTo>
                    <a:lnTo>
                      <a:pt x="749" y="88"/>
                    </a:lnTo>
                    <a:lnTo>
                      <a:pt x="761" y="180"/>
                    </a:lnTo>
                    <a:lnTo>
                      <a:pt x="774" y="280"/>
                    </a:lnTo>
                    <a:lnTo>
                      <a:pt x="786" y="96"/>
                    </a:lnTo>
                    <a:lnTo>
                      <a:pt x="797" y="153"/>
                    </a:lnTo>
                    <a:lnTo>
                      <a:pt x="811" y="123"/>
                    </a:lnTo>
                    <a:lnTo>
                      <a:pt x="822" y="180"/>
                    </a:lnTo>
                    <a:lnTo>
                      <a:pt x="834" y="134"/>
                    </a:lnTo>
                    <a:lnTo>
                      <a:pt x="845" y="134"/>
                    </a:lnTo>
                    <a:lnTo>
                      <a:pt x="859" y="142"/>
                    </a:lnTo>
                    <a:lnTo>
                      <a:pt x="870" y="86"/>
                    </a:lnTo>
                    <a:lnTo>
                      <a:pt x="882" y="167"/>
                    </a:lnTo>
                    <a:lnTo>
                      <a:pt x="895" y="217"/>
                    </a:lnTo>
                    <a:lnTo>
                      <a:pt x="907" y="194"/>
                    </a:lnTo>
                    <a:lnTo>
                      <a:pt x="918" y="151"/>
                    </a:lnTo>
                    <a:lnTo>
                      <a:pt x="930" y="198"/>
                    </a:lnTo>
                    <a:lnTo>
                      <a:pt x="943" y="96"/>
                    </a:lnTo>
                    <a:lnTo>
                      <a:pt x="955" y="73"/>
                    </a:lnTo>
                    <a:lnTo>
                      <a:pt x="966" y="101"/>
                    </a:lnTo>
                    <a:lnTo>
                      <a:pt x="980" y="96"/>
                    </a:lnTo>
                    <a:lnTo>
                      <a:pt x="991" y="182"/>
                    </a:lnTo>
                    <a:lnTo>
                      <a:pt x="1003" y="124"/>
                    </a:lnTo>
                    <a:lnTo>
                      <a:pt x="1014" y="61"/>
                    </a:lnTo>
                    <a:lnTo>
                      <a:pt x="1028" y="126"/>
                    </a:lnTo>
                    <a:lnTo>
                      <a:pt x="1039" y="159"/>
                    </a:lnTo>
                    <a:lnTo>
                      <a:pt x="1051" y="128"/>
                    </a:lnTo>
                    <a:lnTo>
                      <a:pt x="1064" y="217"/>
                    </a:lnTo>
                    <a:lnTo>
                      <a:pt x="1076" y="165"/>
                    </a:lnTo>
                    <a:lnTo>
                      <a:pt x="1087" y="257"/>
                    </a:lnTo>
                    <a:lnTo>
                      <a:pt x="1099" y="207"/>
                    </a:lnTo>
                    <a:lnTo>
                      <a:pt x="1112" y="240"/>
                    </a:lnTo>
                    <a:lnTo>
                      <a:pt x="1124" y="130"/>
                    </a:lnTo>
                    <a:lnTo>
                      <a:pt x="1135" y="92"/>
                    </a:lnTo>
                    <a:lnTo>
                      <a:pt x="1149" y="184"/>
                    </a:lnTo>
                    <a:lnTo>
                      <a:pt x="1160" y="221"/>
                    </a:lnTo>
                    <a:lnTo>
                      <a:pt x="1172" y="292"/>
                    </a:lnTo>
                    <a:lnTo>
                      <a:pt x="1183" y="155"/>
                    </a:lnTo>
                    <a:lnTo>
                      <a:pt x="1197" y="290"/>
                    </a:lnTo>
                    <a:lnTo>
                      <a:pt x="1208" y="282"/>
                    </a:lnTo>
                    <a:lnTo>
                      <a:pt x="1220" y="249"/>
                    </a:lnTo>
                    <a:lnTo>
                      <a:pt x="1233" y="299"/>
                    </a:lnTo>
                    <a:lnTo>
                      <a:pt x="1245" y="165"/>
                    </a:lnTo>
                    <a:lnTo>
                      <a:pt x="1256" y="61"/>
                    </a:lnTo>
                    <a:lnTo>
                      <a:pt x="1268" y="132"/>
                    </a:lnTo>
                    <a:lnTo>
                      <a:pt x="1281" y="163"/>
                    </a:lnTo>
                    <a:lnTo>
                      <a:pt x="1293" y="199"/>
                    </a:lnTo>
                    <a:lnTo>
                      <a:pt x="1304" y="205"/>
                    </a:lnTo>
                    <a:lnTo>
                      <a:pt x="1318" y="105"/>
                    </a:lnTo>
                    <a:lnTo>
                      <a:pt x="1329" y="126"/>
                    </a:lnTo>
                    <a:lnTo>
                      <a:pt x="1341" y="171"/>
                    </a:lnTo>
                    <a:lnTo>
                      <a:pt x="1352" y="186"/>
                    </a:lnTo>
                    <a:lnTo>
                      <a:pt x="1366" y="144"/>
                    </a:lnTo>
                    <a:lnTo>
                      <a:pt x="1377" y="292"/>
                    </a:lnTo>
                    <a:lnTo>
                      <a:pt x="1389" y="299"/>
                    </a:lnTo>
                    <a:lnTo>
                      <a:pt x="1402" y="297"/>
                    </a:lnTo>
                    <a:lnTo>
                      <a:pt x="1414" y="299"/>
                    </a:lnTo>
                    <a:lnTo>
                      <a:pt x="1425" y="288"/>
                    </a:lnTo>
                    <a:lnTo>
                      <a:pt x="1437" y="299"/>
                    </a:lnTo>
                    <a:lnTo>
                      <a:pt x="1450" y="297"/>
                    </a:lnTo>
                    <a:lnTo>
                      <a:pt x="1462" y="284"/>
                    </a:lnTo>
                    <a:lnTo>
                      <a:pt x="1473" y="299"/>
                    </a:lnTo>
                    <a:lnTo>
                      <a:pt x="1487" y="299"/>
                    </a:lnTo>
                    <a:lnTo>
                      <a:pt x="1498" y="288"/>
                    </a:lnTo>
                    <a:lnTo>
                      <a:pt x="1510" y="290"/>
                    </a:lnTo>
                    <a:lnTo>
                      <a:pt x="1521" y="299"/>
                    </a:lnTo>
                    <a:lnTo>
                      <a:pt x="1535" y="190"/>
                    </a:lnTo>
                    <a:lnTo>
                      <a:pt x="1546" y="224"/>
                    </a:lnTo>
                    <a:lnTo>
                      <a:pt x="1558" y="296"/>
                    </a:lnTo>
                    <a:lnTo>
                      <a:pt x="1571" y="294"/>
                    </a:lnTo>
                    <a:lnTo>
                      <a:pt x="1583" y="299"/>
                    </a:lnTo>
                    <a:lnTo>
                      <a:pt x="1594" y="296"/>
                    </a:lnTo>
                    <a:lnTo>
                      <a:pt x="1606" y="299"/>
                    </a:lnTo>
                    <a:lnTo>
                      <a:pt x="1619" y="299"/>
                    </a:lnTo>
                    <a:lnTo>
                      <a:pt x="1631" y="299"/>
                    </a:lnTo>
                    <a:lnTo>
                      <a:pt x="1642" y="299"/>
                    </a:lnTo>
                    <a:lnTo>
                      <a:pt x="1656" y="290"/>
                    </a:lnTo>
                    <a:lnTo>
                      <a:pt x="1667" y="238"/>
                    </a:lnTo>
                    <a:lnTo>
                      <a:pt x="1679" y="299"/>
                    </a:lnTo>
                    <a:lnTo>
                      <a:pt x="1690" y="224"/>
                    </a:lnTo>
                    <a:lnTo>
                      <a:pt x="1704" y="297"/>
                    </a:lnTo>
                    <a:lnTo>
                      <a:pt x="1715" y="294"/>
                    </a:lnTo>
                    <a:lnTo>
                      <a:pt x="1727" y="290"/>
                    </a:lnTo>
                    <a:lnTo>
                      <a:pt x="1740" y="292"/>
                    </a:lnTo>
                    <a:lnTo>
                      <a:pt x="1752" y="299"/>
                    </a:lnTo>
                    <a:lnTo>
                      <a:pt x="1763" y="236"/>
                    </a:lnTo>
                    <a:lnTo>
                      <a:pt x="1777" y="176"/>
                    </a:lnTo>
                    <a:lnTo>
                      <a:pt x="1788" y="178"/>
                    </a:lnTo>
                    <a:lnTo>
                      <a:pt x="1800" y="192"/>
                    </a:lnTo>
                    <a:lnTo>
                      <a:pt x="1811" y="240"/>
                    </a:lnTo>
                    <a:lnTo>
                      <a:pt x="1825" y="163"/>
                    </a:lnTo>
                    <a:lnTo>
                      <a:pt x="1836" y="178"/>
                    </a:lnTo>
                    <a:lnTo>
                      <a:pt x="1848" y="290"/>
                    </a:lnTo>
                    <a:lnTo>
                      <a:pt x="1861" y="176"/>
                    </a:lnTo>
                    <a:lnTo>
                      <a:pt x="1873" y="100"/>
                    </a:lnTo>
                    <a:lnTo>
                      <a:pt x="1884" y="253"/>
                    </a:lnTo>
                    <a:lnTo>
                      <a:pt x="1896" y="249"/>
                    </a:lnTo>
                    <a:lnTo>
                      <a:pt x="1909" y="184"/>
                    </a:lnTo>
                    <a:lnTo>
                      <a:pt x="1921" y="184"/>
                    </a:lnTo>
                    <a:lnTo>
                      <a:pt x="1932" y="253"/>
                    </a:lnTo>
                    <a:lnTo>
                      <a:pt x="1946" y="151"/>
                    </a:lnTo>
                    <a:lnTo>
                      <a:pt x="1957" y="253"/>
                    </a:lnTo>
                    <a:lnTo>
                      <a:pt x="1969" y="265"/>
                    </a:lnTo>
                    <a:lnTo>
                      <a:pt x="1980" y="299"/>
                    </a:lnTo>
                    <a:lnTo>
                      <a:pt x="1994" y="294"/>
                    </a:lnTo>
                    <a:lnTo>
                      <a:pt x="2005" y="282"/>
                    </a:lnTo>
                    <a:lnTo>
                      <a:pt x="2017" y="190"/>
                    </a:lnTo>
                    <a:lnTo>
                      <a:pt x="2030" y="299"/>
                    </a:lnTo>
                    <a:lnTo>
                      <a:pt x="2042" y="246"/>
                    </a:lnTo>
                    <a:lnTo>
                      <a:pt x="2053" y="263"/>
                    </a:lnTo>
                    <a:lnTo>
                      <a:pt x="2065" y="263"/>
                    </a:lnTo>
                    <a:lnTo>
                      <a:pt x="2078" y="280"/>
                    </a:lnTo>
                    <a:lnTo>
                      <a:pt x="2090" y="299"/>
                    </a:lnTo>
                    <a:lnTo>
                      <a:pt x="2101" y="269"/>
                    </a:lnTo>
                    <a:lnTo>
                      <a:pt x="2115" y="294"/>
                    </a:lnTo>
                    <a:lnTo>
                      <a:pt x="2126" y="257"/>
                    </a:lnTo>
                    <a:lnTo>
                      <a:pt x="2138" y="286"/>
                    </a:lnTo>
                    <a:lnTo>
                      <a:pt x="2149" y="255"/>
                    </a:lnTo>
                    <a:lnTo>
                      <a:pt x="2163" y="276"/>
                    </a:lnTo>
                    <a:lnTo>
                      <a:pt x="2174" y="232"/>
                    </a:lnTo>
                    <a:lnTo>
                      <a:pt x="2186" y="286"/>
                    </a:lnTo>
                    <a:lnTo>
                      <a:pt x="2199" y="288"/>
                    </a:lnTo>
                    <a:lnTo>
                      <a:pt x="2211" y="278"/>
                    </a:lnTo>
                    <a:lnTo>
                      <a:pt x="2222" y="299"/>
                    </a:lnTo>
                    <a:lnTo>
                      <a:pt x="2234" y="297"/>
                    </a:lnTo>
                    <a:lnTo>
                      <a:pt x="2247" y="299"/>
                    </a:lnTo>
                    <a:lnTo>
                      <a:pt x="2259" y="297"/>
                    </a:lnTo>
                    <a:lnTo>
                      <a:pt x="2270" y="299"/>
                    </a:lnTo>
                    <a:lnTo>
                      <a:pt x="2284" y="299"/>
                    </a:lnTo>
                    <a:lnTo>
                      <a:pt x="2295" y="282"/>
                    </a:lnTo>
                    <a:lnTo>
                      <a:pt x="2307" y="288"/>
                    </a:lnTo>
                    <a:lnTo>
                      <a:pt x="2318" y="294"/>
                    </a:lnTo>
                    <a:lnTo>
                      <a:pt x="2332" y="299"/>
                    </a:lnTo>
                    <a:lnTo>
                      <a:pt x="2343" y="299"/>
                    </a:lnTo>
                    <a:lnTo>
                      <a:pt x="2355" y="290"/>
                    </a:lnTo>
                    <a:lnTo>
                      <a:pt x="2368" y="290"/>
                    </a:lnTo>
                    <a:lnTo>
                      <a:pt x="2380" y="299"/>
                    </a:lnTo>
                    <a:lnTo>
                      <a:pt x="2391" y="292"/>
                    </a:lnTo>
                    <a:lnTo>
                      <a:pt x="2403" y="286"/>
                    </a:lnTo>
                    <a:lnTo>
                      <a:pt x="2416" y="240"/>
                    </a:lnTo>
                    <a:lnTo>
                      <a:pt x="2428" y="299"/>
                    </a:lnTo>
                    <a:lnTo>
                      <a:pt x="2439" y="259"/>
                    </a:lnTo>
                    <a:lnTo>
                      <a:pt x="2453" y="299"/>
                    </a:lnTo>
                    <a:lnTo>
                      <a:pt x="2464" y="274"/>
                    </a:lnTo>
                    <a:lnTo>
                      <a:pt x="2476" y="292"/>
                    </a:lnTo>
                    <a:lnTo>
                      <a:pt x="2487" y="299"/>
                    </a:lnTo>
                    <a:lnTo>
                      <a:pt x="2501" y="232"/>
                    </a:lnTo>
                    <a:lnTo>
                      <a:pt x="2512" y="299"/>
                    </a:lnTo>
                    <a:lnTo>
                      <a:pt x="2524" y="232"/>
                    </a:lnTo>
                    <a:lnTo>
                      <a:pt x="2537" y="292"/>
                    </a:lnTo>
                    <a:lnTo>
                      <a:pt x="2549" y="290"/>
                    </a:lnTo>
                    <a:lnTo>
                      <a:pt x="2560" y="244"/>
                    </a:lnTo>
                    <a:lnTo>
                      <a:pt x="2572" y="274"/>
                    </a:lnTo>
                    <a:lnTo>
                      <a:pt x="2585" y="297"/>
                    </a:lnTo>
                    <a:lnTo>
                      <a:pt x="2597" y="297"/>
                    </a:lnTo>
                    <a:lnTo>
                      <a:pt x="2608" y="278"/>
                    </a:lnTo>
                    <a:lnTo>
                      <a:pt x="2621" y="299"/>
                    </a:lnTo>
                    <a:lnTo>
                      <a:pt x="2633" y="272"/>
                    </a:lnTo>
                    <a:lnTo>
                      <a:pt x="2645" y="299"/>
                    </a:lnTo>
                    <a:lnTo>
                      <a:pt x="2656" y="240"/>
                    </a:lnTo>
                    <a:lnTo>
                      <a:pt x="2669" y="290"/>
                    </a:lnTo>
                    <a:lnTo>
                      <a:pt x="2681" y="299"/>
                    </a:lnTo>
                    <a:lnTo>
                      <a:pt x="2693" y="299"/>
                    </a:lnTo>
                    <a:lnTo>
                      <a:pt x="2706" y="296"/>
                    </a:lnTo>
                    <a:lnTo>
                      <a:pt x="2717" y="296"/>
                    </a:lnTo>
                    <a:lnTo>
                      <a:pt x="2729" y="267"/>
                    </a:lnTo>
                    <a:lnTo>
                      <a:pt x="2741" y="288"/>
                    </a:lnTo>
                    <a:lnTo>
                      <a:pt x="2754" y="299"/>
                    </a:lnTo>
                    <a:lnTo>
                      <a:pt x="2765" y="232"/>
                    </a:lnTo>
                    <a:lnTo>
                      <a:pt x="2777" y="292"/>
                    </a:lnTo>
                    <a:lnTo>
                      <a:pt x="2790" y="299"/>
                    </a:lnTo>
                    <a:lnTo>
                      <a:pt x="2802" y="230"/>
                    </a:lnTo>
                    <a:lnTo>
                      <a:pt x="2813" y="249"/>
                    </a:lnTo>
                    <a:lnTo>
                      <a:pt x="2825" y="292"/>
                    </a:lnTo>
                    <a:lnTo>
                      <a:pt x="2838" y="278"/>
                    </a:lnTo>
                    <a:lnTo>
                      <a:pt x="2850" y="299"/>
                    </a:lnTo>
                    <a:lnTo>
                      <a:pt x="2861" y="263"/>
                    </a:lnTo>
                    <a:lnTo>
                      <a:pt x="2875" y="272"/>
                    </a:lnTo>
                    <a:lnTo>
                      <a:pt x="2886" y="288"/>
                    </a:lnTo>
                    <a:lnTo>
                      <a:pt x="2898" y="286"/>
                    </a:lnTo>
                    <a:lnTo>
                      <a:pt x="2911" y="292"/>
                    </a:lnTo>
                    <a:lnTo>
                      <a:pt x="2923" y="292"/>
                    </a:lnTo>
                    <a:lnTo>
                      <a:pt x="2934" y="299"/>
                    </a:lnTo>
                    <a:lnTo>
                      <a:pt x="2946" y="211"/>
                    </a:lnTo>
                    <a:lnTo>
                      <a:pt x="2959" y="299"/>
                    </a:lnTo>
                    <a:lnTo>
                      <a:pt x="2971" y="299"/>
                    </a:lnTo>
                    <a:lnTo>
                      <a:pt x="2982" y="299"/>
                    </a:lnTo>
                    <a:lnTo>
                      <a:pt x="2996" y="299"/>
                    </a:lnTo>
                    <a:lnTo>
                      <a:pt x="3007" y="271"/>
                    </a:lnTo>
                    <a:lnTo>
                      <a:pt x="3019" y="265"/>
                    </a:lnTo>
                    <a:lnTo>
                      <a:pt x="3030" y="297"/>
                    </a:lnTo>
                    <a:lnTo>
                      <a:pt x="3044" y="299"/>
                    </a:lnTo>
                    <a:lnTo>
                      <a:pt x="3055" y="294"/>
                    </a:lnTo>
                    <a:lnTo>
                      <a:pt x="3067" y="299"/>
                    </a:lnTo>
                    <a:lnTo>
                      <a:pt x="3080" y="267"/>
                    </a:lnTo>
                    <a:lnTo>
                      <a:pt x="3092" y="296"/>
                    </a:lnTo>
                    <a:lnTo>
                      <a:pt x="3103" y="253"/>
                    </a:lnTo>
                    <a:lnTo>
                      <a:pt x="3115" y="276"/>
                    </a:lnTo>
                    <a:lnTo>
                      <a:pt x="3128" y="290"/>
                    </a:lnTo>
                    <a:lnTo>
                      <a:pt x="3140" y="296"/>
                    </a:lnTo>
                    <a:lnTo>
                      <a:pt x="3151" y="282"/>
                    </a:lnTo>
                    <a:lnTo>
                      <a:pt x="3165" y="299"/>
                    </a:lnTo>
                    <a:lnTo>
                      <a:pt x="3176" y="182"/>
                    </a:lnTo>
                    <a:lnTo>
                      <a:pt x="3188" y="274"/>
                    </a:lnTo>
                    <a:lnTo>
                      <a:pt x="3199" y="296"/>
                    </a:lnTo>
                    <a:lnTo>
                      <a:pt x="3213" y="299"/>
                    </a:lnTo>
                    <a:lnTo>
                      <a:pt x="3224" y="292"/>
                    </a:lnTo>
                    <a:lnTo>
                      <a:pt x="3236" y="299"/>
                    </a:lnTo>
                    <a:lnTo>
                      <a:pt x="3249" y="253"/>
                    </a:lnTo>
                    <a:lnTo>
                      <a:pt x="3261" y="274"/>
                    </a:lnTo>
                    <a:lnTo>
                      <a:pt x="3272" y="297"/>
                    </a:lnTo>
                    <a:lnTo>
                      <a:pt x="3284" y="271"/>
                    </a:lnTo>
                    <a:lnTo>
                      <a:pt x="3297" y="263"/>
                    </a:lnTo>
                    <a:lnTo>
                      <a:pt x="3309" y="299"/>
                    </a:lnTo>
                    <a:lnTo>
                      <a:pt x="3320" y="299"/>
                    </a:lnTo>
                    <a:lnTo>
                      <a:pt x="3334" y="286"/>
                    </a:lnTo>
                    <a:lnTo>
                      <a:pt x="3345" y="294"/>
                    </a:lnTo>
                    <a:lnTo>
                      <a:pt x="3357" y="286"/>
                    </a:lnTo>
                    <a:lnTo>
                      <a:pt x="3368" y="299"/>
                    </a:lnTo>
                    <a:lnTo>
                      <a:pt x="3382" y="299"/>
                    </a:lnTo>
                    <a:lnTo>
                      <a:pt x="3393" y="296"/>
                    </a:lnTo>
                    <a:lnTo>
                      <a:pt x="3405" y="278"/>
                    </a:lnTo>
                    <a:lnTo>
                      <a:pt x="3418" y="211"/>
                    </a:lnTo>
                    <a:lnTo>
                      <a:pt x="3430" y="292"/>
                    </a:lnTo>
                    <a:lnTo>
                      <a:pt x="3441" y="299"/>
                    </a:lnTo>
                    <a:lnTo>
                      <a:pt x="3453" y="299"/>
                    </a:lnTo>
                    <a:lnTo>
                      <a:pt x="3466" y="278"/>
                    </a:lnTo>
                    <a:lnTo>
                      <a:pt x="3478" y="299"/>
                    </a:lnTo>
                    <a:lnTo>
                      <a:pt x="3489" y="299"/>
                    </a:lnTo>
                    <a:lnTo>
                      <a:pt x="3503" y="294"/>
                    </a:lnTo>
                    <a:lnTo>
                      <a:pt x="3514" y="299"/>
                    </a:lnTo>
                    <a:lnTo>
                      <a:pt x="3526" y="299"/>
                    </a:lnTo>
                    <a:lnTo>
                      <a:pt x="3537" y="294"/>
                    </a:lnTo>
                    <a:lnTo>
                      <a:pt x="3551" y="267"/>
                    </a:lnTo>
                    <a:lnTo>
                      <a:pt x="3562" y="247"/>
                    </a:lnTo>
                    <a:lnTo>
                      <a:pt x="3574" y="292"/>
                    </a:lnTo>
                    <a:lnTo>
                      <a:pt x="3587" y="292"/>
                    </a:lnTo>
                    <a:lnTo>
                      <a:pt x="3599" y="226"/>
                    </a:lnTo>
                    <a:lnTo>
                      <a:pt x="3610" y="297"/>
                    </a:lnTo>
                    <a:lnTo>
                      <a:pt x="3622" y="299"/>
                    </a:lnTo>
                    <a:lnTo>
                      <a:pt x="3635" y="296"/>
                    </a:lnTo>
                    <a:lnTo>
                      <a:pt x="3647" y="286"/>
                    </a:lnTo>
                    <a:lnTo>
                      <a:pt x="3658" y="296"/>
                    </a:lnTo>
                    <a:lnTo>
                      <a:pt x="3672" y="272"/>
                    </a:lnTo>
                    <a:lnTo>
                      <a:pt x="3683" y="294"/>
                    </a:lnTo>
                    <a:lnTo>
                      <a:pt x="3695" y="299"/>
                    </a:lnTo>
                    <a:lnTo>
                      <a:pt x="3706" y="299"/>
                    </a:lnTo>
                    <a:lnTo>
                      <a:pt x="3720" y="297"/>
                    </a:lnTo>
                    <a:lnTo>
                      <a:pt x="3731" y="299"/>
                    </a:lnTo>
                    <a:lnTo>
                      <a:pt x="3743" y="299"/>
                    </a:lnTo>
                    <a:lnTo>
                      <a:pt x="3756" y="292"/>
                    </a:lnTo>
                    <a:lnTo>
                      <a:pt x="3768" y="299"/>
                    </a:lnTo>
                    <a:lnTo>
                      <a:pt x="3779" y="276"/>
                    </a:lnTo>
                    <a:lnTo>
                      <a:pt x="3791" y="290"/>
                    </a:lnTo>
                    <a:lnTo>
                      <a:pt x="3804" y="299"/>
                    </a:lnTo>
                    <a:lnTo>
                      <a:pt x="3816" y="299"/>
                    </a:lnTo>
                    <a:lnTo>
                      <a:pt x="3827" y="299"/>
                    </a:lnTo>
                    <a:lnTo>
                      <a:pt x="3841" y="282"/>
                    </a:lnTo>
                    <a:lnTo>
                      <a:pt x="3852" y="294"/>
                    </a:lnTo>
                    <a:lnTo>
                      <a:pt x="3864" y="224"/>
                    </a:lnTo>
                    <a:lnTo>
                      <a:pt x="3875" y="176"/>
                    </a:lnTo>
                    <a:lnTo>
                      <a:pt x="3889" y="226"/>
                    </a:lnTo>
                    <a:lnTo>
                      <a:pt x="3900" y="153"/>
                    </a:lnTo>
                    <a:lnTo>
                      <a:pt x="3912" y="292"/>
                    </a:lnTo>
                    <a:lnTo>
                      <a:pt x="3925" y="296"/>
                    </a:lnTo>
                    <a:lnTo>
                      <a:pt x="3937" y="124"/>
                    </a:lnTo>
                    <a:lnTo>
                      <a:pt x="3948" y="167"/>
                    </a:lnTo>
                    <a:lnTo>
                      <a:pt x="3960" y="163"/>
                    </a:lnTo>
                    <a:lnTo>
                      <a:pt x="3973" y="194"/>
                    </a:lnTo>
                    <a:lnTo>
                      <a:pt x="3985" y="128"/>
                    </a:lnTo>
                    <a:lnTo>
                      <a:pt x="3996" y="171"/>
                    </a:lnTo>
                    <a:lnTo>
                      <a:pt x="4010" y="169"/>
                    </a:lnTo>
                    <a:lnTo>
                      <a:pt x="4021" y="155"/>
                    </a:lnTo>
                    <a:lnTo>
                      <a:pt x="4033" y="230"/>
                    </a:lnTo>
                    <a:lnTo>
                      <a:pt x="4046" y="294"/>
                    </a:lnTo>
                    <a:lnTo>
                      <a:pt x="4058" y="232"/>
                    </a:lnTo>
                    <a:lnTo>
                      <a:pt x="4069" y="213"/>
                    </a:lnTo>
                    <a:lnTo>
                      <a:pt x="4081" y="126"/>
                    </a:lnTo>
                    <a:lnTo>
                      <a:pt x="4094" y="155"/>
                    </a:lnTo>
                    <a:lnTo>
                      <a:pt x="4106" y="247"/>
                    </a:lnTo>
                    <a:lnTo>
                      <a:pt x="4117" y="296"/>
                    </a:lnTo>
                    <a:lnTo>
                      <a:pt x="4131" y="294"/>
                    </a:lnTo>
                    <a:lnTo>
                      <a:pt x="4142" y="294"/>
                    </a:lnTo>
                    <a:lnTo>
                      <a:pt x="4154" y="169"/>
                    </a:lnTo>
                    <a:lnTo>
                      <a:pt x="4165" y="182"/>
                    </a:lnTo>
                    <a:lnTo>
                      <a:pt x="4179" y="292"/>
                    </a:lnTo>
                    <a:lnTo>
                      <a:pt x="4190" y="140"/>
                    </a:lnTo>
                    <a:lnTo>
                      <a:pt x="4202" y="219"/>
                    </a:lnTo>
                    <a:lnTo>
                      <a:pt x="4215" y="169"/>
                    </a:lnTo>
                    <a:lnTo>
                      <a:pt x="4227" y="171"/>
                    </a:lnTo>
                    <a:lnTo>
                      <a:pt x="4238" y="174"/>
                    </a:lnTo>
                    <a:lnTo>
                      <a:pt x="4250" y="51"/>
                    </a:lnTo>
                    <a:lnTo>
                      <a:pt x="4263" y="213"/>
                    </a:lnTo>
                    <a:lnTo>
                      <a:pt x="4275" y="188"/>
                    </a:lnTo>
                    <a:lnTo>
                      <a:pt x="4286" y="146"/>
                    </a:lnTo>
                    <a:lnTo>
                      <a:pt x="4300" y="111"/>
                    </a:lnTo>
                    <a:lnTo>
                      <a:pt x="4311" y="109"/>
                    </a:lnTo>
                    <a:lnTo>
                      <a:pt x="4323" y="134"/>
                    </a:lnTo>
                    <a:lnTo>
                      <a:pt x="4334" y="94"/>
                    </a:lnTo>
                    <a:lnTo>
                      <a:pt x="4348" y="88"/>
                    </a:lnTo>
                    <a:lnTo>
                      <a:pt x="4359" y="115"/>
                    </a:lnTo>
                    <a:lnTo>
                      <a:pt x="4371" y="121"/>
                    </a:lnTo>
                    <a:lnTo>
                      <a:pt x="4384" y="105"/>
                    </a:lnTo>
                    <a:lnTo>
                      <a:pt x="4396" y="169"/>
                    </a:lnTo>
                    <a:lnTo>
                      <a:pt x="4407" y="126"/>
                    </a:lnTo>
                    <a:lnTo>
                      <a:pt x="4419" y="51"/>
                    </a:lnTo>
                    <a:lnTo>
                      <a:pt x="4432" y="59"/>
                    </a:lnTo>
                    <a:lnTo>
                      <a:pt x="4444" y="142"/>
                    </a:lnTo>
                    <a:lnTo>
                      <a:pt x="4455" y="101"/>
                    </a:lnTo>
                    <a:lnTo>
                      <a:pt x="4469" y="94"/>
                    </a:lnTo>
                    <a:lnTo>
                      <a:pt x="4480" y="82"/>
                    </a:lnTo>
                    <a:lnTo>
                      <a:pt x="4492" y="151"/>
                    </a:lnTo>
                    <a:lnTo>
                      <a:pt x="4503" y="101"/>
                    </a:lnTo>
                    <a:lnTo>
                      <a:pt x="4517" y="130"/>
                    </a:lnTo>
                    <a:lnTo>
                      <a:pt x="4528" y="69"/>
                    </a:lnTo>
                    <a:lnTo>
                      <a:pt x="4540" y="134"/>
                    </a:lnTo>
                    <a:lnTo>
                      <a:pt x="4553" y="71"/>
                    </a:lnTo>
                    <a:lnTo>
                      <a:pt x="4565" y="75"/>
                    </a:lnTo>
                    <a:lnTo>
                      <a:pt x="4576" y="167"/>
                    </a:lnTo>
                    <a:lnTo>
                      <a:pt x="4588" y="155"/>
                    </a:lnTo>
                    <a:lnTo>
                      <a:pt x="4601" y="123"/>
                    </a:lnTo>
                    <a:lnTo>
                      <a:pt x="4613" y="51"/>
                    </a:lnTo>
                    <a:lnTo>
                      <a:pt x="4624" y="103"/>
                    </a:lnTo>
                    <a:lnTo>
                      <a:pt x="4638" y="48"/>
                    </a:lnTo>
                    <a:lnTo>
                      <a:pt x="4649" y="107"/>
                    </a:lnTo>
                    <a:lnTo>
                      <a:pt x="4661" y="123"/>
                    </a:lnTo>
                    <a:lnTo>
                      <a:pt x="4672" y="90"/>
                    </a:lnTo>
                    <a:lnTo>
                      <a:pt x="4686" y="188"/>
                    </a:lnTo>
                    <a:lnTo>
                      <a:pt x="4697" y="136"/>
                    </a:lnTo>
                    <a:lnTo>
                      <a:pt x="4709" y="121"/>
                    </a:lnTo>
                    <a:lnTo>
                      <a:pt x="4722" y="107"/>
                    </a:lnTo>
                    <a:lnTo>
                      <a:pt x="4734" y="82"/>
                    </a:lnTo>
                    <a:lnTo>
                      <a:pt x="4745" y="117"/>
                    </a:lnTo>
                    <a:lnTo>
                      <a:pt x="4757" y="148"/>
                    </a:lnTo>
                    <a:lnTo>
                      <a:pt x="4770" y="188"/>
                    </a:lnTo>
                    <a:lnTo>
                      <a:pt x="4782" y="119"/>
                    </a:lnTo>
                    <a:lnTo>
                      <a:pt x="4793" y="174"/>
                    </a:lnTo>
                    <a:lnTo>
                      <a:pt x="4807" y="128"/>
                    </a:lnTo>
                    <a:lnTo>
                      <a:pt x="4818" y="65"/>
                    </a:lnTo>
                    <a:lnTo>
                      <a:pt x="4830" y="142"/>
                    </a:lnTo>
                    <a:lnTo>
                      <a:pt x="4841" y="65"/>
                    </a:lnTo>
                    <a:lnTo>
                      <a:pt x="4855" y="53"/>
                    </a:lnTo>
                    <a:lnTo>
                      <a:pt x="4866" y="174"/>
                    </a:lnTo>
                    <a:lnTo>
                      <a:pt x="4878" y="67"/>
                    </a:lnTo>
                    <a:lnTo>
                      <a:pt x="4891" y="55"/>
                    </a:lnTo>
                    <a:lnTo>
                      <a:pt x="4903" y="107"/>
                    </a:lnTo>
                    <a:lnTo>
                      <a:pt x="4914" y="92"/>
                    </a:lnTo>
                    <a:lnTo>
                      <a:pt x="4926" y="163"/>
                    </a:lnTo>
                    <a:lnTo>
                      <a:pt x="4939" y="130"/>
                    </a:lnTo>
                    <a:lnTo>
                      <a:pt x="4951" y="63"/>
                    </a:lnTo>
                    <a:lnTo>
                      <a:pt x="4962" y="82"/>
                    </a:lnTo>
                    <a:lnTo>
                      <a:pt x="4976" y="69"/>
                    </a:lnTo>
                    <a:lnTo>
                      <a:pt x="4987" y="76"/>
                    </a:lnTo>
                    <a:lnTo>
                      <a:pt x="4999" y="80"/>
                    </a:lnTo>
                    <a:lnTo>
                      <a:pt x="5010" y="90"/>
                    </a:lnTo>
                    <a:lnTo>
                      <a:pt x="5024" y="78"/>
                    </a:lnTo>
                    <a:lnTo>
                      <a:pt x="5035" y="55"/>
                    </a:lnTo>
                    <a:lnTo>
                      <a:pt x="5047" y="109"/>
                    </a:lnTo>
                    <a:lnTo>
                      <a:pt x="5060" y="144"/>
                    </a:lnTo>
                    <a:lnTo>
                      <a:pt x="5072" y="101"/>
                    </a:lnTo>
                    <a:lnTo>
                      <a:pt x="5083" y="73"/>
                    </a:lnTo>
                    <a:lnTo>
                      <a:pt x="5095" y="159"/>
                    </a:lnTo>
                    <a:lnTo>
                      <a:pt x="5108" y="159"/>
                    </a:lnTo>
                    <a:lnTo>
                      <a:pt x="5120" y="88"/>
                    </a:lnTo>
                    <a:lnTo>
                      <a:pt x="5131" y="128"/>
                    </a:lnTo>
                    <a:lnTo>
                      <a:pt x="5145" y="84"/>
                    </a:lnTo>
                    <a:lnTo>
                      <a:pt x="5156" y="151"/>
                    </a:lnTo>
                    <a:lnTo>
                      <a:pt x="5168" y="26"/>
                    </a:lnTo>
                    <a:lnTo>
                      <a:pt x="5179" y="65"/>
                    </a:lnTo>
                    <a:lnTo>
                      <a:pt x="5193" y="182"/>
                    </a:lnTo>
                    <a:lnTo>
                      <a:pt x="5204" y="142"/>
                    </a:lnTo>
                    <a:lnTo>
                      <a:pt x="5216" y="94"/>
                    </a:lnTo>
                    <a:lnTo>
                      <a:pt x="5229" y="80"/>
                    </a:lnTo>
                    <a:lnTo>
                      <a:pt x="5241" y="124"/>
                    </a:lnTo>
                    <a:lnTo>
                      <a:pt x="5252" y="78"/>
                    </a:lnTo>
                    <a:lnTo>
                      <a:pt x="5265" y="186"/>
                    </a:lnTo>
                    <a:lnTo>
                      <a:pt x="5277" y="76"/>
                    </a:lnTo>
                    <a:lnTo>
                      <a:pt x="5289" y="124"/>
                    </a:lnTo>
                    <a:lnTo>
                      <a:pt x="5300" y="140"/>
                    </a:lnTo>
                    <a:lnTo>
                      <a:pt x="5314" y="103"/>
                    </a:lnTo>
                    <a:lnTo>
                      <a:pt x="5325" y="32"/>
                    </a:lnTo>
                    <a:lnTo>
                      <a:pt x="5337" y="148"/>
                    </a:lnTo>
                    <a:lnTo>
                      <a:pt x="5350" y="159"/>
                    </a:lnTo>
                    <a:lnTo>
                      <a:pt x="5362" y="163"/>
                    </a:lnTo>
                    <a:lnTo>
                      <a:pt x="5373" y="213"/>
                    </a:lnTo>
                    <a:lnTo>
                      <a:pt x="5385" y="148"/>
                    </a:lnTo>
                    <a:lnTo>
                      <a:pt x="5398" y="159"/>
                    </a:lnTo>
                    <a:lnTo>
                      <a:pt x="5410" y="117"/>
                    </a:lnTo>
                    <a:lnTo>
                      <a:pt x="5410" y="299"/>
                    </a:lnTo>
                    <a:lnTo>
                      <a:pt x="5398" y="299"/>
                    </a:lnTo>
                    <a:lnTo>
                      <a:pt x="5385" y="299"/>
                    </a:lnTo>
                    <a:lnTo>
                      <a:pt x="5373" y="299"/>
                    </a:lnTo>
                    <a:lnTo>
                      <a:pt x="5362" y="299"/>
                    </a:lnTo>
                    <a:lnTo>
                      <a:pt x="5350" y="299"/>
                    </a:lnTo>
                    <a:lnTo>
                      <a:pt x="5337" y="299"/>
                    </a:lnTo>
                    <a:lnTo>
                      <a:pt x="5325" y="299"/>
                    </a:lnTo>
                    <a:lnTo>
                      <a:pt x="5314" y="299"/>
                    </a:lnTo>
                    <a:lnTo>
                      <a:pt x="5300" y="299"/>
                    </a:lnTo>
                    <a:lnTo>
                      <a:pt x="5289" y="299"/>
                    </a:lnTo>
                    <a:lnTo>
                      <a:pt x="5277" y="299"/>
                    </a:lnTo>
                    <a:lnTo>
                      <a:pt x="5265" y="299"/>
                    </a:lnTo>
                    <a:lnTo>
                      <a:pt x="5252" y="299"/>
                    </a:lnTo>
                    <a:lnTo>
                      <a:pt x="5241" y="299"/>
                    </a:lnTo>
                    <a:lnTo>
                      <a:pt x="5229" y="299"/>
                    </a:lnTo>
                    <a:lnTo>
                      <a:pt x="5216" y="299"/>
                    </a:lnTo>
                    <a:lnTo>
                      <a:pt x="5204" y="299"/>
                    </a:lnTo>
                    <a:lnTo>
                      <a:pt x="5193" y="299"/>
                    </a:lnTo>
                    <a:lnTo>
                      <a:pt x="5179" y="299"/>
                    </a:lnTo>
                    <a:lnTo>
                      <a:pt x="5168" y="299"/>
                    </a:lnTo>
                    <a:lnTo>
                      <a:pt x="5156" y="299"/>
                    </a:lnTo>
                    <a:lnTo>
                      <a:pt x="5145" y="299"/>
                    </a:lnTo>
                    <a:lnTo>
                      <a:pt x="5131" y="299"/>
                    </a:lnTo>
                    <a:lnTo>
                      <a:pt x="5120" y="299"/>
                    </a:lnTo>
                    <a:lnTo>
                      <a:pt x="5108" y="299"/>
                    </a:lnTo>
                    <a:lnTo>
                      <a:pt x="5095" y="299"/>
                    </a:lnTo>
                    <a:lnTo>
                      <a:pt x="5083" y="299"/>
                    </a:lnTo>
                    <a:lnTo>
                      <a:pt x="5072" y="299"/>
                    </a:lnTo>
                    <a:lnTo>
                      <a:pt x="5060" y="299"/>
                    </a:lnTo>
                    <a:lnTo>
                      <a:pt x="5047" y="299"/>
                    </a:lnTo>
                    <a:lnTo>
                      <a:pt x="5035" y="299"/>
                    </a:lnTo>
                    <a:lnTo>
                      <a:pt x="5024" y="299"/>
                    </a:lnTo>
                    <a:lnTo>
                      <a:pt x="5010" y="299"/>
                    </a:lnTo>
                    <a:lnTo>
                      <a:pt x="4999" y="299"/>
                    </a:lnTo>
                    <a:lnTo>
                      <a:pt x="4987" y="299"/>
                    </a:lnTo>
                    <a:lnTo>
                      <a:pt x="4976" y="299"/>
                    </a:lnTo>
                    <a:lnTo>
                      <a:pt x="4962" y="299"/>
                    </a:lnTo>
                    <a:lnTo>
                      <a:pt x="4951" y="299"/>
                    </a:lnTo>
                    <a:lnTo>
                      <a:pt x="4939" y="299"/>
                    </a:lnTo>
                    <a:lnTo>
                      <a:pt x="4926" y="299"/>
                    </a:lnTo>
                    <a:lnTo>
                      <a:pt x="4914" y="299"/>
                    </a:lnTo>
                    <a:lnTo>
                      <a:pt x="4903" y="299"/>
                    </a:lnTo>
                    <a:lnTo>
                      <a:pt x="4891" y="299"/>
                    </a:lnTo>
                    <a:lnTo>
                      <a:pt x="4878" y="299"/>
                    </a:lnTo>
                    <a:lnTo>
                      <a:pt x="4866" y="299"/>
                    </a:lnTo>
                    <a:lnTo>
                      <a:pt x="4855" y="299"/>
                    </a:lnTo>
                    <a:lnTo>
                      <a:pt x="4841" y="299"/>
                    </a:lnTo>
                    <a:lnTo>
                      <a:pt x="4830" y="299"/>
                    </a:lnTo>
                    <a:lnTo>
                      <a:pt x="4818" y="299"/>
                    </a:lnTo>
                    <a:lnTo>
                      <a:pt x="4807" y="299"/>
                    </a:lnTo>
                    <a:lnTo>
                      <a:pt x="4793" y="299"/>
                    </a:lnTo>
                    <a:lnTo>
                      <a:pt x="4782" y="299"/>
                    </a:lnTo>
                    <a:lnTo>
                      <a:pt x="4770" y="299"/>
                    </a:lnTo>
                    <a:lnTo>
                      <a:pt x="4757" y="299"/>
                    </a:lnTo>
                    <a:lnTo>
                      <a:pt x="4745" y="299"/>
                    </a:lnTo>
                    <a:lnTo>
                      <a:pt x="4734" y="299"/>
                    </a:lnTo>
                    <a:lnTo>
                      <a:pt x="4722" y="299"/>
                    </a:lnTo>
                    <a:lnTo>
                      <a:pt x="4709" y="299"/>
                    </a:lnTo>
                    <a:lnTo>
                      <a:pt x="4697" y="299"/>
                    </a:lnTo>
                    <a:lnTo>
                      <a:pt x="4686" y="299"/>
                    </a:lnTo>
                    <a:lnTo>
                      <a:pt x="4672" y="299"/>
                    </a:lnTo>
                    <a:lnTo>
                      <a:pt x="4661" y="299"/>
                    </a:lnTo>
                    <a:lnTo>
                      <a:pt x="4649" y="299"/>
                    </a:lnTo>
                    <a:lnTo>
                      <a:pt x="4638" y="299"/>
                    </a:lnTo>
                    <a:lnTo>
                      <a:pt x="4624" y="299"/>
                    </a:lnTo>
                    <a:lnTo>
                      <a:pt x="4613" y="299"/>
                    </a:lnTo>
                    <a:lnTo>
                      <a:pt x="4601" y="299"/>
                    </a:lnTo>
                    <a:lnTo>
                      <a:pt x="4588" y="299"/>
                    </a:lnTo>
                    <a:lnTo>
                      <a:pt x="4576" y="299"/>
                    </a:lnTo>
                    <a:lnTo>
                      <a:pt x="4565" y="299"/>
                    </a:lnTo>
                    <a:lnTo>
                      <a:pt x="4553" y="299"/>
                    </a:lnTo>
                    <a:lnTo>
                      <a:pt x="4540" y="299"/>
                    </a:lnTo>
                    <a:lnTo>
                      <a:pt x="4528" y="299"/>
                    </a:lnTo>
                    <a:lnTo>
                      <a:pt x="4517" y="299"/>
                    </a:lnTo>
                    <a:lnTo>
                      <a:pt x="4503" y="299"/>
                    </a:lnTo>
                    <a:lnTo>
                      <a:pt x="4492" y="299"/>
                    </a:lnTo>
                    <a:lnTo>
                      <a:pt x="4480" y="299"/>
                    </a:lnTo>
                    <a:lnTo>
                      <a:pt x="4469" y="299"/>
                    </a:lnTo>
                    <a:lnTo>
                      <a:pt x="4455" y="299"/>
                    </a:lnTo>
                    <a:lnTo>
                      <a:pt x="4444" y="299"/>
                    </a:lnTo>
                    <a:lnTo>
                      <a:pt x="4432" y="299"/>
                    </a:lnTo>
                    <a:lnTo>
                      <a:pt x="4419" y="299"/>
                    </a:lnTo>
                    <a:lnTo>
                      <a:pt x="4407" y="299"/>
                    </a:lnTo>
                    <a:lnTo>
                      <a:pt x="4396" y="299"/>
                    </a:lnTo>
                    <a:lnTo>
                      <a:pt x="4384" y="299"/>
                    </a:lnTo>
                    <a:lnTo>
                      <a:pt x="4371" y="299"/>
                    </a:lnTo>
                    <a:lnTo>
                      <a:pt x="4359" y="299"/>
                    </a:lnTo>
                    <a:lnTo>
                      <a:pt x="4348" y="299"/>
                    </a:lnTo>
                    <a:lnTo>
                      <a:pt x="4334" y="299"/>
                    </a:lnTo>
                    <a:lnTo>
                      <a:pt x="4323" y="299"/>
                    </a:lnTo>
                    <a:lnTo>
                      <a:pt x="4311" y="299"/>
                    </a:lnTo>
                    <a:lnTo>
                      <a:pt x="4300" y="299"/>
                    </a:lnTo>
                    <a:lnTo>
                      <a:pt x="4286" y="299"/>
                    </a:lnTo>
                    <a:lnTo>
                      <a:pt x="4275" y="299"/>
                    </a:lnTo>
                    <a:lnTo>
                      <a:pt x="4263" y="299"/>
                    </a:lnTo>
                    <a:lnTo>
                      <a:pt x="4250" y="299"/>
                    </a:lnTo>
                    <a:lnTo>
                      <a:pt x="4238" y="299"/>
                    </a:lnTo>
                    <a:lnTo>
                      <a:pt x="4227" y="299"/>
                    </a:lnTo>
                    <a:lnTo>
                      <a:pt x="4215" y="299"/>
                    </a:lnTo>
                    <a:lnTo>
                      <a:pt x="4202" y="299"/>
                    </a:lnTo>
                    <a:lnTo>
                      <a:pt x="4190" y="299"/>
                    </a:lnTo>
                    <a:lnTo>
                      <a:pt x="4179" y="299"/>
                    </a:lnTo>
                    <a:lnTo>
                      <a:pt x="4165" y="299"/>
                    </a:lnTo>
                    <a:lnTo>
                      <a:pt x="4154" y="299"/>
                    </a:lnTo>
                    <a:lnTo>
                      <a:pt x="4142" y="299"/>
                    </a:lnTo>
                    <a:lnTo>
                      <a:pt x="4131" y="299"/>
                    </a:lnTo>
                    <a:lnTo>
                      <a:pt x="4117" y="299"/>
                    </a:lnTo>
                    <a:lnTo>
                      <a:pt x="4106" y="299"/>
                    </a:lnTo>
                    <a:lnTo>
                      <a:pt x="4094" y="299"/>
                    </a:lnTo>
                    <a:lnTo>
                      <a:pt x="4081" y="299"/>
                    </a:lnTo>
                    <a:lnTo>
                      <a:pt x="4069" y="299"/>
                    </a:lnTo>
                    <a:lnTo>
                      <a:pt x="4058" y="299"/>
                    </a:lnTo>
                    <a:lnTo>
                      <a:pt x="4046" y="299"/>
                    </a:lnTo>
                    <a:lnTo>
                      <a:pt x="4033" y="299"/>
                    </a:lnTo>
                    <a:lnTo>
                      <a:pt x="4021" y="299"/>
                    </a:lnTo>
                    <a:lnTo>
                      <a:pt x="4010" y="299"/>
                    </a:lnTo>
                    <a:lnTo>
                      <a:pt x="3996" y="299"/>
                    </a:lnTo>
                    <a:lnTo>
                      <a:pt x="3985" y="299"/>
                    </a:lnTo>
                    <a:lnTo>
                      <a:pt x="3973" y="299"/>
                    </a:lnTo>
                    <a:lnTo>
                      <a:pt x="3960" y="299"/>
                    </a:lnTo>
                    <a:lnTo>
                      <a:pt x="3948" y="299"/>
                    </a:lnTo>
                    <a:lnTo>
                      <a:pt x="3937" y="299"/>
                    </a:lnTo>
                    <a:lnTo>
                      <a:pt x="3925" y="299"/>
                    </a:lnTo>
                    <a:lnTo>
                      <a:pt x="3912" y="299"/>
                    </a:lnTo>
                    <a:lnTo>
                      <a:pt x="3900" y="299"/>
                    </a:lnTo>
                    <a:lnTo>
                      <a:pt x="3889" y="299"/>
                    </a:lnTo>
                    <a:lnTo>
                      <a:pt x="3875" y="299"/>
                    </a:lnTo>
                    <a:lnTo>
                      <a:pt x="3864" y="299"/>
                    </a:lnTo>
                    <a:lnTo>
                      <a:pt x="3852" y="299"/>
                    </a:lnTo>
                    <a:lnTo>
                      <a:pt x="3841" y="299"/>
                    </a:lnTo>
                    <a:lnTo>
                      <a:pt x="3827" y="299"/>
                    </a:lnTo>
                    <a:lnTo>
                      <a:pt x="3816" y="299"/>
                    </a:lnTo>
                    <a:lnTo>
                      <a:pt x="3804" y="299"/>
                    </a:lnTo>
                    <a:lnTo>
                      <a:pt x="3791" y="299"/>
                    </a:lnTo>
                    <a:lnTo>
                      <a:pt x="3779" y="299"/>
                    </a:lnTo>
                    <a:lnTo>
                      <a:pt x="3768" y="299"/>
                    </a:lnTo>
                    <a:lnTo>
                      <a:pt x="3756" y="299"/>
                    </a:lnTo>
                    <a:lnTo>
                      <a:pt x="3743" y="299"/>
                    </a:lnTo>
                    <a:lnTo>
                      <a:pt x="3731" y="299"/>
                    </a:lnTo>
                    <a:lnTo>
                      <a:pt x="3720" y="299"/>
                    </a:lnTo>
                    <a:lnTo>
                      <a:pt x="3706" y="299"/>
                    </a:lnTo>
                    <a:lnTo>
                      <a:pt x="3695" y="299"/>
                    </a:lnTo>
                    <a:lnTo>
                      <a:pt x="3683" y="299"/>
                    </a:lnTo>
                    <a:lnTo>
                      <a:pt x="3672" y="299"/>
                    </a:lnTo>
                    <a:lnTo>
                      <a:pt x="3658" y="299"/>
                    </a:lnTo>
                    <a:lnTo>
                      <a:pt x="3647" y="299"/>
                    </a:lnTo>
                    <a:lnTo>
                      <a:pt x="3635" y="299"/>
                    </a:lnTo>
                    <a:lnTo>
                      <a:pt x="3622" y="299"/>
                    </a:lnTo>
                    <a:lnTo>
                      <a:pt x="3610" y="299"/>
                    </a:lnTo>
                    <a:lnTo>
                      <a:pt x="3599" y="299"/>
                    </a:lnTo>
                    <a:lnTo>
                      <a:pt x="3587" y="299"/>
                    </a:lnTo>
                    <a:lnTo>
                      <a:pt x="3574" y="299"/>
                    </a:lnTo>
                    <a:lnTo>
                      <a:pt x="3562" y="299"/>
                    </a:lnTo>
                    <a:lnTo>
                      <a:pt x="3551" y="299"/>
                    </a:lnTo>
                    <a:lnTo>
                      <a:pt x="3537" y="299"/>
                    </a:lnTo>
                    <a:lnTo>
                      <a:pt x="3526" y="299"/>
                    </a:lnTo>
                    <a:lnTo>
                      <a:pt x="3514" y="299"/>
                    </a:lnTo>
                    <a:lnTo>
                      <a:pt x="3503" y="299"/>
                    </a:lnTo>
                    <a:lnTo>
                      <a:pt x="3489" y="299"/>
                    </a:lnTo>
                    <a:lnTo>
                      <a:pt x="3478" y="299"/>
                    </a:lnTo>
                    <a:lnTo>
                      <a:pt x="3466" y="299"/>
                    </a:lnTo>
                    <a:lnTo>
                      <a:pt x="3453" y="299"/>
                    </a:lnTo>
                    <a:lnTo>
                      <a:pt x="3441" y="299"/>
                    </a:lnTo>
                    <a:lnTo>
                      <a:pt x="3430" y="299"/>
                    </a:lnTo>
                    <a:lnTo>
                      <a:pt x="3418" y="299"/>
                    </a:lnTo>
                    <a:lnTo>
                      <a:pt x="3405" y="299"/>
                    </a:lnTo>
                    <a:lnTo>
                      <a:pt x="3393" y="299"/>
                    </a:lnTo>
                    <a:lnTo>
                      <a:pt x="3382" y="299"/>
                    </a:lnTo>
                    <a:lnTo>
                      <a:pt x="3368" y="299"/>
                    </a:lnTo>
                    <a:lnTo>
                      <a:pt x="3357" y="299"/>
                    </a:lnTo>
                    <a:lnTo>
                      <a:pt x="3345" y="299"/>
                    </a:lnTo>
                    <a:lnTo>
                      <a:pt x="3334" y="299"/>
                    </a:lnTo>
                    <a:lnTo>
                      <a:pt x="3320" y="299"/>
                    </a:lnTo>
                    <a:lnTo>
                      <a:pt x="3309" y="299"/>
                    </a:lnTo>
                    <a:lnTo>
                      <a:pt x="3297" y="299"/>
                    </a:lnTo>
                    <a:lnTo>
                      <a:pt x="3284" y="299"/>
                    </a:lnTo>
                    <a:lnTo>
                      <a:pt x="3272" y="299"/>
                    </a:lnTo>
                    <a:lnTo>
                      <a:pt x="3261" y="299"/>
                    </a:lnTo>
                    <a:lnTo>
                      <a:pt x="3249" y="299"/>
                    </a:lnTo>
                    <a:lnTo>
                      <a:pt x="3236" y="299"/>
                    </a:lnTo>
                    <a:lnTo>
                      <a:pt x="3224" y="299"/>
                    </a:lnTo>
                    <a:lnTo>
                      <a:pt x="3213" y="299"/>
                    </a:lnTo>
                    <a:lnTo>
                      <a:pt x="3199" y="299"/>
                    </a:lnTo>
                    <a:lnTo>
                      <a:pt x="3188" y="299"/>
                    </a:lnTo>
                    <a:lnTo>
                      <a:pt x="3176" y="299"/>
                    </a:lnTo>
                    <a:lnTo>
                      <a:pt x="3165" y="299"/>
                    </a:lnTo>
                    <a:lnTo>
                      <a:pt x="3151" y="299"/>
                    </a:lnTo>
                    <a:lnTo>
                      <a:pt x="3140" y="299"/>
                    </a:lnTo>
                    <a:lnTo>
                      <a:pt x="3128" y="299"/>
                    </a:lnTo>
                    <a:lnTo>
                      <a:pt x="3115" y="299"/>
                    </a:lnTo>
                    <a:lnTo>
                      <a:pt x="3103" y="299"/>
                    </a:lnTo>
                    <a:lnTo>
                      <a:pt x="3092" y="299"/>
                    </a:lnTo>
                    <a:lnTo>
                      <a:pt x="3080" y="299"/>
                    </a:lnTo>
                    <a:lnTo>
                      <a:pt x="3067" y="299"/>
                    </a:lnTo>
                    <a:lnTo>
                      <a:pt x="3055" y="299"/>
                    </a:lnTo>
                    <a:lnTo>
                      <a:pt x="3044" y="299"/>
                    </a:lnTo>
                    <a:lnTo>
                      <a:pt x="3030" y="299"/>
                    </a:lnTo>
                    <a:lnTo>
                      <a:pt x="3019" y="299"/>
                    </a:lnTo>
                    <a:lnTo>
                      <a:pt x="3007" y="299"/>
                    </a:lnTo>
                    <a:lnTo>
                      <a:pt x="2996" y="299"/>
                    </a:lnTo>
                    <a:lnTo>
                      <a:pt x="2982" y="299"/>
                    </a:lnTo>
                    <a:lnTo>
                      <a:pt x="2971" y="299"/>
                    </a:lnTo>
                    <a:lnTo>
                      <a:pt x="2959" y="299"/>
                    </a:lnTo>
                    <a:lnTo>
                      <a:pt x="2946" y="299"/>
                    </a:lnTo>
                    <a:lnTo>
                      <a:pt x="2934" y="299"/>
                    </a:lnTo>
                    <a:lnTo>
                      <a:pt x="2923" y="299"/>
                    </a:lnTo>
                    <a:lnTo>
                      <a:pt x="2911" y="299"/>
                    </a:lnTo>
                    <a:lnTo>
                      <a:pt x="2898" y="299"/>
                    </a:lnTo>
                    <a:lnTo>
                      <a:pt x="2886" y="299"/>
                    </a:lnTo>
                    <a:lnTo>
                      <a:pt x="2875" y="299"/>
                    </a:lnTo>
                    <a:lnTo>
                      <a:pt x="2861" y="299"/>
                    </a:lnTo>
                    <a:lnTo>
                      <a:pt x="2850" y="299"/>
                    </a:lnTo>
                    <a:lnTo>
                      <a:pt x="2838" y="299"/>
                    </a:lnTo>
                    <a:lnTo>
                      <a:pt x="2825" y="299"/>
                    </a:lnTo>
                    <a:lnTo>
                      <a:pt x="2813" y="299"/>
                    </a:lnTo>
                    <a:lnTo>
                      <a:pt x="2802" y="299"/>
                    </a:lnTo>
                    <a:lnTo>
                      <a:pt x="2790" y="299"/>
                    </a:lnTo>
                    <a:lnTo>
                      <a:pt x="2777" y="299"/>
                    </a:lnTo>
                    <a:lnTo>
                      <a:pt x="2765" y="299"/>
                    </a:lnTo>
                    <a:lnTo>
                      <a:pt x="2754" y="299"/>
                    </a:lnTo>
                    <a:lnTo>
                      <a:pt x="2741" y="299"/>
                    </a:lnTo>
                    <a:lnTo>
                      <a:pt x="2729" y="299"/>
                    </a:lnTo>
                    <a:lnTo>
                      <a:pt x="2717" y="299"/>
                    </a:lnTo>
                    <a:lnTo>
                      <a:pt x="2706" y="299"/>
                    </a:lnTo>
                    <a:lnTo>
                      <a:pt x="2693" y="299"/>
                    </a:lnTo>
                    <a:lnTo>
                      <a:pt x="2681" y="299"/>
                    </a:lnTo>
                    <a:lnTo>
                      <a:pt x="2669" y="299"/>
                    </a:lnTo>
                    <a:lnTo>
                      <a:pt x="2656" y="299"/>
                    </a:lnTo>
                    <a:lnTo>
                      <a:pt x="2645" y="299"/>
                    </a:lnTo>
                    <a:lnTo>
                      <a:pt x="2633" y="299"/>
                    </a:lnTo>
                    <a:lnTo>
                      <a:pt x="2621" y="299"/>
                    </a:lnTo>
                    <a:lnTo>
                      <a:pt x="2608" y="299"/>
                    </a:lnTo>
                    <a:lnTo>
                      <a:pt x="2597" y="299"/>
                    </a:lnTo>
                    <a:lnTo>
                      <a:pt x="2585" y="299"/>
                    </a:lnTo>
                    <a:lnTo>
                      <a:pt x="2572" y="299"/>
                    </a:lnTo>
                    <a:lnTo>
                      <a:pt x="2560" y="299"/>
                    </a:lnTo>
                    <a:lnTo>
                      <a:pt x="2549" y="299"/>
                    </a:lnTo>
                    <a:lnTo>
                      <a:pt x="2537" y="299"/>
                    </a:lnTo>
                    <a:lnTo>
                      <a:pt x="2524" y="299"/>
                    </a:lnTo>
                    <a:lnTo>
                      <a:pt x="2512" y="299"/>
                    </a:lnTo>
                    <a:lnTo>
                      <a:pt x="2501" y="299"/>
                    </a:lnTo>
                    <a:lnTo>
                      <a:pt x="2487" y="299"/>
                    </a:lnTo>
                    <a:lnTo>
                      <a:pt x="2476" y="299"/>
                    </a:lnTo>
                    <a:lnTo>
                      <a:pt x="2464" y="299"/>
                    </a:lnTo>
                    <a:lnTo>
                      <a:pt x="2453" y="299"/>
                    </a:lnTo>
                    <a:lnTo>
                      <a:pt x="2439" y="299"/>
                    </a:lnTo>
                    <a:lnTo>
                      <a:pt x="2428" y="299"/>
                    </a:lnTo>
                    <a:lnTo>
                      <a:pt x="2416" y="299"/>
                    </a:lnTo>
                    <a:lnTo>
                      <a:pt x="2403" y="299"/>
                    </a:lnTo>
                    <a:lnTo>
                      <a:pt x="2391" y="299"/>
                    </a:lnTo>
                    <a:lnTo>
                      <a:pt x="2380" y="299"/>
                    </a:lnTo>
                    <a:lnTo>
                      <a:pt x="2368" y="299"/>
                    </a:lnTo>
                    <a:lnTo>
                      <a:pt x="2355" y="299"/>
                    </a:lnTo>
                    <a:lnTo>
                      <a:pt x="2343" y="299"/>
                    </a:lnTo>
                    <a:lnTo>
                      <a:pt x="2332" y="299"/>
                    </a:lnTo>
                    <a:lnTo>
                      <a:pt x="2318" y="299"/>
                    </a:lnTo>
                    <a:lnTo>
                      <a:pt x="2307" y="299"/>
                    </a:lnTo>
                    <a:lnTo>
                      <a:pt x="2295" y="299"/>
                    </a:lnTo>
                    <a:lnTo>
                      <a:pt x="2284" y="299"/>
                    </a:lnTo>
                    <a:lnTo>
                      <a:pt x="2270" y="299"/>
                    </a:lnTo>
                    <a:lnTo>
                      <a:pt x="2259" y="299"/>
                    </a:lnTo>
                    <a:lnTo>
                      <a:pt x="2247" y="299"/>
                    </a:lnTo>
                    <a:lnTo>
                      <a:pt x="2234" y="299"/>
                    </a:lnTo>
                    <a:lnTo>
                      <a:pt x="2222" y="299"/>
                    </a:lnTo>
                    <a:lnTo>
                      <a:pt x="2211" y="299"/>
                    </a:lnTo>
                    <a:lnTo>
                      <a:pt x="2199" y="299"/>
                    </a:lnTo>
                    <a:lnTo>
                      <a:pt x="2186" y="299"/>
                    </a:lnTo>
                    <a:lnTo>
                      <a:pt x="2174" y="299"/>
                    </a:lnTo>
                    <a:lnTo>
                      <a:pt x="2163" y="299"/>
                    </a:lnTo>
                    <a:lnTo>
                      <a:pt x="2149" y="299"/>
                    </a:lnTo>
                    <a:lnTo>
                      <a:pt x="2138" y="299"/>
                    </a:lnTo>
                    <a:lnTo>
                      <a:pt x="2126" y="299"/>
                    </a:lnTo>
                    <a:lnTo>
                      <a:pt x="2115" y="299"/>
                    </a:lnTo>
                    <a:lnTo>
                      <a:pt x="2101" y="299"/>
                    </a:lnTo>
                    <a:lnTo>
                      <a:pt x="2090" y="299"/>
                    </a:lnTo>
                    <a:lnTo>
                      <a:pt x="2078" y="299"/>
                    </a:lnTo>
                    <a:lnTo>
                      <a:pt x="2065" y="299"/>
                    </a:lnTo>
                    <a:lnTo>
                      <a:pt x="2053" y="299"/>
                    </a:lnTo>
                    <a:lnTo>
                      <a:pt x="2042" y="299"/>
                    </a:lnTo>
                    <a:lnTo>
                      <a:pt x="2030" y="299"/>
                    </a:lnTo>
                    <a:lnTo>
                      <a:pt x="2017" y="299"/>
                    </a:lnTo>
                    <a:lnTo>
                      <a:pt x="2005" y="299"/>
                    </a:lnTo>
                    <a:lnTo>
                      <a:pt x="1994" y="299"/>
                    </a:lnTo>
                    <a:lnTo>
                      <a:pt x="1980" y="299"/>
                    </a:lnTo>
                    <a:lnTo>
                      <a:pt x="1969" y="299"/>
                    </a:lnTo>
                    <a:lnTo>
                      <a:pt x="1957" y="299"/>
                    </a:lnTo>
                    <a:lnTo>
                      <a:pt x="1946" y="299"/>
                    </a:lnTo>
                    <a:lnTo>
                      <a:pt x="1932" y="299"/>
                    </a:lnTo>
                    <a:lnTo>
                      <a:pt x="1921" y="299"/>
                    </a:lnTo>
                    <a:lnTo>
                      <a:pt x="1909" y="299"/>
                    </a:lnTo>
                    <a:lnTo>
                      <a:pt x="1896" y="299"/>
                    </a:lnTo>
                    <a:lnTo>
                      <a:pt x="1884" y="299"/>
                    </a:lnTo>
                    <a:lnTo>
                      <a:pt x="1873" y="299"/>
                    </a:lnTo>
                    <a:lnTo>
                      <a:pt x="1861" y="299"/>
                    </a:lnTo>
                    <a:lnTo>
                      <a:pt x="1848" y="299"/>
                    </a:lnTo>
                    <a:lnTo>
                      <a:pt x="1836" y="299"/>
                    </a:lnTo>
                    <a:lnTo>
                      <a:pt x="1825" y="299"/>
                    </a:lnTo>
                    <a:lnTo>
                      <a:pt x="1811" y="299"/>
                    </a:lnTo>
                    <a:lnTo>
                      <a:pt x="1800" y="299"/>
                    </a:lnTo>
                    <a:lnTo>
                      <a:pt x="1788" y="299"/>
                    </a:lnTo>
                    <a:lnTo>
                      <a:pt x="1777" y="299"/>
                    </a:lnTo>
                    <a:lnTo>
                      <a:pt x="1763" y="299"/>
                    </a:lnTo>
                    <a:lnTo>
                      <a:pt x="1752" y="299"/>
                    </a:lnTo>
                    <a:lnTo>
                      <a:pt x="1740" y="299"/>
                    </a:lnTo>
                    <a:lnTo>
                      <a:pt x="1727" y="299"/>
                    </a:lnTo>
                    <a:lnTo>
                      <a:pt x="1715" y="299"/>
                    </a:lnTo>
                    <a:lnTo>
                      <a:pt x="1704" y="299"/>
                    </a:lnTo>
                    <a:lnTo>
                      <a:pt x="1690" y="299"/>
                    </a:lnTo>
                    <a:lnTo>
                      <a:pt x="1679" y="299"/>
                    </a:lnTo>
                    <a:lnTo>
                      <a:pt x="1667" y="299"/>
                    </a:lnTo>
                    <a:lnTo>
                      <a:pt x="1656" y="299"/>
                    </a:lnTo>
                    <a:lnTo>
                      <a:pt x="1642" y="299"/>
                    </a:lnTo>
                    <a:lnTo>
                      <a:pt x="1631" y="299"/>
                    </a:lnTo>
                    <a:lnTo>
                      <a:pt x="1619" y="299"/>
                    </a:lnTo>
                    <a:lnTo>
                      <a:pt x="1606" y="299"/>
                    </a:lnTo>
                    <a:lnTo>
                      <a:pt x="1594" y="299"/>
                    </a:lnTo>
                    <a:lnTo>
                      <a:pt x="1583" y="299"/>
                    </a:lnTo>
                    <a:lnTo>
                      <a:pt x="1571" y="299"/>
                    </a:lnTo>
                    <a:lnTo>
                      <a:pt x="1558" y="299"/>
                    </a:lnTo>
                    <a:lnTo>
                      <a:pt x="1546" y="299"/>
                    </a:lnTo>
                    <a:lnTo>
                      <a:pt x="1535" y="299"/>
                    </a:lnTo>
                    <a:lnTo>
                      <a:pt x="1521" y="299"/>
                    </a:lnTo>
                    <a:lnTo>
                      <a:pt x="1510" y="299"/>
                    </a:lnTo>
                    <a:lnTo>
                      <a:pt x="1498" y="299"/>
                    </a:lnTo>
                    <a:lnTo>
                      <a:pt x="1487" y="299"/>
                    </a:lnTo>
                    <a:lnTo>
                      <a:pt x="1473" y="299"/>
                    </a:lnTo>
                    <a:lnTo>
                      <a:pt x="1462" y="299"/>
                    </a:lnTo>
                    <a:lnTo>
                      <a:pt x="1450" y="299"/>
                    </a:lnTo>
                    <a:lnTo>
                      <a:pt x="1437" y="299"/>
                    </a:lnTo>
                    <a:lnTo>
                      <a:pt x="1425" y="299"/>
                    </a:lnTo>
                    <a:lnTo>
                      <a:pt x="1414" y="299"/>
                    </a:lnTo>
                    <a:lnTo>
                      <a:pt x="1402" y="299"/>
                    </a:lnTo>
                    <a:lnTo>
                      <a:pt x="1389" y="299"/>
                    </a:lnTo>
                    <a:lnTo>
                      <a:pt x="1377" y="299"/>
                    </a:lnTo>
                    <a:lnTo>
                      <a:pt x="1366" y="299"/>
                    </a:lnTo>
                    <a:lnTo>
                      <a:pt x="1352" y="299"/>
                    </a:lnTo>
                    <a:lnTo>
                      <a:pt x="1341" y="299"/>
                    </a:lnTo>
                    <a:lnTo>
                      <a:pt x="1329" y="299"/>
                    </a:lnTo>
                    <a:lnTo>
                      <a:pt x="1318" y="299"/>
                    </a:lnTo>
                    <a:lnTo>
                      <a:pt x="1304" y="299"/>
                    </a:lnTo>
                    <a:lnTo>
                      <a:pt x="1293" y="299"/>
                    </a:lnTo>
                    <a:lnTo>
                      <a:pt x="1281" y="299"/>
                    </a:lnTo>
                    <a:lnTo>
                      <a:pt x="1268" y="299"/>
                    </a:lnTo>
                    <a:lnTo>
                      <a:pt x="1256" y="299"/>
                    </a:lnTo>
                    <a:lnTo>
                      <a:pt x="1245" y="299"/>
                    </a:lnTo>
                    <a:lnTo>
                      <a:pt x="1233" y="299"/>
                    </a:lnTo>
                    <a:lnTo>
                      <a:pt x="1220" y="299"/>
                    </a:lnTo>
                    <a:lnTo>
                      <a:pt x="1208" y="299"/>
                    </a:lnTo>
                    <a:lnTo>
                      <a:pt x="1197" y="299"/>
                    </a:lnTo>
                    <a:lnTo>
                      <a:pt x="1183" y="299"/>
                    </a:lnTo>
                    <a:lnTo>
                      <a:pt x="1172" y="299"/>
                    </a:lnTo>
                    <a:lnTo>
                      <a:pt x="1160" y="299"/>
                    </a:lnTo>
                    <a:lnTo>
                      <a:pt x="1149" y="299"/>
                    </a:lnTo>
                    <a:lnTo>
                      <a:pt x="1135" y="299"/>
                    </a:lnTo>
                    <a:lnTo>
                      <a:pt x="1124" y="299"/>
                    </a:lnTo>
                    <a:lnTo>
                      <a:pt x="1112" y="299"/>
                    </a:lnTo>
                    <a:lnTo>
                      <a:pt x="1099" y="299"/>
                    </a:lnTo>
                    <a:lnTo>
                      <a:pt x="1087" y="299"/>
                    </a:lnTo>
                    <a:lnTo>
                      <a:pt x="1076" y="299"/>
                    </a:lnTo>
                    <a:lnTo>
                      <a:pt x="1064" y="299"/>
                    </a:lnTo>
                    <a:lnTo>
                      <a:pt x="1051" y="299"/>
                    </a:lnTo>
                    <a:lnTo>
                      <a:pt x="1039" y="299"/>
                    </a:lnTo>
                    <a:lnTo>
                      <a:pt x="1028" y="299"/>
                    </a:lnTo>
                    <a:lnTo>
                      <a:pt x="1014" y="299"/>
                    </a:lnTo>
                    <a:lnTo>
                      <a:pt x="1003" y="299"/>
                    </a:lnTo>
                    <a:lnTo>
                      <a:pt x="991" y="299"/>
                    </a:lnTo>
                    <a:lnTo>
                      <a:pt x="980" y="299"/>
                    </a:lnTo>
                    <a:lnTo>
                      <a:pt x="966" y="299"/>
                    </a:lnTo>
                    <a:lnTo>
                      <a:pt x="955" y="299"/>
                    </a:lnTo>
                    <a:lnTo>
                      <a:pt x="943" y="299"/>
                    </a:lnTo>
                    <a:lnTo>
                      <a:pt x="930" y="299"/>
                    </a:lnTo>
                    <a:lnTo>
                      <a:pt x="918" y="299"/>
                    </a:lnTo>
                    <a:lnTo>
                      <a:pt x="907" y="299"/>
                    </a:lnTo>
                    <a:lnTo>
                      <a:pt x="895" y="299"/>
                    </a:lnTo>
                    <a:lnTo>
                      <a:pt x="882" y="299"/>
                    </a:lnTo>
                    <a:lnTo>
                      <a:pt x="870" y="299"/>
                    </a:lnTo>
                    <a:lnTo>
                      <a:pt x="859" y="299"/>
                    </a:lnTo>
                    <a:lnTo>
                      <a:pt x="845" y="299"/>
                    </a:lnTo>
                    <a:lnTo>
                      <a:pt x="834" y="299"/>
                    </a:lnTo>
                    <a:lnTo>
                      <a:pt x="822" y="299"/>
                    </a:lnTo>
                    <a:lnTo>
                      <a:pt x="811" y="299"/>
                    </a:lnTo>
                    <a:lnTo>
                      <a:pt x="797" y="299"/>
                    </a:lnTo>
                    <a:lnTo>
                      <a:pt x="786" y="299"/>
                    </a:lnTo>
                    <a:lnTo>
                      <a:pt x="774" y="299"/>
                    </a:lnTo>
                    <a:lnTo>
                      <a:pt x="761" y="299"/>
                    </a:lnTo>
                    <a:lnTo>
                      <a:pt x="749" y="299"/>
                    </a:lnTo>
                    <a:lnTo>
                      <a:pt x="738" y="299"/>
                    </a:lnTo>
                    <a:lnTo>
                      <a:pt x="726" y="299"/>
                    </a:lnTo>
                    <a:lnTo>
                      <a:pt x="713" y="299"/>
                    </a:lnTo>
                    <a:lnTo>
                      <a:pt x="701" y="299"/>
                    </a:lnTo>
                    <a:lnTo>
                      <a:pt x="690" y="299"/>
                    </a:lnTo>
                    <a:lnTo>
                      <a:pt x="676" y="299"/>
                    </a:lnTo>
                    <a:lnTo>
                      <a:pt x="665" y="299"/>
                    </a:lnTo>
                    <a:lnTo>
                      <a:pt x="653" y="299"/>
                    </a:lnTo>
                    <a:lnTo>
                      <a:pt x="642" y="299"/>
                    </a:lnTo>
                    <a:lnTo>
                      <a:pt x="628" y="299"/>
                    </a:lnTo>
                    <a:lnTo>
                      <a:pt x="617" y="299"/>
                    </a:lnTo>
                    <a:lnTo>
                      <a:pt x="605" y="299"/>
                    </a:lnTo>
                    <a:lnTo>
                      <a:pt x="592" y="299"/>
                    </a:lnTo>
                    <a:lnTo>
                      <a:pt x="580" y="299"/>
                    </a:lnTo>
                    <a:lnTo>
                      <a:pt x="569" y="299"/>
                    </a:lnTo>
                    <a:lnTo>
                      <a:pt x="555" y="299"/>
                    </a:lnTo>
                    <a:lnTo>
                      <a:pt x="544" y="299"/>
                    </a:lnTo>
                    <a:lnTo>
                      <a:pt x="532" y="299"/>
                    </a:lnTo>
                    <a:lnTo>
                      <a:pt x="521" y="299"/>
                    </a:lnTo>
                    <a:lnTo>
                      <a:pt x="507" y="299"/>
                    </a:lnTo>
                    <a:lnTo>
                      <a:pt x="496" y="299"/>
                    </a:lnTo>
                    <a:lnTo>
                      <a:pt x="484" y="299"/>
                    </a:lnTo>
                    <a:lnTo>
                      <a:pt x="471" y="299"/>
                    </a:lnTo>
                    <a:lnTo>
                      <a:pt x="459" y="299"/>
                    </a:lnTo>
                    <a:lnTo>
                      <a:pt x="448" y="299"/>
                    </a:lnTo>
                    <a:lnTo>
                      <a:pt x="436" y="299"/>
                    </a:lnTo>
                    <a:lnTo>
                      <a:pt x="423" y="299"/>
                    </a:lnTo>
                    <a:lnTo>
                      <a:pt x="411" y="299"/>
                    </a:lnTo>
                    <a:lnTo>
                      <a:pt x="400" y="299"/>
                    </a:lnTo>
                    <a:lnTo>
                      <a:pt x="386" y="299"/>
                    </a:lnTo>
                    <a:lnTo>
                      <a:pt x="375" y="299"/>
                    </a:lnTo>
                    <a:lnTo>
                      <a:pt x="363" y="299"/>
                    </a:lnTo>
                    <a:lnTo>
                      <a:pt x="352" y="299"/>
                    </a:lnTo>
                    <a:lnTo>
                      <a:pt x="338" y="299"/>
                    </a:lnTo>
                    <a:lnTo>
                      <a:pt x="327" y="299"/>
                    </a:lnTo>
                    <a:lnTo>
                      <a:pt x="315" y="299"/>
                    </a:lnTo>
                    <a:lnTo>
                      <a:pt x="302" y="299"/>
                    </a:lnTo>
                    <a:lnTo>
                      <a:pt x="290" y="299"/>
                    </a:lnTo>
                    <a:lnTo>
                      <a:pt x="279" y="299"/>
                    </a:lnTo>
                    <a:lnTo>
                      <a:pt x="267" y="299"/>
                    </a:lnTo>
                    <a:lnTo>
                      <a:pt x="254" y="299"/>
                    </a:lnTo>
                    <a:lnTo>
                      <a:pt x="242" y="299"/>
                    </a:lnTo>
                    <a:lnTo>
                      <a:pt x="231" y="299"/>
                    </a:lnTo>
                    <a:lnTo>
                      <a:pt x="217" y="299"/>
                    </a:lnTo>
                    <a:lnTo>
                      <a:pt x="206" y="299"/>
                    </a:lnTo>
                    <a:lnTo>
                      <a:pt x="194" y="299"/>
                    </a:lnTo>
                    <a:lnTo>
                      <a:pt x="183" y="299"/>
                    </a:lnTo>
                    <a:lnTo>
                      <a:pt x="169" y="299"/>
                    </a:lnTo>
                    <a:lnTo>
                      <a:pt x="158" y="299"/>
                    </a:lnTo>
                    <a:lnTo>
                      <a:pt x="146" y="299"/>
                    </a:lnTo>
                    <a:lnTo>
                      <a:pt x="133" y="299"/>
                    </a:lnTo>
                    <a:lnTo>
                      <a:pt x="121" y="299"/>
                    </a:lnTo>
                    <a:lnTo>
                      <a:pt x="110" y="299"/>
                    </a:lnTo>
                    <a:lnTo>
                      <a:pt x="98" y="299"/>
                    </a:lnTo>
                    <a:lnTo>
                      <a:pt x="85" y="299"/>
                    </a:lnTo>
                    <a:lnTo>
                      <a:pt x="73" y="299"/>
                    </a:lnTo>
                    <a:lnTo>
                      <a:pt x="62" y="299"/>
                    </a:lnTo>
                    <a:lnTo>
                      <a:pt x="48" y="299"/>
                    </a:lnTo>
                    <a:lnTo>
                      <a:pt x="37" y="299"/>
                    </a:lnTo>
                    <a:lnTo>
                      <a:pt x="25" y="299"/>
                    </a:lnTo>
                    <a:lnTo>
                      <a:pt x="14" y="299"/>
                    </a:lnTo>
                    <a:lnTo>
                      <a:pt x="0" y="299"/>
                    </a:lnTo>
                    <a:lnTo>
                      <a:pt x="0" y="211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2" name="Freeform 61"/>
              <p:cNvSpPr>
                <a:spLocks/>
              </p:cNvSpPr>
              <p:nvPr/>
            </p:nvSpPr>
            <p:spPr bwMode="auto">
              <a:xfrm rot="5400000" flipV="1">
                <a:off x="1792137" y="3212376"/>
                <a:ext cx="4481497" cy="199634"/>
              </a:xfrm>
              <a:custGeom>
                <a:avLst/>
                <a:gdLst>
                  <a:gd name="T0" fmla="*/ 160 w 5410"/>
                  <a:gd name="T1" fmla="*/ 153 h 299"/>
                  <a:gd name="T2" fmla="*/ 333 w 5410"/>
                  <a:gd name="T3" fmla="*/ 67 h 299"/>
                  <a:gd name="T4" fmla="*/ 505 w 5410"/>
                  <a:gd name="T5" fmla="*/ 134 h 299"/>
                  <a:gd name="T6" fmla="*/ 678 w 5410"/>
                  <a:gd name="T7" fmla="*/ 146 h 299"/>
                  <a:gd name="T8" fmla="*/ 851 w 5410"/>
                  <a:gd name="T9" fmla="*/ 130 h 299"/>
                  <a:gd name="T10" fmla="*/ 1026 w 5410"/>
                  <a:gd name="T11" fmla="*/ 117 h 299"/>
                  <a:gd name="T12" fmla="*/ 1199 w 5410"/>
                  <a:gd name="T13" fmla="*/ 84 h 299"/>
                  <a:gd name="T14" fmla="*/ 1371 w 5410"/>
                  <a:gd name="T15" fmla="*/ 61 h 299"/>
                  <a:gd name="T16" fmla="*/ 1544 w 5410"/>
                  <a:gd name="T17" fmla="*/ 167 h 299"/>
                  <a:gd name="T18" fmla="*/ 1717 w 5410"/>
                  <a:gd name="T19" fmla="*/ 98 h 299"/>
                  <a:gd name="T20" fmla="*/ 1890 w 5410"/>
                  <a:gd name="T21" fmla="*/ 84 h 299"/>
                  <a:gd name="T22" fmla="*/ 2063 w 5410"/>
                  <a:gd name="T23" fmla="*/ 226 h 299"/>
                  <a:gd name="T24" fmla="*/ 2237 w 5410"/>
                  <a:gd name="T25" fmla="*/ 201 h 299"/>
                  <a:gd name="T26" fmla="*/ 2410 w 5410"/>
                  <a:gd name="T27" fmla="*/ 299 h 299"/>
                  <a:gd name="T28" fmla="*/ 2583 w 5410"/>
                  <a:gd name="T29" fmla="*/ 182 h 299"/>
                  <a:gd name="T30" fmla="*/ 2756 w 5410"/>
                  <a:gd name="T31" fmla="*/ 217 h 299"/>
                  <a:gd name="T32" fmla="*/ 2929 w 5410"/>
                  <a:gd name="T33" fmla="*/ 269 h 299"/>
                  <a:gd name="T34" fmla="*/ 3102 w 5410"/>
                  <a:gd name="T35" fmla="*/ 269 h 299"/>
                  <a:gd name="T36" fmla="*/ 3274 w 5410"/>
                  <a:gd name="T37" fmla="*/ 244 h 299"/>
                  <a:gd name="T38" fmla="*/ 3447 w 5410"/>
                  <a:gd name="T39" fmla="*/ 201 h 299"/>
                  <a:gd name="T40" fmla="*/ 3622 w 5410"/>
                  <a:gd name="T41" fmla="*/ 244 h 299"/>
                  <a:gd name="T42" fmla="*/ 3795 w 5410"/>
                  <a:gd name="T43" fmla="*/ 263 h 299"/>
                  <a:gd name="T44" fmla="*/ 3967 w 5410"/>
                  <a:gd name="T45" fmla="*/ 299 h 299"/>
                  <a:gd name="T46" fmla="*/ 4140 w 5410"/>
                  <a:gd name="T47" fmla="*/ 201 h 299"/>
                  <a:gd name="T48" fmla="*/ 4313 w 5410"/>
                  <a:gd name="T49" fmla="*/ 109 h 299"/>
                  <a:gd name="T50" fmla="*/ 4486 w 5410"/>
                  <a:gd name="T51" fmla="*/ 173 h 299"/>
                  <a:gd name="T52" fmla="*/ 4659 w 5410"/>
                  <a:gd name="T53" fmla="*/ 86 h 299"/>
                  <a:gd name="T54" fmla="*/ 4833 w 5410"/>
                  <a:gd name="T55" fmla="*/ 92 h 299"/>
                  <a:gd name="T56" fmla="*/ 5006 w 5410"/>
                  <a:gd name="T57" fmla="*/ 130 h 299"/>
                  <a:gd name="T58" fmla="*/ 5179 w 5410"/>
                  <a:gd name="T59" fmla="*/ 94 h 299"/>
                  <a:gd name="T60" fmla="*/ 5352 w 5410"/>
                  <a:gd name="T61" fmla="*/ 115 h 299"/>
                  <a:gd name="T62" fmla="*/ 5308 w 5410"/>
                  <a:gd name="T63" fmla="*/ 299 h 299"/>
                  <a:gd name="T64" fmla="*/ 5135 w 5410"/>
                  <a:gd name="T65" fmla="*/ 299 h 299"/>
                  <a:gd name="T66" fmla="*/ 4962 w 5410"/>
                  <a:gd name="T67" fmla="*/ 299 h 299"/>
                  <a:gd name="T68" fmla="*/ 4789 w 5410"/>
                  <a:gd name="T69" fmla="*/ 299 h 299"/>
                  <a:gd name="T70" fmla="*/ 4616 w 5410"/>
                  <a:gd name="T71" fmla="*/ 299 h 299"/>
                  <a:gd name="T72" fmla="*/ 4444 w 5410"/>
                  <a:gd name="T73" fmla="*/ 299 h 299"/>
                  <a:gd name="T74" fmla="*/ 4271 w 5410"/>
                  <a:gd name="T75" fmla="*/ 299 h 299"/>
                  <a:gd name="T76" fmla="*/ 4096 w 5410"/>
                  <a:gd name="T77" fmla="*/ 299 h 299"/>
                  <a:gd name="T78" fmla="*/ 3923 w 5410"/>
                  <a:gd name="T79" fmla="*/ 299 h 299"/>
                  <a:gd name="T80" fmla="*/ 3751 w 5410"/>
                  <a:gd name="T81" fmla="*/ 299 h 299"/>
                  <a:gd name="T82" fmla="*/ 3578 w 5410"/>
                  <a:gd name="T83" fmla="*/ 299 h 299"/>
                  <a:gd name="T84" fmla="*/ 3405 w 5410"/>
                  <a:gd name="T85" fmla="*/ 299 h 299"/>
                  <a:gd name="T86" fmla="*/ 3232 w 5410"/>
                  <a:gd name="T87" fmla="*/ 299 h 299"/>
                  <a:gd name="T88" fmla="*/ 3059 w 5410"/>
                  <a:gd name="T89" fmla="*/ 299 h 299"/>
                  <a:gd name="T90" fmla="*/ 2886 w 5410"/>
                  <a:gd name="T91" fmla="*/ 299 h 299"/>
                  <a:gd name="T92" fmla="*/ 2712 w 5410"/>
                  <a:gd name="T93" fmla="*/ 299 h 299"/>
                  <a:gd name="T94" fmla="*/ 2539 w 5410"/>
                  <a:gd name="T95" fmla="*/ 299 h 299"/>
                  <a:gd name="T96" fmla="*/ 2366 w 5410"/>
                  <a:gd name="T97" fmla="*/ 299 h 299"/>
                  <a:gd name="T98" fmla="*/ 2193 w 5410"/>
                  <a:gd name="T99" fmla="*/ 299 h 299"/>
                  <a:gd name="T100" fmla="*/ 2020 w 5410"/>
                  <a:gd name="T101" fmla="*/ 299 h 299"/>
                  <a:gd name="T102" fmla="*/ 1848 w 5410"/>
                  <a:gd name="T103" fmla="*/ 299 h 299"/>
                  <a:gd name="T104" fmla="*/ 1675 w 5410"/>
                  <a:gd name="T105" fmla="*/ 299 h 299"/>
                  <a:gd name="T106" fmla="*/ 1500 w 5410"/>
                  <a:gd name="T107" fmla="*/ 299 h 299"/>
                  <a:gd name="T108" fmla="*/ 1327 w 5410"/>
                  <a:gd name="T109" fmla="*/ 299 h 299"/>
                  <a:gd name="T110" fmla="*/ 1154 w 5410"/>
                  <a:gd name="T111" fmla="*/ 299 h 299"/>
                  <a:gd name="T112" fmla="*/ 982 w 5410"/>
                  <a:gd name="T113" fmla="*/ 299 h 299"/>
                  <a:gd name="T114" fmla="*/ 809 w 5410"/>
                  <a:gd name="T115" fmla="*/ 299 h 299"/>
                  <a:gd name="T116" fmla="*/ 636 w 5410"/>
                  <a:gd name="T117" fmla="*/ 299 h 299"/>
                  <a:gd name="T118" fmla="*/ 463 w 5410"/>
                  <a:gd name="T119" fmla="*/ 299 h 299"/>
                  <a:gd name="T120" fmla="*/ 290 w 5410"/>
                  <a:gd name="T121" fmla="*/ 299 h 299"/>
                  <a:gd name="T122" fmla="*/ 116 w 5410"/>
                  <a:gd name="T123" fmla="*/ 299 h 2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</a:cxnLst>
                <a:rect l="0" t="0" r="r" b="b"/>
                <a:pathLst>
                  <a:path w="5410" h="299">
                    <a:moveTo>
                      <a:pt x="0" y="174"/>
                    </a:moveTo>
                    <a:lnTo>
                      <a:pt x="16" y="171"/>
                    </a:lnTo>
                    <a:lnTo>
                      <a:pt x="29" y="167"/>
                    </a:lnTo>
                    <a:lnTo>
                      <a:pt x="45" y="134"/>
                    </a:lnTo>
                    <a:lnTo>
                      <a:pt x="58" y="161"/>
                    </a:lnTo>
                    <a:lnTo>
                      <a:pt x="73" y="119"/>
                    </a:lnTo>
                    <a:lnTo>
                      <a:pt x="87" y="188"/>
                    </a:lnTo>
                    <a:lnTo>
                      <a:pt x="102" y="126"/>
                    </a:lnTo>
                    <a:lnTo>
                      <a:pt x="116" y="140"/>
                    </a:lnTo>
                    <a:lnTo>
                      <a:pt x="131" y="140"/>
                    </a:lnTo>
                    <a:lnTo>
                      <a:pt x="145" y="107"/>
                    </a:lnTo>
                    <a:lnTo>
                      <a:pt x="160" y="153"/>
                    </a:lnTo>
                    <a:lnTo>
                      <a:pt x="173" y="65"/>
                    </a:lnTo>
                    <a:lnTo>
                      <a:pt x="189" y="176"/>
                    </a:lnTo>
                    <a:lnTo>
                      <a:pt x="202" y="171"/>
                    </a:lnTo>
                    <a:lnTo>
                      <a:pt x="217" y="84"/>
                    </a:lnTo>
                    <a:lnTo>
                      <a:pt x="231" y="138"/>
                    </a:lnTo>
                    <a:lnTo>
                      <a:pt x="246" y="119"/>
                    </a:lnTo>
                    <a:lnTo>
                      <a:pt x="260" y="128"/>
                    </a:lnTo>
                    <a:lnTo>
                      <a:pt x="275" y="94"/>
                    </a:lnTo>
                    <a:lnTo>
                      <a:pt x="290" y="92"/>
                    </a:lnTo>
                    <a:lnTo>
                      <a:pt x="304" y="86"/>
                    </a:lnTo>
                    <a:lnTo>
                      <a:pt x="319" y="32"/>
                    </a:lnTo>
                    <a:lnTo>
                      <a:pt x="333" y="67"/>
                    </a:lnTo>
                    <a:lnTo>
                      <a:pt x="348" y="82"/>
                    </a:lnTo>
                    <a:lnTo>
                      <a:pt x="361" y="167"/>
                    </a:lnTo>
                    <a:lnTo>
                      <a:pt x="377" y="163"/>
                    </a:lnTo>
                    <a:lnTo>
                      <a:pt x="390" y="146"/>
                    </a:lnTo>
                    <a:lnTo>
                      <a:pt x="406" y="113"/>
                    </a:lnTo>
                    <a:lnTo>
                      <a:pt x="419" y="174"/>
                    </a:lnTo>
                    <a:lnTo>
                      <a:pt x="434" y="128"/>
                    </a:lnTo>
                    <a:lnTo>
                      <a:pt x="448" y="157"/>
                    </a:lnTo>
                    <a:lnTo>
                      <a:pt x="463" y="211"/>
                    </a:lnTo>
                    <a:lnTo>
                      <a:pt x="477" y="82"/>
                    </a:lnTo>
                    <a:lnTo>
                      <a:pt x="492" y="96"/>
                    </a:lnTo>
                    <a:lnTo>
                      <a:pt x="505" y="134"/>
                    </a:lnTo>
                    <a:lnTo>
                      <a:pt x="521" y="173"/>
                    </a:lnTo>
                    <a:lnTo>
                      <a:pt x="534" y="134"/>
                    </a:lnTo>
                    <a:lnTo>
                      <a:pt x="550" y="113"/>
                    </a:lnTo>
                    <a:lnTo>
                      <a:pt x="563" y="128"/>
                    </a:lnTo>
                    <a:lnTo>
                      <a:pt x="578" y="153"/>
                    </a:lnTo>
                    <a:lnTo>
                      <a:pt x="592" y="155"/>
                    </a:lnTo>
                    <a:lnTo>
                      <a:pt x="607" y="157"/>
                    </a:lnTo>
                    <a:lnTo>
                      <a:pt x="621" y="69"/>
                    </a:lnTo>
                    <a:lnTo>
                      <a:pt x="636" y="76"/>
                    </a:lnTo>
                    <a:lnTo>
                      <a:pt x="649" y="121"/>
                    </a:lnTo>
                    <a:lnTo>
                      <a:pt x="665" y="117"/>
                    </a:lnTo>
                    <a:lnTo>
                      <a:pt x="678" y="146"/>
                    </a:lnTo>
                    <a:lnTo>
                      <a:pt x="694" y="96"/>
                    </a:lnTo>
                    <a:lnTo>
                      <a:pt x="707" y="144"/>
                    </a:lnTo>
                    <a:lnTo>
                      <a:pt x="722" y="105"/>
                    </a:lnTo>
                    <a:lnTo>
                      <a:pt x="736" y="128"/>
                    </a:lnTo>
                    <a:lnTo>
                      <a:pt x="751" y="100"/>
                    </a:lnTo>
                    <a:lnTo>
                      <a:pt x="765" y="130"/>
                    </a:lnTo>
                    <a:lnTo>
                      <a:pt x="780" y="130"/>
                    </a:lnTo>
                    <a:lnTo>
                      <a:pt x="794" y="128"/>
                    </a:lnTo>
                    <a:lnTo>
                      <a:pt x="809" y="96"/>
                    </a:lnTo>
                    <a:lnTo>
                      <a:pt x="822" y="119"/>
                    </a:lnTo>
                    <a:lnTo>
                      <a:pt x="838" y="84"/>
                    </a:lnTo>
                    <a:lnTo>
                      <a:pt x="851" y="130"/>
                    </a:lnTo>
                    <a:lnTo>
                      <a:pt x="866" y="119"/>
                    </a:lnTo>
                    <a:lnTo>
                      <a:pt x="880" y="94"/>
                    </a:lnTo>
                    <a:lnTo>
                      <a:pt x="895" y="75"/>
                    </a:lnTo>
                    <a:lnTo>
                      <a:pt x="909" y="28"/>
                    </a:lnTo>
                    <a:lnTo>
                      <a:pt x="924" y="103"/>
                    </a:lnTo>
                    <a:lnTo>
                      <a:pt x="939" y="159"/>
                    </a:lnTo>
                    <a:lnTo>
                      <a:pt x="953" y="78"/>
                    </a:lnTo>
                    <a:lnTo>
                      <a:pt x="968" y="113"/>
                    </a:lnTo>
                    <a:lnTo>
                      <a:pt x="982" y="96"/>
                    </a:lnTo>
                    <a:lnTo>
                      <a:pt x="997" y="65"/>
                    </a:lnTo>
                    <a:lnTo>
                      <a:pt x="1010" y="121"/>
                    </a:lnTo>
                    <a:lnTo>
                      <a:pt x="1026" y="117"/>
                    </a:lnTo>
                    <a:lnTo>
                      <a:pt x="1039" y="48"/>
                    </a:lnTo>
                    <a:lnTo>
                      <a:pt x="1055" y="84"/>
                    </a:lnTo>
                    <a:lnTo>
                      <a:pt x="1068" y="0"/>
                    </a:lnTo>
                    <a:lnTo>
                      <a:pt x="1083" y="63"/>
                    </a:lnTo>
                    <a:lnTo>
                      <a:pt x="1097" y="86"/>
                    </a:lnTo>
                    <a:lnTo>
                      <a:pt x="1112" y="123"/>
                    </a:lnTo>
                    <a:lnTo>
                      <a:pt x="1126" y="186"/>
                    </a:lnTo>
                    <a:lnTo>
                      <a:pt x="1141" y="146"/>
                    </a:lnTo>
                    <a:lnTo>
                      <a:pt x="1154" y="100"/>
                    </a:lnTo>
                    <a:lnTo>
                      <a:pt x="1170" y="107"/>
                    </a:lnTo>
                    <a:lnTo>
                      <a:pt x="1183" y="111"/>
                    </a:lnTo>
                    <a:lnTo>
                      <a:pt x="1199" y="84"/>
                    </a:lnTo>
                    <a:lnTo>
                      <a:pt x="1212" y="142"/>
                    </a:lnTo>
                    <a:lnTo>
                      <a:pt x="1227" y="42"/>
                    </a:lnTo>
                    <a:lnTo>
                      <a:pt x="1241" y="130"/>
                    </a:lnTo>
                    <a:lnTo>
                      <a:pt x="1256" y="73"/>
                    </a:lnTo>
                    <a:lnTo>
                      <a:pt x="1270" y="63"/>
                    </a:lnTo>
                    <a:lnTo>
                      <a:pt x="1285" y="130"/>
                    </a:lnTo>
                    <a:lnTo>
                      <a:pt x="1299" y="96"/>
                    </a:lnTo>
                    <a:lnTo>
                      <a:pt x="1314" y="80"/>
                    </a:lnTo>
                    <a:lnTo>
                      <a:pt x="1327" y="107"/>
                    </a:lnTo>
                    <a:lnTo>
                      <a:pt x="1343" y="146"/>
                    </a:lnTo>
                    <a:lnTo>
                      <a:pt x="1356" y="30"/>
                    </a:lnTo>
                    <a:lnTo>
                      <a:pt x="1371" y="61"/>
                    </a:lnTo>
                    <a:lnTo>
                      <a:pt x="1385" y="98"/>
                    </a:lnTo>
                    <a:lnTo>
                      <a:pt x="1400" y="163"/>
                    </a:lnTo>
                    <a:lnTo>
                      <a:pt x="1414" y="192"/>
                    </a:lnTo>
                    <a:lnTo>
                      <a:pt x="1429" y="142"/>
                    </a:lnTo>
                    <a:lnTo>
                      <a:pt x="1443" y="90"/>
                    </a:lnTo>
                    <a:lnTo>
                      <a:pt x="1458" y="65"/>
                    </a:lnTo>
                    <a:lnTo>
                      <a:pt x="1471" y="82"/>
                    </a:lnTo>
                    <a:lnTo>
                      <a:pt x="1487" y="151"/>
                    </a:lnTo>
                    <a:lnTo>
                      <a:pt x="1500" y="94"/>
                    </a:lnTo>
                    <a:lnTo>
                      <a:pt x="1515" y="100"/>
                    </a:lnTo>
                    <a:lnTo>
                      <a:pt x="1529" y="126"/>
                    </a:lnTo>
                    <a:lnTo>
                      <a:pt x="1544" y="167"/>
                    </a:lnTo>
                    <a:lnTo>
                      <a:pt x="1558" y="123"/>
                    </a:lnTo>
                    <a:lnTo>
                      <a:pt x="1573" y="126"/>
                    </a:lnTo>
                    <a:lnTo>
                      <a:pt x="1588" y="176"/>
                    </a:lnTo>
                    <a:lnTo>
                      <a:pt x="1602" y="94"/>
                    </a:lnTo>
                    <a:lnTo>
                      <a:pt x="1617" y="167"/>
                    </a:lnTo>
                    <a:lnTo>
                      <a:pt x="1631" y="163"/>
                    </a:lnTo>
                    <a:lnTo>
                      <a:pt x="1646" y="96"/>
                    </a:lnTo>
                    <a:lnTo>
                      <a:pt x="1659" y="57"/>
                    </a:lnTo>
                    <a:lnTo>
                      <a:pt x="1675" y="151"/>
                    </a:lnTo>
                    <a:lnTo>
                      <a:pt x="1688" y="192"/>
                    </a:lnTo>
                    <a:lnTo>
                      <a:pt x="1704" y="132"/>
                    </a:lnTo>
                    <a:lnTo>
                      <a:pt x="1717" y="98"/>
                    </a:lnTo>
                    <a:lnTo>
                      <a:pt x="1732" y="130"/>
                    </a:lnTo>
                    <a:lnTo>
                      <a:pt x="1746" y="142"/>
                    </a:lnTo>
                    <a:lnTo>
                      <a:pt x="1761" y="98"/>
                    </a:lnTo>
                    <a:lnTo>
                      <a:pt x="1775" y="123"/>
                    </a:lnTo>
                    <a:lnTo>
                      <a:pt x="1790" y="115"/>
                    </a:lnTo>
                    <a:lnTo>
                      <a:pt x="1803" y="276"/>
                    </a:lnTo>
                    <a:lnTo>
                      <a:pt x="1819" y="146"/>
                    </a:lnTo>
                    <a:lnTo>
                      <a:pt x="1832" y="109"/>
                    </a:lnTo>
                    <a:lnTo>
                      <a:pt x="1848" y="138"/>
                    </a:lnTo>
                    <a:lnTo>
                      <a:pt x="1861" y="142"/>
                    </a:lnTo>
                    <a:lnTo>
                      <a:pt x="1876" y="92"/>
                    </a:lnTo>
                    <a:lnTo>
                      <a:pt x="1890" y="84"/>
                    </a:lnTo>
                    <a:lnTo>
                      <a:pt x="1905" y="117"/>
                    </a:lnTo>
                    <a:lnTo>
                      <a:pt x="1919" y="176"/>
                    </a:lnTo>
                    <a:lnTo>
                      <a:pt x="1934" y="265"/>
                    </a:lnTo>
                    <a:lnTo>
                      <a:pt x="1948" y="124"/>
                    </a:lnTo>
                    <a:lnTo>
                      <a:pt x="1963" y="299"/>
                    </a:lnTo>
                    <a:lnTo>
                      <a:pt x="1976" y="294"/>
                    </a:lnTo>
                    <a:lnTo>
                      <a:pt x="1992" y="132"/>
                    </a:lnTo>
                    <a:lnTo>
                      <a:pt x="2005" y="144"/>
                    </a:lnTo>
                    <a:lnTo>
                      <a:pt x="2020" y="167"/>
                    </a:lnTo>
                    <a:lnTo>
                      <a:pt x="2034" y="126"/>
                    </a:lnTo>
                    <a:lnTo>
                      <a:pt x="2049" y="178"/>
                    </a:lnTo>
                    <a:lnTo>
                      <a:pt x="2063" y="226"/>
                    </a:lnTo>
                    <a:lnTo>
                      <a:pt x="2078" y="194"/>
                    </a:lnTo>
                    <a:lnTo>
                      <a:pt x="2092" y="236"/>
                    </a:lnTo>
                    <a:lnTo>
                      <a:pt x="2107" y="274"/>
                    </a:lnTo>
                    <a:lnTo>
                      <a:pt x="2120" y="199"/>
                    </a:lnTo>
                    <a:lnTo>
                      <a:pt x="2136" y="221"/>
                    </a:lnTo>
                    <a:lnTo>
                      <a:pt x="2149" y="194"/>
                    </a:lnTo>
                    <a:lnTo>
                      <a:pt x="2164" y="190"/>
                    </a:lnTo>
                    <a:lnTo>
                      <a:pt x="2178" y="188"/>
                    </a:lnTo>
                    <a:lnTo>
                      <a:pt x="2193" y="222"/>
                    </a:lnTo>
                    <a:lnTo>
                      <a:pt x="2207" y="128"/>
                    </a:lnTo>
                    <a:lnTo>
                      <a:pt x="2222" y="230"/>
                    </a:lnTo>
                    <a:lnTo>
                      <a:pt x="2237" y="201"/>
                    </a:lnTo>
                    <a:lnTo>
                      <a:pt x="2251" y="188"/>
                    </a:lnTo>
                    <a:lnTo>
                      <a:pt x="2266" y="107"/>
                    </a:lnTo>
                    <a:lnTo>
                      <a:pt x="2280" y="211"/>
                    </a:lnTo>
                    <a:lnTo>
                      <a:pt x="2295" y="222"/>
                    </a:lnTo>
                    <a:lnTo>
                      <a:pt x="2308" y="178"/>
                    </a:lnTo>
                    <a:lnTo>
                      <a:pt x="2324" y="180"/>
                    </a:lnTo>
                    <a:lnTo>
                      <a:pt x="2337" y="259"/>
                    </a:lnTo>
                    <a:lnTo>
                      <a:pt x="2353" y="196"/>
                    </a:lnTo>
                    <a:lnTo>
                      <a:pt x="2366" y="253"/>
                    </a:lnTo>
                    <a:lnTo>
                      <a:pt x="2381" y="299"/>
                    </a:lnTo>
                    <a:lnTo>
                      <a:pt x="2395" y="226"/>
                    </a:lnTo>
                    <a:lnTo>
                      <a:pt x="2410" y="299"/>
                    </a:lnTo>
                    <a:lnTo>
                      <a:pt x="2424" y="296"/>
                    </a:lnTo>
                    <a:lnTo>
                      <a:pt x="2439" y="203"/>
                    </a:lnTo>
                    <a:lnTo>
                      <a:pt x="2453" y="284"/>
                    </a:lnTo>
                    <a:lnTo>
                      <a:pt x="2468" y="276"/>
                    </a:lnTo>
                    <a:lnTo>
                      <a:pt x="2481" y="286"/>
                    </a:lnTo>
                    <a:lnTo>
                      <a:pt x="2497" y="299"/>
                    </a:lnTo>
                    <a:lnTo>
                      <a:pt x="2510" y="211"/>
                    </a:lnTo>
                    <a:lnTo>
                      <a:pt x="2525" y="299"/>
                    </a:lnTo>
                    <a:lnTo>
                      <a:pt x="2539" y="290"/>
                    </a:lnTo>
                    <a:lnTo>
                      <a:pt x="2554" y="286"/>
                    </a:lnTo>
                    <a:lnTo>
                      <a:pt x="2568" y="211"/>
                    </a:lnTo>
                    <a:lnTo>
                      <a:pt x="2583" y="182"/>
                    </a:lnTo>
                    <a:lnTo>
                      <a:pt x="2597" y="299"/>
                    </a:lnTo>
                    <a:lnTo>
                      <a:pt x="2612" y="299"/>
                    </a:lnTo>
                    <a:lnTo>
                      <a:pt x="2625" y="276"/>
                    </a:lnTo>
                    <a:lnTo>
                      <a:pt x="2641" y="299"/>
                    </a:lnTo>
                    <a:lnTo>
                      <a:pt x="2654" y="238"/>
                    </a:lnTo>
                    <a:lnTo>
                      <a:pt x="2669" y="247"/>
                    </a:lnTo>
                    <a:lnTo>
                      <a:pt x="2683" y="288"/>
                    </a:lnTo>
                    <a:lnTo>
                      <a:pt x="2698" y="299"/>
                    </a:lnTo>
                    <a:lnTo>
                      <a:pt x="2712" y="299"/>
                    </a:lnTo>
                    <a:lnTo>
                      <a:pt x="2727" y="161"/>
                    </a:lnTo>
                    <a:lnTo>
                      <a:pt x="2741" y="271"/>
                    </a:lnTo>
                    <a:lnTo>
                      <a:pt x="2756" y="217"/>
                    </a:lnTo>
                    <a:lnTo>
                      <a:pt x="2769" y="290"/>
                    </a:lnTo>
                    <a:lnTo>
                      <a:pt x="2785" y="253"/>
                    </a:lnTo>
                    <a:lnTo>
                      <a:pt x="2798" y="257"/>
                    </a:lnTo>
                    <a:lnTo>
                      <a:pt x="2813" y="224"/>
                    </a:lnTo>
                    <a:lnTo>
                      <a:pt x="2827" y="294"/>
                    </a:lnTo>
                    <a:lnTo>
                      <a:pt x="2842" y="299"/>
                    </a:lnTo>
                    <a:lnTo>
                      <a:pt x="2856" y="259"/>
                    </a:lnTo>
                    <a:lnTo>
                      <a:pt x="2871" y="271"/>
                    </a:lnTo>
                    <a:lnTo>
                      <a:pt x="2886" y="194"/>
                    </a:lnTo>
                    <a:lnTo>
                      <a:pt x="2900" y="272"/>
                    </a:lnTo>
                    <a:lnTo>
                      <a:pt x="2915" y="249"/>
                    </a:lnTo>
                    <a:lnTo>
                      <a:pt x="2929" y="269"/>
                    </a:lnTo>
                    <a:lnTo>
                      <a:pt x="2944" y="299"/>
                    </a:lnTo>
                    <a:lnTo>
                      <a:pt x="2957" y="299"/>
                    </a:lnTo>
                    <a:lnTo>
                      <a:pt x="2973" y="265"/>
                    </a:lnTo>
                    <a:lnTo>
                      <a:pt x="2986" y="299"/>
                    </a:lnTo>
                    <a:lnTo>
                      <a:pt x="3002" y="294"/>
                    </a:lnTo>
                    <a:lnTo>
                      <a:pt x="3015" y="238"/>
                    </a:lnTo>
                    <a:lnTo>
                      <a:pt x="3030" y="234"/>
                    </a:lnTo>
                    <a:lnTo>
                      <a:pt x="3044" y="290"/>
                    </a:lnTo>
                    <a:lnTo>
                      <a:pt x="3059" y="251"/>
                    </a:lnTo>
                    <a:lnTo>
                      <a:pt x="3073" y="276"/>
                    </a:lnTo>
                    <a:lnTo>
                      <a:pt x="3088" y="215"/>
                    </a:lnTo>
                    <a:lnTo>
                      <a:pt x="3102" y="269"/>
                    </a:lnTo>
                    <a:lnTo>
                      <a:pt x="3117" y="261"/>
                    </a:lnTo>
                    <a:lnTo>
                      <a:pt x="3130" y="182"/>
                    </a:lnTo>
                    <a:lnTo>
                      <a:pt x="3146" y="257"/>
                    </a:lnTo>
                    <a:lnTo>
                      <a:pt x="3159" y="171"/>
                    </a:lnTo>
                    <a:lnTo>
                      <a:pt x="3174" y="178"/>
                    </a:lnTo>
                    <a:lnTo>
                      <a:pt x="3188" y="261"/>
                    </a:lnTo>
                    <a:lnTo>
                      <a:pt x="3203" y="228"/>
                    </a:lnTo>
                    <a:lnTo>
                      <a:pt x="3217" y="222"/>
                    </a:lnTo>
                    <a:lnTo>
                      <a:pt x="3232" y="201"/>
                    </a:lnTo>
                    <a:lnTo>
                      <a:pt x="3246" y="297"/>
                    </a:lnTo>
                    <a:lnTo>
                      <a:pt x="3261" y="184"/>
                    </a:lnTo>
                    <a:lnTo>
                      <a:pt x="3274" y="244"/>
                    </a:lnTo>
                    <a:lnTo>
                      <a:pt x="3290" y="226"/>
                    </a:lnTo>
                    <a:lnTo>
                      <a:pt x="3303" y="180"/>
                    </a:lnTo>
                    <a:lnTo>
                      <a:pt x="3318" y="222"/>
                    </a:lnTo>
                    <a:lnTo>
                      <a:pt x="3332" y="190"/>
                    </a:lnTo>
                    <a:lnTo>
                      <a:pt x="3347" y="282"/>
                    </a:lnTo>
                    <a:lnTo>
                      <a:pt x="3361" y="290"/>
                    </a:lnTo>
                    <a:lnTo>
                      <a:pt x="3376" y="299"/>
                    </a:lnTo>
                    <a:lnTo>
                      <a:pt x="3390" y="299"/>
                    </a:lnTo>
                    <a:lnTo>
                      <a:pt x="3405" y="299"/>
                    </a:lnTo>
                    <a:lnTo>
                      <a:pt x="3418" y="263"/>
                    </a:lnTo>
                    <a:lnTo>
                      <a:pt x="3434" y="299"/>
                    </a:lnTo>
                    <a:lnTo>
                      <a:pt x="3447" y="201"/>
                    </a:lnTo>
                    <a:lnTo>
                      <a:pt x="3462" y="297"/>
                    </a:lnTo>
                    <a:lnTo>
                      <a:pt x="3476" y="124"/>
                    </a:lnTo>
                    <a:lnTo>
                      <a:pt x="3491" y="296"/>
                    </a:lnTo>
                    <a:lnTo>
                      <a:pt x="3505" y="286"/>
                    </a:lnTo>
                    <a:lnTo>
                      <a:pt x="3520" y="299"/>
                    </a:lnTo>
                    <a:lnTo>
                      <a:pt x="3535" y="299"/>
                    </a:lnTo>
                    <a:lnTo>
                      <a:pt x="3549" y="257"/>
                    </a:lnTo>
                    <a:lnTo>
                      <a:pt x="3564" y="188"/>
                    </a:lnTo>
                    <a:lnTo>
                      <a:pt x="3578" y="259"/>
                    </a:lnTo>
                    <a:lnTo>
                      <a:pt x="3593" y="299"/>
                    </a:lnTo>
                    <a:lnTo>
                      <a:pt x="3607" y="299"/>
                    </a:lnTo>
                    <a:lnTo>
                      <a:pt x="3622" y="244"/>
                    </a:lnTo>
                    <a:lnTo>
                      <a:pt x="3635" y="163"/>
                    </a:lnTo>
                    <a:lnTo>
                      <a:pt x="3651" y="207"/>
                    </a:lnTo>
                    <a:lnTo>
                      <a:pt x="3664" y="213"/>
                    </a:lnTo>
                    <a:lnTo>
                      <a:pt x="3679" y="276"/>
                    </a:lnTo>
                    <a:lnTo>
                      <a:pt x="3693" y="230"/>
                    </a:lnTo>
                    <a:lnTo>
                      <a:pt x="3708" y="186"/>
                    </a:lnTo>
                    <a:lnTo>
                      <a:pt x="3722" y="157"/>
                    </a:lnTo>
                    <a:lnTo>
                      <a:pt x="3737" y="236"/>
                    </a:lnTo>
                    <a:lnTo>
                      <a:pt x="3751" y="267"/>
                    </a:lnTo>
                    <a:lnTo>
                      <a:pt x="3766" y="288"/>
                    </a:lnTo>
                    <a:lnTo>
                      <a:pt x="3779" y="219"/>
                    </a:lnTo>
                    <a:lnTo>
                      <a:pt x="3795" y="263"/>
                    </a:lnTo>
                    <a:lnTo>
                      <a:pt x="3808" y="255"/>
                    </a:lnTo>
                    <a:lnTo>
                      <a:pt x="3823" y="188"/>
                    </a:lnTo>
                    <a:lnTo>
                      <a:pt x="3837" y="136"/>
                    </a:lnTo>
                    <a:lnTo>
                      <a:pt x="3852" y="144"/>
                    </a:lnTo>
                    <a:lnTo>
                      <a:pt x="3866" y="297"/>
                    </a:lnTo>
                    <a:lnTo>
                      <a:pt x="3881" y="299"/>
                    </a:lnTo>
                    <a:lnTo>
                      <a:pt x="3895" y="297"/>
                    </a:lnTo>
                    <a:lnTo>
                      <a:pt x="3910" y="299"/>
                    </a:lnTo>
                    <a:lnTo>
                      <a:pt x="3923" y="267"/>
                    </a:lnTo>
                    <a:lnTo>
                      <a:pt x="3939" y="294"/>
                    </a:lnTo>
                    <a:lnTo>
                      <a:pt x="3952" y="299"/>
                    </a:lnTo>
                    <a:lnTo>
                      <a:pt x="3967" y="299"/>
                    </a:lnTo>
                    <a:lnTo>
                      <a:pt x="3981" y="296"/>
                    </a:lnTo>
                    <a:lnTo>
                      <a:pt x="3996" y="292"/>
                    </a:lnTo>
                    <a:lnTo>
                      <a:pt x="4010" y="238"/>
                    </a:lnTo>
                    <a:lnTo>
                      <a:pt x="4025" y="240"/>
                    </a:lnTo>
                    <a:lnTo>
                      <a:pt x="4039" y="299"/>
                    </a:lnTo>
                    <a:lnTo>
                      <a:pt x="4054" y="201"/>
                    </a:lnTo>
                    <a:lnTo>
                      <a:pt x="4067" y="159"/>
                    </a:lnTo>
                    <a:lnTo>
                      <a:pt x="4083" y="215"/>
                    </a:lnTo>
                    <a:lnTo>
                      <a:pt x="4096" y="194"/>
                    </a:lnTo>
                    <a:lnTo>
                      <a:pt x="4111" y="276"/>
                    </a:lnTo>
                    <a:lnTo>
                      <a:pt x="4125" y="169"/>
                    </a:lnTo>
                    <a:lnTo>
                      <a:pt x="4140" y="201"/>
                    </a:lnTo>
                    <a:lnTo>
                      <a:pt x="4154" y="265"/>
                    </a:lnTo>
                    <a:lnTo>
                      <a:pt x="4169" y="242"/>
                    </a:lnTo>
                    <a:lnTo>
                      <a:pt x="4184" y="224"/>
                    </a:lnTo>
                    <a:lnTo>
                      <a:pt x="4198" y="46"/>
                    </a:lnTo>
                    <a:lnTo>
                      <a:pt x="4213" y="105"/>
                    </a:lnTo>
                    <a:lnTo>
                      <a:pt x="4227" y="107"/>
                    </a:lnTo>
                    <a:lnTo>
                      <a:pt x="4242" y="146"/>
                    </a:lnTo>
                    <a:lnTo>
                      <a:pt x="4256" y="159"/>
                    </a:lnTo>
                    <a:lnTo>
                      <a:pt x="4271" y="48"/>
                    </a:lnTo>
                    <a:lnTo>
                      <a:pt x="4284" y="126"/>
                    </a:lnTo>
                    <a:lnTo>
                      <a:pt x="4300" y="126"/>
                    </a:lnTo>
                    <a:lnTo>
                      <a:pt x="4313" y="109"/>
                    </a:lnTo>
                    <a:lnTo>
                      <a:pt x="4328" y="80"/>
                    </a:lnTo>
                    <a:lnTo>
                      <a:pt x="4342" y="119"/>
                    </a:lnTo>
                    <a:lnTo>
                      <a:pt x="4357" y="184"/>
                    </a:lnTo>
                    <a:lnTo>
                      <a:pt x="4371" y="130"/>
                    </a:lnTo>
                    <a:lnTo>
                      <a:pt x="4386" y="124"/>
                    </a:lnTo>
                    <a:lnTo>
                      <a:pt x="4400" y="171"/>
                    </a:lnTo>
                    <a:lnTo>
                      <a:pt x="4415" y="128"/>
                    </a:lnTo>
                    <a:lnTo>
                      <a:pt x="4428" y="48"/>
                    </a:lnTo>
                    <a:lnTo>
                      <a:pt x="4444" y="144"/>
                    </a:lnTo>
                    <a:lnTo>
                      <a:pt x="4457" y="146"/>
                    </a:lnTo>
                    <a:lnTo>
                      <a:pt x="4472" y="238"/>
                    </a:lnTo>
                    <a:lnTo>
                      <a:pt x="4486" y="173"/>
                    </a:lnTo>
                    <a:lnTo>
                      <a:pt x="4501" y="63"/>
                    </a:lnTo>
                    <a:lnTo>
                      <a:pt x="4515" y="151"/>
                    </a:lnTo>
                    <a:lnTo>
                      <a:pt x="4530" y="100"/>
                    </a:lnTo>
                    <a:lnTo>
                      <a:pt x="4544" y="88"/>
                    </a:lnTo>
                    <a:lnTo>
                      <a:pt x="4559" y="113"/>
                    </a:lnTo>
                    <a:lnTo>
                      <a:pt x="4572" y="113"/>
                    </a:lnTo>
                    <a:lnTo>
                      <a:pt x="4588" y="119"/>
                    </a:lnTo>
                    <a:lnTo>
                      <a:pt x="4601" y="228"/>
                    </a:lnTo>
                    <a:lnTo>
                      <a:pt x="4616" y="165"/>
                    </a:lnTo>
                    <a:lnTo>
                      <a:pt x="4630" y="192"/>
                    </a:lnTo>
                    <a:lnTo>
                      <a:pt x="4645" y="178"/>
                    </a:lnTo>
                    <a:lnTo>
                      <a:pt x="4659" y="86"/>
                    </a:lnTo>
                    <a:lnTo>
                      <a:pt x="4674" y="136"/>
                    </a:lnTo>
                    <a:lnTo>
                      <a:pt x="4688" y="115"/>
                    </a:lnTo>
                    <a:lnTo>
                      <a:pt x="4703" y="90"/>
                    </a:lnTo>
                    <a:lnTo>
                      <a:pt x="4716" y="167"/>
                    </a:lnTo>
                    <a:lnTo>
                      <a:pt x="4732" y="149"/>
                    </a:lnTo>
                    <a:lnTo>
                      <a:pt x="4745" y="134"/>
                    </a:lnTo>
                    <a:lnTo>
                      <a:pt x="4761" y="111"/>
                    </a:lnTo>
                    <a:lnTo>
                      <a:pt x="4774" y="153"/>
                    </a:lnTo>
                    <a:lnTo>
                      <a:pt x="4789" y="199"/>
                    </a:lnTo>
                    <a:lnTo>
                      <a:pt x="4803" y="240"/>
                    </a:lnTo>
                    <a:lnTo>
                      <a:pt x="4818" y="130"/>
                    </a:lnTo>
                    <a:lnTo>
                      <a:pt x="4833" y="92"/>
                    </a:lnTo>
                    <a:lnTo>
                      <a:pt x="4847" y="128"/>
                    </a:lnTo>
                    <a:lnTo>
                      <a:pt x="4862" y="71"/>
                    </a:lnTo>
                    <a:lnTo>
                      <a:pt x="4876" y="100"/>
                    </a:lnTo>
                    <a:lnTo>
                      <a:pt x="4891" y="144"/>
                    </a:lnTo>
                    <a:lnTo>
                      <a:pt x="4905" y="75"/>
                    </a:lnTo>
                    <a:lnTo>
                      <a:pt x="4920" y="69"/>
                    </a:lnTo>
                    <a:lnTo>
                      <a:pt x="4933" y="103"/>
                    </a:lnTo>
                    <a:lnTo>
                      <a:pt x="4949" y="180"/>
                    </a:lnTo>
                    <a:lnTo>
                      <a:pt x="4962" y="84"/>
                    </a:lnTo>
                    <a:lnTo>
                      <a:pt x="4977" y="90"/>
                    </a:lnTo>
                    <a:lnTo>
                      <a:pt x="4991" y="59"/>
                    </a:lnTo>
                    <a:lnTo>
                      <a:pt x="5006" y="130"/>
                    </a:lnTo>
                    <a:lnTo>
                      <a:pt x="5020" y="140"/>
                    </a:lnTo>
                    <a:lnTo>
                      <a:pt x="5035" y="119"/>
                    </a:lnTo>
                    <a:lnTo>
                      <a:pt x="5049" y="50"/>
                    </a:lnTo>
                    <a:lnTo>
                      <a:pt x="5064" y="157"/>
                    </a:lnTo>
                    <a:lnTo>
                      <a:pt x="5077" y="121"/>
                    </a:lnTo>
                    <a:lnTo>
                      <a:pt x="5093" y="128"/>
                    </a:lnTo>
                    <a:lnTo>
                      <a:pt x="5106" y="198"/>
                    </a:lnTo>
                    <a:lnTo>
                      <a:pt x="5121" y="142"/>
                    </a:lnTo>
                    <a:lnTo>
                      <a:pt x="5135" y="103"/>
                    </a:lnTo>
                    <a:lnTo>
                      <a:pt x="5150" y="117"/>
                    </a:lnTo>
                    <a:lnTo>
                      <a:pt x="5164" y="88"/>
                    </a:lnTo>
                    <a:lnTo>
                      <a:pt x="5179" y="94"/>
                    </a:lnTo>
                    <a:lnTo>
                      <a:pt x="5193" y="36"/>
                    </a:lnTo>
                    <a:lnTo>
                      <a:pt x="5208" y="67"/>
                    </a:lnTo>
                    <a:lnTo>
                      <a:pt x="5221" y="155"/>
                    </a:lnTo>
                    <a:lnTo>
                      <a:pt x="5237" y="163"/>
                    </a:lnTo>
                    <a:lnTo>
                      <a:pt x="5250" y="199"/>
                    </a:lnTo>
                    <a:lnTo>
                      <a:pt x="5265" y="132"/>
                    </a:lnTo>
                    <a:lnTo>
                      <a:pt x="5279" y="176"/>
                    </a:lnTo>
                    <a:lnTo>
                      <a:pt x="5294" y="84"/>
                    </a:lnTo>
                    <a:lnTo>
                      <a:pt x="5308" y="109"/>
                    </a:lnTo>
                    <a:lnTo>
                      <a:pt x="5323" y="90"/>
                    </a:lnTo>
                    <a:lnTo>
                      <a:pt x="5337" y="140"/>
                    </a:lnTo>
                    <a:lnTo>
                      <a:pt x="5352" y="115"/>
                    </a:lnTo>
                    <a:lnTo>
                      <a:pt x="5365" y="161"/>
                    </a:lnTo>
                    <a:lnTo>
                      <a:pt x="5381" y="188"/>
                    </a:lnTo>
                    <a:lnTo>
                      <a:pt x="5394" y="132"/>
                    </a:lnTo>
                    <a:lnTo>
                      <a:pt x="5410" y="199"/>
                    </a:lnTo>
                    <a:lnTo>
                      <a:pt x="5410" y="299"/>
                    </a:lnTo>
                    <a:lnTo>
                      <a:pt x="5394" y="299"/>
                    </a:lnTo>
                    <a:lnTo>
                      <a:pt x="5381" y="299"/>
                    </a:lnTo>
                    <a:lnTo>
                      <a:pt x="5365" y="299"/>
                    </a:lnTo>
                    <a:lnTo>
                      <a:pt x="5352" y="299"/>
                    </a:lnTo>
                    <a:lnTo>
                      <a:pt x="5337" y="299"/>
                    </a:lnTo>
                    <a:lnTo>
                      <a:pt x="5323" y="299"/>
                    </a:lnTo>
                    <a:lnTo>
                      <a:pt x="5308" y="299"/>
                    </a:lnTo>
                    <a:lnTo>
                      <a:pt x="5294" y="299"/>
                    </a:lnTo>
                    <a:lnTo>
                      <a:pt x="5279" y="299"/>
                    </a:lnTo>
                    <a:lnTo>
                      <a:pt x="5265" y="299"/>
                    </a:lnTo>
                    <a:lnTo>
                      <a:pt x="5250" y="299"/>
                    </a:lnTo>
                    <a:lnTo>
                      <a:pt x="5237" y="299"/>
                    </a:lnTo>
                    <a:lnTo>
                      <a:pt x="5221" y="299"/>
                    </a:lnTo>
                    <a:lnTo>
                      <a:pt x="5208" y="299"/>
                    </a:lnTo>
                    <a:lnTo>
                      <a:pt x="5193" y="299"/>
                    </a:lnTo>
                    <a:lnTo>
                      <a:pt x="5179" y="299"/>
                    </a:lnTo>
                    <a:lnTo>
                      <a:pt x="5164" y="299"/>
                    </a:lnTo>
                    <a:lnTo>
                      <a:pt x="5150" y="299"/>
                    </a:lnTo>
                    <a:lnTo>
                      <a:pt x="5135" y="299"/>
                    </a:lnTo>
                    <a:lnTo>
                      <a:pt x="5121" y="299"/>
                    </a:lnTo>
                    <a:lnTo>
                      <a:pt x="5106" y="299"/>
                    </a:lnTo>
                    <a:lnTo>
                      <a:pt x="5093" y="299"/>
                    </a:lnTo>
                    <a:lnTo>
                      <a:pt x="5077" y="299"/>
                    </a:lnTo>
                    <a:lnTo>
                      <a:pt x="5064" y="299"/>
                    </a:lnTo>
                    <a:lnTo>
                      <a:pt x="5049" y="299"/>
                    </a:lnTo>
                    <a:lnTo>
                      <a:pt x="5035" y="299"/>
                    </a:lnTo>
                    <a:lnTo>
                      <a:pt x="5020" y="299"/>
                    </a:lnTo>
                    <a:lnTo>
                      <a:pt x="5006" y="299"/>
                    </a:lnTo>
                    <a:lnTo>
                      <a:pt x="4991" y="299"/>
                    </a:lnTo>
                    <a:lnTo>
                      <a:pt x="4977" y="299"/>
                    </a:lnTo>
                    <a:lnTo>
                      <a:pt x="4962" y="299"/>
                    </a:lnTo>
                    <a:lnTo>
                      <a:pt x="4949" y="299"/>
                    </a:lnTo>
                    <a:lnTo>
                      <a:pt x="4933" y="299"/>
                    </a:lnTo>
                    <a:lnTo>
                      <a:pt x="4920" y="299"/>
                    </a:lnTo>
                    <a:lnTo>
                      <a:pt x="4905" y="299"/>
                    </a:lnTo>
                    <a:lnTo>
                      <a:pt x="4891" y="299"/>
                    </a:lnTo>
                    <a:lnTo>
                      <a:pt x="4876" y="299"/>
                    </a:lnTo>
                    <a:lnTo>
                      <a:pt x="4862" y="299"/>
                    </a:lnTo>
                    <a:lnTo>
                      <a:pt x="4847" y="299"/>
                    </a:lnTo>
                    <a:lnTo>
                      <a:pt x="4833" y="299"/>
                    </a:lnTo>
                    <a:lnTo>
                      <a:pt x="4818" y="299"/>
                    </a:lnTo>
                    <a:lnTo>
                      <a:pt x="4803" y="299"/>
                    </a:lnTo>
                    <a:lnTo>
                      <a:pt x="4789" y="299"/>
                    </a:lnTo>
                    <a:lnTo>
                      <a:pt x="4774" y="299"/>
                    </a:lnTo>
                    <a:lnTo>
                      <a:pt x="4761" y="299"/>
                    </a:lnTo>
                    <a:lnTo>
                      <a:pt x="4745" y="299"/>
                    </a:lnTo>
                    <a:lnTo>
                      <a:pt x="4732" y="299"/>
                    </a:lnTo>
                    <a:lnTo>
                      <a:pt x="4716" y="299"/>
                    </a:lnTo>
                    <a:lnTo>
                      <a:pt x="4703" y="299"/>
                    </a:lnTo>
                    <a:lnTo>
                      <a:pt x="4688" y="299"/>
                    </a:lnTo>
                    <a:lnTo>
                      <a:pt x="4674" y="299"/>
                    </a:lnTo>
                    <a:lnTo>
                      <a:pt x="4659" y="299"/>
                    </a:lnTo>
                    <a:lnTo>
                      <a:pt x="4645" y="299"/>
                    </a:lnTo>
                    <a:lnTo>
                      <a:pt x="4630" y="299"/>
                    </a:lnTo>
                    <a:lnTo>
                      <a:pt x="4616" y="299"/>
                    </a:lnTo>
                    <a:lnTo>
                      <a:pt x="4601" y="299"/>
                    </a:lnTo>
                    <a:lnTo>
                      <a:pt x="4588" y="299"/>
                    </a:lnTo>
                    <a:lnTo>
                      <a:pt x="4572" y="299"/>
                    </a:lnTo>
                    <a:lnTo>
                      <a:pt x="4559" y="299"/>
                    </a:lnTo>
                    <a:lnTo>
                      <a:pt x="4544" y="299"/>
                    </a:lnTo>
                    <a:lnTo>
                      <a:pt x="4530" y="299"/>
                    </a:lnTo>
                    <a:lnTo>
                      <a:pt x="4515" y="299"/>
                    </a:lnTo>
                    <a:lnTo>
                      <a:pt x="4501" y="299"/>
                    </a:lnTo>
                    <a:lnTo>
                      <a:pt x="4486" y="299"/>
                    </a:lnTo>
                    <a:lnTo>
                      <a:pt x="4472" y="299"/>
                    </a:lnTo>
                    <a:lnTo>
                      <a:pt x="4457" y="299"/>
                    </a:lnTo>
                    <a:lnTo>
                      <a:pt x="4444" y="299"/>
                    </a:lnTo>
                    <a:lnTo>
                      <a:pt x="4428" y="299"/>
                    </a:lnTo>
                    <a:lnTo>
                      <a:pt x="4415" y="299"/>
                    </a:lnTo>
                    <a:lnTo>
                      <a:pt x="4400" y="299"/>
                    </a:lnTo>
                    <a:lnTo>
                      <a:pt x="4386" y="299"/>
                    </a:lnTo>
                    <a:lnTo>
                      <a:pt x="4371" y="299"/>
                    </a:lnTo>
                    <a:lnTo>
                      <a:pt x="4357" y="299"/>
                    </a:lnTo>
                    <a:lnTo>
                      <a:pt x="4342" y="299"/>
                    </a:lnTo>
                    <a:lnTo>
                      <a:pt x="4328" y="299"/>
                    </a:lnTo>
                    <a:lnTo>
                      <a:pt x="4313" y="299"/>
                    </a:lnTo>
                    <a:lnTo>
                      <a:pt x="4300" y="299"/>
                    </a:lnTo>
                    <a:lnTo>
                      <a:pt x="4284" y="299"/>
                    </a:lnTo>
                    <a:lnTo>
                      <a:pt x="4271" y="299"/>
                    </a:lnTo>
                    <a:lnTo>
                      <a:pt x="4256" y="299"/>
                    </a:lnTo>
                    <a:lnTo>
                      <a:pt x="4242" y="299"/>
                    </a:lnTo>
                    <a:lnTo>
                      <a:pt x="4227" y="299"/>
                    </a:lnTo>
                    <a:lnTo>
                      <a:pt x="4213" y="299"/>
                    </a:lnTo>
                    <a:lnTo>
                      <a:pt x="4198" y="299"/>
                    </a:lnTo>
                    <a:lnTo>
                      <a:pt x="4184" y="299"/>
                    </a:lnTo>
                    <a:lnTo>
                      <a:pt x="4169" y="299"/>
                    </a:lnTo>
                    <a:lnTo>
                      <a:pt x="4154" y="299"/>
                    </a:lnTo>
                    <a:lnTo>
                      <a:pt x="4140" y="299"/>
                    </a:lnTo>
                    <a:lnTo>
                      <a:pt x="4125" y="299"/>
                    </a:lnTo>
                    <a:lnTo>
                      <a:pt x="4111" y="299"/>
                    </a:lnTo>
                    <a:lnTo>
                      <a:pt x="4096" y="299"/>
                    </a:lnTo>
                    <a:lnTo>
                      <a:pt x="4083" y="299"/>
                    </a:lnTo>
                    <a:lnTo>
                      <a:pt x="4067" y="299"/>
                    </a:lnTo>
                    <a:lnTo>
                      <a:pt x="4054" y="299"/>
                    </a:lnTo>
                    <a:lnTo>
                      <a:pt x="4039" y="299"/>
                    </a:lnTo>
                    <a:lnTo>
                      <a:pt x="4025" y="299"/>
                    </a:lnTo>
                    <a:lnTo>
                      <a:pt x="4010" y="299"/>
                    </a:lnTo>
                    <a:lnTo>
                      <a:pt x="3996" y="299"/>
                    </a:lnTo>
                    <a:lnTo>
                      <a:pt x="3981" y="299"/>
                    </a:lnTo>
                    <a:lnTo>
                      <a:pt x="3967" y="299"/>
                    </a:lnTo>
                    <a:lnTo>
                      <a:pt x="3952" y="299"/>
                    </a:lnTo>
                    <a:lnTo>
                      <a:pt x="3939" y="299"/>
                    </a:lnTo>
                    <a:lnTo>
                      <a:pt x="3923" y="299"/>
                    </a:lnTo>
                    <a:lnTo>
                      <a:pt x="3910" y="299"/>
                    </a:lnTo>
                    <a:lnTo>
                      <a:pt x="3895" y="299"/>
                    </a:lnTo>
                    <a:lnTo>
                      <a:pt x="3881" y="299"/>
                    </a:lnTo>
                    <a:lnTo>
                      <a:pt x="3866" y="299"/>
                    </a:lnTo>
                    <a:lnTo>
                      <a:pt x="3852" y="299"/>
                    </a:lnTo>
                    <a:lnTo>
                      <a:pt x="3837" y="299"/>
                    </a:lnTo>
                    <a:lnTo>
                      <a:pt x="3823" y="299"/>
                    </a:lnTo>
                    <a:lnTo>
                      <a:pt x="3808" y="299"/>
                    </a:lnTo>
                    <a:lnTo>
                      <a:pt x="3795" y="299"/>
                    </a:lnTo>
                    <a:lnTo>
                      <a:pt x="3779" y="299"/>
                    </a:lnTo>
                    <a:lnTo>
                      <a:pt x="3766" y="299"/>
                    </a:lnTo>
                    <a:lnTo>
                      <a:pt x="3751" y="299"/>
                    </a:lnTo>
                    <a:lnTo>
                      <a:pt x="3737" y="299"/>
                    </a:lnTo>
                    <a:lnTo>
                      <a:pt x="3722" y="299"/>
                    </a:lnTo>
                    <a:lnTo>
                      <a:pt x="3708" y="299"/>
                    </a:lnTo>
                    <a:lnTo>
                      <a:pt x="3693" y="299"/>
                    </a:lnTo>
                    <a:lnTo>
                      <a:pt x="3679" y="299"/>
                    </a:lnTo>
                    <a:lnTo>
                      <a:pt x="3664" y="299"/>
                    </a:lnTo>
                    <a:lnTo>
                      <a:pt x="3651" y="299"/>
                    </a:lnTo>
                    <a:lnTo>
                      <a:pt x="3635" y="299"/>
                    </a:lnTo>
                    <a:lnTo>
                      <a:pt x="3622" y="299"/>
                    </a:lnTo>
                    <a:lnTo>
                      <a:pt x="3607" y="299"/>
                    </a:lnTo>
                    <a:lnTo>
                      <a:pt x="3593" y="299"/>
                    </a:lnTo>
                    <a:lnTo>
                      <a:pt x="3578" y="299"/>
                    </a:lnTo>
                    <a:lnTo>
                      <a:pt x="3564" y="299"/>
                    </a:lnTo>
                    <a:lnTo>
                      <a:pt x="3549" y="299"/>
                    </a:lnTo>
                    <a:lnTo>
                      <a:pt x="3535" y="299"/>
                    </a:lnTo>
                    <a:lnTo>
                      <a:pt x="3520" y="299"/>
                    </a:lnTo>
                    <a:lnTo>
                      <a:pt x="3505" y="299"/>
                    </a:lnTo>
                    <a:lnTo>
                      <a:pt x="3491" y="299"/>
                    </a:lnTo>
                    <a:lnTo>
                      <a:pt x="3476" y="299"/>
                    </a:lnTo>
                    <a:lnTo>
                      <a:pt x="3462" y="299"/>
                    </a:lnTo>
                    <a:lnTo>
                      <a:pt x="3447" y="299"/>
                    </a:lnTo>
                    <a:lnTo>
                      <a:pt x="3434" y="299"/>
                    </a:lnTo>
                    <a:lnTo>
                      <a:pt x="3418" y="299"/>
                    </a:lnTo>
                    <a:lnTo>
                      <a:pt x="3405" y="299"/>
                    </a:lnTo>
                    <a:lnTo>
                      <a:pt x="3390" y="299"/>
                    </a:lnTo>
                    <a:lnTo>
                      <a:pt x="3376" y="299"/>
                    </a:lnTo>
                    <a:lnTo>
                      <a:pt x="3361" y="299"/>
                    </a:lnTo>
                    <a:lnTo>
                      <a:pt x="3347" y="299"/>
                    </a:lnTo>
                    <a:lnTo>
                      <a:pt x="3332" y="299"/>
                    </a:lnTo>
                    <a:lnTo>
                      <a:pt x="3318" y="299"/>
                    </a:lnTo>
                    <a:lnTo>
                      <a:pt x="3303" y="299"/>
                    </a:lnTo>
                    <a:lnTo>
                      <a:pt x="3290" y="299"/>
                    </a:lnTo>
                    <a:lnTo>
                      <a:pt x="3274" y="299"/>
                    </a:lnTo>
                    <a:lnTo>
                      <a:pt x="3261" y="299"/>
                    </a:lnTo>
                    <a:lnTo>
                      <a:pt x="3246" y="299"/>
                    </a:lnTo>
                    <a:lnTo>
                      <a:pt x="3232" y="299"/>
                    </a:lnTo>
                    <a:lnTo>
                      <a:pt x="3217" y="299"/>
                    </a:lnTo>
                    <a:lnTo>
                      <a:pt x="3203" y="299"/>
                    </a:lnTo>
                    <a:lnTo>
                      <a:pt x="3188" y="299"/>
                    </a:lnTo>
                    <a:lnTo>
                      <a:pt x="3174" y="299"/>
                    </a:lnTo>
                    <a:lnTo>
                      <a:pt x="3159" y="299"/>
                    </a:lnTo>
                    <a:lnTo>
                      <a:pt x="3146" y="299"/>
                    </a:lnTo>
                    <a:lnTo>
                      <a:pt x="3130" y="299"/>
                    </a:lnTo>
                    <a:lnTo>
                      <a:pt x="3117" y="299"/>
                    </a:lnTo>
                    <a:lnTo>
                      <a:pt x="3102" y="299"/>
                    </a:lnTo>
                    <a:lnTo>
                      <a:pt x="3088" y="299"/>
                    </a:lnTo>
                    <a:lnTo>
                      <a:pt x="3073" y="299"/>
                    </a:lnTo>
                    <a:lnTo>
                      <a:pt x="3059" y="299"/>
                    </a:lnTo>
                    <a:lnTo>
                      <a:pt x="3044" y="299"/>
                    </a:lnTo>
                    <a:lnTo>
                      <a:pt x="3030" y="299"/>
                    </a:lnTo>
                    <a:lnTo>
                      <a:pt x="3015" y="299"/>
                    </a:lnTo>
                    <a:lnTo>
                      <a:pt x="3002" y="299"/>
                    </a:lnTo>
                    <a:lnTo>
                      <a:pt x="2986" y="299"/>
                    </a:lnTo>
                    <a:lnTo>
                      <a:pt x="2973" y="299"/>
                    </a:lnTo>
                    <a:lnTo>
                      <a:pt x="2957" y="299"/>
                    </a:lnTo>
                    <a:lnTo>
                      <a:pt x="2944" y="299"/>
                    </a:lnTo>
                    <a:lnTo>
                      <a:pt x="2929" y="299"/>
                    </a:lnTo>
                    <a:lnTo>
                      <a:pt x="2915" y="299"/>
                    </a:lnTo>
                    <a:lnTo>
                      <a:pt x="2900" y="299"/>
                    </a:lnTo>
                    <a:lnTo>
                      <a:pt x="2886" y="299"/>
                    </a:lnTo>
                    <a:lnTo>
                      <a:pt x="2871" y="299"/>
                    </a:lnTo>
                    <a:lnTo>
                      <a:pt x="2856" y="299"/>
                    </a:lnTo>
                    <a:lnTo>
                      <a:pt x="2842" y="299"/>
                    </a:lnTo>
                    <a:lnTo>
                      <a:pt x="2827" y="299"/>
                    </a:lnTo>
                    <a:lnTo>
                      <a:pt x="2813" y="299"/>
                    </a:lnTo>
                    <a:lnTo>
                      <a:pt x="2798" y="299"/>
                    </a:lnTo>
                    <a:lnTo>
                      <a:pt x="2785" y="299"/>
                    </a:lnTo>
                    <a:lnTo>
                      <a:pt x="2769" y="299"/>
                    </a:lnTo>
                    <a:lnTo>
                      <a:pt x="2756" y="299"/>
                    </a:lnTo>
                    <a:lnTo>
                      <a:pt x="2741" y="299"/>
                    </a:lnTo>
                    <a:lnTo>
                      <a:pt x="2727" y="299"/>
                    </a:lnTo>
                    <a:lnTo>
                      <a:pt x="2712" y="299"/>
                    </a:lnTo>
                    <a:lnTo>
                      <a:pt x="2698" y="299"/>
                    </a:lnTo>
                    <a:lnTo>
                      <a:pt x="2683" y="299"/>
                    </a:lnTo>
                    <a:lnTo>
                      <a:pt x="2669" y="299"/>
                    </a:lnTo>
                    <a:lnTo>
                      <a:pt x="2654" y="299"/>
                    </a:lnTo>
                    <a:lnTo>
                      <a:pt x="2641" y="299"/>
                    </a:lnTo>
                    <a:lnTo>
                      <a:pt x="2625" y="299"/>
                    </a:lnTo>
                    <a:lnTo>
                      <a:pt x="2612" y="299"/>
                    </a:lnTo>
                    <a:lnTo>
                      <a:pt x="2597" y="299"/>
                    </a:lnTo>
                    <a:lnTo>
                      <a:pt x="2583" y="299"/>
                    </a:lnTo>
                    <a:lnTo>
                      <a:pt x="2568" y="299"/>
                    </a:lnTo>
                    <a:lnTo>
                      <a:pt x="2554" y="299"/>
                    </a:lnTo>
                    <a:lnTo>
                      <a:pt x="2539" y="299"/>
                    </a:lnTo>
                    <a:lnTo>
                      <a:pt x="2525" y="299"/>
                    </a:lnTo>
                    <a:lnTo>
                      <a:pt x="2510" y="299"/>
                    </a:lnTo>
                    <a:lnTo>
                      <a:pt x="2497" y="299"/>
                    </a:lnTo>
                    <a:lnTo>
                      <a:pt x="2481" y="299"/>
                    </a:lnTo>
                    <a:lnTo>
                      <a:pt x="2468" y="299"/>
                    </a:lnTo>
                    <a:lnTo>
                      <a:pt x="2453" y="299"/>
                    </a:lnTo>
                    <a:lnTo>
                      <a:pt x="2439" y="299"/>
                    </a:lnTo>
                    <a:lnTo>
                      <a:pt x="2424" y="299"/>
                    </a:lnTo>
                    <a:lnTo>
                      <a:pt x="2410" y="299"/>
                    </a:lnTo>
                    <a:lnTo>
                      <a:pt x="2395" y="299"/>
                    </a:lnTo>
                    <a:lnTo>
                      <a:pt x="2381" y="299"/>
                    </a:lnTo>
                    <a:lnTo>
                      <a:pt x="2366" y="299"/>
                    </a:lnTo>
                    <a:lnTo>
                      <a:pt x="2353" y="299"/>
                    </a:lnTo>
                    <a:lnTo>
                      <a:pt x="2337" y="299"/>
                    </a:lnTo>
                    <a:lnTo>
                      <a:pt x="2324" y="299"/>
                    </a:lnTo>
                    <a:lnTo>
                      <a:pt x="2308" y="299"/>
                    </a:lnTo>
                    <a:lnTo>
                      <a:pt x="2295" y="299"/>
                    </a:lnTo>
                    <a:lnTo>
                      <a:pt x="2280" y="299"/>
                    </a:lnTo>
                    <a:lnTo>
                      <a:pt x="2266" y="299"/>
                    </a:lnTo>
                    <a:lnTo>
                      <a:pt x="2251" y="299"/>
                    </a:lnTo>
                    <a:lnTo>
                      <a:pt x="2237" y="299"/>
                    </a:lnTo>
                    <a:lnTo>
                      <a:pt x="2222" y="299"/>
                    </a:lnTo>
                    <a:lnTo>
                      <a:pt x="2207" y="299"/>
                    </a:lnTo>
                    <a:lnTo>
                      <a:pt x="2193" y="299"/>
                    </a:lnTo>
                    <a:lnTo>
                      <a:pt x="2178" y="299"/>
                    </a:lnTo>
                    <a:lnTo>
                      <a:pt x="2164" y="299"/>
                    </a:lnTo>
                    <a:lnTo>
                      <a:pt x="2149" y="299"/>
                    </a:lnTo>
                    <a:lnTo>
                      <a:pt x="2136" y="299"/>
                    </a:lnTo>
                    <a:lnTo>
                      <a:pt x="2120" y="299"/>
                    </a:lnTo>
                    <a:lnTo>
                      <a:pt x="2107" y="299"/>
                    </a:lnTo>
                    <a:lnTo>
                      <a:pt x="2092" y="299"/>
                    </a:lnTo>
                    <a:lnTo>
                      <a:pt x="2078" y="299"/>
                    </a:lnTo>
                    <a:lnTo>
                      <a:pt x="2063" y="299"/>
                    </a:lnTo>
                    <a:lnTo>
                      <a:pt x="2049" y="299"/>
                    </a:lnTo>
                    <a:lnTo>
                      <a:pt x="2034" y="299"/>
                    </a:lnTo>
                    <a:lnTo>
                      <a:pt x="2020" y="299"/>
                    </a:lnTo>
                    <a:lnTo>
                      <a:pt x="2005" y="299"/>
                    </a:lnTo>
                    <a:lnTo>
                      <a:pt x="1992" y="299"/>
                    </a:lnTo>
                    <a:lnTo>
                      <a:pt x="1976" y="299"/>
                    </a:lnTo>
                    <a:lnTo>
                      <a:pt x="1963" y="299"/>
                    </a:lnTo>
                    <a:lnTo>
                      <a:pt x="1948" y="299"/>
                    </a:lnTo>
                    <a:lnTo>
                      <a:pt x="1934" y="299"/>
                    </a:lnTo>
                    <a:lnTo>
                      <a:pt x="1919" y="299"/>
                    </a:lnTo>
                    <a:lnTo>
                      <a:pt x="1905" y="299"/>
                    </a:lnTo>
                    <a:lnTo>
                      <a:pt x="1890" y="299"/>
                    </a:lnTo>
                    <a:lnTo>
                      <a:pt x="1876" y="299"/>
                    </a:lnTo>
                    <a:lnTo>
                      <a:pt x="1861" y="299"/>
                    </a:lnTo>
                    <a:lnTo>
                      <a:pt x="1848" y="299"/>
                    </a:lnTo>
                    <a:lnTo>
                      <a:pt x="1832" y="299"/>
                    </a:lnTo>
                    <a:lnTo>
                      <a:pt x="1819" y="299"/>
                    </a:lnTo>
                    <a:lnTo>
                      <a:pt x="1803" y="299"/>
                    </a:lnTo>
                    <a:lnTo>
                      <a:pt x="1790" y="299"/>
                    </a:lnTo>
                    <a:lnTo>
                      <a:pt x="1775" y="299"/>
                    </a:lnTo>
                    <a:lnTo>
                      <a:pt x="1761" y="299"/>
                    </a:lnTo>
                    <a:lnTo>
                      <a:pt x="1746" y="299"/>
                    </a:lnTo>
                    <a:lnTo>
                      <a:pt x="1732" y="299"/>
                    </a:lnTo>
                    <a:lnTo>
                      <a:pt x="1717" y="299"/>
                    </a:lnTo>
                    <a:lnTo>
                      <a:pt x="1704" y="299"/>
                    </a:lnTo>
                    <a:lnTo>
                      <a:pt x="1688" y="299"/>
                    </a:lnTo>
                    <a:lnTo>
                      <a:pt x="1675" y="299"/>
                    </a:lnTo>
                    <a:lnTo>
                      <a:pt x="1659" y="299"/>
                    </a:lnTo>
                    <a:lnTo>
                      <a:pt x="1646" y="299"/>
                    </a:lnTo>
                    <a:lnTo>
                      <a:pt x="1631" y="299"/>
                    </a:lnTo>
                    <a:lnTo>
                      <a:pt x="1617" y="299"/>
                    </a:lnTo>
                    <a:lnTo>
                      <a:pt x="1602" y="299"/>
                    </a:lnTo>
                    <a:lnTo>
                      <a:pt x="1588" y="299"/>
                    </a:lnTo>
                    <a:lnTo>
                      <a:pt x="1573" y="299"/>
                    </a:lnTo>
                    <a:lnTo>
                      <a:pt x="1558" y="299"/>
                    </a:lnTo>
                    <a:lnTo>
                      <a:pt x="1544" y="299"/>
                    </a:lnTo>
                    <a:lnTo>
                      <a:pt x="1529" y="299"/>
                    </a:lnTo>
                    <a:lnTo>
                      <a:pt x="1515" y="299"/>
                    </a:lnTo>
                    <a:lnTo>
                      <a:pt x="1500" y="299"/>
                    </a:lnTo>
                    <a:lnTo>
                      <a:pt x="1487" y="299"/>
                    </a:lnTo>
                    <a:lnTo>
                      <a:pt x="1471" y="299"/>
                    </a:lnTo>
                    <a:lnTo>
                      <a:pt x="1458" y="299"/>
                    </a:lnTo>
                    <a:lnTo>
                      <a:pt x="1443" y="299"/>
                    </a:lnTo>
                    <a:lnTo>
                      <a:pt x="1429" y="299"/>
                    </a:lnTo>
                    <a:lnTo>
                      <a:pt x="1414" y="299"/>
                    </a:lnTo>
                    <a:lnTo>
                      <a:pt x="1400" y="299"/>
                    </a:lnTo>
                    <a:lnTo>
                      <a:pt x="1385" y="299"/>
                    </a:lnTo>
                    <a:lnTo>
                      <a:pt x="1371" y="299"/>
                    </a:lnTo>
                    <a:lnTo>
                      <a:pt x="1356" y="299"/>
                    </a:lnTo>
                    <a:lnTo>
                      <a:pt x="1343" y="299"/>
                    </a:lnTo>
                    <a:lnTo>
                      <a:pt x="1327" y="299"/>
                    </a:lnTo>
                    <a:lnTo>
                      <a:pt x="1314" y="299"/>
                    </a:lnTo>
                    <a:lnTo>
                      <a:pt x="1299" y="299"/>
                    </a:lnTo>
                    <a:lnTo>
                      <a:pt x="1285" y="299"/>
                    </a:lnTo>
                    <a:lnTo>
                      <a:pt x="1270" y="299"/>
                    </a:lnTo>
                    <a:lnTo>
                      <a:pt x="1256" y="299"/>
                    </a:lnTo>
                    <a:lnTo>
                      <a:pt x="1241" y="299"/>
                    </a:lnTo>
                    <a:lnTo>
                      <a:pt x="1227" y="299"/>
                    </a:lnTo>
                    <a:lnTo>
                      <a:pt x="1212" y="299"/>
                    </a:lnTo>
                    <a:lnTo>
                      <a:pt x="1199" y="299"/>
                    </a:lnTo>
                    <a:lnTo>
                      <a:pt x="1183" y="299"/>
                    </a:lnTo>
                    <a:lnTo>
                      <a:pt x="1170" y="299"/>
                    </a:lnTo>
                    <a:lnTo>
                      <a:pt x="1154" y="299"/>
                    </a:lnTo>
                    <a:lnTo>
                      <a:pt x="1141" y="299"/>
                    </a:lnTo>
                    <a:lnTo>
                      <a:pt x="1126" y="299"/>
                    </a:lnTo>
                    <a:lnTo>
                      <a:pt x="1112" y="299"/>
                    </a:lnTo>
                    <a:lnTo>
                      <a:pt x="1097" y="299"/>
                    </a:lnTo>
                    <a:lnTo>
                      <a:pt x="1083" y="299"/>
                    </a:lnTo>
                    <a:lnTo>
                      <a:pt x="1068" y="299"/>
                    </a:lnTo>
                    <a:lnTo>
                      <a:pt x="1055" y="299"/>
                    </a:lnTo>
                    <a:lnTo>
                      <a:pt x="1039" y="299"/>
                    </a:lnTo>
                    <a:lnTo>
                      <a:pt x="1026" y="299"/>
                    </a:lnTo>
                    <a:lnTo>
                      <a:pt x="1010" y="299"/>
                    </a:lnTo>
                    <a:lnTo>
                      <a:pt x="997" y="299"/>
                    </a:lnTo>
                    <a:lnTo>
                      <a:pt x="982" y="299"/>
                    </a:lnTo>
                    <a:lnTo>
                      <a:pt x="968" y="299"/>
                    </a:lnTo>
                    <a:lnTo>
                      <a:pt x="953" y="299"/>
                    </a:lnTo>
                    <a:lnTo>
                      <a:pt x="939" y="299"/>
                    </a:lnTo>
                    <a:lnTo>
                      <a:pt x="924" y="299"/>
                    </a:lnTo>
                    <a:lnTo>
                      <a:pt x="909" y="299"/>
                    </a:lnTo>
                    <a:lnTo>
                      <a:pt x="895" y="299"/>
                    </a:lnTo>
                    <a:lnTo>
                      <a:pt x="880" y="299"/>
                    </a:lnTo>
                    <a:lnTo>
                      <a:pt x="866" y="299"/>
                    </a:lnTo>
                    <a:lnTo>
                      <a:pt x="851" y="299"/>
                    </a:lnTo>
                    <a:lnTo>
                      <a:pt x="838" y="299"/>
                    </a:lnTo>
                    <a:lnTo>
                      <a:pt x="822" y="299"/>
                    </a:lnTo>
                    <a:lnTo>
                      <a:pt x="809" y="299"/>
                    </a:lnTo>
                    <a:lnTo>
                      <a:pt x="794" y="299"/>
                    </a:lnTo>
                    <a:lnTo>
                      <a:pt x="780" y="299"/>
                    </a:lnTo>
                    <a:lnTo>
                      <a:pt x="765" y="299"/>
                    </a:lnTo>
                    <a:lnTo>
                      <a:pt x="751" y="299"/>
                    </a:lnTo>
                    <a:lnTo>
                      <a:pt x="736" y="299"/>
                    </a:lnTo>
                    <a:lnTo>
                      <a:pt x="722" y="299"/>
                    </a:lnTo>
                    <a:lnTo>
                      <a:pt x="707" y="299"/>
                    </a:lnTo>
                    <a:lnTo>
                      <a:pt x="694" y="299"/>
                    </a:lnTo>
                    <a:lnTo>
                      <a:pt x="678" y="299"/>
                    </a:lnTo>
                    <a:lnTo>
                      <a:pt x="665" y="299"/>
                    </a:lnTo>
                    <a:lnTo>
                      <a:pt x="649" y="299"/>
                    </a:lnTo>
                    <a:lnTo>
                      <a:pt x="636" y="299"/>
                    </a:lnTo>
                    <a:lnTo>
                      <a:pt x="621" y="299"/>
                    </a:lnTo>
                    <a:lnTo>
                      <a:pt x="607" y="299"/>
                    </a:lnTo>
                    <a:lnTo>
                      <a:pt x="592" y="299"/>
                    </a:lnTo>
                    <a:lnTo>
                      <a:pt x="578" y="299"/>
                    </a:lnTo>
                    <a:lnTo>
                      <a:pt x="563" y="299"/>
                    </a:lnTo>
                    <a:lnTo>
                      <a:pt x="550" y="299"/>
                    </a:lnTo>
                    <a:lnTo>
                      <a:pt x="534" y="299"/>
                    </a:lnTo>
                    <a:lnTo>
                      <a:pt x="521" y="299"/>
                    </a:lnTo>
                    <a:lnTo>
                      <a:pt x="505" y="299"/>
                    </a:lnTo>
                    <a:lnTo>
                      <a:pt x="492" y="299"/>
                    </a:lnTo>
                    <a:lnTo>
                      <a:pt x="477" y="299"/>
                    </a:lnTo>
                    <a:lnTo>
                      <a:pt x="463" y="299"/>
                    </a:lnTo>
                    <a:lnTo>
                      <a:pt x="448" y="299"/>
                    </a:lnTo>
                    <a:lnTo>
                      <a:pt x="434" y="299"/>
                    </a:lnTo>
                    <a:lnTo>
                      <a:pt x="419" y="299"/>
                    </a:lnTo>
                    <a:lnTo>
                      <a:pt x="406" y="299"/>
                    </a:lnTo>
                    <a:lnTo>
                      <a:pt x="390" y="299"/>
                    </a:lnTo>
                    <a:lnTo>
                      <a:pt x="377" y="299"/>
                    </a:lnTo>
                    <a:lnTo>
                      <a:pt x="361" y="299"/>
                    </a:lnTo>
                    <a:lnTo>
                      <a:pt x="348" y="299"/>
                    </a:lnTo>
                    <a:lnTo>
                      <a:pt x="333" y="299"/>
                    </a:lnTo>
                    <a:lnTo>
                      <a:pt x="319" y="299"/>
                    </a:lnTo>
                    <a:lnTo>
                      <a:pt x="304" y="299"/>
                    </a:lnTo>
                    <a:lnTo>
                      <a:pt x="290" y="299"/>
                    </a:lnTo>
                    <a:lnTo>
                      <a:pt x="275" y="299"/>
                    </a:lnTo>
                    <a:lnTo>
                      <a:pt x="260" y="299"/>
                    </a:lnTo>
                    <a:lnTo>
                      <a:pt x="246" y="299"/>
                    </a:lnTo>
                    <a:lnTo>
                      <a:pt x="231" y="299"/>
                    </a:lnTo>
                    <a:lnTo>
                      <a:pt x="217" y="299"/>
                    </a:lnTo>
                    <a:lnTo>
                      <a:pt x="202" y="299"/>
                    </a:lnTo>
                    <a:lnTo>
                      <a:pt x="189" y="299"/>
                    </a:lnTo>
                    <a:lnTo>
                      <a:pt x="173" y="299"/>
                    </a:lnTo>
                    <a:lnTo>
                      <a:pt x="160" y="299"/>
                    </a:lnTo>
                    <a:lnTo>
                      <a:pt x="145" y="299"/>
                    </a:lnTo>
                    <a:lnTo>
                      <a:pt x="131" y="299"/>
                    </a:lnTo>
                    <a:lnTo>
                      <a:pt x="116" y="299"/>
                    </a:lnTo>
                    <a:lnTo>
                      <a:pt x="102" y="299"/>
                    </a:lnTo>
                    <a:lnTo>
                      <a:pt x="87" y="299"/>
                    </a:lnTo>
                    <a:lnTo>
                      <a:pt x="73" y="299"/>
                    </a:lnTo>
                    <a:lnTo>
                      <a:pt x="58" y="299"/>
                    </a:lnTo>
                    <a:lnTo>
                      <a:pt x="45" y="299"/>
                    </a:lnTo>
                    <a:lnTo>
                      <a:pt x="29" y="299"/>
                    </a:lnTo>
                    <a:lnTo>
                      <a:pt x="16" y="299"/>
                    </a:lnTo>
                    <a:lnTo>
                      <a:pt x="0" y="299"/>
                    </a:lnTo>
                    <a:lnTo>
                      <a:pt x="0" y="174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3" name="Freeform 70"/>
              <p:cNvSpPr>
                <a:spLocks/>
              </p:cNvSpPr>
              <p:nvPr/>
            </p:nvSpPr>
            <p:spPr bwMode="auto">
              <a:xfrm rot="5400000" flipV="1">
                <a:off x="2607950" y="3066713"/>
                <a:ext cx="4185289" cy="190317"/>
              </a:xfrm>
              <a:custGeom>
                <a:avLst/>
                <a:gdLst>
                  <a:gd name="T0" fmla="*/ 156 w 5410"/>
                  <a:gd name="T1" fmla="*/ 152 h 286"/>
                  <a:gd name="T2" fmla="*/ 325 w 5410"/>
                  <a:gd name="T3" fmla="*/ 119 h 286"/>
                  <a:gd name="T4" fmla="*/ 496 w 5410"/>
                  <a:gd name="T5" fmla="*/ 60 h 286"/>
                  <a:gd name="T6" fmla="*/ 665 w 5410"/>
                  <a:gd name="T7" fmla="*/ 136 h 286"/>
                  <a:gd name="T8" fmla="*/ 836 w 5410"/>
                  <a:gd name="T9" fmla="*/ 204 h 286"/>
                  <a:gd name="T10" fmla="*/ 1005 w 5410"/>
                  <a:gd name="T11" fmla="*/ 35 h 286"/>
                  <a:gd name="T12" fmla="*/ 1176 w 5410"/>
                  <a:gd name="T13" fmla="*/ 92 h 286"/>
                  <a:gd name="T14" fmla="*/ 1345 w 5410"/>
                  <a:gd name="T15" fmla="*/ 98 h 286"/>
                  <a:gd name="T16" fmla="*/ 1515 w 5410"/>
                  <a:gd name="T17" fmla="*/ 173 h 286"/>
                  <a:gd name="T18" fmla="*/ 1684 w 5410"/>
                  <a:gd name="T19" fmla="*/ 267 h 286"/>
                  <a:gd name="T20" fmla="*/ 1855 w 5410"/>
                  <a:gd name="T21" fmla="*/ 152 h 286"/>
                  <a:gd name="T22" fmla="*/ 2026 w 5410"/>
                  <a:gd name="T23" fmla="*/ 246 h 286"/>
                  <a:gd name="T24" fmla="*/ 2195 w 5410"/>
                  <a:gd name="T25" fmla="*/ 246 h 286"/>
                  <a:gd name="T26" fmla="*/ 2366 w 5410"/>
                  <a:gd name="T27" fmla="*/ 225 h 286"/>
                  <a:gd name="T28" fmla="*/ 2535 w 5410"/>
                  <a:gd name="T29" fmla="*/ 286 h 286"/>
                  <a:gd name="T30" fmla="*/ 2706 w 5410"/>
                  <a:gd name="T31" fmla="*/ 177 h 286"/>
                  <a:gd name="T32" fmla="*/ 2875 w 5410"/>
                  <a:gd name="T33" fmla="*/ 286 h 286"/>
                  <a:gd name="T34" fmla="*/ 3046 w 5410"/>
                  <a:gd name="T35" fmla="*/ 286 h 286"/>
                  <a:gd name="T36" fmla="*/ 3215 w 5410"/>
                  <a:gd name="T37" fmla="*/ 281 h 286"/>
                  <a:gd name="T38" fmla="*/ 3386 w 5410"/>
                  <a:gd name="T39" fmla="*/ 217 h 286"/>
                  <a:gd name="T40" fmla="*/ 3555 w 5410"/>
                  <a:gd name="T41" fmla="*/ 286 h 286"/>
                  <a:gd name="T42" fmla="*/ 3726 w 5410"/>
                  <a:gd name="T43" fmla="*/ 271 h 286"/>
                  <a:gd name="T44" fmla="*/ 3895 w 5410"/>
                  <a:gd name="T45" fmla="*/ 286 h 286"/>
                  <a:gd name="T46" fmla="*/ 4065 w 5410"/>
                  <a:gd name="T47" fmla="*/ 246 h 286"/>
                  <a:gd name="T48" fmla="*/ 4234 w 5410"/>
                  <a:gd name="T49" fmla="*/ 111 h 286"/>
                  <a:gd name="T50" fmla="*/ 4405 w 5410"/>
                  <a:gd name="T51" fmla="*/ 188 h 286"/>
                  <a:gd name="T52" fmla="*/ 4574 w 5410"/>
                  <a:gd name="T53" fmla="*/ 133 h 286"/>
                  <a:gd name="T54" fmla="*/ 4745 w 5410"/>
                  <a:gd name="T55" fmla="*/ 98 h 286"/>
                  <a:gd name="T56" fmla="*/ 4914 w 5410"/>
                  <a:gd name="T57" fmla="*/ 90 h 286"/>
                  <a:gd name="T58" fmla="*/ 5085 w 5410"/>
                  <a:gd name="T59" fmla="*/ 90 h 286"/>
                  <a:gd name="T60" fmla="*/ 5254 w 5410"/>
                  <a:gd name="T61" fmla="*/ 146 h 286"/>
                  <a:gd name="T62" fmla="*/ 5410 w 5410"/>
                  <a:gd name="T63" fmla="*/ 286 h 286"/>
                  <a:gd name="T64" fmla="*/ 5239 w 5410"/>
                  <a:gd name="T65" fmla="*/ 286 h 286"/>
                  <a:gd name="T66" fmla="*/ 5070 w 5410"/>
                  <a:gd name="T67" fmla="*/ 286 h 286"/>
                  <a:gd name="T68" fmla="*/ 4899 w 5410"/>
                  <a:gd name="T69" fmla="*/ 286 h 286"/>
                  <a:gd name="T70" fmla="*/ 4730 w 5410"/>
                  <a:gd name="T71" fmla="*/ 286 h 286"/>
                  <a:gd name="T72" fmla="*/ 4559 w 5410"/>
                  <a:gd name="T73" fmla="*/ 286 h 286"/>
                  <a:gd name="T74" fmla="*/ 4390 w 5410"/>
                  <a:gd name="T75" fmla="*/ 286 h 286"/>
                  <a:gd name="T76" fmla="*/ 4219 w 5410"/>
                  <a:gd name="T77" fmla="*/ 286 h 286"/>
                  <a:gd name="T78" fmla="*/ 4050 w 5410"/>
                  <a:gd name="T79" fmla="*/ 286 h 286"/>
                  <a:gd name="T80" fmla="*/ 3879 w 5410"/>
                  <a:gd name="T81" fmla="*/ 286 h 286"/>
                  <a:gd name="T82" fmla="*/ 3710 w 5410"/>
                  <a:gd name="T83" fmla="*/ 286 h 286"/>
                  <a:gd name="T84" fmla="*/ 3539 w 5410"/>
                  <a:gd name="T85" fmla="*/ 286 h 286"/>
                  <a:gd name="T86" fmla="*/ 3370 w 5410"/>
                  <a:gd name="T87" fmla="*/ 286 h 286"/>
                  <a:gd name="T88" fmla="*/ 3199 w 5410"/>
                  <a:gd name="T89" fmla="*/ 286 h 286"/>
                  <a:gd name="T90" fmla="*/ 3030 w 5410"/>
                  <a:gd name="T91" fmla="*/ 286 h 286"/>
                  <a:gd name="T92" fmla="*/ 2860 w 5410"/>
                  <a:gd name="T93" fmla="*/ 286 h 286"/>
                  <a:gd name="T94" fmla="*/ 2691 w 5410"/>
                  <a:gd name="T95" fmla="*/ 286 h 286"/>
                  <a:gd name="T96" fmla="*/ 2520 w 5410"/>
                  <a:gd name="T97" fmla="*/ 286 h 286"/>
                  <a:gd name="T98" fmla="*/ 2351 w 5410"/>
                  <a:gd name="T99" fmla="*/ 286 h 286"/>
                  <a:gd name="T100" fmla="*/ 2180 w 5410"/>
                  <a:gd name="T101" fmla="*/ 286 h 286"/>
                  <a:gd name="T102" fmla="*/ 2009 w 5410"/>
                  <a:gd name="T103" fmla="*/ 286 h 286"/>
                  <a:gd name="T104" fmla="*/ 1840 w 5410"/>
                  <a:gd name="T105" fmla="*/ 286 h 286"/>
                  <a:gd name="T106" fmla="*/ 1669 w 5410"/>
                  <a:gd name="T107" fmla="*/ 286 h 286"/>
                  <a:gd name="T108" fmla="*/ 1500 w 5410"/>
                  <a:gd name="T109" fmla="*/ 286 h 286"/>
                  <a:gd name="T110" fmla="*/ 1329 w 5410"/>
                  <a:gd name="T111" fmla="*/ 286 h 286"/>
                  <a:gd name="T112" fmla="*/ 1160 w 5410"/>
                  <a:gd name="T113" fmla="*/ 286 h 286"/>
                  <a:gd name="T114" fmla="*/ 989 w 5410"/>
                  <a:gd name="T115" fmla="*/ 286 h 286"/>
                  <a:gd name="T116" fmla="*/ 820 w 5410"/>
                  <a:gd name="T117" fmla="*/ 286 h 286"/>
                  <a:gd name="T118" fmla="*/ 649 w 5410"/>
                  <a:gd name="T119" fmla="*/ 286 h 286"/>
                  <a:gd name="T120" fmla="*/ 481 w 5410"/>
                  <a:gd name="T121" fmla="*/ 286 h 286"/>
                  <a:gd name="T122" fmla="*/ 310 w 5410"/>
                  <a:gd name="T123" fmla="*/ 286 h 286"/>
                  <a:gd name="T124" fmla="*/ 141 w 5410"/>
                  <a:gd name="T125" fmla="*/ 286 h 2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5410" h="286">
                    <a:moveTo>
                      <a:pt x="0" y="236"/>
                    </a:moveTo>
                    <a:lnTo>
                      <a:pt x="16" y="96"/>
                    </a:lnTo>
                    <a:lnTo>
                      <a:pt x="31" y="42"/>
                    </a:lnTo>
                    <a:lnTo>
                      <a:pt x="47" y="127"/>
                    </a:lnTo>
                    <a:lnTo>
                      <a:pt x="62" y="87"/>
                    </a:lnTo>
                    <a:lnTo>
                      <a:pt x="79" y="140"/>
                    </a:lnTo>
                    <a:lnTo>
                      <a:pt x="95" y="156"/>
                    </a:lnTo>
                    <a:lnTo>
                      <a:pt x="110" y="69"/>
                    </a:lnTo>
                    <a:lnTo>
                      <a:pt x="125" y="87"/>
                    </a:lnTo>
                    <a:lnTo>
                      <a:pt x="141" y="100"/>
                    </a:lnTo>
                    <a:lnTo>
                      <a:pt x="156" y="152"/>
                    </a:lnTo>
                    <a:lnTo>
                      <a:pt x="171" y="169"/>
                    </a:lnTo>
                    <a:lnTo>
                      <a:pt x="187" y="65"/>
                    </a:lnTo>
                    <a:lnTo>
                      <a:pt x="202" y="85"/>
                    </a:lnTo>
                    <a:lnTo>
                      <a:pt x="217" y="154"/>
                    </a:lnTo>
                    <a:lnTo>
                      <a:pt x="233" y="48"/>
                    </a:lnTo>
                    <a:lnTo>
                      <a:pt x="248" y="110"/>
                    </a:lnTo>
                    <a:lnTo>
                      <a:pt x="264" y="111"/>
                    </a:lnTo>
                    <a:lnTo>
                      <a:pt x="279" y="133"/>
                    </a:lnTo>
                    <a:lnTo>
                      <a:pt x="294" y="115"/>
                    </a:lnTo>
                    <a:lnTo>
                      <a:pt x="310" y="131"/>
                    </a:lnTo>
                    <a:lnTo>
                      <a:pt x="325" y="119"/>
                    </a:lnTo>
                    <a:lnTo>
                      <a:pt x="340" y="83"/>
                    </a:lnTo>
                    <a:lnTo>
                      <a:pt x="356" y="73"/>
                    </a:lnTo>
                    <a:lnTo>
                      <a:pt x="371" y="133"/>
                    </a:lnTo>
                    <a:lnTo>
                      <a:pt x="386" y="140"/>
                    </a:lnTo>
                    <a:lnTo>
                      <a:pt x="404" y="87"/>
                    </a:lnTo>
                    <a:lnTo>
                      <a:pt x="419" y="119"/>
                    </a:lnTo>
                    <a:lnTo>
                      <a:pt x="434" y="77"/>
                    </a:lnTo>
                    <a:lnTo>
                      <a:pt x="450" y="94"/>
                    </a:lnTo>
                    <a:lnTo>
                      <a:pt x="465" y="25"/>
                    </a:lnTo>
                    <a:lnTo>
                      <a:pt x="481" y="108"/>
                    </a:lnTo>
                    <a:lnTo>
                      <a:pt x="496" y="60"/>
                    </a:lnTo>
                    <a:lnTo>
                      <a:pt x="511" y="37"/>
                    </a:lnTo>
                    <a:lnTo>
                      <a:pt x="527" y="69"/>
                    </a:lnTo>
                    <a:lnTo>
                      <a:pt x="542" y="69"/>
                    </a:lnTo>
                    <a:lnTo>
                      <a:pt x="557" y="87"/>
                    </a:lnTo>
                    <a:lnTo>
                      <a:pt x="573" y="111"/>
                    </a:lnTo>
                    <a:lnTo>
                      <a:pt x="588" y="161"/>
                    </a:lnTo>
                    <a:lnTo>
                      <a:pt x="603" y="135"/>
                    </a:lnTo>
                    <a:lnTo>
                      <a:pt x="619" y="110"/>
                    </a:lnTo>
                    <a:lnTo>
                      <a:pt x="634" y="133"/>
                    </a:lnTo>
                    <a:lnTo>
                      <a:pt x="649" y="81"/>
                    </a:lnTo>
                    <a:lnTo>
                      <a:pt x="665" y="136"/>
                    </a:lnTo>
                    <a:lnTo>
                      <a:pt x="680" y="46"/>
                    </a:lnTo>
                    <a:lnTo>
                      <a:pt x="696" y="62"/>
                    </a:lnTo>
                    <a:lnTo>
                      <a:pt x="711" y="121"/>
                    </a:lnTo>
                    <a:lnTo>
                      <a:pt x="728" y="83"/>
                    </a:lnTo>
                    <a:lnTo>
                      <a:pt x="744" y="102"/>
                    </a:lnTo>
                    <a:lnTo>
                      <a:pt x="759" y="67"/>
                    </a:lnTo>
                    <a:lnTo>
                      <a:pt x="774" y="177"/>
                    </a:lnTo>
                    <a:lnTo>
                      <a:pt x="790" y="69"/>
                    </a:lnTo>
                    <a:lnTo>
                      <a:pt x="805" y="127"/>
                    </a:lnTo>
                    <a:lnTo>
                      <a:pt x="820" y="38"/>
                    </a:lnTo>
                    <a:lnTo>
                      <a:pt x="836" y="204"/>
                    </a:lnTo>
                    <a:lnTo>
                      <a:pt x="851" y="0"/>
                    </a:lnTo>
                    <a:lnTo>
                      <a:pt x="866" y="129"/>
                    </a:lnTo>
                    <a:lnTo>
                      <a:pt x="882" y="154"/>
                    </a:lnTo>
                    <a:lnTo>
                      <a:pt x="897" y="88"/>
                    </a:lnTo>
                    <a:lnTo>
                      <a:pt x="913" y="79"/>
                    </a:lnTo>
                    <a:lnTo>
                      <a:pt x="928" y="98"/>
                    </a:lnTo>
                    <a:lnTo>
                      <a:pt x="943" y="98"/>
                    </a:lnTo>
                    <a:lnTo>
                      <a:pt x="959" y="90"/>
                    </a:lnTo>
                    <a:lnTo>
                      <a:pt x="974" y="92"/>
                    </a:lnTo>
                    <a:lnTo>
                      <a:pt x="989" y="92"/>
                    </a:lnTo>
                    <a:lnTo>
                      <a:pt x="1005" y="35"/>
                    </a:lnTo>
                    <a:lnTo>
                      <a:pt x="1020" y="81"/>
                    </a:lnTo>
                    <a:lnTo>
                      <a:pt x="1035" y="113"/>
                    </a:lnTo>
                    <a:lnTo>
                      <a:pt x="1053" y="123"/>
                    </a:lnTo>
                    <a:lnTo>
                      <a:pt x="1068" y="152"/>
                    </a:lnTo>
                    <a:lnTo>
                      <a:pt x="1083" y="75"/>
                    </a:lnTo>
                    <a:lnTo>
                      <a:pt x="1099" y="94"/>
                    </a:lnTo>
                    <a:lnTo>
                      <a:pt x="1114" y="63"/>
                    </a:lnTo>
                    <a:lnTo>
                      <a:pt x="1130" y="108"/>
                    </a:lnTo>
                    <a:lnTo>
                      <a:pt x="1145" y="233"/>
                    </a:lnTo>
                    <a:lnTo>
                      <a:pt x="1160" y="48"/>
                    </a:lnTo>
                    <a:lnTo>
                      <a:pt x="1176" y="92"/>
                    </a:lnTo>
                    <a:lnTo>
                      <a:pt x="1191" y="119"/>
                    </a:lnTo>
                    <a:lnTo>
                      <a:pt x="1206" y="192"/>
                    </a:lnTo>
                    <a:lnTo>
                      <a:pt x="1222" y="90"/>
                    </a:lnTo>
                    <a:lnTo>
                      <a:pt x="1237" y="135"/>
                    </a:lnTo>
                    <a:lnTo>
                      <a:pt x="1252" y="79"/>
                    </a:lnTo>
                    <a:lnTo>
                      <a:pt x="1268" y="88"/>
                    </a:lnTo>
                    <a:lnTo>
                      <a:pt x="1283" y="135"/>
                    </a:lnTo>
                    <a:lnTo>
                      <a:pt x="1299" y="119"/>
                    </a:lnTo>
                    <a:lnTo>
                      <a:pt x="1314" y="167"/>
                    </a:lnTo>
                    <a:lnTo>
                      <a:pt x="1329" y="50"/>
                    </a:lnTo>
                    <a:lnTo>
                      <a:pt x="1345" y="98"/>
                    </a:lnTo>
                    <a:lnTo>
                      <a:pt x="1360" y="186"/>
                    </a:lnTo>
                    <a:lnTo>
                      <a:pt x="1377" y="123"/>
                    </a:lnTo>
                    <a:lnTo>
                      <a:pt x="1393" y="181"/>
                    </a:lnTo>
                    <a:lnTo>
                      <a:pt x="1408" y="211"/>
                    </a:lnTo>
                    <a:lnTo>
                      <a:pt x="1423" y="102"/>
                    </a:lnTo>
                    <a:lnTo>
                      <a:pt x="1439" y="179"/>
                    </a:lnTo>
                    <a:lnTo>
                      <a:pt x="1454" y="173"/>
                    </a:lnTo>
                    <a:lnTo>
                      <a:pt x="1469" y="136"/>
                    </a:lnTo>
                    <a:lnTo>
                      <a:pt x="1485" y="204"/>
                    </a:lnTo>
                    <a:lnTo>
                      <a:pt x="1500" y="129"/>
                    </a:lnTo>
                    <a:lnTo>
                      <a:pt x="1515" y="173"/>
                    </a:lnTo>
                    <a:lnTo>
                      <a:pt x="1531" y="106"/>
                    </a:lnTo>
                    <a:lnTo>
                      <a:pt x="1546" y="140"/>
                    </a:lnTo>
                    <a:lnTo>
                      <a:pt x="1562" y="146"/>
                    </a:lnTo>
                    <a:lnTo>
                      <a:pt x="1577" y="156"/>
                    </a:lnTo>
                    <a:lnTo>
                      <a:pt x="1592" y="148"/>
                    </a:lnTo>
                    <a:lnTo>
                      <a:pt x="1608" y="129"/>
                    </a:lnTo>
                    <a:lnTo>
                      <a:pt x="1623" y="206"/>
                    </a:lnTo>
                    <a:lnTo>
                      <a:pt x="1638" y="150"/>
                    </a:lnTo>
                    <a:lnTo>
                      <a:pt x="1654" y="156"/>
                    </a:lnTo>
                    <a:lnTo>
                      <a:pt x="1669" y="169"/>
                    </a:lnTo>
                    <a:lnTo>
                      <a:pt x="1684" y="267"/>
                    </a:lnTo>
                    <a:lnTo>
                      <a:pt x="1702" y="115"/>
                    </a:lnTo>
                    <a:lnTo>
                      <a:pt x="1717" y="181"/>
                    </a:lnTo>
                    <a:lnTo>
                      <a:pt x="1732" y="179"/>
                    </a:lnTo>
                    <a:lnTo>
                      <a:pt x="1748" y="173"/>
                    </a:lnTo>
                    <a:lnTo>
                      <a:pt x="1763" y="129"/>
                    </a:lnTo>
                    <a:lnTo>
                      <a:pt x="1779" y="148"/>
                    </a:lnTo>
                    <a:lnTo>
                      <a:pt x="1794" y="236"/>
                    </a:lnTo>
                    <a:lnTo>
                      <a:pt x="1809" y="200"/>
                    </a:lnTo>
                    <a:lnTo>
                      <a:pt x="1825" y="213"/>
                    </a:lnTo>
                    <a:lnTo>
                      <a:pt x="1840" y="238"/>
                    </a:lnTo>
                    <a:lnTo>
                      <a:pt x="1855" y="152"/>
                    </a:lnTo>
                    <a:lnTo>
                      <a:pt x="1871" y="281"/>
                    </a:lnTo>
                    <a:lnTo>
                      <a:pt x="1886" y="271"/>
                    </a:lnTo>
                    <a:lnTo>
                      <a:pt x="1901" y="283"/>
                    </a:lnTo>
                    <a:lnTo>
                      <a:pt x="1917" y="252"/>
                    </a:lnTo>
                    <a:lnTo>
                      <a:pt x="1932" y="286"/>
                    </a:lnTo>
                    <a:lnTo>
                      <a:pt x="1948" y="284"/>
                    </a:lnTo>
                    <a:lnTo>
                      <a:pt x="1963" y="256"/>
                    </a:lnTo>
                    <a:lnTo>
                      <a:pt x="1978" y="286"/>
                    </a:lnTo>
                    <a:lnTo>
                      <a:pt x="1994" y="229"/>
                    </a:lnTo>
                    <a:lnTo>
                      <a:pt x="2009" y="240"/>
                    </a:lnTo>
                    <a:lnTo>
                      <a:pt x="2026" y="246"/>
                    </a:lnTo>
                    <a:lnTo>
                      <a:pt x="2042" y="133"/>
                    </a:lnTo>
                    <a:lnTo>
                      <a:pt x="2057" y="265"/>
                    </a:lnTo>
                    <a:lnTo>
                      <a:pt x="2072" y="286"/>
                    </a:lnTo>
                    <a:lnTo>
                      <a:pt x="2088" y="286"/>
                    </a:lnTo>
                    <a:lnTo>
                      <a:pt x="2103" y="286"/>
                    </a:lnTo>
                    <a:lnTo>
                      <a:pt x="2118" y="286"/>
                    </a:lnTo>
                    <a:lnTo>
                      <a:pt x="2134" y="261"/>
                    </a:lnTo>
                    <a:lnTo>
                      <a:pt x="2149" y="286"/>
                    </a:lnTo>
                    <a:lnTo>
                      <a:pt x="2164" y="259"/>
                    </a:lnTo>
                    <a:lnTo>
                      <a:pt x="2180" y="263"/>
                    </a:lnTo>
                    <a:lnTo>
                      <a:pt x="2195" y="246"/>
                    </a:lnTo>
                    <a:lnTo>
                      <a:pt x="2211" y="286"/>
                    </a:lnTo>
                    <a:lnTo>
                      <a:pt x="2226" y="286"/>
                    </a:lnTo>
                    <a:lnTo>
                      <a:pt x="2241" y="283"/>
                    </a:lnTo>
                    <a:lnTo>
                      <a:pt x="2257" y="275"/>
                    </a:lnTo>
                    <a:lnTo>
                      <a:pt x="2272" y="286"/>
                    </a:lnTo>
                    <a:lnTo>
                      <a:pt x="2287" y="286"/>
                    </a:lnTo>
                    <a:lnTo>
                      <a:pt x="2303" y="286"/>
                    </a:lnTo>
                    <a:lnTo>
                      <a:pt x="2318" y="254"/>
                    </a:lnTo>
                    <a:lnTo>
                      <a:pt x="2333" y="252"/>
                    </a:lnTo>
                    <a:lnTo>
                      <a:pt x="2351" y="275"/>
                    </a:lnTo>
                    <a:lnTo>
                      <a:pt x="2366" y="225"/>
                    </a:lnTo>
                    <a:lnTo>
                      <a:pt x="2381" y="275"/>
                    </a:lnTo>
                    <a:lnTo>
                      <a:pt x="2397" y="175"/>
                    </a:lnTo>
                    <a:lnTo>
                      <a:pt x="2412" y="254"/>
                    </a:lnTo>
                    <a:lnTo>
                      <a:pt x="2428" y="242"/>
                    </a:lnTo>
                    <a:lnTo>
                      <a:pt x="2443" y="267"/>
                    </a:lnTo>
                    <a:lnTo>
                      <a:pt x="2458" y="198"/>
                    </a:lnTo>
                    <a:lnTo>
                      <a:pt x="2474" y="281"/>
                    </a:lnTo>
                    <a:lnTo>
                      <a:pt x="2489" y="209"/>
                    </a:lnTo>
                    <a:lnTo>
                      <a:pt x="2504" y="204"/>
                    </a:lnTo>
                    <a:lnTo>
                      <a:pt x="2520" y="242"/>
                    </a:lnTo>
                    <a:lnTo>
                      <a:pt x="2535" y="286"/>
                    </a:lnTo>
                    <a:lnTo>
                      <a:pt x="2550" y="281"/>
                    </a:lnTo>
                    <a:lnTo>
                      <a:pt x="2566" y="269"/>
                    </a:lnTo>
                    <a:lnTo>
                      <a:pt x="2581" y="221"/>
                    </a:lnTo>
                    <a:lnTo>
                      <a:pt x="2597" y="211"/>
                    </a:lnTo>
                    <a:lnTo>
                      <a:pt x="2612" y="244"/>
                    </a:lnTo>
                    <a:lnTo>
                      <a:pt x="2627" y="269"/>
                    </a:lnTo>
                    <a:lnTo>
                      <a:pt x="2643" y="240"/>
                    </a:lnTo>
                    <a:lnTo>
                      <a:pt x="2658" y="284"/>
                    </a:lnTo>
                    <a:lnTo>
                      <a:pt x="2675" y="284"/>
                    </a:lnTo>
                    <a:lnTo>
                      <a:pt x="2691" y="286"/>
                    </a:lnTo>
                    <a:lnTo>
                      <a:pt x="2706" y="177"/>
                    </a:lnTo>
                    <a:lnTo>
                      <a:pt x="2721" y="211"/>
                    </a:lnTo>
                    <a:lnTo>
                      <a:pt x="2737" y="286"/>
                    </a:lnTo>
                    <a:lnTo>
                      <a:pt x="2752" y="286"/>
                    </a:lnTo>
                    <a:lnTo>
                      <a:pt x="2767" y="286"/>
                    </a:lnTo>
                    <a:lnTo>
                      <a:pt x="2783" y="286"/>
                    </a:lnTo>
                    <a:lnTo>
                      <a:pt x="2798" y="286"/>
                    </a:lnTo>
                    <a:lnTo>
                      <a:pt x="2813" y="286"/>
                    </a:lnTo>
                    <a:lnTo>
                      <a:pt x="2829" y="259"/>
                    </a:lnTo>
                    <a:lnTo>
                      <a:pt x="2844" y="286"/>
                    </a:lnTo>
                    <a:lnTo>
                      <a:pt x="2860" y="286"/>
                    </a:lnTo>
                    <a:lnTo>
                      <a:pt x="2875" y="286"/>
                    </a:lnTo>
                    <a:lnTo>
                      <a:pt x="2890" y="286"/>
                    </a:lnTo>
                    <a:lnTo>
                      <a:pt x="2906" y="286"/>
                    </a:lnTo>
                    <a:lnTo>
                      <a:pt x="2921" y="286"/>
                    </a:lnTo>
                    <a:lnTo>
                      <a:pt x="2936" y="286"/>
                    </a:lnTo>
                    <a:lnTo>
                      <a:pt x="2952" y="286"/>
                    </a:lnTo>
                    <a:lnTo>
                      <a:pt x="2967" y="286"/>
                    </a:lnTo>
                    <a:lnTo>
                      <a:pt x="2982" y="286"/>
                    </a:lnTo>
                    <a:lnTo>
                      <a:pt x="3000" y="286"/>
                    </a:lnTo>
                    <a:lnTo>
                      <a:pt x="3015" y="286"/>
                    </a:lnTo>
                    <a:lnTo>
                      <a:pt x="3030" y="286"/>
                    </a:lnTo>
                    <a:lnTo>
                      <a:pt x="3046" y="286"/>
                    </a:lnTo>
                    <a:lnTo>
                      <a:pt x="3061" y="286"/>
                    </a:lnTo>
                    <a:lnTo>
                      <a:pt x="3077" y="286"/>
                    </a:lnTo>
                    <a:lnTo>
                      <a:pt x="3092" y="286"/>
                    </a:lnTo>
                    <a:lnTo>
                      <a:pt x="3107" y="286"/>
                    </a:lnTo>
                    <a:lnTo>
                      <a:pt x="3123" y="258"/>
                    </a:lnTo>
                    <a:lnTo>
                      <a:pt x="3138" y="286"/>
                    </a:lnTo>
                    <a:lnTo>
                      <a:pt x="3153" y="286"/>
                    </a:lnTo>
                    <a:lnTo>
                      <a:pt x="3169" y="252"/>
                    </a:lnTo>
                    <a:lnTo>
                      <a:pt x="3184" y="275"/>
                    </a:lnTo>
                    <a:lnTo>
                      <a:pt x="3199" y="267"/>
                    </a:lnTo>
                    <a:lnTo>
                      <a:pt x="3215" y="281"/>
                    </a:lnTo>
                    <a:lnTo>
                      <a:pt x="3230" y="261"/>
                    </a:lnTo>
                    <a:lnTo>
                      <a:pt x="3246" y="286"/>
                    </a:lnTo>
                    <a:lnTo>
                      <a:pt x="3261" y="279"/>
                    </a:lnTo>
                    <a:lnTo>
                      <a:pt x="3276" y="283"/>
                    </a:lnTo>
                    <a:lnTo>
                      <a:pt x="3292" y="267"/>
                    </a:lnTo>
                    <a:lnTo>
                      <a:pt x="3307" y="286"/>
                    </a:lnTo>
                    <a:lnTo>
                      <a:pt x="3324" y="286"/>
                    </a:lnTo>
                    <a:lnTo>
                      <a:pt x="3340" y="244"/>
                    </a:lnTo>
                    <a:lnTo>
                      <a:pt x="3355" y="179"/>
                    </a:lnTo>
                    <a:lnTo>
                      <a:pt x="3370" y="275"/>
                    </a:lnTo>
                    <a:lnTo>
                      <a:pt x="3386" y="217"/>
                    </a:lnTo>
                    <a:lnTo>
                      <a:pt x="3401" y="286"/>
                    </a:lnTo>
                    <a:lnTo>
                      <a:pt x="3416" y="286"/>
                    </a:lnTo>
                    <a:lnTo>
                      <a:pt x="3432" y="190"/>
                    </a:lnTo>
                    <a:lnTo>
                      <a:pt x="3447" y="286"/>
                    </a:lnTo>
                    <a:lnTo>
                      <a:pt x="3462" y="286"/>
                    </a:lnTo>
                    <a:lnTo>
                      <a:pt x="3478" y="165"/>
                    </a:lnTo>
                    <a:lnTo>
                      <a:pt x="3493" y="283"/>
                    </a:lnTo>
                    <a:lnTo>
                      <a:pt x="3509" y="281"/>
                    </a:lnTo>
                    <a:lnTo>
                      <a:pt x="3524" y="281"/>
                    </a:lnTo>
                    <a:lnTo>
                      <a:pt x="3539" y="286"/>
                    </a:lnTo>
                    <a:lnTo>
                      <a:pt x="3555" y="286"/>
                    </a:lnTo>
                    <a:lnTo>
                      <a:pt x="3570" y="286"/>
                    </a:lnTo>
                    <a:lnTo>
                      <a:pt x="3585" y="281"/>
                    </a:lnTo>
                    <a:lnTo>
                      <a:pt x="3601" y="256"/>
                    </a:lnTo>
                    <a:lnTo>
                      <a:pt x="3616" y="242"/>
                    </a:lnTo>
                    <a:lnTo>
                      <a:pt x="3631" y="286"/>
                    </a:lnTo>
                    <a:lnTo>
                      <a:pt x="3649" y="259"/>
                    </a:lnTo>
                    <a:lnTo>
                      <a:pt x="3664" y="286"/>
                    </a:lnTo>
                    <a:lnTo>
                      <a:pt x="3679" y="286"/>
                    </a:lnTo>
                    <a:lnTo>
                      <a:pt x="3695" y="286"/>
                    </a:lnTo>
                    <a:lnTo>
                      <a:pt x="3710" y="286"/>
                    </a:lnTo>
                    <a:lnTo>
                      <a:pt x="3726" y="271"/>
                    </a:lnTo>
                    <a:lnTo>
                      <a:pt x="3741" y="261"/>
                    </a:lnTo>
                    <a:lnTo>
                      <a:pt x="3756" y="265"/>
                    </a:lnTo>
                    <a:lnTo>
                      <a:pt x="3772" y="286"/>
                    </a:lnTo>
                    <a:lnTo>
                      <a:pt x="3787" y="204"/>
                    </a:lnTo>
                    <a:lnTo>
                      <a:pt x="3802" y="211"/>
                    </a:lnTo>
                    <a:lnTo>
                      <a:pt x="3818" y="204"/>
                    </a:lnTo>
                    <a:lnTo>
                      <a:pt x="3833" y="238"/>
                    </a:lnTo>
                    <a:lnTo>
                      <a:pt x="3848" y="165"/>
                    </a:lnTo>
                    <a:lnTo>
                      <a:pt x="3864" y="284"/>
                    </a:lnTo>
                    <a:lnTo>
                      <a:pt x="3879" y="281"/>
                    </a:lnTo>
                    <a:lnTo>
                      <a:pt x="3895" y="286"/>
                    </a:lnTo>
                    <a:lnTo>
                      <a:pt x="3910" y="286"/>
                    </a:lnTo>
                    <a:lnTo>
                      <a:pt x="3925" y="186"/>
                    </a:lnTo>
                    <a:lnTo>
                      <a:pt x="3941" y="281"/>
                    </a:lnTo>
                    <a:lnTo>
                      <a:pt x="3956" y="248"/>
                    </a:lnTo>
                    <a:lnTo>
                      <a:pt x="3973" y="286"/>
                    </a:lnTo>
                    <a:lnTo>
                      <a:pt x="3989" y="286"/>
                    </a:lnTo>
                    <a:lnTo>
                      <a:pt x="4004" y="286"/>
                    </a:lnTo>
                    <a:lnTo>
                      <a:pt x="4019" y="263"/>
                    </a:lnTo>
                    <a:lnTo>
                      <a:pt x="4035" y="286"/>
                    </a:lnTo>
                    <a:lnTo>
                      <a:pt x="4050" y="256"/>
                    </a:lnTo>
                    <a:lnTo>
                      <a:pt x="4065" y="246"/>
                    </a:lnTo>
                    <a:lnTo>
                      <a:pt x="4081" y="263"/>
                    </a:lnTo>
                    <a:lnTo>
                      <a:pt x="4096" y="244"/>
                    </a:lnTo>
                    <a:lnTo>
                      <a:pt x="4111" y="271"/>
                    </a:lnTo>
                    <a:lnTo>
                      <a:pt x="4127" y="196"/>
                    </a:lnTo>
                    <a:lnTo>
                      <a:pt x="4142" y="173"/>
                    </a:lnTo>
                    <a:lnTo>
                      <a:pt x="4158" y="246"/>
                    </a:lnTo>
                    <a:lnTo>
                      <a:pt x="4173" y="188"/>
                    </a:lnTo>
                    <a:lnTo>
                      <a:pt x="4188" y="240"/>
                    </a:lnTo>
                    <a:lnTo>
                      <a:pt x="4204" y="213"/>
                    </a:lnTo>
                    <a:lnTo>
                      <a:pt x="4219" y="209"/>
                    </a:lnTo>
                    <a:lnTo>
                      <a:pt x="4234" y="111"/>
                    </a:lnTo>
                    <a:lnTo>
                      <a:pt x="4250" y="242"/>
                    </a:lnTo>
                    <a:lnTo>
                      <a:pt x="4265" y="208"/>
                    </a:lnTo>
                    <a:lnTo>
                      <a:pt x="4280" y="135"/>
                    </a:lnTo>
                    <a:lnTo>
                      <a:pt x="4298" y="227"/>
                    </a:lnTo>
                    <a:lnTo>
                      <a:pt x="4313" y="229"/>
                    </a:lnTo>
                    <a:lnTo>
                      <a:pt x="4328" y="173"/>
                    </a:lnTo>
                    <a:lnTo>
                      <a:pt x="4344" y="188"/>
                    </a:lnTo>
                    <a:lnTo>
                      <a:pt x="4359" y="163"/>
                    </a:lnTo>
                    <a:lnTo>
                      <a:pt x="4375" y="136"/>
                    </a:lnTo>
                    <a:lnTo>
                      <a:pt x="4390" y="225"/>
                    </a:lnTo>
                    <a:lnTo>
                      <a:pt x="4405" y="188"/>
                    </a:lnTo>
                    <a:lnTo>
                      <a:pt x="4421" y="238"/>
                    </a:lnTo>
                    <a:lnTo>
                      <a:pt x="4436" y="279"/>
                    </a:lnTo>
                    <a:lnTo>
                      <a:pt x="4451" y="167"/>
                    </a:lnTo>
                    <a:lnTo>
                      <a:pt x="4467" y="169"/>
                    </a:lnTo>
                    <a:lnTo>
                      <a:pt x="4482" y="286"/>
                    </a:lnTo>
                    <a:lnTo>
                      <a:pt x="4497" y="217"/>
                    </a:lnTo>
                    <a:lnTo>
                      <a:pt x="4513" y="125"/>
                    </a:lnTo>
                    <a:lnTo>
                      <a:pt x="4528" y="233"/>
                    </a:lnTo>
                    <a:lnTo>
                      <a:pt x="4544" y="186"/>
                    </a:lnTo>
                    <a:lnTo>
                      <a:pt x="4559" y="117"/>
                    </a:lnTo>
                    <a:lnTo>
                      <a:pt x="4574" y="133"/>
                    </a:lnTo>
                    <a:lnTo>
                      <a:pt x="4590" y="94"/>
                    </a:lnTo>
                    <a:lnTo>
                      <a:pt x="4605" y="240"/>
                    </a:lnTo>
                    <a:lnTo>
                      <a:pt x="4622" y="111"/>
                    </a:lnTo>
                    <a:lnTo>
                      <a:pt x="4638" y="238"/>
                    </a:lnTo>
                    <a:lnTo>
                      <a:pt x="4653" y="62"/>
                    </a:lnTo>
                    <a:lnTo>
                      <a:pt x="4668" y="104"/>
                    </a:lnTo>
                    <a:lnTo>
                      <a:pt x="4684" y="79"/>
                    </a:lnTo>
                    <a:lnTo>
                      <a:pt x="4699" y="111"/>
                    </a:lnTo>
                    <a:lnTo>
                      <a:pt x="4714" y="40"/>
                    </a:lnTo>
                    <a:lnTo>
                      <a:pt x="4730" y="42"/>
                    </a:lnTo>
                    <a:lnTo>
                      <a:pt x="4745" y="98"/>
                    </a:lnTo>
                    <a:lnTo>
                      <a:pt x="4761" y="179"/>
                    </a:lnTo>
                    <a:lnTo>
                      <a:pt x="4776" y="87"/>
                    </a:lnTo>
                    <a:lnTo>
                      <a:pt x="4791" y="88"/>
                    </a:lnTo>
                    <a:lnTo>
                      <a:pt x="4807" y="133"/>
                    </a:lnTo>
                    <a:lnTo>
                      <a:pt x="4822" y="165"/>
                    </a:lnTo>
                    <a:lnTo>
                      <a:pt x="4837" y="192"/>
                    </a:lnTo>
                    <a:lnTo>
                      <a:pt x="4853" y="177"/>
                    </a:lnTo>
                    <a:lnTo>
                      <a:pt x="4868" y="19"/>
                    </a:lnTo>
                    <a:lnTo>
                      <a:pt x="4883" y="75"/>
                    </a:lnTo>
                    <a:lnTo>
                      <a:pt x="4899" y="154"/>
                    </a:lnTo>
                    <a:lnTo>
                      <a:pt x="4914" y="90"/>
                    </a:lnTo>
                    <a:lnTo>
                      <a:pt x="4929" y="54"/>
                    </a:lnTo>
                    <a:lnTo>
                      <a:pt x="4947" y="98"/>
                    </a:lnTo>
                    <a:lnTo>
                      <a:pt x="4962" y="87"/>
                    </a:lnTo>
                    <a:lnTo>
                      <a:pt x="4977" y="46"/>
                    </a:lnTo>
                    <a:lnTo>
                      <a:pt x="4993" y="102"/>
                    </a:lnTo>
                    <a:lnTo>
                      <a:pt x="5008" y="136"/>
                    </a:lnTo>
                    <a:lnTo>
                      <a:pt x="5024" y="104"/>
                    </a:lnTo>
                    <a:lnTo>
                      <a:pt x="5039" y="111"/>
                    </a:lnTo>
                    <a:lnTo>
                      <a:pt x="5054" y="44"/>
                    </a:lnTo>
                    <a:lnTo>
                      <a:pt x="5070" y="102"/>
                    </a:lnTo>
                    <a:lnTo>
                      <a:pt x="5085" y="90"/>
                    </a:lnTo>
                    <a:lnTo>
                      <a:pt x="5100" y="83"/>
                    </a:lnTo>
                    <a:lnTo>
                      <a:pt x="5116" y="102"/>
                    </a:lnTo>
                    <a:lnTo>
                      <a:pt x="5131" y="121"/>
                    </a:lnTo>
                    <a:lnTo>
                      <a:pt x="5146" y="77"/>
                    </a:lnTo>
                    <a:lnTo>
                      <a:pt x="5162" y="98"/>
                    </a:lnTo>
                    <a:lnTo>
                      <a:pt x="5177" y="63"/>
                    </a:lnTo>
                    <a:lnTo>
                      <a:pt x="5193" y="152"/>
                    </a:lnTo>
                    <a:lnTo>
                      <a:pt x="5208" y="77"/>
                    </a:lnTo>
                    <a:lnTo>
                      <a:pt x="5223" y="98"/>
                    </a:lnTo>
                    <a:lnTo>
                      <a:pt x="5239" y="150"/>
                    </a:lnTo>
                    <a:lnTo>
                      <a:pt x="5254" y="146"/>
                    </a:lnTo>
                    <a:lnTo>
                      <a:pt x="5271" y="71"/>
                    </a:lnTo>
                    <a:lnTo>
                      <a:pt x="5287" y="113"/>
                    </a:lnTo>
                    <a:lnTo>
                      <a:pt x="5302" y="144"/>
                    </a:lnTo>
                    <a:lnTo>
                      <a:pt x="5317" y="135"/>
                    </a:lnTo>
                    <a:lnTo>
                      <a:pt x="5333" y="142"/>
                    </a:lnTo>
                    <a:lnTo>
                      <a:pt x="5348" y="92"/>
                    </a:lnTo>
                    <a:lnTo>
                      <a:pt x="5363" y="27"/>
                    </a:lnTo>
                    <a:lnTo>
                      <a:pt x="5379" y="121"/>
                    </a:lnTo>
                    <a:lnTo>
                      <a:pt x="5394" y="192"/>
                    </a:lnTo>
                    <a:lnTo>
                      <a:pt x="5410" y="171"/>
                    </a:lnTo>
                    <a:lnTo>
                      <a:pt x="5410" y="286"/>
                    </a:lnTo>
                    <a:lnTo>
                      <a:pt x="5394" y="286"/>
                    </a:lnTo>
                    <a:lnTo>
                      <a:pt x="5379" y="286"/>
                    </a:lnTo>
                    <a:lnTo>
                      <a:pt x="5363" y="286"/>
                    </a:lnTo>
                    <a:lnTo>
                      <a:pt x="5348" y="286"/>
                    </a:lnTo>
                    <a:lnTo>
                      <a:pt x="5333" y="286"/>
                    </a:lnTo>
                    <a:lnTo>
                      <a:pt x="5317" y="286"/>
                    </a:lnTo>
                    <a:lnTo>
                      <a:pt x="5302" y="286"/>
                    </a:lnTo>
                    <a:lnTo>
                      <a:pt x="5287" y="286"/>
                    </a:lnTo>
                    <a:lnTo>
                      <a:pt x="5271" y="286"/>
                    </a:lnTo>
                    <a:lnTo>
                      <a:pt x="5254" y="286"/>
                    </a:lnTo>
                    <a:lnTo>
                      <a:pt x="5239" y="286"/>
                    </a:lnTo>
                    <a:lnTo>
                      <a:pt x="5223" y="286"/>
                    </a:lnTo>
                    <a:lnTo>
                      <a:pt x="5208" y="286"/>
                    </a:lnTo>
                    <a:lnTo>
                      <a:pt x="5193" y="286"/>
                    </a:lnTo>
                    <a:lnTo>
                      <a:pt x="5177" y="286"/>
                    </a:lnTo>
                    <a:lnTo>
                      <a:pt x="5162" y="286"/>
                    </a:lnTo>
                    <a:lnTo>
                      <a:pt x="5146" y="286"/>
                    </a:lnTo>
                    <a:lnTo>
                      <a:pt x="5131" y="286"/>
                    </a:lnTo>
                    <a:lnTo>
                      <a:pt x="5116" y="286"/>
                    </a:lnTo>
                    <a:lnTo>
                      <a:pt x="5100" y="286"/>
                    </a:lnTo>
                    <a:lnTo>
                      <a:pt x="5085" y="286"/>
                    </a:lnTo>
                    <a:lnTo>
                      <a:pt x="5070" y="286"/>
                    </a:lnTo>
                    <a:lnTo>
                      <a:pt x="5054" y="286"/>
                    </a:lnTo>
                    <a:lnTo>
                      <a:pt x="5039" y="286"/>
                    </a:lnTo>
                    <a:lnTo>
                      <a:pt x="5024" y="286"/>
                    </a:lnTo>
                    <a:lnTo>
                      <a:pt x="5008" y="286"/>
                    </a:lnTo>
                    <a:lnTo>
                      <a:pt x="4993" y="286"/>
                    </a:lnTo>
                    <a:lnTo>
                      <a:pt x="4977" y="286"/>
                    </a:lnTo>
                    <a:lnTo>
                      <a:pt x="4962" y="286"/>
                    </a:lnTo>
                    <a:lnTo>
                      <a:pt x="4947" y="286"/>
                    </a:lnTo>
                    <a:lnTo>
                      <a:pt x="4929" y="286"/>
                    </a:lnTo>
                    <a:lnTo>
                      <a:pt x="4914" y="286"/>
                    </a:lnTo>
                    <a:lnTo>
                      <a:pt x="4899" y="286"/>
                    </a:lnTo>
                    <a:lnTo>
                      <a:pt x="4883" y="286"/>
                    </a:lnTo>
                    <a:lnTo>
                      <a:pt x="4868" y="286"/>
                    </a:lnTo>
                    <a:lnTo>
                      <a:pt x="4853" y="286"/>
                    </a:lnTo>
                    <a:lnTo>
                      <a:pt x="4837" y="286"/>
                    </a:lnTo>
                    <a:lnTo>
                      <a:pt x="4822" y="286"/>
                    </a:lnTo>
                    <a:lnTo>
                      <a:pt x="4807" y="286"/>
                    </a:lnTo>
                    <a:lnTo>
                      <a:pt x="4791" y="286"/>
                    </a:lnTo>
                    <a:lnTo>
                      <a:pt x="4776" y="286"/>
                    </a:lnTo>
                    <a:lnTo>
                      <a:pt x="4761" y="286"/>
                    </a:lnTo>
                    <a:lnTo>
                      <a:pt x="4745" y="286"/>
                    </a:lnTo>
                    <a:lnTo>
                      <a:pt x="4730" y="286"/>
                    </a:lnTo>
                    <a:lnTo>
                      <a:pt x="4714" y="286"/>
                    </a:lnTo>
                    <a:lnTo>
                      <a:pt x="4699" y="286"/>
                    </a:lnTo>
                    <a:lnTo>
                      <a:pt x="4684" y="286"/>
                    </a:lnTo>
                    <a:lnTo>
                      <a:pt x="4668" y="286"/>
                    </a:lnTo>
                    <a:lnTo>
                      <a:pt x="4653" y="286"/>
                    </a:lnTo>
                    <a:lnTo>
                      <a:pt x="4638" y="286"/>
                    </a:lnTo>
                    <a:lnTo>
                      <a:pt x="4622" y="286"/>
                    </a:lnTo>
                    <a:lnTo>
                      <a:pt x="4605" y="286"/>
                    </a:lnTo>
                    <a:lnTo>
                      <a:pt x="4590" y="286"/>
                    </a:lnTo>
                    <a:lnTo>
                      <a:pt x="4574" y="286"/>
                    </a:lnTo>
                    <a:lnTo>
                      <a:pt x="4559" y="286"/>
                    </a:lnTo>
                    <a:lnTo>
                      <a:pt x="4544" y="286"/>
                    </a:lnTo>
                    <a:lnTo>
                      <a:pt x="4528" y="286"/>
                    </a:lnTo>
                    <a:lnTo>
                      <a:pt x="4513" y="286"/>
                    </a:lnTo>
                    <a:lnTo>
                      <a:pt x="4497" y="286"/>
                    </a:lnTo>
                    <a:lnTo>
                      <a:pt x="4482" y="286"/>
                    </a:lnTo>
                    <a:lnTo>
                      <a:pt x="4467" y="286"/>
                    </a:lnTo>
                    <a:lnTo>
                      <a:pt x="4451" y="286"/>
                    </a:lnTo>
                    <a:lnTo>
                      <a:pt x="4436" y="286"/>
                    </a:lnTo>
                    <a:lnTo>
                      <a:pt x="4421" y="286"/>
                    </a:lnTo>
                    <a:lnTo>
                      <a:pt x="4405" y="286"/>
                    </a:lnTo>
                    <a:lnTo>
                      <a:pt x="4390" y="286"/>
                    </a:lnTo>
                    <a:lnTo>
                      <a:pt x="4375" y="286"/>
                    </a:lnTo>
                    <a:lnTo>
                      <a:pt x="4359" y="286"/>
                    </a:lnTo>
                    <a:lnTo>
                      <a:pt x="4344" y="286"/>
                    </a:lnTo>
                    <a:lnTo>
                      <a:pt x="4328" y="286"/>
                    </a:lnTo>
                    <a:lnTo>
                      <a:pt x="4313" y="286"/>
                    </a:lnTo>
                    <a:lnTo>
                      <a:pt x="4298" y="286"/>
                    </a:lnTo>
                    <a:lnTo>
                      <a:pt x="4280" y="286"/>
                    </a:lnTo>
                    <a:lnTo>
                      <a:pt x="4265" y="286"/>
                    </a:lnTo>
                    <a:lnTo>
                      <a:pt x="4250" y="286"/>
                    </a:lnTo>
                    <a:lnTo>
                      <a:pt x="4234" y="286"/>
                    </a:lnTo>
                    <a:lnTo>
                      <a:pt x="4219" y="286"/>
                    </a:lnTo>
                    <a:lnTo>
                      <a:pt x="4204" y="286"/>
                    </a:lnTo>
                    <a:lnTo>
                      <a:pt x="4188" y="286"/>
                    </a:lnTo>
                    <a:lnTo>
                      <a:pt x="4173" y="286"/>
                    </a:lnTo>
                    <a:lnTo>
                      <a:pt x="4158" y="286"/>
                    </a:lnTo>
                    <a:lnTo>
                      <a:pt x="4142" y="286"/>
                    </a:lnTo>
                    <a:lnTo>
                      <a:pt x="4127" y="286"/>
                    </a:lnTo>
                    <a:lnTo>
                      <a:pt x="4111" y="286"/>
                    </a:lnTo>
                    <a:lnTo>
                      <a:pt x="4096" y="286"/>
                    </a:lnTo>
                    <a:lnTo>
                      <a:pt x="4081" y="286"/>
                    </a:lnTo>
                    <a:lnTo>
                      <a:pt x="4065" y="286"/>
                    </a:lnTo>
                    <a:lnTo>
                      <a:pt x="4050" y="286"/>
                    </a:lnTo>
                    <a:lnTo>
                      <a:pt x="4035" y="286"/>
                    </a:lnTo>
                    <a:lnTo>
                      <a:pt x="4019" y="286"/>
                    </a:lnTo>
                    <a:lnTo>
                      <a:pt x="4004" y="286"/>
                    </a:lnTo>
                    <a:lnTo>
                      <a:pt x="3989" y="286"/>
                    </a:lnTo>
                    <a:lnTo>
                      <a:pt x="3973" y="286"/>
                    </a:lnTo>
                    <a:lnTo>
                      <a:pt x="3956" y="286"/>
                    </a:lnTo>
                    <a:lnTo>
                      <a:pt x="3941" y="286"/>
                    </a:lnTo>
                    <a:lnTo>
                      <a:pt x="3925" y="286"/>
                    </a:lnTo>
                    <a:lnTo>
                      <a:pt x="3910" y="286"/>
                    </a:lnTo>
                    <a:lnTo>
                      <a:pt x="3895" y="286"/>
                    </a:lnTo>
                    <a:lnTo>
                      <a:pt x="3879" y="286"/>
                    </a:lnTo>
                    <a:lnTo>
                      <a:pt x="3864" y="286"/>
                    </a:lnTo>
                    <a:lnTo>
                      <a:pt x="3848" y="286"/>
                    </a:lnTo>
                    <a:lnTo>
                      <a:pt x="3833" y="286"/>
                    </a:lnTo>
                    <a:lnTo>
                      <a:pt x="3818" y="286"/>
                    </a:lnTo>
                    <a:lnTo>
                      <a:pt x="3802" y="286"/>
                    </a:lnTo>
                    <a:lnTo>
                      <a:pt x="3787" y="286"/>
                    </a:lnTo>
                    <a:lnTo>
                      <a:pt x="3772" y="286"/>
                    </a:lnTo>
                    <a:lnTo>
                      <a:pt x="3756" y="286"/>
                    </a:lnTo>
                    <a:lnTo>
                      <a:pt x="3741" y="286"/>
                    </a:lnTo>
                    <a:lnTo>
                      <a:pt x="3726" y="286"/>
                    </a:lnTo>
                    <a:lnTo>
                      <a:pt x="3710" y="286"/>
                    </a:lnTo>
                    <a:lnTo>
                      <a:pt x="3695" y="286"/>
                    </a:lnTo>
                    <a:lnTo>
                      <a:pt x="3679" y="286"/>
                    </a:lnTo>
                    <a:lnTo>
                      <a:pt x="3664" y="286"/>
                    </a:lnTo>
                    <a:lnTo>
                      <a:pt x="3649" y="286"/>
                    </a:lnTo>
                    <a:lnTo>
                      <a:pt x="3631" y="286"/>
                    </a:lnTo>
                    <a:lnTo>
                      <a:pt x="3616" y="286"/>
                    </a:lnTo>
                    <a:lnTo>
                      <a:pt x="3601" y="286"/>
                    </a:lnTo>
                    <a:lnTo>
                      <a:pt x="3585" y="286"/>
                    </a:lnTo>
                    <a:lnTo>
                      <a:pt x="3570" y="286"/>
                    </a:lnTo>
                    <a:lnTo>
                      <a:pt x="3555" y="286"/>
                    </a:lnTo>
                    <a:lnTo>
                      <a:pt x="3539" y="286"/>
                    </a:lnTo>
                    <a:lnTo>
                      <a:pt x="3524" y="286"/>
                    </a:lnTo>
                    <a:lnTo>
                      <a:pt x="3509" y="286"/>
                    </a:lnTo>
                    <a:lnTo>
                      <a:pt x="3493" y="286"/>
                    </a:lnTo>
                    <a:lnTo>
                      <a:pt x="3478" y="286"/>
                    </a:lnTo>
                    <a:lnTo>
                      <a:pt x="3462" y="286"/>
                    </a:lnTo>
                    <a:lnTo>
                      <a:pt x="3447" y="286"/>
                    </a:lnTo>
                    <a:lnTo>
                      <a:pt x="3432" y="286"/>
                    </a:lnTo>
                    <a:lnTo>
                      <a:pt x="3416" y="286"/>
                    </a:lnTo>
                    <a:lnTo>
                      <a:pt x="3401" y="286"/>
                    </a:lnTo>
                    <a:lnTo>
                      <a:pt x="3386" y="286"/>
                    </a:lnTo>
                    <a:lnTo>
                      <a:pt x="3370" y="286"/>
                    </a:lnTo>
                    <a:lnTo>
                      <a:pt x="3355" y="286"/>
                    </a:lnTo>
                    <a:lnTo>
                      <a:pt x="3340" y="286"/>
                    </a:lnTo>
                    <a:lnTo>
                      <a:pt x="3324" y="286"/>
                    </a:lnTo>
                    <a:lnTo>
                      <a:pt x="3307" y="286"/>
                    </a:lnTo>
                    <a:lnTo>
                      <a:pt x="3292" y="286"/>
                    </a:lnTo>
                    <a:lnTo>
                      <a:pt x="3276" y="286"/>
                    </a:lnTo>
                    <a:lnTo>
                      <a:pt x="3261" y="286"/>
                    </a:lnTo>
                    <a:lnTo>
                      <a:pt x="3246" y="286"/>
                    </a:lnTo>
                    <a:lnTo>
                      <a:pt x="3230" y="286"/>
                    </a:lnTo>
                    <a:lnTo>
                      <a:pt x="3215" y="286"/>
                    </a:lnTo>
                    <a:lnTo>
                      <a:pt x="3199" y="286"/>
                    </a:lnTo>
                    <a:lnTo>
                      <a:pt x="3184" y="286"/>
                    </a:lnTo>
                    <a:lnTo>
                      <a:pt x="3169" y="286"/>
                    </a:lnTo>
                    <a:lnTo>
                      <a:pt x="3153" y="286"/>
                    </a:lnTo>
                    <a:lnTo>
                      <a:pt x="3138" y="286"/>
                    </a:lnTo>
                    <a:lnTo>
                      <a:pt x="3123" y="286"/>
                    </a:lnTo>
                    <a:lnTo>
                      <a:pt x="3107" y="286"/>
                    </a:lnTo>
                    <a:lnTo>
                      <a:pt x="3092" y="286"/>
                    </a:lnTo>
                    <a:lnTo>
                      <a:pt x="3077" y="286"/>
                    </a:lnTo>
                    <a:lnTo>
                      <a:pt x="3061" y="286"/>
                    </a:lnTo>
                    <a:lnTo>
                      <a:pt x="3046" y="286"/>
                    </a:lnTo>
                    <a:lnTo>
                      <a:pt x="3030" y="286"/>
                    </a:lnTo>
                    <a:lnTo>
                      <a:pt x="3015" y="286"/>
                    </a:lnTo>
                    <a:lnTo>
                      <a:pt x="3000" y="286"/>
                    </a:lnTo>
                    <a:lnTo>
                      <a:pt x="2982" y="286"/>
                    </a:lnTo>
                    <a:lnTo>
                      <a:pt x="2967" y="286"/>
                    </a:lnTo>
                    <a:lnTo>
                      <a:pt x="2952" y="286"/>
                    </a:lnTo>
                    <a:lnTo>
                      <a:pt x="2936" y="286"/>
                    </a:lnTo>
                    <a:lnTo>
                      <a:pt x="2921" y="286"/>
                    </a:lnTo>
                    <a:lnTo>
                      <a:pt x="2906" y="286"/>
                    </a:lnTo>
                    <a:lnTo>
                      <a:pt x="2890" y="286"/>
                    </a:lnTo>
                    <a:lnTo>
                      <a:pt x="2875" y="286"/>
                    </a:lnTo>
                    <a:lnTo>
                      <a:pt x="2860" y="286"/>
                    </a:lnTo>
                    <a:lnTo>
                      <a:pt x="2844" y="286"/>
                    </a:lnTo>
                    <a:lnTo>
                      <a:pt x="2829" y="286"/>
                    </a:lnTo>
                    <a:lnTo>
                      <a:pt x="2813" y="286"/>
                    </a:lnTo>
                    <a:lnTo>
                      <a:pt x="2798" y="286"/>
                    </a:lnTo>
                    <a:lnTo>
                      <a:pt x="2783" y="286"/>
                    </a:lnTo>
                    <a:lnTo>
                      <a:pt x="2767" y="286"/>
                    </a:lnTo>
                    <a:lnTo>
                      <a:pt x="2752" y="286"/>
                    </a:lnTo>
                    <a:lnTo>
                      <a:pt x="2737" y="286"/>
                    </a:lnTo>
                    <a:lnTo>
                      <a:pt x="2721" y="286"/>
                    </a:lnTo>
                    <a:lnTo>
                      <a:pt x="2706" y="286"/>
                    </a:lnTo>
                    <a:lnTo>
                      <a:pt x="2691" y="286"/>
                    </a:lnTo>
                    <a:lnTo>
                      <a:pt x="2675" y="286"/>
                    </a:lnTo>
                    <a:lnTo>
                      <a:pt x="2658" y="286"/>
                    </a:lnTo>
                    <a:lnTo>
                      <a:pt x="2643" y="286"/>
                    </a:lnTo>
                    <a:lnTo>
                      <a:pt x="2627" y="286"/>
                    </a:lnTo>
                    <a:lnTo>
                      <a:pt x="2612" y="286"/>
                    </a:lnTo>
                    <a:lnTo>
                      <a:pt x="2597" y="286"/>
                    </a:lnTo>
                    <a:lnTo>
                      <a:pt x="2581" y="286"/>
                    </a:lnTo>
                    <a:lnTo>
                      <a:pt x="2566" y="286"/>
                    </a:lnTo>
                    <a:lnTo>
                      <a:pt x="2550" y="286"/>
                    </a:lnTo>
                    <a:lnTo>
                      <a:pt x="2535" y="286"/>
                    </a:lnTo>
                    <a:lnTo>
                      <a:pt x="2520" y="286"/>
                    </a:lnTo>
                    <a:lnTo>
                      <a:pt x="2504" y="286"/>
                    </a:lnTo>
                    <a:lnTo>
                      <a:pt x="2489" y="286"/>
                    </a:lnTo>
                    <a:lnTo>
                      <a:pt x="2474" y="286"/>
                    </a:lnTo>
                    <a:lnTo>
                      <a:pt x="2458" y="286"/>
                    </a:lnTo>
                    <a:lnTo>
                      <a:pt x="2443" y="286"/>
                    </a:lnTo>
                    <a:lnTo>
                      <a:pt x="2428" y="286"/>
                    </a:lnTo>
                    <a:lnTo>
                      <a:pt x="2412" y="286"/>
                    </a:lnTo>
                    <a:lnTo>
                      <a:pt x="2397" y="286"/>
                    </a:lnTo>
                    <a:lnTo>
                      <a:pt x="2381" y="286"/>
                    </a:lnTo>
                    <a:lnTo>
                      <a:pt x="2366" y="286"/>
                    </a:lnTo>
                    <a:lnTo>
                      <a:pt x="2351" y="286"/>
                    </a:lnTo>
                    <a:lnTo>
                      <a:pt x="2333" y="286"/>
                    </a:lnTo>
                    <a:lnTo>
                      <a:pt x="2318" y="286"/>
                    </a:lnTo>
                    <a:lnTo>
                      <a:pt x="2303" y="286"/>
                    </a:lnTo>
                    <a:lnTo>
                      <a:pt x="2287" y="286"/>
                    </a:lnTo>
                    <a:lnTo>
                      <a:pt x="2272" y="286"/>
                    </a:lnTo>
                    <a:lnTo>
                      <a:pt x="2257" y="286"/>
                    </a:lnTo>
                    <a:lnTo>
                      <a:pt x="2241" y="286"/>
                    </a:lnTo>
                    <a:lnTo>
                      <a:pt x="2226" y="286"/>
                    </a:lnTo>
                    <a:lnTo>
                      <a:pt x="2211" y="286"/>
                    </a:lnTo>
                    <a:lnTo>
                      <a:pt x="2195" y="286"/>
                    </a:lnTo>
                    <a:lnTo>
                      <a:pt x="2180" y="286"/>
                    </a:lnTo>
                    <a:lnTo>
                      <a:pt x="2164" y="286"/>
                    </a:lnTo>
                    <a:lnTo>
                      <a:pt x="2149" y="286"/>
                    </a:lnTo>
                    <a:lnTo>
                      <a:pt x="2134" y="286"/>
                    </a:lnTo>
                    <a:lnTo>
                      <a:pt x="2118" y="286"/>
                    </a:lnTo>
                    <a:lnTo>
                      <a:pt x="2103" y="286"/>
                    </a:lnTo>
                    <a:lnTo>
                      <a:pt x="2088" y="286"/>
                    </a:lnTo>
                    <a:lnTo>
                      <a:pt x="2072" y="286"/>
                    </a:lnTo>
                    <a:lnTo>
                      <a:pt x="2057" y="286"/>
                    </a:lnTo>
                    <a:lnTo>
                      <a:pt x="2042" y="286"/>
                    </a:lnTo>
                    <a:lnTo>
                      <a:pt x="2026" y="286"/>
                    </a:lnTo>
                    <a:lnTo>
                      <a:pt x="2009" y="286"/>
                    </a:lnTo>
                    <a:lnTo>
                      <a:pt x="1994" y="286"/>
                    </a:lnTo>
                    <a:lnTo>
                      <a:pt x="1978" y="286"/>
                    </a:lnTo>
                    <a:lnTo>
                      <a:pt x="1963" y="286"/>
                    </a:lnTo>
                    <a:lnTo>
                      <a:pt x="1948" y="286"/>
                    </a:lnTo>
                    <a:lnTo>
                      <a:pt x="1932" y="286"/>
                    </a:lnTo>
                    <a:lnTo>
                      <a:pt x="1917" y="286"/>
                    </a:lnTo>
                    <a:lnTo>
                      <a:pt x="1901" y="286"/>
                    </a:lnTo>
                    <a:lnTo>
                      <a:pt x="1886" y="286"/>
                    </a:lnTo>
                    <a:lnTo>
                      <a:pt x="1871" y="286"/>
                    </a:lnTo>
                    <a:lnTo>
                      <a:pt x="1855" y="286"/>
                    </a:lnTo>
                    <a:lnTo>
                      <a:pt x="1840" y="286"/>
                    </a:lnTo>
                    <a:lnTo>
                      <a:pt x="1825" y="286"/>
                    </a:lnTo>
                    <a:lnTo>
                      <a:pt x="1809" y="286"/>
                    </a:lnTo>
                    <a:lnTo>
                      <a:pt x="1794" y="286"/>
                    </a:lnTo>
                    <a:lnTo>
                      <a:pt x="1779" y="286"/>
                    </a:lnTo>
                    <a:lnTo>
                      <a:pt x="1763" y="286"/>
                    </a:lnTo>
                    <a:lnTo>
                      <a:pt x="1748" y="286"/>
                    </a:lnTo>
                    <a:lnTo>
                      <a:pt x="1732" y="286"/>
                    </a:lnTo>
                    <a:lnTo>
                      <a:pt x="1717" y="286"/>
                    </a:lnTo>
                    <a:lnTo>
                      <a:pt x="1702" y="286"/>
                    </a:lnTo>
                    <a:lnTo>
                      <a:pt x="1684" y="286"/>
                    </a:lnTo>
                    <a:lnTo>
                      <a:pt x="1669" y="286"/>
                    </a:lnTo>
                    <a:lnTo>
                      <a:pt x="1654" y="286"/>
                    </a:lnTo>
                    <a:lnTo>
                      <a:pt x="1638" y="286"/>
                    </a:lnTo>
                    <a:lnTo>
                      <a:pt x="1623" y="286"/>
                    </a:lnTo>
                    <a:lnTo>
                      <a:pt x="1608" y="286"/>
                    </a:lnTo>
                    <a:lnTo>
                      <a:pt x="1592" y="286"/>
                    </a:lnTo>
                    <a:lnTo>
                      <a:pt x="1577" y="286"/>
                    </a:lnTo>
                    <a:lnTo>
                      <a:pt x="1562" y="286"/>
                    </a:lnTo>
                    <a:lnTo>
                      <a:pt x="1546" y="286"/>
                    </a:lnTo>
                    <a:lnTo>
                      <a:pt x="1531" y="286"/>
                    </a:lnTo>
                    <a:lnTo>
                      <a:pt x="1515" y="286"/>
                    </a:lnTo>
                    <a:lnTo>
                      <a:pt x="1500" y="286"/>
                    </a:lnTo>
                    <a:lnTo>
                      <a:pt x="1485" y="286"/>
                    </a:lnTo>
                    <a:lnTo>
                      <a:pt x="1469" y="286"/>
                    </a:lnTo>
                    <a:lnTo>
                      <a:pt x="1454" y="286"/>
                    </a:lnTo>
                    <a:lnTo>
                      <a:pt x="1439" y="286"/>
                    </a:lnTo>
                    <a:lnTo>
                      <a:pt x="1423" y="286"/>
                    </a:lnTo>
                    <a:lnTo>
                      <a:pt x="1408" y="286"/>
                    </a:lnTo>
                    <a:lnTo>
                      <a:pt x="1393" y="286"/>
                    </a:lnTo>
                    <a:lnTo>
                      <a:pt x="1377" y="286"/>
                    </a:lnTo>
                    <a:lnTo>
                      <a:pt x="1360" y="286"/>
                    </a:lnTo>
                    <a:lnTo>
                      <a:pt x="1345" y="286"/>
                    </a:lnTo>
                    <a:lnTo>
                      <a:pt x="1329" y="286"/>
                    </a:lnTo>
                    <a:lnTo>
                      <a:pt x="1314" y="286"/>
                    </a:lnTo>
                    <a:lnTo>
                      <a:pt x="1299" y="286"/>
                    </a:lnTo>
                    <a:lnTo>
                      <a:pt x="1283" y="286"/>
                    </a:lnTo>
                    <a:lnTo>
                      <a:pt x="1268" y="286"/>
                    </a:lnTo>
                    <a:lnTo>
                      <a:pt x="1252" y="286"/>
                    </a:lnTo>
                    <a:lnTo>
                      <a:pt x="1237" y="286"/>
                    </a:lnTo>
                    <a:lnTo>
                      <a:pt x="1222" y="286"/>
                    </a:lnTo>
                    <a:lnTo>
                      <a:pt x="1206" y="286"/>
                    </a:lnTo>
                    <a:lnTo>
                      <a:pt x="1191" y="286"/>
                    </a:lnTo>
                    <a:lnTo>
                      <a:pt x="1176" y="286"/>
                    </a:lnTo>
                    <a:lnTo>
                      <a:pt x="1160" y="286"/>
                    </a:lnTo>
                    <a:lnTo>
                      <a:pt x="1145" y="286"/>
                    </a:lnTo>
                    <a:lnTo>
                      <a:pt x="1130" y="286"/>
                    </a:lnTo>
                    <a:lnTo>
                      <a:pt x="1114" y="286"/>
                    </a:lnTo>
                    <a:lnTo>
                      <a:pt x="1099" y="286"/>
                    </a:lnTo>
                    <a:lnTo>
                      <a:pt x="1083" y="286"/>
                    </a:lnTo>
                    <a:lnTo>
                      <a:pt x="1068" y="286"/>
                    </a:lnTo>
                    <a:lnTo>
                      <a:pt x="1053" y="286"/>
                    </a:lnTo>
                    <a:lnTo>
                      <a:pt x="1035" y="286"/>
                    </a:lnTo>
                    <a:lnTo>
                      <a:pt x="1020" y="286"/>
                    </a:lnTo>
                    <a:lnTo>
                      <a:pt x="1005" y="286"/>
                    </a:lnTo>
                    <a:lnTo>
                      <a:pt x="989" y="286"/>
                    </a:lnTo>
                    <a:lnTo>
                      <a:pt x="974" y="286"/>
                    </a:lnTo>
                    <a:lnTo>
                      <a:pt x="959" y="286"/>
                    </a:lnTo>
                    <a:lnTo>
                      <a:pt x="943" y="286"/>
                    </a:lnTo>
                    <a:lnTo>
                      <a:pt x="928" y="286"/>
                    </a:lnTo>
                    <a:lnTo>
                      <a:pt x="913" y="286"/>
                    </a:lnTo>
                    <a:lnTo>
                      <a:pt x="897" y="286"/>
                    </a:lnTo>
                    <a:lnTo>
                      <a:pt x="882" y="286"/>
                    </a:lnTo>
                    <a:lnTo>
                      <a:pt x="866" y="286"/>
                    </a:lnTo>
                    <a:lnTo>
                      <a:pt x="851" y="286"/>
                    </a:lnTo>
                    <a:lnTo>
                      <a:pt x="836" y="286"/>
                    </a:lnTo>
                    <a:lnTo>
                      <a:pt x="820" y="286"/>
                    </a:lnTo>
                    <a:lnTo>
                      <a:pt x="805" y="286"/>
                    </a:lnTo>
                    <a:lnTo>
                      <a:pt x="790" y="286"/>
                    </a:lnTo>
                    <a:lnTo>
                      <a:pt x="774" y="286"/>
                    </a:lnTo>
                    <a:lnTo>
                      <a:pt x="759" y="286"/>
                    </a:lnTo>
                    <a:lnTo>
                      <a:pt x="744" y="286"/>
                    </a:lnTo>
                    <a:lnTo>
                      <a:pt x="728" y="286"/>
                    </a:lnTo>
                    <a:lnTo>
                      <a:pt x="711" y="286"/>
                    </a:lnTo>
                    <a:lnTo>
                      <a:pt x="696" y="286"/>
                    </a:lnTo>
                    <a:lnTo>
                      <a:pt x="680" y="286"/>
                    </a:lnTo>
                    <a:lnTo>
                      <a:pt x="665" y="286"/>
                    </a:lnTo>
                    <a:lnTo>
                      <a:pt x="649" y="286"/>
                    </a:lnTo>
                    <a:lnTo>
                      <a:pt x="634" y="286"/>
                    </a:lnTo>
                    <a:lnTo>
                      <a:pt x="619" y="286"/>
                    </a:lnTo>
                    <a:lnTo>
                      <a:pt x="603" y="286"/>
                    </a:lnTo>
                    <a:lnTo>
                      <a:pt x="588" y="286"/>
                    </a:lnTo>
                    <a:lnTo>
                      <a:pt x="573" y="286"/>
                    </a:lnTo>
                    <a:lnTo>
                      <a:pt x="557" y="286"/>
                    </a:lnTo>
                    <a:lnTo>
                      <a:pt x="542" y="286"/>
                    </a:lnTo>
                    <a:lnTo>
                      <a:pt x="527" y="286"/>
                    </a:lnTo>
                    <a:lnTo>
                      <a:pt x="511" y="286"/>
                    </a:lnTo>
                    <a:lnTo>
                      <a:pt x="496" y="286"/>
                    </a:lnTo>
                    <a:lnTo>
                      <a:pt x="481" y="286"/>
                    </a:lnTo>
                    <a:lnTo>
                      <a:pt x="465" y="286"/>
                    </a:lnTo>
                    <a:lnTo>
                      <a:pt x="450" y="286"/>
                    </a:lnTo>
                    <a:lnTo>
                      <a:pt x="434" y="286"/>
                    </a:lnTo>
                    <a:lnTo>
                      <a:pt x="419" y="286"/>
                    </a:lnTo>
                    <a:lnTo>
                      <a:pt x="404" y="286"/>
                    </a:lnTo>
                    <a:lnTo>
                      <a:pt x="386" y="286"/>
                    </a:lnTo>
                    <a:lnTo>
                      <a:pt x="371" y="286"/>
                    </a:lnTo>
                    <a:lnTo>
                      <a:pt x="356" y="286"/>
                    </a:lnTo>
                    <a:lnTo>
                      <a:pt x="340" y="286"/>
                    </a:lnTo>
                    <a:lnTo>
                      <a:pt x="325" y="286"/>
                    </a:lnTo>
                    <a:lnTo>
                      <a:pt x="310" y="286"/>
                    </a:lnTo>
                    <a:lnTo>
                      <a:pt x="294" y="286"/>
                    </a:lnTo>
                    <a:lnTo>
                      <a:pt x="279" y="286"/>
                    </a:lnTo>
                    <a:lnTo>
                      <a:pt x="264" y="286"/>
                    </a:lnTo>
                    <a:lnTo>
                      <a:pt x="248" y="286"/>
                    </a:lnTo>
                    <a:lnTo>
                      <a:pt x="233" y="286"/>
                    </a:lnTo>
                    <a:lnTo>
                      <a:pt x="217" y="286"/>
                    </a:lnTo>
                    <a:lnTo>
                      <a:pt x="202" y="286"/>
                    </a:lnTo>
                    <a:lnTo>
                      <a:pt x="187" y="286"/>
                    </a:lnTo>
                    <a:lnTo>
                      <a:pt x="171" y="286"/>
                    </a:lnTo>
                    <a:lnTo>
                      <a:pt x="156" y="286"/>
                    </a:lnTo>
                    <a:lnTo>
                      <a:pt x="141" y="286"/>
                    </a:lnTo>
                    <a:lnTo>
                      <a:pt x="125" y="286"/>
                    </a:lnTo>
                    <a:lnTo>
                      <a:pt x="110" y="286"/>
                    </a:lnTo>
                    <a:lnTo>
                      <a:pt x="95" y="286"/>
                    </a:lnTo>
                    <a:lnTo>
                      <a:pt x="79" y="286"/>
                    </a:lnTo>
                    <a:lnTo>
                      <a:pt x="62" y="286"/>
                    </a:lnTo>
                    <a:lnTo>
                      <a:pt x="47" y="286"/>
                    </a:lnTo>
                    <a:lnTo>
                      <a:pt x="31" y="286"/>
                    </a:lnTo>
                    <a:lnTo>
                      <a:pt x="16" y="286"/>
                    </a:lnTo>
                    <a:lnTo>
                      <a:pt x="0" y="286"/>
                    </a:lnTo>
                    <a:lnTo>
                      <a:pt x="0" y="236"/>
                    </a:lnTo>
                    <a:close/>
                  </a:path>
                </a:pathLst>
              </a:custGeom>
              <a:solidFill>
                <a:srgbClr val="9BBB5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4" name="Freeform 53"/>
              <p:cNvSpPr>
                <a:spLocks/>
              </p:cNvSpPr>
              <p:nvPr/>
            </p:nvSpPr>
            <p:spPr bwMode="auto">
              <a:xfrm rot="5400000" flipV="1">
                <a:off x="878520" y="3476682"/>
                <a:ext cx="5001190" cy="187655"/>
              </a:xfrm>
              <a:custGeom>
                <a:avLst/>
                <a:gdLst>
                  <a:gd name="T0" fmla="*/ 169 w 5410"/>
                  <a:gd name="T1" fmla="*/ 90 h 280"/>
                  <a:gd name="T2" fmla="*/ 350 w 5410"/>
                  <a:gd name="T3" fmla="*/ 163 h 280"/>
                  <a:gd name="T4" fmla="*/ 532 w 5410"/>
                  <a:gd name="T5" fmla="*/ 102 h 280"/>
                  <a:gd name="T6" fmla="*/ 713 w 5410"/>
                  <a:gd name="T7" fmla="*/ 73 h 280"/>
                  <a:gd name="T8" fmla="*/ 893 w 5410"/>
                  <a:gd name="T9" fmla="*/ 150 h 280"/>
                  <a:gd name="T10" fmla="*/ 1076 w 5410"/>
                  <a:gd name="T11" fmla="*/ 159 h 280"/>
                  <a:gd name="T12" fmla="*/ 1256 w 5410"/>
                  <a:gd name="T13" fmla="*/ 94 h 280"/>
                  <a:gd name="T14" fmla="*/ 1437 w 5410"/>
                  <a:gd name="T15" fmla="*/ 265 h 280"/>
                  <a:gd name="T16" fmla="*/ 1619 w 5410"/>
                  <a:gd name="T17" fmla="*/ 255 h 280"/>
                  <a:gd name="T18" fmla="*/ 1800 w 5410"/>
                  <a:gd name="T19" fmla="*/ 280 h 280"/>
                  <a:gd name="T20" fmla="*/ 1980 w 5410"/>
                  <a:gd name="T21" fmla="*/ 255 h 280"/>
                  <a:gd name="T22" fmla="*/ 2163 w 5410"/>
                  <a:gd name="T23" fmla="*/ 263 h 280"/>
                  <a:gd name="T24" fmla="*/ 2343 w 5410"/>
                  <a:gd name="T25" fmla="*/ 275 h 280"/>
                  <a:gd name="T26" fmla="*/ 2524 w 5410"/>
                  <a:gd name="T27" fmla="*/ 250 h 280"/>
                  <a:gd name="T28" fmla="*/ 2706 w 5410"/>
                  <a:gd name="T29" fmla="*/ 275 h 280"/>
                  <a:gd name="T30" fmla="*/ 2886 w 5410"/>
                  <a:gd name="T31" fmla="*/ 240 h 280"/>
                  <a:gd name="T32" fmla="*/ 3067 w 5410"/>
                  <a:gd name="T33" fmla="*/ 242 h 280"/>
                  <a:gd name="T34" fmla="*/ 3249 w 5410"/>
                  <a:gd name="T35" fmla="*/ 234 h 280"/>
                  <a:gd name="T36" fmla="*/ 3430 w 5410"/>
                  <a:gd name="T37" fmla="*/ 257 h 280"/>
                  <a:gd name="T38" fmla="*/ 3610 w 5410"/>
                  <a:gd name="T39" fmla="*/ 129 h 280"/>
                  <a:gd name="T40" fmla="*/ 3793 w 5410"/>
                  <a:gd name="T41" fmla="*/ 278 h 280"/>
                  <a:gd name="T42" fmla="*/ 3973 w 5410"/>
                  <a:gd name="T43" fmla="*/ 265 h 280"/>
                  <a:gd name="T44" fmla="*/ 4154 w 5410"/>
                  <a:gd name="T45" fmla="*/ 198 h 280"/>
                  <a:gd name="T46" fmla="*/ 4336 w 5410"/>
                  <a:gd name="T47" fmla="*/ 167 h 280"/>
                  <a:gd name="T48" fmla="*/ 4517 w 5410"/>
                  <a:gd name="T49" fmla="*/ 277 h 280"/>
                  <a:gd name="T50" fmla="*/ 4697 w 5410"/>
                  <a:gd name="T51" fmla="*/ 127 h 280"/>
                  <a:gd name="T52" fmla="*/ 4880 w 5410"/>
                  <a:gd name="T53" fmla="*/ 23 h 280"/>
                  <a:gd name="T54" fmla="*/ 5060 w 5410"/>
                  <a:gd name="T55" fmla="*/ 136 h 280"/>
                  <a:gd name="T56" fmla="*/ 5241 w 5410"/>
                  <a:gd name="T57" fmla="*/ 25 h 280"/>
                  <a:gd name="T58" fmla="*/ 5410 w 5410"/>
                  <a:gd name="T59" fmla="*/ 280 h 280"/>
                  <a:gd name="T60" fmla="*/ 5229 w 5410"/>
                  <a:gd name="T61" fmla="*/ 280 h 280"/>
                  <a:gd name="T62" fmla="*/ 5047 w 5410"/>
                  <a:gd name="T63" fmla="*/ 280 h 280"/>
                  <a:gd name="T64" fmla="*/ 4866 w 5410"/>
                  <a:gd name="T65" fmla="*/ 280 h 280"/>
                  <a:gd name="T66" fmla="*/ 4686 w 5410"/>
                  <a:gd name="T67" fmla="*/ 280 h 280"/>
                  <a:gd name="T68" fmla="*/ 4503 w 5410"/>
                  <a:gd name="T69" fmla="*/ 280 h 280"/>
                  <a:gd name="T70" fmla="*/ 4323 w 5410"/>
                  <a:gd name="T71" fmla="*/ 280 h 280"/>
                  <a:gd name="T72" fmla="*/ 4142 w 5410"/>
                  <a:gd name="T73" fmla="*/ 280 h 280"/>
                  <a:gd name="T74" fmla="*/ 3960 w 5410"/>
                  <a:gd name="T75" fmla="*/ 280 h 280"/>
                  <a:gd name="T76" fmla="*/ 3779 w 5410"/>
                  <a:gd name="T77" fmla="*/ 280 h 280"/>
                  <a:gd name="T78" fmla="*/ 3599 w 5410"/>
                  <a:gd name="T79" fmla="*/ 280 h 280"/>
                  <a:gd name="T80" fmla="*/ 3416 w 5410"/>
                  <a:gd name="T81" fmla="*/ 280 h 280"/>
                  <a:gd name="T82" fmla="*/ 3236 w 5410"/>
                  <a:gd name="T83" fmla="*/ 280 h 280"/>
                  <a:gd name="T84" fmla="*/ 3055 w 5410"/>
                  <a:gd name="T85" fmla="*/ 280 h 280"/>
                  <a:gd name="T86" fmla="*/ 2873 w 5410"/>
                  <a:gd name="T87" fmla="*/ 280 h 280"/>
                  <a:gd name="T88" fmla="*/ 2693 w 5410"/>
                  <a:gd name="T89" fmla="*/ 280 h 280"/>
                  <a:gd name="T90" fmla="*/ 2512 w 5410"/>
                  <a:gd name="T91" fmla="*/ 280 h 280"/>
                  <a:gd name="T92" fmla="*/ 2330 w 5410"/>
                  <a:gd name="T93" fmla="*/ 280 h 280"/>
                  <a:gd name="T94" fmla="*/ 2149 w 5410"/>
                  <a:gd name="T95" fmla="*/ 280 h 280"/>
                  <a:gd name="T96" fmla="*/ 1969 w 5410"/>
                  <a:gd name="T97" fmla="*/ 280 h 280"/>
                  <a:gd name="T98" fmla="*/ 1786 w 5410"/>
                  <a:gd name="T99" fmla="*/ 280 h 280"/>
                  <a:gd name="T100" fmla="*/ 1606 w 5410"/>
                  <a:gd name="T101" fmla="*/ 280 h 280"/>
                  <a:gd name="T102" fmla="*/ 1425 w 5410"/>
                  <a:gd name="T103" fmla="*/ 280 h 280"/>
                  <a:gd name="T104" fmla="*/ 1243 w 5410"/>
                  <a:gd name="T105" fmla="*/ 280 h 280"/>
                  <a:gd name="T106" fmla="*/ 1062 w 5410"/>
                  <a:gd name="T107" fmla="*/ 280 h 280"/>
                  <a:gd name="T108" fmla="*/ 882 w 5410"/>
                  <a:gd name="T109" fmla="*/ 280 h 280"/>
                  <a:gd name="T110" fmla="*/ 699 w 5410"/>
                  <a:gd name="T111" fmla="*/ 280 h 280"/>
                  <a:gd name="T112" fmla="*/ 519 w 5410"/>
                  <a:gd name="T113" fmla="*/ 280 h 280"/>
                  <a:gd name="T114" fmla="*/ 337 w 5410"/>
                  <a:gd name="T115" fmla="*/ 280 h 280"/>
                  <a:gd name="T116" fmla="*/ 156 w 5410"/>
                  <a:gd name="T117" fmla="*/ 280 h 2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</a:cxnLst>
                <a:rect l="0" t="0" r="r" b="b"/>
                <a:pathLst>
                  <a:path w="5410" h="280">
                    <a:moveTo>
                      <a:pt x="0" y="142"/>
                    </a:moveTo>
                    <a:lnTo>
                      <a:pt x="14" y="148"/>
                    </a:lnTo>
                    <a:lnTo>
                      <a:pt x="27" y="69"/>
                    </a:lnTo>
                    <a:lnTo>
                      <a:pt x="41" y="0"/>
                    </a:lnTo>
                    <a:lnTo>
                      <a:pt x="52" y="36"/>
                    </a:lnTo>
                    <a:lnTo>
                      <a:pt x="66" y="92"/>
                    </a:lnTo>
                    <a:lnTo>
                      <a:pt x="79" y="113"/>
                    </a:lnTo>
                    <a:lnTo>
                      <a:pt x="91" y="59"/>
                    </a:lnTo>
                    <a:lnTo>
                      <a:pt x="104" y="42"/>
                    </a:lnTo>
                    <a:lnTo>
                      <a:pt x="118" y="48"/>
                    </a:lnTo>
                    <a:lnTo>
                      <a:pt x="131" y="54"/>
                    </a:lnTo>
                    <a:lnTo>
                      <a:pt x="143" y="113"/>
                    </a:lnTo>
                    <a:lnTo>
                      <a:pt x="156" y="129"/>
                    </a:lnTo>
                    <a:lnTo>
                      <a:pt x="169" y="90"/>
                    </a:lnTo>
                    <a:lnTo>
                      <a:pt x="183" y="113"/>
                    </a:lnTo>
                    <a:lnTo>
                      <a:pt x="194" y="98"/>
                    </a:lnTo>
                    <a:lnTo>
                      <a:pt x="208" y="161"/>
                    </a:lnTo>
                    <a:lnTo>
                      <a:pt x="221" y="82"/>
                    </a:lnTo>
                    <a:lnTo>
                      <a:pt x="235" y="111"/>
                    </a:lnTo>
                    <a:lnTo>
                      <a:pt x="246" y="25"/>
                    </a:lnTo>
                    <a:lnTo>
                      <a:pt x="260" y="67"/>
                    </a:lnTo>
                    <a:lnTo>
                      <a:pt x="273" y="13"/>
                    </a:lnTo>
                    <a:lnTo>
                      <a:pt x="287" y="154"/>
                    </a:lnTo>
                    <a:lnTo>
                      <a:pt x="298" y="227"/>
                    </a:lnTo>
                    <a:lnTo>
                      <a:pt x="312" y="67"/>
                    </a:lnTo>
                    <a:lnTo>
                      <a:pt x="325" y="127"/>
                    </a:lnTo>
                    <a:lnTo>
                      <a:pt x="337" y="52"/>
                    </a:lnTo>
                    <a:lnTo>
                      <a:pt x="350" y="163"/>
                    </a:lnTo>
                    <a:lnTo>
                      <a:pt x="363" y="107"/>
                    </a:lnTo>
                    <a:lnTo>
                      <a:pt x="377" y="125"/>
                    </a:lnTo>
                    <a:lnTo>
                      <a:pt x="388" y="121"/>
                    </a:lnTo>
                    <a:lnTo>
                      <a:pt x="402" y="154"/>
                    </a:lnTo>
                    <a:lnTo>
                      <a:pt x="415" y="129"/>
                    </a:lnTo>
                    <a:lnTo>
                      <a:pt x="429" y="152"/>
                    </a:lnTo>
                    <a:lnTo>
                      <a:pt x="440" y="102"/>
                    </a:lnTo>
                    <a:lnTo>
                      <a:pt x="454" y="79"/>
                    </a:lnTo>
                    <a:lnTo>
                      <a:pt x="467" y="7"/>
                    </a:lnTo>
                    <a:lnTo>
                      <a:pt x="481" y="94"/>
                    </a:lnTo>
                    <a:lnTo>
                      <a:pt x="492" y="163"/>
                    </a:lnTo>
                    <a:lnTo>
                      <a:pt x="505" y="117"/>
                    </a:lnTo>
                    <a:lnTo>
                      <a:pt x="519" y="203"/>
                    </a:lnTo>
                    <a:lnTo>
                      <a:pt x="532" y="102"/>
                    </a:lnTo>
                    <a:lnTo>
                      <a:pt x="544" y="119"/>
                    </a:lnTo>
                    <a:lnTo>
                      <a:pt x="557" y="104"/>
                    </a:lnTo>
                    <a:lnTo>
                      <a:pt x="571" y="69"/>
                    </a:lnTo>
                    <a:lnTo>
                      <a:pt x="584" y="77"/>
                    </a:lnTo>
                    <a:lnTo>
                      <a:pt x="596" y="146"/>
                    </a:lnTo>
                    <a:lnTo>
                      <a:pt x="609" y="142"/>
                    </a:lnTo>
                    <a:lnTo>
                      <a:pt x="623" y="117"/>
                    </a:lnTo>
                    <a:lnTo>
                      <a:pt x="634" y="84"/>
                    </a:lnTo>
                    <a:lnTo>
                      <a:pt x="648" y="107"/>
                    </a:lnTo>
                    <a:lnTo>
                      <a:pt x="661" y="111"/>
                    </a:lnTo>
                    <a:lnTo>
                      <a:pt x="674" y="154"/>
                    </a:lnTo>
                    <a:lnTo>
                      <a:pt x="686" y="152"/>
                    </a:lnTo>
                    <a:lnTo>
                      <a:pt x="699" y="71"/>
                    </a:lnTo>
                    <a:lnTo>
                      <a:pt x="713" y="73"/>
                    </a:lnTo>
                    <a:lnTo>
                      <a:pt x="726" y="86"/>
                    </a:lnTo>
                    <a:lnTo>
                      <a:pt x="738" y="150"/>
                    </a:lnTo>
                    <a:lnTo>
                      <a:pt x="751" y="138"/>
                    </a:lnTo>
                    <a:lnTo>
                      <a:pt x="765" y="167"/>
                    </a:lnTo>
                    <a:lnTo>
                      <a:pt x="778" y="121"/>
                    </a:lnTo>
                    <a:lnTo>
                      <a:pt x="790" y="102"/>
                    </a:lnTo>
                    <a:lnTo>
                      <a:pt x="803" y="111"/>
                    </a:lnTo>
                    <a:lnTo>
                      <a:pt x="817" y="180"/>
                    </a:lnTo>
                    <a:lnTo>
                      <a:pt x="830" y="109"/>
                    </a:lnTo>
                    <a:lnTo>
                      <a:pt x="842" y="65"/>
                    </a:lnTo>
                    <a:lnTo>
                      <a:pt x="855" y="132"/>
                    </a:lnTo>
                    <a:lnTo>
                      <a:pt x="868" y="32"/>
                    </a:lnTo>
                    <a:lnTo>
                      <a:pt x="882" y="109"/>
                    </a:lnTo>
                    <a:lnTo>
                      <a:pt x="893" y="150"/>
                    </a:lnTo>
                    <a:lnTo>
                      <a:pt x="907" y="117"/>
                    </a:lnTo>
                    <a:lnTo>
                      <a:pt x="920" y="105"/>
                    </a:lnTo>
                    <a:lnTo>
                      <a:pt x="932" y="94"/>
                    </a:lnTo>
                    <a:lnTo>
                      <a:pt x="945" y="132"/>
                    </a:lnTo>
                    <a:lnTo>
                      <a:pt x="959" y="79"/>
                    </a:lnTo>
                    <a:lnTo>
                      <a:pt x="972" y="123"/>
                    </a:lnTo>
                    <a:lnTo>
                      <a:pt x="984" y="250"/>
                    </a:lnTo>
                    <a:lnTo>
                      <a:pt x="997" y="102"/>
                    </a:lnTo>
                    <a:lnTo>
                      <a:pt x="1010" y="79"/>
                    </a:lnTo>
                    <a:lnTo>
                      <a:pt x="1024" y="96"/>
                    </a:lnTo>
                    <a:lnTo>
                      <a:pt x="1035" y="180"/>
                    </a:lnTo>
                    <a:lnTo>
                      <a:pt x="1049" y="123"/>
                    </a:lnTo>
                    <a:lnTo>
                      <a:pt x="1062" y="182"/>
                    </a:lnTo>
                    <a:lnTo>
                      <a:pt x="1076" y="159"/>
                    </a:lnTo>
                    <a:lnTo>
                      <a:pt x="1087" y="230"/>
                    </a:lnTo>
                    <a:lnTo>
                      <a:pt x="1101" y="123"/>
                    </a:lnTo>
                    <a:lnTo>
                      <a:pt x="1114" y="152"/>
                    </a:lnTo>
                    <a:lnTo>
                      <a:pt x="1128" y="86"/>
                    </a:lnTo>
                    <a:lnTo>
                      <a:pt x="1139" y="88"/>
                    </a:lnTo>
                    <a:lnTo>
                      <a:pt x="1153" y="40"/>
                    </a:lnTo>
                    <a:lnTo>
                      <a:pt x="1166" y="117"/>
                    </a:lnTo>
                    <a:lnTo>
                      <a:pt x="1178" y="109"/>
                    </a:lnTo>
                    <a:lnTo>
                      <a:pt x="1191" y="194"/>
                    </a:lnTo>
                    <a:lnTo>
                      <a:pt x="1204" y="179"/>
                    </a:lnTo>
                    <a:lnTo>
                      <a:pt x="1218" y="71"/>
                    </a:lnTo>
                    <a:lnTo>
                      <a:pt x="1229" y="179"/>
                    </a:lnTo>
                    <a:lnTo>
                      <a:pt x="1243" y="209"/>
                    </a:lnTo>
                    <a:lnTo>
                      <a:pt x="1256" y="94"/>
                    </a:lnTo>
                    <a:lnTo>
                      <a:pt x="1270" y="146"/>
                    </a:lnTo>
                    <a:lnTo>
                      <a:pt x="1281" y="57"/>
                    </a:lnTo>
                    <a:lnTo>
                      <a:pt x="1295" y="25"/>
                    </a:lnTo>
                    <a:lnTo>
                      <a:pt x="1308" y="150"/>
                    </a:lnTo>
                    <a:lnTo>
                      <a:pt x="1322" y="38"/>
                    </a:lnTo>
                    <a:lnTo>
                      <a:pt x="1333" y="127"/>
                    </a:lnTo>
                    <a:lnTo>
                      <a:pt x="1347" y="180"/>
                    </a:lnTo>
                    <a:lnTo>
                      <a:pt x="1360" y="36"/>
                    </a:lnTo>
                    <a:lnTo>
                      <a:pt x="1373" y="67"/>
                    </a:lnTo>
                    <a:lnTo>
                      <a:pt x="1385" y="94"/>
                    </a:lnTo>
                    <a:lnTo>
                      <a:pt x="1398" y="169"/>
                    </a:lnTo>
                    <a:lnTo>
                      <a:pt x="1412" y="138"/>
                    </a:lnTo>
                    <a:lnTo>
                      <a:pt x="1425" y="163"/>
                    </a:lnTo>
                    <a:lnTo>
                      <a:pt x="1437" y="265"/>
                    </a:lnTo>
                    <a:lnTo>
                      <a:pt x="1450" y="148"/>
                    </a:lnTo>
                    <a:lnTo>
                      <a:pt x="1464" y="171"/>
                    </a:lnTo>
                    <a:lnTo>
                      <a:pt x="1475" y="213"/>
                    </a:lnTo>
                    <a:lnTo>
                      <a:pt x="1489" y="227"/>
                    </a:lnTo>
                    <a:lnTo>
                      <a:pt x="1502" y="259"/>
                    </a:lnTo>
                    <a:lnTo>
                      <a:pt x="1515" y="236"/>
                    </a:lnTo>
                    <a:lnTo>
                      <a:pt x="1527" y="257"/>
                    </a:lnTo>
                    <a:lnTo>
                      <a:pt x="1540" y="234"/>
                    </a:lnTo>
                    <a:lnTo>
                      <a:pt x="1554" y="273"/>
                    </a:lnTo>
                    <a:lnTo>
                      <a:pt x="1567" y="205"/>
                    </a:lnTo>
                    <a:lnTo>
                      <a:pt x="1579" y="202"/>
                    </a:lnTo>
                    <a:lnTo>
                      <a:pt x="1592" y="280"/>
                    </a:lnTo>
                    <a:lnTo>
                      <a:pt x="1606" y="267"/>
                    </a:lnTo>
                    <a:lnTo>
                      <a:pt x="1619" y="255"/>
                    </a:lnTo>
                    <a:lnTo>
                      <a:pt x="1631" y="267"/>
                    </a:lnTo>
                    <a:lnTo>
                      <a:pt x="1644" y="280"/>
                    </a:lnTo>
                    <a:lnTo>
                      <a:pt x="1658" y="242"/>
                    </a:lnTo>
                    <a:lnTo>
                      <a:pt x="1671" y="280"/>
                    </a:lnTo>
                    <a:lnTo>
                      <a:pt x="1683" y="269"/>
                    </a:lnTo>
                    <a:lnTo>
                      <a:pt x="1696" y="278"/>
                    </a:lnTo>
                    <a:lnTo>
                      <a:pt x="1709" y="280"/>
                    </a:lnTo>
                    <a:lnTo>
                      <a:pt x="1721" y="280"/>
                    </a:lnTo>
                    <a:lnTo>
                      <a:pt x="1734" y="280"/>
                    </a:lnTo>
                    <a:lnTo>
                      <a:pt x="1748" y="280"/>
                    </a:lnTo>
                    <a:lnTo>
                      <a:pt x="1761" y="280"/>
                    </a:lnTo>
                    <a:lnTo>
                      <a:pt x="1773" y="280"/>
                    </a:lnTo>
                    <a:lnTo>
                      <a:pt x="1786" y="280"/>
                    </a:lnTo>
                    <a:lnTo>
                      <a:pt x="1800" y="280"/>
                    </a:lnTo>
                    <a:lnTo>
                      <a:pt x="1813" y="280"/>
                    </a:lnTo>
                    <a:lnTo>
                      <a:pt x="1825" y="280"/>
                    </a:lnTo>
                    <a:lnTo>
                      <a:pt x="1838" y="280"/>
                    </a:lnTo>
                    <a:lnTo>
                      <a:pt x="1852" y="280"/>
                    </a:lnTo>
                    <a:lnTo>
                      <a:pt x="1865" y="280"/>
                    </a:lnTo>
                    <a:lnTo>
                      <a:pt x="1876" y="280"/>
                    </a:lnTo>
                    <a:lnTo>
                      <a:pt x="1890" y="263"/>
                    </a:lnTo>
                    <a:lnTo>
                      <a:pt x="1903" y="257"/>
                    </a:lnTo>
                    <a:lnTo>
                      <a:pt x="1917" y="248"/>
                    </a:lnTo>
                    <a:lnTo>
                      <a:pt x="1928" y="232"/>
                    </a:lnTo>
                    <a:lnTo>
                      <a:pt x="1942" y="261"/>
                    </a:lnTo>
                    <a:lnTo>
                      <a:pt x="1955" y="255"/>
                    </a:lnTo>
                    <a:lnTo>
                      <a:pt x="1969" y="257"/>
                    </a:lnTo>
                    <a:lnTo>
                      <a:pt x="1980" y="255"/>
                    </a:lnTo>
                    <a:lnTo>
                      <a:pt x="1994" y="280"/>
                    </a:lnTo>
                    <a:lnTo>
                      <a:pt x="2007" y="257"/>
                    </a:lnTo>
                    <a:lnTo>
                      <a:pt x="2019" y="219"/>
                    </a:lnTo>
                    <a:lnTo>
                      <a:pt x="2032" y="280"/>
                    </a:lnTo>
                    <a:lnTo>
                      <a:pt x="2045" y="248"/>
                    </a:lnTo>
                    <a:lnTo>
                      <a:pt x="2059" y="280"/>
                    </a:lnTo>
                    <a:lnTo>
                      <a:pt x="2070" y="277"/>
                    </a:lnTo>
                    <a:lnTo>
                      <a:pt x="2084" y="267"/>
                    </a:lnTo>
                    <a:lnTo>
                      <a:pt x="2097" y="273"/>
                    </a:lnTo>
                    <a:lnTo>
                      <a:pt x="2111" y="280"/>
                    </a:lnTo>
                    <a:lnTo>
                      <a:pt x="2122" y="255"/>
                    </a:lnTo>
                    <a:lnTo>
                      <a:pt x="2136" y="242"/>
                    </a:lnTo>
                    <a:lnTo>
                      <a:pt x="2149" y="275"/>
                    </a:lnTo>
                    <a:lnTo>
                      <a:pt x="2163" y="263"/>
                    </a:lnTo>
                    <a:lnTo>
                      <a:pt x="2174" y="248"/>
                    </a:lnTo>
                    <a:lnTo>
                      <a:pt x="2188" y="273"/>
                    </a:lnTo>
                    <a:lnTo>
                      <a:pt x="2201" y="280"/>
                    </a:lnTo>
                    <a:lnTo>
                      <a:pt x="2214" y="280"/>
                    </a:lnTo>
                    <a:lnTo>
                      <a:pt x="2226" y="275"/>
                    </a:lnTo>
                    <a:lnTo>
                      <a:pt x="2239" y="267"/>
                    </a:lnTo>
                    <a:lnTo>
                      <a:pt x="2253" y="278"/>
                    </a:lnTo>
                    <a:lnTo>
                      <a:pt x="2266" y="180"/>
                    </a:lnTo>
                    <a:lnTo>
                      <a:pt x="2278" y="280"/>
                    </a:lnTo>
                    <a:lnTo>
                      <a:pt x="2291" y="280"/>
                    </a:lnTo>
                    <a:lnTo>
                      <a:pt x="2305" y="213"/>
                    </a:lnTo>
                    <a:lnTo>
                      <a:pt x="2316" y="261"/>
                    </a:lnTo>
                    <a:lnTo>
                      <a:pt x="2330" y="277"/>
                    </a:lnTo>
                    <a:lnTo>
                      <a:pt x="2343" y="275"/>
                    </a:lnTo>
                    <a:lnTo>
                      <a:pt x="2356" y="227"/>
                    </a:lnTo>
                    <a:lnTo>
                      <a:pt x="2368" y="280"/>
                    </a:lnTo>
                    <a:lnTo>
                      <a:pt x="2381" y="280"/>
                    </a:lnTo>
                    <a:lnTo>
                      <a:pt x="2395" y="280"/>
                    </a:lnTo>
                    <a:lnTo>
                      <a:pt x="2408" y="280"/>
                    </a:lnTo>
                    <a:lnTo>
                      <a:pt x="2420" y="273"/>
                    </a:lnTo>
                    <a:lnTo>
                      <a:pt x="2433" y="280"/>
                    </a:lnTo>
                    <a:lnTo>
                      <a:pt x="2447" y="280"/>
                    </a:lnTo>
                    <a:lnTo>
                      <a:pt x="2460" y="238"/>
                    </a:lnTo>
                    <a:lnTo>
                      <a:pt x="2472" y="163"/>
                    </a:lnTo>
                    <a:lnTo>
                      <a:pt x="2485" y="157"/>
                    </a:lnTo>
                    <a:lnTo>
                      <a:pt x="2499" y="129"/>
                    </a:lnTo>
                    <a:lnTo>
                      <a:pt x="2512" y="246"/>
                    </a:lnTo>
                    <a:lnTo>
                      <a:pt x="2524" y="250"/>
                    </a:lnTo>
                    <a:lnTo>
                      <a:pt x="2537" y="213"/>
                    </a:lnTo>
                    <a:lnTo>
                      <a:pt x="2550" y="263"/>
                    </a:lnTo>
                    <a:lnTo>
                      <a:pt x="2562" y="238"/>
                    </a:lnTo>
                    <a:lnTo>
                      <a:pt x="2575" y="277"/>
                    </a:lnTo>
                    <a:lnTo>
                      <a:pt x="2589" y="217"/>
                    </a:lnTo>
                    <a:lnTo>
                      <a:pt x="2602" y="253"/>
                    </a:lnTo>
                    <a:lnTo>
                      <a:pt x="2614" y="253"/>
                    </a:lnTo>
                    <a:lnTo>
                      <a:pt x="2627" y="242"/>
                    </a:lnTo>
                    <a:lnTo>
                      <a:pt x="2641" y="215"/>
                    </a:lnTo>
                    <a:lnTo>
                      <a:pt x="2654" y="253"/>
                    </a:lnTo>
                    <a:lnTo>
                      <a:pt x="2666" y="280"/>
                    </a:lnTo>
                    <a:lnTo>
                      <a:pt x="2679" y="280"/>
                    </a:lnTo>
                    <a:lnTo>
                      <a:pt x="2693" y="263"/>
                    </a:lnTo>
                    <a:lnTo>
                      <a:pt x="2706" y="275"/>
                    </a:lnTo>
                    <a:lnTo>
                      <a:pt x="2717" y="234"/>
                    </a:lnTo>
                    <a:lnTo>
                      <a:pt x="2731" y="202"/>
                    </a:lnTo>
                    <a:lnTo>
                      <a:pt x="2744" y="273"/>
                    </a:lnTo>
                    <a:lnTo>
                      <a:pt x="2758" y="269"/>
                    </a:lnTo>
                    <a:lnTo>
                      <a:pt x="2769" y="280"/>
                    </a:lnTo>
                    <a:lnTo>
                      <a:pt x="2783" y="273"/>
                    </a:lnTo>
                    <a:lnTo>
                      <a:pt x="2796" y="273"/>
                    </a:lnTo>
                    <a:lnTo>
                      <a:pt x="2810" y="211"/>
                    </a:lnTo>
                    <a:lnTo>
                      <a:pt x="2821" y="184"/>
                    </a:lnTo>
                    <a:lnTo>
                      <a:pt x="2835" y="252"/>
                    </a:lnTo>
                    <a:lnTo>
                      <a:pt x="2848" y="261"/>
                    </a:lnTo>
                    <a:lnTo>
                      <a:pt x="2860" y="182"/>
                    </a:lnTo>
                    <a:lnTo>
                      <a:pt x="2873" y="271"/>
                    </a:lnTo>
                    <a:lnTo>
                      <a:pt x="2886" y="240"/>
                    </a:lnTo>
                    <a:lnTo>
                      <a:pt x="2900" y="242"/>
                    </a:lnTo>
                    <a:lnTo>
                      <a:pt x="2911" y="277"/>
                    </a:lnTo>
                    <a:lnTo>
                      <a:pt x="2925" y="278"/>
                    </a:lnTo>
                    <a:lnTo>
                      <a:pt x="2938" y="248"/>
                    </a:lnTo>
                    <a:lnTo>
                      <a:pt x="2952" y="242"/>
                    </a:lnTo>
                    <a:lnTo>
                      <a:pt x="2963" y="275"/>
                    </a:lnTo>
                    <a:lnTo>
                      <a:pt x="2977" y="265"/>
                    </a:lnTo>
                    <a:lnTo>
                      <a:pt x="2990" y="265"/>
                    </a:lnTo>
                    <a:lnTo>
                      <a:pt x="3004" y="217"/>
                    </a:lnTo>
                    <a:lnTo>
                      <a:pt x="3015" y="273"/>
                    </a:lnTo>
                    <a:lnTo>
                      <a:pt x="3029" y="275"/>
                    </a:lnTo>
                    <a:lnTo>
                      <a:pt x="3042" y="280"/>
                    </a:lnTo>
                    <a:lnTo>
                      <a:pt x="3055" y="280"/>
                    </a:lnTo>
                    <a:lnTo>
                      <a:pt x="3067" y="242"/>
                    </a:lnTo>
                    <a:lnTo>
                      <a:pt x="3080" y="180"/>
                    </a:lnTo>
                    <a:lnTo>
                      <a:pt x="3094" y="154"/>
                    </a:lnTo>
                    <a:lnTo>
                      <a:pt x="3107" y="219"/>
                    </a:lnTo>
                    <a:lnTo>
                      <a:pt x="3119" y="257"/>
                    </a:lnTo>
                    <a:lnTo>
                      <a:pt x="3132" y="269"/>
                    </a:lnTo>
                    <a:lnTo>
                      <a:pt x="3146" y="259"/>
                    </a:lnTo>
                    <a:lnTo>
                      <a:pt x="3157" y="280"/>
                    </a:lnTo>
                    <a:lnTo>
                      <a:pt x="3171" y="257"/>
                    </a:lnTo>
                    <a:lnTo>
                      <a:pt x="3184" y="238"/>
                    </a:lnTo>
                    <a:lnTo>
                      <a:pt x="3198" y="280"/>
                    </a:lnTo>
                    <a:lnTo>
                      <a:pt x="3209" y="280"/>
                    </a:lnTo>
                    <a:lnTo>
                      <a:pt x="3222" y="271"/>
                    </a:lnTo>
                    <a:lnTo>
                      <a:pt x="3236" y="280"/>
                    </a:lnTo>
                    <a:lnTo>
                      <a:pt x="3249" y="234"/>
                    </a:lnTo>
                    <a:lnTo>
                      <a:pt x="3261" y="273"/>
                    </a:lnTo>
                    <a:lnTo>
                      <a:pt x="3274" y="263"/>
                    </a:lnTo>
                    <a:lnTo>
                      <a:pt x="3288" y="273"/>
                    </a:lnTo>
                    <a:lnTo>
                      <a:pt x="3301" y="217"/>
                    </a:lnTo>
                    <a:lnTo>
                      <a:pt x="3313" y="263"/>
                    </a:lnTo>
                    <a:lnTo>
                      <a:pt x="3326" y="265"/>
                    </a:lnTo>
                    <a:lnTo>
                      <a:pt x="3340" y="273"/>
                    </a:lnTo>
                    <a:lnTo>
                      <a:pt x="3353" y="246"/>
                    </a:lnTo>
                    <a:lnTo>
                      <a:pt x="3365" y="275"/>
                    </a:lnTo>
                    <a:lnTo>
                      <a:pt x="3378" y="265"/>
                    </a:lnTo>
                    <a:lnTo>
                      <a:pt x="3391" y="244"/>
                    </a:lnTo>
                    <a:lnTo>
                      <a:pt x="3403" y="278"/>
                    </a:lnTo>
                    <a:lnTo>
                      <a:pt x="3416" y="280"/>
                    </a:lnTo>
                    <a:lnTo>
                      <a:pt x="3430" y="257"/>
                    </a:lnTo>
                    <a:lnTo>
                      <a:pt x="3443" y="280"/>
                    </a:lnTo>
                    <a:lnTo>
                      <a:pt x="3455" y="280"/>
                    </a:lnTo>
                    <a:lnTo>
                      <a:pt x="3468" y="271"/>
                    </a:lnTo>
                    <a:lnTo>
                      <a:pt x="3482" y="280"/>
                    </a:lnTo>
                    <a:lnTo>
                      <a:pt x="3495" y="280"/>
                    </a:lnTo>
                    <a:lnTo>
                      <a:pt x="3507" y="271"/>
                    </a:lnTo>
                    <a:lnTo>
                      <a:pt x="3520" y="271"/>
                    </a:lnTo>
                    <a:lnTo>
                      <a:pt x="3534" y="253"/>
                    </a:lnTo>
                    <a:lnTo>
                      <a:pt x="3547" y="261"/>
                    </a:lnTo>
                    <a:lnTo>
                      <a:pt x="3558" y="280"/>
                    </a:lnTo>
                    <a:lnTo>
                      <a:pt x="3572" y="267"/>
                    </a:lnTo>
                    <a:lnTo>
                      <a:pt x="3585" y="232"/>
                    </a:lnTo>
                    <a:lnTo>
                      <a:pt x="3599" y="107"/>
                    </a:lnTo>
                    <a:lnTo>
                      <a:pt x="3610" y="129"/>
                    </a:lnTo>
                    <a:lnTo>
                      <a:pt x="3624" y="261"/>
                    </a:lnTo>
                    <a:lnTo>
                      <a:pt x="3637" y="198"/>
                    </a:lnTo>
                    <a:lnTo>
                      <a:pt x="3651" y="225"/>
                    </a:lnTo>
                    <a:lnTo>
                      <a:pt x="3662" y="265"/>
                    </a:lnTo>
                    <a:lnTo>
                      <a:pt x="3676" y="280"/>
                    </a:lnTo>
                    <a:lnTo>
                      <a:pt x="3689" y="280"/>
                    </a:lnTo>
                    <a:lnTo>
                      <a:pt x="3701" y="280"/>
                    </a:lnTo>
                    <a:lnTo>
                      <a:pt x="3714" y="277"/>
                    </a:lnTo>
                    <a:lnTo>
                      <a:pt x="3727" y="280"/>
                    </a:lnTo>
                    <a:lnTo>
                      <a:pt x="3741" y="280"/>
                    </a:lnTo>
                    <a:lnTo>
                      <a:pt x="3752" y="280"/>
                    </a:lnTo>
                    <a:lnTo>
                      <a:pt x="3766" y="250"/>
                    </a:lnTo>
                    <a:lnTo>
                      <a:pt x="3779" y="244"/>
                    </a:lnTo>
                    <a:lnTo>
                      <a:pt x="3793" y="278"/>
                    </a:lnTo>
                    <a:lnTo>
                      <a:pt x="3804" y="273"/>
                    </a:lnTo>
                    <a:lnTo>
                      <a:pt x="3818" y="280"/>
                    </a:lnTo>
                    <a:lnTo>
                      <a:pt x="3831" y="280"/>
                    </a:lnTo>
                    <a:lnTo>
                      <a:pt x="3845" y="263"/>
                    </a:lnTo>
                    <a:lnTo>
                      <a:pt x="3856" y="278"/>
                    </a:lnTo>
                    <a:lnTo>
                      <a:pt x="3870" y="269"/>
                    </a:lnTo>
                    <a:lnTo>
                      <a:pt x="3883" y="280"/>
                    </a:lnTo>
                    <a:lnTo>
                      <a:pt x="3896" y="278"/>
                    </a:lnTo>
                    <a:lnTo>
                      <a:pt x="3908" y="252"/>
                    </a:lnTo>
                    <a:lnTo>
                      <a:pt x="3921" y="280"/>
                    </a:lnTo>
                    <a:lnTo>
                      <a:pt x="3935" y="280"/>
                    </a:lnTo>
                    <a:lnTo>
                      <a:pt x="3948" y="271"/>
                    </a:lnTo>
                    <a:lnTo>
                      <a:pt x="3960" y="161"/>
                    </a:lnTo>
                    <a:lnTo>
                      <a:pt x="3973" y="265"/>
                    </a:lnTo>
                    <a:lnTo>
                      <a:pt x="3987" y="267"/>
                    </a:lnTo>
                    <a:lnTo>
                      <a:pt x="3998" y="246"/>
                    </a:lnTo>
                    <a:lnTo>
                      <a:pt x="4012" y="273"/>
                    </a:lnTo>
                    <a:lnTo>
                      <a:pt x="4025" y="253"/>
                    </a:lnTo>
                    <a:lnTo>
                      <a:pt x="4039" y="265"/>
                    </a:lnTo>
                    <a:lnTo>
                      <a:pt x="4050" y="280"/>
                    </a:lnTo>
                    <a:lnTo>
                      <a:pt x="4063" y="280"/>
                    </a:lnTo>
                    <a:lnTo>
                      <a:pt x="4077" y="280"/>
                    </a:lnTo>
                    <a:lnTo>
                      <a:pt x="4090" y="257"/>
                    </a:lnTo>
                    <a:lnTo>
                      <a:pt x="4102" y="242"/>
                    </a:lnTo>
                    <a:lnTo>
                      <a:pt x="4115" y="90"/>
                    </a:lnTo>
                    <a:lnTo>
                      <a:pt x="4129" y="213"/>
                    </a:lnTo>
                    <a:lnTo>
                      <a:pt x="4142" y="257"/>
                    </a:lnTo>
                    <a:lnTo>
                      <a:pt x="4154" y="198"/>
                    </a:lnTo>
                    <a:lnTo>
                      <a:pt x="4167" y="271"/>
                    </a:lnTo>
                    <a:lnTo>
                      <a:pt x="4181" y="202"/>
                    </a:lnTo>
                    <a:lnTo>
                      <a:pt x="4194" y="221"/>
                    </a:lnTo>
                    <a:lnTo>
                      <a:pt x="4206" y="159"/>
                    </a:lnTo>
                    <a:lnTo>
                      <a:pt x="4219" y="184"/>
                    </a:lnTo>
                    <a:lnTo>
                      <a:pt x="4232" y="209"/>
                    </a:lnTo>
                    <a:lnTo>
                      <a:pt x="4244" y="42"/>
                    </a:lnTo>
                    <a:lnTo>
                      <a:pt x="4257" y="177"/>
                    </a:lnTo>
                    <a:lnTo>
                      <a:pt x="4271" y="188"/>
                    </a:lnTo>
                    <a:lnTo>
                      <a:pt x="4284" y="32"/>
                    </a:lnTo>
                    <a:lnTo>
                      <a:pt x="4296" y="184"/>
                    </a:lnTo>
                    <a:lnTo>
                      <a:pt x="4309" y="203"/>
                    </a:lnTo>
                    <a:lnTo>
                      <a:pt x="4323" y="223"/>
                    </a:lnTo>
                    <a:lnTo>
                      <a:pt x="4336" y="167"/>
                    </a:lnTo>
                    <a:lnTo>
                      <a:pt x="4348" y="179"/>
                    </a:lnTo>
                    <a:lnTo>
                      <a:pt x="4361" y="213"/>
                    </a:lnTo>
                    <a:lnTo>
                      <a:pt x="4375" y="79"/>
                    </a:lnTo>
                    <a:lnTo>
                      <a:pt x="4388" y="134"/>
                    </a:lnTo>
                    <a:lnTo>
                      <a:pt x="4400" y="207"/>
                    </a:lnTo>
                    <a:lnTo>
                      <a:pt x="4413" y="121"/>
                    </a:lnTo>
                    <a:lnTo>
                      <a:pt x="4426" y="238"/>
                    </a:lnTo>
                    <a:lnTo>
                      <a:pt x="4440" y="92"/>
                    </a:lnTo>
                    <a:lnTo>
                      <a:pt x="4451" y="261"/>
                    </a:lnTo>
                    <a:lnTo>
                      <a:pt x="4465" y="200"/>
                    </a:lnTo>
                    <a:lnTo>
                      <a:pt x="4478" y="177"/>
                    </a:lnTo>
                    <a:lnTo>
                      <a:pt x="4492" y="155"/>
                    </a:lnTo>
                    <a:lnTo>
                      <a:pt x="4503" y="205"/>
                    </a:lnTo>
                    <a:lnTo>
                      <a:pt x="4517" y="277"/>
                    </a:lnTo>
                    <a:lnTo>
                      <a:pt x="4530" y="215"/>
                    </a:lnTo>
                    <a:lnTo>
                      <a:pt x="4542" y="146"/>
                    </a:lnTo>
                    <a:lnTo>
                      <a:pt x="4555" y="152"/>
                    </a:lnTo>
                    <a:lnTo>
                      <a:pt x="4568" y="161"/>
                    </a:lnTo>
                    <a:lnTo>
                      <a:pt x="4582" y="144"/>
                    </a:lnTo>
                    <a:lnTo>
                      <a:pt x="4593" y="203"/>
                    </a:lnTo>
                    <a:lnTo>
                      <a:pt x="4607" y="209"/>
                    </a:lnTo>
                    <a:lnTo>
                      <a:pt x="4620" y="234"/>
                    </a:lnTo>
                    <a:lnTo>
                      <a:pt x="4634" y="213"/>
                    </a:lnTo>
                    <a:lnTo>
                      <a:pt x="4645" y="230"/>
                    </a:lnTo>
                    <a:lnTo>
                      <a:pt x="4659" y="186"/>
                    </a:lnTo>
                    <a:lnTo>
                      <a:pt x="4672" y="134"/>
                    </a:lnTo>
                    <a:lnTo>
                      <a:pt x="4686" y="163"/>
                    </a:lnTo>
                    <a:lnTo>
                      <a:pt x="4697" y="127"/>
                    </a:lnTo>
                    <a:lnTo>
                      <a:pt x="4711" y="179"/>
                    </a:lnTo>
                    <a:lnTo>
                      <a:pt x="4724" y="180"/>
                    </a:lnTo>
                    <a:lnTo>
                      <a:pt x="4737" y="81"/>
                    </a:lnTo>
                    <a:lnTo>
                      <a:pt x="4749" y="82"/>
                    </a:lnTo>
                    <a:lnTo>
                      <a:pt x="4762" y="207"/>
                    </a:lnTo>
                    <a:lnTo>
                      <a:pt x="4776" y="146"/>
                    </a:lnTo>
                    <a:lnTo>
                      <a:pt x="4789" y="71"/>
                    </a:lnTo>
                    <a:lnTo>
                      <a:pt x="4801" y="111"/>
                    </a:lnTo>
                    <a:lnTo>
                      <a:pt x="4814" y="140"/>
                    </a:lnTo>
                    <a:lnTo>
                      <a:pt x="4828" y="65"/>
                    </a:lnTo>
                    <a:lnTo>
                      <a:pt x="4839" y="127"/>
                    </a:lnTo>
                    <a:lnTo>
                      <a:pt x="4853" y="155"/>
                    </a:lnTo>
                    <a:lnTo>
                      <a:pt x="4866" y="90"/>
                    </a:lnTo>
                    <a:lnTo>
                      <a:pt x="4880" y="23"/>
                    </a:lnTo>
                    <a:lnTo>
                      <a:pt x="4891" y="0"/>
                    </a:lnTo>
                    <a:lnTo>
                      <a:pt x="4905" y="88"/>
                    </a:lnTo>
                    <a:lnTo>
                      <a:pt x="4918" y="57"/>
                    </a:lnTo>
                    <a:lnTo>
                      <a:pt x="4931" y="67"/>
                    </a:lnTo>
                    <a:lnTo>
                      <a:pt x="4943" y="175"/>
                    </a:lnTo>
                    <a:lnTo>
                      <a:pt x="4956" y="100"/>
                    </a:lnTo>
                    <a:lnTo>
                      <a:pt x="4970" y="123"/>
                    </a:lnTo>
                    <a:lnTo>
                      <a:pt x="4983" y="152"/>
                    </a:lnTo>
                    <a:lnTo>
                      <a:pt x="4995" y="155"/>
                    </a:lnTo>
                    <a:lnTo>
                      <a:pt x="5008" y="111"/>
                    </a:lnTo>
                    <a:lnTo>
                      <a:pt x="5022" y="132"/>
                    </a:lnTo>
                    <a:lnTo>
                      <a:pt x="5035" y="29"/>
                    </a:lnTo>
                    <a:lnTo>
                      <a:pt x="5047" y="96"/>
                    </a:lnTo>
                    <a:lnTo>
                      <a:pt x="5060" y="136"/>
                    </a:lnTo>
                    <a:lnTo>
                      <a:pt x="5073" y="111"/>
                    </a:lnTo>
                    <a:lnTo>
                      <a:pt x="5085" y="130"/>
                    </a:lnTo>
                    <a:lnTo>
                      <a:pt x="5098" y="63"/>
                    </a:lnTo>
                    <a:lnTo>
                      <a:pt x="5112" y="73"/>
                    </a:lnTo>
                    <a:lnTo>
                      <a:pt x="5125" y="79"/>
                    </a:lnTo>
                    <a:lnTo>
                      <a:pt x="5137" y="69"/>
                    </a:lnTo>
                    <a:lnTo>
                      <a:pt x="5150" y="184"/>
                    </a:lnTo>
                    <a:lnTo>
                      <a:pt x="5164" y="129"/>
                    </a:lnTo>
                    <a:lnTo>
                      <a:pt x="5177" y="75"/>
                    </a:lnTo>
                    <a:lnTo>
                      <a:pt x="5189" y="48"/>
                    </a:lnTo>
                    <a:lnTo>
                      <a:pt x="5202" y="79"/>
                    </a:lnTo>
                    <a:lnTo>
                      <a:pt x="5216" y="98"/>
                    </a:lnTo>
                    <a:lnTo>
                      <a:pt x="5229" y="113"/>
                    </a:lnTo>
                    <a:lnTo>
                      <a:pt x="5241" y="25"/>
                    </a:lnTo>
                    <a:lnTo>
                      <a:pt x="5254" y="152"/>
                    </a:lnTo>
                    <a:lnTo>
                      <a:pt x="5267" y="144"/>
                    </a:lnTo>
                    <a:lnTo>
                      <a:pt x="5281" y="109"/>
                    </a:lnTo>
                    <a:lnTo>
                      <a:pt x="5292" y="34"/>
                    </a:lnTo>
                    <a:lnTo>
                      <a:pt x="5306" y="138"/>
                    </a:lnTo>
                    <a:lnTo>
                      <a:pt x="5319" y="67"/>
                    </a:lnTo>
                    <a:lnTo>
                      <a:pt x="5333" y="109"/>
                    </a:lnTo>
                    <a:lnTo>
                      <a:pt x="5344" y="73"/>
                    </a:lnTo>
                    <a:lnTo>
                      <a:pt x="5358" y="61"/>
                    </a:lnTo>
                    <a:lnTo>
                      <a:pt x="5371" y="117"/>
                    </a:lnTo>
                    <a:lnTo>
                      <a:pt x="5383" y="167"/>
                    </a:lnTo>
                    <a:lnTo>
                      <a:pt x="5396" y="161"/>
                    </a:lnTo>
                    <a:lnTo>
                      <a:pt x="5410" y="253"/>
                    </a:lnTo>
                    <a:lnTo>
                      <a:pt x="5410" y="280"/>
                    </a:lnTo>
                    <a:lnTo>
                      <a:pt x="5396" y="280"/>
                    </a:lnTo>
                    <a:lnTo>
                      <a:pt x="5383" y="280"/>
                    </a:lnTo>
                    <a:lnTo>
                      <a:pt x="5371" y="280"/>
                    </a:lnTo>
                    <a:lnTo>
                      <a:pt x="5358" y="280"/>
                    </a:lnTo>
                    <a:lnTo>
                      <a:pt x="5344" y="280"/>
                    </a:lnTo>
                    <a:lnTo>
                      <a:pt x="5333" y="280"/>
                    </a:lnTo>
                    <a:lnTo>
                      <a:pt x="5319" y="280"/>
                    </a:lnTo>
                    <a:lnTo>
                      <a:pt x="5306" y="280"/>
                    </a:lnTo>
                    <a:lnTo>
                      <a:pt x="5292" y="280"/>
                    </a:lnTo>
                    <a:lnTo>
                      <a:pt x="5281" y="280"/>
                    </a:lnTo>
                    <a:lnTo>
                      <a:pt x="5267" y="280"/>
                    </a:lnTo>
                    <a:lnTo>
                      <a:pt x="5254" y="280"/>
                    </a:lnTo>
                    <a:lnTo>
                      <a:pt x="5241" y="280"/>
                    </a:lnTo>
                    <a:lnTo>
                      <a:pt x="5229" y="280"/>
                    </a:lnTo>
                    <a:lnTo>
                      <a:pt x="5216" y="280"/>
                    </a:lnTo>
                    <a:lnTo>
                      <a:pt x="5202" y="280"/>
                    </a:lnTo>
                    <a:lnTo>
                      <a:pt x="5189" y="280"/>
                    </a:lnTo>
                    <a:lnTo>
                      <a:pt x="5177" y="280"/>
                    </a:lnTo>
                    <a:lnTo>
                      <a:pt x="5164" y="280"/>
                    </a:lnTo>
                    <a:lnTo>
                      <a:pt x="5150" y="280"/>
                    </a:lnTo>
                    <a:lnTo>
                      <a:pt x="5137" y="280"/>
                    </a:lnTo>
                    <a:lnTo>
                      <a:pt x="5125" y="280"/>
                    </a:lnTo>
                    <a:lnTo>
                      <a:pt x="5112" y="280"/>
                    </a:lnTo>
                    <a:lnTo>
                      <a:pt x="5098" y="280"/>
                    </a:lnTo>
                    <a:lnTo>
                      <a:pt x="5085" y="280"/>
                    </a:lnTo>
                    <a:lnTo>
                      <a:pt x="5073" y="280"/>
                    </a:lnTo>
                    <a:lnTo>
                      <a:pt x="5060" y="280"/>
                    </a:lnTo>
                    <a:lnTo>
                      <a:pt x="5047" y="280"/>
                    </a:lnTo>
                    <a:lnTo>
                      <a:pt x="5035" y="280"/>
                    </a:lnTo>
                    <a:lnTo>
                      <a:pt x="5022" y="280"/>
                    </a:lnTo>
                    <a:lnTo>
                      <a:pt x="5008" y="280"/>
                    </a:lnTo>
                    <a:lnTo>
                      <a:pt x="4995" y="280"/>
                    </a:lnTo>
                    <a:lnTo>
                      <a:pt x="4983" y="280"/>
                    </a:lnTo>
                    <a:lnTo>
                      <a:pt x="4970" y="280"/>
                    </a:lnTo>
                    <a:lnTo>
                      <a:pt x="4956" y="280"/>
                    </a:lnTo>
                    <a:lnTo>
                      <a:pt x="4943" y="280"/>
                    </a:lnTo>
                    <a:lnTo>
                      <a:pt x="4931" y="280"/>
                    </a:lnTo>
                    <a:lnTo>
                      <a:pt x="4918" y="280"/>
                    </a:lnTo>
                    <a:lnTo>
                      <a:pt x="4905" y="280"/>
                    </a:lnTo>
                    <a:lnTo>
                      <a:pt x="4891" y="280"/>
                    </a:lnTo>
                    <a:lnTo>
                      <a:pt x="4880" y="280"/>
                    </a:lnTo>
                    <a:lnTo>
                      <a:pt x="4866" y="280"/>
                    </a:lnTo>
                    <a:lnTo>
                      <a:pt x="4853" y="280"/>
                    </a:lnTo>
                    <a:lnTo>
                      <a:pt x="4839" y="280"/>
                    </a:lnTo>
                    <a:lnTo>
                      <a:pt x="4828" y="280"/>
                    </a:lnTo>
                    <a:lnTo>
                      <a:pt x="4814" y="280"/>
                    </a:lnTo>
                    <a:lnTo>
                      <a:pt x="4801" y="280"/>
                    </a:lnTo>
                    <a:lnTo>
                      <a:pt x="4789" y="280"/>
                    </a:lnTo>
                    <a:lnTo>
                      <a:pt x="4776" y="280"/>
                    </a:lnTo>
                    <a:lnTo>
                      <a:pt x="4762" y="280"/>
                    </a:lnTo>
                    <a:lnTo>
                      <a:pt x="4749" y="280"/>
                    </a:lnTo>
                    <a:lnTo>
                      <a:pt x="4737" y="280"/>
                    </a:lnTo>
                    <a:lnTo>
                      <a:pt x="4724" y="280"/>
                    </a:lnTo>
                    <a:lnTo>
                      <a:pt x="4711" y="280"/>
                    </a:lnTo>
                    <a:lnTo>
                      <a:pt x="4697" y="280"/>
                    </a:lnTo>
                    <a:lnTo>
                      <a:pt x="4686" y="280"/>
                    </a:lnTo>
                    <a:lnTo>
                      <a:pt x="4672" y="280"/>
                    </a:lnTo>
                    <a:lnTo>
                      <a:pt x="4659" y="280"/>
                    </a:lnTo>
                    <a:lnTo>
                      <a:pt x="4645" y="280"/>
                    </a:lnTo>
                    <a:lnTo>
                      <a:pt x="4634" y="280"/>
                    </a:lnTo>
                    <a:lnTo>
                      <a:pt x="4620" y="280"/>
                    </a:lnTo>
                    <a:lnTo>
                      <a:pt x="4607" y="280"/>
                    </a:lnTo>
                    <a:lnTo>
                      <a:pt x="4593" y="280"/>
                    </a:lnTo>
                    <a:lnTo>
                      <a:pt x="4582" y="280"/>
                    </a:lnTo>
                    <a:lnTo>
                      <a:pt x="4568" y="280"/>
                    </a:lnTo>
                    <a:lnTo>
                      <a:pt x="4555" y="280"/>
                    </a:lnTo>
                    <a:lnTo>
                      <a:pt x="4542" y="280"/>
                    </a:lnTo>
                    <a:lnTo>
                      <a:pt x="4530" y="280"/>
                    </a:lnTo>
                    <a:lnTo>
                      <a:pt x="4517" y="280"/>
                    </a:lnTo>
                    <a:lnTo>
                      <a:pt x="4503" y="280"/>
                    </a:lnTo>
                    <a:lnTo>
                      <a:pt x="4492" y="280"/>
                    </a:lnTo>
                    <a:lnTo>
                      <a:pt x="4478" y="280"/>
                    </a:lnTo>
                    <a:lnTo>
                      <a:pt x="4465" y="280"/>
                    </a:lnTo>
                    <a:lnTo>
                      <a:pt x="4451" y="280"/>
                    </a:lnTo>
                    <a:lnTo>
                      <a:pt x="4440" y="280"/>
                    </a:lnTo>
                    <a:lnTo>
                      <a:pt x="4426" y="280"/>
                    </a:lnTo>
                    <a:lnTo>
                      <a:pt x="4413" y="280"/>
                    </a:lnTo>
                    <a:lnTo>
                      <a:pt x="4400" y="280"/>
                    </a:lnTo>
                    <a:lnTo>
                      <a:pt x="4388" y="280"/>
                    </a:lnTo>
                    <a:lnTo>
                      <a:pt x="4375" y="280"/>
                    </a:lnTo>
                    <a:lnTo>
                      <a:pt x="4361" y="280"/>
                    </a:lnTo>
                    <a:lnTo>
                      <a:pt x="4348" y="280"/>
                    </a:lnTo>
                    <a:lnTo>
                      <a:pt x="4336" y="280"/>
                    </a:lnTo>
                    <a:lnTo>
                      <a:pt x="4323" y="280"/>
                    </a:lnTo>
                    <a:lnTo>
                      <a:pt x="4309" y="280"/>
                    </a:lnTo>
                    <a:lnTo>
                      <a:pt x="4296" y="280"/>
                    </a:lnTo>
                    <a:lnTo>
                      <a:pt x="4284" y="280"/>
                    </a:lnTo>
                    <a:lnTo>
                      <a:pt x="4271" y="280"/>
                    </a:lnTo>
                    <a:lnTo>
                      <a:pt x="4257" y="280"/>
                    </a:lnTo>
                    <a:lnTo>
                      <a:pt x="4244" y="280"/>
                    </a:lnTo>
                    <a:lnTo>
                      <a:pt x="4232" y="280"/>
                    </a:lnTo>
                    <a:lnTo>
                      <a:pt x="4219" y="280"/>
                    </a:lnTo>
                    <a:lnTo>
                      <a:pt x="4206" y="280"/>
                    </a:lnTo>
                    <a:lnTo>
                      <a:pt x="4194" y="280"/>
                    </a:lnTo>
                    <a:lnTo>
                      <a:pt x="4181" y="280"/>
                    </a:lnTo>
                    <a:lnTo>
                      <a:pt x="4167" y="280"/>
                    </a:lnTo>
                    <a:lnTo>
                      <a:pt x="4154" y="280"/>
                    </a:lnTo>
                    <a:lnTo>
                      <a:pt x="4142" y="280"/>
                    </a:lnTo>
                    <a:lnTo>
                      <a:pt x="4129" y="280"/>
                    </a:lnTo>
                    <a:lnTo>
                      <a:pt x="4115" y="280"/>
                    </a:lnTo>
                    <a:lnTo>
                      <a:pt x="4102" y="280"/>
                    </a:lnTo>
                    <a:lnTo>
                      <a:pt x="4090" y="280"/>
                    </a:lnTo>
                    <a:lnTo>
                      <a:pt x="4077" y="280"/>
                    </a:lnTo>
                    <a:lnTo>
                      <a:pt x="4063" y="280"/>
                    </a:lnTo>
                    <a:lnTo>
                      <a:pt x="4050" y="280"/>
                    </a:lnTo>
                    <a:lnTo>
                      <a:pt x="4039" y="280"/>
                    </a:lnTo>
                    <a:lnTo>
                      <a:pt x="4025" y="280"/>
                    </a:lnTo>
                    <a:lnTo>
                      <a:pt x="4012" y="280"/>
                    </a:lnTo>
                    <a:lnTo>
                      <a:pt x="3998" y="280"/>
                    </a:lnTo>
                    <a:lnTo>
                      <a:pt x="3987" y="280"/>
                    </a:lnTo>
                    <a:lnTo>
                      <a:pt x="3973" y="280"/>
                    </a:lnTo>
                    <a:lnTo>
                      <a:pt x="3960" y="280"/>
                    </a:lnTo>
                    <a:lnTo>
                      <a:pt x="3948" y="280"/>
                    </a:lnTo>
                    <a:lnTo>
                      <a:pt x="3935" y="280"/>
                    </a:lnTo>
                    <a:lnTo>
                      <a:pt x="3921" y="280"/>
                    </a:lnTo>
                    <a:lnTo>
                      <a:pt x="3908" y="280"/>
                    </a:lnTo>
                    <a:lnTo>
                      <a:pt x="3896" y="280"/>
                    </a:lnTo>
                    <a:lnTo>
                      <a:pt x="3883" y="280"/>
                    </a:lnTo>
                    <a:lnTo>
                      <a:pt x="3870" y="280"/>
                    </a:lnTo>
                    <a:lnTo>
                      <a:pt x="3856" y="280"/>
                    </a:lnTo>
                    <a:lnTo>
                      <a:pt x="3845" y="280"/>
                    </a:lnTo>
                    <a:lnTo>
                      <a:pt x="3831" y="280"/>
                    </a:lnTo>
                    <a:lnTo>
                      <a:pt x="3818" y="280"/>
                    </a:lnTo>
                    <a:lnTo>
                      <a:pt x="3804" y="280"/>
                    </a:lnTo>
                    <a:lnTo>
                      <a:pt x="3793" y="280"/>
                    </a:lnTo>
                    <a:lnTo>
                      <a:pt x="3779" y="280"/>
                    </a:lnTo>
                    <a:lnTo>
                      <a:pt x="3766" y="280"/>
                    </a:lnTo>
                    <a:lnTo>
                      <a:pt x="3752" y="280"/>
                    </a:lnTo>
                    <a:lnTo>
                      <a:pt x="3741" y="280"/>
                    </a:lnTo>
                    <a:lnTo>
                      <a:pt x="3727" y="280"/>
                    </a:lnTo>
                    <a:lnTo>
                      <a:pt x="3714" y="280"/>
                    </a:lnTo>
                    <a:lnTo>
                      <a:pt x="3701" y="280"/>
                    </a:lnTo>
                    <a:lnTo>
                      <a:pt x="3689" y="280"/>
                    </a:lnTo>
                    <a:lnTo>
                      <a:pt x="3676" y="280"/>
                    </a:lnTo>
                    <a:lnTo>
                      <a:pt x="3662" y="280"/>
                    </a:lnTo>
                    <a:lnTo>
                      <a:pt x="3651" y="280"/>
                    </a:lnTo>
                    <a:lnTo>
                      <a:pt x="3637" y="280"/>
                    </a:lnTo>
                    <a:lnTo>
                      <a:pt x="3624" y="280"/>
                    </a:lnTo>
                    <a:lnTo>
                      <a:pt x="3610" y="280"/>
                    </a:lnTo>
                    <a:lnTo>
                      <a:pt x="3599" y="280"/>
                    </a:lnTo>
                    <a:lnTo>
                      <a:pt x="3585" y="280"/>
                    </a:lnTo>
                    <a:lnTo>
                      <a:pt x="3572" y="280"/>
                    </a:lnTo>
                    <a:lnTo>
                      <a:pt x="3558" y="280"/>
                    </a:lnTo>
                    <a:lnTo>
                      <a:pt x="3547" y="280"/>
                    </a:lnTo>
                    <a:lnTo>
                      <a:pt x="3534" y="280"/>
                    </a:lnTo>
                    <a:lnTo>
                      <a:pt x="3520" y="280"/>
                    </a:lnTo>
                    <a:lnTo>
                      <a:pt x="3507" y="280"/>
                    </a:lnTo>
                    <a:lnTo>
                      <a:pt x="3495" y="280"/>
                    </a:lnTo>
                    <a:lnTo>
                      <a:pt x="3482" y="280"/>
                    </a:lnTo>
                    <a:lnTo>
                      <a:pt x="3468" y="280"/>
                    </a:lnTo>
                    <a:lnTo>
                      <a:pt x="3455" y="280"/>
                    </a:lnTo>
                    <a:lnTo>
                      <a:pt x="3443" y="280"/>
                    </a:lnTo>
                    <a:lnTo>
                      <a:pt x="3430" y="280"/>
                    </a:lnTo>
                    <a:lnTo>
                      <a:pt x="3416" y="280"/>
                    </a:lnTo>
                    <a:lnTo>
                      <a:pt x="3403" y="280"/>
                    </a:lnTo>
                    <a:lnTo>
                      <a:pt x="3391" y="280"/>
                    </a:lnTo>
                    <a:lnTo>
                      <a:pt x="3378" y="280"/>
                    </a:lnTo>
                    <a:lnTo>
                      <a:pt x="3365" y="280"/>
                    </a:lnTo>
                    <a:lnTo>
                      <a:pt x="3353" y="280"/>
                    </a:lnTo>
                    <a:lnTo>
                      <a:pt x="3340" y="280"/>
                    </a:lnTo>
                    <a:lnTo>
                      <a:pt x="3326" y="280"/>
                    </a:lnTo>
                    <a:lnTo>
                      <a:pt x="3313" y="280"/>
                    </a:lnTo>
                    <a:lnTo>
                      <a:pt x="3301" y="280"/>
                    </a:lnTo>
                    <a:lnTo>
                      <a:pt x="3288" y="280"/>
                    </a:lnTo>
                    <a:lnTo>
                      <a:pt x="3274" y="280"/>
                    </a:lnTo>
                    <a:lnTo>
                      <a:pt x="3261" y="280"/>
                    </a:lnTo>
                    <a:lnTo>
                      <a:pt x="3249" y="280"/>
                    </a:lnTo>
                    <a:lnTo>
                      <a:pt x="3236" y="280"/>
                    </a:lnTo>
                    <a:lnTo>
                      <a:pt x="3222" y="280"/>
                    </a:lnTo>
                    <a:lnTo>
                      <a:pt x="3209" y="280"/>
                    </a:lnTo>
                    <a:lnTo>
                      <a:pt x="3198" y="280"/>
                    </a:lnTo>
                    <a:lnTo>
                      <a:pt x="3184" y="280"/>
                    </a:lnTo>
                    <a:lnTo>
                      <a:pt x="3171" y="280"/>
                    </a:lnTo>
                    <a:lnTo>
                      <a:pt x="3157" y="280"/>
                    </a:lnTo>
                    <a:lnTo>
                      <a:pt x="3146" y="280"/>
                    </a:lnTo>
                    <a:lnTo>
                      <a:pt x="3132" y="280"/>
                    </a:lnTo>
                    <a:lnTo>
                      <a:pt x="3119" y="280"/>
                    </a:lnTo>
                    <a:lnTo>
                      <a:pt x="3107" y="280"/>
                    </a:lnTo>
                    <a:lnTo>
                      <a:pt x="3094" y="280"/>
                    </a:lnTo>
                    <a:lnTo>
                      <a:pt x="3080" y="280"/>
                    </a:lnTo>
                    <a:lnTo>
                      <a:pt x="3067" y="280"/>
                    </a:lnTo>
                    <a:lnTo>
                      <a:pt x="3055" y="280"/>
                    </a:lnTo>
                    <a:lnTo>
                      <a:pt x="3042" y="280"/>
                    </a:lnTo>
                    <a:lnTo>
                      <a:pt x="3029" y="280"/>
                    </a:lnTo>
                    <a:lnTo>
                      <a:pt x="3015" y="280"/>
                    </a:lnTo>
                    <a:lnTo>
                      <a:pt x="3004" y="280"/>
                    </a:lnTo>
                    <a:lnTo>
                      <a:pt x="2990" y="280"/>
                    </a:lnTo>
                    <a:lnTo>
                      <a:pt x="2977" y="280"/>
                    </a:lnTo>
                    <a:lnTo>
                      <a:pt x="2963" y="280"/>
                    </a:lnTo>
                    <a:lnTo>
                      <a:pt x="2952" y="280"/>
                    </a:lnTo>
                    <a:lnTo>
                      <a:pt x="2938" y="280"/>
                    </a:lnTo>
                    <a:lnTo>
                      <a:pt x="2925" y="280"/>
                    </a:lnTo>
                    <a:lnTo>
                      <a:pt x="2911" y="280"/>
                    </a:lnTo>
                    <a:lnTo>
                      <a:pt x="2900" y="280"/>
                    </a:lnTo>
                    <a:lnTo>
                      <a:pt x="2886" y="280"/>
                    </a:lnTo>
                    <a:lnTo>
                      <a:pt x="2873" y="280"/>
                    </a:lnTo>
                    <a:lnTo>
                      <a:pt x="2860" y="280"/>
                    </a:lnTo>
                    <a:lnTo>
                      <a:pt x="2848" y="280"/>
                    </a:lnTo>
                    <a:lnTo>
                      <a:pt x="2835" y="280"/>
                    </a:lnTo>
                    <a:lnTo>
                      <a:pt x="2821" y="280"/>
                    </a:lnTo>
                    <a:lnTo>
                      <a:pt x="2810" y="280"/>
                    </a:lnTo>
                    <a:lnTo>
                      <a:pt x="2796" y="280"/>
                    </a:lnTo>
                    <a:lnTo>
                      <a:pt x="2783" y="280"/>
                    </a:lnTo>
                    <a:lnTo>
                      <a:pt x="2769" y="280"/>
                    </a:lnTo>
                    <a:lnTo>
                      <a:pt x="2758" y="280"/>
                    </a:lnTo>
                    <a:lnTo>
                      <a:pt x="2744" y="280"/>
                    </a:lnTo>
                    <a:lnTo>
                      <a:pt x="2731" y="280"/>
                    </a:lnTo>
                    <a:lnTo>
                      <a:pt x="2717" y="280"/>
                    </a:lnTo>
                    <a:lnTo>
                      <a:pt x="2706" y="280"/>
                    </a:lnTo>
                    <a:lnTo>
                      <a:pt x="2693" y="280"/>
                    </a:lnTo>
                    <a:lnTo>
                      <a:pt x="2679" y="280"/>
                    </a:lnTo>
                    <a:lnTo>
                      <a:pt x="2666" y="280"/>
                    </a:lnTo>
                    <a:lnTo>
                      <a:pt x="2654" y="280"/>
                    </a:lnTo>
                    <a:lnTo>
                      <a:pt x="2641" y="280"/>
                    </a:lnTo>
                    <a:lnTo>
                      <a:pt x="2627" y="280"/>
                    </a:lnTo>
                    <a:lnTo>
                      <a:pt x="2614" y="280"/>
                    </a:lnTo>
                    <a:lnTo>
                      <a:pt x="2602" y="280"/>
                    </a:lnTo>
                    <a:lnTo>
                      <a:pt x="2589" y="280"/>
                    </a:lnTo>
                    <a:lnTo>
                      <a:pt x="2575" y="280"/>
                    </a:lnTo>
                    <a:lnTo>
                      <a:pt x="2562" y="280"/>
                    </a:lnTo>
                    <a:lnTo>
                      <a:pt x="2550" y="280"/>
                    </a:lnTo>
                    <a:lnTo>
                      <a:pt x="2537" y="280"/>
                    </a:lnTo>
                    <a:lnTo>
                      <a:pt x="2524" y="280"/>
                    </a:lnTo>
                    <a:lnTo>
                      <a:pt x="2512" y="280"/>
                    </a:lnTo>
                    <a:lnTo>
                      <a:pt x="2499" y="280"/>
                    </a:lnTo>
                    <a:lnTo>
                      <a:pt x="2485" y="280"/>
                    </a:lnTo>
                    <a:lnTo>
                      <a:pt x="2472" y="280"/>
                    </a:lnTo>
                    <a:lnTo>
                      <a:pt x="2460" y="280"/>
                    </a:lnTo>
                    <a:lnTo>
                      <a:pt x="2447" y="280"/>
                    </a:lnTo>
                    <a:lnTo>
                      <a:pt x="2433" y="280"/>
                    </a:lnTo>
                    <a:lnTo>
                      <a:pt x="2420" y="280"/>
                    </a:lnTo>
                    <a:lnTo>
                      <a:pt x="2408" y="280"/>
                    </a:lnTo>
                    <a:lnTo>
                      <a:pt x="2395" y="280"/>
                    </a:lnTo>
                    <a:lnTo>
                      <a:pt x="2381" y="280"/>
                    </a:lnTo>
                    <a:lnTo>
                      <a:pt x="2368" y="280"/>
                    </a:lnTo>
                    <a:lnTo>
                      <a:pt x="2356" y="280"/>
                    </a:lnTo>
                    <a:lnTo>
                      <a:pt x="2343" y="280"/>
                    </a:lnTo>
                    <a:lnTo>
                      <a:pt x="2330" y="280"/>
                    </a:lnTo>
                    <a:lnTo>
                      <a:pt x="2316" y="280"/>
                    </a:lnTo>
                    <a:lnTo>
                      <a:pt x="2305" y="280"/>
                    </a:lnTo>
                    <a:lnTo>
                      <a:pt x="2291" y="280"/>
                    </a:lnTo>
                    <a:lnTo>
                      <a:pt x="2278" y="280"/>
                    </a:lnTo>
                    <a:lnTo>
                      <a:pt x="2266" y="280"/>
                    </a:lnTo>
                    <a:lnTo>
                      <a:pt x="2253" y="280"/>
                    </a:lnTo>
                    <a:lnTo>
                      <a:pt x="2239" y="280"/>
                    </a:lnTo>
                    <a:lnTo>
                      <a:pt x="2226" y="280"/>
                    </a:lnTo>
                    <a:lnTo>
                      <a:pt x="2214" y="280"/>
                    </a:lnTo>
                    <a:lnTo>
                      <a:pt x="2201" y="280"/>
                    </a:lnTo>
                    <a:lnTo>
                      <a:pt x="2188" y="280"/>
                    </a:lnTo>
                    <a:lnTo>
                      <a:pt x="2174" y="280"/>
                    </a:lnTo>
                    <a:lnTo>
                      <a:pt x="2163" y="280"/>
                    </a:lnTo>
                    <a:lnTo>
                      <a:pt x="2149" y="280"/>
                    </a:lnTo>
                    <a:lnTo>
                      <a:pt x="2136" y="280"/>
                    </a:lnTo>
                    <a:lnTo>
                      <a:pt x="2122" y="280"/>
                    </a:lnTo>
                    <a:lnTo>
                      <a:pt x="2111" y="280"/>
                    </a:lnTo>
                    <a:lnTo>
                      <a:pt x="2097" y="280"/>
                    </a:lnTo>
                    <a:lnTo>
                      <a:pt x="2084" y="280"/>
                    </a:lnTo>
                    <a:lnTo>
                      <a:pt x="2070" y="280"/>
                    </a:lnTo>
                    <a:lnTo>
                      <a:pt x="2059" y="280"/>
                    </a:lnTo>
                    <a:lnTo>
                      <a:pt x="2045" y="280"/>
                    </a:lnTo>
                    <a:lnTo>
                      <a:pt x="2032" y="280"/>
                    </a:lnTo>
                    <a:lnTo>
                      <a:pt x="2019" y="280"/>
                    </a:lnTo>
                    <a:lnTo>
                      <a:pt x="2007" y="280"/>
                    </a:lnTo>
                    <a:lnTo>
                      <a:pt x="1994" y="280"/>
                    </a:lnTo>
                    <a:lnTo>
                      <a:pt x="1980" y="280"/>
                    </a:lnTo>
                    <a:lnTo>
                      <a:pt x="1969" y="280"/>
                    </a:lnTo>
                    <a:lnTo>
                      <a:pt x="1955" y="280"/>
                    </a:lnTo>
                    <a:lnTo>
                      <a:pt x="1942" y="280"/>
                    </a:lnTo>
                    <a:lnTo>
                      <a:pt x="1928" y="280"/>
                    </a:lnTo>
                    <a:lnTo>
                      <a:pt x="1917" y="280"/>
                    </a:lnTo>
                    <a:lnTo>
                      <a:pt x="1903" y="280"/>
                    </a:lnTo>
                    <a:lnTo>
                      <a:pt x="1890" y="280"/>
                    </a:lnTo>
                    <a:lnTo>
                      <a:pt x="1876" y="280"/>
                    </a:lnTo>
                    <a:lnTo>
                      <a:pt x="1865" y="280"/>
                    </a:lnTo>
                    <a:lnTo>
                      <a:pt x="1852" y="280"/>
                    </a:lnTo>
                    <a:lnTo>
                      <a:pt x="1838" y="280"/>
                    </a:lnTo>
                    <a:lnTo>
                      <a:pt x="1825" y="280"/>
                    </a:lnTo>
                    <a:lnTo>
                      <a:pt x="1813" y="280"/>
                    </a:lnTo>
                    <a:lnTo>
                      <a:pt x="1800" y="280"/>
                    </a:lnTo>
                    <a:lnTo>
                      <a:pt x="1786" y="280"/>
                    </a:lnTo>
                    <a:lnTo>
                      <a:pt x="1773" y="280"/>
                    </a:lnTo>
                    <a:lnTo>
                      <a:pt x="1761" y="280"/>
                    </a:lnTo>
                    <a:lnTo>
                      <a:pt x="1748" y="280"/>
                    </a:lnTo>
                    <a:lnTo>
                      <a:pt x="1734" y="280"/>
                    </a:lnTo>
                    <a:lnTo>
                      <a:pt x="1721" y="280"/>
                    </a:lnTo>
                    <a:lnTo>
                      <a:pt x="1709" y="280"/>
                    </a:lnTo>
                    <a:lnTo>
                      <a:pt x="1696" y="280"/>
                    </a:lnTo>
                    <a:lnTo>
                      <a:pt x="1683" y="280"/>
                    </a:lnTo>
                    <a:lnTo>
                      <a:pt x="1671" y="280"/>
                    </a:lnTo>
                    <a:lnTo>
                      <a:pt x="1658" y="280"/>
                    </a:lnTo>
                    <a:lnTo>
                      <a:pt x="1644" y="280"/>
                    </a:lnTo>
                    <a:lnTo>
                      <a:pt x="1631" y="280"/>
                    </a:lnTo>
                    <a:lnTo>
                      <a:pt x="1619" y="280"/>
                    </a:lnTo>
                    <a:lnTo>
                      <a:pt x="1606" y="280"/>
                    </a:lnTo>
                    <a:lnTo>
                      <a:pt x="1592" y="280"/>
                    </a:lnTo>
                    <a:lnTo>
                      <a:pt x="1579" y="280"/>
                    </a:lnTo>
                    <a:lnTo>
                      <a:pt x="1567" y="280"/>
                    </a:lnTo>
                    <a:lnTo>
                      <a:pt x="1554" y="280"/>
                    </a:lnTo>
                    <a:lnTo>
                      <a:pt x="1540" y="280"/>
                    </a:lnTo>
                    <a:lnTo>
                      <a:pt x="1527" y="280"/>
                    </a:lnTo>
                    <a:lnTo>
                      <a:pt x="1515" y="280"/>
                    </a:lnTo>
                    <a:lnTo>
                      <a:pt x="1502" y="280"/>
                    </a:lnTo>
                    <a:lnTo>
                      <a:pt x="1489" y="280"/>
                    </a:lnTo>
                    <a:lnTo>
                      <a:pt x="1475" y="280"/>
                    </a:lnTo>
                    <a:lnTo>
                      <a:pt x="1464" y="280"/>
                    </a:lnTo>
                    <a:lnTo>
                      <a:pt x="1450" y="280"/>
                    </a:lnTo>
                    <a:lnTo>
                      <a:pt x="1437" y="280"/>
                    </a:lnTo>
                    <a:lnTo>
                      <a:pt x="1425" y="280"/>
                    </a:lnTo>
                    <a:lnTo>
                      <a:pt x="1412" y="280"/>
                    </a:lnTo>
                    <a:lnTo>
                      <a:pt x="1398" y="280"/>
                    </a:lnTo>
                    <a:lnTo>
                      <a:pt x="1385" y="280"/>
                    </a:lnTo>
                    <a:lnTo>
                      <a:pt x="1373" y="280"/>
                    </a:lnTo>
                    <a:lnTo>
                      <a:pt x="1360" y="280"/>
                    </a:lnTo>
                    <a:lnTo>
                      <a:pt x="1347" y="280"/>
                    </a:lnTo>
                    <a:lnTo>
                      <a:pt x="1333" y="280"/>
                    </a:lnTo>
                    <a:lnTo>
                      <a:pt x="1322" y="280"/>
                    </a:lnTo>
                    <a:lnTo>
                      <a:pt x="1308" y="280"/>
                    </a:lnTo>
                    <a:lnTo>
                      <a:pt x="1295" y="280"/>
                    </a:lnTo>
                    <a:lnTo>
                      <a:pt x="1281" y="280"/>
                    </a:lnTo>
                    <a:lnTo>
                      <a:pt x="1270" y="280"/>
                    </a:lnTo>
                    <a:lnTo>
                      <a:pt x="1256" y="280"/>
                    </a:lnTo>
                    <a:lnTo>
                      <a:pt x="1243" y="280"/>
                    </a:lnTo>
                    <a:lnTo>
                      <a:pt x="1229" y="280"/>
                    </a:lnTo>
                    <a:lnTo>
                      <a:pt x="1218" y="280"/>
                    </a:lnTo>
                    <a:lnTo>
                      <a:pt x="1204" y="280"/>
                    </a:lnTo>
                    <a:lnTo>
                      <a:pt x="1191" y="280"/>
                    </a:lnTo>
                    <a:lnTo>
                      <a:pt x="1178" y="280"/>
                    </a:lnTo>
                    <a:lnTo>
                      <a:pt x="1166" y="280"/>
                    </a:lnTo>
                    <a:lnTo>
                      <a:pt x="1153" y="280"/>
                    </a:lnTo>
                    <a:lnTo>
                      <a:pt x="1139" y="280"/>
                    </a:lnTo>
                    <a:lnTo>
                      <a:pt x="1128" y="280"/>
                    </a:lnTo>
                    <a:lnTo>
                      <a:pt x="1114" y="280"/>
                    </a:lnTo>
                    <a:lnTo>
                      <a:pt x="1101" y="280"/>
                    </a:lnTo>
                    <a:lnTo>
                      <a:pt x="1087" y="280"/>
                    </a:lnTo>
                    <a:lnTo>
                      <a:pt x="1076" y="280"/>
                    </a:lnTo>
                    <a:lnTo>
                      <a:pt x="1062" y="280"/>
                    </a:lnTo>
                    <a:lnTo>
                      <a:pt x="1049" y="280"/>
                    </a:lnTo>
                    <a:lnTo>
                      <a:pt x="1035" y="280"/>
                    </a:lnTo>
                    <a:lnTo>
                      <a:pt x="1024" y="280"/>
                    </a:lnTo>
                    <a:lnTo>
                      <a:pt x="1010" y="280"/>
                    </a:lnTo>
                    <a:lnTo>
                      <a:pt x="997" y="280"/>
                    </a:lnTo>
                    <a:lnTo>
                      <a:pt x="984" y="280"/>
                    </a:lnTo>
                    <a:lnTo>
                      <a:pt x="972" y="280"/>
                    </a:lnTo>
                    <a:lnTo>
                      <a:pt x="959" y="280"/>
                    </a:lnTo>
                    <a:lnTo>
                      <a:pt x="945" y="280"/>
                    </a:lnTo>
                    <a:lnTo>
                      <a:pt x="932" y="280"/>
                    </a:lnTo>
                    <a:lnTo>
                      <a:pt x="920" y="280"/>
                    </a:lnTo>
                    <a:lnTo>
                      <a:pt x="907" y="280"/>
                    </a:lnTo>
                    <a:lnTo>
                      <a:pt x="893" y="280"/>
                    </a:lnTo>
                    <a:lnTo>
                      <a:pt x="882" y="280"/>
                    </a:lnTo>
                    <a:lnTo>
                      <a:pt x="868" y="280"/>
                    </a:lnTo>
                    <a:lnTo>
                      <a:pt x="855" y="280"/>
                    </a:lnTo>
                    <a:lnTo>
                      <a:pt x="842" y="280"/>
                    </a:lnTo>
                    <a:lnTo>
                      <a:pt x="830" y="280"/>
                    </a:lnTo>
                    <a:lnTo>
                      <a:pt x="817" y="280"/>
                    </a:lnTo>
                    <a:lnTo>
                      <a:pt x="803" y="280"/>
                    </a:lnTo>
                    <a:lnTo>
                      <a:pt x="790" y="280"/>
                    </a:lnTo>
                    <a:lnTo>
                      <a:pt x="778" y="280"/>
                    </a:lnTo>
                    <a:lnTo>
                      <a:pt x="765" y="280"/>
                    </a:lnTo>
                    <a:lnTo>
                      <a:pt x="751" y="280"/>
                    </a:lnTo>
                    <a:lnTo>
                      <a:pt x="738" y="280"/>
                    </a:lnTo>
                    <a:lnTo>
                      <a:pt x="726" y="280"/>
                    </a:lnTo>
                    <a:lnTo>
                      <a:pt x="713" y="280"/>
                    </a:lnTo>
                    <a:lnTo>
                      <a:pt x="699" y="280"/>
                    </a:lnTo>
                    <a:lnTo>
                      <a:pt x="686" y="280"/>
                    </a:lnTo>
                    <a:lnTo>
                      <a:pt x="674" y="280"/>
                    </a:lnTo>
                    <a:lnTo>
                      <a:pt x="661" y="280"/>
                    </a:lnTo>
                    <a:lnTo>
                      <a:pt x="648" y="280"/>
                    </a:lnTo>
                    <a:lnTo>
                      <a:pt x="634" y="280"/>
                    </a:lnTo>
                    <a:lnTo>
                      <a:pt x="623" y="280"/>
                    </a:lnTo>
                    <a:lnTo>
                      <a:pt x="609" y="280"/>
                    </a:lnTo>
                    <a:lnTo>
                      <a:pt x="596" y="280"/>
                    </a:lnTo>
                    <a:lnTo>
                      <a:pt x="584" y="280"/>
                    </a:lnTo>
                    <a:lnTo>
                      <a:pt x="571" y="280"/>
                    </a:lnTo>
                    <a:lnTo>
                      <a:pt x="557" y="280"/>
                    </a:lnTo>
                    <a:lnTo>
                      <a:pt x="544" y="280"/>
                    </a:lnTo>
                    <a:lnTo>
                      <a:pt x="532" y="280"/>
                    </a:lnTo>
                    <a:lnTo>
                      <a:pt x="519" y="280"/>
                    </a:lnTo>
                    <a:lnTo>
                      <a:pt x="505" y="280"/>
                    </a:lnTo>
                    <a:lnTo>
                      <a:pt x="492" y="280"/>
                    </a:lnTo>
                    <a:lnTo>
                      <a:pt x="481" y="280"/>
                    </a:lnTo>
                    <a:lnTo>
                      <a:pt x="467" y="280"/>
                    </a:lnTo>
                    <a:lnTo>
                      <a:pt x="454" y="280"/>
                    </a:lnTo>
                    <a:lnTo>
                      <a:pt x="440" y="280"/>
                    </a:lnTo>
                    <a:lnTo>
                      <a:pt x="429" y="280"/>
                    </a:lnTo>
                    <a:lnTo>
                      <a:pt x="415" y="280"/>
                    </a:lnTo>
                    <a:lnTo>
                      <a:pt x="402" y="280"/>
                    </a:lnTo>
                    <a:lnTo>
                      <a:pt x="388" y="280"/>
                    </a:lnTo>
                    <a:lnTo>
                      <a:pt x="377" y="280"/>
                    </a:lnTo>
                    <a:lnTo>
                      <a:pt x="363" y="280"/>
                    </a:lnTo>
                    <a:lnTo>
                      <a:pt x="350" y="280"/>
                    </a:lnTo>
                    <a:lnTo>
                      <a:pt x="337" y="280"/>
                    </a:lnTo>
                    <a:lnTo>
                      <a:pt x="325" y="280"/>
                    </a:lnTo>
                    <a:lnTo>
                      <a:pt x="312" y="280"/>
                    </a:lnTo>
                    <a:lnTo>
                      <a:pt x="298" y="280"/>
                    </a:lnTo>
                    <a:lnTo>
                      <a:pt x="287" y="280"/>
                    </a:lnTo>
                    <a:lnTo>
                      <a:pt x="273" y="280"/>
                    </a:lnTo>
                    <a:lnTo>
                      <a:pt x="260" y="280"/>
                    </a:lnTo>
                    <a:lnTo>
                      <a:pt x="246" y="280"/>
                    </a:lnTo>
                    <a:lnTo>
                      <a:pt x="235" y="280"/>
                    </a:lnTo>
                    <a:lnTo>
                      <a:pt x="221" y="280"/>
                    </a:lnTo>
                    <a:lnTo>
                      <a:pt x="208" y="280"/>
                    </a:lnTo>
                    <a:lnTo>
                      <a:pt x="194" y="280"/>
                    </a:lnTo>
                    <a:lnTo>
                      <a:pt x="183" y="280"/>
                    </a:lnTo>
                    <a:lnTo>
                      <a:pt x="169" y="280"/>
                    </a:lnTo>
                    <a:lnTo>
                      <a:pt x="156" y="280"/>
                    </a:lnTo>
                    <a:lnTo>
                      <a:pt x="143" y="280"/>
                    </a:lnTo>
                    <a:lnTo>
                      <a:pt x="131" y="280"/>
                    </a:lnTo>
                    <a:lnTo>
                      <a:pt x="118" y="280"/>
                    </a:lnTo>
                    <a:lnTo>
                      <a:pt x="104" y="280"/>
                    </a:lnTo>
                    <a:lnTo>
                      <a:pt x="91" y="280"/>
                    </a:lnTo>
                    <a:lnTo>
                      <a:pt x="79" y="280"/>
                    </a:lnTo>
                    <a:lnTo>
                      <a:pt x="66" y="280"/>
                    </a:lnTo>
                    <a:lnTo>
                      <a:pt x="52" y="280"/>
                    </a:lnTo>
                    <a:lnTo>
                      <a:pt x="41" y="280"/>
                    </a:lnTo>
                    <a:lnTo>
                      <a:pt x="27" y="280"/>
                    </a:lnTo>
                    <a:lnTo>
                      <a:pt x="14" y="280"/>
                    </a:lnTo>
                    <a:lnTo>
                      <a:pt x="0" y="280"/>
                    </a:lnTo>
                    <a:lnTo>
                      <a:pt x="0" y="142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5" name="Freeform 44"/>
              <p:cNvSpPr>
                <a:spLocks/>
              </p:cNvSpPr>
              <p:nvPr/>
            </p:nvSpPr>
            <p:spPr bwMode="auto">
              <a:xfrm rot="5400000" flipV="1">
                <a:off x="495324" y="3198179"/>
                <a:ext cx="4435049" cy="182332"/>
              </a:xfrm>
              <a:custGeom>
                <a:avLst/>
                <a:gdLst>
                  <a:gd name="T0" fmla="*/ 162 w 5410"/>
                  <a:gd name="T1" fmla="*/ 223 h 273"/>
                  <a:gd name="T2" fmla="*/ 337 w 5410"/>
                  <a:gd name="T3" fmla="*/ 110 h 273"/>
                  <a:gd name="T4" fmla="*/ 511 w 5410"/>
                  <a:gd name="T5" fmla="*/ 122 h 273"/>
                  <a:gd name="T6" fmla="*/ 686 w 5410"/>
                  <a:gd name="T7" fmla="*/ 168 h 273"/>
                  <a:gd name="T8" fmla="*/ 861 w 5410"/>
                  <a:gd name="T9" fmla="*/ 66 h 273"/>
                  <a:gd name="T10" fmla="*/ 1035 w 5410"/>
                  <a:gd name="T11" fmla="*/ 77 h 273"/>
                  <a:gd name="T12" fmla="*/ 1210 w 5410"/>
                  <a:gd name="T13" fmla="*/ 89 h 273"/>
                  <a:gd name="T14" fmla="*/ 1387 w 5410"/>
                  <a:gd name="T15" fmla="*/ 98 h 273"/>
                  <a:gd name="T16" fmla="*/ 1562 w 5410"/>
                  <a:gd name="T17" fmla="*/ 106 h 273"/>
                  <a:gd name="T18" fmla="*/ 1736 w 5410"/>
                  <a:gd name="T19" fmla="*/ 191 h 273"/>
                  <a:gd name="T20" fmla="*/ 1911 w 5410"/>
                  <a:gd name="T21" fmla="*/ 250 h 273"/>
                  <a:gd name="T22" fmla="*/ 2086 w 5410"/>
                  <a:gd name="T23" fmla="*/ 273 h 273"/>
                  <a:gd name="T24" fmla="*/ 2260 w 5410"/>
                  <a:gd name="T25" fmla="*/ 260 h 273"/>
                  <a:gd name="T26" fmla="*/ 2435 w 5410"/>
                  <a:gd name="T27" fmla="*/ 264 h 273"/>
                  <a:gd name="T28" fmla="*/ 2610 w 5410"/>
                  <a:gd name="T29" fmla="*/ 258 h 273"/>
                  <a:gd name="T30" fmla="*/ 2785 w 5410"/>
                  <a:gd name="T31" fmla="*/ 256 h 273"/>
                  <a:gd name="T32" fmla="*/ 2959 w 5410"/>
                  <a:gd name="T33" fmla="*/ 196 h 273"/>
                  <a:gd name="T34" fmla="*/ 3136 w 5410"/>
                  <a:gd name="T35" fmla="*/ 214 h 273"/>
                  <a:gd name="T36" fmla="*/ 3311 w 5410"/>
                  <a:gd name="T37" fmla="*/ 216 h 273"/>
                  <a:gd name="T38" fmla="*/ 3486 w 5410"/>
                  <a:gd name="T39" fmla="*/ 108 h 273"/>
                  <a:gd name="T40" fmla="*/ 3660 w 5410"/>
                  <a:gd name="T41" fmla="*/ 143 h 273"/>
                  <a:gd name="T42" fmla="*/ 3835 w 5410"/>
                  <a:gd name="T43" fmla="*/ 154 h 273"/>
                  <a:gd name="T44" fmla="*/ 4010 w 5410"/>
                  <a:gd name="T45" fmla="*/ 110 h 273"/>
                  <a:gd name="T46" fmla="*/ 4184 w 5410"/>
                  <a:gd name="T47" fmla="*/ 102 h 273"/>
                  <a:gd name="T48" fmla="*/ 4359 w 5410"/>
                  <a:gd name="T49" fmla="*/ 131 h 273"/>
                  <a:gd name="T50" fmla="*/ 4534 w 5410"/>
                  <a:gd name="T51" fmla="*/ 85 h 273"/>
                  <a:gd name="T52" fmla="*/ 4711 w 5410"/>
                  <a:gd name="T53" fmla="*/ 112 h 273"/>
                  <a:gd name="T54" fmla="*/ 4885 w 5410"/>
                  <a:gd name="T55" fmla="*/ 41 h 273"/>
                  <a:gd name="T56" fmla="*/ 5060 w 5410"/>
                  <a:gd name="T57" fmla="*/ 147 h 273"/>
                  <a:gd name="T58" fmla="*/ 5235 w 5410"/>
                  <a:gd name="T59" fmla="*/ 60 h 273"/>
                  <a:gd name="T60" fmla="*/ 5410 w 5410"/>
                  <a:gd name="T61" fmla="*/ 221 h 273"/>
                  <a:gd name="T62" fmla="*/ 5248 w 5410"/>
                  <a:gd name="T63" fmla="*/ 273 h 273"/>
                  <a:gd name="T64" fmla="*/ 5073 w 5410"/>
                  <a:gd name="T65" fmla="*/ 273 h 273"/>
                  <a:gd name="T66" fmla="*/ 4899 w 5410"/>
                  <a:gd name="T67" fmla="*/ 273 h 273"/>
                  <a:gd name="T68" fmla="*/ 4724 w 5410"/>
                  <a:gd name="T69" fmla="*/ 273 h 273"/>
                  <a:gd name="T70" fmla="*/ 4549 w 5410"/>
                  <a:gd name="T71" fmla="*/ 273 h 273"/>
                  <a:gd name="T72" fmla="*/ 4375 w 5410"/>
                  <a:gd name="T73" fmla="*/ 273 h 273"/>
                  <a:gd name="T74" fmla="*/ 4200 w 5410"/>
                  <a:gd name="T75" fmla="*/ 273 h 273"/>
                  <a:gd name="T76" fmla="*/ 4025 w 5410"/>
                  <a:gd name="T77" fmla="*/ 273 h 273"/>
                  <a:gd name="T78" fmla="*/ 3850 w 5410"/>
                  <a:gd name="T79" fmla="*/ 273 h 273"/>
                  <a:gd name="T80" fmla="*/ 3674 w 5410"/>
                  <a:gd name="T81" fmla="*/ 273 h 273"/>
                  <a:gd name="T82" fmla="*/ 3499 w 5410"/>
                  <a:gd name="T83" fmla="*/ 273 h 273"/>
                  <a:gd name="T84" fmla="*/ 3324 w 5410"/>
                  <a:gd name="T85" fmla="*/ 273 h 273"/>
                  <a:gd name="T86" fmla="*/ 3150 w 5410"/>
                  <a:gd name="T87" fmla="*/ 273 h 273"/>
                  <a:gd name="T88" fmla="*/ 2975 w 5410"/>
                  <a:gd name="T89" fmla="*/ 273 h 273"/>
                  <a:gd name="T90" fmla="*/ 2800 w 5410"/>
                  <a:gd name="T91" fmla="*/ 273 h 273"/>
                  <a:gd name="T92" fmla="*/ 2625 w 5410"/>
                  <a:gd name="T93" fmla="*/ 273 h 273"/>
                  <a:gd name="T94" fmla="*/ 2451 w 5410"/>
                  <a:gd name="T95" fmla="*/ 273 h 273"/>
                  <a:gd name="T96" fmla="*/ 2276 w 5410"/>
                  <a:gd name="T97" fmla="*/ 273 h 273"/>
                  <a:gd name="T98" fmla="*/ 2101 w 5410"/>
                  <a:gd name="T99" fmla="*/ 273 h 273"/>
                  <a:gd name="T100" fmla="*/ 1924 w 5410"/>
                  <a:gd name="T101" fmla="*/ 273 h 273"/>
                  <a:gd name="T102" fmla="*/ 1750 w 5410"/>
                  <a:gd name="T103" fmla="*/ 273 h 273"/>
                  <a:gd name="T104" fmla="*/ 1575 w 5410"/>
                  <a:gd name="T105" fmla="*/ 273 h 273"/>
                  <a:gd name="T106" fmla="*/ 1400 w 5410"/>
                  <a:gd name="T107" fmla="*/ 273 h 273"/>
                  <a:gd name="T108" fmla="*/ 1226 w 5410"/>
                  <a:gd name="T109" fmla="*/ 273 h 273"/>
                  <a:gd name="T110" fmla="*/ 1051 w 5410"/>
                  <a:gd name="T111" fmla="*/ 273 h 273"/>
                  <a:gd name="T112" fmla="*/ 876 w 5410"/>
                  <a:gd name="T113" fmla="*/ 273 h 273"/>
                  <a:gd name="T114" fmla="*/ 701 w 5410"/>
                  <a:gd name="T115" fmla="*/ 273 h 273"/>
                  <a:gd name="T116" fmla="*/ 527 w 5410"/>
                  <a:gd name="T117" fmla="*/ 273 h 273"/>
                  <a:gd name="T118" fmla="*/ 350 w 5410"/>
                  <a:gd name="T119" fmla="*/ 273 h 273"/>
                  <a:gd name="T120" fmla="*/ 175 w 5410"/>
                  <a:gd name="T121" fmla="*/ 273 h 273"/>
                  <a:gd name="T122" fmla="*/ 0 w 5410"/>
                  <a:gd name="T123" fmla="*/ 273 h 2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</a:cxnLst>
                <a:rect l="0" t="0" r="r" b="b"/>
                <a:pathLst>
                  <a:path w="5410" h="273">
                    <a:moveTo>
                      <a:pt x="0" y="200"/>
                    </a:moveTo>
                    <a:lnTo>
                      <a:pt x="16" y="131"/>
                    </a:lnTo>
                    <a:lnTo>
                      <a:pt x="29" y="74"/>
                    </a:lnTo>
                    <a:lnTo>
                      <a:pt x="45" y="60"/>
                    </a:lnTo>
                    <a:lnTo>
                      <a:pt x="60" y="60"/>
                    </a:lnTo>
                    <a:lnTo>
                      <a:pt x="73" y="129"/>
                    </a:lnTo>
                    <a:lnTo>
                      <a:pt x="89" y="62"/>
                    </a:lnTo>
                    <a:lnTo>
                      <a:pt x="102" y="120"/>
                    </a:lnTo>
                    <a:lnTo>
                      <a:pt x="118" y="106"/>
                    </a:lnTo>
                    <a:lnTo>
                      <a:pt x="133" y="106"/>
                    </a:lnTo>
                    <a:lnTo>
                      <a:pt x="146" y="145"/>
                    </a:lnTo>
                    <a:lnTo>
                      <a:pt x="162" y="223"/>
                    </a:lnTo>
                    <a:lnTo>
                      <a:pt x="175" y="83"/>
                    </a:lnTo>
                    <a:lnTo>
                      <a:pt x="191" y="160"/>
                    </a:lnTo>
                    <a:lnTo>
                      <a:pt x="206" y="166"/>
                    </a:lnTo>
                    <a:lnTo>
                      <a:pt x="219" y="200"/>
                    </a:lnTo>
                    <a:lnTo>
                      <a:pt x="235" y="175"/>
                    </a:lnTo>
                    <a:lnTo>
                      <a:pt x="248" y="112"/>
                    </a:lnTo>
                    <a:lnTo>
                      <a:pt x="264" y="118"/>
                    </a:lnTo>
                    <a:lnTo>
                      <a:pt x="279" y="125"/>
                    </a:lnTo>
                    <a:lnTo>
                      <a:pt x="292" y="181"/>
                    </a:lnTo>
                    <a:lnTo>
                      <a:pt x="308" y="122"/>
                    </a:lnTo>
                    <a:lnTo>
                      <a:pt x="321" y="70"/>
                    </a:lnTo>
                    <a:lnTo>
                      <a:pt x="337" y="110"/>
                    </a:lnTo>
                    <a:lnTo>
                      <a:pt x="350" y="131"/>
                    </a:lnTo>
                    <a:lnTo>
                      <a:pt x="365" y="122"/>
                    </a:lnTo>
                    <a:lnTo>
                      <a:pt x="381" y="75"/>
                    </a:lnTo>
                    <a:lnTo>
                      <a:pt x="394" y="64"/>
                    </a:lnTo>
                    <a:lnTo>
                      <a:pt x="409" y="83"/>
                    </a:lnTo>
                    <a:lnTo>
                      <a:pt x="423" y="110"/>
                    </a:lnTo>
                    <a:lnTo>
                      <a:pt x="438" y="147"/>
                    </a:lnTo>
                    <a:lnTo>
                      <a:pt x="454" y="60"/>
                    </a:lnTo>
                    <a:lnTo>
                      <a:pt x="467" y="41"/>
                    </a:lnTo>
                    <a:lnTo>
                      <a:pt x="482" y="127"/>
                    </a:lnTo>
                    <a:lnTo>
                      <a:pt x="496" y="102"/>
                    </a:lnTo>
                    <a:lnTo>
                      <a:pt x="511" y="122"/>
                    </a:lnTo>
                    <a:lnTo>
                      <a:pt x="527" y="43"/>
                    </a:lnTo>
                    <a:lnTo>
                      <a:pt x="540" y="108"/>
                    </a:lnTo>
                    <a:lnTo>
                      <a:pt x="555" y="4"/>
                    </a:lnTo>
                    <a:lnTo>
                      <a:pt x="569" y="54"/>
                    </a:lnTo>
                    <a:lnTo>
                      <a:pt x="584" y="14"/>
                    </a:lnTo>
                    <a:lnTo>
                      <a:pt x="600" y="39"/>
                    </a:lnTo>
                    <a:lnTo>
                      <a:pt x="613" y="47"/>
                    </a:lnTo>
                    <a:lnTo>
                      <a:pt x="628" y="74"/>
                    </a:lnTo>
                    <a:lnTo>
                      <a:pt x="642" y="114"/>
                    </a:lnTo>
                    <a:lnTo>
                      <a:pt x="657" y="64"/>
                    </a:lnTo>
                    <a:lnTo>
                      <a:pt x="673" y="91"/>
                    </a:lnTo>
                    <a:lnTo>
                      <a:pt x="686" y="168"/>
                    </a:lnTo>
                    <a:lnTo>
                      <a:pt x="701" y="75"/>
                    </a:lnTo>
                    <a:lnTo>
                      <a:pt x="715" y="104"/>
                    </a:lnTo>
                    <a:lnTo>
                      <a:pt x="730" y="49"/>
                    </a:lnTo>
                    <a:lnTo>
                      <a:pt x="744" y="41"/>
                    </a:lnTo>
                    <a:lnTo>
                      <a:pt x="759" y="168"/>
                    </a:lnTo>
                    <a:lnTo>
                      <a:pt x="774" y="100"/>
                    </a:lnTo>
                    <a:lnTo>
                      <a:pt x="788" y="102"/>
                    </a:lnTo>
                    <a:lnTo>
                      <a:pt x="803" y="133"/>
                    </a:lnTo>
                    <a:lnTo>
                      <a:pt x="817" y="104"/>
                    </a:lnTo>
                    <a:lnTo>
                      <a:pt x="832" y="74"/>
                    </a:lnTo>
                    <a:lnTo>
                      <a:pt x="847" y="179"/>
                    </a:lnTo>
                    <a:lnTo>
                      <a:pt x="861" y="66"/>
                    </a:lnTo>
                    <a:lnTo>
                      <a:pt x="876" y="22"/>
                    </a:lnTo>
                    <a:lnTo>
                      <a:pt x="890" y="125"/>
                    </a:lnTo>
                    <a:lnTo>
                      <a:pt x="905" y="18"/>
                    </a:lnTo>
                    <a:lnTo>
                      <a:pt x="920" y="102"/>
                    </a:lnTo>
                    <a:lnTo>
                      <a:pt x="934" y="160"/>
                    </a:lnTo>
                    <a:lnTo>
                      <a:pt x="949" y="77"/>
                    </a:lnTo>
                    <a:lnTo>
                      <a:pt x="962" y="22"/>
                    </a:lnTo>
                    <a:lnTo>
                      <a:pt x="978" y="70"/>
                    </a:lnTo>
                    <a:lnTo>
                      <a:pt x="993" y="47"/>
                    </a:lnTo>
                    <a:lnTo>
                      <a:pt x="1007" y="62"/>
                    </a:lnTo>
                    <a:lnTo>
                      <a:pt x="1022" y="35"/>
                    </a:lnTo>
                    <a:lnTo>
                      <a:pt x="1035" y="77"/>
                    </a:lnTo>
                    <a:lnTo>
                      <a:pt x="1051" y="56"/>
                    </a:lnTo>
                    <a:lnTo>
                      <a:pt x="1066" y="131"/>
                    </a:lnTo>
                    <a:lnTo>
                      <a:pt x="1080" y="118"/>
                    </a:lnTo>
                    <a:lnTo>
                      <a:pt x="1095" y="116"/>
                    </a:lnTo>
                    <a:lnTo>
                      <a:pt x="1108" y="31"/>
                    </a:lnTo>
                    <a:lnTo>
                      <a:pt x="1124" y="20"/>
                    </a:lnTo>
                    <a:lnTo>
                      <a:pt x="1137" y="87"/>
                    </a:lnTo>
                    <a:lnTo>
                      <a:pt x="1153" y="50"/>
                    </a:lnTo>
                    <a:lnTo>
                      <a:pt x="1168" y="152"/>
                    </a:lnTo>
                    <a:lnTo>
                      <a:pt x="1181" y="102"/>
                    </a:lnTo>
                    <a:lnTo>
                      <a:pt x="1197" y="104"/>
                    </a:lnTo>
                    <a:lnTo>
                      <a:pt x="1210" y="89"/>
                    </a:lnTo>
                    <a:lnTo>
                      <a:pt x="1226" y="70"/>
                    </a:lnTo>
                    <a:lnTo>
                      <a:pt x="1241" y="112"/>
                    </a:lnTo>
                    <a:lnTo>
                      <a:pt x="1254" y="137"/>
                    </a:lnTo>
                    <a:lnTo>
                      <a:pt x="1270" y="270"/>
                    </a:lnTo>
                    <a:lnTo>
                      <a:pt x="1283" y="273"/>
                    </a:lnTo>
                    <a:lnTo>
                      <a:pt x="1299" y="233"/>
                    </a:lnTo>
                    <a:lnTo>
                      <a:pt x="1314" y="271"/>
                    </a:lnTo>
                    <a:lnTo>
                      <a:pt x="1327" y="187"/>
                    </a:lnTo>
                    <a:lnTo>
                      <a:pt x="1343" y="91"/>
                    </a:lnTo>
                    <a:lnTo>
                      <a:pt x="1356" y="106"/>
                    </a:lnTo>
                    <a:lnTo>
                      <a:pt x="1371" y="106"/>
                    </a:lnTo>
                    <a:lnTo>
                      <a:pt x="1387" y="98"/>
                    </a:lnTo>
                    <a:lnTo>
                      <a:pt x="1400" y="81"/>
                    </a:lnTo>
                    <a:lnTo>
                      <a:pt x="1416" y="77"/>
                    </a:lnTo>
                    <a:lnTo>
                      <a:pt x="1429" y="102"/>
                    </a:lnTo>
                    <a:lnTo>
                      <a:pt x="1444" y="100"/>
                    </a:lnTo>
                    <a:lnTo>
                      <a:pt x="1458" y="79"/>
                    </a:lnTo>
                    <a:lnTo>
                      <a:pt x="1473" y="139"/>
                    </a:lnTo>
                    <a:lnTo>
                      <a:pt x="1489" y="125"/>
                    </a:lnTo>
                    <a:lnTo>
                      <a:pt x="1502" y="227"/>
                    </a:lnTo>
                    <a:lnTo>
                      <a:pt x="1517" y="175"/>
                    </a:lnTo>
                    <a:lnTo>
                      <a:pt x="1531" y="135"/>
                    </a:lnTo>
                    <a:lnTo>
                      <a:pt x="1546" y="208"/>
                    </a:lnTo>
                    <a:lnTo>
                      <a:pt x="1562" y="106"/>
                    </a:lnTo>
                    <a:lnTo>
                      <a:pt x="1575" y="164"/>
                    </a:lnTo>
                    <a:lnTo>
                      <a:pt x="1590" y="189"/>
                    </a:lnTo>
                    <a:lnTo>
                      <a:pt x="1604" y="172"/>
                    </a:lnTo>
                    <a:lnTo>
                      <a:pt x="1619" y="129"/>
                    </a:lnTo>
                    <a:lnTo>
                      <a:pt x="1635" y="191"/>
                    </a:lnTo>
                    <a:lnTo>
                      <a:pt x="1648" y="131"/>
                    </a:lnTo>
                    <a:lnTo>
                      <a:pt x="1663" y="98"/>
                    </a:lnTo>
                    <a:lnTo>
                      <a:pt x="1677" y="116"/>
                    </a:lnTo>
                    <a:lnTo>
                      <a:pt x="1692" y="77"/>
                    </a:lnTo>
                    <a:lnTo>
                      <a:pt x="1707" y="145"/>
                    </a:lnTo>
                    <a:lnTo>
                      <a:pt x="1721" y="202"/>
                    </a:lnTo>
                    <a:lnTo>
                      <a:pt x="1736" y="191"/>
                    </a:lnTo>
                    <a:lnTo>
                      <a:pt x="1750" y="239"/>
                    </a:lnTo>
                    <a:lnTo>
                      <a:pt x="1765" y="273"/>
                    </a:lnTo>
                    <a:lnTo>
                      <a:pt x="1780" y="273"/>
                    </a:lnTo>
                    <a:lnTo>
                      <a:pt x="1794" y="273"/>
                    </a:lnTo>
                    <a:lnTo>
                      <a:pt x="1809" y="273"/>
                    </a:lnTo>
                    <a:lnTo>
                      <a:pt x="1823" y="273"/>
                    </a:lnTo>
                    <a:lnTo>
                      <a:pt x="1838" y="273"/>
                    </a:lnTo>
                    <a:lnTo>
                      <a:pt x="1852" y="273"/>
                    </a:lnTo>
                    <a:lnTo>
                      <a:pt x="1867" y="273"/>
                    </a:lnTo>
                    <a:lnTo>
                      <a:pt x="1882" y="273"/>
                    </a:lnTo>
                    <a:lnTo>
                      <a:pt x="1896" y="273"/>
                    </a:lnTo>
                    <a:lnTo>
                      <a:pt x="1911" y="250"/>
                    </a:lnTo>
                    <a:lnTo>
                      <a:pt x="1924" y="273"/>
                    </a:lnTo>
                    <a:lnTo>
                      <a:pt x="1940" y="273"/>
                    </a:lnTo>
                    <a:lnTo>
                      <a:pt x="1955" y="268"/>
                    </a:lnTo>
                    <a:lnTo>
                      <a:pt x="1969" y="273"/>
                    </a:lnTo>
                    <a:lnTo>
                      <a:pt x="1984" y="271"/>
                    </a:lnTo>
                    <a:lnTo>
                      <a:pt x="1997" y="271"/>
                    </a:lnTo>
                    <a:lnTo>
                      <a:pt x="2013" y="273"/>
                    </a:lnTo>
                    <a:lnTo>
                      <a:pt x="2028" y="273"/>
                    </a:lnTo>
                    <a:lnTo>
                      <a:pt x="2042" y="273"/>
                    </a:lnTo>
                    <a:lnTo>
                      <a:pt x="2057" y="273"/>
                    </a:lnTo>
                    <a:lnTo>
                      <a:pt x="2070" y="273"/>
                    </a:lnTo>
                    <a:lnTo>
                      <a:pt x="2086" y="273"/>
                    </a:lnTo>
                    <a:lnTo>
                      <a:pt x="2101" y="256"/>
                    </a:lnTo>
                    <a:lnTo>
                      <a:pt x="2115" y="195"/>
                    </a:lnTo>
                    <a:lnTo>
                      <a:pt x="2130" y="114"/>
                    </a:lnTo>
                    <a:lnTo>
                      <a:pt x="2143" y="198"/>
                    </a:lnTo>
                    <a:lnTo>
                      <a:pt x="2159" y="177"/>
                    </a:lnTo>
                    <a:lnTo>
                      <a:pt x="2174" y="196"/>
                    </a:lnTo>
                    <a:lnTo>
                      <a:pt x="2188" y="233"/>
                    </a:lnTo>
                    <a:lnTo>
                      <a:pt x="2203" y="195"/>
                    </a:lnTo>
                    <a:lnTo>
                      <a:pt x="2216" y="206"/>
                    </a:lnTo>
                    <a:lnTo>
                      <a:pt x="2232" y="258"/>
                    </a:lnTo>
                    <a:lnTo>
                      <a:pt x="2245" y="245"/>
                    </a:lnTo>
                    <a:lnTo>
                      <a:pt x="2260" y="260"/>
                    </a:lnTo>
                    <a:lnTo>
                      <a:pt x="2276" y="214"/>
                    </a:lnTo>
                    <a:lnTo>
                      <a:pt x="2289" y="260"/>
                    </a:lnTo>
                    <a:lnTo>
                      <a:pt x="2305" y="266"/>
                    </a:lnTo>
                    <a:lnTo>
                      <a:pt x="2318" y="147"/>
                    </a:lnTo>
                    <a:lnTo>
                      <a:pt x="2333" y="223"/>
                    </a:lnTo>
                    <a:lnTo>
                      <a:pt x="2349" y="239"/>
                    </a:lnTo>
                    <a:lnTo>
                      <a:pt x="2362" y="262"/>
                    </a:lnTo>
                    <a:lnTo>
                      <a:pt x="2378" y="248"/>
                    </a:lnTo>
                    <a:lnTo>
                      <a:pt x="2391" y="179"/>
                    </a:lnTo>
                    <a:lnTo>
                      <a:pt x="2406" y="87"/>
                    </a:lnTo>
                    <a:lnTo>
                      <a:pt x="2422" y="191"/>
                    </a:lnTo>
                    <a:lnTo>
                      <a:pt x="2435" y="264"/>
                    </a:lnTo>
                    <a:lnTo>
                      <a:pt x="2451" y="202"/>
                    </a:lnTo>
                    <a:lnTo>
                      <a:pt x="2464" y="225"/>
                    </a:lnTo>
                    <a:lnTo>
                      <a:pt x="2479" y="273"/>
                    </a:lnTo>
                    <a:lnTo>
                      <a:pt x="2495" y="254"/>
                    </a:lnTo>
                    <a:lnTo>
                      <a:pt x="2508" y="127"/>
                    </a:lnTo>
                    <a:lnTo>
                      <a:pt x="2524" y="212"/>
                    </a:lnTo>
                    <a:lnTo>
                      <a:pt x="2537" y="250"/>
                    </a:lnTo>
                    <a:lnTo>
                      <a:pt x="2552" y="170"/>
                    </a:lnTo>
                    <a:lnTo>
                      <a:pt x="2566" y="172"/>
                    </a:lnTo>
                    <a:lnTo>
                      <a:pt x="2581" y="266"/>
                    </a:lnTo>
                    <a:lnTo>
                      <a:pt x="2597" y="204"/>
                    </a:lnTo>
                    <a:lnTo>
                      <a:pt x="2610" y="258"/>
                    </a:lnTo>
                    <a:lnTo>
                      <a:pt x="2625" y="220"/>
                    </a:lnTo>
                    <a:lnTo>
                      <a:pt x="2639" y="245"/>
                    </a:lnTo>
                    <a:lnTo>
                      <a:pt x="2654" y="266"/>
                    </a:lnTo>
                    <a:lnTo>
                      <a:pt x="2669" y="260"/>
                    </a:lnTo>
                    <a:lnTo>
                      <a:pt x="2683" y="231"/>
                    </a:lnTo>
                    <a:lnTo>
                      <a:pt x="2698" y="239"/>
                    </a:lnTo>
                    <a:lnTo>
                      <a:pt x="2712" y="239"/>
                    </a:lnTo>
                    <a:lnTo>
                      <a:pt x="2727" y="208"/>
                    </a:lnTo>
                    <a:lnTo>
                      <a:pt x="2742" y="237"/>
                    </a:lnTo>
                    <a:lnTo>
                      <a:pt x="2756" y="175"/>
                    </a:lnTo>
                    <a:lnTo>
                      <a:pt x="2771" y="271"/>
                    </a:lnTo>
                    <a:lnTo>
                      <a:pt x="2785" y="256"/>
                    </a:lnTo>
                    <a:lnTo>
                      <a:pt x="2800" y="156"/>
                    </a:lnTo>
                    <a:lnTo>
                      <a:pt x="2815" y="202"/>
                    </a:lnTo>
                    <a:lnTo>
                      <a:pt x="2829" y="254"/>
                    </a:lnTo>
                    <a:lnTo>
                      <a:pt x="2844" y="233"/>
                    </a:lnTo>
                    <a:lnTo>
                      <a:pt x="2858" y="196"/>
                    </a:lnTo>
                    <a:lnTo>
                      <a:pt x="2873" y="225"/>
                    </a:lnTo>
                    <a:lnTo>
                      <a:pt x="2888" y="218"/>
                    </a:lnTo>
                    <a:lnTo>
                      <a:pt x="2902" y="216"/>
                    </a:lnTo>
                    <a:lnTo>
                      <a:pt x="2917" y="237"/>
                    </a:lnTo>
                    <a:lnTo>
                      <a:pt x="2931" y="212"/>
                    </a:lnTo>
                    <a:lnTo>
                      <a:pt x="2946" y="210"/>
                    </a:lnTo>
                    <a:lnTo>
                      <a:pt x="2959" y="196"/>
                    </a:lnTo>
                    <a:lnTo>
                      <a:pt x="2975" y="252"/>
                    </a:lnTo>
                    <a:lnTo>
                      <a:pt x="2990" y="248"/>
                    </a:lnTo>
                    <a:lnTo>
                      <a:pt x="3004" y="154"/>
                    </a:lnTo>
                    <a:lnTo>
                      <a:pt x="3019" y="250"/>
                    </a:lnTo>
                    <a:lnTo>
                      <a:pt x="3032" y="145"/>
                    </a:lnTo>
                    <a:lnTo>
                      <a:pt x="3048" y="191"/>
                    </a:lnTo>
                    <a:lnTo>
                      <a:pt x="3063" y="246"/>
                    </a:lnTo>
                    <a:lnTo>
                      <a:pt x="3077" y="250"/>
                    </a:lnTo>
                    <a:lnTo>
                      <a:pt x="3092" y="198"/>
                    </a:lnTo>
                    <a:lnTo>
                      <a:pt x="3105" y="233"/>
                    </a:lnTo>
                    <a:lnTo>
                      <a:pt x="3121" y="143"/>
                    </a:lnTo>
                    <a:lnTo>
                      <a:pt x="3136" y="214"/>
                    </a:lnTo>
                    <a:lnTo>
                      <a:pt x="3150" y="227"/>
                    </a:lnTo>
                    <a:lnTo>
                      <a:pt x="3165" y="189"/>
                    </a:lnTo>
                    <a:lnTo>
                      <a:pt x="3178" y="204"/>
                    </a:lnTo>
                    <a:lnTo>
                      <a:pt x="3194" y="179"/>
                    </a:lnTo>
                    <a:lnTo>
                      <a:pt x="3209" y="168"/>
                    </a:lnTo>
                    <a:lnTo>
                      <a:pt x="3222" y="208"/>
                    </a:lnTo>
                    <a:lnTo>
                      <a:pt x="3238" y="168"/>
                    </a:lnTo>
                    <a:lnTo>
                      <a:pt x="3251" y="237"/>
                    </a:lnTo>
                    <a:lnTo>
                      <a:pt x="3267" y="216"/>
                    </a:lnTo>
                    <a:lnTo>
                      <a:pt x="3282" y="210"/>
                    </a:lnTo>
                    <a:lnTo>
                      <a:pt x="3295" y="175"/>
                    </a:lnTo>
                    <a:lnTo>
                      <a:pt x="3311" y="216"/>
                    </a:lnTo>
                    <a:lnTo>
                      <a:pt x="3324" y="68"/>
                    </a:lnTo>
                    <a:lnTo>
                      <a:pt x="3340" y="189"/>
                    </a:lnTo>
                    <a:lnTo>
                      <a:pt x="3353" y="202"/>
                    </a:lnTo>
                    <a:lnTo>
                      <a:pt x="3368" y="89"/>
                    </a:lnTo>
                    <a:lnTo>
                      <a:pt x="3384" y="39"/>
                    </a:lnTo>
                    <a:lnTo>
                      <a:pt x="3397" y="200"/>
                    </a:lnTo>
                    <a:lnTo>
                      <a:pt x="3413" y="172"/>
                    </a:lnTo>
                    <a:lnTo>
                      <a:pt x="3426" y="106"/>
                    </a:lnTo>
                    <a:lnTo>
                      <a:pt x="3441" y="102"/>
                    </a:lnTo>
                    <a:lnTo>
                      <a:pt x="3457" y="100"/>
                    </a:lnTo>
                    <a:lnTo>
                      <a:pt x="3470" y="98"/>
                    </a:lnTo>
                    <a:lnTo>
                      <a:pt x="3486" y="108"/>
                    </a:lnTo>
                    <a:lnTo>
                      <a:pt x="3499" y="97"/>
                    </a:lnTo>
                    <a:lnTo>
                      <a:pt x="3514" y="110"/>
                    </a:lnTo>
                    <a:lnTo>
                      <a:pt x="3530" y="66"/>
                    </a:lnTo>
                    <a:lnTo>
                      <a:pt x="3543" y="114"/>
                    </a:lnTo>
                    <a:lnTo>
                      <a:pt x="3558" y="181"/>
                    </a:lnTo>
                    <a:lnTo>
                      <a:pt x="3572" y="177"/>
                    </a:lnTo>
                    <a:lnTo>
                      <a:pt x="3587" y="160"/>
                    </a:lnTo>
                    <a:lnTo>
                      <a:pt x="3603" y="52"/>
                    </a:lnTo>
                    <a:lnTo>
                      <a:pt x="3616" y="87"/>
                    </a:lnTo>
                    <a:lnTo>
                      <a:pt x="3631" y="122"/>
                    </a:lnTo>
                    <a:lnTo>
                      <a:pt x="3645" y="135"/>
                    </a:lnTo>
                    <a:lnTo>
                      <a:pt x="3660" y="143"/>
                    </a:lnTo>
                    <a:lnTo>
                      <a:pt x="3674" y="148"/>
                    </a:lnTo>
                    <a:lnTo>
                      <a:pt x="3689" y="27"/>
                    </a:lnTo>
                    <a:lnTo>
                      <a:pt x="3704" y="173"/>
                    </a:lnTo>
                    <a:lnTo>
                      <a:pt x="3718" y="150"/>
                    </a:lnTo>
                    <a:lnTo>
                      <a:pt x="3733" y="162"/>
                    </a:lnTo>
                    <a:lnTo>
                      <a:pt x="3747" y="210"/>
                    </a:lnTo>
                    <a:lnTo>
                      <a:pt x="3762" y="145"/>
                    </a:lnTo>
                    <a:lnTo>
                      <a:pt x="3777" y="77"/>
                    </a:lnTo>
                    <a:lnTo>
                      <a:pt x="3791" y="85"/>
                    </a:lnTo>
                    <a:lnTo>
                      <a:pt x="3806" y="93"/>
                    </a:lnTo>
                    <a:lnTo>
                      <a:pt x="3820" y="166"/>
                    </a:lnTo>
                    <a:lnTo>
                      <a:pt x="3835" y="154"/>
                    </a:lnTo>
                    <a:lnTo>
                      <a:pt x="3850" y="118"/>
                    </a:lnTo>
                    <a:lnTo>
                      <a:pt x="3864" y="75"/>
                    </a:lnTo>
                    <a:lnTo>
                      <a:pt x="3879" y="43"/>
                    </a:lnTo>
                    <a:lnTo>
                      <a:pt x="3893" y="129"/>
                    </a:lnTo>
                    <a:lnTo>
                      <a:pt x="3908" y="77"/>
                    </a:lnTo>
                    <a:lnTo>
                      <a:pt x="3923" y="64"/>
                    </a:lnTo>
                    <a:lnTo>
                      <a:pt x="3937" y="79"/>
                    </a:lnTo>
                    <a:lnTo>
                      <a:pt x="3952" y="147"/>
                    </a:lnTo>
                    <a:lnTo>
                      <a:pt x="3966" y="102"/>
                    </a:lnTo>
                    <a:lnTo>
                      <a:pt x="3981" y="56"/>
                    </a:lnTo>
                    <a:lnTo>
                      <a:pt x="3996" y="56"/>
                    </a:lnTo>
                    <a:lnTo>
                      <a:pt x="4010" y="110"/>
                    </a:lnTo>
                    <a:lnTo>
                      <a:pt x="4025" y="72"/>
                    </a:lnTo>
                    <a:lnTo>
                      <a:pt x="4039" y="49"/>
                    </a:lnTo>
                    <a:lnTo>
                      <a:pt x="4054" y="79"/>
                    </a:lnTo>
                    <a:lnTo>
                      <a:pt x="4067" y="147"/>
                    </a:lnTo>
                    <a:lnTo>
                      <a:pt x="4083" y="45"/>
                    </a:lnTo>
                    <a:lnTo>
                      <a:pt x="4098" y="112"/>
                    </a:lnTo>
                    <a:lnTo>
                      <a:pt x="4111" y="120"/>
                    </a:lnTo>
                    <a:lnTo>
                      <a:pt x="4127" y="154"/>
                    </a:lnTo>
                    <a:lnTo>
                      <a:pt x="4140" y="77"/>
                    </a:lnTo>
                    <a:lnTo>
                      <a:pt x="4156" y="116"/>
                    </a:lnTo>
                    <a:lnTo>
                      <a:pt x="4171" y="172"/>
                    </a:lnTo>
                    <a:lnTo>
                      <a:pt x="4184" y="102"/>
                    </a:lnTo>
                    <a:lnTo>
                      <a:pt x="4200" y="54"/>
                    </a:lnTo>
                    <a:lnTo>
                      <a:pt x="4213" y="85"/>
                    </a:lnTo>
                    <a:lnTo>
                      <a:pt x="4229" y="60"/>
                    </a:lnTo>
                    <a:lnTo>
                      <a:pt x="4244" y="56"/>
                    </a:lnTo>
                    <a:lnTo>
                      <a:pt x="4257" y="104"/>
                    </a:lnTo>
                    <a:lnTo>
                      <a:pt x="4273" y="145"/>
                    </a:lnTo>
                    <a:lnTo>
                      <a:pt x="4286" y="60"/>
                    </a:lnTo>
                    <a:lnTo>
                      <a:pt x="4302" y="158"/>
                    </a:lnTo>
                    <a:lnTo>
                      <a:pt x="4317" y="74"/>
                    </a:lnTo>
                    <a:lnTo>
                      <a:pt x="4330" y="50"/>
                    </a:lnTo>
                    <a:lnTo>
                      <a:pt x="4346" y="79"/>
                    </a:lnTo>
                    <a:lnTo>
                      <a:pt x="4359" y="131"/>
                    </a:lnTo>
                    <a:lnTo>
                      <a:pt x="4375" y="74"/>
                    </a:lnTo>
                    <a:lnTo>
                      <a:pt x="4390" y="91"/>
                    </a:lnTo>
                    <a:lnTo>
                      <a:pt x="4403" y="43"/>
                    </a:lnTo>
                    <a:lnTo>
                      <a:pt x="4419" y="14"/>
                    </a:lnTo>
                    <a:lnTo>
                      <a:pt x="4432" y="150"/>
                    </a:lnTo>
                    <a:lnTo>
                      <a:pt x="4448" y="123"/>
                    </a:lnTo>
                    <a:lnTo>
                      <a:pt x="4461" y="95"/>
                    </a:lnTo>
                    <a:lnTo>
                      <a:pt x="4476" y="35"/>
                    </a:lnTo>
                    <a:lnTo>
                      <a:pt x="4492" y="77"/>
                    </a:lnTo>
                    <a:lnTo>
                      <a:pt x="4505" y="68"/>
                    </a:lnTo>
                    <a:lnTo>
                      <a:pt x="4520" y="112"/>
                    </a:lnTo>
                    <a:lnTo>
                      <a:pt x="4534" y="85"/>
                    </a:lnTo>
                    <a:lnTo>
                      <a:pt x="4549" y="110"/>
                    </a:lnTo>
                    <a:lnTo>
                      <a:pt x="4565" y="104"/>
                    </a:lnTo>
                    <a:lnTo>
                      <a:pt x="4578" y="56"/>
                    </a:lnTo>
                    <a:lnTo>
                      <a:pt x="4593" y="133"/>
                    </a:lnTo>
                    <a:lnTo>
                      <a:pt x="4607" y="77"/>
                    </a:lnTo>
                    <a:lnTo>
                      <a:pt x="4622" y="39"/>
                    </a:lnTo>
                    <a:lnTo>
                      <a:pt x="4638" y="97"/>
                    </a:lnTo>
                    <a:lnTo>
                      <a:pt x="4651" y="62"/>
                    </a:lnTo>
                    <a:lnTo>
                      <a:pt x="4666" y="66"/>
                    </a:lnTo>
                    <a:lnTo>
                      <a:pt x="4680" y="24"/>
                    </a:lnTo>
                    <a:lnTo>
                      <a:pt x="4695" y="77"/>
                    </a:lnTo>
                    <a:lnTo>
                      <a:pt x="4711" y="112"/>
                    </a:lnTo>
                    <a:lnTo>
                      <a:pt x="4724" y="120"/>
                    </a:lnTo>
                    <a:lnTo>
                      <a:pt x="4739" y="225"/>
                    </a:lnTo>
                    <a:lnTo>
                      <a:pt x="4753" y="139"/>
                    </a:lnTo>
                    <a:lnTo>
                      <a:pt x="4768" y="60"/>
                    </a:lnTo>
                    <a:lnTo>
                      <a:pt x="4782" y="60"/>
                    </a:lnTo>
                    <a:lnTo>
                      <a:pt x="4797" y="108"/>
                    </a:lnTo>
                    <a:lnTo>
                      <a:pt x="4812" y="110"/>
                    </a:lnTo>
                    <a:lnTo>
                      <a:pt x="4826" y="91"/>
                    </a:lnTo>
                    <a:lnTo>
                      <a:pt x="4841" y="62"/>
                    </a:lnTo>
                    <a:lnTo>
                      <a:pt x="4855" y="47"/>
                    </a:lnTo>
                    <a:lnTo>
                      <a:pt x="4870" y="0"/>
                    </a:lnTo>
                    <a:lnTo>
                      <a:pt x="4885" y="41"/>
                    </a:lnTo>
                    <a:lnTo>
                      <a:pt x="4899" y="131"/>
                    </a:lnTo>
                    <a:lnTo>
                      <a:pt x="4914" y="22"/>
                    </a:lnTo>
                    <a:lnTo>
                      <a:pt x="4928" y="75"/>
                    </a:lnTo>
                    <a:lnTo>
                      <a:pt x="4943" y="89"/>
                    </a:lnTo>
                    <a:lnTo>
                      <a:pt x="4958" y="47"/>
                    </a:lnTo>
                    <a:lnTo>
                      <a:pt x="4972" y="54"/>
                    </a:lnTo>
                    <a:lnTo>
                      <a:pt x="4987" y="27"/>
                    </a:lnTo>
                    <a:lnTo>
                      <a:pt x="5001" y="97"/>
                    </a:lnTo>
                    <a:lnTo>
                      <a:pt x="5016" y="49"/>
                    </a:lnTo>
                    <a:lnTo>
                      <a:pt x="5031" y="2"/>
                    </a:lnTo>
                    <a:lnTo>
                      <a:pt x="5045" y="112"/>
                    </a:lnTo>
                    <a:lnTo>
                      <a:pt x="5060" y="147"/>
                    </a:lnTo>
                    <a:lnTo>
                      <a:pt x="5073" y="104"/>
                    </a:lnTo>
                    <a:lnTo>
                      <a:pt x="5089" y="60"/>
                    </a:lnTo>
                    <a:lnTo>
                      <a:pt x="5104" y="129"/>
                    </a:lnTo>
                    <a:lnTo>
                      <a:pt x="5118" y="47"/>
                    </a:lnTo>
                    <a:lnTo>
                      <a:pt x="5133" y="81"/>
                    </a:lnTo>
                    <a:lnTo>
                      <a:pt x="5146" y="102"/>
                    </a:lnTo>
                    <a:lnTo>
                      <a:pt x="5162" y="114"/>
                    </a:lnTo>
                    <a:lnTo>
                      <a:pt x="5175" y="122"/>
                    </a:lnTo>
                    <a:lnTo>
                      <a:pt x="5191" y="18"/>
                    </a:lnTo>
                    <a:lnTo>
                      <a:pt x="5206" y="147"/>
                    </a:lnTo>
                    <a:lnTo>
                      <a:pt x="5219" y="49"/>
                    </a:lnTo>
                    <a:lnTo>
                      <a:pt x="5235" y="60"/>
                    </a:lnTo>
                    <a:lnTo>
                      <a:pt x="5248" y="104"/>
                    </a:lnTo>
                    <a:lnTo>
                      <a:pt x="5264" y="106"/>
                    </a:lnTo>
                    <a:lnTo>
                      <a:pt x="5279" y="72"/>
                    </a:lnTo>
                    <a:lnTo>
                      <a:pt x="5292" y="27"/>
                    </a:lnTo>
                    <a:lnTo>
                      <a:pt x="5308" y="75"/>
                    </a:lnTo>
                    <a:lnTo>
                      <a:pt x="5321" y="168"/>
                    </a:lnTo>
                    <a:lnTo>
                      <a:pt x="5337" y="72"/>
                    </a:lnTo>
                    <a:lnTo>
                      <a:pt x="5352" y="131"/>
                    </a:lnTo>
                    <a:lnTo>
                      <a:pt x="5365" y="139"/>
                    </a:lnTo>
                    <a:lnTo>
                      <a:pt x="5381" y="148"/>
                    </a:lnTo>
                    <a:lnTo>
                      <a:pt x="5394" y="164"/>
                    </a:lnTo>
                    <a:lnTo>
                      <a:pt x="5410" y="221"/>
                    </a:lnTo>
                    <a:lnTo>
                      <a:pt x="5410" y="273"/>
                    </a:lnTo>
                    <a:lnTo>
                      <a:pt x="5394" y="273"/>
                    </a:lnTo>
                    <a:lnTo>
                      <a:pt x="5381" y="273"/>
                    </a:lnTo>
                    <a:lnTo>
                      <a:pt x="5365" y="273"/>
                    </a:lnTo>
                    <a:lnTo>
                      <a:pt x="5352" y="273"/>
                    </a:lnTo>
                    <a:lnTo>
                      <a:pt x="5337" y="273"/>
                    </a:lnTo>
                    <a:lnTo>
                      <a:pt x="5321" y="273"/>
                    </a:lnTo>
                    <a:lnTo>
                      <a:pt x="5308" y="273"/>
                    </a:lnTo>
                    <a:lnTo>
                      <a:pt x="5292" y="273"/>
                    </a:lnTo>
                    <a:lnTo>
                      <a:pt x="5279" y="273"/>
                    </a:lnTo>
                    <a:lnTo>
                      <a:pt x="5264" y="273"/>
                    </a:lnTo>
                    <a:lnTo>
                      <a:pt x="5248" y="273"/>
                    </a:lnTo>
                    <a:lnTo>
                      <a:pt x="5235" y="273"/>
                    </a:lnTo>
                    <a:lnTo>
                      <a:pt x="5219" y="273"/>
                    </a:lnTo>
                    <a:lnTo>
                      <a:pt x="5206" y="273"/>
                    </a:lnTo>
                    <a:lnTo>
                      <a:pt x="5191" y="273"/>
                    </a:lnTo>
                    <a:lnTo>
                      <a:pt x="5175" y="273"/>
                    </a:lnTo>
                    <a:lnTo>
                      <a:pt x="5162" y="273"/>
                    </a:lnTo>
                    <a:lnTo>
                      <a:pt x="5146" y="273"/>
                    </a:lnTo>
                    <a:lnTo>
                      <a:pt x="5133" y="273"/>
                    </a:lnTo>
                    <a:lnTo>
                      <a:pt x="5118" y="273"/>
                    </a:lnTo>
                    <a:lnTo>
                      <a:pt x="5104" y="273"/>
                    </a:lnTo>
                    <a:lnTo>
                      <a:pt x="5089" y="273"/>
                    </a:lnTo>
                    <a:lnTo>
                      <a:pt x="5073" y="273"/>
                    </a:lnTo>
                    <a:lnTo>
                      <a:pt x="5060" y="273"/>
                    </a:lnTo>
                    <a:lnTo>
                      <a:pt x="5045" y="273"/>
                    </a:lnTo>
                    <a:lnTo>
                      <a:pt x="5031" y="273"/>
                    </a:lnTo>
                    <a:lnTo>
                      <a:pt x="5016" y="273"/>
                    </a:lnTo>
                    <a:lnTo>
                      <a:pt x="5001" y="273"/>
                    </a:lnTo>
                    <a:lnTo>
                      <a:pt x="4987" y="273"/>
                    </a:lnTo>
                    <a:lnTo>
                      <a:pt x="4972" y="273"/>
                    </a:lnTo>
                    <a:lnTo>
                      <a:pt x="4958" y="273"/>
                    </a:lnTo>
                    <a:lnTo>
                      <a:pt x="4943" y="273"/>
                    </a:lnTo>
                    <a:lnTo>
                      <a:pt x="4928" y="273"/>
                    </a:lnTo>
                    <a:lnTo>
                      <a:pt x="4914" y="273"/>
                    </a:lnTo>
                    <a:lnTo>
                      <a:pt x="4899" y="273"/>
                    </a:lnTo>
                    <a:lnTo>
                      <a:pt x="4885" y="273"/>
                    </a:lnTo>
                    <a:lnTo>
                      <a:pt x="4870" y="273"/>
                    </a:lnTo>
                    <a:lnTo>
                      <a:pt x="4855" y="273"/>
                    </a:lnTo>
                    <a:lnTo>
                      <a:pt x="4841" y="273"/>
                    </a:lnTo>
                    <a:lnTo>
                      <a:pt x="4826" y="273"/>
                    </a:lnTo>
                    <a:lnTo>
                      <a:pt x="4812" y="273"/>
                    </a:lnTo>
                    <a:lnTo>
                      <a:pt x="4797" y="273"/>
                    </a:lnTo>
                    <a:lnTo>
                      <a:pt x="4782" y="273"/>
                    </a:lnTo>
                    <a:lnTo>
                      <a:pt x="4768" y="273"/>
                    </a:lnTo>
                    <a:lnTo>
                      <a:pt x="4753" y="273"/>
                    </a:lnTo>
                    <a:lnTo>
                      <a:pt x="4739" y="273"/>
                    </a:lnTo>
                    <a:lnTo>
                      <a:pt x="4724" y="273"/>
                    </a:lnTo>
                    <a:lnTo>
                      <a:pt x="4711" y="273"/>
                    </a:lnTo>
                    <a:lnTo>
                      <a:pt x="4695" y="273"/>
                    </a:lnTo>
                    <a:lnTo>
                      <a:pt x="4680" y="273"/>
                    </a:lnTo>
                    <a:lnTo>
                      <a:pt x="4666" y="273"/>
                    </a:lnTo>
                    <a:lnTo>
                      <a:pt x="4651" y="273"/>
                    </a:lnTo>
                    <a:lnTo>
                      <a:pt x="4638" y="273"/>
                    </a:lnTo>
                    <a:lnTo>
                      <a:pt x="4622" y="273"/>
                    </a:lnTo>
                    <a:lnTo>
                      <a:pt x="4607" y="273"/>
                    </a:lnTo>
                    <a:lnTo>
                      <a:pt x="4593" y="273"/>
                    </a:lnTo>
                    <a:lnTo>
                      <a:pt x="4578" y="273"/>
                    </a:lnTo>
                    <a:lnTo>
                      <a:pt x="4565" y="273"/>
                    </a:lnTo>
                    <a:lnTo>
                      <a:pt x="4549" y="273"/>
                    </a:lnTo>
                    <a:lnTo>
                      <a:pt x="4534" y="273"/>
                    </a:lnTo>
                    <a:lnTo>
                      <a:pt x="4520" y="273"/>
                    </a:lnTo>
                    <a:lnTo>
                      <a:pt x="4505" y="273"/>
                    </a:lnTo>
                    <a:lnTo>
                      <a:pt x="4492" y="273"/>
                    </a:lnTo>
                    <a:lnTo>
                      <a:pt x="4476" y="273"/>
                    </a:lnTo>
                    <a:lnTo>
                      <a:pt x="4461" y="273"/>
                    </a:lnTo>
                    <a:lnTo>
                      <a:pt x="4448" y="273"/>
                    </a:lnTo>
                    <a:lnTo>
                      <a:pt x="4432" y="273"/>
                    </a:lnTo>
                    <a:lnTo>
                      <a:pt x="4419" y="273"/>
                    </a:lnTo>
                    <a:lnTo>
                      <a:pt x="4403" y="273"/>
                    </a:lnTo>
                    <a:lnTo>
                      <a:pt x="4390" y="273"/>
                    </a:lnTo>
                    <a:lnTo>
                      <a:pt x="4375" y="273"/>
                    </a:lnTo>
                    <a:lnTo>
                      <a:pt x="4359" y="273"/>
                    </a:lnTo>
                    <a:lnTo>
                      <a:pt x="4346" y="273"/>
                    </a:lnTo>
                    <a:lnTo>
                      <a:pt x="4330" y="273"/>
                    </a:lnTo>
                    <a:lnTo>
                      <a:pt x="4317" y="273"/>
                    </a:lnTo>
                    <a:lnTo>
                      <a:pt x="4302" y="273"/>
                    </a:lnTo>
                    <a:lnTo>
                      <a:pt x="4286" y="273"/>
                    </a:lnTo>
                    <a:lnTo>
                      <a:pt x="4273" y="273"/>
                    </a:lnTo>
                    <a:lnTo>
                      <a:pt x="4257" y="273"/>
                    </a:lnTo>
                    <a:lnTo>
                      <a:pt x="4244" y="273"/>
                    </a:lnTo>
                    <a:lnTo>
                      <a:pt x="4229" y="273"/>
                    </a:lnTo>
                    <a:lnTo>
                      <a:pt x="4213" y="273"/>
                    </a:lnTo>
                    <a:lnTo>
                      <a:pt x="4200" y="273"/>
                    </a:lnTo>
                    <a:lnTo>
                      <a:pt x="4184" y="273"/>
                    </a:lnTo>
                    <a:lnTo>
                      <a:pt x="4171" y="273"/>
                    </a:lnTo>
                    <a:lnTo>
                      <a:pt x="4156" y="273"/>
                    </a:lnTo>
                    <a:lnTo>
                      <a:pt x="4140" y="273"/>
                    </a:lnTo>
                    <a:lnTo>
                      <a:pt x="4127" y="273"/>
                    </a:lnTo>
                    <a:lnTo>
                      <a:pt x="4111" y="273"/>
                    </a:lnTo>
                    <a:lnTo>
                      <a:pt x="4098" y="273"/>
                    </a:lnTo>
                    <a:lnTo>
                      <a:pt x="4083" y="273"/>
                    </a:lnTo>
                    <a:lnTo>
                      <a:pt x="4067" y="273"/>
                    </a:lnTo>
                    <a:lnTo>
                      <a:pt x="4054" y="273"/>
                    </a:lnTo>
                    <a:lnTo>
                      <a:pt x="4039" y="273"/>
                    </a:lnTo>
                    <a:lnTo>
                      <a:pt x="4025" y="273"/>
                    </a:lnTo>
                    <a:lnTo>
                      <a:pt x="4010" y="273"/>
                    </a:lnTo>
                    <a:lnTo>
                      <a:pt x="3996" y="273"/>
                    </a:lnTo>
                    <a:lnTo>
                      <a:pt x="3981" y="273"/>
                    </a:lnTo>
                    <a:lnTo>
                      <a:pt x="3966" y="273"/>
                    </a:lnTo>
                    <a:lnTo>
                      <a:pt x="3952" y="273"/>
                    </a:lnTo>
                    <a:lnTo>
                      <a:pt x="3937" y="273"/>
                    </a:lnTo>
                    <a:lnTo>
                      <a:pt x="3923" y="273"/>
                    </a:lnTo>
                    <a:lnTo>
                      <a:pt x="3908" y="273"/>
                    </a:lnTo>
                    <a:lnTo>
                      <a:pt x="3893" y="273"/>
                    </a:lnTo>
                    <a:lnTo>
                      <a:pt x="3879" y="273"/>
                    </a:lnTo>
                    <a:lnTo>
                      <a:pt x="3864" y="273"/>
                    </a:lnTo>
                    <a:lnTo>
                      <a:pt x="3850" y="273"/>
                    </a:lnTo>
                    <a:lnTo>
                      <a:pt x="3835" y="273"/>
                    </a:lnTo>
                    <a:lnTo>
                      <a:pt x="3820" y="273"/>
                    </a:lnTo>
                    <a:lnTo>
                      <a:pt x="3806" y="273"/>
                    </a:lnTo>
                    <a:lnTo>
                      <a:pt x="3791" y="273"/>
                    </a:lnTo>
                    <a:lnTo>
                      <a:pt x="3777" y="273"/>
                    </a:lnTo>
                    <a:lnTo>
                      <a:pt x="3762" y="273"/>
                    </a:lnTo>
                    <a:lnTo>
                      <a:pt x="3747" y="273"/>
                    </a:lnTo>
                    <a:lnTo>
                      <a:pt x="3733" y="273"/>
                    </a:lnTo>
                    <a:lnTo>
                      <a:pt x="3718" y="273"/>
                    </a:lnTo>
                    <a:lnTo>
                      <a:pt x="3704" y="273"/>
                    </a:lnTo>
                    <a:lnTo>
                      <a:pt x="3689" y="273"/>
                    </a:lnTo>
                    <a:lnTo>
                      <a:pt x="3674" y="273"/>
                    </a:lnTo>
                    <a:lnTo>
                      <a:pt x="3660" y="273"/>
                    </a:lnTo>
                    <a:lnTo>
                      <a:pt x="3645" y="273"/>
                    </a:lnTo>
                    <a:lnTo>
                      <a:pt x="3631" y="273"/>
                    </a:lnTo>
                    <a:lnTo>
                      <a:pt x="3616" y="273"/>
                    </a:lnTo>
                    <a:lnTo>
                      <a:pt x="3603" y="273"/>
                    </a:lnTo>
                    <a:lnTo>
                      <a:pt x="3587" y="273"/>
                    </a:lnTo>
                    <a:lnTo>
                      <a:pt x="3572" y="273"/>
                    </a:lnTo>
                    <a:lnTo>
                      <a:pt x="3558" y="273"/>
                    </a:lnTo>
                    <a:lnTo>
                      <a:pt x="3543" y="273"/>
                    </a:lnTo>
                    <a:lnTo>
                      <a:pt x="3530" y="273"/>
                    </a:lnTo>
                    <a:lnTo>
                      <a:pt x="3514" y="273"/>
                    </a:lnTo>
                    <a:lnTo>
                      <a:pt x="3499" y="273"/>
                    </a:lnTo>
                    <a:lnTo>
                      <a:pt x="3486" y="273"/>
                    </a:lnTo>
                    <a:lnTo>
                      <a:pt x="3470" y="273"/>
                    </a:lnTo>
                    <a:lnTo>
                      <a:pt x="3457" y="273"/>
                    </a:lnTo>
                    <a:lnTo>
                      <a:pt x="3441" y="273"/>
                    </a:lnTo>
                    <a:lnTo>
                      <a:pt x="3426" y="273"/>
                    </a:lnTo>
                    <a:lnTo>
                      <a:pt x="3413" y="273"/>
                    </a:lnTo>
                    <a:lnTo>
                      <a:pt x="3397" y="273"/>
                    </a:lnTo>
                    <a:lnTo>
                      <a:pt x="3384" y="273"/>
                    </a:lnTo>
                    <a:lnTo>
                      <a:pt x="3368" y="273"/>
                    </a:lnTo>
                    <a:lnTo>
                      <a:pt x="3353" y="273"/>
                    </a:lnTo>
                    <a:lnTo>
                      <a:pt x="3340" y="273"/>
                    </a:lnTo>
                    <a:lnTo>
                      <a:pt x="3324" y="273"/>
                    </a:lnTo>
                    <a:lnTo>
                      <a:pt x="3311" y="273"/>
                    </a:lnTo>
                    <a:lnTo>
                      <a:pt x="3295" y="273"/>
                    </a:lnTo>
                    <a:lnTo>
                      <a:pt x="3282" y="273"/>
                    </a:lnTo>
                    <a:lnTo>
                      <a:pt x="3267" y="273"/>
                    </a:lnTo>
                    <a:lnTo>
                      <a:pt x="3251" y="273"/>
                    </a:lnTo>
                    <a:lnTo>
                      <a:pt x="3238" y="273"/>
                    </a:lnTo>
                    <a:lnTo>
                      <a:pt x="3222" y="273"/>
                    </a:lnTo>
                    <a:lnTo>
                      <a:pt x="3209" y="273"/>
                    </a:lnTo>
                    <a:lnTo>
                      <a:pt x="3194" y="273"/>
                    </a:lnTo>
                    <a:lnTo>
                      <a:pt x="3178" y="273"/>
                    </a:lnTo>
                    <a:lnTo>
                      <a:pt x="3165" y="273"/>
                    </a:lnTo>
                    <a:lnTo>
                      <a:pt x="3150" y="273"/>
                    </a:lnTo>
                    <a:lnTo>
                      <a:pt x="3136" y="273"/>
                    </a:lnTo>
                    <a:lnTo>
                      <a:pt x="3121" y="273"/>
                    </a:lnTo>
                    <a:lnTo>
                      <a:pt x="3105" y="273"/>
                    </a:lnTo>
                    <a:lnTo>
                      <a:pt x="3092" y="273"/>
                    </a:lnTo>
                    <a:lnTo>
                      <a:pt x="3077" y="273"/>
                    </a:lnTo>
                    <a:lnTo>
                      <a:pt x="3063" y="273"/>
                    </a:lnTo>
                    <a:lnTo>
                      <a:pt x="3048" y="273"/>
                    </a:lnTo>
                    <a:lnTo>
                      <a:pt x="3032" y="273"/>
                    </a:lnTo>
                    <a:lnTo>
                      <a:pt x="3019" y="273"/>
                    </a:lnTo>
                    <a:lnTo>
                      <a:pt x="3004" y="273"/>
                    </a:lnTo>
                    <a:lnTo>
                      <a:pt x="2990" y="273"/>
                    </a:lnTo>
                    <a:lnTo>
                      <a:pt x="2975" y="273"/>
                    </a:lnTo>
                    <a:lnTo>
                      <a:pt x="2959" y="273"/>
                    </a:lnTo>
                    <a:lnTo>
                      <a:pt x="2946" y="273"/>
                    </a:lnTo>
                    <a:lnTo>
                      <a:pt x="2931" y="273"/>
                    </a:lnTo>
                    <a:lnTo>
                      <a:pt x="2917" y="273"/>
                    </a:lnTo>
                    <a:lnTo>
                      <a:pt x="2902" y="273"/>
                    </a:lnTo>
                    <a:lnTo>
                      <a:pt x="2888" y="273"/>
                    </a:lnTo>
                    <a:lnTo>
                      <a:pt x="2873" y="273"/>
                    </a:lnTo>
                    <a:lnTo>
                      <a:pt x="2858" y="273"/>
                    </a:lnTo>
                    <a:lnTo>
                      <a:pt x="2844" y="273"/>
                    </a:lnTo>
                    <a:lnTo>
                      <a:pt x="2829" y="273"/>
                    </a:lnTo>
                    <a:lnTo>
                      <a:pt x="2815" y="273"/>
                    </a:lnTo>
                    <a:lnTo>
                      <a:pt x="2800" y="273"/>
                    </a:lnTo>
                    <a:lnTo>
                      <a:pt x="2785" y="273"/>
                    </a:lnTo>
                    <a:lnTo>
                      <a:pt x="2771" y="273"/>
                    </a:lnTo>
                    <a:lnTo>
                      <a:pt x="2756" y="273"/>
                    </a:lnTo>
                    <a:lnTo>
                      <a:pt x="2742" y="273"/>
                    </a:lnTo>
                    <a:lnTo>
                      <a:pt x="2727" y="273"/>
                    </a:lnTo>
                    <a:lnTo>
                      <a:pt x="2712" y="273"/>
                    </a:lnTo>
                    <a:lnTo>
                      <a:pt x="2698" y="273"/>
                    </a:lnTo>
                    <a:lnTo>
                      <a:pt x="2683" y="273"/>
                    </a:lnTo>
                    <a:lnTo>
                      <a:pt x="2669" y="273"/>
                    </a:lnTo>
                    <a:lnTo>
                      <a:pt x="2654" y="273"/>
                    </a:lnTo>
                    <a:lnTo>
                      <a:pt x="2639" y="273"/>
                    </a:lnTo>
                    <a:lnTo>
                      <a:pt x="2625" y="273"/>
                    </a:lnTo>
                    <a:lnTo>
                      <a:pt x="2610" y="273"/>
                    </a:lnTo>
                    <a:lnTo>
                      <a:pt x="2597" y="273"/>
                    </a:lnTo>
                    <a:lnTo>
                      <a:pt x="2581" y="273"/>
                    </a:lnTo>
                    <a:lnTo>
                      <a:pt x="2566" y="273"/>
                    </a:lnTo>
                    <a:lnTo>
                      <a:pt x="2552" y="273"/>
                    </a:lnTo>
                    <a:lnTo>
                      <a:pt x="2537" y="273"/>
                    </a:lnTo>
                    <a:lnTo>
                      <a:pt x="2524" y="273"/>
                    </a:lnTo>
                    <a:lnTo>
                      <a:pt x="2508" y="273"/>
                    </a:lnTo>
                    <a:lnTo>
                      <a:pt x="2495" y="273"/>
                    </a:lnTo>
                    <a:lnTo>
                      <a:pt x="2479" y="273"/>
                    </a:lnTo>
                    <a:lnTo>
                      <a:pt x="2464" y="273"/>
                    </a:lnTo>
                    <a:lnTo>
                      <a:pt x="2451" y="273"/>
                    </a:lnTo>
                    <a:lnTo>
                      <a:pt x="2435" y="273"/>
                    </a:lnTo>
                    <a:lnTo>
                      <a:pt x="2422" y="273"/>
                    </a:lnTo>
                    <a:lnTo>
                      <a:pt x="2406" y="273"/>
                    </a:lnTo>
                    <a:lnTo>
                      <a:pt x="2391" y="273"/>
                    </a:lnTo>
                    <a:lnTo>
                      <a:pt x="2378" y="273"/>
                    </a:lnTo>
                    <a:lnTo>
                      <a:pt x="2362" y="273"/>
                    </a:lnTo>
                    <a:lnTo>
                      <a:pt x="2349" y="273"/>
                    </a:lnTo>
                    <a:lnTo>
                      <a:pt x="2333" y="273"/>
                    </a:lnTo>
                    <a:lnTo>
                      <a:pt x="2318" y="273"/>
                    </a:lnTo>
                    <a:lnTo>
                      <a:pt x="2305" y="273"/>
                    </a:lnTo>
                    <a:lnTo>
                      <a:pt x="2289" y="273"/>
                    </a:lnTo>
                    <a:lnTo>
                      <a:pt x="2276" y="273"/>
                    </a:lnTo>
                    <a:lnTo>
                      <a:pt x="2260" y="273"/>
                    </a:lnTo>
                    <a:lnTo>
                      <a:pt x="2245" y="273"/>
                    </a:lnTo>
                    <a:lnTo>
                      <a:pt x="2232" y="273"/>
                    </a:lnTo>
                    <a:lnTo>
                      <a:pt x="2216" y="273"/>
                    </a:lnTo>
                    <a:lnTo>
                      <a:pt x="2203" y="273"/>
                    </a:lnTo>
                    <a:lnTo>
                      <a:pt x="2188" y="273"/>
                    </a:lnTo>
                    <a:lnTo>
                      <a:pt x="2174" y="273"/>
                    </a:lnTo>
                    <a:lnTo>
                      <a:pt x="2159" y="273"/>
                    </a:lnTo>
                    <a:lnTo>
                      <a:pt x="2143" y="273"/>
                    </a:lnTo>
                    <a:lnTo>
                      <a:pt x="2130" y="273"/>
                    </a:lnTo>
                    <a:lnTo>
                      <a:pt x="2115" y="273"/>
                    </a:lnTo>
                    <a:lnTo>
                      <a:pt x="2101" y="273"/>
                    </a:lnTo>
                    <a:lnTo>
                      <a:pt x="2086" y="273"/>
                    </a:lnTo>
                    <a:lnTo>
                      <a:pt x="2070" y="273"/>
                    </a:lnTo>
                    <a:lnTo>
                      <a:pt x="2057" y="273"/>
                    </a:lnTo>
                    <a:lnTo>
                      <a:pt x="2042" y="273"/>
                    </a:lnTo>
                    <a:lnTo>
                      <a:pt x="2028" y="273"/>
                    </a:lnTo>
                    <a:lnTo>
                      <a:pt x="2013" y="273"/>
                    </a:lnTo>
                    <a:lnTo>
                      <a:pt x="1997" y="273"/>
                    </a:lnTo>
                    <a:lnTo>
                      <a:pt x="1984" y="273"/>
                    </a:lnTo>
                    <a:lnTo>
                      <a:pt x="1969" y="273"/>
                    </a:lnTo>
                    <a:lnTo>
                      <a:pt x="1955" y="273"/>
                    </a:lnTo>
                    <a:lnTo>
                      <a:pt x="1940" y="273"/>
                    </a:lnTo>
                    <a:lnTo>
                      <a:pt x="1924" y="273"/>
                    </a:lnTo>
                    <a:lnTo>
                      <a:pt x="1911" y="273"/>
                    </a:lnTo>
                    <a:lnTo>
                      <a:pt x="1896" y="273"/>
                    </a:lnTo>
                    <a:lnTo>
                      <a:pt x="1882" y="273"/>
                    </a:lnTo>
                    <a:lnTo>
                      <a:pt x="1867" y="273"/>
                    </a:lnTo>
                    <a:lnTo>
                      <a:pt x="1852" y="273"/>
                    </a:lnTo>
                    <a:lnTo>
                      <a:pt x="1838" y="273"/>
                    </a:lnTo>
                    <a:lnTo>
                      <a:pt x="1823" y="273"/>
                    </a:lnTo>
                    <a:lnTo>
                      <a:pt x="1809" y="273"/>
                    </a:lnTo>
                    <a:lnTo>
                      <a:pt x="1794" y="273"/>
                    </a:lnTo>
                    <a:lnTo>
                      <a:pt x="1780" y="273"/>
                    </a:lnTo>
                    <a:lnTo>
                      <a:pt x="1765" y="273"/>
                    </a:lnTo>
                    <a:lnTo>
                      <a:pt x="1750" y="273"/>
                    </a:lnTo>
                    <a:lnTo>
                      <a:pt x="1736" y="273"/>
                    </a:lnTo>
                    <a:lnTo>
                      <a:pt x="1721" y="273"/>
                    </a:lnTo>
                    <a:lnTo>
                      <a:pt x="1707" y="273"/>
                    </a:lnTo>
                    <a:lnTo>
                      <a:pt x="1692" y="273"/>
                    </a:lnTo>
                    <a:lnTo>
                      <a:pt x="1677" y="273"/>
                    </a:lnTo>
                    <a:lnTo>
                      <a:pt x="1663" y="273"/>
                    </a:lnTo>
                    <a:lnTo>
                      <a:pt x="1648" y="273"/>
                    </a:lnTo>
                    <a:lnTo>
                      <a:pt x="1635" y="273"/>
                    </a:lnTo>
                    <a:lnTo>
                      <a:pt x="1619" y="273"/>
                    </a:lnTo>
                    <a:lnTo>
                      <a:pt x="1604" y="273"/>
                    </a:lnTo>
                    <a:lnTo>
                      <a:pt x="1590" y="273"/>
                    </a:lnTo>
                    <a:lnTo>
                      <a:pt x="1575" y="273"/>
                    </a:lnTo>
                    <a:lnTo>
                      <a:pt x="1562" y="273"/>
                    </a:lnTo>
                    <a:lnTo>
                      <a:pt x="1546" y="273"/>
                    </a:lnTo>
                    <a:lnTo>
                      <a:pt x="1531" y="273"/>
                    </a:lnTo>
                    <a:lnTo>
                      <a:pt x="1517" y="273"/>
                    </a:lnTo>
                    <a:lnTo>
                      <a:pt x="1502" y="273"/>
                    </a:lnTo>
                    <a:lnTo>
                      <a:pt x="1489" y="273"/>
                    </a:lnTo>
                    <a:lnTo>
                      <a:pt x="1473" y="273"/>
                    </a:lnTo>
                    <a:lnTo>
                      <a:pt x="1458" y="273"/>
                    </a:lnTo>
                    <a:lnTo>
                      <a:pt x="1444" y="273"/>
                    </a:lnTo>
                    <a:lnTo>
                      <a:pt x="1429" y="273"/>
                    </a:lnTo>
                    <a:lnTo>
                      <a:pt x="1416" y="273"/>
                    </a:lnTo>
                    <a:lnTo>
                      <a:pt x="1400" y="273"/>
                    </a:lnTo>
                    <a:lnTo>
                      <a:pt x="1387" y="273"/>
                    </a:lnTo>
                    <a:lnTo>
                      <a:pt x="1371" y="273"/>
                    </a:lnTo>
                    <a:lnTo>
                      <a:pt x="1356" y="273"/>
                    </a:lnTo>
                    <a:lnTo>
                      <a:pt x="1343" y="273"/>
                    </a:lnTo>
                    <a:lnTo>
                      <a:pt x="1327" y="273"/>
                    </a:lnTo>
                    <a:lnTo>
                      <a:pt x="1314" y="273"/>
                    </a:lnTo>
                    <a:lnTo>
                      <a:pt x="1299" y="273"/>
                    </a:lnTo>
                    <a:lnTo>
                      <a:pt x="1283" y="273"/>
                    </a:lnTo>
                    <a:lnTo>
                      <a:pt x="1270" y="273"/>
                    </a:lnTo>
                    <a:lnTo>
                      <a:pt x="1254" y="273"/>
                    </a:lnTo>
                    <a:lnTo>
                      <a:pt x="1241" y="273"/>
                    </a:lnTo>
                    <a:lnTo>
                      <a:pt x="1226" y="273"/>
                    </a:lnTo>
                    <a:lnTo>
                      <a:pt x="1210" y="273"/>
                    </a:lnTo>
                    <a:lnTo>
                      <a:pt x="1197" y="273"/>
                    </a:lnTo>
                    <a:lnTo>
                      <a:pt x="1181" y="273"/>
                    </a:lnTo>
                    <a:lnTo>
                      <a:pt x="1168" y="273"/>
                    </a:lnTo>
                    <a:lnTo>
                      <a:pt x="1153" y="273"/>
                    </a:lnTo>
                    <a:lnTo>
                      <a:pt x="1137" y="273"/>
                    </a:lnTo>
                    <a:lnTo>
                      <a:pt x="1124" y="273"/>
                    </a:lnTo>
                    <a:lnTo>
                      <a:pt x="1108" y="273"/>
                    </a:lnTo>
                    <a:lnTo>
                      <a:pt x="1095" y="273"/>
                    </a:lnTo>
                    <a:lnTo>
                      <a:pt x="1080" y="273"/>
                    </a:lnTo>
                    <a:lnTo>
                      <a:pt x="1066" y="273"/>
                    </a:lnTo>
                    <a:lnTo>
                      <a:pt x="1051" y="273"/>
                    </a:lnTo>
                    <a:lnTo>
                      <a:pt x="1035" y="273"/>
                    </a:lnTo>
                    <a:lnTo>
                      <a:pt x="1022" y="273"/>
                    </a:lnTo>
                    <a:lnTo>
                      <a:pt x="1007" y="273"/>
                    </a:lnTo>
                    <a:lnTo>
                      <a:pt x="993" y="273"/>
                    </a:lnTo>
                    <a:lnTo>
                      <a:pt x="978" y="273"/>
                    </a:lnTo>
                    <a:lnTo>
                      <a:pt x="962" y="273"/>
                    </a:lnTo>
                    <a:lnTo>
                      <a:pt x="949" y="273"/>
                    </a:lnTo>
                    <a:lnTo>
                      <a:pt x="934" y="273"/>
                    </a:lnTo>
                    <a:lnTo>
                      <a:pt x="920" y="273"/>
                    </a:lnTo>
                    <a:lnTo>
                      <a:pt x="905" y="273"/>
                    </a:lnTo>
                    <a:lnTo>
                      <a:pt x="890" y="273"/>
                    </a:lnTo>
                    <a:lnTo>
                      <a:pt x="876" y="273"/>
                    </a:lnTo>
                    <a:lnTo>
                      <a:pt x="861" y="273"/>
                    </a:lnTo>
                    <a:lnTo>
                      <a:pt x="847" y="273"/>
                    </a:lnTo>
                    <a:lnTo>
                      <a:pt x="832" y="273"/>
                    </a:lnTo>
                    <a:lnTo>
                      <a:pt x="817" y="273"/>
                    </a:lnTo>
                    <a:lnTo>
                      <a:pt x="803" y="273"/>
                    </a:lnTo>
                    <a:lnTo>
                      <a:pt x="788" y="273"/>
                    </a:lnTo>
                    <a:lnTo>
                      <a:pt x="774" y="273"/>
                    </a:lnTo>
                    <a:lnTo>
                      <a:pt x="759" y="273"/>
                    </a:lnTo>
                    <a:lnTo>
                      <a:pt x="744" y="273"/>
                    </a:lnTo>
                    <a:lnTo>
                      <a:pt x="730" y="273"/>
                    </a:lnTo>
                    <a:lnTo>
                      <a:pt x="715" y="273"/>
                    </a:lnTo>
                    <a:lnTo>
                      <a:pt x="701" y="273"/>
                    </a:lnTo>
                    <a:lnTo>
                      <a:pt x="686" y="273"/>
                    </a:lnTo>
                    <a:lnTo>
                      <a:pt x="673" y="273"/>
                    </a:lnTo>
                    <a:lnTo>
                      <a:pt x="657" y="273"/>
                    </a:lnTo>
                    <a:lnTo>
                      <a:pt x="642" y="273"/>
                    </a:lnTo>
                    <a:lnTo>
                      <a:pt x="628" y="273"/>
                    </a:lnTo>
                    <a:lnTo>
                      <a:pt x="613" y="273"/>
                    </a:lnTo>
                    <a:lnTo>
                      <a:pt x="600" y="273"/>
                    </a:lnTo>
                    <a:lnTo>
                      <a:pt x="584" y="273"/>
                    </a:lnTo>
                    <a:lnTo>
                      <a:pt x="569" y="273"/>
                    </a:lnTo>
                    <a:lnTo>
                      <a:pt x="555" y="273"/>
                    </a:lnTo>
                    <a:lnTo>
                      <a:pt x="540" y="273"/>
                    </a:lnTo>
                    <a:lnTo>
                      <a:pt x="527" y="273"/>
                    </a:lnTo>
                    <a:lnTo>
                      <a:pt x="511" y="273"/>
                    </a:lnTo>
                    <a:lnTo>
                      <a:pt x="496" y="273"/>
                    </a:lnTo>
                    <a:lnTo>
                      <a:pt x="482" y="273"/>
                    </a:lnTo>
                    <a:lnTo>
                      <a:pt x="467" y="273"/>
                    </a:lnTo>
                    <a:lnTo>
                      <a:pt x="454" y="273"/>
                    </a:lnTo>
                    <a:lnTo>
                      <a:pt x="438" y="273"/>
                    </a:lnTo>
                    <a:lnTo>
                      <a:pt x="423" y="273"/>
                    </a:lnTo>
                    <a:lnTo>
                      <a:pt x="409" y="273"/>
                    </a:lnTo>
                    <a:lnTo>
                      <a:pt x="394" y="273"/>
                    </a:lnTo>
                    <a:lnTo>
                      <a:pt x="381" y="273"/>
                    </a:lnTo>
                    <a:lnTo>
                      <a:pt x="365" y="273"/>
                    </a:lnTo>
                    <a:lnTo>
                      <a:pt x="350" y="273"/>
                    </a:lnTo>
                    <a:lnTo>
                      <a:pt x="337" y="273"/>
                    </a:lnTo>
                    <a:lnTo>
                      <a:pt x="321" y="273"/>
                    </a:lnTo>
                    <a:lnTo>
                      <a:pt x="308" y="273"/>
                    </a:lnTo>
                    <a:lnTo>
                      <a:pt x="292" y="273"/>
                    </a:lnTo>
                    <a:lnTo>
                      <a:pt x="279" y="273"/>
                    </a:lnTo>
                    <a:lnTo>
                      <a:pt x="264" y="273"/>
                    </a:lnTo>
                    <a:lnTo>
                      <a:pt x="248" y="273"/>
                    </a:lnTo>
                    <a:lnTo>
                      <a:pt x="235" y="273"/>
                    </a:lnTo>
                    <a:lnTo>
                      <a:pt x="219" y="273"/>
                    </a:lnTo>
                    <a:lnTo>
                      <a:pt x="206" y="273"/>
                    </a:lnTo>
                    <a:lnTo>
                      <a:pt x="191" y="273"/>
                    </a:lnTo>
                    <a:lnTo>
                      <a:pt x="175" y="273"/>
                    </a:lnTo>
                    <a:lnTo>
                      <a:pt x="162" y="273"/>
                    </a:lnTo>
                    <a:lnTo>
                      <a:pt x="146" y="273"/>
                    </a:lnTo>
                    <a:lnTo>
                      <a:pt x="133" y="273"/>
                    </a:lnTo>
                    <a:lnTo>
                      <a:pt x="118" y="273"/>
                    </a:lnTo>
                    <a:lnTo>
                      <a:pt x="102" y="273"/>
                    </a:lnTo>
                    <a:lnTo>
                      <a:pt x="89" y="273"/>
                    </a:lnTo>
                    <a:lnTo>
                      <a:pt x="73" y="273"/>
                    </a:lnTo>
                    <a:lnTo>
                      <a:pt x="60" y="273"/>
                    </a:lnTo>
                    <a:lnTo>
                      <a:pt x="45" y="273"/>
                    </a:lnTo>
                    <a:lnTo>
                      <a:pt x="29" y="273"/>
                    </a:lnTo>
                    <a:lnTo>
                      <a:pt x="16" y="273"/>
                    </a:lnTo>
                    <a:lnTo>
                      <a:pt x="0" y="273"/>
                    </a:lnTo>
                    <a:lnTo>
                      <a:pt x="0" y="200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6" name="Freeform 35"/>
              <p:cNvSpPr>
                <a:spLocks/>
              </p:cNvSpPr>
              <p:nvPr/>
            </p:nvSpPr>
            <p:spPr bwMode="auto">
              <a:xfrm rot="5400000" flipV="1">
                <a:off x="-49276" y="3068674"/>
                <a:ext cx="4180036" cy="191648"/>
              </a:xfrm>
              <a:custGeom>
                <a:avLst/>
                <a:gdLst>
                  <a:gd name="T0" fmla="*/ 156 w 5410"/>
                  <a:gd name="T1" fmla="*/ 83 h 288"/>
                  <a:gd name="T2" fmla="*/ 325 w 5410"/>
                  <a:gd name="T3" fmla="*/ 96 h 288"/>
                  <a:gd name="T4" fmla="*/ 496 w 5410"/>
                  <a:gd name="T5" fmla="*/ 171 h 288"/>
                  <a:gd name="T6" fmla="*/ 665 w 5410"/>
                  <a:gd name="T7" fmla="*/ 85 h 288"/>
                  <a:gd name="T8" fmla="*/ 836 w 5410"/>
                  <a:gd name="T9" fmla="*/ 152 h 288"/>
                  <a:gd name="T10" fmla="*/ 1005 w 5410"/>
                  <a:gd name="T11" fmla="*/ 69 h 288"/>
                  <a:gd name="T12" fmla="*/ 1176 w 5410"/>
                  <a:gd name="T13" fmla="*/ 142 h 288"/>
                  <a:gd name="T14" fmla="*/ 1345 w 5410"/>
                  <a:gd name="T15" fmla="*/ 288 h 288"/>
                  <a:gd name="T16" fmla="*/ 1515 w 5410"/>
                  <a:gd name="T17" fmla="*/ 146 h 288"/>
                  <a:gd name="T18" fmla="*/ 1684 w 5410"/>
                  <a:gd name="T19" fmla="*/ 108 h 288"/>
                  <a:gd name="T20" fmla="*/ 1855 w 5410"/>
                  <a:gd name="T21" fmla="*/ 288 h 288"/>
                  <a:gd name="T22" fmla="*/ 2026 w 5410"/>
                  <a:gd name="T23" fmla="*/ 165 h 288"/>
                  <a:gd name="T24" fmla="*/ 2195 w 5410"/>
                  <a:gd name="T25" fmla="*/ 275 h 288"/>
                  <a:gd name="T26" fmla="*/ 2366 w 5410"/>
                  <a:gd name="T27" fmla="*/ 235 h 288"/>
                  <a:gd name="T28" fmla="*/ 2535 w 5410"/>
                  <a:gd name="T29" fmla="*/ 285 h 288"/>
                  <a:gd name="T30" fmla="*/ 2706 w 5410"/>
                  <a:gd name="T31" fmla="*/ 171 h 288"/>
                  <a:gd name="T32" fmla="*/ 2875 w 5410"/>
                  <a:gd name="T33" fmla="*/ 258 h 288"/>
                  <a:gd name="T34" fmla="*/ 3046 w 5410"/>
                  <a:gd name="T35" fmla="*/ 288 h 288"/>
                  <a:gd name="T36" fmla="*/ 3215 w 5410"/>
                  <a:gd name="T37" fmla="*/ 277 h 288"/>
                  <a:gd name="T38" fmla="*/ 3386 w 5410"/>
                  <a:gd name="T39" fmla="*/ 288 h 288"/>
                  <a:gd name="T40" fmla="*/ 3555 w 5410"/>
                  <a:gd name="T41" fmla="*/ 277 h 288"/>
                  <a:gd name="T42" fmla="*/ 3726 w 5410"/>
                  <a:gd name="T43" fmla="*/ 73 h 288"/>
                  <a:gd name="T44" fmla="*/ 3895 w 5410"/>
                  <a:gd name="T45" fmla="*/ 90 h 288"/>
                  <a:gd name="T46" fmla="*/ 4065 w 5410"/>
                  <a:gd name="T47" fmla="*/ 48 h 288"/>
                  <a:gd name="T48" fmla="*/ 4234 w 5410"/>
                  <a:gd name="T49" fmla="*/ 183 h 288"/>
                  <a:gd name="T50" fmla="*/ 4405 w 5410"/>
                  <a:gd name="T51" fmla="*/ 152 h 288"/>
                  <a:gd name="T52" fmla="*/ 4574 w 5410"/>
                  <a:gd name="T53" fmla="*/ 31 h 288"/>
                  <a:gd name="T54" fmla="*/ 4745 w 5410"/>
                  <a:gd name="T55" fmla="*/ 89 h 288"/>
                  <a:gd name="T56" fmla="*/ 4914 w 5410"/>
                  <a:gd name="T57" fmla="*/ 71 h 288"/>
                  <a:gd name="T58" fmla="*/ 5085 w 5410"/>
                  <a:gd name="T59" fmla="*/ 92 h 288"/>
                  <a:gd name="T60" fmla="*/ 5254 w 5410"/>
                  <a:gd name="T61" fmla="*/ 35 h 288"/>
                  <a:gd name="T62" fmla="*/ 5410 w 5410"/>
                  <a:gd name="T63" fmla="*/ 288 h 288"/>
                  <a:gd name="T64" fmla="*/ 5239 w 5410"/>
                  <a:gd name="T65" fmla="*/ 288 h 288"/>
                  <a:gd name="T66" fmla="*/ 5070 w 5410"/>
                  <a:gd name="T67" fmla="*/ 288 h 288"/>
                  <a:gd name="T68" fmla="*/ 4899 w 5410"/>
                  <a:gd name="T69" fmla="*/ 288 h 288"/>
                  <a:gd name="T70" fmla="*/ 4730 w 5410"/>
                  <a:gd name="T71" fmla="*/ 288 h 288"/>
                  <a:gd name="T72" fmla="*/ 4559 w 5410"/>
                  <a:gd name="T73" fmla="*/ 288 h 288"/>
                  <a:gd name="T74" fmla="*/ 4390 w 5410"/>
                  <a:gd name="T75" fmla="*/ 288 h 288"/>
                  <a:gd name="T76" fmla="*/ 4219 w 5410"/>
                  <a:gd name="T77" fmla="*/ 288 h 288"/>
                  <a:gd name="T78" fmla="*/ 4050 w 5410"/>
                  <a:gd name="T79" fmla="*/ 288 h 288"/>
                  <a:gd name="T80" fmla="*/ 3879 w 5410"/>
                  <a:gd name="T81" fmla="*/ 288 h 288"/>
                  <a:gd name="T82" fmla="*/ 3710 w 5410"/>
                  <a:gd name="T83" fmla="*/ 288 h 288"/>
                  <a:gd name="T84" fmla="*/ 3539 w 5410"/>
                  <a:gd name="T85" fmla="*/ 288 h 288"/>
                  <a:gd name="T86" fmla="*/ 3370 w 5410"/>
                  <a:gd name="T87" fmla="*/ 288 h 288"/>
                  <a:gd name="T88" fmla="*/ 3199 w 5410"/>
                  <a:gd name="T89" fmla="*/ 288 h 288"/>
                  <a:gd name="T90" fmla="*/ 3030 w 5410"/>
                  <a:gd name="T91" fmla="*/ 288 h 288"/>
                  <a:gd name="T92" fmla="*/ 2860 w 5410"/>
                  <a:gd name="T93" fmla="*/ 288 h 288"/>
                  <a:gd name="T94" fmla="*/ 2691 w 5410"/>
                  <a:gd name="T95" fmla="*/ 288 h 288"/>
                  <a:gd name="T96" fmla="*/ 2520 w 5410"/>
                  <a:gd name="T97" fmla="*/ 288 h 288"/>
                  <a:gd name="T98" fmla="*/ 2351 w 5410"/>
                  <a:gd name="T99" fmla="*/ 288 h 288"/>
                  <a:gd name="T100" fmla="*/ 2180 w 5410"/>
                  <a:gd name="T101" fmla="*/ 288 h 288"/>
                  <a:gd name="T102" fmla="*/ 2009 w 5410"/>
                  <a:gd name="T103" fmla="*/ 288 h 288"/>
                  <a:gd name="T104" fmla="*/ 1840 w 5410"/>
                  <a:gd name="T105" fmla="*/ 288 h 288"/>
                  <a:gd name="T106" fmla="*/ 1669 w 5410"/>
                  <a:gd name="T107" fmla="*/ 288 h 288"/>
                  <a:gd name="T108" fmla="*/ 1500 w 5410"/>
                  <a:gd name="T109" fmla="*/ 288 h 288"/>
                  <a:gd name="T110" fmla="*/ 1329 w 5410"/>
                  <a:gd name="T111" fmla="*/ 288 h 288"/>
                  <a:gd name="T112" fmla="*/ 1160 w 5410"/>
                  <a:gd name="T113" fmla="*/ 288 h 288"/>
                  <a:gd name="T114" fmla="*/ 989 w 5410"/>
                  <a:gd name="T115" fmla="*/ 288 h 288"/>
                  <a:gd name="T116" fmla="*/ 820 w 5410"/>
                  <a:gd name="T117" fmla="*/ 288 h 288"/>
                  <a:gd name="T118" fmla="*/ 649 w 5410"/>
                  <a:gd name="T119" fmla="*/ 288 h 288"/>
                  <a:gd name="T120" fmla="*/ 481 w 5410"/>
                  <a:gd name="T121" fmla="*/ 288 h 288"/>
                  <a:gd name="T122" fmla="*/ 310 w 5410"/>
                  <a:gd name="T123" fmla="*/ 288 h 288"/>
                  <a:gd name="T124" fmla="*/ 141 w 5410"/>
                  <a:gd name="T125" fmla="*/ 288 h 2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5410" h="288">
                    <a:moveTo>
                      <a:pt x="0" y="223"/>
                    </a:moveTo>
                    <a:lnTo>
                      <a:pt x="16" y="98"/>
                    </a:lnTo>
                    <a:lnTo>
                      <a:pt x="31" y="140"/>
                    </a:lnTo>
                    <a:lnTo>
                      <a:pt x="47" y="108"/>
                    </a:lnTo>
                    <a:lnTo>
                      <a:pt x="62" y="125"/>
                    </a:lnTo>
                    <a:lnTo>
                      <a:pt x="79" y="165"/>
                    </a:lnTo>
                    <a:lnTo>
                      <a:pt x="95" y="39"/>
                    </a:lnTo>
                    <a:lnTo>
                      <a:pt x="110" y="52"/>
                    </a:lnTo>
                    <a:lnTo>
                      <a:pt x="125" y="90"/>
                    </a:lnTo>
                    <a:lnTo>
                      <a:pt x="141" y="160"/>
                    </a:lnTo>
                    <a:lnTo>
                      <a:pt x="156" y="83"/>
                    </a:lnTo>
                    <a:lnTo>
                      <a:pt x="171" y="113"/>
                    </a:lnTo>
                    <a:lnTo>
                      <a:pt x="187" y="115"/>
                    </a:lnTo>
                    <a:lnTo>
                      <a:pt x="202" y="90"/>
                    </a:lnTo>
                    <a:lnTo>
                      <a:pt x="217" y="125"/>
                    </a:lnTo>
                    <a:lnTo>
                      <a:pt x="233" y="85"/>
                    </a:lnTo>
                    <a:lnTo>
                      <a:pt x="248" y="56"/>
                    </a:lnTo>
                    <a:lnTo>
                      <a:pt x="264" y="106"/>
                    </a:lnTo>
                    <a:lnTo>
                      <a:pt x="279" y="85"/>
                    </a:lnTo>
                    <a:lnTo>
                      <a:pt x="294" y="71"/>
                    </a:lnTo>
                    <a:lnTo>
                      <a:pt x="310" y="104"/>
                    </a:lnTo>
                    <a:lnTo>
                      <a:pt x="325" y="96"/>
                    </a:lnTo>
                    <a:lnTo>
                      <a:pt x="340" y="119"/>
                    </a:lnTo>
                    <a:lnTo>
                      <a:pt x="356" y="127"/>
                    </a:lnTo>
                    <a:lnTo>
                      <a:pt x="371" y="104"/>
                    </a:lnTo>
                    <a:lnTo>
                      <a:pt x="386" y="90"/>
                    </a:lnTo>
                    <a:lnTo>
                      <a:pt x="404" y="81"/>
                    </a:lnTo>
                    <a:lnTo>
                      <a:pt x="419" y="106"/>
                    </a:lnTo>
                    <a:lnTo>
                      <a:pt x="434" y="87"/>
                    </a:lnTo>
                    <a:lnTo>
                      <a:pt x="450" y="113"/>
                    </a:lnTo>
                    <a:lnTo>
                      <a:pt x="465" y="110"/>
                    </a:lnTo>
                    <a:lnTo>
                      <a:pt x="481" y="112"/>
                    </a:lnTo>
                    <a:lnTo>
                      <a:pt x="496" y="171"/>
                    </a:lnTo>
                    <a:lnTo>
                      <a:pt x="511" y="167"/>
                    </a:lnTo>
                    <a:lnTo>
                      <a:pt x="527" y="60"/>
                    </a:lnTo>
                    <a:lnTo>
                      <a:pt x="542" y="60"/>
                    </a:lnTo>
                    <a:lnTo>
                      <a:pt x="557" y="254"/>
                    </a:lnTo>
                    <a:lnTo>
                      <a:pt x="573" y="285"/>
                    </a:lnTo>
                    <a:lnTo>
                      <a:pt x="588" y="131"/>
                    </a:lnTo>
                    <a:lnTo>
                      <a:pt x="603" y="75"/>
                    </a:lnTo>
                    <a:lnTo>
                      <a:pt x="619" y="100"/>
                    </a:lnTo>
                    <a:lnTo>
                      <a:pt x="634" y="187"/>
                    </a:lnTo>
                    <a:lnTo>
                      <a:pt x="649" y="110"/>
                    </a:lnTo>
                    <a:lnTo>
                      <a:pt x="665" y="85"/>
                    </a:lnTo>
                    <a:lnTo>
                      <a:pt x="680" y="87"/>
                    </a:lnTo>
                    <a:lnTo>
                      <a:pt x="696" y="210"/>
                    </a:lnTo>
                    <a:lnTo>
                      <a:pt x="711" y="64"/>
                    </a:lnTo>
                    <a:lnTo>
                      <a:pt x="728" y="106"/>
                    </a:lnTo>
                    <a:lnTo>
                      <a:pt x="744" y="152"/>
                    </a:lnTo>
                    <a:lnTo>
                      <a:pt x="759" y="58"/>
                    </a:lnTo>
                    <a:lnTo>
                      <a:pt x="774" y="131"/>
                    </a:lnTo>
                    <a:lnTo>
                      <a:pt x="790" y="77"/>
                    </a:lnTo>
                    <a:lnTo>
                      <a:pt x="805" y="110"/>
                    </a:lnTo>
                    <a:lnTo>
                      <a:pt x="820" y="148"/>
                    </a:lnTo>
                    <a:lnTo>
                      <a:pt x="836" y="152"/>
                    </a:lnTo>
                    <a:lnTo>
                      <a:pt x="851" y="108"/>
                    </a:lnTo>
                    <a:lnTo>
                      <a:pt x="866" y="0"/>
                    </a:lnTo>
                    <a:lnTo>
                      <a:pt x="882" y="19"/>
                    </a:lnTo>
                    <a:lnTo>
                      <a:pt x="897" y="142"/>
                    </a:lnTo>
                    <a:lnTo>
                      <a:pt x="913" y="65"/>
                    </a:lnTo>
                    <a:lnTo>
                      <a:pt x="928" y="131"/>
                    </a:lnTo>
                    <a:lnTo>
                      <a:pt x="943" y="115"/>
                    </a:lnTo>
                    <a:lnTo>
                      <a:pt x="959" y="90"/>
                    </a:lnTo>
                    <a:lnTo>
                      <a:pt x="974" y="123"/>
                    </a:lnTo>
                    <a:lnTo>
                      <a:pt x="989" y="100"/>
                    </a:lnTo>
                    <a:lnTo>
                      <a:pt x="1005" y="69"/>
                    </a:lnTo>
                    <a:lnTo>
                      <a:pt x="1020" y="96"/>
                    </a:lnTo>
                    <a:lnTo>
                      <a:pt x="1035" y="167"/>
                    </a:lnTo>
                    <a:lnTo>
                      <a:pt x="1053" y="165"/>
                    </a:lnTo>
                    <a:lnTo>
                      <a:pt x="1068" y="106"/>
                    </a:lnTo>
                    <a:lnTo>
                      <a:pt x="1083" y="50"/>
                    </a:lnTo>
                    <a:lnTo>
                      <a:pt x="1099" y="104"/>
                    </a:lnTo>
                    <a:lnTo>
                      <a:pt x="1114" y="96"/>
                    </a:lnTo>
                    <a:lnTo>
                      <a:pt x="1130" y="42"/>
                    </a:lnTo>
                    <a:lnTo>
                      <a:pt x="1145" y="119"/>
                    </a:lnTo>
                    <a:lnTo>
                      <a:pt x="1160" y="173"/>
                    </a:lnTo>
                    <a:lnTo>
                      <a:pt x="1176" y="142"/>
                    </a:lnTo>
                    <a:lnTo>
                      <a:pt x="1191" y="169"/>
                    </a:lnTo>
                    <a:lnTo>
                      <a:pt x="1206" y="77"/>
                    </a:lnTo>
                    <a:lnTo>
                      <a:pt x="1222" y="152"/>
                    </a:lnTo>
                    <a:lnTo>
                      <a:pt x="1237" y="142"/>
                    </a:lnTo>
                    <a:lnTo>
                      <a:pt x="1252" y="187"/>
                    </a:lnTo>
                    <a:lnTo>
                      <a:pt x="1268" y="169"/>
                    </a:lnTo>
                    <a:lnTo>
                      <a:pt x="1283" y="173"/>
                    </a:lnTo>
                    <a:lnTo>
                      <a:pt x="1299" y="123"/>
                    </a:lnTo>
                    <a:lnTo>
                      <a:pt x="1314" y="190"/>
                    </a:lnTo>
                    <a:lnTo>
                      <a:pt x="1329" y="288"/>
                    </a:lnTo>
                    <a:lnTo>
                      <a:pt x="1345" y="288"/>
                    </a:lnTo>
                    <a:lnTo>
                      <a:pt x="1360" y="71"/>
                    </a:lnTo>
                    <a:lnTo>
                      <a:pt x="1377" y="123"/>
                    </a:lnTo>
                    <a:lnTo>
                      <a:pt x="1393" y="123"/>
                    </a:lnTo>
                    <a:lnTo>
                      <a:pt x="1408" y="73"/>
                    </a:lnTo>
                    <a:lnTo>
                      <a:pt x="1423" y="115"/>
                    </a:lnTo>
                    <a:lnTo>
                      <a:pt x="1439" y="181"/>
                    </a:lnTo>
                    <a:lnTo>
                      <a:pt x="1454" y="179"/>
                    </a:lnTo>
                    <a:lnTo>
                      <a:pt x="1469" y="156"/>
                    </a:lnTo>
                    <a:lnTo>
                      <a:pt x="1485" y="108"/>
                    </a:lnTo>
                    <a:lnTo>
                      <a:pt x="1500" y="115"/>
                    </a:lnTo>
                    <a:lnTo>
                      <a:pt x="1515" y="146"/>
                    </a:lnTo>
                    <a:lnTo>
                      <a:pt x="1531" y="104"/>
                    </a:lnTo>
                    <a:lnTo>
                      <a:pt x="1546" y="152"/>
                    </a:lnTo>
                    <a:lnTo>
                      <a:pt x="1562" y="112"/>
                    </a:lnTo>
                    <a:lnTo>
                      <a:pt x="1577" y="142"/>
                    </a:lnTo>
                    <a:lnTo>
                      <a:pt x="1592" y="281"/>
                    </a:lnTo>
                    <a:lnTo>
                      <a:pt x="1608" y="235"/>
                    </a:lnTo>
                    <a:lnTo>
                      <a:pt x="1623" y="119"/>
                    </a:lnTo>
                    <a:lnTo>
                      <a:pt x="1638" y="119"/>
                    </a:lnTo>
                    <a:lnTo>
                      <a:pt x="1654" y="200"/>
                    </a:lnTo>
                    <a:lnTo>
                      <a:pt x="1669" y="138"/>
                    </a:lnTo>
                    <a:lnTo>
                      <a:pt x="1684" y="108"/>
                    </a:lnTo>
                    <a:lnTo>
                      <a:pt x="1702" y="286"/>
                    </a:lnTo>
                    <a:lnTo>
                      <a:pt x="1717" y="250"/>
                    </a:lnTo>
                    <a:lnTo>
                      <a:pt x="1732" y="71"/>
                    </a:lnTo>
                    <a:lnTo>
                      <a:pt x="1748" y="198"/>
                    </a:lnTo>
                    <a:lnTo>
                      <a:pt x="1763" y="158"/>
                    </a:lnTo>
                    <a:lnTo>
                      <a:pt x="1779" y="173"/>
                    </a:lnTo>
                    <a:lnTo>
                      <a:pt x="1794" y="281"/>
                    </a:lnTo>
                    <a:lnTo>
                      <a:pt x="1809" y="263"/>
                    </a:lnTo>
                    <a:lnTo>
                      <a:pt x="1825" y="288"/>
                    </a:lnTo>
                    <a:lnTo>
                      <a:pt x="1840" y="288"/>
                    </a:lnTo>
                    <a:lnTo>
                      <a:pt x="1855" y="288"/>
                    </a:lnTo>
                    <a:lnTo>
                      <a:pt x="1871" y="273"/>
                    </a:lnTo>
                    <a:lnTo>
                      <a:pt x="1886" y="288"/>
                    </a:lnTo>
                    <a:lnTo>
                      <a:pt x="1901" y="288"/>
                    </a:lnTo>
                    <a:lnTo>
                      <a:pt x="1917" y="288"/>
                    </a:lnTo>
                    <a:lnTo>
                      <a:pt x="1932" y="288"/>
                    </a:lnTo>
                    <a:lnTo>
                      <a:pt x="1948" y="288"/>
                    </a:lnTo>
                    <a:lnTo>
                      <a:pt x="1963" y="288"/>
                    </a:lnTo>
                    <a:lnTo>
                      <a:pt x="1978" y="265"/>
                    </a:lnTo>
                    <a:lnTo>
                      <a:pt x="1994" y="288"/>
                    </a:lnTo>
                    <a:lnTo>
                      <a:pt x="2009" y="271"/>
                    </a:lnTo>
                    <a:lnTo>
                      <a:pt x="2026" y="165"/>
                    </a:lnTo>
                    <a:lnTo>
                      <a:pt x="2042" y="281"/>
                    </a:lnTo>
                    <a:lnTo>
                      <a:pt x="2057" y="288"/>
                    </a:lnTo>
                    <a:lnTo>
                      <a:pt x="2072" y="279"/>
                    </a:lnTo>
                    <a:lnTo>
                      <a:pt x="2088" y="288"/>
                    </a:lnTo>
                    <a:lnTo>
                      <a:pt x="2103" y="288"/>
                    </a:lnTo>
                    <a:lnTo>
                      <a:pt x="2118" y="288"/>
                    </a:lnTo>
                    <a:lnTo>
                      <a:pt x="2134" y="263"/>
                    </a:lnTo>
                    <a:lnTo>
                      <a:pt x="2149" y="263"/>
                    </a:lnTo>
                    <a:lnTo>
                      <a:pt x="2164" y="288"/>
                    </a:lnTo>
                    <a:lnTo>
                      <a:pt x="2180" y="288"/>
                    </a:lnTo>
                    <a:lnTo>
                      <a:pt x="2195" y="275"/>
                    </a:lnTo>
                    <a:lnTo>
                      <a:pt x="2211" y="285"/>
                    </a:lnTo>
                    <a:lnTo>
                      <a:pt x="2226" y="183"/>
                    </a:lnTo>
                    <a:lnTo>
                      <a:pt x="2241" y="194"/>
                    </a:lnTo>
                    <a:lnTo>
                      <a:pt x="2257" y="179"/>
                    </a:lnTo>
                    <a:lnTo>
                      <a:pt x="2272" y="163"/>
                    </a:lnTo>
                    <a:lnTo>
                      <a:pt x="2287" y="175"/>
                    </a:lnTo>
                    <a:lnTo>
                      <a:pt x="2303" y="223"/>
                    </a:lnTo>
                    <a:lnTo>
                      <a:pt x="2318" y="181"/>
                    </a:lnTo>
                    <a:lnTo>
                      <a:pt x="2333" y="192"/>
                    </a:lnTo>
                    <a:lnTo>
                      <a:pt x="2351" y="219"/>
                    </a:lnTo>
                    <a:lnTo>
                      <a:pt x="2366" y="235"/>
                    </a:lnTo>
                    <a:lnTo>
                      <a:pt x="2381" y="244"/>
                    </a:lnTo>
                    <a:lnTo>
                      <a:pt x="2397" y="267"/>
                    </a:lnTo>
                    <a:lnTo>
                      <a:pt x="2412" y="283"/>
                    </a:lnTo>
                    <a:lnTo>
                      <a:pt x="2428" y="288"/>
                    </a:lnTo>
                    <a:lnTo>
                      <a:pt x="2443" y="281"/>
                    </a:lnTo>
                    <a:lnTo>
                      <a:pt x="2458" y="283"/>
                    </a:lnTo>
                    <a:lnTo>
                      <a:pt x="2474" y="288"/>
                    </a:lnTo>
                    <a:lnTo>
                      <a:pt x="2489" y="288"/>
                    </a:lnTo>
                    <a:lnTo>
                      <a:pt x="2504" y="288"/>
                    </a:lnTo>
                    <a:lnTo>
                      <a:pt x="2520" y="288"/>
                    </a:lnTo>
                    <a:lnTo>
                      <a:pt x="2535" y="285"/>
                    </a:lnTo>
                    <a:lnTo>
                      <a:pt x="2550" y="227"/>
                    </a:lnTo>
                    <a:lnTo>
                      <a:pt x="2566" y="288"/>
                    </a:lnTo>
                    <a:lnTo>
                      <a:pt x="2581" y="223"/>
                    </a:lnTo>
                    <a:lnTo>
                      <a:pt x="2597" y="261"/>
                    </a:lnTo>
                    <a:lnTo>
                      <a:pt x="2612" y="269"/>
                    </a:lnTo>
                    <a:lnTo>
                      <a:pt x="2627" y="206"/>
                    </a:lnTo>
                    <a:lnTo>
                      <a:pt x="2643" y="250"/>
                    </a:lnTo>
                    <a:lnTo>
                      <a:pt x="2658" y="227"/>
                    </a:lnTo>
                    <a:lnTo>
                      <a:pt x="2675" y="238"/>
                    </a:lnTo>
                    <a:lnTo>
                      <a:pt x="2691" y="236"/>
                    </a:lnTo>
                    <a:lnTo>
                      <a:pt x="2706" y="171"/>
                    </a:lnTo>
                    <a:lnTo>
                      <a:pt x="2721" y="219"/>
                    </a:lnTo>
                    <a:lnTo>
                      <a:pt x="2737" y="261"/>
                    </a:lnTo>
                    <a:lnTo>
                      <a:pt x="2752" y="254"/>
                    </a:lnTo>
                    <a:lnTo>
                      <a:pt x="2767" y="288"/>
                    </a:lnTo>
                    <a:lnTo>
                      <a:pt x="2783" y="283"/>
                    </a:lnTo>
                    <a:lnTo>
                      <a:pt x="2798" y="279"/>
                    </a:lnTo>
                    <a:lnTo>
                      <a:pt x="2813" y="231"/>
                    </a:lnTo>
                    <a:lnTo>
                      <a:pt x="2829" y="267"/>
                    </a:lnTo>
                    <a:lnTo>
                      <a:pt x="2844" y="285"/>
                    </a:lnTo>
                    <a:lnTo>
                      <a:pt x="2860" y="154"/>
                    </a:lnTo>
                    <a:lnTo>
                      <a:pt x="2875" y="258"/>
                    </a:lnTo>
                    <a:lnTo>
                      <a:pt x="2890" y="288"/>
                    </a:lnTo>
                    <a:lnTo>
                      <a:pt x="2906" y="286"/>
                    </a:lnTo>
                    <a:lnTo>
                      <a:pt x="2921" y="242"/>
                    </a:lnTo>
                    <a:lnTo>
                      <a:pt x="2936" y="225"/>
                    </a:lnTo>
                    <a:lnTo>
                      <a:pt x="2952" y="112"/>
                    </a:lnTo>
                    <a:lnTo>
                      <a:pt x="2967" y="236"/>
                    </a:lnTo>
                    <a:lnTo>
                      <a:pt x="2982" y="190"/>
                    </a:lnTo>
                    <a:lnTo>
                      <a:pt x="3000" y="248"/>
                    </a:lnTo>
                    <a:lnTo>
                      <a:pt x="3015" y="288"/>
                    </a:lnTo>
                    <a:lnTo>
                      <a:pt x="3030" y="288"/>
                    </a:lnTo>
                    <a:lnTo>
                      <a:pt x="3046" y="288"/>
                    </a:lnTo>
                    <a:lnTo>
                      <a:pt x="3061" y="288"/>
                    </a:lnTo>
                    <a:lnTo>
                      <a:pt x="3077" y="288"/>
                    </a:lnTo>
                    <a:lnTo>
                      <a:pt x="3092" y="288"/>
                    </a:lnTo>
                    <a:lnTo>
                      <a:pt x="3107" y="288"/>
                    </a:lnTo>
                    <a:lnTo>
                      <a:pt x="3123" y="288"/>
                    </a:lnTo>
                    <a:lnTo>
                      <a:pt x="3138" y="288"/>
                    </a:lnTo>
                    <a:lnTo>
                      <a:pt x="3153" y="283"/>
                    </a:lnTo>
                    <a:lnTo>
                      <a:pt x="3169" y="288"/>
                    </a:lnTo>
                    <a:lnTo>
                      <a:pt x="3184" y="265"/>
                    </a:lnTo>
                    <a:lnTo>
                      <a:pt x="3199" y="281"/>
                    </a:lnTo>
                    <a:lnTo>
                      <a:pt x="3215" y="277"/>
                    </a:lnTo>
                    <a:lnTo>
                      <a:pt x="3230" y="288"/>
                    </a:lnTo>
                    <a:lnTo>
                      <a:pt x="3246" y="288"/>
                    </a:lnTo>
                    <a:lnTo>
                      <a:pt x="3261" y="281"/>
                    </a:lnTo>
                    <a:lnTo>
                      <a:pt x="3276" y="288"/>
                    </a:lnTo>
                    <a:lnTo>
                      <a:pt x="3292" y="267"/>
                    </a:lnTo>
                    <a:lnTo>
                      <a:pt x="3307" y="279"/>
                    </a:lnTo>
                    <a:lnTo>
                      <a:pt x="3324" y="288"/>
                    </a:lnTo>
                    <a:lnTo>
                      <a:pt x="3340" y="281"/>
                    </a:lnTo>
                    <a:lnTo>
                      <a:pt x="3355" y="288"/>
                    </a:lnTo>
                    <a:lnTo>
                      <a:pt x="3370" y="288"/>
                    </a:lnTo>
                    <a:lnTo>
                      <a:pt x="3386" y="288"/>
                    </a:lnTo>
                    <a:lnTo>
                      <a:pt x="3401" y="286"/>
                    </a:lnTo>
                    <a:lnTo>
                      <a:pt x="3416" y="221"/>
                    </a:lnTo>
                    <a:lnTo>
                      <a:pt x="3432" y="263"/>
                    </a:lnTo>
                    <a:lnTo>
                      <a:pt x="3447" y="194"/>
                    </a:lnTo>
                    <a:lnTo>
                      <a:pt x="3462" y="158"/>
                    </a:lnTo>
                    <a:lnTo>
                      <a:pt x="3478" y="210"/>
                    </a:lnTo>
                    <a:lnTo>
                      <a:pt x="3493" y="242"/>
                    </a:lnTo>
                    <a:lnTo>
                      <a:pt x="3509" y="286"/>
                    </a:lnTo>
                    <a:lnTo>
                      <a:pt x="3524" y="219"/>
                    </a:lnTo>
                    <a:lnTo>
                      <a:pt x="3539" y="267"/>
                    </a:lnTo>
                    <a:lnTo>
                      <a:pt x="3555" y="277"/>
                    </a:lnTo>
                    <a:lnTo>
                      <a:pt x="3570" y="281"/>
                    </a:lnTo>
                    <a:lnTo>
                      <a:pt x="3585" y="77"/>
                    </a:lnTo>
                    <a:lnTo>
                      <a:pt x="3601" y="175"/>
                    </a:lnTo>
                    <a:lnTo>
                      <a:pt x="3616" y="177"/>
                    </a:lnTo>
                    <a:lnTo>
                      <a:pt x="3631" y="133"/>
                    </a:lnTo>
                    <a:lnTo>
                      <a:pt x="3649" y="165"/>
                    </a:lnTo>
                    <a:lnTo>
                      <a:pt x="3664" y="83"/>
                    </a:lnTo>
                    <a:lnTo>
                      <a:pt x="3679" y="144"/>
                    </a:lnTo>
                    <a:lnTo>
                      <a:pt x="3695" y="181"/>
                    </a:lnTo>
                    <a:lnTo>
                      <a:pt x="3710" y="258"/>
                    </a:lnTo>
                    <a:lnTo>
                      <a:pt x="3726" y="73"/>
                    </a:lnTo>
                    <a:lnTo>
                      <a:pt x="3741" y="131"/>
                    </a:lnTo>
                    <a:lnTo>
                      <a:pt x="3756" y="146"/>
                    </a:lnTo>
                    <a:lnTo>
                      <a:pt x="3772" y="160"/>
                    </a:lnTo>
                    <a:lnTo>
                      <a:pt x="3787" y="123"/>
                    </a:lnTo>
                    <a:lnTo>
                      <a:pt x="3802" y="37"/>
                    </a:lnTo>
                    <a:lnTo>
                      <a:pt x="3818" y="117"/>
                    </a:lnTo>
                    <a:lnTo>
                      <a:pt x="3833" y="142"/>
                    </a:lnTo>
                    <a:lnTo>
                      <a:pt x="3848" y="198"/>
                    </a:lnTo>
                    <a:lnTo>
                      <a:pt x="3864" y="150"/>
                    </a:lnTo>
                    <a:lnTo>
                      <a:pt x="3879" y="73"/>
                    </a:lnTo>
                    <a:lnTo>
                      <a:pt x="3895" y="90"/>
                    </a:lnTo>
                    <a:lnTo>
                      <a:pt x="3910" y="81"/>
                    </a:lnTo>
                    <a:lnTo>
                      <a:pt x="3925" y="73"/>
                    </a:lnTo>
                    <a:lnTo>
                      <a:pt x="3941" y="65"/>
                    </a:lnTo>
                    <a:lnTo>
                      <a:pt x="3956" y="100"/>
                    </a:lnTo>
                    <a:lnTo>
                      <a:pt x="3973" y="60"/>
                    </a:lnTo>
                    <a:lnTo>
                      <a:pt x="3989" y="138"/>
                    </a:lnTo>
                    <a:lnTo>
                      <a:pt x="4004" y="81"/>
                    </a:lnTo>
                    <a:lnTo>
                      <a:pt x="4019" y="108"/>
                    </a:lnTo>
                    <a:lnTo>
                      <a:pt x="4035" y="135"/>
                    </a:lnTo>
                    <a:lnTo>
                      <a:pt x="4050" y="185"/>
                    </a:lnTo>
                    <a:lnTo>
                      <a:pt x="4065" y="48"/>
                    </a:lnTo>
                    <a:lnTo>
                      <a:pt x="4081" y="181"/>
                    </a:lnTo>
                    <a:lnTo>
                      <a:pt x="4096" y="169"/>
                    </a:lnTo>
                    <a:lnTo>
                      <a:pt x="4111" y="187"/>
                    </a:lnTo>
                    <a:lnTo>
                      <a:pt x="4127" y="108"/>
                    </a:lnTo>
                    <a:lnTo>
                      <a:pt x="4142" y="158"/>
                    </a:lnTo>
                    <a:lnTo>
                      <a:pt x="4158" y="69"/>
                    </a:lnTo>
                    <a:lnTo>
                      <a:pt x="4173" y="156"/>
                    </a:lnTo>
                    <a:lnTo>
                      <a:pt x="4188" y="123"/>
                    </a:lnTo>
                    <a:lnTo>
                      <a:pt x="4204" y="71"/>
                    </a:lnTo>
                    <a:lnTo>
                      <a:pt x="4219" y="50"/>
                    </a:lnTo>
                    <a:lnTo>
                      <a:pt x="4234" y="183"/>
                    </a:lnTo>
                    <a:lnTo>
                      <a:pt x="4250" y="135"/>
                    </a:lnTo>
                    <a:lnTo>
                      <a:pt x="4265" y="148"/>
                    </a:lnTo>
                    <a:lnTo>
                      <a:pt x="4280" y="133"/>
                    </a:lnTo>
                    <a:lnTo>
                      <a:pt x="4298" y="135"/>
                    </a:lnTo>
                    <a:lnTo>
                      <a:pt x="4313" y="163"/>
                    </a:lnTo>
                    <a:lnTo>
                      <a:pt x="4328" y="65"/>
                    </a:lnTo>
                    <a:lnTo>
                      <a:pt x="4344" y="121"/>
                    </a:lnTo>
                    <a:lnTo>
                      <a:pt x="4359" y="75"/>
                    </a:lnTo>
                    <a:lnTo>
                      <a:pt x="4375" y="123"/>
                    </a:lnTo>
                    <a:lnTo>
                      <a:pt x="4390" y="79"/>
                    </a:lnTo>
                    <a:lnTo>
                      <a:pt x="4405" y="152"/>
                    </a:lnTo>
                    <a:lnTo>
                      <a:pt x="4421" y="50"/>
                    </a:lnTo>
                    <a:lnTo>
                      <a:pt x="4436" y="156"/>
                    </a:lnTo>
                    <a:lnTo>
                      <a:pt x="4451" y="177"/>
                    </a:lnTo>
                    <a:lnTo>
                      <a:pt x="4467" y="133"/>
                    </a:lnTo>
                    <a:lnTo>
                      <a:pt x="4482" y="94"/>
                    </a:lnTo>
                    <a:lnTo>
                      <a:pt x="4497" y="89"/>
                    </a:lnTo>
                    <a:lnTo>
                      <a:pt x="4513" y="39"/>
                    </a:lnTo>
                    <a:lnTo>
                      <a:pt x="4528" y="37"/>
                    </a:lnTo>
                    <a:lnTo>
                      <a:pt x="4544" y="117"/>
                    </a:lnTo>
                    <a:lnTo>
                      <a:pt x="4559" y="87"/>
                    </a:lnTo>
                    <a:lnTo>
                      <a:pt x="4574" y="31"/>
                    </a:lnTo>
                    <a:lnTo>
                      <a:pt x="4590" y="73"/>
                    </a:lnTo>
                    <a:lnTo>
                      <a:pt x="4605" y="25"/>
                    </a:lnTo>
                    <a:lnTo>
                      <a:pt x="4622" y="129"/>
                    </a:lnTo>
                    <a:lnTo>
                      <a:pt x="4638" y="92"/>
                    </a:lnTo>
                    <a:lnTo>
                      <a:pt x="4653" y="85"/>
                    </a:lnTo>
                    <a:lnTo>
                      <a:pt x="4668" y="104"/>
                    </a:lnTo>
                    <a:lnTo>
                      <a:pt x="4684" y="42"/>
                    </a:lnTo>
                    <a:lnTo>
                      <a:pt x="4699" y="62"/>
                    </a:lnTo>
                    <a:lnTo>
                      <a:pt x="4714" y="112"/>
                    </a:lnTo>
                    <a:lnTo>
                      <a:pt x="4730" y="44"/>
                    </a:lnTo>
                    <a:lnTo>
                      <a:pt x="4745" y="89"/>
                    </a:lnTo>
                    <a:lnTo>
                      <a:pt x="4761" y="54"/>
                    </a:lnTo>
                    <a:lnTo>
                      <a:pt x="4776" y="85"/>
                    </a:lnTo>
                    <a:lnTo>
                      <a:pt x="4791" y="62"/>
                    </a:lnTo>
                    <a:lnTo>
                      <a:pt x="4807" y="44"/>
                    </a:lnTo>
                    <a:lnTo>
                      <a:pt x="4822" y="129"/>
                    </a:lnTo>
                    <a:lnTo>
                      <a:pt x="4837" y="113"/>
                    </a:lnTo>
                    <a:lnTo>
                      <a:pt x="4853" y="58"/>
                    </a:lnTo>
                    <a:lnTo>
                      <a:pt x="4868" y="106"/>
                    </a:lnTo>
                    <a:lnTo>
                      <a:pt x="4883" y="35"/>
                    </a:lnTo>
                    <a:lnTo>
                      <a:pt x="4899" y="112"/>
                    </a:lnTo>
                    <a:lnTo>
                      <a:pt x="4914" y="71"/>
                    </a:lnTo>
                    <a:lnTo>
                      <a:pt x="4929" y="211"/>
                    </a:lnTo>
                    <a:lnTo>
                      <a:pt x="4947" y="175"/>
                    </a:lnTo>
                    <a:lnTo>
                      <a:pt x="4962" y="152"/>
                    </a:lnTo>
                    <a:lnTo>
                      <a:pt x="4977" y="108"/>
                    </a:lnTo>
                    <a:lnTo>
                      <a:pt x="4993" y="35"/>
                    </a:lnTo>
                    <a:lnTo>
                      <a:pt x="5008" y="85"/>
                    </a:lnTo>
                    <a:lnTo>
                      <a:pt x="5024" y="29"/>
                    </a:lnTo>
                    <a:lnTo>
                      <a:pt x="5039" y="160"/>
                    </a:lnTo>
                    <a:lnTo>
                      <a:pt x="5054" y="204"/>
                    </a:lnTo>
                    <a:lnTo>
                      <a:pt x="5070" y="150"/>
                    </a:lnTo>
                    <a:lnTo>
                      <a:pt x="5085" y="92"/>
                    </a:lnTo>
                    <a:lnTo>
                      <a:pt x="5100" y="69"/>
                    </a:lnTo>
                    <a:lnTo>
                      <a:pt x="5116" y="100"/>
                    </a:lnTo>
                    <a:lnTo>
                      <a:pt x="5131" y="117"/>
                    </a:lnTo>
                    <a:lnTo>
                      <a:pt x="5146" y="56"/>
                    </a:lnTo>
                    <a:lnTo>
                      <a:pt x="5162" y="75"/>
                    </a:lnTo>
                    <a:lnTo>
                      <a:pt x="5177" y="52"/>
                    </a:lnTo>
                    <a:lnTo>
                      <a:pt x="5193" y="71"/>
                    </a:lnTo>
                    <a:lnTo>
                      <a:pt x="5208" y="106"/>
                    </a:lnTo>
                    <a:lnTo>
                      <a:pt x="5223" y="65"/>
                    </a:lnTo>
                    <a:lnTo>
                      <a:pt x="5239" y="67"/>
                    </a:lnTo>
                    <a:lnTo>
                      <a:pt x="5254" y="35"/>
                    </a:lnTo>
                    <a:lnTo>
                      <a:pt x="5271" y="94"/>
                    </a:lnTo>
                    <a:lnTo>
                      <a:pt x="5287" y="110"/>
                    </a:lnTo>
                    <a:lnTo>
                      <a:pt x="5302" y="158"/>
                    </a:lnTo>
                    <a:lnTo>
                      <a:pt x="5317" y="29"/>
                    </a:lnTo>
                    <a:lnTo>
                      <a:pt x="5333" y="154"/>
                    </a:lnTo>
                    <a:lnTo>
                      <a:pt x="5348" y="25"/>
                    </a:lnTo>
                    <a:lnTo>
                      <a:pt x="5363" y="90"/>
                    </a:lnTo>
                    <a:lnTo>
                      <a:pt x="5379" y="152"/>
                    </a:lnTo>
                    <a:lnTo>
                      <a:pt x="5394" y="181"/>
                    </a:lnTo>
                    <a:lnTo>
                      <a:pt x="5410" y="77"/>
                    </a:lnTo>
                    <a:lnTo>
                      <a:pt x="5410" y="288"/>
                    </a:lnTo>
                    <a:lnTo>
                      <a:pt x="5394" y="288"/>
                    </a:lnTo>
                    <a:lnTo>
                      <a:pt x="5379" y="288"/>
                    </a:lnTo>
                    <a:lnTo>
                      <a:pt x="5363" y="288"/>
                    </a:lnTo>
                    <a:lnTo>
                      <a:pt x="5348" y="288"/>
                    </a:lnTo>
                    <a:lnTo>
                      <a:pt x="5333" y="288"/>
                    </a:lnTo>
                    <a:lnTo>
                      <a:pt x="5317" y="288"/>
                    </a:lnTo>
                    <a:lnTo>
                      <a:pt x="5302" y="288"/>
                    </a:lnTo>
                    <a:lnTo>
                      <a:pt x="5287" y="288"/>
                    </a:lnTo>
                    <a:lnTo>
                      <a:pt x="5271" y="288"/>
                    </a:lnTo>
                    <a:lnTo>
                      <a:pt x="5254" y="288"/>
                    </a:lnTo>
                    <a:lnTo>
                      <a:pt x="5239" y="288"/>
                    </a:lnTo>
                    <a:lnTo>
                      <a:pt x="5223" y="288"/>
                    </a:lnTo>
                    <a:lnTo>
                      <a:pt x="5208" y="288"/>
                    </a:lnTo>
                    <a:lnTo>
                      <a:pt x="5193" y="288"/>
                    </a:lnTo>
                    <a:lnTo>
                      <a:pt x="5177" y="288"/>
                    </a:lnTo>
                    <a:lnTo>
                      <a:pt x="5162" y="288"/>
                    </a:lnTo>
                    <a:lnTo>
                      <a:pt x="5146" y="288"/>
                    </a:lnTo>
                    <a:lnTo>
                      <a:pt x="5131" y="288"/>
                    </a:lnTo>
                    <a:lnTo>
                      <a:pt x="5116" y="288"/>
                    </a:lnTo>
                    <a:lnTo>
                      <a:pt x="5100" y="288"/>
                    </a:lnTo>
                    <a:lnTo>
                      <a:pt x="5085" y="288"/>
                    </a:lnTo>
                    <a:lnTo>
                      <a:pt x="5070" y="288"/>
                    </a:lnTo>
                    <a:lnTo>
                      <a:pt x="5054" y="288"/>
                    </a:lnTo>
                    <a:lnTo>
                      <a:pt x="5039" y="288"/>
                    </a:lnTo>
                    <a:lnTo>
                      <a:pt x="5024" y="288"/>
                    </a:lnTo>
                    <a:lnTo>
                      <a:pt x="5008" y="288"/>
                    </a:lnTo>
                    <a:lnTo>
                      <a:pt x="4993" y="288"/>
                    </a:lnTo>
                    <a:lnTo>
                      <a:pt x="4977" y="288"/>
                    </a:lnTo>
                    <a:lnTo>
                      <a:pt x="4962" y="288"/>
                    </a:lnTo>
                    <a:lnTo>
                      <a:pt x="4947" y="288"/>
                    </a:lnTo>
                    <a:lnTo>
                      <a:pt x="4929" y="288"/>
                    </a:lnTo>
                    <a:lnTo>
                      <a:pt x="4914" y="288"/>
                    </a:lnTo>
                    <a:lnTo>
                      <a:pt x="4899" y="288"/>
                    </a:lnTo>
                    <a:lnTo>
                      <a:pt x="4883" y="288"/>
                    </a:lnTo>
                    <a:lnTo>
                      <a:pt x="4868" y="288"/>
                    </a:lnTo>
                    <a:lnTo>
                      <a:pt x="4853" y="288"/>
                    </a:lnTo>
                    <a:lnTo>
                      <a:pt x="4837" y="288"/>
                    </a:lnTo>
                    <a:lnTo>
                      <a:pt x="4822" y="288"/>
                    </a:lnTo>
                    <a:lnTo>
                      <a:pt x="4807" y="288"/>
                    </a:lnTo>
                    <a:lnTo>
                      <a:pt x="4791" y="288"/>
                    </a:lnTo>
                    <a:lnTo>
                      <a:pt x="4776" y="288"/>
                    </a:lnTo>
                    <a:lnTo>
                      <a:pt x="4761" y="288"/>
                    </a:lnTo>
                    <a:lnTo>
                      <a:pt x="4745" y="288"/>
                    </a:lnTo>
                    <a:lnTo>
                      <a:pt x="4730" y="288"/>
                    </a:lnTo>
                    <a:lnTo>
                      <a:pt x="4714" y="288"/>
                    </a:lnTo>
                    <a:lnTo>
                      <a:pt x="4699" y="288"/>
                    </a:lnTo>
                    <a:lnTo>
                      <a:pt x="4684" y="288"/>
                    </a:lnTo>
                    <a:lnTo>
                      <a:pt x="4668" y="288"/>
                    </a:lnTo>
                    <a:lnTo>
                      <a:pt x="4653" y="288"/>
                    </a:lnTo>
                    <a:lnTo>
                      <a:pt x="4638" y="288"/>
                    </a:lnTo>
                    <a:lnTo>
                      <a:pt x="4622" y="288"/>
                    </a:lnTo>
                    <a:lnTo>
                      <a:pt x="4605" y="288"/>
                    </a:lnTo>
                    <a:lnTo>
                      <a:pt x="4590" y="288"/>
                    </a:lnTo>
                    <a:lnTo>
                      <a:pt x="4574" y="288"/>
                    </a:lnTo>
                    <a:lnTo>
                      <a:pt x="4559" y="288"/>
                    </a:lnTo>
                    <a:lnTo>
                      <a:pt x="4544" y="288"/>
                    </a:lnTo>
                    <a:lnTo>
                      <a:pt x="4528" y="288"/>
                    </a:lnTo>
                    <a:lnTo>
                      <a:pt x="4513" y="288"/>
                    </a:lnTo>
                    <a:lnTo>
                      <a:pt x="4497" y="288"/>
                    </a:lnTo>
                    <a:lnTo>
                      <a:pt x="4482" y="288"/>
                    </a:lnTo>
                    <a:lnTo>
                      <a:pt x="4467" y="288"/>
                    </a:lnTo>
                    <a:lnTo>
                      <a:pt x="4451" y="288"/>
                    </a:lnTo>
                    <a:lnTo>
                      <a:pt x="4436" y="288"/>
                    </a:lnTo>
                    <a:lnTo>
                      <a:pt x="4421" y="288"/>
                    </a:lnTo>
                    <a:lnTo>
                      <a:pt x="4405" y="288"/>
                    </a:lnTo>
                    <a:lnTo>
                      <a:pt x="4390" y="288"/>
                    </a:lnTo>
                    <a:lnTo>
                      <a:pt x="4375" y="288"/>
                    </a:lnTo>
                    <a:lnTo>
                      <a:pt x="4359" y="288"/>
                    </a:lnTo>
                    <a:lnTo>
                      <a:pt x="4344" y="288"/>
                    </a:lnTo>
                    <a:lnTo>
                      <a:pt x="4328" y="288"/>
                    </a:lnTo>
                    <a:lnTo>
                      <a:pt x="4313" y="288"/>
                    </a:lnTo>
                    <a:lnTo>
                      <a:pt x="4298" y="288"/>
                    </a:lnTo>
                    <a:lnTo>
                      <a:pt x="4280" y="288"/>
                    </a:lnTo>
                    <a:lnTo>
                      <a:pt x="4265" y="288"/>
                    </a:lnTo>
                    <a:lnTo>
                      <a:pt x="4250" y="288"/>
                    </a:lnTo>
                    <a:lnTo>
                      <a:pt x="4234" y="288"/>
                    </a:lnTo>
                    <a:lnTo>
                      <a:pt x="4219" y="288"/>
                    </a:lnTo>
                    <a:lnTo>
                      <a:pt x="4204" y="288"/>
                    </a:lnTo>
                    <a:lnTo>
                      <a:pt x="4188" y="288"/>
                    </a:lnTo>
                    <a:lnTo>
                      <a:pt x="4173" y="288"/>
                    </a:lnTo>
                    <a:lnTo>
                      <a:pt x="4158" y="288"/>
                    </a:lnTo>
                    <a:lnTo>
                      <a:pt x="4142" y="288"/>
                    </a:lnTo>
                    <a:lnTo>
                      <a:pt x="4127" y="288"/>
                    </a:lnTo>
                    <a:lnTo>
                      <a:pt x="4111" y="288"/>
                    </a:lnTo>
                    <a:lnTo>
                      <a:pt x="4096" y="288"/>
                    </a:lnTo>
                    <a:lnTo>
                      <a:pt x="4081" y="288"/>
                    </a:lnTo>
                    <a:lnTo>
                      <a:pt x="4065" y="288"/>
                    </a:lnTo>
                    <a:lnTo>
                      <a:pt x="4050" y="288"/>
                    </a:lnTo>
                    <a:lnTo>
                      <a:pt x="4035" y="288"/>
                    </a:lnTo>
                    <a:lnTo>
                      <a:pt x="4019" y="288"/>
                    </a:lnTo>
                    <a:lnTo>
                      <a:pt x="4004" y="288"/>
                    </a:lnTo>
                    <a:lnTo>
                      <a:pt x="3989" y="288"/>
                    </a:lnTo>
                    <a:lnTo>
                      <a:pt x="3973" y="288"/>
                    </a:lnTo>
                    <a:lnTo>
                      <a:pt x="3956" y="288"/>
                    </a:lnTo>
                    <a:lnTo>
                      <a:pt x="3941" y="288"/>
                    </a:lnTo>
                    <a:lnTo>
                      <a:pt x="3925" y="288"/>
                    </a:lnTo>
                    <a:lnTo>
                      <a:pt x="3910" y="288"/>
                    </a:lnTo>
                    <a:lnTo>
                      <a:pt x="3895" y="288"/>
                    </a:lnTo>
                    <a:lnTo>
                      <a:pt x="3879" y="288"/>
                    </a:lnTo>
                    <a:lnTo>
                      <a:pt x="3864" y="288"/>
                    </a:lnTo>
                    <a:lnTo>
                      <a:pt x="3848" y="288"/>
                    </a:lnTo>
                    <a:lnTo>
                      <a:pt x="3833" y="288"/>
                    </a:lnTo>
                    <a:lnTo>
                      <a:pt x="3818" y="288"/>
                    </a:lnTo>
                    <a:lnTo>
                      <a:pt x="3802" y="288"/>
                    </a:lnTo>
                    <a:lnTo>
                      <a:pt x="3787" y="288"/>
                    </a:lnTo>
                    <a:lnTo>
                      <a:pt x="3772" y="288"/>
                    </a:lnTo>
                    <a:lnTo>
                      <a:pt x="3756" y="288"/>
                    </a:lnTo>
                    <a:lnTo>
                      <a:pt x="3741" y="288"/>
                    </a:lnTo>
                    <a:lnTo>
                      <a:pt x="3726" y="288"/>
                    </a:lnTo>
                    <a:lnTo>
                      <a:pt x="3710" y="288"/>
                    </a:lnTo>
                    <a:lnTo>
                      <a:pt x="3695" y="288"/>
                    </a:lnTo>
                    <a:lnTo>
                      <a:pt x="3679" y="288"/>
                    </a:lnTo>
                    <a:lnTo>
                      <a:pt x="3664" y="288"/>
                    </a:lnTo>
                    <a:lnTo>
                      <a:pt x="3649" y="288"/>
                    </a:lnTo>
                    <a:lnTo>
                      <a:pt x="3631" y="288"/>
                    </a:lnTo>
                    <a:lnTo>
                      <a:pt x="3616" y="288"/>
                    </a:lnTo>
                    <a:lnTo>
                      <a:pt x="3601" y="288"/>
                    </a:lnTo>
                    <a:lnTo>
                      <a:pt x="3585" y="288"/>
                    </a:lnTo>
                    <a:lnTo>
                      <a:pt x="3570" y="288"/>
                    </a:lnTo>
                    <a:lnTo>
                      <a:pt x="3555" y="288"/>
                    </a:lnTo>
                    <a:lnTo>
                      <a:pt x="3539" y="288"/>
                    </a:lnTo>
                    <a:lnTo>
                      <a:pt x="3524" y="288"/>
                    </a:lnTo>
                    <a:lnTo>
                      <a:pt x="3509" y="288"/>
                    </a:lnTo>
                    <a:lnTo>
                      <a:pt x="3493" y="288"/>
                    </a:lnTo>
                    <a:lnTo>
                      <a:pt x="3478" y="288"/>
                    </a:lnTo>
                    <a:lnTo>
                      <a:pt x="3462" y="288"/>
                    </a:lnTo>
                    <a:lnTo>
                      <a:pt x="3447" y="288"/>
                    </a:lnTo>
                    <a:lnTo>
                      <a:pt x="3432" y="288"/>
                    </a:lnTo>
                    <a:lnTo>
                      <a:pt x="3416" y="288"/>
                    </a:lnTo>
                    <a:lnTo>
                      <a:pt x="3401" y="288"/>
                    </a:lnTo>
                    <a:lnTo>
                      <a:pt x="3386" y="288"/>
                    </a:lnTo>
                    <a:lnTo>
                      <a:pt x="3370" y="288"/>
                    </a:lnTo>
                    <a:lnTo>
                      <a:pt x="3355" y="288"/>
                    </a:lnTo>
                    <a:lnTo>
                      <a:pt x="3340" y="288"/>
                    </a:lnTo>
                    <a:lnTo>
                      <a:pt x="3324" y="288"/>
                    </a:lnTo>
                    <a:lnTo>
                      <a:pt x="3307" y="288"/>
                    </a:lnTo>
                    <a:lnTo>
                      <a:pt x="3292" y="288"/>
                    </a:lnTo>
                    <a:lnTo>
                      <a:pt x="3276" y="288"/>
                    </a:lnTo>
                    <a:lnTo>
                      <a:pt x="3261" y="288"/>
                    </a:lnTo>
                    <a:lnTo>
                      <a:pt x="3246" y="288"/>
                    </a:lnTo>
                    <a:lnTo>
                      <a:pt x="3230" y="288"/>
                    </a:lnTo>
                    <a:lnTo>
                      <a:pt x="3215" y="288"/>
                    </a:lnTo>
                    <a:lnTo>
                      <a:pt x="3199" y="288"/>
                    </a:lnTo>
                    <a:lnTo>
                      <a:pt x="3184" y="288"/>
                    </a:lnTo>
                    <a:lnTo>
                      <a:pt x="3169" y="288"/>
                    </a:lnTo>
                    <a:lnTo>
                      <a:pt x="3153" y="288"/>
                    </a:lnTo>
                    <a:lnTo>
                      <a:pt x="3138" y="288"/>
                    </a:lnTo>
                    <a:lnTo>
                      <a:pt x="3123" y="288"/>
                    </a:lnTo>
                    <a:lnTo>
                      <a:pt x="3107" y="288"/>
                    </a:lnTo>
                    <a:lnTo>
                      <a:pt x="3092" y="288"/>
                    </a:lnTo>
                    <a:lnTo>
                      <a:pt x="3077" y="288"/>
                    </a:lnTo>
                    <a:lnTo>
                      <a:pt x="3061" y="288"/>
                    </a:lnTo>
                    <a:lnTo>
                      <a:pt x="3046" y="288"/>
                    </a:lnTo>
                    <a:lnTo>
                      <a:pt x="3030" y="288"/>
                    </a:lnTo>
                    <a:lnTo>
                      <a:pt x="3015" y="288"/>
                    </a:lnTo>
                    <a:lnTo>
                      <a:pt x="3000" y="288"/>
                    </a:lnTo>
                    <a:lnTo>
                      <a:pt x="2982" y="288"/>
                    </a:lnTo>
                    <a:lnTo>
                      <a:pt x="2967" y="288"/>
                    </a:lnTo>
                    <a:lnTo>
                      <a:pt x="2952" y="288"/>
                    </a:lnTo>
                    <a:lnTo>
                      <a:pt x="2936" y="288"/>
                    </a:lnTo>
                    <a:lnTo>
                      <a:pt x="2921" y="288"/>
                    </a:lnTo>
                    <a:lnTo>
                      <a:pt x="2906" y="288"/>
                    </a:lnTo>
                    <a:lnTo>
                      <a:pt x="2890" y="288"/>
                    </a:lnTo>
                    <a:lnTo>
                      <a:pt x="2875" y="288"/>
                    </a:lnTo>
                    <a:lnTo>
                      <a:pt x="2860" y="288"/>
                    </a:lnTo>
                    <a:lnTo>
                      <a:pt x="2844" y="288"/>
                    </a:lnTo>
                    <a:lnTo>
                      <a:pt x="2829" y="288"/>
                    </a:lnTo>
                    <a:lnTo>
                      <a:pt x="2813" y="288"/>
                    </a:lnTo>
                    <a:lnTo>
                      <a:pt x="2798" y="288"/>
                    </a:lnTo>
                    <a:lnTo>
                      <a:pt x="2783" y="288"/>
                    </a:lnTo>
                    <a:lnTo>
                      <a:pt x="2767" y="288"/>
                    </a:lnTo>
                    <a:lnTo>
                      <a:pt x="2752" y="288"/>
                    </a:lnTo>
                    <a:lnTo>
                      <a:pt x="2737" y="288"/>
                    </a:lnTo>
                    <a:lnTo>
                      <a:pt x="2721" y="288"/>
                    </a:lnTo>
                    <a:lnTo>
                      <a:pt x="2706" y="288"/>
                    </a:lnTo>
                    <a:lnTo>
                      <a:pt x="2691" y="288"/>
                    </a:lnTo>
                    <a:lnTo>
                      <a:pt x="2675" y="288"/>
                    </a:lnTo>
                    <a:lnTo>
                      <a:pt x="2658" y="288"/>
                    </a:lnTo>
                    <a:lnTo>
                      <a:pt x="2643" y="288"/>
                    </a:lnTo>
                    <a:lnTo>
                      <a:pt x="2627" y="288"/>
                    </a:lnTo>
                    <a:lnTo>
                      <a:pt x="2612" y="288"/>
                    </a:lnTo>
                    <a:lnTo>
                      <a:pt x="2597" y="288"/>
                    </a:lnTo>
                    <a:lnTo>
                      <a:pt x="2581" y="288"/>
                    </a:lnTo>
                    <a:lnTo>
                      <a:pt x="2566" y="288"/>
                    </a:lnTo>
                    <a:lnTo>
                      <a:pt x="2550" y="288"/>
                    </a:lnTo>
                    <a:lnTo>
                      <a:pt x="2535" y="288"/>
                    </a:lnTo>
                    <a:lnTo>
                      <a:pt x="2520" y="288"/>
                    </a:lnTo>
                    <a:lnTo>
                      <a:pt x="2504" y="288"/>
                    </a:lnTo>
                    <a:lnTo>
                      <a:pt x="2489" y="288"/>
                    </a:lnTo>
                    <a:lnTo>
                      <a:pt x="2474" y="288"/>
                    </a:lnTo>
                    <a:lnTo>
                      <a:pt x="2458" y="288"/>
                    </a:lnTo>
                    <a:lnTo>
                      <a:pt x="2443" y="288"/>
                    </a:lnTo>
                    <a:lnTo>
                      <a:pt x="2428" y="288"/>
                    </a:lnTo>
                    <a:lnTo>
                      <a:pt x="2412" y="288"/>
                    </a:lnTo>
                    <a:lnTo>
                      <a:pt x="2397" y="288"/>
                    </a:lnTo>
                    <a:lnTo>
                      <a:pt x="2381" y="288"/>
                    </a:lnTo>
                    <a:lnTo>
                      <a:pt x="2366" y="288"/>
                    </a:lnTo>
                    <a:lnTo>
                      <a:pt x="2351" y="288"/>
                    </a:lnTo>
                    <a:lnTo>
                      <a:pt x="2333" y="288"/>
                    </a:lnTo>
                    <a:lnTo>
                      <a:pt x="2318" y="288"/>
                    </a:lnTo>
                    <a:lnTo>
                      <a:pt x="2303" y="288"/>
                    </a:lnTo>
                    <a:lnTo>
                      <a:pt x="2287" y="288"/>
                    </a:lnTo>
                    <a:lnTo>
                      <a:pt x="2272" y="288"/>
                    </a:lnTo>
                    <a:lnTo>
                      <a:pt x="2257" y="288"/>
                    </a:lnTo>
                    <a:lnTo>
                      <a:pt x="2241" y="288"/>
                    </a:lnTo>
                    <a:lnTo>
                      <a:pt x="2226" y="288"/>
                    </a:lnTo>
                    <a:lnTo>
                      <a:pt x="2211" y="288"/>
                    </a:lnTo>
                    <a:lnTo>
                      <a:pt x="2195" y="288"/>
                    </a:lnTo>
                    <a:lnTo>
                      <a:pt x="2180" y="288"/>
                    </a:lnTo>
                    <a:lnTo>
                      <a:pt x="2164" y="288"/>
                    </a:lnTo>
                    <a:lnTo>
                      <a:pt x="2149" y="288"/>
                    </a:lnTo>
                    <a:lnTo>
                      <a:pt x="2134" y="288"/>
                    </a:lnTo>
                    <a:lnTo>
                      <a:pt x="2118" y="288"/>
                    </a:lnTo>
                    <a:lnTo>
                      <a:pt x="2103" y="288"/>
                    </a:lnTo>
                    <a:lnTo>
                      <a:pt x="2088" y="288"/>
                    </a:lnTo>
                    <a:lnTo>
                      <a:pt x="2072" y="288"/>
                    </a:lnTo>
                    <a:lnTo>
                      <a:pt x="2057" y="288"/>
                    </a:lnTo>
                    <a:lnTo>
                      <a:pt x="2042" y="288"/>
                    </a:lnTo>
                    <a:lnTo>
                      <a:pt x="2026" y="288"/>
                    </a:lnTo>
                    <a:lnTo>
                      <a:pt x="2009" y="288"/>
                    </a:lnTo>
                    <a:lnTo>
                      <a:pt x="1994" y="288"/>
                    </a:lnTo>
                    <a:lnTo>
                      <a:pt x="1978" y="288"/>
                    </a:lnTo>
                    <a:lnTo>
                      <a:pt x="1963" y="288"/>
                    </a:lnTo>
                    <a:lnTo>
                      <a:pt x="1948" y="288"/>
                    </a:lnTo>
                    <a:lnTo>
                      <a:pt x="1932" y="288"/>
                    </a:lnTo>
                    <a:lnTo>
                      <a:pt x="1917" y="288"/>
                    </a:lnTo>
                    <a:lnTo>
                      <a:pt x="1901" y="288"/>
                    </a:lnTo>
                    <a:lnTo>
                      <a:pt x="1886" y="288"/>
                    </a:lnTo>
                    <a:lnTo>
                      <a:pt x="1871" y="288"/>
                    </a:lnTo>
                    <a:lnTo>
                      <a:pt x="1855" y="288"/>
                    </a:lnTo>
                    <a:lnTo>
                      <a:pt x="1840" y="288"/>
                    </a:lnTo>
                    <a:lnTo>
                      <a:pt x="1825" y="288"/>
                    </a:lnTo>
                    <a:lnTo>
                      <a:pt x="1809" y="288"/>
                    </a:lnTo>
                    <a:lnTo>
                      <a:pt x="1794" y="288"/>
                    </a:lnTo>
                    <a:lnTo>
                      <a:pt x="1779" y="288"/>
                    </a:lnTo>
                    <a:lnTo>
                      <a:pt x="1763" y="288"/>
                    </a:lnTo>
                    <a:lnTo>
                      <a:pt x="1748" y="288"/>
                    </a:lnTo>
                    <a:lnTo>
                      <a:pt x="1732" y="288"/>
                    </a:lnTo>
                    <a:lnTo>
                      <a:pt x="1717" y="288"/>
                    </a:lnTo>
                    <a:lnTo>
                      <a:pt x="1702" y="288"/>
                    </a:lnTo>
                    <a:lnTo>
                      <a:pt x="1684" y="288"/>
                    </a:lnTo>
                    <a:lnTo>
                      <a:pt x="1669" y="288"/>
                    </a:lnTo>
                    <a:lnTo>
                      <a:pt x="1654" y="288"/>
                    </a:lnTo>
                    <a:lnTo>
                      <a:pt x="1638" y="288"/>
                    </a:lnTo>
                    <a:lnTo>
                      <a:pt x="1623" y="288"/>
                    </a:lnTo>
                    <a:lnTo>
                      <a:pt x="1608" y="288"/>
                    </a:lnTo>
                    <a:lnTo>
                      <a:pt x="1592" y="288"/>
                    </a:lnTo>
                    <a:lnTo>
                      <a:pt x="1577" y="288"/>
                    </a:lnTo>
                    <a:lnTo>
                      <a:pt x="1562" y="288"/>
                    </a:lnTo>
                    <a:lnTo>
                      <a:pt x="1546" y="288"/>
                    </a:lnTo>
                    <a:lnTo>
                      <a:pt x="1531" y="288"/>
                    </a:lnTo>
                    <a:lnTo>
                      <a:pt x="1515" y="288"/>
                    </a:lnTo>
                    <a:lnTo>
                      <a:pt x="1500" y="288"/>
                    </a:lnTo>
                    <a:lnTo>
                      <a:pt x="1485" y="288"/>
                    </a:lnTo>
                    <a:lnTo>
                      <a:pt x="1469" y="288"/>
                    </a:lnTo>
                    <a:lnTo>
                      <a:pt x="1454" y="288"/>
                    </a:lnTo>
                    <a:lnTo>
                      <a:pt x="1439" y="288"/>
                    </a:lnTo>
                    <a:lnTo>
                      <a:pt x="1423" y="288"/>
                    </a:lnTo>
                    <a:lnTo>
                      <a:pt x="1408" y="288"/>
                    </a:lnTo>
                    <a:lnTo>
                      <a:pt x="1393" y="288"/>
                    </a:lnTo>
                    <a:lnTo>
                      <a:pt x="1377" y="288"/>
                    </a:lnTo>
                    <a:lnTo>
                      <a:pt x="1360" y="288"/>
                    </a:lnTo>
                    <a:lnTo>
                      <a:pt x="1345" y="288"/>
                    </a:lnTo>
                    <a:lnTo>
                      <a:pt x="1329" y="288"/>
                    </a:lnTo>
                    <a:lnTo>
                      <a:pt x="1314" y="288"/>
                    </a:lnTo>
                    <a:lnTo>
                      <a:pt x="1299" y="288"/>
                    </a:lnTo>
                    <a:lnTo>
                      <a:pt x="1283" y="288"/>
                    </a:lnTo>
                    <a:lnTo>
                      <a:pt x="1268" y="288"/>
                    </a:lnTo>
                    <a:lnTo>
                      <a:pt x="1252" y="288"/>
                    </a:lnTo>
                    <a:lnTo>
                      <a:pt x="1237" y="288"/>
                    </a:lnTo>
                    <a:lnTo>
                      <a:pt x="1222" y="288"/>
                    </a:lnTo>
                    <a:lnTo>
                      <a:pt x="1206" y="288"/>
                    </a:lnTo>
                    <a:lnTo>
                      <a:pt x="1191" y="288"/>
                    </a:lnTo>
                    <a:lnTo>
                      <a:pt x="1176" y="288"/>
                    </a:lnTo>
                    <a:lnTo>
                      <a:pt x="1160" y="288"/>
                    </a:lnTo>
                    <a:lnTo>
                      <a:pt x="1145" y="288"/>
                    </a:lnTo>
                    <a:lnTo>
                      <a:pt x="1130" y="288"/>
                    </a:lnTo>
                    <a:lnTo>
                      <a:pt x="1114" y="288"/>
                    </a:lnTo>
                    <a:lnTo>
                      <a:pt x="1099" y="288"/>
                    </a:lnTo>
                    <a:lnTo>
                      <a:pt x="1083" y="288"/>
                    </a:lnTo>
                    <a:lnTo>
                      <a:pt x="1068" y="288"/>
                    </a:lnTo>
                    <a:lnTo>
                      <a:pt x="1053" y="288"/>
                    </a:lnTo>
                    <a:lnTo>
                      <a:pt x="1035" y="288"/>
                    </a:lnTo>
                    <a:lnTo>
                      <a:pt x="1020" y="288"/>
                    </a:lnTo>
                    <a:lnTo>
                      <a:pt x="1005" y="288"/>
                    </a:lnTo>
                    <a:lnTo>
                      <a:pt x="989" y="288"/>
                    </a:lnTo>
                    <a:lnTo>
                      <a:pt x="974" y="288"/>
                    </a:lnTo>
                    <a:lnTo>
                      <a:pt x="959" y="288"/>
                    </a:lnTo>
                    <a:lnTo>
                      <a:pt x="943" y="288"/>
                    </a:lnTo>
                    <a:lnTo>
                      <a:pt x="928" y="288"/>
                    </a:lnTo>
                    <a:lnTo>
                      <a:pt x="913" y="288"/>
                    </a:lnTo>
                    <a:lnTo>
                      <a:pt x="897" y="288"/>
                    </a:lnTo>
                    <a:lnTo>
                      <a:pt x="882" y="288"/>
                    </a:lnTo>
                    <a:lnTo>
                      <a:pt x="866" y="288"/>
                    </a:lnTo>
                    <a:lnTo>
                      <a:pt x="851" y="288"/>
                    </a:lnTo>
                    <a:lnTo>
                      <a:pt x="836" y="288"/>
                    </a:lnTo>
                    <a:lnTo>
                      <a:pt x="820" y="288"/>
                    </a:lnTo>
                    <a:lnTo>
                      <a:pt x="805" y="288"/>
                    </a:lnTo>
                    <a:lnTo>
                      <a:pt x="790" y="288"/>
                    </a:lnTo>
                    <a:lnTo>
                      <a:pt x="774" y="288"/>
                    </a:lnTo>
                    <a:lnTo>
                      <a:pt x="759" y="288"/>
                    </a:lnTo>
                    <a:lnTo>
                      <a:pt x="744" y="288"/>
                    </a:lnTo>
                    <a:lnTo>
                      <a:pt x="728" y="288"/>
                    </a:lnTo>
                    <a:lnTo>
                      <a:pt x="711" y="288"/>
                    </a:lnTo>
                    <a:lnTo>
                      <a:pt x="696" y="288"/>
                    </a:lnTo>
                    <a:lnTo>
                      <a:pt x="680" y="288"/>
                    </a:lnTo>
                    <a:lnTo>
                      <a:pt x="665" y="288"/>
                    </a:lnTo>
                    <a:lnTo>
                      <a:pt x="649" y="288"/>
                    </a:lnTo>
                    <a:lnTo>
                      <a:pt x="634" y="288"/>
                    </a:lnTo>
                    <a:lnTo>
                      <a:pt x="619" y="288"/>
                    </a:lnTo>
                    <a:lnTo>
                      <a:pt x="603" y="288"/>
                    </a:lnTo>
                    <a:lnTo>
                      <a:pt x="588" y="288"/>
                    </a:lnTo>
                    <a:lnTo>
                      <a:pt x="573" y="288"/>
                    </a:lnTo>
                    <a:lnTo>
                      <a:pt x="557" y="288"/>
                    </a:lnTo>
                    <a:lnTo>
                      <a:pt x="542" y="288"/>
                    </a:lnTo>
                    <a:lnTo>
                      <a:pt x="527" y="288"/>
                    </a:lnTo>
                    <a:lnTo>
                      <a:pt x="511" y="288"/>
                    </a:lnTo>
                    <a:lnTo>
                      <a:pt x="496" y="288"/>
                    </a:lnTo>
                    <a:lnTo>
                      <a:pt x="481" y="288"/>
                    </a:lnTo>
                    <a:lnTo>
                      <a:pt x="465" y="288"/>
                    </a:lnTo>
                    <a:lnTo>
                      <a:pt x="450" y="288"/>
                    </a:lnTo>
                    <a:lnTo>
                      <a:pt x="434" y="288"/>
                    </a:lnTo>
                    <a:lnTo>
                      <a:pt x="419" y="288"/>
                    </a:lnTo>
                    <a:lnTo>
                      <a:pt x="404" y="288"/>
                    </a:lnTo>
                    <a:lnTo>
                      <a:pt x="386" y="288"/>
                    </a:lnTo>
                    <a:lnTo>
                      <a:pt x="371" y="288"/>
                    </a:lnTo>
                    <a:lnTo>
                      <a:pt x="356" y="288"/>
                    </a:lnTo>
                    <a:lnTo>
                      <a:pt x="340" y="288"/>
                    </a:lnTo>
                    <a:lnTo>
                      <a:pt x="325" y="288"/>
                    </a:lnTo>
                    <a:lnTo>
                      <a:pt x="310" y="288"/>
                    </a:lnTo>
                    <a:lnTo>
                      <a:pt x="294" y="288"/>
                    </a:lnTo>
                    <a:lnTo>
                      <a:pt x="279" y="288"/>
                    </a:lnTo>
                    <a:lnTo>
                      <a:pt x="264" y="288"/>
                    </a:lnTo>
                    <a:lnTo>
                      <a:pt x="248" y="288"/>
                    </a:lnTo>
                    <a:lnTo>
                      <a:pt x="233" y="288"/>
                    </a:lnTo>
                    <a:lnTo>
                      <a:pt x="217" y="288"/>
                    </a:lnTo>
                    <a:lnTo>
                      <a:pt x="202" y="288"/>
                    </a:lnTo>
                    <a:lnTo>
                      <a:pt x="187" y="288"/>
                    </a:lnTo>
                    <a:lnTo>
                      <a:pt x="171" y="288"/>
                    </a:lnTo>
                    <a:lnTo>
                      <a:pt x="156" y="288"/>
                    </a:lnTo>
                    <a:lnTo>
                      <a:pt x="141" y="288"/>
                    </a:lnTo>
                    <a:lnTo>
                      <a:pt x="125" y="288"/>
                    </a:lnTo>
                    <a:lnTo>
                      <a:pt x="110" y="288"/>
                    </a:lnTo>
                    <a:lnTo>
                      <a:pt x="95" y="288"/>
                    </a:lnTo>
                    <a:lnTo>
                      <a:pt x="79" y="288"/>
                    </a:lnTo>
                    <a:lnTo>
                      <a:pt x="62" y="288"/>
                    </a:lnTo>
                    <a:lnTo>
                      <a:pt x="47" y="288"/>
                    </a:lnTo>
                    <a:lnTo>
                      <a:pt x="31" y="288"/>
                    </a:lnTo>
                    <a:lnTo>
                      <a:pt x="16" y="288"/>
                    </a:lnTo>
                    <a:lnTo>
                      <a:pt x="0" y="288"/>
                    </a:lnTo>
                    <a:lnTo>
                      <a:pt x="0" y="223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7" name="Freeform 26"/>
              <p:cNvSpPr>
                <a:spLocks/>
              </p:cNvSpPr>
              <p:nvPr/>
            </p:nvSpPr>
            <p:spPr bwMode="auto">
              <a:xfrm rot="5400000" flipV="1">
                <a:off x="-384362" y="2728816"/>
                <a:ext cx="3520854" cy="196972"/>
              </a:xfrm>
              <a:custGeom>
                <a:avLst/>
                <a:gdLst>
                  <a:gd name="T0" fmla="*/ 166 w 5410"/>
                  <a:gd name="T1" fmla="*/ 296 h 296"/>
                  <a:gd name="T2" fmla="*/ 350 w 5410"/>
                  <a:gd name="T3" fmla="*/ 296 h 296"/>
                  <a:gd name="T4" fmla="*/ 532 w 5410"/>
                  <a:gd name="T5" fmla="*/ 296 h 296"/>
                  <a:gd name="T6" fmla="*/ 717 w 5410"/>
                  <a:gd name="T7" fmla="*/ 296 h 296"/>
                  <a:gd name="T8" fmla="*/ 899 w 5410"/>
                  <a:gd name="T9" fmla="*/ 296 h 296"/>
                  <a:gd name="T10" fmla="*/ 1083 w 5410"/>
                  <a:gd name="T11" fmla="*/ 244 h 296"/>
                  <a:gd name="T12" fmla="*/ 1266 w 5410"/>
                  <a:gd name="T13" fmla="*/ 254 h 296"/>
                  <a:gd name="T14" fmla="*/ 1450 w 5410"/>
                  <a:gd name="T15" fmla="*/ 273 h 296"/>
                  <a:gd name="T16" fmla="*/ 1633 w 5410"/>
                  <a:gd name="T17" fmla="*/ 277 h 296"/>
                  <a:gd name="T18" fmla="*/ 1817 w 5410"/>
                  <a:gd name="T19" fmla="*/ 227 h 296"/>
                  <a:gd name="T20" fmla="*/ 1999 w 5410"/>
                  <a:gd name="T21" fmla="*/ 294 h 296"/>
                  <a:gd name="T22" fmla="*/ 2184 w 5410"/>
                  <a:gd name="T23" fmla="*/ 279 h 296"/>
                  <a:gd name="T24" fmla="*/ 2366 w 5410"/>
                  <a:gd name="T25" fmla="*/ 277 h 296"/>
                  <a:gd name="T26" fmla="*/ 2549 w 5410"/>
                  <a:gd name="T27" fmla="*/ 150 h 296"/>
                  <a:gd name="T28" fmla="*/ 2733 w 5410"/>
                  <a:gd name="T29" fmla="*/ 248 h 296"/>
                  <a:gd name="T30" fmla="*/ 2915 w 5410"/>
                  <a:gd name="T31" fmla="*/ 175 h 296"/>
                  <a:gd name="T32" fmla="*/ 3100 w 5410"/>
                  <a:gd name="T33" fmla="*/ 135 h 296"/>
                  <a:gd name="T34" fmla="*/ 3282 w 5410"/>
                  <a:gd name="T35" fmla="*/ 43 h 296"/>
                  <a:gd name="T36" fmla="*/ 3466 w 5410"/>
                  <a:gd name="T37" fmla="*/ 129 h 296"/>
                  <a:gd name="T38" fmla="*/ 3649 w 5410"/>
                  <a:gd name="T39" fmla="*/ 175 h 296"/>
                  <a:gd name="T40" fmla="*/ 3833 w 5410"/>
                  <a:gd name="T41" fmla="*/ 154 h 296"/>
                  <a:gd name="T42" fmla="*/ 4015 w 5410"/>
                  <a:gd name="T43" fmla="*/ 95 h 296"/>
                  <a:gd name="T44" fmla="*/ 4200 w 5410"/>
                  <a:gd name="T45" fmla="*/ 100 h 296"/>
                  <a:gd name="T46" fmla="*/ 4382 w 5410"/>
                  <a:gd name="T47" fmla="*/ 95 h 296"/>
                  <a:gd name="T48" fmla="*/ 4567 w 5410"/>
                  <a:gd name="T49" fmla="*/ 72 h 296"/>
                  <a:gd name="T50" fmla="*/ 4749 w 5410"/>
                  <a:gd name="T51" fmla="*/ 143 h 296"/>
                  <a:gd name="T52" fmla="*/ 4933 w 5410"/>
                  <a:gd name="T53" fmla="*/ 121 h 296"/>
                  <a:gd name="T54" fmla="*/ 5116 w 5410"/>
                  <a:gd name="T55" fmla="*/ 162 h 296"/>
                  <a:gd name="T56" fmla="*/ 5300 w 5410"/>
                  <a:gd name="T57" fmla="*/ 121 h 296"/>
                  <a:gd name="T58" fmla="*/ 5354 w 5410"/>
                  <a:gd name="T59" fmla="*/ 296 h 296"/>
                  <a:gd name="T60" fmla="*/ 5171 w 5410"/>
                  <a:gd name="T61" fmla="*/ 296 h 296"/>
                  <a:gd name="T62" fmla="*/ 4987 w 5410"/>
                  <a:gd name="T63" fmla="*/ 296 h 296"/>
                  <a:gd name="T64" fmla="*/ 4805 w 5410"/>
                  <a:gd name="T65" fmla="*/ 296 h 296"/>
                  <a:gd name="T66" fmla="*/ 4620 w 5410"/>
                  <a:gd name="T67" fmla="*/ 296 h 296"/>
                  <a:gd name="T68" fmla="*/ 4438 w 5410"/>
                  <a:gd name="T69" fmla="*/ 296 h 296"/>
                  <a:gd name="T70" fmla="*/ 4254 w 5410"/>
                  <a:gd name="T71" fmla="*/ 296 h 296"/>
                  <a:gd name="T72" fmla="*/ 4071 w 5410"/>
                  <a:gd name="T73" fmla="*/ 296 h 296"/>
                  <a:gd name="T74" fmla="*/ 3887 w 5410"/>
                  <a:gd name="T75" fmla="*/ 296 h 296"/>
                  <a:gd name="T76" fmla="*/ 3704 w 5410"/>
                  <a:gd name="T77" fmla="*/ 296 h 296"/>
                  <a:gd name="T78" fmla="*/ 3522 w 5410"/>
                  <a:gd name="T79" fmla="*/ 296 h 296"/>
                  <a:gd name="T80" fmla="*/ 3338 w 5410"/>
                  <a:gd name="T81" fmla="*/ 296 h 296"/>
                  <a:gd name="T82" fmla="*/ 3155 w 5410"/>
                  <a:gd name="T83" fmla="*/ 296 h 296"/>
                  <a:gd name="T84" fmla="*/ 2971 w 5410"/>
                  <a:gd name="T85" fmla="*/ 296 h 296"/>
                  <a:gd name="T86" fmla="*/ 2789 w 5410"/>
                  <a:gd name="T87" fmla="*/ 296 h 296"/>
                  <a:gd name="T88" fmla="*/ 2604 w 5410"/>
                  <a:gd name="T89" fmla="*/ 296 h 296"/>
                  <a:gd name="T90" fmla="*/ 2422 w 5410"/>
                  <a:gd name="T91" fmla="*/ 296 h 296"/>
                  <a:gd name="T92" fmla="*/ 2237 w 5410"/>
                  <a:gd name="T93" fmla="*/ 296 h 296"/>
                  <a:gd name="T94" fmla="*/ 2055 w 5410"/>
                  <a:gd name="T95" fmla="*/ 296 h 296"/>
                  <a:gd name="T96" fmla="*/ 1871 w 5410"/>
                  <a:gd name="T97" fmla="*/ 296 h 296"/>
                  <a:gd name="T98" fmla="*/ 1688 w 5410"/>
                  <a:gd name="T99" fmla="*/ 296 h 296"/>
                  <a:gd name="T100" fmla="*/ 1504 w 5410"/>
                  <a:gd name="T101" fmla="*/ 296 h 296"/>
                  <a:gd name="T102" fmla="*/ 1322 w 5410"/>
                  <a:gd name="T103" fmla="*/ 296 h 296"/>
                  <a:gd name="T104" fmla="*/ 1137 w 5410"/>
                  <a:gd name="T105" fmla="*/ 296 h 296"/>
                  <a:gd name="T106" fmla="*/ 955 w 5410"/>
                  <a:gd name="T107" fmla="*/ 296 h 296"/>
                  <a:gd name="T108" fmla="*/ 770 w 5410"/>
                  <a:gd name="T109" fmla="*/ 296 h 296"/>
                  <a:gd name="T110" fmla="*/ 588 w 5410"/>
                  <a:gd name="T111" fmla="*/ 296 h 296"/>
                  <a:gd name="T112" fmla="*/ 404 w 5410"/>
                  <a:gd name="T113" fmla="*/ 296 h 296"/>
                  <a:gd name="T114" fmla="*/ 221 w 5410"/>
                  <a:gd name="T115" fmla="*/ 296 h 296"/>
                  <a:gd name="T116" fmla="*/ 37 w 5410"/>
                  <a:gd name="T117" fmla="*/ 296 h 2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</a:cxnLst>
                <a:rect l="0" t="0" r="r" b="b"/>
                <a:pathLst>
                  <a:path w="5410" h="296">
                    <a:moveTo>
                      <a:pt x="0" y="296"/>
                    </a:moveTo>
                    <a:lnTo>
                      <a:pt x="20" y="291"/>
                    </a:lnTo>
                    <a:lnTo>
                      <a:pt x="37" y="296"/>
                    </a:lnTo>
                    <a:lnTo>
                      <a:pt x="56" y="296"/>
                    </a:lnTo>
                    <a:lnTo>
                      <a:pt x="73" y="296"/>
                    </a:lnTo>
                    <a:lnTo>
                      <a:pt x="93" y="296"/>
                    </a:lnTo>
                    <a:lnTo>
                      <a:pt x="112" y="296"/>
                    </a:lnTo>
                    <a:lnTo>
                      <a:pt x="129" y="294"/>
                    </a:lnTo>
                    <a:lnTo>
                      <a:pt x="148" y="293"/>
                    </a:lnTo>
                    <a:lnTo>
                      <a:pt x="166" y="296"/>
                    </a:lnTo>
                    <a:lnTo>
                      <a:pt x="185" y="223"/>
                    </a:lnTo>
                    <a:lnTo>
                      <a:pt x="202" y="296"/>
                    </a:lnTo>
                    <a:lnTo>
                      <a:pt x="221" y="277"/>
                    </a:lnTo>
                    <a:lnTo>
                      <a:pt x="239" y="296"/>
                    </a:lnTo>
                    <a:lnTo>
                      <a:pt x="258" y="296"/>
                    </a:lnTo>
                    <a:lnTo>
                      <a:pt x="277" y="294"/>
                    </a:lnTo>
                    <a:lnTo>
                      <a:pt x="294" y="296"/>
                    </a:lnTo>
                    <a:lnTo>
                      <a:pt x="313" y="296"/>
                    </a:lnTo>
                    <a:lnTo>
                      <a:pt x="331" y="296"/>
                    </a:lnTo>
                    <a:lnTo>
                      <a:pt x="350" y="296"/>
                    </a:lnTo>
                    <a:lnTo>
                      <a:pt x="367" y="289"/>
                    </a:lnTo>
                    <a:lnTo>
                      <a:pt x="386" y="296"/>
                    </a:lnTo>
                    <a:lnTo>
                      <a:pt x="404" y="264"/>
                    </a:lnTo>
                    <a:lnTo>
                      <a:pt x="423" y="273"/>
                    </a:lnTo>
                    <a:lnTo>
                      <a:pt x="440" y="218"/>
                    </a:lnTo>
                    <a:lnTo>
                      <a:pt x="459" y="275"/>
                    </a:lnTo>
                    <a:lnTo>
                      <a:pt x="479" y="296"/>
                    </a:lnTo>
                    <a:lnTo>
                      <a:pt x="496" y="293"/>
                    </a:lnTo>
                    <a:lnTo>
                      <a:pt x="515" y="296"/>
                    </a:lnTo>
                    <a:lnTo>
                      <a:pt x="532" y="296"/>
                    </a:lnTo>
                    <a:lnTo>
                      <a:pt x="552" y="296"/>
                    </a:lnTo>
                    <a:lnTo>
                      <a:pt x="569" y="296"/>
                    </a:lnTo>
                    <a:lnTo>
                      <a:pt x="588" y="296"/>
                    </a:lnTo>
                    <a:lnTo>
                      <a:pt x="605" y="296"/>
                    </a:lnTo>
                    <a:lnTo>
                      <a:pt x="625" y="296"/>
                    </a:lnTo>
                    <a:lnTo>
                      <a:pt x="642" y="296"/>
                    </a:lnTo>
                    <a:lnTo>
                      <a:pt x="661" y="296"/>
                    </a:lnTo>
                    <a:lnTo>
                      <a:pt x="680" y="296"/>
                    </a:lnTo>
                    <a:lnTo>
                      <a:pt x="698" y="296"/>
                    </a:lnTo>
                    <a:lnTo>
                      <a:pt x="717" y="296"/>
                    </a:lnTo>
                    <a:lnTo>
                      <a:pt x="734" y="287"/>
                    </a:lnTo>
                    <a:lnTo>
                      <a:pt x="753" y="296"/>
                    </a:lnTo>
                    <a:lnTo>
                      <a:pt x="770" y="296"/>
                    </a:lnTo>
                    <a:lnTo>
                      <a:pt x="790" y="291"/>
                    </a:lnTo>
                    <a:lnTo>
                      <a:pt x="807" y="269"/>
                    </a:lnTo>
                    <a:lnTo>
                      <a:pt x="826" y="244"/>
                    </a:lnTo>
                    <a:lnTo>
                      <a:pt x="843" y="294"/>
                    </a:lnTo>
                    <a:lnTo>
                      <a:pt x="863" y="291"/>
                    </a:lnTo>
                    <a:lnTo>
                      <a:pt x="882" y="293"/>
                    </a:lnTo>
                    <a:lnTo>
                      <a:pt x="899" y="296"/>
                    </a:lnTo>
                    <a:lnTo>
                      <a:pt x="918" y="296"/>
                    </a:lnTo>
                    <a:lnTo>
                      <a:pt x="936" y="296"/>
                    </a:lnTo>
                    <a:lnTo>
                      <a:pt x="955" y="294"/>
                    </a:lnTo>
                    <a:lnTo>
                      <a:pt x="972" y="256"/>
                    </a:lnTo>
                    <a:lnTo>
                      <a:pt x="991" y="221"/>
                    </a:lnTo>
                    <a:lnTo>
                      <a:pt x="1009" y="281"/>
                    </a:lnTo>
                    <a:lnTo>
                      <a:pt x="1028" y="289"/>
                    </a:lnTo>
                    <a:lnTo>
                      <a:pt x="1047" y="296"/>
                    </a:lnTo>
                    <a:lnTo>
                      <a:pt x="1064" y="293"/>
                    </a:lnTo>
                    <a:lnTo>
                      <a:pt x="1083" y="244"/>
                    </a:lnTo>
                    <a:lnTo>
                      <a:pt x="1101" y="241"/>
                    </a:lnTo>
                    <a:lnTo>
                      <a:pt x="1120" y="291"/>
                    </a:lnTo>
                    <a:lnTo>
                      <a:pt x="1137" y="244"/>
                    </a:lnTo>
                    <a:lnTo>
                      <a:pt x="1156" y="243"/>
                    </a:lnTo>
                    <a:lnTo>
                      <a:pt x="1174" y="296"/>
                    </a:lnTo>
                    <a:lnTo>
                      <a:pt x="1193" y="289"/>
                    </a:lnTo>
                    <a:lnTo>
                      <a:pt x="1210" y="289"/>
                    </a:lnTo>
                    <a:lnTo>
                      <a:pt x="1229" y="287"/>
                    </a:lnTo>
                    <a:lnTo>
                      <a:pt x="1249" y="296"/>
                    </a:lnTo>
                    <a:lnTo>
                      <a:pt x="1266" y="254"/>
                    </a:lnTo>
                    <a:lnTo>
                      <a:pt x="1285" y="252"/>
                    </a:lnTo>
                    <a:lnTo>
                      <a:pt x="1302" y="268"/>
                    </a:lnTo>
                    <a:lnTo>
                      <a:pt x="1322" y="233"/>
                    </a:lnTo>
                    <a:lnTo>
                      <a:pt x="1339" y="271"/>
                    </a:lnTo>
                    <a:lnTo>
                      <a:pt x="1358" y="296"/>
                    </a:lnTo>
                    <a:lnTo>
                      <a:pt x="1375" y="296"/>
                    </a:lnTo>
                    <a:lnTo>
                      <a:pt x="1395" y="227"/>
                    </a:lnTo>
                    <a:lnTo>
                      <a:pt x="1412" y="281"/>
                    </a:lnTo>
                    <a:lnTo>
                      <a:pt x="1431" y="285"/>
                    </a:lnTo>
                    <a:lnTo>
                      <a:pt x="1450" y="273"/>
                    </a:lnTo>
                    <a:lnTo>
                      <a:pt x="1467" y="285"/>
                    </a:lnTo>
                    <a:lnTo>
                      <a:pt x="1487" y="291"/>
                    </a:lnTo>
                    <a:lnTo>
                      <a:pt x="1504" y="262"/>
                    </a:lnTo>
                    <a:lnTo>
                      <a:pt x="1523" y="294"/>
                    </a:lnTo>
                    <a:lnTo>
                      <a:pt x="1540" y="289"/>
                    </a:lnTo>
                    <a:lnTo>
                      <a:pt x="1560" y="296"/>
                    </a:lnTo>
                    <a:lnTo>
                      <a:pt x="1577" y="285"/>
                    </a:lnTo>
                    <a:lnTo>
                      <a:pt x="1596" y="293"/>
                    </a:lnTo>
                    <a:lnTo>
                      <a:pt x="1615" y="296"/>
                    </a:lnTo>
                    <a:lnTo>
                      <a:pt x="1633" y="277"/>
                    </a:lnTo>
                    <a:lnTo>
                      <a:pt x="1652" y="296"/>
                    </a:lnTo>
                    <a:lnTo>
                      <a:pt x="1669" y="293"/>
                    </a:lnTo>
                    <a:lnTo>
                      <a:pt x="1688" y="277"/>
                    </a:lnTo>
                    <a:lnTo>
                      <a:pt x="1706" y="250"/>
                    </a:lnTo>
                    <a:lnTo>
                      <a:pt x="1725" y="283"/>
                    </a:lnTo>
                    <a:lnTo>
                      <a:pt x="1742" y="294"/>
                    </a:lnTo>
                    <a:lnTo>
                      <a:pt x="1761" y="266"/>
                    </a:lnTo>
                    <a:lnTo>
                      <a:pt x="1779" y="219"/>
                    </a:lnTo>
                    <a:lnTo>
                      <a:pt x="1798" y="268"/>
                    </a:lnTo>
                    <a:lnTo>
                      <a:pt x="1817" y="227"/>
                    </a:lnTo>
                    <a:lnTo>
                      <a:pt x="1834" y="202"/>
                    </a:lnTo>
                    <a:lnTo>
                      <a:pt x="1853" y="289"/>
                    </a:lnTo>
                    <a:lnTo>
                      <a:pt x="1871" y="281"/>
                    </a:lnTo>
                    <a:lnTo>
                      <a:pt x="1890" y="277"/>
                    </a:lnTo>
                    <a:lnTo>
                      <a:pt x="1907" y="277"/>
                    </a:lnTo>
                    <a:lnTo>
                      <a:pt x="1926" y="281"/>
                    </a:lnTo>
                    <a:lnTo>
                      <a:pt x="1944" y="244"/>
                    </a:lnTo>
                    <a:lnTo>
                      <a:pt x="1963" y="296"/>
                    </a:lnTo>
                    <a:lnTo>
                      <a:pt x="1980" y="285"/>
                    </a:lnTo>
                    <a:lnTo>
                      <a:pt x="1999" y="294"/>
                    </a:lnTo>
                    <a:lnTo>
                      <a:pt x="2019" y="296"/>
                    </a:lnTo>
                    <a:lnTo>
                      <a:pt x="2036" y="252"/>
                    </a:lnTo>
                    <a:lnTo>
                      <a:pt x="2055" y="296"/>
                    </a:lnTo>
                    <a:lnTo>
                      <a:pt x="2072" y="294"/>
                    </a:lnTo>
                    <a:lnTo>
                      <a:pt x="2092" y="296"/>
                    </a:lnTo>
                    <a:lnTo>
                      <a:pt x="2109" y="296"/>
                    </a:lnTo>
                    <a:lnTo>
                      <a:pt x="2128" y="296"/>
                    </a:lnTo>
                    <a:lnTo>
                      <a:pt x="2145" y="296"/>
                    </a:lnTo>
                    <a:lnTo>
                      <a:pt x="2164" y="279"/>
                    </a:lnTo>
                    <a:lnTo>
                      <a:pt x="2184" y="279"/>
                    </a:lnTo>
                    <a:lnTo>
                      <a:pt x="2201" y="294"/>
                    </a:lnTo>
                    <a:lnTo>
                      <a:pt x="2220" y="293"/>
                    </a:lnTo>
                    <a:lnTo>
                      <a:pt x="2237" y="296"/>
                    </a:lnTo>
                    <a:lnTo>
                      <a:pt x="2257" y="296"/>
                    </a:lnTo>
                    <a:lnTo>
                      <a:pt x="2274" y="269"/>
                    </a:lnTo>
                    <a:lnTo>
                      <a:pt x="2293" y="296"/>
                    </a:lnTo>
                    <a:lnTo>
                      <a:pt x="2310" y="204"/>
                    </a:lnTo>
                    <a:lnTo>
                      <a:pt x="2330" y="266"/>
                    </a:lnTo>
                    <a:lnTo>
                      <a:pt x="2347" y="241"/>
                    </a:lnTo>
                    <a:lnTo>
                      <a:pt x="2366" y="277"/>
                    </a:lnTo>
                    <a:lnTo>
                      <a:pt x="2385" y="177"/>
                    </a:lnTo>
                    <a:lnTo>
                      <a:pt x="2403" y="229"/>
                    </a:lnTo>
                    <a:lnTo>
                      <a:pt x="2422" y="266"/>
                    </a:lnTo>
                    <a:lnTo>
                      <a:pt x="2439" y="214"/>
                    </a:lnTo>
                    <a:lnTo>
                      <a:pt x="2458" y="208"/>
                    </a:lnTo>
                    <a:lnTo>
                      <a:pt x="2476" y="248"/>
                    </a:lnTo>
                    <a:lnTo>
                      <a:pt x="2495" y="133"/>
                    </a:lnTo>
                    <a:lnTo>
                      <a:pt x="2512" y="179"/>
                    </a:lnTo>
                    <a:lnTo>
                      <a:pt x="2531" y="171"/>
                    </a:lnTo>
                    <a:lnTo>
                      <a:pt x="2549" y="150"/>
                    </a:lnTo>
                    <a:lnTo>
                      <a:pt x="2568" y="183"/>
                    </a:lnTo>
                    <a:lnTo>
                      <a:pt x="2587" y="187"/>
                    </a:lnTo>
                    <a:lnTo>
                      <a:pt x="2604" y="204"/>
                    </a:lnTo>
                    <a:lnTo>
                      <a:pt x="2623" y="123"/>
                    </a:lnTo>
                    <a:lnTo>
                      <a:pt x="2641" y="100"/>
                    </a:lnTo>
                    <a:lnTo>
                      <a:pt x="2660" y="168"/>
                    </a:lnTo>
                    <a:lnTo>
                      <a:pt x="2677" y="248"/>
                    </a:lnTo>
                    <a:lnTo>
                      <a:pt x="2696" y="235"/>
                    </a:lnTo>
                    <a:lnTo>
                      <a:pt x="2714" y="277"/>
                    </a:lnTo>
                    <a:lnTo>
                      <a:pt x="2733" y="248"/>
                    </a:lnTo>
                    <a:lnTo>
                      <a:pt x="2750" y="121"/>
                    </a:lnTo>
                    <a:lnTo>
                      <a:pt x="2769" y="77"/>
                    </a:lnTo>
                    <a:lnTo>
                      <a:pt x="2789" y="137"/>
                    </a:lnTo>
                    <a:lnTo>
                      <a:pt x="2806" y="100"/>
                    </a:lnTo>
                    <a:lnTo>
                      <a:pt x="2825" y="200"/>
                    </a:lnTo>
                    <a:lnTo>
                      <a:pt x="2842" y="58"/>
                    </a:lnTo>
                    <a:lnTo>
                      <a:pt x="2861" y="183"/>
                    </a:lnTo>
                    <a:lnTo>
                      <a:pt x="2879" y="125"/>
                    </a:lnTo>
                    <a:lnTo>
                      <a:pt x="2898" y="156"/>
                    </a:lnTo>
                    <a:lnTo>
                      <a:pt x="2915" y="175"/>
                    </a:lnTo>
                    <a:lnTo>
                      <a:pt x="2934" y="196"/>
                    </a:lnTo>
                    <a:lnTo>
                      <a:pt x="2954" y="268"/>
                    </a:lnTo>
                    <a:lnTo>
                      <a:pt x="2971" y="175"/>
                    </a:lnTo>
                    <a:lnTo>
                      <a:pt x="2990" y="129"/>
                    </a:lnTo>
                    <a:lnTo>
                      <a:pt x="3007" y="145"/>
                    </a:lnTo>
                    <a:lnTo>
                      <a:pt x="3027" y="218"/>
                    </a:lnTo>
                    <a:lnTo>
                      <a:pt x="3044" y="148"/>
                    </a:lnTo>
                    <a:lnTo>
                      <a:pt x="3063" y="195"/>
                    </a:lnTo>
                    <a:lnTo>
                      <a:pt x="3080" y="162"/>
                    </a:lnTo>
                    <a:lnTo>
                      <a:pt x="3100" y="135"/>
                    </a:lnTo>
                    <a:lnTo>
                      <a:pt x="3117" y="93"/>
                    </a:lnTo>
                    <a:lnTo>
                      <a:pt x="3136" y="154"/>
                    </a:lnTo>
                    <a:lnTo>
                      <a:pt x="3155" y="131"/>
                    </a:lnTo>
                    <a:lnTo>
                      <a:pt x="3173" y="212"/>
                    </a:lnTo>
                    <a:lnTo>
                      <a:pt x="3192" y="208"/>
                    </a:lnTo>
                    <a:lnTo>
                      <a:pt x="3209" y="79"/>
                    </a:lnTo>
                    <a:lnTo>
                      <a:pt x="3228" y="52"/>
                    </a:lnTo>
                    <a:lnTo>
                      <a:pt x="3246" y="131"/>
                    </a:lnTo>
                    <a:lnTo>
                      <a:pt x="3265" y="177"/>
                    </a:lnTo>
                    <a:lnTo>
                      <a:pt x="3282" y="43"/>
                    </a:lnTo>
                    <a:lnTo>
                      <a:pt x="3301" y="104"/>
                    </a:lnTo>
                    <a:lnTo>
                      <a:pt x="3318" y="118"/>
                    </a:lnTo>
                    <a:lnTo>
                      <a:pt x="3338" y="52"/>
                    </a:lnTo>
                    <a:lnTo>
                      <a:pt x="3357" y="104"/>
                    </a:lnTo>
                    <a:lnTo>
                      <a:pt x="3374" y="170"/>
                    </a:lnTo>
                    <a:lnTo>
                      <a:pt x="3393" y="108"/>
                    </a:lnTo>
                    <a:lnTo>
                      <a:pt x="3411" y="62"/>
                    </a:lnTo>
                    <a:lnTo>
                      <a:pt x="3430" y="139"/>
                    </a:lnTo>
                    <a:lnTo>
                      <a:pt x="3447" y="118"/>
                    </a:lnTo>
                    <a:lnTo>
                      <a:pt x="3466" y="129"/>
                    </a:lnTo>
                    <a:lnTo>
                      <a:pt x="3484" y="31"/>
                    </a:lnTo>
                    <a:lnTo>
                      <a:pt x="3503" y="116"/>
                    </a:lnTo>
                    <a:lnTo>
                      <a:pt x="3522" y="77"/>
                    </a:lnTo>
                    <a:lnTo>
                      <a:pt x="3539" y="145"/>
                    </a:lnTo>
                    <a:lnTo>
                      <a:pt x="3558" y="112"/>
                    </a:lnTo>
                    <a:lnTo>
                      <a:pt x="3576" y="110"/>
                    </a:lnTo>
                    <a:lnTo>
                      <a:pt x="3595" y="141"/>
                    </a:lnTo>
                    <a:lnTo>
                      <a:pt x="3612" y="48"/>
                    </a:lnTo>
                    <a:lnTo>
                      <a:pt x="3631" y="116"/>
                    </a:lnTo>
                    <a:lnTo>
                      <a:pt x="3649" y="175"/>
                    </a:lnTo>
                    <a:lnTo>
                      <a:pt x="3668" y="198"/>
                    </a:lnTo>
                    <a:lnTo>
                      <a:pt x="3685" y="93"/>
                    </a:lnTo>
                    <a:lnTo>
                      <a:pt x="3704" y="102"/>
                    </a:lnTo>
                    <a:lnTo>
                      <a:pt x="3724" y="135"/>
                    </a:lnTo>
                    <a:lnTo>
                      <a:pt x="3741" y="43"/>
                    </a:lnTo>
                    <a:lnTo>
                      <a:pt x="3760" y="77"/>
                    </a:lnTo>
                    <a:lnTo>
                      <a:pt x="3777" y="45"/>
                    </a:lnTo>
                    <a:lnTo>
                      <a:pt x="3797" y="116"/>
                    </a:lnTo>
                    <a:lnTo>
                      <a:pt x="3814" y="133"/>
                    </a:lnTo>
                    <a:lnTo>
                      <a:pt x="3833" y="154"/>
                    </a:lnTo>
                    <a:lnTo>
                      <a:pt x="3850" y="123"/>
                    </a:lnTo>
                    <a:lnTo>
                      <a:pt x="3870" y="106"/>
                    </a:lnTo>
                    <a:lnTo>
                      <a:pt x="3887" y="104"/>
                    </a:lnTo>
                    <a:lnTo>
                      <a:pt x="3906" y="158"/>
                    </a:lnTo>
                    <a:lnTo>
                      <a:pt x="3925" y="196"/>
                    </a:lnTo>
                    <a:lnTo>
                      <a:pt x="3943" y="158"/>
                    </a:lnTo>
                    <a:lnTo>
                      <a:pt x="3962" y="150"/>
                    </a:lnTo>
                    <a:lnTo>
                      <a:pt x="3979" y="91"/>
                    </a:lnTo>
                    <a:lnTo>
                      <a:pt x="3998" y="133"/>
                    </a:lnTo>
                    <a:lnTo>
                      <a:pt x="4015" y="95"/>
                    </a:lnTo>
                    <a:lnTo>
                      <a:pt x="4035" y="181"/>
                    </a:lnTo>
                    <a:lnTo>
                      <a:pt x="4052" y="62"/>
                    </a:lnTo>
                    <a:lnTo>
                      <a:pt x="4071" y="81"/>
                    </a:lnTo>
                    <a:lnTo>
                      <a:pt x="4088" y="93"/>
                    </a:lnTo>
                    <a:lnTo>
                      <a:pt x="4108" y="27"/>
                    </a:lnTo>
                    <a:lnTo>
                      <a:pt x="4127" y="77"/>
                    </a:lnTo>
                    <a:lnTo>
                      <a:pt x="4144" y="81"/>
                    </a:lnTo>
                    <a:lnTo>
                      <a:pt x="4163" y="170"/>
                    </a:lnTo>
                    <a:lnTo>
                      <a:pt x="4181" y="89"/>
                    </a:lnTo>
                    <a:lnTo>
                      <a:pt x="4200" y="100"/>
                    </a:lnTo>
                    <a:lnTo>
                      <a:pt x="4217" y="171"/>
                    </a:lnTo>
                    <a:lnTo>
                      <a:pt x="4236" y="68"/>
                    </a:lnTo>
                    <a:lnTo>
                      <a:pt x="4254" y="206"/>
                    </a:lnTo>
                    <a:lnTo>
                      <a:pt x="4273" y="118"/>
                    </a:lnTo>
                    <a:lnTo>
                      <a:pt x="4292" y="70"/>
                    </a:lnTo>
                    <a:lnTo>
                      <a:pt x="4309" y="108"/>
                    </a:lnTo>
                    <a:lnTo>
                      <a:pt x="4328" y="127"/>
                    </a:lnTo>
                    <a:lnTo>
                      <a:pt x="4346" y="148"/>
                    </a:lnTo>
                    <a:lnTo>
                      <a:pt x="4365" y="143"/>
                    </a:lnTo>
                    <a:lnTo>
                      <a:pt x="4382" y="95"/>
                    </a:lnTo>
                    <a:lnTo>
                      <a:pt x="4401" y="127"/>
                    </a:lnTo>
                    <a:lnTo>
                      <a:pt x="4419" y="131"/>
                    </a:lnTo>
                    <a:lnTo>
                      <a:pt x="4438" y="110"/>
                    </a:lnTo>
                    <a:lnTo>
                      <a:pt x="4455" y="133"/>
                    </a:lnTo>
                    <a:lnTo>
                      <a:pt x="4474" y="64"/>
                    </a:lnTo>
                    <a:lnTo>
                      <a:pt x="4494" y="129"/>
                    </a:lnTo>
                    <a:lnTo>
                      <a:pt x="4511" y="123"/>
                    </a:lnTo>
                    <a:lnTo>
                      <a:pt x="4530" y="121"/>
                    </a:lnTo>
                    <a:lnTo>
                      <a:pt x="4547" y="102"/>
                    </a:lnTo>
                    <a:lnTo>
                      <a:pt x="4567" y="72"/>
                    </a:lnTo>
                    <a:lnTo>
                      <a:pt x="4584" y="79"/>
                    </a:lnTo>
                    <a:lnTo>
                      <a:pt x="4603" y="139"/>
                    </a:lnTo>
                    <a:lnTo>
                      <a:pt x="4620" y="95"/>
                    </a:lnTo>
                    <a:lnTo>
                      <a:pt x="4640" y="123"/>
                    </a:lnTo>
                    <a:lnTo>
                      <a:pt x="4657" y="85"/>
                    </a:lnTo>
                    <a:lnTo>
                      <a:pt x="4676" y="66"/>
                    </a:lnTo>
                    <a:lnTo>
                      <a:pt x="4695" y="181"/>
                    </a:lnTo>
                    <a:lnTo>
                      <a:pt x="4712" y="0"/>
                    </a:lnTo>
                    <a:lnTo>
                      <a:pt x="4732" y="48"/>
                    </a:lnTo>
                    <a:lnTo>
                      <a:pt x="4749" y="143"/>
                    </a:lnTo>
                    <a:lnTo>
                      <a:pt x="4768" y="250"/>
                    </a:lnTo>
                    <a:lnTo>
                      <a:pt x="4785" y="97"/>
                    </a:lnTo>
                    <a:lnTo>
                      <a:pt x="4805" y="68"/>
                    </a:lnTo>
                    <a:lnTo>
                      <a:pt x="4822" y="79"/>
                    </a:lnTo>
                    <a:lnTo>
                      <a:pt x="4841" y="98"/>
                    </a:lnTo>
                    <a:lnTo>
                      <a:pt x="4860" y="89"/>
                    </a:lnTo>
                    <a:lnTo>
                      <a:pt x="4878" y="93"/>
                    </a:lnTo>
                    <a:lnTo>
                      <a:pt x="4897" y="148"/>
                    </a:lnTo>
                    <a:lnTo>
                      <a:pt x="4914" y="148"/>
                    </a:lnTo>
                    <a:lnTo>
                      <a:pt x="4933" y="121"/>
                    </a:lnTo>
                    <a:lnTo>
                      <a:pt x="4951" y="98"/>
                    </a:lnTo>
                    <a:lnTo>
                      <a:pt x="4970" y="91"/>
                    </a:lnTo>
                    <a:lnTo>
                      <a:pt x="4987" y="16"/>
                    </a:lnTo>
                    <a:lnTo>
                      <a:pt x="5006" y="152"/>
                    </a:lnTo>
                    <a:lnTo>
                      <a:pt x="5024" y="121"/>
                    </a:lnTo>
                    <a:lnTo>
                      <a:pt x="5043" y="95"/>
                    </a:lnTo>
                    <a:lnTo>
                      <a:pt x="5062" y="89"/>
                    </a:lnTo>
                    <a:lnTo>
                      <a:pt x="5079" y="118"/>
                    </a:lnTo>
                    <a:lnTo>
                      <a:pt x="5098" y="31"/>
                    </a:lnTo>
                    <a:lnTo>
                      <a:pt x="5116" y="162"/>
                    </a:lnTo>
                    <a:lnTo>
                      <a:pt x="5135" y="58"/>
                    </a:lnTo>
                    <a:lnTo>
                      <a:pt x="5152" y="146"/>
                    </a:lnTo>
                    <a:lnTo>
                      <a:pt x="5171" y="91"/>
                    </a:lnTo>
                    <a:lnTo>
                      <a:pt x="5189" y="141"/>
                    </a:lnTo>
                    <a:lnTo>
                      <a:pt x="5208" y="108"/>
                    </a:lnTo>
                    <a:lnTo>
                      <a:pt x="5225" y="95"/>
                    </a:lnTo>
                    <a:lnTo>
                      <a:pt x="5244" y="108"/>
                    </a:lnTo>
                    <a:lnTo>
                      <a:pt x="5264" y="97"/>
                    </a:lnTo>
                    <a:lnTo>
                      <a:pt x="5281" y="110"/>
                    </a:lnTo>
                    <a:lnTo>
                      <a:pt x="5300" y="121"/>
                    </a:lnTo>
                    <a:lnTo>
                      <a:pt x="5317" y="150"/>
                    </a:lnTo>
                    <a:lnTo>
                      <a:pt x="5337" y="127"/>
                    </a:lnTo>
                    <a:lnTo>
                      <a:pt x="5354" y="114"/>
                    </a:lnTo>
                    <a:lnTo>
                      <a:pt x="5373" y="141"/>
                    </a:lnTo>
                    <a:lnTo>
                      <a:pt x="5390" y="191"/>
                    </a:lnTo>
                    <a:lnTo>
                      <a:pt x="5410" y="89"/>
                    </a:lnTo>
                    <a:lnTo>
                      <a:pt x="5410" y="296"/>
                    </a:lnTo>
                    <a:lnTo>
                      <a:pt x="5390" y="296"/>
                    </a:lnTo>
                    <a:lnTo>
                      <a:pt x="5373" y="296"/>
                    </a:lnTo>
                    <a:lnTo>
                      <a:pt x="5354" y="296"/>
                    </a:lnTo>
                    <a:lnTo>
                      <a:pt x="5337" y="296"/>
                    </a:lnTo>
                    <a:lnTo>
                      <a:pt x="5317" y="296"/>
                    </a:lnTo>
                    <a:lnTo>
                      <a:pt x="5300" y="296"/>
                    </a:lnTo>
                    <a:lnTo>
                      <a:pt x="5281" y="296"/>
                    </a:lnTo>
                    <a:lnTo>
                      <a:pt x="5264" y="296"/>
                    </a:lnTo>
                    <a:lnTo>
                      <a:pt x="5244" y="296"/>
                    </a:lnTo>
                    <a:lnTo>
                      <a:pt x="5225" y="296"/>
                    </a:lnTo>
                    <a:lnTo>
                      <a:pt x="5208" y="296"/>
                    </a:lnTo>
                    <a:lnTo>
                      <a:pt x="5189" y="296"/>
                    </a:lnTo>
                    <a:lnTo>
                      <a:pt x="5171" y="296"/>
                    </a:lnTo>
                    <a:lnTo>
                      <a:pt x="5152" y="296"/>
                    </a:lnTo>
                    <a:lnTo>
                      <a:pt x="5135" y="296"/>
                    </a:lnTo>
                    <a:lnTo>
                      <a:pt x="5116" y="296"/>
                    </a:lnTo>
                    <a:lnTo>
                      <a:pt x="5098" y="296"/>
                    </a:lnTo>
                    <a:lnTo>
                      <a:pt x="5079" y="296"/>
                    </a:lnTo>
                    <a:lnTo>
                      <a:pt x="5062" y="296"/>
                    </a:lnTo>
                    <a:lnTo>
                      <a:pt x="5043" y="296"/>
                    </a:lnTo>
                    <a:lnTo>
                      <a:pt x="5024" y="296"/>
                    </a:lnTo>
                    <a:lnTo>
                      <a:pt x="5006" y="296"/>
                    </a:lnTo>
                    <a:lnTo>
                      <a:pt x="4987" y="296"/>
                    </a:lnTo>
                    <a:lnTo>
                      <a:pt x="4970" y="296"/>
                    </a:lnTo>
                    <a:lnTo>
                      <a:pt x="4951" y="296"/>
                    </a:lnTo>
                    <a:lnTo>
                      <a:pt x="4933" y="296"/>
                    </a:lnTo>
                    <a:lnTo>
                      <a:pt x="4914" y="296"/>
                    </a:lnTo>
                    <a:lnTo>
                      <a:pt x="4897" y="296"/>
                    </a:lnTo>
                    <a:lnTo>
                      <a:pt x="4878" y="296"/>
                    </a:lnTo>
                    <a:lnTo>
                      <a:pt x="4860" y="296"/>
                    </a:lnTo>
                    <a:lnTo>
                      <a:pt x="4841" y="296"/>
                    </a:lnTo>
                    <a:lnTo>
                      <a:pt x="4822" y="296"/>
                    </a:lnTo>
                    <a:lnTo>
                      <a:pt x="4805" y="296"/>
                    </a:lnTo>
                    <a:lnTo>
                      <a:pt x="4785" y="296"/>
                    </a:lnTo>
                    <a:lnTo>
                      <a:pt x="4768" y="296"/>
                    </a:lnTo>
                    <a:lnTo>
                      <a:pt x="4749" y="296"/>
                    </a:lnTo>
                    <a:lnTo>
                      <a:pt x="4732" y="296"/>
                    </a:lnTo>
                    <a:lnTo>
                      <a:pt x="4712" y="296"/>
                    </a:lnTo>
                    <a:lnTo>
                      <a:pt x="4695" y="296"/>
                    </a:lnTo>
                    <a:lnTo>
                      <a:pt x="4676" y="296"/>
                    </a:lnTo>
                    <a:lnTo>
                      <a:pt x="4657" y="296"/>
                    </a:lnTo>
                    <a:lnTo>
                      <a:pt x="4640" y="296"/>
                    </a:lnTo>
                    <a:lnTo>
                      <a:pt x="4620" y="296"/>
                    </a:lnTo>
                    <a:lnTo>
                      <a:pt x="4603" y="296"/>
                    </a:lnTo>
                    <a:lnTo>
                      <a:pt x="4584" y="296"/>
                    </a:lnTo>
                    <a:lnTo>
                      <a:pt x="4567" y="296"/>
                    </a:lnTo>
                    <a:lnTo>
                      <a:pt x="4547" y="296"/>
                    </a:lnTo>
                    <a:lnTo>
                      <a:pt x="4530" y="296"/>
                    </a:lnTo>
                    <a:lnTo>
                      <a:pt x="4511" y="296"/>
                    </a:lnTo>
                    <a:lnTo>
                      <a:pt x="4494" y="296"/>
                    </a:lnTo>
                    <a:lnTo>
                      <a:pt x="4474" y="296"/>
                    </a:lnTo>
                    <a:lnTo>
                      <a:pt x="4455" y="296"/>
                    </a:lnTo>
                    <a:lnTo>
                      <a:pt x="4438" y="296"/>
                    </a:lnTo>
                    <a:lnTo>
                      <a:pt x="4419" y="296"/>
                    </a:lnTo>
                    <a:lnTo>
                      <a:pt x="4401" y="296"/>
                    </a:lnTo>
                    <a:lnTo>
                      <a:pt x="4382" y="296"/>
                    </a:lnTo>
                    <a:lnTo>
                      <a:pt x="4365" y="296"/>
                    </a:lnTo>
                    <a:lnTo>
                      <a:pt x="4346" y="296"/>
                    </a:lnTo>
                    <a:lnTo>
                      <a:pt x="4328" y="296"/>
                    </a:lnTo>
                    <a:lnTo>
                      <a:pt x="4309" y="296"/>
                    </a:lnTo>
                    <a:lnTo>
                      <a:pt x="4292" y="296"/>
                    </a:lnTo>
                    <a:lnTo>
                      <a:pt x="4273" y="296"/>
                    </a:lnTo>
                    <a:lnTo>
                      <a:pt x="4254" y="296"/>
                    </a:lnTo>
                    <a:lnTo>
                      <a:pt x="4236" y="296"/>
                    </a:lnTo>
                    <a:lnTo>
                      <a:pt x="4217" y="296"/>
                    </a:lnTo>
                    <a:lnTo>
                      <a:pt x="4200" y="296"/>
                    </a:lnTo>
                    <a:lnTo>
                      <a:pt x="4181" y="296"/>
                    </a:lnTo>
                    <a:lnTo>
                      <a:pt x="4163" y="296"/>
                    </a:lnTo>
                    <a:lnTo>
                      <a:pt x="4144" y="296"/>
                    </a:lnTo>
                    <a:lnTo>
                      <a:pt x="4127" y="296"/>
                    </a:lnTo>
                    <a:lnTo>
                      <a:pt x="4108" y="296"/>
                    </a:lnTo>
                    <a:lnTo>
                      <a:pt x="4088" y="296"/>
                    </a:lnTo>
                    <a:lnTo>
                      <a:pt x="4071" y="296"/>
                    </a:lnTo>
                    <a:lnTo>
                      <a:pt x="4052" y="296"/>
                    </a:lnTo>
                    <a:lnTo>
                      <a:pt x="4035" y="296"/>
                    </a:lnTo>
                    <a:lnTo>
                      <a:pt x="4015" y="296"/>
                    </a:lnTo>
                    <a:lnTo>
                      <a:pt x="3998" y="296"/>
                    </a:lnTo>
                    <a:lnTo>
                      <a:pt x="3979" y="296"/>
                    </a:lnTo>
                    <a:lnTo>
                      <a:pt x="3962" y="296"/>
                    </a:lnTo>
                    <a:lnTo>
                      <a:pt x="3943" y="296"/>
                    </a:lnTo>
                    <a:lnTo>
                      <a:pt x="3925" y="296"/>
                    </a:lnTo>
                    <a:lnTo>
                      <a:pt x="3906" y="296"/>
                    </a:lnTo>
                    <a:lnTo>
                      <a:pt x="3887" y="296"/>
                    </a:lnTo>
                    <a:lnTo>
                      <a:pt x="3870" y="296"/>
                    </a:lnTo>
                    <a:lnTo>
                      <a:pt x="3850" y="296"/>
                    </a:lnTo>
                    <a:lnTo>
                      <a:pt x="3833" y="296"/>
                    </a:lnTo>
                    <a:lnTo>
                      <a:pt x="3814" y="296"/>
                    </a:lnTo>
                    <a:lnTo>
                      <a:pt x="3797" y="296"/>
                    </a:lnTo>
                    <a:lnTo>
                      <a:pt x="3777" y="296"/>
                    </a:lnTo>
                    <a:lnTo>
                      <a:pt x="3760" y="296"/>
                    </a:lnTo>
                    <a:lnTo>
                      <a:pt x="3741" y="296"/>
                    </a:lnTo>
                    <a:lnTo>
                      <a:pt x="3724" y="296"/>
                    </a:lnTo>
                    <a:lnTo>
                      <a:pt x="3704" y="296"/>
                    </a:lnTo>
                    <a:lnTo>
                      <a:pt x="3685" y="296"/>
                    </a:lnTo>
                    <a:lnTo>
                      <a:pt x="3668" y="296"/>
                    </a:lnTo>
                    <a:lnTo>
                      <a:pt x="3649" y="296"/>
                    </a:lnTo>
                    <a:lnTo>
                      <a:pt x="3631" y="296"/>
                    </a:lnTo>
                    <a:lnTo>
                      <a:pt x="3612" y="296"/>
                    </a:lnTo>
                    <a:lnTo>
                      <a:pt x="3595" y="296"/>
                    </a:lnTo>
                    <a:lnTo>
                      <a:pt x="3576" y="296"/>
                    </a:lnTo>
                    <a:lnTo>
                      <a:pt x="3558" y="296"/>
                    </a:lnTo>
                    <a:lnTo>
                      <a:pt x="3539" y="296"/>
                    </a:lnTo>
                    <a:lnTo>
                      <a:pt x="3522" y="296"/>
                    </a:lnTo>
                    <a:lnTo>
                      <a:pt x="3503" y="296"/>
                    </a:lnTo>
                    <a:lnTo>
                      <a:pt x="3484" y="296"/>
                    </a:lnTo>
                    <a:lnTo>
                      <a:pt x="3466" y="296"/>
                    </a:lnTo>
                    <a:lnTo>
                      <a:pt x="3447" y="296"/>
                    </a:lnTo>
                    <a:lnTo>
                      <a:pt x="3430" y="296"/>
                    </a:lnTo>
                    <a:lnTo>
                      <a:pt x="3411" y="296"/>
                    </a:lnTo>
                    <a:lnTo>
                      <a:pt x="3393" y="296"/>
                    </a:lnTo>
                    <a:lnTo>
                      <a:pt x="3374" y="296"/>
                    </a:lnTo>
                    <a:lnTo>
                      <a:pt x="3357" y="296"/>
                    </a:lnTo>
                    <a:lnTo>
                      <a:pt x="3338" y="296"/>
                    </a:lnTo>
                    <a:lnTo>
                      <a:pt x="3318" y="296"/>
                    </a:lnTo>
                    <a:lnTo>
                      <a:pt x="3301" y="296"/>
                    </a:lnTo>
                    <a:lnTo>
                      <a:pt x="3282" y="296"/>
                    </a:lnTo>
                    <a:lnTo>
                      <a:pt x="3265" y="296"/>
                    </a:lnTo>
                    <a:lnTo>
                      <a:pt x="3246" y="296"/>
                    </a:lnTo>
                    <a:lnTo>
                      <a:pt x="3228" y="296"/>
                    </a:lnTo>
                    <a:lnTo>
                      <a:pt x="3209" y="296"/>
                    </a:lnTo>
                    <a:lnTo>
                      <a:pt x="3192" y="296"/>
                    </a:lnTo>
                    <a:lnTo>
                      <a:pt x="3173" y="296"/>
                    </a:lnTo>
                    <a:lnTo>
                      <a:pt x="3155" y="296"/>
                    </a:lnTo>
                    <a:lnTo>
                      <a:pt x="3136" y="296"/>
                    </a:lnTo>
                    <a:lnTo>
                      <a:pt x="3117" y="296"/>
                    </a:lnTo>
                    <a:lnTo>
                      <a:pt x="3100" y="296"/>
                    </a:lnTo>
                    <a:lnTo>
                      <a:pt x="3080" y="296"/>
                    </a:lnTo>
                    <a:lnTo>
                      <a:pt x="3063" y="296"/>
                    </a:lnTo>
                    <a:lnTo>
                      <a:pt x="3044" y="296"/>
                    </a:lnTo>
                    <a:lnTo>
                      <a:pt x="3027" y="296"/>
                    </a:lnTo>
                    <a:lnTo>
                      <a:pt x="3007" y="296"/>
                    </a:lnTo>
                    <a:lnTo>
                      <a:pt x="2990" y="296"/>
                    </a:lnTo>
                    <a:lnTo>
                      <a:pt x="2971" y="296"/>
                    </a:lnTo>
                    <a:lnTo>
                      <a:pt x="2954" y="296"/>
                    </a:lnTo>
                    <a:lnTo>
                      <a:pt x="2934" y="296"/>
                    </a:lnTo>
                    <a:lnTo>
                      <a:pt x="2915" y="296"/>
                    </a:lnTo>
                    <a:lnTo>
                      <a:pt x="2898" y="296"/>
                    </a:lnTo>
                    <a:lnTo>
                      <a:pt x="2879" y="296"/>
                    </a:lnTo>
                    <a:lnTo>
                      <a:pt x="2861" y="296"/>
                    </a:lnTo>
                    <a:lnTo>
                      <a:pt x="2842" y="296"/>
                    </a:lnTo>
                    <a:lnTo>
                      <a:pt x="2825" y="296"/>
                    </a:lnTo>
                    <a:lnTo>
                      <a:pt x="2806" y="296"/>
                    </a:lnTo>
                    <a:lnTo>
                      <a:pt x="2789" y="296"/>
                    </a:lnTo>
                    <a:lnTo>
                      <a:pt x="2769" y="296"/>
                    </a:lnTo>
                    <a:lnTo>
                      <a:pt x="2750" y="296"/>
                    </a:lnTo>
                    <a:lnTo>
                      <a:pt x="2733" y="296"/>
                    </a:lnTo>
                    <a:lnTo>
                      <a:pt x="2714" y="296"/>
                    </a:lnTo>
                    <a:lnTo>
                      <a:pt x="2696" y="296"/>
                    </a:lnTo>
                    <a:lnTo>
                      <a:pt x="2677" y="296"/>
                    </a:lnTo>
                    <a:lnTo>
                      <a:pt x="2660" y="296"/>
                    </a:lnTo>
                    <a:lnTo>
                      <a:pt x="2641" y="296"/>
                    </a:lnTo>
                    <a:lnTo>
                      <a:pt x="2623" y="296"/>
                    </a:lnTo>
                    <a:lnTo>
                      <a:pt x="2604" y="296"/>
                    </a:lnTo>
                    <a:lnTo>
                      <a:pt x="2587" y="296"/>
                    </a:lnTo>
                    <a:lnTo>
                      <a:pt x="2568" y="296"/>
                    </a:lnTo>
                    <a:lnTo>
                      <a:pt x="2549" y="296"/>
                    </a:lnTo>
                    <a:lnTo>
                      <a:pt x="2531" y="296"/>
                    </a:lnTo>
                    <a:lnTo>
                      <a:pt x="2512" y="296"/>
                    </a:lnTo>
                    <a:lnTo>
                      <a:pt x="2495" y="296"/>
                    </a:lnTo>
                    <a:lnTo>
                      <a:pt x="2476" y="296"/>
                    </a:lnTo>
                    <a:lnTo>
                      <a:pt x="2458" y="296"/>
                    </a:lnTo>
                    <a:lnTo>
                      <a:pt x="2439" y="296"/>
                    </a:lnTo>
                    <a:lnTo>
                      <a:pt x="2422" y="296"/>
                    </a:lnTo>
                    <a:lnTo>
                      <a:pt x="2403" y="296"/>
                    </a:lnTo>
                    <a:lnTo>
                      <a:pt x="2385" y="296"/>
                    </a:lnTo>
                    <a:lnTo>
                      <a:pt x="2366" y="296"/>
                    </a:lnTo>
                    <a:lnTo>
                      <a:pt x="2347" y="296"/>
                    </a:lnTo>
                    <a:lnTo>
                      <a:pt x="2330" y="296"/>
                    </a:lnTo>
                    <a:lnTo>
                      <a:pt x="2310" y="296"/>
                    </a:lnTo>
                    <a:lnTo>
                      <a:pt x="2293" y="296"/>
                    </a:lnTo>
                    <a:lnTo>
                      <a:pt x="2274" y="296"/>
                    </a:lnTo>
                    <a:lnTo>
                      <a:pt x="2257" y="296"/>
                    </a:lnTo>
                    <a:lnTo>
                      <a:pt x="2237" y="296"/>
                    </a:lnTo>
                    <a:lnTo>
                      <a:pt x="2220" y="296"/>
                    </a:lnTo>
                    <a:lnTo>
                      <a:pt x="2201" y="296"/>
                    </a:lnTo>
                    <a:lnTo>
                      <a:pt x="2184" y="296"/>
                    </a:lnTo>
                    <a:lnTo>
                      <a:pt x="2164" y="296"/>
                    </a:lnTo>
                    <a:lnTo>
                      <a:pt x="2145" y="296"/>
                    </a:lnTo>
                    <a:lnTo>
                      <a:pt x="2128" y="296"/>
                    </a:lnTo>
                    <a:lnTo>
                      <a:pt x="2109" y="296"/>
                    </a:lnTo>
                    <a:lnTo>
                      <a:pt x="2092" y="296"/>
                    </a:lnTo>
                    <a:lnTo>
                      <a:pt x="2072" y="296"/>
                    </a:lnTo>
                    <a:lnTo>
                      <a:pt x="2055" y="296"/>
                    </a:lnTo>
                    <a:lnTo>
                      <a:pt x="2036" y="296"/>
                    </a:lnTo>
                    <a:lnTo>
                      <a:pt x="2019" y="296"/>
                    </a:lnTo>
                    <a:lnTo>
                      <a:pt x="1999" y="296"/>
                    </a:lnTo>
                    <a:lnTo>
                      <a:pt x="1980" y="296"/>
                    </a:lnTo>
                    <a:lnTo>
                      <a:pt x="1963" y="296"/>
                    </a:lnTo>
                    <a:lnTo>
                      <a:pt x="1944" y="296"/>
                    </a:lnTo>
                    <a:lnTo>
                      <a:pt x="1926" y="296"/>
                    </a:lnTo>
                    <a:lnTo>
                      <a:pt x="1907" y="296"/>
                    </a:lnTo>
                    <a:lnTo>
                      <a:pt x="1890" y="296"/>
                    </a:lnTo>
                    <a:lnTo>
                      <a:pt x="1871" y="296"/>
                    </a:lnTo>
                    <a:lnTo>
                      <a:pt x="1853" y="296"/>
                    </a:lnTo>
                    <a:lnTo>
                      <a:pt x="1834" y="296"/>
                    </a:lnTo>
                    <a:lnTo>
                      <a:pt x="1817" y="296"/>
                    </a:lnTo>
                    <a:lnTo>
                      <a:pt x="1798" y="296"/>
                    </a:lnTo>
                    <a:lnTo>
                      <a:pt x="1779" y="296"/>
                    </a:lnTo>
                    <a:lnTo>
                      <a:pt x="1761" y="296"/>
                    </a:lnTo>
                    <a:lnTo>
                      <a:pt x="1742" y="296"/>
                    </a:lnTo>
                    <a:lnTo>
                      <a:pt x="1725" y="296"/>
                    </a:lnTo>
                    <a:lnTo>
                      <a:pt x="1706" y="296"/>
                    </a:lnTo>
                    <a:lnTo>
                      <a:pt x="1688" y="296"/>
                    </a:lnTo>
                    <a:lnTo>
                      <a:pt x="1669" y="296"/>
                    </a:lnTo>
                    <a:lnTo>
                      <a:pt x="1652" y="296"/>
                    </a:lnTo>
                    <a:lnTo>
                      <a:pt x="1633" y="296"/>
                    </a:lnTo>
                    <a:lnTo>
                      <a:pt x="1615" y="296"/>
                    </a:lnTo>
                    <a:lnTo>
                      <a:pt x="1596" y="296"/>
                    </a:lnTo>
                    <a:lnTo>
                      <a:pt x="1577" y="296"/>
                    </a:lnTo>
                    <a:lnTo>
                      <a:pt x="1560" y="296"/>
                    </a:lnTo>
                    <a:lnTo>
                      <a:pt x="1540" y="296"/>
                    </a:lnTo>
                    <a:lnTo>
                      <a:pt x="1523" y="296"/>
                    </a:lnTo>
                    <a:lnTo>
                      <a:pt x="1504" y="296"/>
                    </a:lnTo>
                    <a:lnTo>
                      <a:pt x="1487" y="296"/>
                    </a:lnTo>
                    <a:lnTo>
                      <a:pt x="1467" y="296"/>
                    </a:lnTo>
                    <a:lnTo>
                      <a:pt x="1450" y="296"/>
                    </a:lnTo>
                    <a:lnTo>
                      <a:pt x="1431" y="296"/>
                    </a:lnTo>
                    <a:lnTo>
                      <a:pt x="1412" y="296"/>
                    </a:lnTo>
                    <a:lnTo>
                      <a:pt x="1395" y="296"/>
                    </a:lnTo>
                    <a:lnTo>
                      <a:pt x="1375" y="296"/>
                    </a:lnTo>
                    <a:lnTo>
                      <a:pt x="1358" y="296"/>
                    </a:lnTo>
                    <a:lnTo>
                      <a:pt x="1339" y="296"/>
                    </a:lnTo>
                    <a:lnTo>
                      <a:pt x="1322" y="296"/>
                    </a:lnTo>
                    <a:lnTo>
                      <a:pt x="1302" y="296"/>
                    </a:lnTo>
                    <a:lnTo>
                      <a:pt x="1285" y="296"/>
                    </a:lnTo>
                    <a:lnTo>
                      <a:pt x="1266" y="296"/>
                    </a:lnTo>
                    <a:lnTo>
                      <a:pt x="1249" y="296"/>
                    </a:lnTo>
                    <a:lnTo>
                      <a:pt x="1229" y="296"/>
                    </a:lnTo>
                    <a:lnTo>
                      <a:pt x="1210" y="296"/>
                    </a:lnTo>
                    <a:lnTo>
                      <a:pt x="1193" y="296"/>
                    </a:lnTo>
                    <a:lnTo>
                      <a:pt x="1174" y="296"/>
                    </a:lnTo>
                    <a:lnTo>
                      <a:pt x="1156" y="296"/>
                    </a:lnTo>
                    <a:lnTo>
                      <a:pt x="1137" y="296"/>
                    </a:lnTo>
                    <a:lnTo>
                      <a:pt x="1120" y="296"/>
                    </a:lnTo>
                    <a:lnTo>
                      <a:pt x="1101" y="296"/>
                    </a:lnTo>
                    <a:lnTo>
                      <a:pt x="1083" y="296"/>
                    </a:lnTo>
                    <a:lnTo>
                      <a:pt x="1064" y="296"/>
                    </a:lnTo>
                    <a:lnTo>
                      <a:pt x="1047" y="296"/>
                    </a:lnTo>
                    <a:lnTo>
                      <a:pt x="1028" y="296"/>
                    </a:lnTo>
                    <a:lnTo>
                      <a:pt x="1009" y="296"/>
                    </a:lnTo>
                    <a:lnTo>
                      <a:pt x="991" y="296"/>
                    </a:lnTo>
                    <a:lnTo>
                      <a:pt x="972" y="296"/>
                    </a:lnTo>
                    <a:lnTo>
                      <a:pt x="955" y="296"/>
                    </a:lnTo>
                    <a:lnTo>
                      <a:pt x="936" y="296"/>
                    </a:lnTo>
                    <a:lnTo>
                      <a:pt x="918" y="296"/>
                    </a:lnTo>
                    <a:lnTo>
                      <a:pt x="899" y="296"/>
                    </a:lnTo>
                    <a:lnTo>
                      <a:pt x="882" y="296"/>
                    </a:lnTo>
                    <a:lnTo>
                      <a:pt x="863" y="296"/>
                    </a:lnTo>
                    <a:lnTo>
                      <a:pt x="843" y="296"/>
                    </a:lnTo>
                    <a:lnTo>
                      <a:pt x="826" y="296"/>
                    </a:lnTo>
                    <a:lnTo>
                      <a:pt x="807" y="296"/>
                    </a:lnTo>
                    <a:lnTo>
                      <a:pt x="790" y="296"/>
                    </a:lnTo>
                    <a:lnTo>
                      <a:pt x="770" y="296"/>
                    </a:lnTo>
                    <a:lnTo>
                      <a:pt x="753" y="296"/>
                    </a:lnTo>
                    <a:lnTo>
                      <a:pt x="734" y="296"/>
                    </a:lnTo>
                    <a:lnTo>
                      <a:pt x="717" y="296"/>
                    </a:lnTo>
                    <a:lnTo>
                      <a:pt x="698" y="296"/>
                    </a:lnTo>
                    <a:lnTo>
                      <a:pt x="680" y="296"/>
                    </a:lnTo>
                    <a:lnTo>
                      <a:pt x="661" y="296"/>
                    </a:lnTo>
                    <a:lnTo>
                      <a:pt x="642" y="296"/>
                    </a:lnTo>
                    <a:lnTo>
                      <a:pt x="625" y="296"/>
                    </a:lnTo>
                    <a:lnTo>
                      <a:pt x="605" y="296"/>
                    </a:lnTo>
                    <a:lnTo>
                      <a:pt x="588" y="296"/>
                    </a:lnTo>
                    <a:lnTo>
                      <a:pt x="569" y="296"/>
                    </a:lnTo>
                    <a:lnTo>
                      <a:pt x="552" y="296"/>
                    </a:lnTo>
                    <a:lnTo>
                      <a:pt x="532" y="296"/>
                    </a:lnTo>
                    <a:lnTo>
                      <a:pt x="515" y="296"/>
                    </a:lnTo>
                    <a:lnTo>
                      <a:pt x="496" y="296"/>
                    </a:lnTo>
                    <a:lnTo>
                      <a:pt x="479" y="296"/>
                    </a:lnTo>
                    <a:lnTo>
                      <a:pt x="459" y="296"/>
                    </a:lnTo>
                    <a:lnTo>
                      <a:pt x="440" y="296"/>
                    </a:lnTo>
                    <a:lnTo>
                      <a:pt x="423" y="296"/>
                    </a:lnTo>
                    <a:lnTo>
                      <a:pt x="404" y="296"/>
                    </a:lnTo>
                    <a:lnTo>
                      <a:pt x="386" y="296"/>
                    </a:lnTo>
                    <a:lnTo>
                      <a:pt x="367" y="296"/>
                    </a:lnTo>
                    <a:lnTo>
                      <a:pt x="350" y="296"/>
                    </a:lnTo>
                    <a:lnTo>
                      <a:pt x="331" y="296"/>
                    </a:lnTo>
                    <a:lnTo>
                      <a:pt x="313" y="296"/>
                    </a:lnTo>
                    <a:lnTo>
                      <a:pt x="294" y="296"/>
                    </a:lnTo>
                    <a:lnTo>
                      <a:pt x="277" y="296"/>
                    </a:lnTo>
                    <a:lnTo>
                      <a:pt x="258" y="296"/>
                    </a:lnTo>
                    <a:lnTo>
                      <a:pt x="239" y="296"/>
                    </a:lnTo>
                    <a:lnTo>
                      <a:pt x="221" y="296"/>
                    </a:lnTo>
                    <a:lnTo>
                      <a:pt x="202" y="296"/>
                    </a:lnTo>
                    <a:lnTo>
                      <a:pt x="185" y="296"/>
                    </a:lnTo>
                    <a:lnTo>
                      <a:pt x="166" y="296"/>
                    </a:lnTo>
                    <a:lnTo>
                      <a:pt x="148" y="296"/>
                    </a:lnTo>
                    <a:lnTo>
                      <a:pt x="129" y="296"/>
                    </a:lnTo>
                    <a:lnTo>
                      <a:pt x="112" y="296"/>
                    </a:lnTo>
                    <a:lnTo>
                      <a:pt x="93" y="296"/>
                    </a:lnTo>
                    <a:lnTo>
                      <a:pt x="73" y="296"/>
                    </a:lnTo>
                    <a:lnTo>
                      <a:pt x="56" y="296"/>
                    </a:lnTo>
                    <a:lnTo>
                      <a:pt x="37" y="296"/>
                    </a:lnTo>
                    <a:lnTo>
                      <a:pt x="20" y="296"/>
                    </a:lnTo>
                    <a:lnTo>
                      <a:pt x="0" y="296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18" name="Freeform 17"/>
              <p:cNvSpPr>
                <a:spLocks/>
              </p:cNvSpPr>
              <p:nvPr/>
            </p:nvSpPr>
            <p:spPr bwMode="auto">
              <a:xfrm rot="5400000" flipV="1">
                <a:off x="-1012815" y="2718890"/>
                <a:ext cx="3481515" cy="181001"/>
              </a:xfrm>
              <a:custGeom>
                <a:avLst/>
                <a:gdLst>
                  <a:gd name="T0" fmla="*/ 169 w 5409"/>
                  <a:gd name="T1" fmla="*/ 62 h 271"/>
                  <a:gd name="T2" fmla="*/ 356 w 5409"/>
                  <a:gd name="T3" fmla="*/ 29 h 271"/>
                  <a:gd name="T4" fmla="*/ 542 w 5409"/>
                  <a:gd name="T5" fmla="*/ 112 h 271"/>
                  <a:gd name="T6" fmla="*/ 728 w 5409"/>
                  <a:gd name="T7" fmla="*/ 23 h 271"/>
                  <a:gd name="T8" fmla="*/ 914 w 5409"/>
                  <a:gd name="T9" fmla="*/ 91 h 271"/>
                  <a:gd name="T10" fmla="*/ 1101 w 5409"/>
                  <a:gd name="T11" fmla="*/ 16 h 271"/>
                  <a:gd name="T12" fmla="*/ 1287 w 5409"/>
                  <a:gd name="T13" fmla="*/ 87 h 271"/>
                  <a:gd name="T14" fmla="*/ 1475 w 5409"/>
                  <a:gd name="T15" fmla="*/ 129 h 271"/>
                  <a:gd name="T16" fmla="*/ 1661 w 5409"/>
                  <a:gd name="T17" fmla="*/ 52 h 271"/>
                  <a:gd name="T18" fmla="*/ 1848 w 5409"/>
                  <a:gd name="T19" fmla="*/ 47 h 271"/>
                  <a:gd name="T20" fmla="*/ 2034 w 5409"/>
                  <a:gd name="T21" fmla="*/ 129 h 271"/>
                  <a:gd name="T22" fmla="*/ 2220 w 5409"/>
                  <a:gd name="T23" fmla="*/ 110 h 271"/>
                  <a:gd name="T24" fmla="*/ 2406 w 5409"/>
                  <a:gd name="T25" fmla="*/ 196 h 271"/>
                  <a:gd name="T26" fmla="*/ 2593 w 5409"/>
                  <a:gd name="T27" fmla="*/ 166 h 271"/>
                  <a:gd name="T28" fmla="*/ 2779 w 5409"/>
                  <a:gd name="T29" fmla="*/ 246 h 271"/>
                  <a:gd name="T30" fmla="*/ 2967 w 5409"/>
                  <a:gd name="T31" fmla="*/ 266 h 271"/>
                  <a:gd name="T32" fmla="*/ 3153 w 5409"/>
                  <a:gd name="T33" fmla="*/ 271 h 271"/>
                  <a:gd name="T34" fmla="*/ 3340 w 5409"/>
                  <a:gd name="T35" fmla="*/ 271 h 271"/>
                  <a:gd name="T36" fmla="*/ 3526 w 5409"/>
                  <a:gd name="T37" fmla="*/ 250 h 271"/>
                  <a:gd name="T38" fmla="*/ 3712 w 5409"/>
                  <a:gd name="T39" fmla="*/ 235 h 271"/>
                  <a:gd name="T40" fmla="*/ 3898 w 5409"/>
                  <a:gd name="T41" fmla="*/ 221 h 271"/>
                  <a:gd name="T42" fmla="*/ 4085 w 5409"/>
                  <a:gd name="T43" fmla="*/ 262 h 271"/>
                  <a:gd name="T44" fmla="*/ 4271 w 5409"/>
                  <a:gd name="T45" fmla="*/ 271 h 271"/>
                  <a:gd name="T46" fmla="*/ 4459 w 5409"/>
                  <a:gd name="T47" fmla="*/ 243 h 271"/>
                  <a:gd name="T48" fmla="*/ 4645 w 5409"/>
                  <a:gd name="T49" fmla="*/ 250 h 271"/>
                  <a:gd name="T50" fmla="*/ 4831 w 5409"/>
                  <a:gd name="T51" fmla="*/ 214 h 271"/>
                  <a:gd name="T52" fmla="*/ 5018 w 5409"/>
                  <a:gd name="T53" fmla="*/ 271 h 271"/>
                  <a:gd name="T54" fmla="*/ 5204 w 5409"/>
                  <a:gd name="T55" fmla="*/ 216 h 271"/>
                  <a:gd name="T56" fmla="*/ 5390 w 5409"/>
                  <a:gd name="T57" fmla="*/ 244 h 271"/>
                  <a:gd name="T58" fmla="*/ 5260 w 5409"/>
                  <a:gd name="T59" fmla="*/ 271 h 271"/>
                  <a:gd name="T60" fmla="*/ 5073 w 5409"/>
                  <a:gd name="T61" fmla="*/ 271 h 271"/>
                  <a:gd name="T62" fmla="*/ 4887 w 5409"/>
                  <a:gd name="T63" fmla="*/ 271 h 271"/>
                  <a:gd name="T64" fmla="*/ 4701 w 5409"/>
                  <a:gd name="T65" fmla="*/ 271 h 271"/>
                  <a:gd name="T66" fmla="*/ 4515 w 5409"/>
                  <a:gd name="T67" fmla="*/ 271 h 271"/>
                  <a:gd name="T68" fmla="*/ 4328 w 5409"/>
                  <a:gd name="T69" fmla="*/ 271 h 271"/>
                  <a:gd name="T70" fmla="*/ 4140 w 5409"/>
                  <a:gd name="T71" fmla="*/ 271 h 271"/>
                  <a:gd name="T72" fmla="*/ 3954 w 5409"/>
                  <a:gd name="T73" fmla="*/ 271 h 271"/>
                  <a:gd name="T74" fmla="*/ 3768 w 5409"/>
                  <a:gd name="T75" fmla="*/ 271 h 271"/>
                  <a:gd name="T76" fmla="*/ 3581 w 5409"/>
                  <a:gd name="T77" fmla="*/ 271 h 271"/>
                  <a:gd name="T78" fmla="*/ 3395 w 5409"/>
                  <a:gd name="T79" fmla="*/ 271 h 271"/>
                  <a:gd name="T80" fmla="*/ 3209 w 5409"/>
                  <a:gd name="T81" fmla="*/ 271 h 271"/>
                  <a:gd name="T82" fmla="*/ 3023 w 5409"/>
                  <a:gd name="T83" fmla="*/ 271 h 271"/>
                  <a:gd name="T84" fmla="*/ 2836 w 5409"/>
                  <a:gd name="T85" fmla="*/ 271 h 271"/>
                  <a:gd name="T86" fmla="*/ 2648 w 5409"/>
                  <a:gd name="T87" fmla="*/ 271 h 271"/>
                  <a:gd name="T88" fmla="*/ 2462 w 5409"/>
                  <a:gd name="T89" fmla="*/ 271 h 271"/>
                  <a:gd name="T90" fmla="*/ 2276 w 5409"/>
                  <a:gd name="T91" fmla="*/ 271 h 271"/>
                  <a:gd name="T92" fmla="*/ 2090 w 5409"/>
                  <a:gd name="T93" fmla="*/ 271 h 271"/>
                  <a:gd name="T94" fmla="*/ 1903 w 5409"/>
                  <a:gd name="T95" fmla="*/ 271 h 271"/>
                  <a:gd name="T96" fmla="*/ 1717 w 5409"/>
                  <a:gd name="T97" fmla="*/ 271 h 271"/>
                  <a:gd name="T98" fmla="*/ 1531 w 5409"/>
                  <a:gd name="T99" fmla="*/ 271 h 271"/>
                  <a:gd name="T100" fmla="*/ 1345 w 5409"/>
                  <a:gd name="T101" fmla="*/ 271 h 271"/>
                  <a:gd name="T102" fmla="*/ 1156 w 5409"/>
                  <a:gd name="T103" fmla="*/ 271 h 271"/>
                  <a:gd name="T104" fmla="*/ 970 w 5409"/>
                  <a:gd name="T105" fmla="*/ 271 h 271"/>
                  <a:gd name="T106" fmla="*/ 784 w 5409"/>
                  <a:gd name="T107" fmla="*/ 271 h 271"/>
                  <a:gd name="T108" fmla="*/ 598 w 5409"/>
                  <a:gd name="T109" fmla="*/ 271 h 271"/>
                  <a:gd name="T110" fmla="*/ 411 w 5409"/>
                  <a:gd name="T111" fmla="*/ 271 h 271"/>
                  <a:gd name="T112" fmla="*/ 225 w 5409"/>
                  <a:gd name="T113" fmla="*/ 271 h 271"/>
                  <a:gd name="T114" fmla="*/ 39 w 5409"/>
                  <a:gd name="T115" fmla="*/ 271 h 2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</a:cxnLst>
                <a:rect l="0" t="0" r="r" b="b"/>
                <a:pathLst>
                  <a:path w="5409" h="271">
                    <a:moveTo>
                      <a:pt x="0" y="125"/>
                    </a:moveTo>
                    <a:lnTo>
                      <a:pt x="20" y="58"/>
                    </a:lnTo>
                    <a:lnTo>
                      <a:pt x="39" y="54"/>
                    </a:lnTo>
                    <a:lnTo>
                      <a:pt x="56" y="50"/>
                    </a:lnTo>
                    <a:lnTo>
                      <a:pt x="75" y="120"/>
                    </a:lnTo>
                    <a:lnTo>
                      <a:pt x="95" y="110"/>
                    </a:lnTo>
                    <a:lnTo>
                      <a:pt x="114" y="141"/>
                    </a:lnTo>
                    <a:lnTo>
                      <a:pt x="131" y="137"/>
                    </a:lnTo>
                    <a:lnTo>
                      <a:pt x="150" y="45"/>
                    </a:lnTo>
                    <a:lnTo>
                      <a:pt x="169" y="62"/>
                    </a:lnTo>
                    <a:lnTo>
                      <a:pt x="187" y="150"/>
                    </a:lnTo>
                    <a:lnTo>
                      <a:pt x="206" y="85"/>
                    </a:lnTo>
                    <a:lnTo>
                      <a:pt x="225" y="96"/>
                    </a:lnTo>
                    <a:lnTo>
                      <a:pt x="244" y="181"/>
                    </a:lnTo>
                    <a:lnTo>
                      <a:pt x="262" y="10"/>
                    </a:lnTo>
                    <a:lnTo>
                      <a:pt x="281" y="164"/>
                    </a:lnTo>
                    <a:lnTo>
                      <a:pt x="300" y="58"/>
                    </a:lnTo>
                    <a:lnTo>
                      <a:pt x="317" y="112"/>
                    </a:lnTo>
                    <a:lnTo>
                      <a:pt x="337" y="81"/>
                    </a:lnTo>
                    <a:lnTo>
                      <a:pt x="356" y="29"/>
                    </a:lnTo>
                    <a:lnTo>
                      <a:pt x="375" y="85"/>
                    </a:lnTo>
                    <a:lnTo>
                      <a:pt x="392" y="133"/>
                    </a:lnTo>
                    <a:lnTo>
                      <a:pt x="411" y="125"/>
                    </a:lnTo>
                    <a:lnTo>
                      <a:pt x="431" y="43"/>
                    </a:lnTo>
                    <a:lnTo>
                      <a:pt x="448" y="41"/>
                    </a:lnTo>
                    <a:lnTo>
                      <a:pt x="467" y="89"/>
                    </a:lnTo>
                    <a:lnTo>
                      <a:pt x="486" y="139"/>
                    </a:lnTo>
                    <a:lnTo>
                      <a:pt x="505" y="68"/>
                    </a:lnTo>
                    <a:lnTo>
                      <a:pt x="523" y="52"/>
                    </a:lnTo>
                    <a:lnTo>
                      <a:pt x="542" y="112"/>
                    </a:lnTo>
                    <a:lnTo>
                      <a:pt x="561" y="102"/>
                    </a:lnTo>
                    <a:lnTo>
                      <a:pt x="578" y="123"/>
                    </a:lnTo>
                    <a:lnTo>
                      <a:pt x="598" y="54"/>
                    </a:lnTo>
                    <a:lnTo>
                      <a:pt x="617" y="8"/>
                    </a:lnTo>
                    <a:lnTo>
                      <a:pt x="636" y="77"/>
                    </a:lnTo>
                    <a:lnTo>
                      <a:pt x="653" y="41"/>
                    </a:lnTo>
                    <a:lnTo>
                      <a:pt x="673" y="43"/>
                    </a:lnTo>
                    <a:lnTo>
                      <a:pt x="692" y="43"/>
                    </a:lnTo>
                    <a:lnTo>
                      <a:pt x="709" y="127"/>
                    </a:lnTo>
                    <a:lnTo>
                      <a:pt x="728" y="23"/>
                    </a:lnTo>
                    <a:lnTo>
                      <a:pt x="747" y="110"/>
                    </a:lnTo>
                    <a:lnTo>
                      <a:pt x="767" y="83"/>
                    </a:lnTo>
                    <a:lnTo>
                      <a:pt x="784" y="41"/>
                    </a:lnTo>
                    <a:lnTo>
                      <a:pt x="803" y="127"/>
                    </a:lnTo>
                    <a:lnTo>
                      <a:pt x="822" y="123"/>
                    </a:lnTo>
                    <a:lnTo>
                      <a:pt x="840" y="104"/>
                    </a:lnTo>
                    <a:lnTo>
                      <a:pt x="859" y="114"/>
                    </a:lnTo>
                    <a:lnTo>
                      <a:pt x="878" y="58"/>
                    </a:lnTo>
                    <a:lnTo>
                      <a:pt x="895" y="150"/>
                    </a:lnTo>
                    <a:lnTo>
                      <a:pt x="914" y="91"/>
                    </a:lnTo>
                    <a:lnTo>
                      <a:pt x="934" y="56"/>
                    </a:lnTo>
                    <a:lnTo>
                      <a:pt x="953" y="87"/>
                    </a:lnTo>
                    <a:lnTo>
                      <a:pt x="970" y="72"/>
                    </a:lnTo>
                    <a:lnTo>
                      <a:pt x="989" y="100"/>
                    </a:lnTo>
                    <a:lnTo>
                      <a:pt x="1009" y="125"/>
                    </a:lnTo>
                    <a:lnTo>
                      <a:pt x="1026" y="72"/>
                    </a:lnTo>
                    <a:lnTo>
                      <a:pt x="1045" y="83"/>
                    </a:lnTo>
                    <a:lnTo>
                      <a:pt x="1064" y="50"/>
                    </a:lnTo>
                    <a:lnTo>
                      <a:pt x="1083" y="27"/>
                    </a:lnTo>
                    <a:lnTo>
                      <a:pt x="1101" y="16"/>
                    </a:lnTo>
                    <a:lnTo>
                      <a:pt x="1120" y="33"/>
                    </a:lnTo>
                    <a:lnTo>
                      <a:pt x="1139" y="45"/>
                    </a:lnTo>
                    <a:lnTo>
                      <a:pt x="1156" y="98"/>
                    </a:lnTo>
                    <a:lnTo>
                      <a:pt x="1176" y="87"/>
                    </a:lnTo>
                    <a:lnTo>
                      <a:pt x="1195" y="106"/>
                    </a:lnTo>
                    <a:lnTo>
                      <a:pt x="1214" y="145"/>
                    </a:lnTo>
                    <a:lnTo>
                      <a:pt x="1231" y="48"/>
                    </a:lnTo>
                    <a:lnTo>
                      <a:pt x="1250" y="114"/>
                    </a:lnTo>
                    <a:lnTo>
                      <a:pt x="1270" y="77"/>
                    </a:lnTo>
                    <a:lnTo>
                      <a:pt x="1287" y="87"/>
                    </a:lnTo>
                    <a:lnTo>
                      <a:pt x="1306" y="143"/>
                    </a:lnTo>
                    <a:lnTo>
                      <a:pt x="1325" y="62"/>
                    </a:lnTo>
                    <a:lnTo>
                      <a:pt x="1345" y="87"/>
                    </a:lnTo>
                    <a:lnTo>
                      <a:pt x="1362" y="100"/>
                    </a:lnTo>
                    <a:lnTo>
                      <a:pt x="1381" y="52"/>
                    </a:lnTo>
                    <a:lnTo>
                      <a:pt x="1400" y="70"/>
                    </a:lnTo>
                    <a:lnTo>
                      <a:pt x="1418" y="87"/>
                    </a:lnTo>
                    <a:lnTo>
                      <a:pt x="1437" y="50"/>
                    </a:lnTo>
                    <a:lnTo>
                      <a:pt x="1456" y="48"/>
                    </a:lnTo>
                    <a:lnTo>
                      <a:pt x="1475" y="129"/>
                    </a:lnTo>
                    <a:lnTo>
                      <a:pt x="1492" y="52"/>
                    </a:lnTo>
                    <a:lnTo>
                      <a:pt x="1512" y="131"/>
                    </a:lnTo>
                    <a:lnTo>
                      <a:pt x="1531" y="139"/>
                    </a:lnTo>
                    <a:lnTo>
                      <a:pt x="1548" y="87"/>
                    </a:lnTo>
                    <a:lnTo>
                      <a:pt x="1567" y="79"/>
                    </a:lnTo>
                    <a:lnTo>
                      <a:pt x="1586" y="64"/>
                    </a:lnTo>
                    <a:lnTo>
                      <a:pt x="1606" y="162"/>
                    </a:lnTo>
                    <a:lnTo>
                      <a:pt x="1623" y="25"/>
                    </a:lnTo>
                    <a:lnTo>
                      <a:pt x="1642" y="112"/>
                    </a:lnTo>
                    <a:lnTo>
                      <a:pt x="1661" y="52"/>
                    </a:lnTo>
                    <a:lnTo>
                      <a:pt x="1679" y="91"/>
                    </a:lnTo>
                    <a:lnTo>
                      <a:pt x="1698" y="83"/>
                    </a:lnTo>
                    <a:lnTo>
                      <a:pt x="1717" y="129"/>
                    </a:lnTo>
                    <a:lnTo>
                      <a:pt x="1736" y="116"/>
                    </a:lnTo>
                    <a:lnTo>
                      <a:pt x="1754" y="31"/>
                    </a:lnTo>
                    <a:lnTo>
                      <a:pt x="1773" y="73"/>
                    </a:lnTo>
                    <a:lnTo>
                      <a:pt x="1792" y="131"/>
                    </a:lnTo>
                    <a:lnTo>
                      <a:pt x="1809" y="16"/>
                    </a:lnTo>
                    <a:lnTo>
                      <a:pt x="1828" y="56"/>
                    </a:lnTo>
                    <a:lnTo>
                      <a:pt x="1848" y="47"/>
                    </a:lnTo>
                    <a:lnTo>
                      <a:pt x="1867" y="110"/>
                    </a:lnTo>
                    <a:lnTo>
                      <a:pt x="1884" y="131"/>
                    </a:lnTo>
                    <a:lnTo>
                      <a:pt x="1903" y="8"/>
                    </a:lnTo>
                    <a:lnTo>
                      <a:pt x="1923" y="91"/>
                    </a:lnTo>
                    <a:lnTo>
                      <a:pt x="1940" y="162"/>
                    </a:lnTo>
                    <a:lnTo>
                      <a:pt x="1959" y="27"/>
                    </a:lnTo>
                    <a:lnTo>
                      <a:pt x="1978" y="110"/>
                    </a:lnTo>
                    <a:lnTo>
                      <a:pt x="1997" y="81"/>
                    </a:lnTo>
                    <a:lnTo>
                      <a:pt x="2015" y="100"/>
                    </a:lnTo>
                    <a:lnTo>
                      <a:pt x="2034" y="129"/>
                    </a:lnTo>
                    <a:lnTo>
                      <a:pt x="2053" y="112"/>
                    </a:lnTo>
                    <a:lnTo>
                      <a:pt x="2070" y="83"/>
                    </a:lnTo>
                    <a:lnTo>
                      <a:pt x="2090" y="154"/>
                    </a:lnTo>
                    <a:lnTo>
                      <a:pt x="2109" y="35"/>
                    </a:lnTo>
                    <a:lnTo>
                      <a:pt x="2128" y="83"/>
                    </a:lnTo>
                    <a:lnTo>
                      <a:pt x="2145" y="0"/>
                    </a:lnTo>
                    <a:lnTo>
                      <a:pt x="2164" y="141"/>
                    </a:lnTo>
                    <a:lnTo>
                      <a:pt x="2184" y="81"/>
                    </a:lnTo>
                    <a:lnTo>
                      <a:pt x="2201" y="54"/>
                    </a:lnTo>
                    <a:lnTo>
                      <a:pt x="2220" y="110"/>
                    </a:lnTo>
                    <a:lnTo>
                      <a:pt x="2239" y="96"/>
                    </a:lnTo>
                    <a:lnTo>
                      <a:pt x="2259" y="260"/>
                    </a:lnTo>
                    <a:lnTo>
                      <a:pt x="2276" y="202"/>
                    </a:lnTo>
                    <a:lnTo>
                      <a:pt x="2295" y="72"/>
                    </a:lnTo>
                    <a:lnTo>
                      <a:pt x="2314" y="89"/>
                    </a:lnTo>
                    <a:lnTo>
                      <a:pt x="2331" y="137"/>
                    </a:lnTo>
                    <a:lnTo>
                      <a:pt x="2351" y="150"/>
                    </a:lnTo>
                    <a:lnTo>
                      <a:pt x="2370" y="185"/>
                    </a:lnTo>
                    <a:lnTo>
                      <a:pt x="2389" y="60"/>
                    </a:lnTo>
                    <a:lnTo>
                      <a:pt x="2406" y="196"/>
                    </a:lnTo>
                    <a:lnTo>
                      <a:pt x="2426" y="214"/>
                    </a:lnTo>
                    <a:lnTo>
                      <a:pt x="2445" y="137"/>
                    </a:lnTo>
                    <a:lnTo>
                      <a:pt x="2462" y="129"/>
                    </a:lnTo>
                    <a:lnTo>
                      <a:pt x="2481" y="183"/>
                    </a:lnTo>
                    <a:lnTo>
                      <a:pt x="2500" y="127"/>
                    </a:lnTo>
                    <a:lnTo>
                      <a:pt x="2518" y="73"/>
                    </a:lnTo>
                    <a:lnTo>
                      <a:pt x="2537" y="189"/>
                    </a:lnTo>
                    <a:lnTo>
                      <a:pt x="2556" y="156"/>
                    </a:lnTo>
                    <a:lnTo>
                      <a:pt x="2575" y="96"/>
                    </a:lnTo>
                    <a:lnTo>
                      <a:pt x="2593" y="166"/>
                    </a:lnTo>
                    <a:lnTo>
                      <a:pt x="2612" y="131"/>
                    </a:lnTo>
                    <a:lnTo>
                      <a:pt x="2631" y="146"/>
                    </a:lnTo>
                    <a:lnTo>
                      <a:pt x="2648" y="54"/>
                    </a:lnTo>
                    <a:lnTo>
                      <a:pt x="2668" y="87"/>
                    </a:lnTo>
                    <a:lnTo>
                      <a:pt x="2687" y="162"/>
                    </a:lnTo>
                    <a:lnTo>
                      <a:pt x="2706" y="106"/>
                    </a:lnTo>
                    <a:lnTo>
                      <a:pt x="2723" y="137"/>
                    </a:lnTo>
                    <a:lnTo>
                      <a:pt x="2742" y="173"/>
                    </a:lnTo>
                    <a:lnTo>
                      <a:pt x="2762" y="170"/>
                    </a:lnTo>
                    <a:lnTo>
                      <a:pt x="2779" y="246"/>
                    </a:lnTo>
                    <a:lnTo>
                      <a:pt x="2798" y="210"/>
                    </a:lnTo>
                    <a:lnTo>
                      <a:pt x="2817" y="87"/>
                    </a:lnTo>
                    <a:lnTo>
                      <a:pt x="2836" y="154"/>
                    </a:lnTo>
                    <a:lnTo>
                      <a:pt x="2854" y="204"/>
                    </a:lnTo>
                    <a:lnTo>
                      <a:pt x="2873" y="171"/>
                    </a:lnTo>
                    <a:lnTo>
                      <a:pt x="2892" y="235"/>
                    </a:lnTo>
                    <a:lnTo>
                      <a:pt x="2909" y="252"/>
                    </a:lnTo>
                    <a:lnTo>
                      <a:pt x="2929" y="171"/>
                    </a:lnTo>
                    <a:lnTo>
                      <a:pt x="2948" y="252"/>
                    </a:lnTo>
                    <a:lnTo>
                      <a:pt x="2967" y="266"/>
                    </a:lnTo>
                    <a:lnTo>
                      <a:pt x="2984" y="271"/>
                    </a:lnTo>
                    <a:lnTo>
                      <a:pt x="3004" y="260"/>
                    </a:lnTo>
                    <a:lnTo>
                      <a:pt x="3023" y="227"/>
                    </a:lnTo>
                    <a:lnTo>
                      <a:pt x="3040" y="271"/>
                    </a:lnTo>
                    <a:lnTo>
                      <a:pt x="3059" y="235"/>
                    </a:lnTo>
                    <a:lnTo>
                      <a:pt x="3078" y="98"/>
                    </a:lnTo>
                    <a:lnTo>
                      <a:pt x="3098" y="271"/>
                    </a:lnTo>
                    <a:lnTo>
                      <a:pt x="3115" y="271"/>
                    </a:lnTo>
                    <a:lnTo>
                      <a:pt x="3134" y="271"/>
                    </a:lnTo>
                    <a:lnTo>
                      <a:pt x="3153" y="271"/>
                    </a:lnTo>
                    <a:lnTo>
                      <a:pt x="3171" y="187"/>
                    </a:lnTo>
                    <a:lnTo>
                      <a:pt x="3190" y="246"/>
                    </a:lnTo>
                    <a:lnTo>
                      <a:pt x="3209" y="268"/>
                    </a:lnTo>
                    <a:lnTo>
                      <a:pt x="3228" y="206"/>
                    </a:lnTo>
                    <a:lnTo>
                      <a:pt x="3245" y="168"/>
                    </a:lnTo>
                    <a:lnTo>
                      <a:pt x="3265" y="246"/>
                    </a:lnTo>
                    <a:lnTo>
                      <a:pt x="3284" y="221"/>
                    </a:lnTo>
                    <a:lnTo>
                      <a:pt x="3301" y="269"/>
                    </a:lnTo>
                    <a:lnTo>
                      <a:pt x="3320" y="271"/>
                    </a:lnTo>
                    <a:lnTo>
                      <a:pt x="3340" y="271"/>
                    </a:lnTo>
                    <a:lnTo>
                      <a:pt x="3359" y="262"/>
                    </a:lnTo>
                    <a:lnTo>
                      <a:pt x="3376" y="271"/>
                    </a:lnTo>
                    <a:lnTo>
                      <a:pt x="3395" y="271"/>
                    </a:lnTo>
                    <a:lnTo>
                      <a:pt x="3414" y="271"/>
                    </a:lnTo>
                    <a:lnTo>
                      <a:pt x="3432" y="264"/>
                    </a:lnTo>
                    <a:lnTo>
                      <a:pt x="3451" y="271"/>
                    </a:lnTo>
                    <a:lnTo>
                      <a:pt x="3470" y="271"/>
                    </a:lnTo>
                    <a:lnTo>
                      <a:pt x="3489" y="271"/>
                    </a:lnTo>
                    <a:lnTo>
                      <a:pt x="3507" y="256"/>
                    </a:lnTo>
                    <a:lnTo>
                      <a:pt x="3526" y="250"/>
                    </a:lnTo>
                    <a:lnTo>
                      <a:pt x="3545" y="262"/>
                    </a:lnTo>
                    <a:lnTo>
                      <a:pt x="3562" y="223"/>
                    </a:lnTo>
                    <a:lnTo>
                      <a:pt x="3581" y="269"/>
                    </a:lnTo>
                    <a:lnTo>
                      <a:pt x="3601" y="248"/>
                    </a:lnTo>
                    <a:lnTo>
                      <a:pt x="3620" y="244"/>
                    </a:lnTo>
                    <a:lnTo>
                      <a:pt x="3637" y="204"/>
                    </a:lnTo>
                    <a:lnTo>
                      <a:pt x="3656" y="137"/>
                    </a:lnTo>
                    <a:lnTo>
                      <a:pt x="3676" y="248"/>
                    </a:lnTo>
                    <a:lnTo>
                      <a:pt x="3693" y="164"/>
                    </a:lnTo>
                    <a:lnTo>
                      <a:pt x="3712" y="235"/>
                    </a:lnTo>
                    <a:lnTo>
                      <a:pt x="3731" y="254"/>
                    </a:lnTo>
                    <a:lnTo>
                      <a:pt x="3750" y="269"/>
                    </a:lnTo>
                    <a:lnTo>
                      <a:pt x="3768" y="264"/>
                    </a:lnTo>
                    <a:lnTo>
                      <a:pt x="3787" y="229"/>
                    </a:lnTo>
                    <a:lnTo>
                      <a:pt x="3806" y="271"/>
                    </a:lnTo>
                    <a:lnTo>
                      <a:pt x="3823" y="237"/>
                    </a:lnTo>
                    <a:lnTo>
                      <a:pt x="3843" y="266"/>
                    </a:lnTo>
                    <a:lnTo>
                      <a:pt x="3862" y="260"/>
                    </a:lnTo>
                    <a:lnTo>
                      <a:pt x="3881" y="243"/>
                    </a:lnTo>
                    <a:lnTo>
                      <a:pt x="3898" y="221"/>
                    </a:lnTo>
                    <a:lnTo>
                      <a:pt x="3918" y="183"/>
                    </a:lnTo>
                    <a:lnTo>
                      <a:pt x="3937" y="258"/>
                    </a:lnTo>
                    <a:lnTo>
                      <a:pt x="3954" y="196"/>
                    </a:lnTo>
                    <a:lnTo>
                      <a:pt x="3973" y="244"/>
                    </a:lnTo>
                    <a:lnTo>
                      <a:pt x="3992" y="223"/>
                    </a:lnTo>
                    <a:lnTo>
                      <a:pt x="4012" y="227"/>
                    </a:lnTo>
                    <a:lnTo>
                      <a:pt x="4029" y="229"/>
                    </a:lnTo>
                    <a:lnTo>
                      <a:pt x="4048" y="254"/>
                    </a:lnTo>
                    <a:lnTo>
                      <a:pt x="4067" y="264"/>
                    </a:lnTo>
                    <a:lnTo>
                      <a:pt x="4085" y="262"/>
                    </a:lnTo>
                    <a:lnTo>
                      <a:pt x="4104" y="246"/>
                    </a:lnTo>
                    <a:lnTo>
                      <a:pt x="4123" y="194"/>
                    </a:lnTo>
                    <a:lnTo>
                      <a:pt x="4140" y="214"/>
                    </a:lnTo>
                    <a:lnTo>
                      <a:pt x="4159" y="266"/>
                    </a:lnTo>
                    <a:lnTo>
                      <a:pt x="4179" y="268"/>
                    </a:lnTo>
                    <a:lnTo>
                      <a:pt x="4198" y="266"/>
                    </a:lnTo>
                    <a:lnTo>
                      <a:pt x="4215" y="256"/>
                    </a:lnTo>
                    <a:lnTo>
                      <a:pt x="4234" y="266"/>
                    </a:lnTo>
                    <a:lnTo>
                      <a:pt x="4254" y="271"/>
                    </a:lnTo>
                    <a:lnTo>
                      <a:pt x="4271" y="271"/>
                    </a:lnTo>
                    <a:lnTo>
                      <a:pt x="4290" y="271"/>
                    </a:lnTo>
                    <a:lnTo>
                      <a:pt x="4309" y="254"/>
                    </a:lnTo>
                    <a:lnTo>
                      <a:pt x="4328" y="244"/>
                    </a:lnTo>
                    <a:lnTo>
                      <a:pt x="4346" y="241"/>
                    </a:lnTo>
                    <a:lnTo>
                      <a:pt x="4365" y="260"/>
                    </a:lnTo>
                    <a:lnTo>
                      <a:pt x="4384" y="256"/>
                    </a:lnTo>
                    <a:lnTo>
                      <a:pt x="4401" y="271"/>
                    </a:lnTo>
                    <a:lnTo>
                      <a:pt x="4421" y="264"/>
                    </a:lnTo>
                    <a:lnTo>
                      <a:pt x="4440" y="256"/>
                    </a:lnTo>
                    <a:lnTo>
                      <a:pt x="4459" y="243"/>
                    </a:lnTo>
                    <a:lnTo>
                      <a:pt x="4476" y="271"/>
                    </a:lnTo>
                    <a:lnTo>
                      <a:pt x="4495" y="237"/>
                    </a:lnTo>
                    <a:lnTo>
                      <a:pt x="4515" y="271"/>
                    </a:lnTo>
                    <a:lnTo>
                      <a:pt x="4532" y="216"/>
                    </a:lnTo>
                    <a:lnTo>
                      <a:pt x="4551" y="256"/>
                    </a:lnTo>
                    <a:lnTo>
                      <a:pt x="4570" y="233"/>
                    </a:lnTo>
                    <a:lnTo>
                      <a:pt x="4590" y="271"/>
                    </a:lnTo>
                    <a:lnTo>
                      <a:pt x="4607" y="252"/>
                    </a:lnTo>
                    <a:lnTo>
                      <a:pt x="4626" y="233"/>
                    </a:lnTo>
                    <a:lnTo>
                      <a:pt x="4645" y="250"/>
                    </a:lnTo>
                    <a:lnTo>
                      <a:pt x="4663" y="271"/>
                    </a:lnTo>
                    <a:lnTo>
                      <a:pt x="4682" y="210"/>
                    </a:lnTo>
                    <a:lnTo>
                      <a:pt x="4701" y="219"/>
                    </a:lnTo>
                    <a:lnTo>
                      <a:pt x="4720" y="239"/>
                    </a:lnTo>
                    <a:lnTo>
                      <a:pt x="4737" y="246"/>
                    </a:lnTo>
                    <a:lnTo>
                      <a:pt x="4757" y="208"/>
                    </a:lnTo>
                    <a:lnTo>
                      <a:pt x="4776" y="208"/>
                    </a:lnTo>
                    <a:lnTo>
                      <a:pt x="4793" y="254"/>
                    </a:lnTo>
                    <a:lnTo>
                      <a:pt x="4812" y="185"/>
                    </a:lnTo>
                    <a:lnTo>
                      <a:pt x="4831" y="214"/>
                    </a:lnTo>
                    <a:lnTo>
                      <a:pt x="4851" y="229"/>
                    </a:lnTo>
                    <a:lnTo>
                      <a:pt x="4868" y="194"/>
                    </a:lnTo>
                    <a:lnTo>
                      <a:pt x="4887" y="181"/>
                    </a:lnTo>
                    <a:lnTo>
                      <a:pt x="4906" y="241"/>
                    </a:lnTo>
                    <a:lnTo>
                      <a:pt x="4924" y="254"/>
                    </a:lnTo>
                    <a:lnTo>
                      <a:pt x="4943" y="143"/>
                    </a:lnTo>
                    <a:lnTo>
                      <a:pt x="4962" y="269"/>
                    </a:lnTo>
                    <a:lnTo>
                      <a:pt x="4981" y="271"/>
                    </a:lnTo>
                    <a:lnTo>
                      <a:pt x="4999" y="271"/>
                    </a:lnTo>
                    <a:lnTo>
                      <a:pt x="5018" y="271"/>
                    </a:lnTo>
                    <a:lnTo>
                      <a:pt x="5037" y="271"/>
                    </a:lnTo>
                    <a:lnTo>
                      <a:pt x="5054" y="235"/>
                    </a:lnTo>
                    <a:lnTo>
                      <a:pt x="5073" y="271"/>
                    </a:lnTo>
                    <a:lnTo>
                      <a:pt x="5093" y="235"/>
                    </a:lnTo>
                    <a:lnTo>
                      <a:pt x="5112" y="177"/>
                    </a:lnTo>
                    <a:lnTo>
                      <a:pt x="5129" y="196"/>
                    </a:lnTo>
                    <a:lnTo>
                      <a:pt x="5148" y="266"/>
                    </a:lnTo>
                    <a:lnTo>
                      <a:pt x="5167" y="262"/>
                    </a:lnTo>
                    <a:lnTo>
                      <a:pt x="5185" y="256"/>
                    </a:lnTo>
                    <a:lnTo>
                      <a:pt x="5204" y="216"/>
                    </a:lnTo>
                    <a:lnTo>
                      <a:pt x="5223" y="191"/>
                    </a:lnTo>
                    <a:lnTo>
                      <a:pt x="5242" y="212"/>
                    </a:lnTo>
                    <a:lnTo>
                      <a:pt x="5260" y="248"/>
                    </a:lnTo>
                    <a:lnTo>
                      <a:pt x="5279" y="262"/>
                    </a:lnTo>
                    <a:lnTo>
                      <a:pt x="5298" y="271"/>
                    </a:lnTo>
                    <a:lnTo>
                      <a:pt x="5315" y="269"/>
                    </a:lnTo>
                    <a:lnTo>
                      <a:pt x="5335" y="268"/>
                    </a:lnTo>
                    <a:lnTo>
                      <a:pt x="5354" y="254"/>
                    </a:lnTo>
                    <a:lnTo>
                      <a:pt x="5373" y="250"/>
                    </a:lnTo>
                    <a:lnTo>
                      <a:pt x="5390" y="244"/>
                    </a:lnTo>
                    <a:lnTo>
                      <a:pt x="5409" y="264"/>
                    </a:lnTo>
                    <a:lnTo>
                      <a:pt x="5409" y="271"/>
                    </a:lnTo>
                    <a:lnTo>
                      <a:pt x="5390" y="271"/>
                    </a:lnTo>
                    <a:lnTo>
                      <a:pt x="5373" y="271"/>
                    </a:lnTo>
                    <a:lnTo>
                      <a:pt x="5354" y="271"/>
                    </a:lnTo>
                    <a:lnTo>
                      <a:pt x="5335" y="271"/>
                    </a:lnTo>
                    <a:lnTo>
                      <a:pt x="5315" y="271"/>
                    </a:lnTo>
                    <a:lnTo>
                      <a:pt x="5298" y="271"/>
                    </a:lnTo>
                    <a:lnTo>
                      <a:pt x="5279" y="271"/>
                    </a:lnTo>
                    <a:lnTo>
                      <a:pt x="5260" y="271"/>
                    </a:lnTo>
                    <a:lnTo>
                      <a:pt x="5242" y="271"/>
                    </a:lnTo>
                    <a:lnTo>
                      <a:pt x="5223" y="271"/>
                    </a:lnTo>
                    <a:lnTo>
                      <a:pt x="5204" y="271"/>
                    </a:lnTo>
                    <a:lnTo>
                      <a:pt x="5185" y="271"/>
                    </a:lnTo>
                    <a:lnTo>
                      <a:pt x="5167" y="271"/>
                    </a:lnTo>
                    <a:lnTo>
                      <a:pt x="5148" y="271"/>
                    </a:lnTo>
                    <a:lnTo>
                      <a:pt x="5129" y="271"/>
                    </a:lnTo>
                    <a:lnTo>
                      <a:pt x="5112" y="271"/>
                    </a:lnTo>
                    <a:lnTo>
                      <a:pt x="5093" y="271"/>
                    </a:lnTo>
                    <a:lnTo>
                      <a:pt x="5073" y="271"/>
                    </a:lnTo>
                    <a:lnTo>
                      <a:pt x="5054" y="271"/>
                    </a:lnTo>
                    <a:lnTo>
                      <a:pt x="5037" y="271"/>
                    </a:lnTo>
                    <a:lnTo>
                      <a:pt x="5018" y="271"/>
                    </a:lnTo>
                    <a:lnTo>
                      <a:pt x="4999" y="271"/>
                    </a:lnTo>
                    <a:lnTo>
                      <a:pt x="4981" y="271"/>
                    </a:lnTo>
                    <a:lnTo>
                      <a:pt x="4962" y="271"/>
                    </a:lnTo>
                    <a:lnTo>
                      <a:pt x="4943" y="271"/>
                    </a:lnTo>
                    <a:lnTo>
                      <a:pt x="4924" y="271"/>
                    </a:lnTo>
                    <a:lnTo>
                      <a:pt x="4906" y="271"/>
                    </a:lnTo>
                    <a:lnTo>
                      <a:pt x="4887" y="271"/>
                    </a:lnTo>
                    <a:lnTo>
                      <a:pt x="4868" y="271"/>
                    </a:lnTo>
                    <a:lnTo>
                      <a:pt x="4851" y="271"/>
                    </a:lnTo>
                    <a:lnTo>
                      <a:pt x="4831" y="271"/>
                    </a:lnTo>
                    <a:lnTo>
                      <a:pt x="4812" y="271"/>
                    </a:lnTo>
                    <a:lnTo>
                      <a:pt x="4793" y="271"/>
                    </a:lnTo>
                    <a:lnTo>
                      <a:pt x="4776" y="271"/>
                    </a:lnTo>
                    <a:lnTo>
                      <a:pt x="4757" y="271"/>
                    </a:lnTo>
                    <a:lnTo>
                      <a:pt x="4737" y="271"/>
                    </a:lnTo>
                    <a:lnTo>
                      <a:pt x="4720" y="271"/>
                    </a:lnTo>
                    <a:lnTo>
                      <a:pt x="4701" y="271"/>
                    </a:lnTo>
                    <a:lnTo>
                      <a:pt x="4682" y="271"/>
                    </a:lnTo>
                    <a:lnTo>
                      <a:pt x="4663" y="271"/>
                    </a:lnTo>
                    <a:lnTo>
                      <a:pt x="4645" y="271"/>
                    </a:lnTo>
                    <a:lnTo>
                      <a:pt x="4626" y="271"/>
                    </a:lnTo>
                    <a:lnTo>
                      <a:pt x="4607" y="271"/>
                    </a:lnTo>
                    <a:lnTo>
                      <a:pt x="4590" y="271"/>
                    </a:lnTo>
                    <a:lnTo>
                      <a:pt x="4570" y="271"/>
                    </a:lnTo>
                    <a:lnTo>
                      <a:pt x="4551" y="271"/>
                    </a:lnTo>
                    <a:lnTo>
                      <a:pt x="4532" y="271"/>
                    </a:lnTo>
                    <a:lnTo>
                      <a:pt x="4515" y="271"/>
                    </a:lnTo>
                    <a:lnTo>
                      <a:pt x="4495" y="271"/>
                    </a:lnTo>
                    <a:lnTo>
                      <a:pt x="4476" y="271"/>
                    </a:lnTo>
                    <a:lnTo>
                      <a:pt x="4459" y="271"/>
                    </a:lnTo>
                    <a:lnTo>
                      <a:pt x="4440" y="271"/>
                    </a:lnTo>
                    <a:lnTo>
                      <a:pt x="4421" y="271"/>
                    </a:lnTo>
                    <a:lnTo>
                      <a:pt x="4401" y="271"/>
                    </a:lnTo>
                    <a:lnTo>
                      <a:pt x="4384" y="271"/>
                    </a:lnTo>
                    <a:lnTo>
                      <a:pt x="4365" y="271"/>
                    </a:lnTo>
                    <a:lnTo>
                      <a:pt x="4346" y="271"/>
                    </a:lnTo>
                    <a:lnTo>
                      <a:pt x="4328" y="271"/>
                    </a:lnTo>
                    <a:lnTo>
                      <a:pt x="4309" y="271"/>
                    </a:lnTo>
                    <a:lnTo>
                      <a:pt x="4290" y="271"/>
                    </a:lnTo>
                    <a:lnTo>
                      <a:pt x="4271" y="271"/>
                    </a:lnTo>
                    <a:lnTo>
                      <a:pt x="4254" y="271"/>
                    </a:lnTo>
                    <a:lnTo>
                      <a:pt x="4234" y="271"/>
                    </a:lnTo>
                    <a:lnTo>
                      <a:pt x="4215" y="271"/>
                    </a:lnTo>
                    <a:lnTo>
                      <a:pt x="4198" y="271"/>
                    </a:lnTo>
                    <a:lnTo>
                      <a:pt x="4179" y="271"/>
                    </a:lnTo>
                    <a:lnTo>
                      <a:pt x="4159" y="271"/>
                    </a:lnTo>
                    <a:lnTo>
                      <a:pt x="4140" y="271"/>
                    </a:lnTo>
                    <a:lnTo>
                      <a:pt x="4123" y="271"/>
                    </a:lnTo>
                    <a:lnTo>
                      <a:pt x="4104" y="271"/>
                    </a:lnTo>
                    <a:lnTo>
                      <a:pt x="4085" y="271"/>
                    </a:lnTo>
                    <a:lnTo>
                      <a:pt x="4067" y="271"/>
                    </a:lnTo>
                    <a:lnTo>
                      <a:pt x="4048" y="271"/>
                    </a:lnTo>
                    <a:lnTo>
                      <a:pt x="4029" y="271"/>
                    </a:lnTo>
                    <a:lnTo>
                      <a:pt x="4012" y="271"/>
                    </a:lnTo>
                    <a:lnTo>
                      <a:pt x="3992" y="271"/>
                    </a:lnTo>
                    <a:lnTo>
                      <a:pt x="3973" y="271"/>
                    </a:lnTo>
                    <a:lnTo>
                      <a:pt x="3954" y="271"/>
                    </a:lnTo>
                    <a:lnTo>
                      <a:pt x="3937" y="271"/>
                    </a:lnTo>
                    <a:lnTo>
                      <a:pt x="3918" y="271"/>
                    </a:lnTo>
                    <a:lnTo>
                      <a:pt x="3898" y="271"/>
                    </a:lnTo>
                    <a:lnTo>
                      <a:pt x="3881" y="271"/>
                    </a:lnTo>
                    <a:lnTo>
                      <a:pt x="3862" y="271"/>
                    </a:lnTo>
                    <a:lnTo>
                      <a:pt x="3843" y="271"/>
                    </a:lnTo>
                    <a:lnTo>
                      <a:pt x="3823" y="271"/>
                    </a:lnTo>
                    <a:lnTo>
                      <a:pt x="3806" y="271"/>
                    </a:lnTo>
                    <a:lnTo>
                      <a:pt x="3787" y="271"/>
                    </a:lnTo>
                    <a:lnTo>
                      <a:pt x="3768" y="271"/>
                    </a:lnTo>
                    <a:lnTo>
                      <a:pt x="3750" y="271"/>
                    </a:lnTo>
                    <a:lnTo>
                      <a:pt x="3731" y="271"/>
                    </a:lnTo>
                    <a:lnTo>
                      <a:pt x="3712" y="271"/>
                    </a:lnTo>
                    <a:lnTo>
                      <a:pt x="3693" y="271"/>
                    </a:lnTo>
                    <a:lnTo>
                      <a:pt x="3676" y="271"/>
                    </a:lnTo>
                    <a:lnTo>
                      <a:pt x="3656" y="271"/>
                    </a:lnTo>
                    <a:lnTo>
                      <a:pt x="3637" y="271"/>
                    </a:lnTo>
                    <a:lnTo>
                      <a:pt x="3620" y="271"/>
                    </a:lnTo>
                    <a:lnTo>
                      <a:pt x="3601" y="271"/>
                    </a:lnTo>
                    <a:lnTo>
                      <a:pt x="3581" y="271"/>
                    </a:lnTo>
                    <a:lnTo>
                      <a:pt x="3562" y="271"/>
                    </a:lnTo>
                    <a:lnTo>
                      <a:pt x="3545" y="271"/>
                    </a:lnTo>
                    <a:lnTo>
                      <a:pt x="3526" y="271"/>
                    </a:lnTo>
                    <a:lnTo>
                      <a:pt x="3507" y="271"/>
                    </a:lnTo>
                    <a:lnTo>
                      <a:pt x="3489" y="271"/>
                    </a:lnTo>
                    <a:lnTo>
                      <a:pt x="3470" y="271"/>
                    </a:lnTo>
                    <a:lnTo>
                      <a:pt x="3451" y="271"/>
                    </a:lnTo>
                    <a:lnTo>
                      <a:pt x="3432" y="271"/>
                    </a:lnTo>
                    <a:lnTo>
                      <a:pt x="3414" y="271"/>
                    </a:lnTo>
                    <a:lnTo>
                      <a:pt x="3395" y="271"/>
                    </a:lnTo>
                    <a:lnTo>
                      <a:pt x="3376" y="271"/>
                    </a:lnTo>
                    <a:lnTo>
                      <a:pt x="3359" y="271"/>
                    </a:lnTo>
                    <a:lnTo>
                      <a:pt x="3340" y="271"/>
                    </a:lnTo>
                    <a:lnTo>
                      <a:pt x="3320" y="271"/>
                    </a:lnTo>
                    <a:lnTo>
                      <a:pt x="3301" y="271"/>
                    </a:lnTo>
                    <a:lnTo>
                      <a:pt x="3284" y="271"/>
                    </a:lnTo>
                    <a:lnTo>
                      <a:pt x="3265" y="271"/>
                    </a:lnTo>
                    <a:lnTo>
                      <a:pt x="3245" y="271"/>
                    </a:lnTo>
                    <a:lnTo>
                      <a:pt x="3228" y="271"/>
                    </a:lnTo>
                    <a:lnTo>
                      <a:pt x="3209" y="271"/>
                    </a:lnTo>
                    <a:lnTo>
                      <a:pt x="3190" y="271"/>
                    </a:lnTo>
                    <a:lnTo>
                      <a:pt x="3171" y="271"/>
                    </a:lnTo>
                    <a:lnTo>
                      <a:pt x="3153" y="271"/>
                    </a:lnTo>
                    <a:lnTo>
                      <a:pt x="3134" y="271"/>
                    </a:lnTo>
                    <a:lnTo>
                      <a:pt x="3115" y="271"/>
                    </a:lnTo>
                    <a:lnTo>
                      <a:pt x="3098" y="271"/>
                    </a:lnTo>
                    <a:lnTo>
                      <a:pt x="3078" y="271"/>
                    </a:lnTo>
                    <a:lnTo>
                      <a:pt x="3059" y="271"/>
                    </a:lnTo>
                    <a:lnTo>
                      <a:pt x="3040" y="271"/>
                    </a:lnTo>
                    <a:lnTo>
                      <a:pt x="3023" y="271"/>
                    </a:lnTo>
                    <a:lnTo>
                      <a:pt x="3004" y="271"/>
                    </a:lnTo>
                    <a:lnTo>
                      <a:pt x="2984" y="271"/>
                    </a:lnTo>
                    <a:lnTo>
                      <a:pt x="2967" y="271"/>
                    </a:lnTo>
                    <a:lnTo>
                      <a:pt x="2948" y="271"/>
                    </a:lnTo>
                    <a:lnTo>
                      <a:pt x="2929" y="271"/>
                    </a:lnTo>
                    <a:lnTo>
                      <a:pt x="2909" y="271"/>
                    </a:lnTo>
                    <a:lnTo>
                      <a:pt x="2892" y="271"/>
                    </a:lnTo>
                    <a:lnTo>
                      <a:pt x="2873" y="271"/>
                    </a:lnTo>
                    <a:lnTo>
                      <a:pt x="2854" y="271"/>
                    </a:lnTo>
                    <a:lnTo>
                      <a:pt x="2836" y="271"/>
                    </a:lnTo>
                    <a:lnTo>
                      <a:pt x="2817" y="271"/>
                    </a:lnTo>
                    <a:lnTo>
                      <a:pt x="2798" y="271"/>
                    </a:lnTo>
                    <a:lnTo>
                      <a:pt x="2779" y="271"/>
                    </a:lnTo>
                    <a:lnTo>
                      <a:pt x="2762" y="271"/>
                    </a:lnTo>
                    <a:lnTo>
                      <a:pt x="2742" y="271"/>
                    </a:lnTo>
                    <a:lnTo>
                      <a:pt x="2723" y="271"/>
                    </a:lnTo>
                    <a:lnTo>
                      <a:pt x="2706" y="271"/>
                    </a:lnTo>
                    <a:lnTo>
                      <a:pt x="2687" y="271"/>
                    </a:lnTo>
                    <a:lnTo>
                      <a:pt x="2668" y="271"/>
                    </a:lnTo>
                    <a:lnTo>
                      <a:pt x="2648" y="271"/>
                    </a:lnTo>
                    <a:lnTo>
                      <a:pt x="2631" y="271"/>
                    </a:lnTo>
                    <a:lnTo>
                      <a:pt x="2612" y="271"/>
                    </a:lnTo>
                    <a:lnTo>
                      <a:pt x="2593" y="271"/>
                    </a:lnTo>
                    <a:lnTo>
                      <a:pt x="2575" y="271"/>
                    </a:lnTo>
                    <a:lnTo>
                      <a:pt x="2556" y="271"/>
                    </a:lnTo>
                    <a:lnTo>
                      <a:pt x="2537" y="271"/>
                    </a:lnTo>
                    <a:lnTo>
                      <a:pt x="2518" y="271"/>
                    </a:lnTo>
                    <a:lnTo>
                      <a:pt x="2500" y="271"/>
                    </a:lnTo>
                    <a:lnTo>
                      <a:pt x="2481" y="271"/>
                    </a:lnTo>
                    <a:lnTo>
                      <a:pt x="2462" y="271"/>
                    </a:lnTo>
                    <a:lnTo>
                      <a:pt x="2445" y="271"/>
                    </a:lnTo>
                    <a:lnTo>
                      <a:pt x="2426" y="271"/>
                    </a:lnTo>
                    <a:lnTo>
                      <a:pt x="2406" y="271"/>
                    </a:lnTo>
                    <a:lnTo>
                      <a:pt x="2389" y="271"/>
                    </a:lnTo>
                    <a:lnTo>
                      <a:pt x="2370" y="271"/>
                    </a:lnTo>
                    <a:lnTo>
                      <a:pt x="2351" y="271"/>
                    </a:lnTo>
                    <a:lnTo>
                      <a:pt x="2331" y="271"/>
                    </a:lnTo>
                    <a:lnTo>
                      <a:pt x="2314" y="271"/>
                    </a:lnTo>
                    <a:lnTo>
                      <a:pt x="2295" y="271"/>
                    </a:lnTo>
                    <a:lnTo>
                      <a:pt x="2276" y="271"/>
                    </a:lnTo>
                    <a:lnTo>
                      <a:pt x="2259" y="271"/>
                    </a:lnTo>
                    <a:lnTo>
                      <a:pt x="2239" y="271"/>
                    </a:lnTo>
                    <a:lnTo>
                      <a:pt x="2220" y="271"/>
                    </a:lnTo>
                    <a:lnTo>
                      <a:pt x="2201" y="271"/>
                    </a:lnTo>
                    <a:lnTo>
                      <a:pt x="2184" y="271"/>
                    </a:lnTo>
                    <a:lnTo>
                      <a:pt x="2164" y="271"/>
                    </a:lnTo>
                    <a:lnTo>
                      <a:pt x="2145" y="271"/>
                    </a:lnTo>
                    <a:lnTo>
                      <a:pt x="2128" y="271"/>
                    </a:lnTo>
                    <a:lnTo>
                      <a:pt x="2109" y="271"/>
                    </a:lnTo>
                    <a:lnTo>
                      <a:pt x="2090" y="271"/>
                    </a:lnTo>
                    <a:lnTo>
                      <a:pt x="2070" y="271"/>
                    </a:lnTo>
                    <a:lnTo>
                      <a:pt x="2053" y="271"/>
                    </a:lnTo>
                    <a:lnTo>
                      <a:pt x="2034" y="271"/>
                    </a:lnTo>
                    <a:lnTo>
                      <a:pt x="2015" y="271"/>
                    </a:lnTo>
                    <a:lnTo>
                      <a:pt x="1997" y="271"/>
                    </a:lnTo>
                    <a:lnTo>
                      <a:pt x="1978" y="271"/>
                    </a:lnTo>
                    <a:lnTo>
                      <a:pt x="1959" y="271"/>
                    </a:lnTo>
                    <a:lnTo>
                      <a:pt x="1940" y="271"/>
                    </a:lnTo>
                    <a:lnTo>
                      <a:pt x="1923" y="271"/>
                    </a:lnTo>
                    <a:lnTo>
                      <a:pt x="1903" y="271"/>
                    </a:lnTo>
                    <a:lnTo>
                      <a:pt x="1884" y="271"/>
                    </a:lnTo>
                    <a:lnTo>
                      <a:pt x="1867" y="271"/>
                    </a:lnTo>
                    <a:lnTo>
                      <a:pt x="1848" y="271"/>
                    </a:lnTo>
                    <a:lnTo>
                      <a:pt x="1828" y="271"/>
                    </a:lnTo>
                    <a:lnTo>
                      <a:pt x="1809" y="271"/>
                    </a:lnTo>
                    <a:lnTo>
                      <a:pt x="1792" y="271"/>
                    </a:lnTo>
                    <a:lnTo>
                      <a:pt x="1773" y="271"/>
                    </a:lnTo>
                    <a:lnTo>
                      <a:pt x="1754" y="271"/>
                    </a:lnTo>
                    <a:lnTo>
                      <a:pt x="1736" y="271"/>
                    </a:lnTo>
                    <a:lnTo>
                      <a:pt x="1717" y="271"/>
                    </a:lnTo>
                    <a:lnTo>
                      <a:pt x="1698" y="271"/>
                    </a:lnTo>
                    <a:lnTo>
                      <a:pt x="1679" y="271"/>
                    </a:lnTo>
                    <a:lnTo>
                      <a:pt x="1661" y="271"/>
                    </a:lnTo>
                    <a:lnTo>
                      <a:pt x="1642" y="271"/>
                    </a:lnTo>
                    <a:lnTo>
                      <a:pt x="1623" y="271"/>
                    </a:lnTo>
                    <a:lnTo>
                      <a:pt x="1606" y="271"/>
                    </a:lnTo>
                    <a:lnTo>
                      <a:pt x="1586" y="271"/>
                    </a:lnTo>
                    <a:lnTo>
                      <a:pt x="1567" y="271"/>
                    </a:lnTo>
                    <a:lnTo>
                      <a:pt x="1548" y="271"/>
                    </a:lnTo>
                    <a:lnTo>
                      <a:pt x="1531" y="271"/>
                    </a:lnTo>
                    <a:lnTo>
                      <a:pt x="1512" y="271"/>
                    </a:lnTo>
                    <a:lnTo>
                      <a:pt x="1492" y="271"/>
                    </a:lnTo>
                    <a:lnTo>
                      <a:pt x="1475" y="271"/>
                    </a:lnTo>
                    <a:lnTo>
                      <a:pt x="1456" y="271"/>
                    </a:lnTo>
                    <a:lnTo>
                      <a:pt x="1437" y="271"/>
                    </a:lnTo>
                    <a:lnTo>
                      <a:pt x="1418" y="271"/>
                    </a:lnTo>
                    <a:lnTo>
                      <a:pt x="1400" y="271"/>
                    </a:lnTo>
                    <a:lnTo>
                      <a:pt x="1381" y="271"/>
                    </a:lnTo>
                    <a:lnTo>
                      <a:pt x="1362" y="271"/>
                    </a:lnTo>
                    <a:lnTo>
                      <a:pt x="1345" y="271"/>
                    </a:lnTo>
                    <a:lnTo>
                      <a:pt x="1325" y="271"/>
                    </a:lnTo>
                    <a:lnTo>
                      <a:pt x="1306" y="271"/>
                    </a:lnTo>
                    <a:lnTo>
                      <a:pt x="1287" y="271"/>
                    </a:lnTo>
                    <a:lnTo>
                      <a:pt x="1270" y="271"/>
                    </a:lnTo>
                    <a:lnTo>
                      <a:pt x="1250" y="271"/>
                    </a:lnTo>
                    <a:lnTo>
                      <a:pt x="1231" y="271"/>
                    </a:lnTo>
                    <a:lnTo>
                      <a:pt x="1214" y="271"/>
                    </a:lnTo>
                    <a:lnTo>
                      <a:pt x="1195" y="271"/>
                    </a:lnTo>
                    <a:lnTo>
                      <a:pt x="1176" y="271"/>
                    </a:lnTo>
                    <a:lnTo>
                      <a:pt x="1156" y="271"/>
                    </a:lnTo>
                    <a:lnTo>
                      <a:pt x="1139" y="271"/>
                    </a:lnTo>
                    <a:lnTo>
                      <a:pt x="1120" y="271"/>
                    </a:lnTo>
                    <a:lnTo>
                      <a:pt x="1101" y="271"/>
                    </a:lnTo>
                    <a:lnTo>
                      <a:pt x="1083" y="271"/>
                    </a:lnTo>
                    <a:lnTo>
                      <a:pt x="1064" y="271"/>
                    </a:lnTo>
                    <a:lnTo>
                      <a:pt x="1045" y="271"/>
                    </a:lnTo>
                    <a:lnTo>
                      <a:pt x="1026" y="271"/>
                    </a:lnTo>
                    <a:lnTo>
                      <a:pt x="1009" y="271"/>
                    </a:lnTo>
                    <a:lnTo>
                      <a:pt x="989" y="271"/>
                    </a:lnTo>
                    <a:lnTo>
                      <a:pt x="970" y="271"/>
                    </a:lnTo>
                    <a:lnTo>
                      <a:pt x="953" y="271"/>
                    </a:lnTo>
                    <a:lnTo>
                      <a:pt x="934" y="271"/>
                    </a:lnTo>
                    <a:lnTo>
                      <a:pt x="914" y="271"/>
                    </a:lnTo>
                    <a:lnTo>
                      <a:pt x="895" y="271"/>
                    </a:lnTo>
                    <a:lnTo>
                      <a:pt x="878" y="271"/>
                    </a:lnTo>
                    <a:lnTo>
                      <a:pt x="859" y="271"/>
                    </a:lnTo>
                    <a:lnTo>
                      <a:pt x="840" y="271"/>
                    </a:lnTo>
                    <a:lnTo>
                      <a:pt x="822" y="271"/>
                    </a:lnTo>
                    <a:lnTo>
                      <a:pt x="803" y="271"/>
                    </a:lnTo>
                    <a:lnTo>
                      <a:pt x="784" y="271"/>
                    </a:lnTo>
                    <a:lnTo>
                      <a:pt x="767" y="271"/>
                    </a:lnTo>
                    <a:lnTo>
                      <a:pt x="747" y="271"/>
                    </a:lnTo>
                    <a:lnTo>
                      <a:pt x="728" y="271"/>
                    </a:lnTo>
                    <a:lnTo>
                      <a:pt x="709" y="271"/>
                    </a:lnTo>
                    <a:lnTo>
                      <a:pt x="692" y="271"/>
                    </a:lnTo>
                    <a:lnTo>
                      <a:pt x="673" y="271"/>
                    </a:lnTo>
                    <a:lnTo>
                      <a:pt x="653" y="271"/>
                    </a:lnTo>
                    <a:lnTo>
                      <a:pt x="636" y="271"/>
                    </a:lnTo>
                    <a:lnTo>
                      <a:pt x="617" y="271"/>
                    </a:lnTo>
                    <a:lnTo>
                      <a:pt x="598" y="271"/>
                    </a:lnTo>
                    <a:lnTo>
                      <a:pt x="578" y="271"/>
                    </a:lnTo>
                    <a:lnTo>
                      <a:pt x="561" y="271"/>
                    </a:lnTo>
                    <a:lnTo>
                      <a:pt x="542" y="271"/>
                    </a:lnTo>
                    <a:lnTo>
                      <a:pt x="523" y="271"/>
                    </a:lnTo>
                    <a:lnTo>
                      <a:pt x="505" y="271"/>
                    </a:lnTo>
                    <a:lnTo>
                      <a:pt x="486" y="271"/>
                    </a:lnTo>
                    <a:lnTo>
                      <a:pt x="467" y="271"/>
                    </a:lnTo>
                    <a:lnTo>
                      <a:pt x="448" y="271"/>
                    </a:lnTo>
                    <a:lnTo>
                      <a:pt x="431" y="271"/>
                    </a:lnTo>
                    <a:lnTo>
                      <a:pt x="411" y="271"/>
                    </a:lnTo>
                    <a:lnTo>
                      <a:pt x="392" y="271"/>
                    </a:lnTo>
                    <a:lnTo>
                      <a:pt x="375" y="271"/>
                    </a:lnTo>
                    <a:lnTo>
                      <a:pt x="356" y="271"/>
                    </a:lnTo>
                    <a:lnTo>
                      <a:pt x="337" y="271"/>
                    </a:lnTo>
                    <a:lnTo>
                      <a:pt x="317" y="271"/>
                    </a:lnTo>
                    <a:lnTo>
                      <a:pt x="300" y="271"/>
                    </a:lnTo>
                    <a:lnTo>
                      <a:pt x="281" y="271"/>
                    </a:lnTo>
                    <a:lnTo>
                      <a:pt x="262" y="271"/>
                    </a:lnTo>
                    <a:lnTo>
                      <a:pt x="244" y="271"/>
                    </a:lnTo>
                    <a:lnTo>
                      <a:pt x="225" y="271"/>
                    </a:lnTo>
                    <a:lnTo>
                      <a:pt x="206" y="271"/>
                    </a:lnTo>
                    <a:lnTo>
                      <a:pt x="187" y="271"/>
                    </a:lnTo>
                    <a:lnTo>
                      <a:pt x="169" y="271"/>
                    </a:lnTo>
                    <a:lnTo>
                      <a:pt x="150" y="271"/>
                    </a:lnTo>
                    <a:lnTo>
                      <a:pt x="131" y="271"/>
                    </a:lnTo>
                    <a:lnTo>
                      <a:pt x="114" y="271"/>
                    </a:lnTo>
                    <a:lnTo>
                      <a:pt x="95" y="271"/>
                    </a:lnTo>
                    <a:lnTo>
                      <a:pt x="75" y="271"/>
                    </a:lnTo>
                    <a:lnTo>
                      <a:pt x="56" y="271"/>
                    </a:lnTo>
                    <a:lnTo>
                      <a:pt x="39" y="271"/>
                    </a:lnTo>
                    <a:lnTo>
                      <a:pt x="20" y="271"/>
                    </a:lnTo>
                    <a:lnTo>
                      <a:pt x="0" y="271"/>
                    </a:lnTo>
                    <a:lnTo>
                      <a:pt x="0" y="125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grpSp>
            <p:nvGrpSpPr>
              <p:cNvPr id="19" name="Groupe 18"/>
              <p:cNvGrpSpPr/>
              <p:nvPr/>
            </p:nvGrpSpPr>
            <p:grpSpPr>
              <a:xfrm>
                <a:off x="813577" y="1071913"/>
                <a:ext cx="132328" cy="3472302"/>
                <a:chOff x="524037" y="319141"/>
                <a:chExt cx="157843" cy="4141805"/>
              </a:xfrm>
            </p:grpSpPr>
            <p:sp>
              <p:nvSpPr>
                <p:cNvPr id="392" name="Pentagone 391"/>
                <p:cNvSpPr>
                  <a:spLocks/>
                </p:cNvSpPr>
                <p:nvPr/>
              </p:nvSpPr>
              <p:spPr>
                <a:xfrm rot="16200000" flipH="1">
                  <a:off x="602186" y="240993"/>
                  <a:ext cx="154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93" name="Pentagone 392"/>
                <p:cNvSpPr>
                  <a:spLocks/>
                </p:cNvSpPr>
                <p:nvPr/>
              </p:nvSpPr>
              <p:spPr>
                <a:xfrm rot="5400000" flipH="1">
                  <a:off x="-427636" y="1272375"/>
                  <a:ext cx="206118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94" name="Pentagone 393"/>
                <p:cNvSpPr>
                  <a:spLocks/>
                </p:cNvSpPr>
                <p:nvPr/>
              </p:nvSpPr>
              <p:spPr>
                <a:xfrm rot="5400000" flipH="1">
                  <a:off x="510980" y="2394962"/>
                  <a:ext cx="18395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95" name="Pentagone 394"/>
                <p:cNvSpPr>
                  <a:spLocks/>
                </p:cNvSpPr>
                <p:nvPr/>
              </p:nvSpPr>
              <p:spPr>
                <a:xfrm rot="16200000" flipH="1">
                  <a:off x="599738" y="2490176"/>
                  <a:ext cx="644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96" name="Pentagone 395"/>
                <p:cNvSpPr>
                  <a:spLocks/>
                </p:cNvSpPr>
                <p:nvPr/>
              </p:nvSpPr>
              <p:spPr>
                <a:xfrm rot="5400000" flipH="1">
                  <a:off x="517152" y="2579219"/>
                  <a:ext cx="17161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97" name="Pentagone 396"/>
                <p:cNvSpPr>
                  <a:spLocks/>
                </p:cNvSpPr>
                <p:nvPr/>
              </p:nvSpPr>
              <p:spPr>
                <a:xfrm rot="16200000" flipH="1">
                  <a:off x="545965" y="2722033"/>
                  <a:ext cx="11398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98" name="Pentagone 397"/>
                <p:cNvSpPr>
                  <a:spLocks/>
                </p:cNvSpPr>
                <p:nvPr/>
              </p:nvSpPr>
              <p:spPr>
                <a:xfrm rot="16200000" flipH="1">
                  <a:off x="537521" y="2844480"/>
                  <a:ext cx="13087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99" name="Pentagone 398"/>
                <p:cNvSpPr>
                  <a:spLocks/>
                </p:cNvSpPr>
                <p:nvPr/>
              </p:nvSpPr>
              <p:spPr>
                <a:xfrm rot="5400000" flipH="1">
                  <a:off x="503627" y="3009263"/>
                  <a:ext cx="19866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0" name="Pentagone 399"/>
                <p:cNvSpPr>
                  <a:spLocks/>
                </p:cNvSpPr>
                <p:nvPr/>
              </p:nvSpPr>
              <p:spPr>
                <a:xfrm rot="5400000" flipH="1">
                  <a:off x="562591" y="3148977"/>
                  <a:ext cx="8073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1" name="Pentagone 400"/>
                <p:cNvSpPr>
                  <a:spLocks/>
                </p:cNvSpPr>
                <p:nvPr/>
              </p:nvSpPr>
              <p:spPr>
                <a:xfrm rot="5400000" flipH="1">
                  <a:off x="589089" y="3203230"/>
                  <a:ext cx="2774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2" name="Pentagone 401"/>
                <p:cNvSpPr>
                  <a:spLocks/>
                </p:cNvSpPr>
                <p:nvPr/>
              </p:nvSpPr>
              <p:spPr>
                <a:xfrm rot="16200000" flipH="1">
                  <a:off x="577777" y="3242296"/>
                  <a:ext cx="5036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3" name="Pentagone 402"/>
                <p:cNvSpPr>
                  <a:spLocks/>
                </p:cNvSpPr>
                <p:nvPr/>
              </p:nvSpPr>
              <p:spPr>
                <a:xfrm rot="16200000" flipH="1">
                  <a:off x="519646" y="3350804"/>
                  <a:ext cx="16662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4" name="Pentagone 403"/>
                <p:cNvSpPr>
                  <a:spLocks/>
                </p:cNvSpPr>
                <p:nvPr/>
              </p:nvSpPr>
              <p:spPr>
                <a:xfrm rot="16200000" flipH="1">
                  <a:off x="586230" y="3450859"/>
                  <a:ext cx="3345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5" name="Pentagone 404"/>
                <p:cNvSpPr>
                  <a:spLocks/>
                </p:cNvSpPr>
                <p:nvPr/>
              </p:nvSpPr>
              <p:spPr>
                <a:xfrm rot="16200000" flipH="1">
                  <a:off x="564740" y="3505821"/>
                  <a:ext cx="7643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6" name="Pentagone 405"/>
                <p:cNvSpPr>
                  <a:spLocks/>
                </p:cNvSpPr>
                <p:nvPr/>
              </p:nvSpPr>
              <p:spPr>
                <a:xfrm rot="5400000" flipH="1">
                  <a:off x="503590" y="3643422"/>
                  <a:ext cx="19873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7" name="Pentagone 406"/>
                <p:cNvSpPr>
                  <a:spLocks/>
                </p:cNvSpPr>
                <p:nvPr/>
              </p:nvSpPr>
              <p:spPr>
                <a:xfrm rot="5400000" flipH="1">
                  <a:off x="575899" y="3769865"/>
                  <a:ext cx="5411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8" name="Pentagone 407"/>
                <p:cNvSpPr>
                  <a:spLocks/>
                </p:cNvSpPr>
                <p:nvPr/>
              </p:nvSpPr>
              <p:spPr>
                <a:xfrm rot="16200000" flipH="1">
                  <a:off x="544988" y="3854910"/>
                  <a:ext cx="11594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09" name="Pentagone 408"/>
                <p:cNvSpPr>
                  <a:spLocks/>
                </p:cNvSpPr>
                <p:nvPr/>
              </p:nvSpPr>
              <p:spPr>
                <a:xfrm rot="16200000" flipH="1">
                  <a:off x="588915" y="3926940"/>
                  <a:ext cx="2808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0" name="Pentagone 409"/>
                <p:cNvSpPr>
                  <a:spLocks/>
                </p:cNvSpPr>
                <p:nvPr/>
              </p:nvSpPr>
              <p:spPr>
                <a:xfrm rot="16200000" flipH="1">
                  <a:off x="572721" y="3971236"/>
                  <a:ext cx="6047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1" name="Pentagone 410"/>
                <p:cNvSpPr>
                  <a:spLocks/>
                </p:cNvSpPr>
                <p:nvPr/>
              </p:nvSpPr>
              <p:spPr>
                <a:xfrm rot="16200000" flipH="1">
                  <a:off x="599637" y="4004810"/>
                  <a:ext cx="664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2" name="Pentagone 411"/>
                <p:cNvSpPr>
                  <a:spLocks/>
                </p:cNvSpPr>
                <p:nvPr/>
              </p:nvSpPr>
              <p:spPr>
                <a:xfrm rot="5400000" flipH="1">
                  <a:off x="600615" y="4010488"/>
                  <a:ext cx="468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3" name="Pentagone 412"/>
                <p:cNvSpPr>
                  <a:spLocks/>
                </p:cNvSpPr>
                <p:nvPr/>
              </p:nvSpPr>
              <p:spPr>
                <a:xfrm rot="5400000" flipH="1">
                  <a:off x="591426" y="4024377"/>
                  <a:ext cx="2306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4" name="Pentagone 413"/>
                <p:cNvSpPr>
                  <a:spLocks/>
                </p:cNvSpPr>
                <p:nvPr/>
              </p:nvSpPr>
              <p:spPr>
                <a:xfrm rot="16200000" flipH="1">
                  <a:off x="560615" y="4078267"/>
                  <a:ext cx="8468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5" name="Pentagone 414"/>
                <p:cNvSpPr>
                  <a:spLocks/>
                </p:cNvSpPr>
                <p:nvPr/>
              </p:nvSpPr>
              <p:spPr>
                <a:xfrm rot="5400000" flipH="1">
                  <a:off x="559732" y="4163851"/>
                  <a:ext cx="8645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6" name="Pentagone 415"/>
                <p:cNvSpPr>
                  <a:spLocks/>
                </p:cNvSpPr>
                <p:nvPr/>
              </p:nvSpPr>
              <p:spPr>
                <a:xfrm rot="16200000" flipH="1">
                  <a:off x="578880" y="4231171"/>
                  <a:ext cx="4815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7" name="Pentagone 416"/>
                <p:cNvSpPr>
                  <a:spLocks/>
                </p:cNvSpPr>
                <p:nvPr/>
              </p:nvSpPr>
              <p:spPr>
                <a:xfrm rot="16200000" flipH="1">
                  <a:off x="602309" y="4255913"/>
                  <a:ext cx="129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8" name="Pentagone 417"/>
                <p:cNvSpPr>
                  <a:spLocks/>
                </p:cNvSpPr>
                <p:nvPr/>
              </p:nvSpPr>
              <p:spPr>
                <a:xfrm rot="16200000" flipH="1">
                  <a:off x="598312" y="4261223"/>
                  <a:ext cx="929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19" name="Pentagone 418"/>
                <p:cNvSpPr>
                  <a:spLocks/>
                </p:cNvSpPr>
                <p:nvPr/>
              </p:nvSpPr>
              <p:spPr>
                <a:xfrm rot="16200000" flipH="1">
                  <a:off x="574022" y="4294820"/>
                  <a:ext cx="5787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20" name="Pentagone 419"/>
                <p:cNvSpPr>
                  <a:spLocks/>
                </p:cNvSpPr>
                <p:nvPr/>
              </p:nvSpPr>
              <p:spPr>
                <a:xfrm rot="16200000" flipH="1">
                  <a:off x="588274" y="4338455"/>
                  <a:ext cx="2937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421" name="Pentagone 420"/>
                <p:cNvSpPr>
                  <a:spLocks/>
                </p:cNvSpPr>
                <p:nvPr/>
              </p:nvSpPr>
              <p:spPr>
                <a:xfrm rot="16200000" flipH="1">
                  <a:off x="588523" y="4367590"/>
                  <a:ext cx="2887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grpSp>
            <p:nvGrpSpPr>
              <p:cNvPr id="20" name="Groupe 19"/>
              <p:cNvGrpSpPr/>
              <p:nvPr/>
            </p:nvGrpSpPr>
            <p:grpSpPr>
              <a:xfrm>
                <a:off x="1475217" y="1071913"/>
                <a:ext cx="132328" cy="3525010"/>
                <a:chOff x="1313249" y="319141"/>
                <a:chExt cx="157843" cy="4204676"/>
              </a:xfrm>
            </p:grpSpPr>
            <p:sp>
              <p:nvSpPr>
                <p:cNvPr id="365" name="Pentagone 364"/>
                <p:cNvSpPr>
                  <a:spLocks/>
                </p:cNvSpPr>
                <p:nvPr/>
              </p:nvSpPr>
              <p:spPr>
                <a:xfrm rot="16200000" flipH="1">
                  <a:off x="1392089" y="240301"/>
                  <a:ext cx="16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66" name="Pentagone 365"/>
                <p:cNvSpPr>
                  <a:spLocks/>
                </p:cNvSpPr>
                <p:nvPr/>
              </p:nvSpPr>
              <p:spPr>
                <a:xfrm rot="5400000" flipH="1">
                  <a:off x="1368377" y="264189"/>
                  <a:ext cx="4758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67" name="Pentagone 366"/>
                <p:cNvSpPr>
                  <a:spLocks/>
                </p:cNvSpPr>
                <p:nvPr/>
              </p:nvSpPr>
              <p:spPr>
                <a:xfrm rot="16200000" flipH="1">
                  <a:off x="1381870" y="298296"/>
                  <a:ext cx="2060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68" name="Pentagone 367"/>
                <p:cNvSpPr>
                  <a:spLocks/>
                </p:cNvSpPr>
                <p:nvPr/>
              </p:nvSpPr>
              <p:spPr>
                <a:xfrm rot="5400000" flipH="1">
                  <a:off x="1344151" y="356629"/>
                  <a:ext cx="9603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69" name="Pentagone 368"/>
                <p:cNvSpPr>
                  <a:spLocks/>
                </p:cNvSpPr>
                <p:nvPr/>
              </p:nvSpPr>
              <p:spPr>
                <a:xfrm rot="16200000" flipH="1">
                  <a:off x="1356814" y="440019"/>
                  <a:ext cx="7071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0" name="Pentagone 369"/>
                <p:cNvSpPr>
                  <a:spLocks/>
                </p:cNvSpPr>
                <p:nvPr/>
              </p:nvSpPr>
              <p:spPr>
                <a:xfrm rot="16200000" flipH="1">
                  <a:off x="1371032" y="496527"/>
                  <a:ext cx="4227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1" name="Pentagone 370"/>
                <p:cNvSpPr>
                  <a:spLocks/>
                </p:cNvSpPr>
                <p:nvPr/>
              </p:nvSpPr>
              <p:spPr>
                <a:xfrm rot="16200000" flipH="1">
                  <a:off x="1385000" y="524850"/>
                  <a:ext cx="1434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2" name="Pentagone 371"/>
                <p:cNvSpPr>
                  <a:spLocks/>
                </p:cNvSpPr>
                <p:nvPr/>
              </p:nvSpPr>
              <p:spPr>
                <a:xfrm rot="16200000" flipH="1">
                  <a:off x="1379652" y="544553"/>
                  <a:ext cx="2503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3" name="Pentagone 372"/>
                <p:cNvSpPr>
                  <a:spLocks/>
                </p:cNvSpPr>
                <p:nvPr/>
              </p:nvSpPr>
              <p:spPr>
                <a:xfrm rot="16200000" flipH="1">
                  <a:off x="1228899" y="720357"/>
                  <a:ext cx="32654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4" name="Pentagone 373"/>
                <p:cNvSpPr>
                  <a:spLocks/>
                </p:cNvSpPr>
                <p:nvPr/>
              </p:nvSpPr>
              <p:spPr>
                <a:xfrm rot="5400000" flipH="1">
                  <a:off x="1376737" y="899076"/>
                  <a:ext cx="3086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5" name="Pentagone 374"/>
                <p:cNvSpPr>
                  <a:spLocks/>
                </p:cNvSpPr>
                <p:nvPr/>
              </p:nvSpPr>
              <p:spPr>
                <a:xfrm rot="16200000" flipH="1">
                  <a:off x="1350298" y="956394"/>
                  <a:ext cx="8374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6" name="Pentagone 375"/>
                <p:cNvSpPr>
                  <a:spLocks/>
                </p:cNvSpPr>
                <p:nvPr/>
              </p:nvSpPr>
              <p:spPr>
                <a:xfrm rot="5400000" flipH="1">
                  <a:off x="1324989" y="1065462"/>
                  <a:ext cx="13436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7" name="Pentagone 376"/>
                <p:cNvSpPr>
                  <a:spLocks/>
                </p:cNvSpPr>
                <p:nvPr/>
              </p:nvSpPr>
              <p:spPr>
                <a:xfrm rot="16200000" flipH="1">
                  <a:off x="1377772" y="1147056"/>
                  <a:ext cx="2879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8" name="Pentagone 377"/>
                <p:cNvSpPr>
                  <a:spLocks/>
                </p:cNvSpPr>
                <p:nvPr/>
              </p:nvSpPr>
              <p:spPr>
                <a:xfrm rot="16200000" flipH="1">
                  <a:off x="1385650" y="1167990"/>
                  <a:ext cx="1304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79" name="Pentagone 378"/>
                <p:cNvSpPr>
                  <a:spLocks/>
                </p:cNvSpPr>
                <p:nvPr/>
              </p:nvSpPr>
              <p:spPr>
                <a:xfrm rot="5400000" flipH="1">
                  <a:off x="1333820" y="1232875"/>
                  <a:ext cx="11670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0" name="Pentagone 379"/>
                <p:cNvSpPr>
                  <a:spLocks/>
                </p:cNvSpPr>
                <p:nvPr/>
              </p:nvSpPr>
              <p:spPr>
                <a:xfrm rot="16200000" flipH="1">
                  <a:off x="1373470" y="1309941"/>
                  <a:ext cx="3740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1" name="Pentagone 380"/>
                <p:cNvSpPr>
                  <a:spLocks/>
                </p:cNvSpPr>
                <p:nvPr/>
              </p:nvSpPr>
              <p:spPr>
                <a:xfrm rot="5400000" flipH="1">
                  <a:off x="1340044" y="1380781"/>
                  <a:ext cx="10425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2" name="Pentagone 381"/>
                <p:cNvSpPr>
                  <a:spLocks/>
                </p:cNvSpPr>
                <p:nvPr/>
              </p:nvSpPr>
              <p:spPr>
                <a:xfrm rot="5400000" flipH="1">
                  <a:off x="1278303" y="1546789"/>
                  <a:ext cx="22773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3" name="Pentagone 382"/>
                <p:cNvSpPr>
                  <a:spLocks/>
                </p:cNvSpPr>
                <p:nvPr/>
              </p:nvSpPr>
              <p:spPr>
                <a:xfrm rot="5400000" flipH="1">
                  <a:off x="1338231" y="1714611"/>
                  <a:ext cx="10787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4" name="Pentagone 383"/>
                <p:cNvSpPr>
                  <a:spLocks/>
                </p:cNvSpPr>
                <p:nvPr/>
              </p:nvSpPr>
              <p:spPr>
                <a:xfrm rot="16200000" flipH="1">
                  <a:off x="1310486" y="1850248"/>
                  <a:ext cx="16336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5" name="Pentagone 384"/>
                <p:cNvSpPr>
                  <a:spLocks/>
                </p:cNvSpPr>
                <p:nvPr/>
              </p:nvSpPr>
              <p:spPr>
                <a:xfrm rot="5400000" flipH="1">
                  <a:off x="1376859" y="1947258"/>
                  <a:ext cx="3062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6" name="Pentagone 385"/>
                <p:cNvSpPr>
                  <a:spLocks/>
                </p:cNvSpPr>
                <p:nvPr/>
              </p:nvSpPr>
              <p:spPr>
                <a:xfrm rot="16200000" flipH="1">
                  <a:off x="1355039" y="1999714"/>
                  <a:ext cx="7426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7" name="Pentagone 386"/>
                <p:cNvSpPr>
                  <a:spLocks/>
                </p:cNvSpPr>
                <p:nvPr/>
              </p:nvSpPr>
              <p:spPr>
                <a:xfrm rot="16200000" flipH="1">
                  <a:off x="1391018" y="2038013"/>
                  <a:ext cx="230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8" name="Pentagone 387"/>
                <p:cNvSpPr>
                  <a:spLocks/>
                </p:cNvSpPr>
                <p:nvPr/>
              </p:nvSpPr>
              <p:spPr>
                <a:xfrm rot="16200000" flipH="1">
                  <a:off x="1177594" y="2253755"/>
                  <a:ext cx="42915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89" name="Pentagone 388"/>
                <p:cNvSpPr>
                  <a:spLocks/>
                </p:cNvSpPr>
                <p:nvPr/>
              </p:nvSpPr>
              <p:spPr>
                <a:xfrm rot="16200000" flipH="1">
                  <a:off x="1391135" y="2469381"/>
                  <a:ext cx="207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90" name="Pentagone 389"/>
                <p:cNvSpPr>
                  <a:spLocks/>
                </p:cNvSpPr>
                <p:nvPr/>
              </p:nvSpPr>
              <p:spPr>
                <a:xfrm rot="5400000" flipH="1">
                  <a:off x="595599" y="3267002"/>
                  <a:ext cx="159314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91" name="Pentagone 390"/>
                <p:cNvSpPr>
                  <a:spLocks/>
                </p:cNvSpPr>
                <p:nvPr/>
              </p:nvSpPr>
              <p:spPr>
                <a:xfrm rot="16200000" flipH="1">
                  <a:off x="1201516" y="4254242"/>
                  <a:ext cx="38130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grpSp>
            <p:nvGrpSpPr>
              <p:cNvPr id="21" name="Groupe 20"/>
              <p:cNvGrpSpPr/>
              <p:nvPr/>
            </p:nvGrpSpPr>
            <p:grpSpPr>
              <a:xfrm>
                <a:off x="2136854" y="1071912"/>
                <a:ext cx="132328" cy="4182993"/>
                <a:chOff x="2102459" y="319140"/>
                <a:chExt cx="157843" cy="4989526"/>
              </a:xfrm>
            </p:grpSpPr>
            <p:sp>
              <p:nvSpPr>
                <p:cNvPr id="334" name="Pentagone 333"/>
                <p:cNvSpPr>
                  <a:spLocks/>
                </p:cNvSpPr>
                <p:nvPr/>
              </p:nvSpPr>
              <p:spPr>
                <a:xfrm rot="16200000" flipH="1">
                  <a:off x="1487986" y="933614"/>
                  <a:ext cx="138678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35" name="Pentagone 334"/>
                <p:cNvSpPr>
                  <a:spLocks/>
                </p:cNvSpPr>
                <p:nvPr/>
              </p:nvSpPr>
              <p:spPr>
                <a:xfrm rot="16200000" flipH="1">
                  <a:off x="2156175" y="1652229"/>
                  <a:ext cx="5041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36" name="Pentagone 335"/>
                <p:cNvSpPr>
                  <a:spLocks/>
                </p:cNvSpPr>
                <p:nvPr/>
              </p:nvSpPr>
              <p:spPr>
                <a:xfrm rot="5400000" flipH="1">
                  <a:off x="2164205" y="1694625"/>
                  <a:ext cx="3435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37" name="Pentagone 336"/>
                <p:cNvSpPr>
                  <a:spLocks/>
                </p:cNvSpPr>
                <p:nvPr/>
              </p:nvSpPr>
              <p:spPr>
                <a:xfrm rot="5400000" flipH="1">
                  <a:off x="2088969" y="1804227"/>
                  <a:ext cx="18482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38" name="Pentagone 337"/>
                <p:cNvSpPr>
                  <a:spLocks/>
                </p:cNvSpPr>
                <p:nvPr/>
              </p:nvSpPr>
              <p:spPr>
                <a:xfrm rot="16200000" flipH="1">
                  <a:off x="2143038" y="1934995"/>
                  <a:ext cx="7668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39" name="Pentagone 338"/>
                <p:cNvSpPr>
                  <a:spLocks/>
                </p:cNvSpPr>
                <p:nvPr/>
              </p:nvSpPr>
              <p:spPr>
                <a:xfrm rot="16200000" flipH="1">
                  <a:off x="2155453" y="1999279"/>
                  <a:ext cx="5185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0" name="Pentagone 339"/>
                <p:cNvSpPr>
                  <a:spLocks/>
                </p:cNvSpPr>
                <p:nvPr/>
              </p:nvSpPr>
              <p:spPr>
                <a:xfrm rot="16200000" flipH="1">
                  <a:off x="2068356" y="2138245"/>
                  <a:ext cx="22604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1" name="Pentagone 340"/>
                <p:cNvSpPr>
                  <a:spLocks/>
                </p:cNvSpPr>
                <p:nvPr/>
              </p:nvSpPr>
              <p:spPr>
                <a:xfrm rot="16200000" flipH="1">
                  <a:off x="2165908" y="2266756"/>
                  <a:ext cx="3094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2" name="Pentagone 341"/>
                <p:cNvSpPr>
                  <a:spLocks/>
                </p:cNvSpPr>
                <p:nvPr/>
              </p:nvSpPr>
              <p:spPr>
                <a:xfrm rot="5400000" flipH="1">
                  <a:off x="2110934" y="2352690"/>
                  <a:ext cx="14089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3" name="Pentagone 342"/>
                <p:cNvSpPr>
                  <a:spLocks/>
                </p:cNvSpPr>
                <p:nvPr/>
              </p:nvSpPr>
              <p:spPr>
                <a:xfrm rot="5400000" flipH="1">
                  <a:off x="2142427" y="2462106"/>
                  <a:ext cx="7790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4" name="Pentagone 343"/>
                <p:cNvSpPr>
                  <a:spLocks/>
                </p:cNvSpPr>
                <p:nvPr/>
              </p:nvSpPr>
              <p:spPr>
                <a:xfrm rot="5400000" flipH="1">
                  <a:off x="2098809" y="2583645"/>
                  <a:ext cx="16514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5" name="Pentagone 344"/>
                <p:cNvSpPr>
                  <a:spLocks/>
                </p:cNvSpPr>
                <p:nvPr/>
              </p:nvSpPr>
              <p:spPr>
                <a:xfrm rot="16200000" flipH="1">
                  <a:off x="2168098" y="2679514"/>
                  <a:ext cx="2656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6" name="Pentagone 345"/>
                <p:cNvSpPr>
                  <a:spLocks/>
                </p:cNvSpPr>
                <p:nvPr/>
              </p:nvSpPr>
              <p:spPr>
                <a:xfrm rot="5400000" flipH="1">
                  <a:off x="2115415" y="2758777"/>
                  <a:ext cx="13193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7" name="Pentagone 346"/>
                <p:cNvSpPr>
                  <a:spLocks/>
                </p:cNvSpPr>
                <p:nvPr/>
              </p:nvSpPr>
              <p:spPr>
                <a:xfrm rot="16200000" flipH="1">
                  <a:off x="2178217" y="2827920"/>
                  <a:ext cx="632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8" name="Pentagone 347"/>
                <p:cNvSpPr>
                  <a:spLocks/>
                </p:cNvSpPr>
                <p:nvPr/>
              </p:nvSpPr>
              <p:spPr>
                <a:xfrm rot="16200000" flipH="1">
                  <a:off x="2145071" y="2867407"/>
                  <a:ext cx="7261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49" name="Pentagone 348"/>
                <p:cNvSpPr>
                  <a:spLocks/>
                </p:cNvSpPr>
                <p:nvPr/>
              </p:nvSpPr>
              <p:spPr>
                <a:xfrm rot="5400000" flipH="1">
                  <a:off x="2164389" y="2920723"/>
                  <a:ext cx="3398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0" name="Pentagone 349"/>
                <p:cNvSpPr>
                  <a:spLocks/>
                </p:cNvSpPr>
                <p:nvPr/>
              </p:nvSpPr>
              <p:spPr>
                <a:xfrm rot="5400000" flipH="1">
                  <a:off x="2170121" y="2948988"/>
                  <a:ext cx="2251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1" name="Pentagone 350"/>
                <p:cNvSpPr>
                  <a:spLocks/>
                </p:cNvSpPr>
                <p:nvPr/>
              </p:nvSpPr>
              <p:spPr>
                <a:xfrm rot="16200000" flipH="1">
                  <a:off x="2157077" y="2984566"/>
                  <a:ext cx="4860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2" name="Pentagone 351"/>
                <p:cNvSpPr>
                  <a:spLocks/>
                </p:cNvSpPr>
                <p:nvPr/>
              </p:nvSpPr>
              <p:spPr>
                <a:xfrm rot="5400000" flipH="1">
                  <a:off x="2177953" y="3012312"/>
                  <a:ext cx="685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3" name="Pentagone 352"/>
                <p:cNvSpPr>
                  <a:spLocks/>
                </p:cNvSpPr>
                <p:nvPr/>
              </p:nvSpPr>
              <p:spPr>
                <a:xfrm rot="5400000" flipH="1">
                  <a:off x="2128442" y="3068693"/>
                  <a:ext cx="10587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4" name="Pentagone 353"/>
                <p:cNvSpPr>
                  <a:spLocks/>
                </p:cNvSpPr>
                <p:nvPr/>
              </p:nvSpPr>
              <p:spPr>
                <a:xfrm rot="16200000" flipH="1">
                  <a:off x="2122812" y="3180214"/>
                  <a:ext cx="11713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5" name="Pentagone 354"/>
                <p:cNvSpPr>
                  <a:spLocks/>
                </p:cNvSpPr>
                <p:nvPr/>
              </p:nvSpPr>
              <p:spPr>
                <a:xfrm rot="5400000" flipH="1">
                  <a:off x="2134896" y="3285282"/>
                  <a:ext cx="9296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6" name="Pentagone 355"/>
                <p:cNvSpPr>
                  <a:spLocks/>
                </p:cNvSpPr>
                <p:nvPr/>
              </p:nvSpPr>
              <p:spPr>
                <a:xfrm rot="5400000" flipH="1">
                  <a:off x="2159749" y="3353413"/>
                  <a:ext cx="4326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7" name="Pentagone 356"/>
                <p:cNvSpPr>
                  <a:spLocks/>
                </p:cNvSpPr>
                <p:nvPr/>
              </p:nvSpPr>
              <p:spPr>
                <a:xfrm rot="16200000" flipH="1">
                  <a:off x="2180824" y="3375617"/>
                  <a:ext cx="111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8" name="Pentagone 357"/>
                <p:cNvSpPr>
                  <a:spLocks/>
                </p:cNvSpPr>
                <p:nvPr/>
              </p:nvSpPr>
              <p:spPr>
                <a:xfrm rot="16200000" flipH="1">
                  <a:off x="2170426" y="3387142"/>
                  <a:ext cx="2190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59" name="Pentagone 358"/>
                <p:cNvSpPr>
                  <a:spLocks/>
                </p:cNvSpPr>
                <p:nvPr/>
              </p:nvSpPr>
              <p:spPr>
                <a:xfrm rot="5400000" flipH="1">
                  <a:off x="2178519" y="3400973"/>
                  <a:ext cx="572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60" name="Pentagone 359"/>
                <p:cNvSpPr>
                  <a:spLocks/>
                </p:cNvSpPr>
                <p:nvPr/>
              </p:nvSpPr>
              <p:spPr>
                <a:xfrm rot="5400000" flipH="1">
                  <a:off x="2181115" y="3404116"/>
                  <a:ext cx="53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61" name="Pentagone 360"/>
                <p:cNvSpPr>
                  <a:spLocks/>
                </p:cNvSpPr>
                <p:nvPr/>
              </p:nvSpPr>
              <p:spPr>
                <a:xfrm rot="16200000" flipH="1">
                  <a:off x="2180285" y="3405492"/>
                  <a:ext cx="219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62" name="Pentagone 361"/>
                <p:cNvSpPr>
                  <a:spLocks/>
                </p:cNvSpPr>
                <p:nvPr/>
              </p:nvSpPr>
              <p:spPr>
                <a:xfrm rot="16200000" flipH="1">
                  <a:off x="1483304" y="4104678"/>
                  <a:ext cx="139615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63" name="Pentagone 362"/>
                <p:cNvSpPr>
                  <a:spLocks/>
                </p:cNvSpPr>
                <p:nvPr/>
              </p:nvSpPr>
              <p:spPr>
                <a:xfrm rot="16200000" flipH="1">
                  <a:off x="2173309" y="4810840"/>
                  <a:ext cx="1614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64" name="Pentagone 363"/>
                <p:cNvSpPr>
                  <a:spLocks/>
                </p:cNvSpPr>
                <p:nvPr/>
              </p:nvSpPr>
              <p:spPr>
                <a:xfrm rot="5400000" flipH="1">
                  <a:off x="1975971" y="5024336"/>
                  <a:ext cx="41081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grpSp>
            <p:nvGrpSpPr>
              <p:cNvPr id="22" name="Groupe 21"/>
              <p:cNvGrpSpPr/>
              <p:nvPr/>
            </p:nvGrpSpPr>
            <p:grpSpPr>
              <a:xfrm>
                <a:off x="2798494" y="1071913"/>
                <a:ext cx="132328" cy="4432072"/>
                <a:chOff x="2891671" y="319141"/>
                <a:chExt cx="157843" cy="5286632"/>
              </a:xfrm>
            </p:grpSpPr>
            <p:sp>
              <p:nvSpPr>
                <p:cNvPr id="317" name="Pentagone 316"/>
                <p:cNvSpPr>
                  <a:spLocks/>
                </p:cNvSpPr>
                <p:nvPr/>
              </p:nvSpPr>
              <p:spPr>
                <a:xfrm rot="16200000" flipH="1">
                  <a:off x="2350295" y="860517"/>
                  <a:ext cx="124059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18" name="Pentagone 317"/>
                <p:cNvSpPr>
                  <a:spLocks/>
                </p:cNvSpPr>
                <p:nvPr/>
              </p:nvSpPr>
              <p:spPr>
                <a:xfrm rot="5400000" flipH="1">
                  <a:off x="2969734" y="1481687"/>
                  <a:ext cx="171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19" name="Pentagone 318"/>
                <p:cNvSpPr>
                  <a:spLocks/>
                </p:cNvSpPr>
                <p:nvPr/>
              </p:nvSpPr>
              <p:spPr>
                <a:xfrm rot="5400000" flipH="1">
                  <a:off x="2940438" y="1512712"/>
                  <a:ext cx="6030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0" name="Pentagone 319"/>
                <p:cNvSpPr>
                  <a:spLocks/>
                </p:cNvSpPr>
                <p:nvPr/>
              </p:nvSpPr>
              <p:spPr>
                <a:xfrm rot="16200000" flipH="1">
                  <a:off x="2970341" y="1543133"/>
                  <a:ext cx="50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1" name="Pentagone 320"/>
                <p:cNvSpPr>
                  <a:spLocks/>
                </p:cNvSpPr>
                <p:nvPr/>
              </p:nvSpPr>
              <p:spPr>
                <a:xfrm rot="5400000" flipH="1">
                  <a:off x="2682718" y="1831273"/>
                  <a:ext cx="57574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2" name="Pentagone 321"/>
                <p:cNvSpPr>
                  <a:spLocks/>
                </p:cNvSpPr>
                <p:nvPr/>
              </p:nvSpPr>
              <p:spPr>
                <a:xfrm rot="16200000" flipH="1">
                  <a:off x="2967444" y="2122310"/>
                  <a:ext cx="629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3" name="Pentagone 322"/>
                <p:cNvSpPr>
                  <a:spLocks/>
                </p:cNvSpPr>
                <p:nvPr/>
              </p:nvSpPr>
              <p:spPr>
                <a:xfrm rot="16200000" flipH="1">
                  <a:off x="2882987" y="2213076"/>
                  <a:ext cx="17521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4" name="Pentagone 323"/>
                <p:cNvSpPr>
                  <a:spLocks/>
                </p:cNvSpPr>
                <p:nvPr/>
              </p:nvSpPr>
              <p:spPr>
                <a:xfrm rot="5400000" flipH="1">
                  <a:off x="2900980" y="2370308"/>
                  <a:ext cx="13922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5" name="Pentagone 324"/>
                <p:cNvSpPr>
                  <a:spLocks/>
                </p:cNvSpPr>
                <p:nvPr/>
              </p:nvSpPr>
              <p:spPr>
                <a:xfrm rot="5400000" flipH="1">
                  <a:off x="2927292" y="2483234"/>
                  <a:ext cx="8660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6" name="Pentagone 325"/>
                <p:cNvSpPr>
                  <a:spLocks/>
                </p:cNvSpPr>
                <p:nvPr/>
              </p:nvSpPr>
              <p:spPr>
                <a:xfrm rot="5400000" flipH="1">
                  <a:off x="2919152" y="2577989"/>
                  <a:ext cx="10288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7" name="Pentagone 326"/>
                <p:cNvSpPr>
                  <a:spLocks/>
                </p:cNvSpPr>
                <p:nvPr/>
              </p:nvSpPr>
              <p:spPr>
                <a:xfrm rot="16200000" flipH="1">
                  <a:off x="2945341" y="2654695"/>
                  <a:ext cx="5050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8" name="Pentagone 327"/>
                <p:cNvSpPr>
                  <a:spLocks/>
                </p:cNvSpPr>
                <p:nvPr/>
              </p:nvSpPr>
              <p:spPr>
                <a:xfrm rot="5400000" flipH="1">
                  <a:off x="2861234" y="2789320"/>
                  <a:ext cx="21871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29" name="Pentagone 328"/>
                <p:cNvSpPr>
                  <a:spLocks/>
                </p:cNvSpPr>
                <p:nvPr/>
              </p:nvSpPr>
              <p:spPr>
                <a:xfrm rot="5400000" flipH="1">
                  <a:off x="2926553" y="2942732"/>
                  <a:ext cx="8807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30" name="Pentagone 329"/>
                <p:cNvSpPr>
                  <a:spLocks/>
                </p:cNvSpPr>
                <p:nvPr/>
              </p:nvSpPr>
              <p:spPr>
                <a:xfrm rot="16200000" flipH="1">
                  <a:off x="2941491" y="3015888"/>
                  <a:ext cx="5820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31" name="Pentagone 330"/>
                <p:cNvSpPr>
                  <a:spLocks/>
                </p:cNvSpPr>
                <p:nvPr/>
              </p:nvSpPr>
              <p:spPr>
                <a:xfrm rot="5400000" flipH="1">
                  <a:off x="2412170" y="3603426"/>
                  <a:ext cx="111684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32" name="Pentagone 331"/>
                <p:cNvSpPr>
                  <a:spLocks/>
                </p:cNvSpPr>
                <p:nvPr/>
              </p:nvSpPr>
              <p:spPr>
                <a:xfrm rot="5400000" flipH="1">
                  <a:off x="2289555" y="4842901"/>
                  <a:ext cx="136207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33" name="Pentagone 332"/>
                <p:cNvSpPr>
                  <a:spLocks/>
                </p:cNvSpPr>
                <p:nvPr/>
              </p:nvSpPr>
              <p:spPr>
                <a:xfrm rot="16200000" flipH="1">
                  <a:off x="2969143" y="5525403"/>
                  <a:ext cx="289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sp>
            <p:nvSpPr>
              <p:cNvPr id="23" name="ZoneTexte 211"/>
              <p:cNvSpPr txBox="1"/>
              <p:nvPr/>
            </p:nvSpPr>
            <p:spPr>
              <a:xfrm flipH="1">
                <a:off x="517146" y="766465"/>
                <a:ext cx="736199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 dirty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 dirty="0"/>
                  <a:t>01</a:t>
                </a:r>
              </a:p>
            </p:txBody>
          </p:sp>
          <p:sp>
            <p:nvSpPr>
              <p:cNvPr id="24" name="ZoneTexte 213"/>
              <p:cNvSpPr txBox="1"/>
              <p:nvPr/>
            </p:nvSpPr>
            <p:spPr>
              <a:xfrm flipH="1">
                <a:off x="1178785" y="766465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 dirty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 dirty="0"/>
                  <a:t>02</a:t>
                </a:r>
              </a:p>
            </p:txBody>
          </p:sp>
          <p:sp>
            <p:nvSpPr>
              <p:cNvPr id="25" name="ZoneTexte 215"/>
              <p:cNvSpPr txBox="1"/>
              <p:nvPr/>
            </p:nvSpPr>
            <p:spPr>
              <a:xfrm flipH="1">
                <a:off x="1840423" y="766465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 dirty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 dirty="0"/>
                  <a:t>03</a:t>
                </a:r>
              </a:p>
            </p:txBody>
          </p:sp>
          <p:sp>
            <p:nvSpPr>
              <p:cNvPr id="26" name="ZoneTexte 217"/>
              <p:cNvSpPr txBox="1"/>
              <p:nvPr/>
            </p:nvSpPr>
            <p:spPr>
              <a:xfrm flipH="1">
                <a:off x="2502062" y="766465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/>
                  <a:t>04</a:t>
                </a:r>
              </a:p>
            </p:txBody>
          </p:sp>
          <p:grpSp>
            <p:nvGrpSpPr>
              <p:cNvPr id="27" name="Groupe 26"/>
              <p:cNvGrpSpPr/>
              <p:nvPr/>
            </p:nvGrpSpPr>
            <p:grpSpPr>
              <a:xfrm>
                <a:off x="3468950" y="1070846"/>
                <a:ext cx="132328" cy="4999134"/>
                <a:chOff x="3691399" y="317869"/>
                <a:chExt cx="157843" cy="5963030"/>
              </a:xfrm>
            </p:grpSpPr>
            <p:sp>
              <p:nvSpPr>
                <p:cNvPr id="265" name="Pentagone 264"/>
                <p:cNvSpPr>
                  <a:spLocks/>
                </p:cNvSpPr>
                <p:nvPr/>
              </p:nvSpPr>
              <p:spPr>
                <a:xfrm rot="5400000" flipH="1">
                  <a:off x="3642660" y="366609"/>
                  <a:ext cx="25532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66" name="Pentagone 265"/>
                <p:cNvSpPr>
                  <a:spLocks/>
                </p:cNvSpPr>
                <p:nvPr/>
              </p:nvSpPr>
              <p:spPr>
                <a:xfrm rot="16200000" flipH="1">
                  <a:off x="3431726" y="832880"/>
                  <a:ext cx="67719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67" name="Pentagone 266"/>
                <p:cNvSpPr>
                  <a:spLocks/>
                </p:cNvSpPr>
                <p:nvPr/>
              </p:nvSpPr>
              <p:spPr>
                <a:xfrm rot="5400000" flipH="1">
                  <a:off x="3374070" y="1567739"/>
                  <a:ext cx="79250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68" name="Pentagone 267"/>
                <p:cNvSpPr>
                  <a:spLocks/>
                </p:cNvSpPr>
                <p:nvPr/>
              </p:nvSpPr>
              <p:spPr>
                <a:xfrm rot="16200000" flipH="1">
                  <a:off x="3769608" y="1964716"/>
                  <a:ext cx="142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69" name="Pentagone 268"/>
                <p:cNvSpPr>
                  <a:spLocks/>
                </p:cNvSpPr>
                <p:nvPr/>
              </p:nvSpPr>
              <p:spPr>
                <a:xfrm rot="5400000" flipH="1">
                  <a:off x="3747763" y="1988001"/>
                  <a:ext cx="4511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0" name="Pentagone 269"/>
                <p:cNvSpPr>
                  <a:spLocks/>
                </p:cNvSpPr>
                <p:nvPr/>
              </p:nvSpPr>
              <p:spPr>
                <a:xfrm rot="16200000" flipH="1">
                  <a:off x="3760604" y="2020291"/>
                  <a:ext cx="1943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1" name="Pentagone 270"/>
                <p:cNvSpPr>
                  <a:spLocks/>
                </p:cNvSpPr>
                <p:nvPr/>
              </p:nvSpPr>
              <p:spPr>
                <a:xfrm rot="16200000" flipH="1">
                  <a:off x="3770122" y="2030221"/>
                  <a:ext cx="39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2" name="Pentagone 271"/>
                <p:cNvSpPr>
                  <a:spLocks/>
                </p:cNvSpPr>
                <p:nvPr/>
              </p:nvSpPr>
              <p:spPr>
                <a:xfrm rot="16200000" flipH="1">
                  <a:off x="3757498" y="2043257"/>
                  <a:ext cx="2564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3" name="Pentagone 272"/>
                <p:cNvSpPr>
                  <a:spLocks/>
                </p:cNvSpPr>
                <p:nvPr/>
              </p:nvSpPr>
              <p:spPr>
                <a:xfrm rot="16200000" flipH="1">
                  <a:off x="3763633" y="2062781"/>
                  <a:ext cx="1337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4" name="Pentagone 273"/>
                <p:cNvSpPr>
                  <a:spLocks/>
                </p:cNvSpPr>
                <p:nvPr/>
              </p:nvSpPr>
              <p:spPr>
                <a:xfrm rot="5400000" flipH="1">
                  <a:off x="3760898" y="2078906"/>
                  <a:ext cx="1884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5" name="Pentagone 274"/>
                <p:cNvSpPr>
                  <a:spLocks/>
                </p:cNvSpPr>
                <p:nvPr/>
              </p:nvSpPr>
              <p:spPr>
                <a:xfrm rot="16200000" flipH="1">
                  <a:off x="3752944" y="2105720"/>
                  <a:ext cx="3475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6" name="Pentagone 275"/>
                <p:cNvSpPr>
                  <a:spLocks/>
                </p:cNvSpPr>
                <p:nvPr/>
              </p:nvSpPr>
              <p:spPr>
                <a:xfrm rot="16200000" flipH="1">
                  <a:off x="3671828" y="2221604"/>
                  <a:ext cx="19698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7" name="Pentagone 276"/>
                <p:cNvSpPr>
                  <a:spLocks/>
                </p:cNvSpPr>
                <p:nvPr/>
              </p:nvSpPr>
              <p:spPr>
                <a:xfrm rot="5400000" flipH="1">
                  <a:off x="3767580" y="2322852"/>
                  <a:ext cx="548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8" name="Pentagone 277"/>
                <p:cNvSpPr>
                  <a:spLocks/>
                </p:cNvSpPr>
                <p:nvPr/>
              </p:nvSpPr>
              <p:spPr>
                <a:xfrm rot="5400000" flipH="1">
                  <a:off x="3756321" y="2339606"/>
                  <a:ext cx="2799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79" name="Pentagone 278"/>
                <p:cNvSpPr>
                  <a:spLocks/>
                </p:cNvSpPr>
                <p:nvPr/>
              </p:nvSpPr>
              <p:spPr>
                <a:xfrm rot="5400000" flipH="1">
                  <a:off x="3722479" y="2401461"/>
                  <a:ext cx="9568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0" name="Pentagone 279"/>
                <p:cNvSpPr>
                  <a:spLocks/>
                </p:cNvSpPr>
                <p:nvPr/>
              </p:nvSpPr>
              <p:spPr>
                <a:xfrm rot="5400000" flipH="1">
                  <a:off x="3750099" y="2469539"/>
                  <a:ext cx="4044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1" name="Pentagone 280"/>
                <p:cNvSpPr>
                  <a:spLocks/>
                </p:cNvSpPr>
                <p:nvPr/>
              </p:nvSpPr>
              <p:spPr>
                <a:xfrm rot="16200000" flipH="1">
                  <a:off x="3758735" y="2501361"/>
                  <a:ext cx="2317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2" name="Pentagone 281"/>
                <p:cNvSpPr>
                  <a:spLocks/>
                </p:cNvSpPr>
                <p:nvPr/>
              </p:nvSpPr>
              <p:spPr>
                <a:xfrm rot="16200000" flipH="1">
                  <a:off x="3711080" y="2572201"/>
                  <a:ext cx="11848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3" name="Pentagone 282"/>
                <p:cNvSpPr>
                  <a:spLocks/>
                </p:cNvSpPr>
                <p:nvPr/>
              </p:nvSpPr>
              <p:spPr>
                <a:xfrm rot="16200000" flipH="1">
                  <a:off x="3767388" y="2634390"/>
                  <a:ext cx="586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4" name="Pentagone 283"/>
                <p:cNvSpPr>
                  <a:spLocks/>
                </p:cNvSpPr>
                <p:nvPr/>
              </p:nvSpPr>
              <p:spPr>
                <a:xfrm rot="16200000" flipH="1">
                  <a:off x="3714915" y="2692741"/>
                  <a:ext cx="11081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5" name="Pentagone 284"/>
                <p:cNvSpPr>
                  <a:spLocks/>
                </p:cNvSpPr>
                <p:nvPr/>
              </p:nvSpPr>
              <p:spPr>
                <a:xfrm rot="5400000" flipH="1">
                  <a:off x="3733254" y="2785227"/>
                  <a:ext cx="7413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6" name="Pentagone 285"/>
                <p:cNvSpPr>
                  <a:spLocks/>
                </p:cNvSpPr>
                <p:nvPr/>
              </p:nvSpPr>
              <p:spPr>
                <a:xfrm rot="16200000" flipH="1">
                  <a:off x="3708267" y="2884362"/>
                  <a:ext cx="12410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7" name="Pentagone 286"/>
                <p:cNvSpPr>
                  <a:spLocks/>
                </p:cNvSpPr>
                <p:nvPr/>
              </p:nvSpPr>
              <p:spPr>
                <a:xfrm rot="16200000" flipH="1">
                  <a:off x="3732037" y="2984714"/>
                  <a:ext cx="7656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8" name="Pentagone 287"/>
                <p:cNvSpPr>
                  <a:spLocks/>
                </p:cNvSpPr>
                <p:nvPr/>
              </p:nvSpPr>
              <p:spPr>
                <a:xfrm rot="16200000" flipH="1">
                  <a:off x="3700530" y="3092802"/>
                  <a:ext cx="13958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89" name="Pentagone 288"/>
                <p:cNvSpPr>
                  <a:spLocks/>
                </p:cNvSpPr>
                <p:nvPr/>
              </p:nvSpPr>
              <p:spPr>
                <a:xfrm rot="16200000" flipH="1">
                  <a:off x="3755727" y="3177202"/>
                  <a:ext cx="2918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0" name="Pentagone 289"/>
                <p:cNvSpPr>
                  <a:spLocks/>
                </p:cNvSpPr>
                <p:nvPr/>
              </p:nvSpPr>
              <p:spPr>
                <a:xfrm rot="5400000" flipH="1">
                  <a:off x="3684100" y="3278030"/>
                  <a:ext cx="17244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1" name="Pentagone 290"/>
                <p:cNvSpPr>
                  <a:spLocks/>
                </p:cNvSpPr>
                <p:nvPr/>
              </p:nvSpPr>
              <p:spPr>
                <a:xfrm rot="5400000" flipH="1">
                  <a:off x="3732912" y="3401674"/>
                  <a:ext cx="7481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2" name="Pentagone 291"/>
                <p:cNvSpPr>
                  <a:spLocks/>
                </p:cNvSpPr>
                <p:nvPr/>
              </p:nvSpPr>
              <p:spPr>
                <a:xfrm rot="5400000" flipH="1">
                  <a:off x="3732639" y="3476780"/>
                  <a:ext cx="7536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3" name="Pentagone 292"/>
                <p:cNvSpPr>
                  <a:spLocks/>
                </p:cNvSpPr>
                <p:nvPr/>
              </p:nvSpPr>
              <p:spPr>
                <a:xfrm rot="16200000" flipH="1">
                  <a:off x="3723828" y="3560969"/>
                  <a:ext cx="9298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4" name="Pentagone 293"/>
                <p:cNvSpPr>
                  <a:spLocks/>
                </p:cNvSpPr>
                <p:nvPr/>
              </p:nvSpPr>
              <p:spPr>
                <a:xfrm rot="16200000" flipH="1">
                  <a:off x="3760214" y="3617583"/>
                  <a:ext cx="2021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5" name="Pentagone 294"/>
                <p:cNvSpPr>
                  <a:spLocks/>
                </p:cNvSpPr>
                <p:nvPr/>
              </p:nvSpPr>
              <p:spPr>
                <a:xfrm rot="16200000" flipH="1">
                  <a:off x="3720287" y="3677738"/>
                  <a:ext cx="10006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6" name="Pentagone 295"/>
                <p:cNvSpPr>
                  <a:spLocks/>
                </p:cNvSpPr>
                <p:nvPr/>
              </p:nvSpPr>
              <p:spPr>
                <a:xfrm rot="5400000" flipH="1">
                  <a:off x="3710368" y="3787738"/>
                  <a:ext cx="11990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7" name="Pentagone 296"/>
                <p:cNvSpPr>
                  <a:spLocks/>
                </p:cNvSpPr>
                <p:nvPr/>
              </p:nvSpPr>
              <p:spPr>
                <a:xfrm rot="16200000" flipH="1">
                  <a:off x="3767337" y="3850689"/>
                  <a:ext cx="596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8" name="Pentagone 297"/>
                <p:cNvSpPr>
                  <a:spLocks/>
                </p:cNvSpPr>
                <p:nvPr/>
              </p:nvSpPr>
              <p:spPr>
                <a:xfrm rot="5400000" flipH="1">
                  <a:off x="3757267" y="3866740"/>
                  <a:ext cx="2610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99" name="Pentagone 298"/>
                <p:cNvSpPr>
                  <a:spLocks/>
                </p:cNvSpPr>
                <p:nvPr/>
              </p:nvSpPr>
              <p:spPr>
                <a:xfrm rot="16200000" flipH="1">
                  <a:off x="3766686" y="3883443"/>
                  <a:ext cx="727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0" name="Pentagone 299"/>
                <p:cNvSpPr>
                  <a:spLocks/>
                </p:cNvSpPr>
                <p:nvPr/>
              </p:nvSpPr>
              <p:spPr>
                <a:xfrm rot="5400000" flipH="1">
                  <a:off x="3738878" y="3918536"/>
                  <a:ext cx="6288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1" name="Pentagone 300"/>
                <p:cNvSpPr>
                  <a:spLocks/>
                </p:cNvSpPr>
                <p:nvPr/>
              </p:nvSpPr>
              <p:spPr>
                <a:xfrm rot="16200000" flipH="1">
                  <a:off x="3768662" y="3951653"/>
                  <a:ext cx="331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2" name="Pentagone 301"/>
                <p:cNvSpPr>
                  <a:spLocks/>
                </p:cNvSpPr>
                <p:nvPr/>
              </p:nvSpPr>
              <p:spPr>
                <a:xfrm rot="5400000" flipH="1">
                  <a:off x="3610771" y="4112876"/>
                  <a:ext cx="31910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3" name="Pentagone 302"/>
                <p:cNvSpPr>
                  <a:spLocks/>
                </p:cNvSpPr>
                <p:nvPr/>
              </p:nvSpPr>
              <p:spPr>
                <a:xfrm rot="16200000" flipH="1">
                  <a:off x="3753202" y="4289560"/>
                  <a:ext cx="3423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4" name="Pentagone 303"/>
                <p:cNvSpPr>
                  <a:spLocks/>
                </p:cNvSpPr>
                <p:nvPr/>
              </p:nvSpPr>
              <p:spPr>
                <a:xfrm rot="16200000" flipH="1">
                  <a:off x="3746372" y="4330642"/>
                  <a:ext cx="4789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5" name="Pentagone 304"/>
                <p:cNvSpPr>
                  <a:spLocks/>
                </p:cNvSpPr>
                <p:nvPr/>
              </p:nvSpPr>
              <p:spPr>
                <a:xfrm rot="16200000" flipH="1">
                  <a:off x="3757065" y="4367862"/>
                  <a:ext cx="2651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6" name="Pentagone 305"/>
                <p:cNvSpPr>
                  <a:spLocks/>
                </p:cNvSpPr>
                <p:nvPr/>
              </p:nvSpPr>
              <p:spPr>
                <a:xfrm rot="5400000" flipH="1">
                  <a:off x="3768277" y="4383175"/>
                  <a:ext cx="408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7" name="Pentagone 306"/>
                <p:cNvSpPr>
                  <a:spLocks/>
                </p:cNvSpPr>
                <p:nvPr/>
              </p:nvSpPr>
              <p:spPr>
                <a:xfrm rot="16200000" flipH="1">
                  <a:off x="3766451" y="4389102"/>
                  <a:ext cx="773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8" name="Pentagone 307"/>
                <p:cNvSpPr>
                  <a:spLocks/>
                </p:cNvSpPr>
                <p:nvPr/>
              </p:nvSpPr>
              <p:spPr>
                <a:xfrm rot="16200000" flipH="1">
                  <a:off x="3714272" y="4449034"/>
                  <a:ext cx="11209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09" name="Pentagone 308"/>
                <p:cNvSpPr>
                  <a:spLocks/>
                </p:cNvSpPr>
                <p:nvPr/>
              </p:nvSpPr>
              <p:spPr>
                <a:xfrm rot="16200000" flipH="1">
                  <a:off x="3708111" y="4567306"/>
                  <a:ext cx="12441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10" name="Pentagone 309"/>
                <p:cNvSpPr>
                  <a:spLocks/>
                </p:cNvSpPr>
                <p:nvPr/>
              </p:nvSpPr>
              <p:spPr>
                <a:xfrm rot="16200000" flipH="1">
                  <a:off x="3740723" y="4659128"/>
                  <a:ext cx="5919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11" name="Pentagone 310"/>
                <p:cNvSpPr>
                  <a:spLocks/>
                </p:cNvSpPr>
                <p:nvPr/>
              </p:nvSpPr>
              <p:spPr>
                <a:xfrm rot="5400000" flipH="1">
                  <a:off x="3767315" y="4691746"/>
                  <a:ext cx="601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12" name="Pentagone 311"/>
                <p:cNvSpPr>
                  <a:spLocks/>
                </p:cNvSpPr>
                <p:nvPr/>
              </p:nvSpPr>
              <p:spPr>
                <a:xfrm rot="16200000" flipH="1">
                  <a:off x="3742795" y="4722292"/>
                  <a:ext cx="5505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13" name="Pentagone 312"/>
                <p:cNvSpPr>
                  <a:spLocks/>
                </p:cNvSpPr>
                <p:nvPr/>
              </p:nvSpPr>
              <p:spPr>
                <a:xfrm rot="5400000" flipH="1">
                  <a:off x="3264851" y="5255302"/>
                  <a:ext cx="101093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14" name="Pentagone 313"/>
                <p:cNvSpPr>
                  <a:spLocks/>
                </p:cNvSpPr>
                <p:nvPr/>
              </p:nvSpPr>
              <p:spPr>
                <a:xfrm rot="5400000" flipH="1">
                  <a:off x="3555407" y="5975700"/>
                  <a:ext cx="42982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15" name="Pentagone 314"/>
                <p:cNvSpPr>
                  <a:spLocks/>
                </p:cNvSpPr>
                <p:nvPr/>
              </p:nvSpPr>
              <p:spPr>
                <a:xfrm rot="16200000" flipH="1">
                  <a:off x="3770124" y="6190827"/>
                  <a:ext cx="39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316" name="Pentagone 315"/>
                <p:cNvSpPr>
                  <a:spLocks/>
                </p:cNvSpPr>
                <p:nvPr/>
              </p:nvSpPr>
              <p:spPr>
                <a:xfrm rot="16200000" flipH="1">
                  <a:off x="3764850" y="6196508"/>
                  <a:ext cx="1094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grpSp>
            <p:nvGrpSpPr>
              <p:cNvPr id="28" name="Groupe 27"/>
              <p:cNvGrpSpPr/>
              <p:nvPr/>
            </p:nvGrpSpPr>
            <p:grpSpPr>
              <a:xfrm>
                <a:off x="4130590" y="1070848"/>
                <a:ext cx="132328" cy="4490316"/>
                <a:chOff x="4480611" y="317870"/>
                <a:chExt cx="157843" cy="5356105"/>
              </a:xfrm>
            </p:grpSpPr>
            <p:sp>
              <p:nvSpPr>
                <p:cNvPr id="229" name="Pentagone 228"/>
                <p:cNvSpPr>
                  <a:spLocks/>
                </p:cNvSpPr>
                <p:nvPr/>
              </p:nvSpPr>
              <p:spPr>
                <a:xfrm rot="16200000" flipH="1">
                  <a:off x="3515459" y="1283022"/>
                  <a:ext cx="208814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0" name="Pentagone 229"/>
                <p:cNvSpPr>
                  <a:spLocks/>
                </p:cNvSpPr>
                <p:nvPr/>
              </p:nvSpPr>
              <p:spPr>
                <a:xfrm rot="16200000" flipH="1">
                  <a:off x="4439943" y="2446699"/>
                  <a:ext cx="23917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1" name="Pentagone 230"/>
                <p:cNvSpPr>
                  <a:spLocks/>
                </p:cNvSpPr>
                <p:nvPr/>
              </p:nvSpPr>
              <p:spPr>
                <a:xfrm rot="16200000" flipH="1">
                  <a:off x="4556612" y="2569224"/>
                  <a:ext cx="584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2" name="Pentagone 231"/>
                <p:cNvSpPr>
                  <a:spLocks/>
                </p:cNvSpPr>
                <p:nvPr/>
              </p:nvSpPr>
              <p:spPr>
                <a:xfrm rot="5400000" flipH="1">
                  <a:off x="4552576" y="2579115"/>
                  <a:ext cx="1391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3" name="Pentagone 232"/>
                <p:cNvSpPr>
                  <a:spLocks/>
                </p:cNvSpPr>
                <p:nvPr/>
              </p:nvSpPr>
              <p:spPr>
                <a:xfrm rot="16200000" flipH="1">
                  <a:off x="4537630" y="2607988"/>
                  <a:ext cx="4380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4" name="Pentagone 233"/>
                <p:cNvSpPr>
                  <a:spLocks/>
                </p:cNvSpPr>
                <p:nvPr/>
              </p:nvSpPr>
              <p:spPr>
                <a:xfrm rot="16200000" flipH="1">
                  <a:off x="4557458" y="2631978"/>
                  <a:ext cx="414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5" name="Pentagone 234"/>
                <p:cNvSpPr>
                  <a:spLocks/>
                </p:cNvSpPr>
                <p:nvPr/>
              </p:nvSpPr>
              <p:spPr>
                <a:xfrm rot="5400000" flipH="1">
                  <a:off x="4528192" y="2665407"/>
                  <a:ext cx="6268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6" name="Pentagone 235"/>
                <p:cNvSpPr>
                  <a:spLocks/>
                </p:cNvSpPr>
                <p:nvPr/>
              </p:nvSpPr>
              <p:spPr>
                <a:xfrm rot="5400000" flipH="1">
                  <a:off x="4522644" y="2733649"/>
                  <a:ext cx="7377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7" name="Pentagone 236"/>
                <p:cNvSpPr>
                  <a:spLocks/>
                </p:cNvSpPr>
                <p:nvPr/>
              </p:nvSpPr>
              <p:spPr>
                <a:xfrm rot="16200000" flipH="1">
                  <a:off x="4538715" y="2791369"/>
                  <a:ext cx="4163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8" name="Pentagone 237"/>
                <p:cNvSpPr>
                  <a:spLocks/>
                </p:cNvSpPr>
                <p:nvPr/>
              </p:nvSpPr>
              <p:spPr>
                <a:xfrm rot="5400000" flipH="1">
                  <a:off x="4530099" y="2841633"/>
                  <a:ext cx="5886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39" name="Pentagone 238"/>
                <p:cNvSpPr>
                  <a:spLocks/>
                </p:cNvSpPr>
                <p:nvPr/>
              </p:nvSpPr>
              <p:spPr>
                <a:xfrm rot="5400000" flipH="1">
                  <a:off x="4525600" y="2905013"/>
                  <a:ext cx="6786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0" name="Pentagone 239"/>
                <p:cNvSpPr>
                  <a:spLocks/>
                </p:cNvSpPr>
                <p:nvPr/>
              </p:nvSpPr>
              <p:spPr>
                <a:xfrm rot="5400000" flipH="1">
                  <a:off x="4555533" y="2942959"/>
                  <a:ext cx="799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1" name="Pentagone 240"/>
                <p:cNvSpPr>
                  <a:spLocks/>
                </p:cNvSpPr>
                <p:nvPr/>
              </p:nvSpPr>
              <p:spPr>
                <a:xfrm rot="5400000" flipH="1">
                  <a:off x="4538810" y="2967695"/>
                  <a:ext cx="4144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2" name="Pentagone 241"/>
                <p:cNvSpPr>
                  <a:spLocks/>
                </p:cNvSpPr>
                <p:nvPr/>
              </p:nvSpPr>
              <p:spPr>
                <a:xfrm rot="16200000" flipH="1">
                  <a:off x="4556023" y="2991940"/>
                  <a:ext cx="701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3" name="Pentagone 242"/>
                <p:cNvSpPr>
                  <a:spLocks/>
                </p:cNvSpPr>
                <p:nvPr/>
              </p:nvSpPr>
              <p:spPr>
                <a:xfrm rot="16200000" flipH="1">
                  <a:off x="4541787" y="3013208"/>
                  <a:ext cx="3549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4" name="Pentagone 243"/>
                <p:cNvSpPr>
                  <a:spLocks/>
                </p:cNvSpPr>
                <p:nvPr/>
              </p:nvSpPr>
              <p:spPr>
                <a:xfrm rot="16200000" flipH="1">
                  <a:off x="4558408" y="3032091"/>
                  <a:ext cx="224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5" name="Pentagone 244"/>
                <p:cNvSpPr>
                  <a:spLocks/>
                </p:cNvSpPr>
                <p:nvPr/>
              </p:nvSpPr>
              <p:spPr>
                <a:xfrm rot="5400000" flipH="1">
                  <a:off x="4535900" y="3056861"/>
                  <a:ext cx="4726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6" name="Pentagone 245"/>
                <p:cNvSpPr>
                  <a:spLocks/>
                </p:cNvSpPr>
                <p:nvPr/>
              </p:nvSpPr>
              <p:spPr>
                <a:xfrm rot="16200000" flipH="1">
                  <a:off x="4557780" y="3082260"/>
                  <a:ext cx="350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7" name="Pentagone 246"/>
                <p:cNvSpPr>
                  <a:spLocks/>
                </p:cNvSpPr>
                <p:nvPr/>
              </p:nvSpPr>
              <p:spPr>
                <a:xfrm rot="16200000" flipH="1">
                  <a:off x="4523163" y="3120395"/>
                  <a:ext cx="7273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8" name="Pentagone 247"/>
                <p:cNvSpPr>
                  <a:spLocks/>
                </p:cNvSpPr>
                <p:nvPr/>
              </p:nvSpPr>
              <p:spPr>
                <a:xfrm rot="5400000" flipH="1">
                  <a:off x="4544808" y="3171503"/>
                  <a:ext cx="2944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49" name="Pentagone 248"/>
                <p:cNvSpPr>
                  <a:spLocks/>
                </p:cNvSpPr>
                <p:nvPr/>
              </p:nvSpPr>
              <p:spPr>
                <a:xfrm rot="5400000" flipH="1">
                  <a:off x="4391444" y="3354329"/>
                  <a:ext cx="33617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0" name="Pentagone 249"/>
                <p:cNvSpPr>
                  <a:spLocks/>
                </p:cNvSpPr>
                <p:nvPr/>
              </p:nvSpPr>
              <p:spPr>
                <a:xfrm rot="16200000" flipH="1">
                  <a:off x="4525541" y="3556423"/>
                  <a:ext cx="6798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1" name="Pentagone 250"/>
                <p:cNvSpPr>
                  <a:spLocks/>
                </p:cNvSpPr>
                <p:nvPr/>
              </p:nvSpPr>
              <p:spPr>
                <a:xfrm rot="5400000" flipH="1">
                  <a:off x="4525312" y="3624649"/>
                  <a:ext cx="6844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2" name="Pentagone 251"/>
                <p:cNvSpPr>
                  <a:spLocks/>
                </p:cNvSpPr>
                <p:nvPr/>
              </p:nvSpPr>
              <p:spPr>
                <a:xfrm rot="5400000" flipH="1">
                  <a:off x="4512832" y="3705585"/>
                  <a:ext cx="9340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3" name="Pentagone 252"/>
                <p:cNvSpPr>
                  <a:spLocks/>
                </p:cNvSpPr>
                <p:nvPr/>
              </p:nvSpPr>
              <p:spPr>
                <a:xfrm rot="5400000" flipH="1">
                  <a:off x="4553666" y="3758166"/>
                  <a:ext cx="1173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4" name="Pentagone 253"/>
                <p:cNvSpPr>
                  <a:spLocks/>
                </p:cNvSpPr>
                <p:nvPr/>
              </p:nvSpPr>
              <p:spPr>
                <a:xfrm rot="16200000" flipH="1">
                  <a:off x="4543201" y="3780378"/>
                  <a:ext cx="3266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5" name="Pentagone 254"/>
                <p:cNvSpPr>
                  <a:spLocks/>
                </p:cNvSpPr>
                <p:nvPr/>
              </p:nvSpPr>
              <p:spPr>
                <a:xfrm rot="16200000" flipH="1">
                  <a:off x="4549724" y="3806533"/>
                  <a:ext cx="1961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6" name="Pentagone 255"/>
                <p:cNvSpPr>
                  <a:spLocks/>
                </p:cNvSpPr>
                <p:nvPr/>
              </p:nvSpPr>
              <p:spPr>
                <a:xfrm rot="16200000" flipH="1">
                  <a:off x="4441701" y="3934186"/>
                  <a:ext cx="23566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7" name="Pentagone 256"/>
                <p:cNvSpPr>
                  <a:spLocks/>
                </p:cNvSpPr>
                <p:nvPr/>
              </p:nvSpPr>
              <p:spPr>
                <a:xfrm rot="5400000" flipH="1">
                  <a:off x="4531323" y="4080241"/>
                  <a:ext cx="5641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8" name="Pentagone 257"/>
                <p:cNvSpPr>
                  <a:spLocks/>
                </p:cNvSpPr>
                <p:nvPr/>
              </p:nvSpPr>
              <p:spPr>
                <a:xfrm rot="16200000" flipH="1">
                  <a:off x="4558273" y="4109724"/>
                  <a:ext cx="251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59" name="Pentagone 258"/>
                <p:cNvSpPr>
                  <a:spLocks/>
                </p:cNvSpPr>
                <p:nvPr/>
              </p:nvSpPr>
              <p:spPr>
                <a:xfrm rot="16200000" flipH="1">
                  <a:off x="4555526" y="4115003"/>
                  <a:ext cx="801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60" name="Pentagone 259"/>
                <p:cNvSpPr>
                  <a:spLocks/>
                </p:cNvSpPr>
                <p:nvPr/>
              </p:nvSpPr>
              <p:spPr>
                <a:xfrm rot="16200000" flipH="1">
                  <a:off x="4556861" y="4121695"/>
                  <a:ext cx="534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61" name="Pentagone 260"/>
                <p:cNvSpPr>
                  <a:spLocks/>
                </p:cNvSpPr>
                <p:nvPr/>
              </p:nvSpPr>
              <p:spPr>
                <a:xfrm rot="16200000" flipH="1">
                  <a:off x="4556723" y="4127190"/>
                  <a:ext cx="561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62" name="Pentagone 261"/>
                <p:cNvSpPr>
                  <a:spLocks/>
                </p:cNvSpPr>
                <p:nvPr/>
              </p:nvSpPr>
              <p:spPr>
                <a:xfrm rot="16200000" flipH="1">
                  <a:off x="4529729" y="4159817"/>
                  <a:ext cx="5960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63" name="Pentagone 262"/>
                <p:cNvSpPr>
                  <a:spLocks/>
                </p:cNvSpPr>
                <p:nvPr/>
              </p:nvSpPr>
              <p:spPr>
                <a:xfrm rot="16200000" flipH="1">
                  <a:off x="4557884" y="4191283"/>
                  <a:ext cx="329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64" name="Pentagone 263"/>
                <p:cNvSpPr>
                  <a:spLocks/>
                </p:cNvSpPr>
                <p:nvPr/>
              </p:nvSpPr>
              <p:spPr>
                <a:xfrm rot="16200000" flipH="1">
                  <a:off x="3858478" y="4894000"/>
                  <a:ext cx="140210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grpSp>
            <p:nvGrpSpPr>
              <p:cNvPr id="29" name="Groupe 28"/>
              <p:cNvGrpSpPr/>
              <p:nvPr/>
            </p:nvGrpSpPr>
            <p:grpSpPr>
              <a:xfrm>
                <a:off x="4792229" y="1070848"/>
                <a:ext cx="132328" cy="4183900"/>
                <a:chOff x="5269823" y="317870"/>
                <a:chExt cx="157842" cy="4990608"/>
              </a:xfrm>
            </p:grpSpPr>
            <p:sp>
              <p:nvSpPr>
                <p:cNvPr id="198" name="Pentagone 197"/>
                <p:cNvSpPr>
                  <a:spLocks/>
                </p:cNvSpPr>
                <p:nvPr/>
              </p:nvSpPr>
              <p:spPr>
                <a:xfrm rot="5400000" flipH="1">
                  <a:off x="4894341" y="693352"/>
                  <a:ext cx="90880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99" name="Pentagone 198"/>
                <p:cNvSpPr>
                  <a:spLocks/>
                </p:cNvSpPr>
                <p:nvPr/>
              </p:nvSpPr>
              <p:spPr>
                <a:xfrm rot="16200000" flipH="1">
                  <a:off x="4853275" y="1643238"/>
                  <a:ext cx="99093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0" name="Pentagone 199"/>
                <p:cNvSpPr>
                  <a:spLocks/>
                </p:cNvSpPr>
                <p:nvPr/>
              </p:nvSpPr>
              <p:spPr>
                <a:xfrm rot="16200000" flipH="1">
                  <a:off x="5346425" y="2141040"/>
                  <a:ext cx="463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1" name="Pentagone 200"/>
                <p:cNvSpPr>
                  <a:spLocks/>
                </p:cNvSpPr>
                <p:nvPr/>
              </p:nvSpPr>
              <p:spPr>
                <a:xfrm rot="16200000" flipH="1">
                  <a:off x="5346578" y="2145539"/>
                  <a:ext cx="433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2" name="Pentagone 201"/>
                <p:cNvSpPr>
                  <a:spLocks/>
                </p:cNvSpPr>
                <p:nvPr/>
              </p:nvSpPr>
              <p:spPr>
                <a:xfrm rot="16200000" flipH="1">
                  <a:off x="5305494" y="2190968"/>
                  <a:ext cx="8649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3" name="Pentagone 202"/>
                <p:cNvSpPr>
                  <a:spLocks/>
                </p:cNvSpPr>
                <p:nvPr/>
              </p:nvSpPr>
              <p:spPr>
                <a:xfrm rot="16200000" flipH="1">
                  <a:off x="5277807" y="2305168"/>
                  <a:ext cx="14187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4" name="Pentagone 203"/>
                <p:cNvSpPr>
                  <a:spLocks/>
                </p:cNvSpPr>
                <p:nvPr/>
              </p:nvSpPr>
              <p:spPr>
                <a:xfrm rot="5400000" flipH="1">
                  <a:off x="5316642" y="2408221"/>
                  <a:ext cx="6420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5" name="Pentagone 204"/>
                <p:cNvSpPr>
                  <a:spLocks/>
                </p:cNvSpPr>
                <p:nvPr/>
              </p:nvSpPr>
              <p:spPr>
                <a:xfrm rot="16200000" flipH="1">
                  <a:off x="5289983" y="2499098"/>
                  <a:ext cx="11752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6" name="Pentagone 205"/>
                <p:cNvSpPr>
                  <a:spLocks/>
                </p:cNvSpPr>
                <p:nvPr/>
              </p:nvSpPr>
              <p:spPr>
                <a:xfrm rot="16200000" flipH="1">
                  <a:off x="5339476" y="2567141"/>
                  <a:ext cx="1853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7" name="Pentagone 206"/>
                <p:cNvSpPr>
                  <a:spLocks/>
                </p:cNvSpPr>
                <p:nvPr/>
              </p:nvSpPr>
              <p:spPr>
                <a:xfrm rot="16200000" flipH="1">
                  <a:off x="5053022" y="2872145"/>
                  <a:ext cx="59144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8" name="Pentagone 207"/>
                <p:cNvSpPr>
                  <a:spLocks/>
                </p:cNvSpPr>
                <p:nvPr/>
              </p:nvSpPr>
              <p:spPr>
                <a:xfrm rot="5400000" flipH="1">
                  <a:off x="5298144" y="3218481"/>
                  <a:ext cx="10120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09" name="Pentagone 208"/>
                <p:cNvSpPr>
                  <a:spLocks/>
                </p:cNvSpPr>
                <p:nvPr/>
              </p:nvSpPr>
              <p:spPr>
                <a:xfrm rot="5400000" flipH="1">
                  <a:off x="5296097" y="3321742"/>
                  <a:ext cx="10529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0" name="Pentagone 209"/>
                <p:cNvSpPr>
                  <a:spLocks/>
                </p:cNvSpPr>
                <p:nvPr/>
              </p:nvSpPr>
              <p:spPr>
                <a:xfrm rot="16200000" flipH="1">
                  <a:off x="5306163" y="3416984"/>
                  <a:ext cx="8516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1" name="Pentagone 210"/>
                <p:cNvSpPr>
                  <a:spLocks/>
                </p:cNvSpPr>
                <p:nvPr/>
              </p:nvSpPr>
              <p:spPr>
                <a:xfrm rot="16200000" flipH="1">
                  <a:off x="5345306" y="3463017"/>
                  <a:ext cx="687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2" name="Pentagone 211"/>
                <p:cNvSpPr>
                  <a:spLocks/>
                </p:cNvSpPr>
                <p:nvPr/>
              </p:nvSpPr>
              <p:spPr>
                <a:xfrm rot="16200000" flipH="1">
                  <a:off x="5329777" y="3485435"/>
                  <a:ext cx="3793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3" name="Pentagone 212"/>
                <p:cNvSpPr>
                  <a:spLocks/>
                </p:cNvSpPr>
                <p:nvPr/>
              </p:nvSpPr>
              <p:spPr>
                <a:xfrm rot="16200000" flipH="1">
                  <a:off x="5337569" y="3515592"/>
                  <a:ext cx="2235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4" name="Pentagone 213"/>
                <p:cNvSpPr>
                  <a:spLocks/>
                </p:cNvSpPr>
                <p:nvPr/>
              </p:nvSpPr>
              <p:spPr>
                <a:xfrm rot="16200000" flipH="1">
                  <a:off x="5336787" y="3538738"/>
                  <a:ext cx="2391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5" name="Pentagone 214"/>
                <p:cNvSpPr>
                  <a:spLocks/>
                </p:cNvSpPr>
                <p:nvPr/>
              </p:nvSpPr>
              <p:spPr>
                <a:xfrm rot="16200000" flipH="1">
                  <a:off x="5342830" y="3556623"/>
                  <a:ext cx="1182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6" name="Pentagone 215"/>
                <p:cNvSpPr>
                  <a:spLocks/>
                </p:cNvSpPr>
                <p:nvPr/>
              </p:nvSpPr>
              <p:spPr>
                <a:xfrm rot="16200000" flipH="1">
                  <a:off x="5345463" y="3565832"/>
                  <a:ext cx="656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7" name="Pentagone 216"/>
                <p:cNvSpPr>
                  <a:spLocks/>
                </p:cNvSpPr>
                <p:nvPr/>
              </p:nvSpPr>
              <p:spPr>
                <a:xfrm rot="16200000" flipH="1">
                  <a:off x="5262255" y="3655616"/>
                  <a:ext cx="17297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8" name="Pentagone 217"/>
                <p:cNvSpPr>
                  <a:spLocks/>
                </p:cNvSpPr>
                <p:nvPr/>
              </p:nvSpPr>
              <p:spPr>
                <a:xfrm rot="16200000" flipH="1">
                  <a:off x="5346274" y="3744589"/>
                  <a:ext cx="493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19" name="Pentagone 218"/>
                <p:cNvSpPr>
                  <a:spLocks/>
                </p:cNvSpPr>
                <p:nvPr/>
              </p:nvSpPr>
              <p:spPr>
                <a:xfrm rot="16200000" flipH="1">
                  <a:off x="5331794" y="3764023"/>
                  <a:ext cx="3389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20" name="Pentagone 219"/>
                <p:cNvSpPr>
                  <a:spLocks/>
                </p:cNvSpPr>
                <p:nvPr/>
              </p:nvSpPr>
              <p:spPr>
                <a:xfrm rot="16200000" flipH="1">
                  <a:off x="5313253" y="3816478"/>
                  <a:ext cx="7098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21" name="Pentagone 220"/>
                <p:cNvSpPr>
                  <a:spLocks/>
                </p:cNvSpPr>
                <p:nvPr/>
              </p:nvSpPr>
              <p:spPr>
                <a:xfrm rot="16200000" flipH="1">
                  <a:off x="5337820" y="3862907"/>
                  <a:ext cx="2184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22" name="Pentagone 221"/>
                <p:cNvSpPr>
                  <a:spLocks/>
                </p:cNvSpPr>
                <p:nvPr/>
              </p:nvSpPr>
              <p:spPr>
                <a:xfrm rot="5400000" flipH="1">
                  <a:off x="5345299" y="3877290"/>
                  <a:ext cx="689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23" name="Pentagone 222"/>
                <p:cNvSpPr>
                  <a:spLocks/>
                </p:cNvSpPr>
                <p:nvPr/>
              </p:nvSpPr>
              <p:spPr>
                <a:xfrm rot="5400000" flipH="1">
                  <a:off x="5304193" y="3925300"/>
                  <a:ext cx="8910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24" name="Pentagone 223"/>
                <p:cNvSpPr>
                  <a:spLocks/>
                </p:cNvSpPr>
                <p:nvPr/>
              </p:nvSpPr>
              <p:spPr>
                <a:xfrm rot="16200000" flipH="1">
                  <a:off x="5346682" y="3971928"/>
                  <a:ext cx="412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25" name="Pentagone 224"/>
                <p:cNvSpPr>
                  <a:spLocks/>
                </p:cNvSpPr>
                <p:nvPr/>
              </p:nvSpPr>
              <p:spPr>
                <a:xfrm rot="16200000" flipH="1">
                  <a:off x="5347654" y="3975094"/>
                  <a:ext cx="217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26" name="Pentagone 225"/>
                <p:cNvSpPr>
                  <a:spLocks/>
                </p:cNvSpPr>
                <p:nvPr/>
              </p:nvSpPr>
              <p:spPr>
                <a:xfrm rot="5400000" flipH="1">
                  <a:off x="5347063" y="3977879"/>
                  <a:ext cx="336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27" name="Pentagone 226"/>
                <p:cNvSpPr>
                  <a:spLocks/>
                </p:cNvSpPr>
                <p:nvPr/>
              </p:nvSpPr>
              <p:spPr>
                <a:xfrm rot="16200000" flipH="1">
                  <a:off x="5331369" y="3996949"/>
                  <a:ext cx="3474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228" name="Pentagone 227"/>
                <p:cNvSpPr>
                  <a:spLocks/>
                </p:cNvSpPr>
                <p:nvPr/>
              </p:nvSpPr>
              <p:spPr>
                <a:xfrm rot="16200000" flipH="1">
                  <a:off x="4741133" y="4621947"/>
                  <a:ext cx="121522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grpSp>
            <p:nvGrpSpPr>
              <p:cNvPr id="30" name="Groupe 29"/>
              <p:cNvGrpSpPr/>
              <p:nvPr/>
            </p:nvGrpSpPr>
            <p:grpSpPr>
              <a:xfrm>
                <a:off x="5453867" y="1070848"/>
                <a:ext cx="132328" cy="5361759"/>
                <a:chOff x="6059034" y="317870"/>
                <a:chExt cx="157843" cy="6395573"/>
              </a:xfrm>
            </p:grpSpPr>
            <p:sp>
              <p:nvSpPr>
                <p:cNvPr id="141" name="Pentagone 140"/>
                <p:cNvSpPr>
                  <a:spLocks/>
                </p:cNvSpPr>
                <p:nvPr/>
              </p:nvSpPr>
              <p:spPr>
                <a:xfrm rot="5400000" flipH="1">
                  <a:off x="5432248" y="944656"/>
                  <a:ext cx="141141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42" name="Pentagone 141"/>
                <p:cNvSpPr>
                  <a:spLocks/>
                </p:cNvSpPr>
                <p:nvPr/>
              </p:nvSpPr>
              <p:spPr>
                <a:xfrm rot="16200000" flipH="1">
                  <a:off x="6135627" y="1652705"/>
                  <a:ext cx="465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43" name="Pentagone 142"/>
                <p:cNvSpPr>
                  <a:spLocks/>
                </p:cNvSpPr>
                <p:nvPr/>
              </p:nvSpPr>
              <p:spPr>
                <a:xfrm rot="5400000" flipH="1">
                  <a:off x="6128585" y="1664419"/>
                  <a:ext cx="1874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44" name="Pentagone 143"/>
                <p:cNvSpPr>
                  <a:spLocks/>
                </p:cNvSpPr>
                <p:nvPr/>
              </p:nvSpPr>
              <p:spPr>
                <a:xfrm rot="5400000" flipH="1">
                  <a:off x="6042519" y="1769240"/>
                  <a:ext cx="19087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45" name="Pentagone 144"/>
                <p:cNvSpPr>
                  <a:spLocks/>
                </p:cNvSpPr>
                <p:nvPr/>
              </p:nvSpPr>
              <p:spPr>
                <a:xfrm rot="16200000" flipH="1">
                  <a:off x="6137746" y="1864901"/>
                  <a:ext cx="41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46" name="Pentagone 145"/>
                <p:cNvSpPr>
                  <a:spLocks/>
                </p:cNvSpPr>
                <p:nvPr/>
              </p:nvSpPr>
              <p:spPr>
                <a:xfrm rot="16200000" flipH="1">
                  <a:off x="6108288" y="1894793"/>
                  <a:ext cx="5933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47" name="Pentagone 146"/>
                <p:cNvSpPr>
                  <a:spLocks/>
                </p:cNvSpPr>
                <p:nvPr/>
              </p:nvSpPr>
              <p:spPr>
                <a:xfrm rot="16200000" flipH="1">
                  <a:off x="6134652" y="1927779"/>
                  <a:ext cx="660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48" name="Pentagone 147"/>
                <p:cNvSpPr>
                  <a:spLocks/>
                </p:cNvSpPr>
                <p:nvPr/>
              </p:nvSpPr>
              <p:spPr>
                <a:xfrm rot="5400000" flipH="1">
                  <a:off x="6116647" y="1952404"/>
                  <a:ext cx="4261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49" name="Pentagone 148"/>
                <p:cNvSpPr>
                  <a:spLocks/>
                </p:cNvSpPr>
                <p:nvPr/>
              </p:nvSpPr>
              <p:spPr>
                <a:xfrm rot="16200000" flipH="1">
                  <a:off x="6100635" y="2011047"/>
                  <a:ext cx="7464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0" name="Pentagone 149"/>
                <p:cNvSpPr>
                  <a:spLocks/>
                </p:cNvSpPr>
                <p:nvPr/>
              </p:nvSpPr>
              <p:spPr>
                <a:xfrm rot="16200000" flipH="1">
                  <a:off x="6127497" y="2058841"/>
                  <a:ext cx="2091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1" name="Pentagone 150"/>
                <p:cNvSpPr>
                  <a:spLocks/>
                </p:cNvSpPr>
                <p:nvPr/>
              </p:nvSpPr>
              <p:spPr>
                <a:xfrm rot="16200000" flipH="1">
                  <a:off x="6071563" y="2135706"/>
                  <a:ext cx="13278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2" name="Pentagone 151"/>
                <p:cNvSpPr>
                  <a:spLocks/>
                </p:cNvSpPr>
                <p:nvPr/>
              </p:nvSpPr>
              <p:spPr>
                <a:xfrm rot="16200000" flipH="1">
                  <a:off x="6077620" y="2262448"/>
                  <a:ext cx="12067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3" name="Pentagone 152"/>
                <p:cNvSpPr>
                  <a:spLocks/>
                </p:cNvSpPr>
                <p:nvPr/>
              </p:nvSpPr>
              <p:spPr>
                <a:xfrm rot="16200000" flipH="1">
                  <a:off x="6088989" y="2371764"/>
                  <a:ext cx="9793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4" name="Pentagone 153"/>
                <p:cNvSpPr>
                  <a:spLocks/>
                </p:cNvSpPr>
                <p:nvPr/>
              </p:nvSpPr>
              <p:spPr>
                <a:xfrm rot="16200000" flipH="1">
                  <a:off x="6042864" y="2515837"/>
                  <a:ext cx="19018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5" name="Pentagone 154"/>
                <p:cNvSpPr>
                  <a:spLocks/>
                </p:cNvSpPr>
                <p:nvPr/>
              </p:nvSpPr>
              <p:spPr>
                <a:xfrm rot="16200000" flipH="1">
                  <a:off x="6087728" y="2661170"/>
                  <a:ext cx="10045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6" name="Pentagone 155"/>
                <p:cNvSpPr>
                  <a:spLocks/>
                </p:cNvSpPr>
                <p:nvPr/>
              </p:nvSpPr>
              <p:spPr>
                <a:xfrm rot="16200000" flipH="1">
                  <a:off x="6110017" y="2739350"/>
                  <a:ext cx="5587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7" name="Pentagone 156"/>
                <p:cNvSpPr>
                  <a:spLocks/>
                </p:cNvSpPr>
                <p:nvPr/>
              </p:nvSpPr>
              <p:spPr>
                <a:xfrm rot="16200000" flipH="1">
                  <a:off x="6083232" y="2822026"/>
                  <a:ext cx="10944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8" name="Pentagone 157"/>
                <p:cNvSpPr>
                  <a:spLocks/>
                </p:cNvSpPr>
                <p:nvPr/>
              </p:nvSpPr>
              <p:spPr>
                <a:xfrm rot="16200000" flipH="1">
                  <a:off x="6132842" y="2881877"/>
                  <a:ext cx="1022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59" name="Pentagone 158"/>
                <p:cNvSpPr>
                  <a:spLocks/>
                </p:cNvSpPr>
                <p:nvPr/>
              </p:nvSpPr>
              <p:spPr>
                <a:xfrm rot="16200000" flipH="1">
                  <a:off x="6121289" y="2903672"/>
                  <a:ext cx="3333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0" name="Pentagone 159"/>
                <p:cNvSpPr>
                  <a:spLocks/>
                </p:cNvSpPr>
                <p:nvPr/>
              </p:nvSpPr>
              <p:spPr>
                <a:xfrm rot="5400000" flipH="1">
                  <a:off x="6124451" y="2933858"/>
                  <a:ext cx="2700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1" name="Pentagone 160"/>
                <p:cNvSpPr>
                  <a:spLocks/>
                </p:cNvSpPr>
                <p:nvPr/>
              </p:nvSpPr>
              <p:spPr>
                <a:xfrm rot="5400000" flipH="1">
                  <a:off x="6074689" y="3010643"/>
                  <a:ext cx="12653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2" name="Pentagone 161"/>
                <p:cNvSpPr>
                  <a:spLocks/>
                </p:cNvSpPr>
                <p:nvPr/>
              </p:nvSpPr>
              <p:spPr>
                <a:xfrm rot="16200000" flipH="1">
                  <a:off x="6107850" y="3104028"/>
                  <a:ext cx="6021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3" name="Pentagone 162"/>
                <p:cNvSpPr>
                  <a:spLocks/>
                </p:cNvSpPr>
                <p:nvPr/>
              </p:nvSpPr>
              <p:spPr>
                <a:xfrm rot="16200000" flipH="1">
                  <a:off x="6136888" y="3135215"/>
                  <a:ext cx="213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4" name="Pentagone 163"/>
                <p:cNvSpPr>
                  <a:spLocks/>
                </p:cNvSpPr>
                <p:nvPr/>
              </p:nvSpPr>
              <p:spPr>
                <a:xfrm rot="5400000" flipH="1">
                  <a:off x="6114098" y="3160154"/>
                  <a:ext cx="4771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5" name="Pentagone 164"/>
                <p:cNvSpPr>
                  <a:spLocks/>
                </p:cNvSpPr>
                <p:nvPr/>
              </p:nvSpPr>
              <p:spPr>
                <a:xfrm rot="5400000" flipH="1">
                  <a:off x="6123074" y="3198907"/>
                  <a:ext cx="2976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6" name="Pentagone 165"/>
                <p:cNvSpPr>
                  <a:spLocks/>
                </p:cNvSpPr>
                <p:nvPr/>
              </p:nvSpPr>
              <p:spPr>
                <a:xfrm rot="16200000" flipH="1">
                  <a:off x="6125312" y="3226446"/>
                  <a:ext cx="2528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7" name="Pentagone 166"/>
                <p:cNvSpPr>
                  <a:spLocks/>
                </p:cNvSpPr>
                <p:nvPr/>
              </p:nvSpPr>
              <p:spPr>
                <a:xfrm rot="5400000" flipH="1">
                  <a:off x="6135340" y="3241718"/>
                  <a:ext cx="523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8" name="Pentagone 167"/>
                <p:cNvSpPr>
                  <a:spLocks/>
                </p:cNvSpPr>
                <p:nvPr/>
              </p:nvSpPr>
              <p:spPr>
                <a:xfrm rot="16200000" flipH="1">
                  <a:off x="6125248" y="3257055"/>
                  <a:ext cx="2541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69" name="Pentagone 168"/>
                <p:cNvSpPr>
                  <a:spLocks/>
                </p:cNvSpPr>
                <p:nvPr/>
              </p:nvSpPr>
              <p:spPr>
                <a:xfrm rot="5400000" flipH="1">
                  <a:off x="6098839" y="3308893"/>
                  <a:ext cx="7823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0" name="Pentagone 169"/>
                <p:cNvSpPr>
                  <a:spLocks/>
                </p:cNvSpPr>
                <p:nvPr/>
              </p:nvSpPr>
              <p:spPr>
                <a:xfrm rot="16200000" flipH="1">
                  <a:off x="6134564" y="3351416"/>
                  <a:ext cx="678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1" name="Pentagone 170"/>
                <p:cNvSpPr>
                  <a:spLocks/>
                </p:cNvSpPr>
                <p:nvPr/>
              </p:nvSpPr>
              <p:spPr>
                <a:xfrm rot="5400000" flipH="1">
                  <a:off x="6060516" y="3432260"/>
                  <a:ext cx="15487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2" name="Pentagone 171"/>
                <p:cNvSpPr>
                  <a:spLocks/>
                </p:cNvSpPr>
                <p:nvPr/>
              </p:nvSpPr>
              <p:spPr>
                <a:xfrm rot="16200000" flipH="1">
                  <a:off x="6126047" y="3521622"/>
                  <a:ext cx="2381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3" name="Pentagone 172"/>
                <p:cNvSpPr>
                  <a:spLocks/>
                </p:cNvSpPr>
                <p:nvPr/>
              </p:nvSpPr>
              <p:spPr>
                <a:xfrm rot="5400000" flipH="1">
                  <a:off x="6128798" y="3542702"/>
                  <a:ext cx="1831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4" name="Pentagone 173"/>
                <p:cNvSpPr>
                  <a:spLocks/>
                </p:cNvSpPr>
                <p:nvPr/>
              </p:nvSpPr>
              <p:spPr>
                <a:xfrm rot="16200000" flipH="1">
                  <a:off x="6124344" y="3565486"/>
                  <a:ext cx="2722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5" name="Pentagone 174"/>
                <p:cNvSpPr>
                  <a:spLocks/>
                </p:cNvSpPr>
                <p:nvPr/>
              </p:nvSpPr>
              <p:spPr>
                <a:xfrm rot="16200000" flipH="1">
                  <a:off x="5954039" y="3763029"/>
                  <a:ext cx="36783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6" name="Pentagone 175"/>
                <p:cNvSpPr>
                  <a:spLocks/>
                </p:cNvSpPr>
                <p:nvPr/>
              </p:nvSpPr>
              <p:spPr>
                <a:xfrm rot="5400000" flipH="1">
                  <a:off x="6021629" y="4063287"/>
                  <a:ext cx="23265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7" name="Pentagone 176"/>
                <p:cNvSpPr>
                  <a:spLocks/>
                </p:cNvSpPr>
                <p:nvPr/>
              </p:nvSpPr>
              <p:spPr>
                <a:xfrm rot="16200000" flipH="1">
                  <a:off x="6126607" y="4190976"/>
                  <a:ext cx="2269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8" name="Pentagone 177"/>
                <p:cNvSpPr>
                  <a:spLocks/>
                </p:cNvSpPr>
                <p:nvPr/>
              </p:nvSpPr>
              <p:spPr>
                <a:xfrm rot="16200000" flipH="1">
                  <a:off x="6136835" y="4203459"/>
                  <a:ext cx="224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79" name="Pentagone 178"/>
                <p:cNvSpPr>
                  <a:spLocks/>
                </p:cNvSpPr>
                <p:nvPr/>
              </p:nvSpPr>
              <p:spPr>
                <a:xfrm rot="5400000" flipH="1">
                  <a:off x="6039580" y="4302968"/>
                  <a:ext cx="19675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0" name="Pentagone 179"/>
                <p:cNvSpPr>
                  <a:spLocks/>
                </p:cNvSpPr>
                <p:nvPr/>
              </p:nvSpPr>
              <p:spPr>
                <a:xfrm rot="16200000" flipH="1">
                  <a:off x="6136697" y="4402616"/>
                  <a:ext cx="251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1" name="Pentagone 180"/>
                <p:cNvSpPr>
                  <a:spLocks/>
                </p:cNvSpPr>
                <p:nvPr/>
              </p:nvSpPr>
              <p:spPr>
                <a:xfrm rot="16200000" flipH="1">
                  <a:off x="6130860" y="4410984"/>
                  <a:ext cx="1419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2" name="Pentagone 181"/>
                <p:cNvSpPr>
                  <a:spLocks/>
                </p:cNvSpPr>
                <p:nvPr/>
              </p:nvSpPr>
              <p:spPr>
                <a:xfrm rot="16200000" flipH="1">
                  <a:off x="6137690" y="4418360"/>
                  <a:ext cx="53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3" name="Pentagone 182"/>
                <p:cNvSpPr>
                  <a:spLocks/>
                </p:cNvSpPr>
                <p:nvPr/>
              </p:nvSpPr>
              <p:spPr>
                <a:xfrm rot="16200000" flipH="1">
                  <a:off x="6133615" y="4422980"/>
                  <a:ext cx="868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4" name="Pentagone 183"/>
                <p:cNvSpPr>
                  <a:spLocks/>
                </p:cNvSpPr>
                <p:nvPr/>
              </p:nvSpPr>
              <p:spPr>
                <a:xfrm rot="16200000" flipH="1">
                  <a:off x="6134665" y="4430625"/>
                  <a:ext cx="658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5" name="Pentagone 184"/>
                <p:cNvSpPr>
                  <a:spLocks/>
                </p:cNvSpPr>
                <p:nvPr/>
              </p:nvSpPr>
              <p:spPr>
                <a:xfrm rot="16200000" flipH="1">
                  <a:off x="6080895" y="4490990"/>
                  <a:ext cx="11412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6" name="Pentagone 185"/>
                <p:cNvSpPr>
                  <a:spLocks/>
                </p:cNvSpPr>
                <p:nvPr/>
              </p:nvSpPr>
              <p:spPr>
                <a:xfrm rot="16200000" flipH="1">
                  <a:off x="6131483" y="4554537"/>
                  <a:ext cx="1294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7" name="Pentagone 186"/>
                <p:cNvSpPr>
                  <a:spLocks/>
                </p:cNvSpPr>
                <p:nvPr/>
              </p:nvSpPr>
              <p:spPr>
                <a:xfrm rot="16200000" flipH="1">
                  <a:off x="6137232" y="4561748"/>
                  <a:ext cx="144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8" name="Pentagone 187"/>
                <p:cNvSpPr>
                  <a:spLocks/>
                </p:cNvSpPr>
                <p:nvPr/>
              </p:nvSpPr>
              <p:spPr>
                <a:xfrm rot="5400000" flipH="1">
                  <a:off x="6126473" y="4573968"/>
                  <a:ext cx="2296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89" name="Pentagone 188"/>
                <p:cNvSpPr>
                  <a:spLocks/>
                </p:cNvSpPr>
                <p:nvPr/>
              </p:nvSpPr>
              <p:spPr>
                <a:xfrm rot="16200000" flipH="1">
                  <a:off x="6134603" y="4588817"/>
                  <a:ext cx="670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90" name="Pentagone 189"/>
                <p:cNvSpPr>
                  <a:spLocks/>
                </p:cNvSpPr>
                <p:nvPr/>
              </p:nvSpPr>
              <p:spPr>
                <a:xfrm rot="16200000" flipH="1">
                  <a:off x="6107514" y="4622626"/>
                  <a:ext cx="6088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91" name="Pentagone 190"/>
                <p:cNvSpPr>
                  <a:spLocks/>
                </p:cNvSpPr>
                <p:nvPr/>
              </p:nvSpPr>
              <p:spPr>
                <a:xfrm rot="16200000" flipH="1">
                  <a:off x="6124673" y="4666364"/>
                  <a:ext cx="2656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92" name="Pentagone 191"/>
                <p:cNvSpPr>
                  <a:spLocks/>
                </p:cNvSpPr>
                <p:nvPr/>
              </p:nvSpPr>
              <p:spPr>
                <a:xfrm rot="16200000" flipH="1">
                  <a:off x="6119323" y="4698292"/>
                  <a:ext cx="3726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93" name="Pentagone 192"/>
                <p:cNvSpPr>
                  <a:spLocks/>
                </p:cNvSpPr>
                <p:nvPr/>
              </p:nvSpPr>
              <p:spPr>
                <a:xfrm rot="16200000" flipH="1">
                  <a:off x="6130814" y="4724080"/>
                  <a:ext cx="1428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94" name="Pentagone 193"/>
                <p:cNvSpPr>
                  <a:spLocks/>
                </p:cNvSpPr>
                <p:nvPr/>
              </p:nvSpPr>
              <p:spPr>
                <a:xfrm rot="16200000" flipH="1">
                  <a:off x="6128553" y="4740638"/>
                  <a:ext cx="1880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95" name="Pentagone 194"/>
                <p:cNvSpPr>
                  <a:spLocks/>
                </p:cNvSpPr>
                <p:nvPr/>
              </p:nvSpPr>
              <p:spPr>
                <a:xfrm rot="16200000" flipH="1">
                  <a:off x="6126493" y="4761518"/>
                  <a:ext cx="2292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96" name="Pentagone 195"/>
                <p:cNvSpPr>
                  <a:spLocks/>
                </p:cNvSpPr>
                <p:nvPr/>
              </p:nvSpPr>
              <p:spPr>
                <a:xfrm rot="16200000" flipH="1">
                  <a:off x="6136019" y="4774931"/>
                  <a:ext cx="387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97" name="Pentagone 196"/>
                <p:cNvSpPr>
                  <a:spLocks/>
                </p:cNvSpPr>
                <p:nvPr/>
              </p:nvSpPr>
              <p:spPr>
                <a:xfrm rot="5400000" flipH="1">
                  <a:off x="5209135" y="5705701"/>
                  <a:ext cx="185764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sp>
            <p:nvSpPr>
              <p:cNvPr id="31" name="ZoneTexte 353"/>
              <p:cNvSpPr txBox="1"/>
              <p:nvPr/>
            </p:nvSpPr>
            <p:spPr>
              <a:xfrm flipH="1">
                <a:off x="3172519" y="765401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 dirty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 dirty="0"/>
                  <a:t>05</a:t>
                </a:r>
              </a:p>
            </p:txBody>
          </p:sp>
          <p:sp>
            <p:nvSpPr>
              <p:cNvPr id="32" name="ZoneTexte 355"/>
              <p:cNvSpPr txBox="1"/>
              <p:nvPr/>
            </p:nvSpPr>
            <p:spPr>
              <a:xfrm flipH="1">
                <a:off x="3834158" y="765401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/>
                  <a:t>06</a:t>
                </a:r>
              </a:p>
            </p:txBody>
          </p:sp>
          <p:sp>
            <p:nvSpPr>
              <p:cNvPr id="33" name="ZoneTexte 357"/>
              <p:cNvSpPr txBox="1"/>
              <p:nvPr/>
            </p:nvSpPr>
            <p:spPr>
              <a:xfrm flipH="1">
                <a:off x="4495798" y="765401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/>
                  <a:t>07</a:t>
                </a:r>
              </a:p>
            </p:txBody>
          </p:sp>
          <p:sp>
            <p:nvSpPr>
              <p:cNvPr id="34" name="ZoneTexte 359"/>
              <p:cNvSpPr txBox="1"/>
              <p:nvPr/>
            </p:nvSpPr>
            <p:spPr>
              <a:xfrm flipH="1">
                <a:off x="5157436" y="765401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/>
                  <a:t>08</a:t>
                </a:r>
              </a:p>
            </p:txBody>
          </p:sp>
          <p:grpSp>
            <p:nvGrpSpPr>
              <p:cNvPr id="35" name="Groupe 34"/>
              <p:cNvGrpSpPr/>
              <p:nvPr/>
            </p:nvGrpSpPr>
            <p:grpSpPr>
              <a:xfrm>
                <a:off x="6156368" y="1070152"/>
                <a:ext cx="132328" cy="4933856"/>
                <a:chOff x="6896985" y="317040"/>
                <a:chExt cx="157843" cy="5885165"/>
              </a:xfrm>
            </p:grpSpPr>
            <p:sp>
              <p:nvSpPr>
                <p:cNvPr id="102" name="Pentagone 101"/>
                <p:cNvSpPr>
                  <a:spLocks/>
                </p:cNvSpPr>
                <p:nvPr/>
              </p:nvSpPr>
              <p:spPr>
                <a:xfrm rot="16200000" flipH="1">
                  <a:off x="6145627" y="1068398"/>
                  <a:ext cx="166055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03" name="Pentagone 102"/>
                <p:cNvSpPr>
                  <a:spLocks/>
                </p:cNvSpPr>
                <p:nvPr/>
              </p:nvSpPr>
              <p:spPr>
                <a:xfrm rot="16200000" flipH="1">
                  <a:off x="6974891" y="1899706"/>
                  <a:ext cx="203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04" name="Pentagone 103"/>
                <p:cNvSpPr>
                  <a:spLocks/>
                </p:cNvSpPr>
                <p:nvPr/>
              </p:nvSpPr>
              <p:spPr>
                <a:xfrm rot="16200000" flipH="1">
                  <a:off x="6825677" y="2050965"/>
                  <a:ext cx="30045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05" name="Pentagone 104"/>
                <p:cNvSpPr>
                  <a:spLocks/>
                </p:cNvSpPr>
                <p:nvPr/>
              </p:nvSpPr>
              <p:spPr>
                <a:xfrm rot="16200000" flipH="1">
                  <a:off x="6948410" y="2228704"/>
                  <a:ext cx="5499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06" name="Pentagone 105"/>
                <p:cNvSpPr>
                  <a:spLocks/>
                </p:cNvSpPr>
                <p:nvPr/>
              </p:nvSpPr>
              <p:spPr>
                <a:xfrm rot="16200000" flipH="1">
                  <a:off x="6971226" y="2260896"/>
                  <a:ext cx="936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07" name="Pentagone 106"/>
                <p:cNvSpPr>
                  <a:spLocks/>
                </p:cNvSpPr>
                <p:nvPr/>
              </p:nvSpPr>
              <p:spPr>
                <a:xfrm rot="16200000" flipH="1">
                  <a:off x="6958781" y="2282716"/>
                  <a:ext cx="3425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08" name="Pentagone 107"/>
                <p:cNvSpPr>
                  <a:spLocks/>
                </p:cNvSpPr>
                <p:nvPr/>
              </p:nvSpPr>
              <p:spPr>
                <a:xfrm rot="5400000" flipH="1">
                  <a:off x="6962505" y="2313257"/>
                  <a:ext cx="2680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09" name="Pentagone 108"/>
                <p:cNvSpPr>
                  <a:spLocks/>
                </p:cNvSpPr>
                <p:nvPr/>
              </p:nvSpPr>
              <p:spPr>
                <a:xfrm rot="16200000" flipH="1">
                  <a:off x="6946444" y="2356135"/>
                  <a:ext cx="5892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0" name="Pentagone 109"/>
                <p:cNvSpPr>
                  <a:spLocks/>
                </p:cNvSpPr>
                <p:nvPr/>
              </p:nvSpPr>
              <p:spPr>
                <a:xfrm rot="5400000" flipH="1">
                  <a:off x="6966050" y="2395469"/>
                  <a:ext cx="1971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1" name="Pentagone 110"/>
                <p:cNvSpPr>
                  <a:spLocks/>
                </p:cNvSpPr>
                <p:nvPr/>
              </p:nvSpPr>
              <p:spPr>
                <a:xfrm rot="16200000" flipH="1">
                  <a:off x="6974721" y="2406525"/>
                  <a:ext cx="237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2" name="Pentagone 111"/>
                <p:cNvSpPr>
                  <a:spLocks/>
                </p:cNvSpPr>
                <p:nvPr/>
              </p:nvSpPr>
              <p:spPr>
                <a:xfrm rot="16200000" flipH="1">
                  <a:off x="6941461" y="2442170"/>
                  <a:ext cx="6889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3" name="Pentagone 112"/>
                <p:cNvSpPr>
                  <a:spLocks/>
                </p:cNvSpPr>
                <p:nvPr/>
              </p:nvSpPr>
              <p:spPr>
                <a:xfrm rot="16200000" flipH="1">
                  <a:off x="6878719" y="2573817"/>
                  <a:ext cx="19437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4" name="Pentagone 113"/>
                <p:cNvSpPr>
                  <a:spLocks/>
                </p:cNvSpPr>
                <p:nvPr/>
              </p:nvSpPr>
              <p:spPr>
                <a:xfrm rot="16200000" flipH="1">
                  <a:off x="6937706" y="2709218"/>
                  <a:ext cx="7640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5" name="Pentagone 114"/>
                <p:cNvSpPr>
                  <a:spLocks/>
                </p:cNvSpPr>
                <p:nvPr/>
              </p:nvSpPr>
              <p:spPr>
                <a:xfrm rot="5400000" flipH="1">
                  <a:off x="6824889" y="2898450"/>
                  <a:ext cx="30203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6" name="Pentagone 115"/>
                <p:cNvSpPr>
                  <a:spLocks/>
                </p:cNvSpPr>
                <p:nvPr/>
              </p:nvSpPr>
              <p:spPr>
                <a:xfrm rot="16200000" flipH="1">
                  <a:off x="6951106" y="3074282"/>
                  <a:ext cx="4960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7" name="Pentagone 116"/>
                <p:cNvSpPr>
                  <a:spLocks/>
                </p:cNvSpPr>
                <p:nvPr/>
              </p:nvSpPr>
              <p:spPr>
                <a:xfrm rot="16200000" flipH="1">
                  <a:off x="6939768" y="3135234"/>
                  <a:ext cx="7227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8" name="Pentagone 117"/>
                <p:cNvSpPr>
                  <a:spLocks/>
                </p:cNvSpPr>
                <p:nvPr/>
              </p:nvSpPr>
              <p:spPr>
                <a:xfrm rot="5400000" flipH="1">
                  <a:off x="6928012" y="3219280"/>
                  <a:ext cx="9578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19" name="Pentagone 118"/>
                <p:cNvSpPr>
                  <a:spLocks/>
                </p:cNvSpPr>
                <p:nvPr/>
              </p:nvSpPr>
              <p:spPr>
                <a:xfrm rot="16200000" flipH="1">
                  <a:off x="6950192" y="3292904"/>
                  <a:ext cx="5142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0" name="Pentagone 119"/>
                <p:cNvSpPr>
                  <a:spLocks/>
                </p:cNvSpPr>
                <p:nvPr/>
              </p:nvSpPr>
              <p:spPr>
                <a:xfrm rot="5400000" flipH="1">
                  <a:off x="6915781" y="3378758"/>
                  <a:ext cx="12025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1" name="Pentagone 120"/>
                <p:cNvSpPr>
                  <a:spLocks/>
                </p:cNvSpPr>
                <p:nvPr/>
              </p:nvSpPr>
              <p:spPr>
                <a:xfrm rot="5400000" flipH="1">
                  <a:off x="6907140" y="3507665"/>
                  <a:ext cx="13753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2" name="Pentagone 121"/>
                <p:cNvSpPr>
                  <a:spLocks/>
                </p:cNvSpPr>
                <p:nvPr/>
              </p:nvSpPr>
              <p:spPr>
                <a:xfrm rot="5400000" flipH="1">
                  <a:off x="6887339" y="3665013"/>
                  <a:ext cx="17713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3" name="Pentagone 122"/>
                <p:cNvSpPr>
                  <a:spLocks/>
                </p:cNvSpPr>
                <p:nvPr/>
              </p:nvSpPr>
              <p:spPr>
                <a:xfrm rot="16200000" flipH="1">
                  <a:off x="6951171" y="3778331"/>
                  <a:ext cx="4947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4" name="Pentagone 123"/>
                <p:cNvSpPr>
                  <a:spLocks/>
                </p:cNvSpPr>
                <p:nvPr/>
              </p:nvSpPr>
              <p:spPr>
                <a:xfrm rot="5400000" flipH="1">
                  <a:off x="6928050" y="3850936"/>
                  <a:ext cx="9571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5" name="Pentagone 124"/>
                <p:cNvSpPr>
                  <a:spLocks/>
                </p:cNvSpPr>
                <p:nvPr/>
              </p:nvSpPr>
              <p:spPr>
                <a:xfrm rot="5400000" flipH="1">
                  <a:off x="6926980" y="3947733"/>
                  <a:ext cx="9785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6" name="Pentagone 125"/>
                <p:cNvSpPr>
                  <a:spLocks/>
                </p:cNvSpPr>
                <p:nvPr/>
              </p:nvSpPr>
              <p:spPr>
                <a:xfrm rot="16200000" flipH="1">
                  <a:off x="6969988" y="4002592"/>
                  <a:ext cx="1183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7" name="Pentagone 126"/>
                <p:cNvSpPr>
                  <a:spLocks/>
                </p:cNvSpPr>
                <p:nvPr/>
              </p:nvSpPr>
              <p:spPr>
                <a:xfrm rot="16200000" flipH="1">
                  <a:off x="6868100" y="4116331"/>
                  <a:ext cx="21561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8" name="Pentagone 127"/>
                <p:cNvSpPr>
                  <a:spLocks/>
                </p:cNvSpPr>
                <p:nvPr/>
              </p:nvSpPr>
              <p:spPr>
                <a:xfrm rot="16200000" flipH="1">
                  <a:off x="6945702" y="4254355"/>
                  <a:ext cx="6040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29" name="Pentagone 128"/>
                <p:cNvSpPr>
                  <a:spLocks/>
                </p:cNvSpPr>
                <p:nvPr/>
              </p:nvSpPr>
              <p:spPr>
                <a:xfrm rot="16200000" flipH="1">
                  <a:off x="6940006" y="4320474"/>
                  <a:ext cx="7180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0" name="Pentagone 129"/>
                <p:cNvSpPr>
                  <a:spLocks/>
                </p:cNvSpPr>
                <p:nvPr/>
              </p:nvSpPr>
              <p:spPr>
                <a:xfrm rot="16200000" flipH="1">
                  <a:off x="6949858" y="4382437"/>
                  <a:ext cx="5209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1" name="Pentagone 130"/>
                <p:cNvSpPr>
                  <a:spLocks/>
                </p:cNvSpPr>
                <p:nvPr/>
              </p:nvSpPr>
              <p:spPr>
                <a:xfrm rot="16200000" flipH="1">
                  <a:off x="6942157" y="4442248"/>
                  <a:ext cx="6749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2" name="Pentagone 131"/>
                <p:cNvSpPr>
                  <a:spLocks/>
                </p:cNvSpPr>
                <p:nvPr/>
              </p:nvSpPr>
              <p:spPr>
                <a:xfrm rot="5400000" flipH="1">
                  <a:off x="6927950" y="4523967"/>
                  <a:ext cx="9591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3" name="Pentagone 132"/>
                <p:cNvSpPr>
                  <a:spLocks/>
                </p:cNvSpPr>
                <p:nvPr/>
              </p:nvSpPr>
              <p:spPr>
                <a:xfrm rot="16200000" flipH="1">
                  <a:off x="6975009" y="4572835"/>
                  <a:ext cx="179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4" name="Pentagone 133"/>
                <p:cNvSpPr>
                  <a:spLocks/>
                </p:cNvSpPr>
                <p:nvPr/>
              </p:nvSpPr>
              <p:spPr>
                <a:xfrm rot="16200000" flipH="1">
                  <a:off x="6948133" y="4601521"/>
                  <a:ext cx="5554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5" name="Pentagone 134"/>
                <p:cNvSpPr>
                  <a:spLocks/>
                </p:cNvSpPr>
                <p:nvPr/>
              </p:nvSpPr>
              <p:spPr>
                <a:xfrm rot="16200000" flipH="1">
                  <a:off x="6972132" y="4633083"/>
                  <a:ext cx="754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6" name="Pentagone 135"/>
                <p:cNvSpPr>
                  <a:spLocks/>
                </p:cNvSpPr>
                <p:nvPr/>
              </p:nvSpPr>
              <p:spPr>
                <a:xfrm rot="16200000" flipH="1">
                  <a:off x="6943341" y="4669437"/>
                  <a:ext cx="6513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7" name="Pentagone 136"/>
                <p:cNvSpPr>
                  <a:spLocks/>
                </p:cNvSpPr>
                <p:nvPr/>
              </p:nvSpPr>
              <p:spPr>
                <a:xfrm rot="16200000" flipH="1">
                  <a:off x="6872821" y="4805102"/>
                  <a:ext cx="20617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8" name="Pentagone 137"/>
                <p:cNvSpPr>
                  <a:spLocks/>
                </p:cNvSpPr>
                <p:nvPr/>
              </p:nvSpPr>
              <p:spPr>
                <a:xfrm rot="5400000" flipH="1">
                  <a:off x="6958782" y="4925325"/>
                  <a:ext cx="3424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39" name="Pentagone 138"/>
                <p:cNvSpPr>
                  <a:spLocks/>
                </p:cNvSpPr>
                <p:nvPr/>
              </p:nvSpPr>
              <p:spPr>
                <a:xfrm rot="5400000" flipH="1">
                  <a:off x="6927744" y="4990626"/>
                  <a:ext cx="9632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40" name="Pentagone 139"/>
                <p:cNvSpPr>
                  <a:spLocks/>
                </p:cNvSpPr>
                <p:nvPr/>
              </p:nvSpPr>
              <p:spPr>
                <a:xfrm rot="16200000" flipH="1">
                  <a:off x="6433666" y="5581044"/>
                  <a:ext cx="108448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grpSp>
            <p:nvGrpSpPr>
              <p:cNvPr id="36" name="Groupe 35"/>
              <p:cNvGrpSpPr/>
              <p:nvPr/>
            </p:nvGrpSpPr>
            <p:grpSpPr>
              <a:xfrm>
                <a:off x="6818007" y="1070151"/>
                <a:ext cx="132328" cy="4500045"/>
                <a:chOff x="7686196" y="317039"/>
                <a:chExt cx="157843" cy="5367710"/>
              </a:xfrm>
            </p:grpSpPr>
            <p:sp>
              <p:nvSpPr>
                <p:cNvPr id="71" name="Pentagone 70"/>
                <p:cNvSpPr>
                  <a:spLocks/>
                </p:cNvSpPr>
                <p:nvPr/>
              </p:nvSpPr>
              <p:spPr>
                <a:xfrm rot="16200000" flipH="1">
                  <a:off x="7722984" y="280252"/>
                  <a:ext cx="8426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72" name="Pentagone 71"/>
                <p:cNvSpPr>
                  <a:spLocks/>
                </p:cNvSpPr>
                <p:nvPr/>
              </p:nvSpPr>
              <p:spPr>
                <a:xfrm rot="5400000" flipH="1">
                  <a:off x="7711776" y="375743"/>
                  <a:ext cx="10668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73" name="Pentagone 72"/>
                <p:cNvSpPr>
                  <a:spLocks/>
                </p:cNvSpPr>
                <p:nvPr/>
              </p:nvSpPr>
              <p:spPr>
                <a:xfrm rot="5400000" flipH="1">
                  <a:off x="7715896" y="478321"/>
                  <a:ext cx="9844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74" name="Pentagone 73"/>
                <p:cNvSpPr>
                  <a:spLocks/>
                </p:cNvSpPr>
                <p:nvPr/>
              </p:nvSpPr>
              <p:spPr>
                <a:xfrm rot="16200000" flipH="1">
                  <a:off x="7758507" y="534168"/>
                  <a:ext cx="1322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75" name="Pentagone 74"/>
                <p:cNvSpPr>
                  <a:spLocks/>
                </p:cNvSpPr>
                <p:nvPr/>
              </p:nvSpPr>
              <p:spPr>
                <a:xfrm rot="16200000" flipH="1">
                  <a:off x="7752891" y="553020"/>
                  <a:ext cx="2445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76" name="Pentagone 75"/>
                <p:cNvSpPr>
                  <a:spLocks/>
                </p:cNvSpPr>
                <p:nvPr/>
              </p:nvSpPr>
              <p:spPr>
                <a:xfrm rot="16200000" flipH="1">
                  <a:off x="7764611" y="565769"/>
                  <a:ext cx="101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77" name="Pentagone 76"/>
                <p:cNvSpPr>
                  <a:spLocks/>
                </p:cNvSpPr>
                <p:nvPr/>
              </p:nvSpPr>
              <p:spPr>
                <a:xfrm rot="5400000" flipH="1">
                  <a:off x="7709224" y="622184"/>
                  <a:ext cx="11178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78" name="Pentagone 77"/>
                <p:cNvSpPr>
                  <a:spLocks/>
                </p:cNvSpPr>
                <p:nvPr/>
              </p:nvSpPr>
              <p:spPr>
                <a:xfrm rot="16200000" flipH="1">
                  <a:off x="7716103" y="727107"/>
                  <a:ext cx="9803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79" name="Pentagone 78"/>
                <p:cNvSpPr>
                  <a:spLocks/>
                </p:cNvSpPr>
                <p:nvPr/>
              </p:nvSpPr>
              <p:spPr>
                <a:xfrm rot="5400000" flipH="1">
                  <a:off x="7739458" y="801796"/>
                  <a:ext cx="5131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0" name="Pentagone 79"/>
                <p:cNvSpPr>
                  <a:spLocks/>
                </p:cNvSpPr>
                <p:nvPr/>
              </p:nvSpPr>
              <p:spPr>
                <a:xfrm rot="16200000" flipH="1">
                  <a:off x="7759870" y="832718"/>
                  <a:ext cx="1049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1" name="Pentagone 80"/>
                <p:cNvSpPr>
                  <a:spLocks/>
                </p:cNvSpPr>
                <p:nvPr/>
              </p:nvSpPr>
              <p:spPr>
                <a:xfrm rot="16200000" flipH="1">
                  <a:off x="7668404" y="934694"/>
                  <a:ext cx="19342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2" name="Pentagone 81"/>
                <p:cNvSpPr>
                  <a:spLocks/>
                </p:cNvSpPr>
                <p:nvPr/>
              </p:nvSpPr>
              <p:spPr>
                <a:xfrm rot="5400000" flipH="1">
                  <a:off x="7697020" y="1099521"/>
                  <a:ext cx="13619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3" name="Pentagone 82"/>
                <p:cNvSpPr>
                  <a:spLocks/>
                </p:cNvSpPr>
                <p:nvPr/>
              </p:nvSpPr>
              <p:spPr>
                <a:xfrm rot="16200000" flipH="1">
                  <a:off x="7713684" y="1219067"/>
                  <a:ext cx="10286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4" name="Pentagone 83"/>
                <p:cNvSpPr>
                  <a:spLocks/>
                </p:cNvSpPr>
                <p:nvPr/>
              </p:nvSpPr>
              <p:spPr>
                <a:xfrm rot="16200000" flipH="1">
                  <a:off x="7704976" y="1330656"/>
                  <a:ext cx="12028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5" name="Pentagone 84"/>
                <p:cNvSpPr>
                  <a:spLocks/>
                </p:cNvSpPr>
                <p:nvPr/>
              </p:nvSpPr>
              <p:spPr>
                <a:xfrm rot="5400000" flipH="1">
                  <a:off x="7653601" y="1502328"/>
                  <a:ext cx="22303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6" name="Pentagone 85"/>
                <p:cNvSpPr>
                  <a:spLocks/>
                </p:cNvSpPr>
                <p:nvPr/>
              </p:nvSpPr>
              <p:spPr>
                <a:xfrm rot="5400000" flipH="1">
                  <a:off x="7595841" y="1783136"/>
                  <a:ext cx="33855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7" name="Pentagone 86"/>
                <p:cNvSpPr>
                  <a:spLocks/>
                </p:cNvSpPr>
                <p:nvPr/>
              </p:nvSpPr>
              <p:spPr>
                <a:xfrm rot="5400000" flipH="1">
                  <a:off x="7686249" y="2031296"/>
                  <a:ext cx="15773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8" name="Pentagone 87"/>
                <p:cNvSpPr>
                  <a:spLocks/>
                </p:cNvSpPr>
                <p:nvPr/>
              </p:nvSpPr>
              <p:spPr>
                <a:xfrm rot="5400000" flipH="1">
                  <a:off x="7678905" y="2196392"/>
                  <a:ext cx="17242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89" name="Pentagone 88"/>
                <p:cNvSpPr>
                  <a:spLocks/>
                </p:cNvSpPr>
                <p:nvPr/>
              </p:nvSpPr>
              <p:spPr>
                <a:xfrm rot="16200000" flipH="1">
                  <a:off x="7637011" y="2410725"/>
                  <a:ext cx="25621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0" name="Pentagone 89"/>
                <p:cNvSpPr>
                  <a:spLocks/>
                </p:cNvSpPr>
                <p:nvPr/>
              </p:nvSpPr>
              <p:spPr>
                <a:xfrm rot="16200000" flipH="1">
                  <a:off x="7753675" y="2550289"/>
                  <a:ext cx="2288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1" name="Pentagone 90"/>
                <p:cNvSpPr>
                  <a:spLocks/>
                </p:cNvSpPr>
                <p:nvPr/>
              </p:nvSpPr>
              <p:spPr>
                <a:xfrm rot="5400000" flipH="1">
                  <a:off x="7688892" y="2637971"/>
                  <a:ext cx="15245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2" name="Pentagone 91"/>
                <p:cNvSpPr>
                  <a:spLocks/>
                </p:cNvSpPr>
                <p:nvPr/>
              </p:nvSpPr>
              <p:spPr>
                <a:xfrm rot="5400000" flipH="1">
                  <a:off x="7711814" y="2767515"/>
                  <a:ext cx="10660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3" name="Pentagone 92"/>
                <p:cNvSpPr>
                  <a:spLocks/>
                </p:cNvSpPr>
                <p:nvPr/>
              </p:nvSpPr>
              <p:spPr>
                <a:xfrm rot="16200000" flipH="1">
                  <a:off x="7752870" y="2833081"/>
                  <a:ext cx="2449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4" name="Pentagone 93"/>
                <p:cNvSpPr>
                  <a:spLocks/>
                </p:cNvSpPr>
                <p:nvPr/>
              </p:nvSpPr>
              <p:spPr>
                <a:xfrm rot="16200000" flipH="1">
                  <a:off x="7737158" y="2873303"/>
                  <a:ext cx="55920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5" name="Pentagone 94"/>
                <p:cNvSpPr>
                  <a:spLocks/>
                </p:cNvSpPr>
                <p:nvPr/>
              </p:nvSpPr>
              <p:spPr>
                <a:xfrm rot="5400000" flipH="1">
                  <a:off x="7731429" y="2934967"/>
                  <a:ext cx="6737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6" name="Pentagone 95"/>
                <p:cNvSpPr>
                  <a:spLocks/>
                </p:cNvSpPr>
                <p:nvPr/>
              </p:nvSpPr>
              <p:spPr>
                <a:xfrm rot="16200000" flipH="1">
                  <a:off x="7719229" y="3014559"/>
                  <a:ext cx="91777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7" name="Pentagone 96"/>
                <p:cNvSpPr>
                  <a:spLocks/>
                </p:cNvSpPr>
                <p:nvPr/>
              </p:nvSpPr>
              <p:spPr>
                <a:xfrm rot="16200000" flipH="1">
                  <a:off x="7710299" y="3115281"/>
                  <a:ext cx="10963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8" name="Pentagone 97"/>
                <p:cNvSpPr>
                  <a:spLocks/>
                </p:cNvSpPr>
                <p:nvPr/>
              </p:nvSpPr>
              <p:spPr>
                <a:xfrm rot="16200000" flipH="1">
                  <a:off x="7751536" y="3183697"/>
                  <a:ext cx="2716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99" name="Pentagone 98"/>
                <p:cNvSpPr>
                  <a:spLocks/>
                </p:cNvSpPr>
                <p:nvPr/>
              </p:nvSpPr>
              <p:spPr>
                <a:xfrm rot="16200000" flipH="1">
                  <a:off x="7727313" y="3235097"/>
                  <a:ext cx="7560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00" name="Pentagone 99"/>
                <p:cNvSpPr>
                  <a:spLocks/>
                </p:cNvSpPr>
                <p:nvPr/>
              </p:nvSpPr>
              <p:spPr>
                <a:xfrm rot="16200000" flipH="1">
                  <a:off x="7764700" y="3273334"/>
                  <a:ext cx="835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101" name="Pentagone 100"/>
                <p:cNvSpPr>
                  <a:spLocks/>
                </p:cNvSpPr>
                <p:nvPr/>
              </p:nvSpPr>
              <p:spPr>
                <a:xfrm rot="5400000" flipH="1">
                  <a:off x="6599086" y="4439797"/>
                  <a:ext cx="233206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grpSp>
            <p:nvGrpSpPr>
              <p:cNvPr id="37" name="Groupe 36"/>
              <p:cNvGrpSpPr/>
              <p:nvPr/>
            </p:nvGrpSpPr>
            <p:grpSpPr>
              <a:xfrm>
                <a:off x="7479647" y="1070151"/>
                <a:ext cx="132328" cy="3338990"/>
                <a:chOff x="8475408" y="317039"/>
                <a:chExt cx="157843" cy="3982790"/>
              </a:xfrm>
            </p:grpSpPr>
            <p:sp>
              <p:nvSpPr>
                <p:cNvPr id="55" name="Pentagone 54"/>
                <p:cNvSpPr>
                  <a:spLocks/>
                </p:cNvSpPr>
                <p:nvPr/>
              </p:nvSpPr>
              <p:spPr>
                <a:xfrm rot="5400000" flipH="1">
                  <a:off x="7696408" y="1096040"/>
                  <a:ext cx="171584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56" name="Pentagone 55"/>
                <p:cNvSpPr>
                  <a:spLocks/>
                </p:cNvSpPr>
                <p:nvPr/>
              </p:nvSpPr>
              <p:spPr>
                <a:xfrm rot="16200000" flipH="1">
                  <a:off x="8552147" y="1956158"/>
                  <a:ext cx="436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57" name="Pentagone 56"/>
                <p:cNvSpPr>
                  <a:spLocks/>
                </p:cNvSpPr>
                <p:nvPr/>
              </p:nvSpPr>
              <p:spPr>
                <a:xfrm rot="16200000" flipH="1">
                  <a:off x="8551873" y="1960812"/>
                  <a:ext cx="491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58" name="Pentagone 57"/>
                <p:cNvSpPr>
                  <a:spLocks/>
                </p:cNvSpPr>
                <p:nvPr/>
              </p:nvSpPr>
              <p:spPr>
                <a:xfrm rot="16200000" flipH="1">
                  <a:off x="8552967" y="1964646"/>
                  <a:ext cx="2724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59" name="Pentagone 58"/>
                <p:cNvSpPr>
                  <a:spLocks/>
                </p:cNvSpPr>
                <p:nvPr/>
              </p:nvSpPr>
              <p:spPr>
                <a:xfrm rot="5400000" flipH="1">
                  <a:off x="8484369" y="2035983"/>
                  <a:ext cx="13992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0" name="Pentagone 59"/>
                <p:cNvSpPr>
                  <a:spLocks/>
                </p:cNvSpPr>
                <p:nvPr/>
              </p:nvSpPr>
              <p:spPr>
                <a:xfrm rot="16200000" flipH="1">
                  <a:off x="8495684" y="2164604"/>
                  <a:ext cx="11729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1" name="Pentagone 60"/>
                <p:cNvSpPr>
                  <a:spLocks/>
                </p:cNvSpPr>
                <p:nvPr/>
              </p:nvSpPr>
              <p:spPr>
                <a:xfrm rot="16200000" flipH="1">
                  <a:off x="8513005" y="2264588"/>
                  <a:ext cx="8264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2" name="Pentagone 61"/>
                <p:cNvSpPr>
                  <a:spLocks/>
                </p:cNvSpPr>
                <p:nvPr/>
              </p:nvSpPr>
              <p:spPr>
                <a:xfrm rot="5400000" flipH="1">
                  <a:off x="8308545" y="2551711"/>
                  <a:ext cx="491569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3" name="Pentagone 62"/>
                <p:cNvSpPr>
                  <a:spLocks/>
                </p:cNvSpPr>
                <p:nvPr/>
              </p:nvSpPr>
              <p:spPr>
                <a:xfrm rot="5400000" flipH="1">
                  <a:off x="8506545" y="2845294"/>
                  <a:ext cx="9556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4" name="Pentagone 63"/>
                <p:cNvSpPr>
                  <a:spLocks/>
                </p:cNvSpPr>
                <p:nvPr/>
              </p:nvSpPr>
              <p:spPr>
                <a:xfrm rot="16200000" flipH="1">
                  <a:off x="8473321" y="2974101"/>
                  <a:ext cx="16201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5" name="Pentagone 64"/>
                <p:cNvSpPr>
                  <a:spLocks/>
                </p:cNvSpPr>
                <p:nvPr/>
              </p:nvSpPr>
              <p:spPr>
                <a:xfrm rot="16200000" flipH="1">
                  <a:off x="8553214" y="3056238"/>
                  <a:ext cx="2231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6" name="Pentagone 65"/>
                <p:cNvSpPr>
                  <a:spLocks/>
                </p:cNvSpPr>
                <p:nvPr/>
              </p:nvSpPr>
              <p:spPr>
                <a:xfrm rot="16200000" flipH="1">
                  <a:off x="8538848" y="3072850"/>
                  <a:ext cx="3096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7" name="Pentagone 66"/>
                <p:cNvSpPr>
                  <a:spLocks/>
                </p:cNvSpPr>
                <p:nvPr/>
              </p:nvSpPr>
              <p:spPr>
                <a:xfrm rot="16200000" flipH="1">
                  <a:off x="8550890" y="3091785"/>
                  <a:ext cx="6878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8" name="Pentagone 67"/>
                <p:cNvSpPr>
                  <a:spLocks/>
                </p:cNvSpPr>
                <p:nvPr/>
              </p:nvSpPr>
              <p:spPr>
                <a:xfrm rot="16200000" flipH="1">
                  <a:off x="8551933" y="3097635"/>
                  <a:ext cx="4793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69" name="Pentagone 68"/>
                <p:cNvSpPr>
                  <a:spLocks/>
                </p:cNvSpPr>
                <p:nvPr/>
              </p:nvSpPr>
              <p:spPr>
                <a:xfrm rot="16200000" flipH="1">
                  <a:off x="8548693" y="3105682"/>
                  <a:ext cx="11272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FFFFFF" mc:Ignorable="a14" a14:legacySpreadsheetColorIndex="1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  <p:sp>
              <p:nvSpPr>
                <p:cNvPr id="70" name="Pentagone 69"/>
                <p:cNvSpPr>
                  <a:spLocks/>
                </p:cNvSpPr>
                <p:nvPr/>
              </p:nvSpPr>
              <p:spPr>
                <a:xfrm rot="5400000" flipH="1">
                  <a:off x="7999541" y="3666120"/>
                  <a:ext cx="1109576" cy="157842"/>
                </a:xfrm>
                <a:prstGeom prst="homePlate">
                  <a:avLst/>
                </a:prstGeom>
                <a:solidFill>
                  <a:srgbClr xmlns:mc="http://schemas.openxmlformats.org/markup-compatibility/2006" xmlns:a14="http://schemas.microsoft.com/office/drawing/2010/main" val="000000" mc:Ignorable="a14" a14:legacySpreadsheetColorIndex="8"/>
                </a:solidFill>
                <a:ln w="6350" cap="flat" cmpd="sng" algn="ctr">
                  <a:solidFill>
                    <a:schemeClr val="bg1">
                      <a:lumMod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lang="fr-FR" sz="1100"/>
                </a:p>
              </p:txBody>
            </p:sp>
          </p:grpSp>
          <p:sp>
            <p:nvSpPr>
              <p:cNvPr id="38" name="ZoneTexte 173"/>
              <p:cNvSpPr txBox="1"/>
              <p:nvPr/>
            </p:nvSpPr>
            <p:spPr>
              <a:xfrm flipH="1">
                <a:off x="5859937" y="764704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/>
                  <a:t>09</a:t>
                </a:r>
              </a:p>
            </p:txBody>
          </p:sp>
          <p:sp>
            <p:nvSpPr>
              <p:cNvPr id="39" name="ZoneTexte 175"/>
              <p:cNvSpPr txBox="1"/>
              <p:nvPr/>
            </p:nvSpPr>
            <p:spPr>
              <a:xfrm flipH="1">
                <a:off x="6521576" y="764704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 dirty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 dirty="0"/>
                  <a:t>10</a:t>
                </a:r>
              </a:p>
            </p:txBody>
          </p:sp>
          <p:sp>
            <p:nvSpPr>
              <p:cNvPr id="40" name="ZoneTexte 177"/>
              <p:cNvSpPr txBox="1"/>
              <p:nvPr/>
            </p:nvSpPr>
            <p:spPr>
              <a:xfrm flipH="1">
                <a:off x="7183215" y="764704"/>
                <a:ext cx="736198" cy="375044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vert="horz"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b="1" i="0" u="none" strike="noStrike" baseline="0" dirty="0">
                    <a:solidFill>
                      <a:srgbClr val="000000"/>
                    </a:solidFill>
                  </a:rPr>
                  <a:t>chr</a:t>
                </a:r>
                <a:r>
                  <a:rPr lang="fr-FR" sz="1200" b="1" dirty="0"/>
                  <a:t>11</a:t>
                </a:r>
              </a:p>
            </p:txBody>
          </p:sp>
          <p:sp>
            <p:nvSpPr>
              <p:cNvPr id="41" name="Freeform 70"/>
              <p:cNvSpPr>
                <a:spLocks/>
              </p:cNvSpPr>
              <p:nvPr/>
            </p:nvSpPr>
            <p:spPr bwMode="auto">
              <a:xfrm rot="5400000" flipV="1">
                <a:off x="2607950" y="3066713"/>
                <a:ext cx="4185289" cy="190317"/>
              </a:xfrm>
              <a:custGeom>
                <a:avLst/>
                <a:gdLst>
                  <a:gd name="T0" fmla="*/ 156 w 5410"/>
                  <a:gd name="T1" fmla="*/ 152 h 286"/>
                  <a:gd name="T2" fmla="*/ 325 w 5410"/>
                  <a:gd name="T3" fmla="*/ 119 h 286"/>
                  <a:gd name="T4" fmla="*/ 496 w 5410"/>
                  <a:gd name="T5" fmla="*/ 60 h 286"/>
                  <a:gd name="T6" fmla="*/ 665 w 5410"/>
                  <a:gd name="T7" fmla="*/ 136 h 286"/>
                  <a:gd name="T8" fmla="*/ 836 w 5410"/>
                  <a:gd name="T9" fmla="*/ 204 h 286"/>
                  <a:gd name="T10" fmla="*/ 1005 w 5410"/>
                  <a:gd name="T11" fmla="*/ 35 h 286"/>
                  <a:gd name="T12" fmla="*/ 1176 w 5410"/>
                  <a:gd name="T13" fmla="*/ 92 h 286"/>
                  <a:gd name="T14" fmla="*/ 1345 w 5410"/>
                  <a:gd name="T15" fmla="*/ 98 h 286"/>
                  <a:gd name="T16" fmla="*/ 1515 w 5410"/>
                  <a:gd name="T17" fmla="*/ 173 h 286"/>
                  <a:gd name="T18" fmla="*/ 1684 w 5410"/>
                  <a:gd name="T19" fmla="*/ 267 h 286"/>
                  <a:gd name="T20" fmla="*/ 1855 w 5410"/>
                  <a:gd name="T21" fmla="*/ 152 h 286"/>
                  <a:gd name="T22" fmla="*/ 2026 w 5410"/>
                  <a:gd name="T23" fmla="*/ 246 h 286"/>
                  <a:gd name="T24" fmla="*/ 2195 w 5410"/>
                  <a:gd name="T25" fmla="*/ 246 h 286"/>
                  <a:gd name="T26" fmla="*/ 2366 w 5410"/>
                  <a:gd name="T27" fmla="*/ 225 h 286"/>
                  <a:gd name="T28" fmla="*/ 2535 w 5410"/>
                  <a:gd name="T29" fmla="*/ 286 h 286"/>
                  <a:gd name="T30" fmla="*/ 2706 w 5410"/>
                  <a:gd name="T31" fmla="*/ 177 h 286"/>
                  <a:gd name="T32" fmla="*/ 2875 w 5410"/>
                  <a:gd name="T33" fmla="*/ 286 h 286"/>
                  <a:gd name="T34" fmla="*/ 3046 w 5410"/>
                  <a:gd name="T35" fmla="*/ 286 h 286"/>
                  <a:gd name="T36" fmla="*/ 3215 w 5410"/>
                  <a:gd name="T37" fmla="*/ 281 h 286"/>
                  <a:gd name="T38" fmla="*/ 3386 w 5410"/>
                  <a:gd name="T39" fmla="*/ 217 h 286"/>
                  <a:gd name="T40" fmla="*/ 3555 w 5410"/>
                  <a:gd name="T41" fmla="*/ 286 h 286"/>
                  <a:gd name="T42" fmla="*/ 3726 w 5410"/>
                  <a:gd name="T43" fmla="*/ 271 h 286"/>
                  <a:gd name="T44" fmla="*/ 3895 w 5410"/>
                  <a:gd name="T45" fmla="*/ 286 h 286"/>
                  <a:gd name="T46" fmla="*/ 4065 w 5410"/>
                  <a:gd name="T47" fmla="*/ 246 h 286"/>
                  <a:gd name="T48" fmla="*/ 4234 w 5410"/>
                  <a:gd name="T49" fmla="*/ 111 h 286"/>
                  <a:gd name="T50" fmla="*/ 4405 w 5410"/>
                  <a:gd name="T51" fmla="*/ 188 h 286"/>
                  <a:gd name="T52" fmla="*/ 4574 w 5410"/>
                  <a:gd name="T53" fmla="*/ 133 h 286"/>
                  <a:gd name="T54" fmla="*/ 4745 w 5410"/>
                  <a:gd name="T55" fmla="*/ 98 h 286"/>
                  <a:gd name="T56" fmla="*/ 4914 w 5410"/>
                  <a:gd name="T57" fmla="*/ 90 h 286"/>
                  <a:gd name="T58" fmla="*/ 5085 w 5410"/>
                  <a:gd name="T59" fmla="*/ 90 h 286"/>
                  <a:gd name="T60" fmla="*/ 5254 w 5410"/>
                  <a:gd name="T61" fmla="*/ 146 h 286"/>
                  <a:gd name="T62" fmla="*/ 5410 w 5410"/>
                  <a:gd name="T63" fmla="*/ 286 h 286"/>
                  <a:gd name="T64" fmla="*/ 5239 w 5410"/>
                  <a:gd name="T65" fmla="*/ 286 h 286"/>
                  <a:gd name="T66" fmla="*/ 5070 w 5410"/>
                  <a:gd name="T67" fmla="*/ 286 h 286"/>
                  <a:gd name="T68" fmla="*/ 4899 w 5410"/>
                  <a:gd name="T69" fmla="*/ 286 h 286"/>
                  <a:gd name="T70" fmla="*/ 4730 w 5410"/>
                  <a:gd name="T71" fmla="*/ 286 h 286"/>
                  <a:gd name="T72" fmla="*/ 4559 w 5410"/>
                  <a:gd name="T73" fmla="*/ 286 h 286"/>
                  <a:gd name="T74" fmla="*/ 4390 w 5410"/>
                  <a:gd name="T75" fmla="*/ 286 h 286"/>
                  <a:gd name="T76" fmla="*/ 4219 w 5410"/>
                  <a:gd name="T77" fmla="*/ 286 h 286"/>
                  <a:gd name="T78" fmla="*/ 4050 w 5410"/>
                  <a:gd name="T79" fmla="*/ 286 h 286"/>
                  <a:gd name="T80" fmla="*/ 3879 w 5410"/>
                  <a:gd name="T81" fmla="*/ 286 h 286"/>
                  <a:gd name="T82" fmla="*/ 3710 w 5410"/>
                  <a:gd name="T83" fmla="*/ 286 h 286"/>
                  <a:gd name="T84" fmla="*/ 3539 w 5410"/>
                  <a:gd name="T85" fmla="*/ 286 h 286"/>
                  <a:gd name="T86" fmla="*/ 3370 w 5410"/>
                  <a:gd name="T87" fmla="*/ 286 h 286"/>
                  <a:gd name="T88" fmla="*/ 3199 w 5410"/>
                  <a:gd name="T89" fmla="*/ 286 h 286"/>
                  <a:gd name="T90" fmla="*/ 3030 w 5410"/>
                  <a:gd name="T91" fmla="*/ 286 h 286"/>
                  <a:gd name="T92" fmla="*/ 2860 w 5410"/>
                  <a:gd name="T93" fmla="*/ 286 h 286"/>
                  <a:gd name="T94" fmla="*/ 2691 w 5410"/>
                  <a:gd name="T95" fmla="*/ 286 h 286"/>
                  <a:gd name="T96" fmla="*/ 2520 w 5410"/>
                  <a:gd name="T97" fmla="*/ 286 h 286"/>
                  <a:gd name="T98" fmla="*/ 2351 w 5410"/>
                  <a:gd name="T99" fmla="*/ 286 h 286"/>
                  <a:gd name="T100" fmla="*/ 2180 w 5410"/>
                  <a:gd name="T101" fmla="*/ 286 h 286"/>
                  <a:gd name="T102" fmla="*/ 2009 w 5410"/>
                  <a:gd name="T103" fmla="*/ 286 h 286"/>
                  <a:gd name="T104" fmla="*/ 1840 w 5410"/>
                  <a:gd name="T105" fmla="*/ 286 h 286"/>
                  <a:gd name="T106" fmla="*/ 1669 w 5410"/>
                  <a:gd name="T107" fmla="*/ 286 h 286"/>
                  <a:gd name="T108" fmla="*/ 1500 w 5410"/>
                  <a:gd name="T109" fmla="*/ 286 h 286"/>
                  <a:gd name="T110" fmla="*/ 1329 w 5410"/>
                  <a:gd name="T111" fmla="*/ 286 h 286"/>
                  <a:gd name="T112" fmla="*/ 1160 w 5410"/>
                  <a:gd name="T113" fmla="*/ 286 h 286"/>
                  <a:gd name="T114" fmla="*/ 989 w 5410"/>
                  <a:gd name="T115" fmla="*/ 286 h 286"/>
                  <a:gd name="T116" fmla="*/ 820 w 5410"/>
                  <a:gd name="T117" fmla="*/ 286 h 286"/>
                  <a:gd name="T118" fmla="*/ 649 w 5410"/>
                  <a:gd name="T119" fmla="*/ 286 h 286"/>
                  <a:gd name="T120" fmla="*/ 481 w 5410"/>
                  <a:gd name="T121" fmla="*/ 286 h 286"/>
                  <a:gd name="T122" fmla="*/ 310 w 5410"/>
                  <a:gd name="T123" fmla="*/ 286 h 286"/>
                  <a:gd name="T124" fmla="*/ 141 w 5410"/>
                  <a:gd name="T125" fmla="*/ 286 h 2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5410" h="286">
                    <a:moveTo>
                      <a:pt x="0" y="236"/>
                    </a:moveTo>
                    <a:lnTo>
                      <a:pt x="16" y="96"/>
                    </a:lnTo>
                    <a:lnTo>
                      <a:pt x="31" y="42"/>
                    </a:lnTo>
                    <a:lnTo>
                      <a:pt x="47" y="127"/>
                    </a:lnTo>
                    <a:lnTo>
                      <a:pt x="62" y="87"/>
                    </a:lnTo>
                    <a:lnTo>
                      <a:pt x="79" y="140"/>
                    </a:lnTo>
                    <a:lnTo>
                      <a:pt x="95" y="156"/>
                    </a:lnTo>
                    <a:lnTo>
                      <a:pt x="110" y="69"/>
                    </a:lnTo>
                    <a:lnTo>
                      <a:pt x="125" y="87"/>
                    </a:lnTo>
                    <a:lnTo>
                      <a:pt x="141" y="100"/>
                    </a:lnTo>
                    <a:lnTo>
                      <a:pt x="156" y="152"/>
                    </a:lnTo>
                    <a:lnTo>
                      <a:pt x="171" y="169"/>
                    </a:lnTo>
                    <a:lnTo>
                      <a:pt x="187" y="65"/>
                    </a:lnTo>
                    <a:lnTo>
                      <a:pt x="202" y="85"/>
                    </a:lnTo>
                    <a:lnTo>
                      <a:pt x="217" y="154"/>
                    </a:lnTo>
                    <a:lnTo>
                      <a:pt x="233" y="48"/>
                    </a:lnTo>
                    <a:lnTo>
                      <a:pt x="248" y="110"/>
                    </a:lnTo>
                    <a:lnTo>
                      <a:pt x="264" y="111"/>
                    </a:lnTo>
                    <a:lnTo>
                      <a:pt x="279" y="133"/>
                    </a:lnTo>
                    <a:lnTo>
                      <a:pt x="294" y="115"/>
                    </a:lnTo>
                    <a:lnTo>
                      <a:pt x="310" y="131"/>
                    </a:lnTo>
                    <a:lnTo>
                      <a:pt x="325" y="119"/>
                    </a:lnTo>
                    <a:lnTo>
                      <a:pt x="340" y="83"/>
                    </a:lnTo>
                    <a:lnTo>
                      <a:pt x="356" y="73"/>
                    </a:lnTo>
                    <a:lnTo>
                      <a:pt x="371" y="133"/>
                    </a:lnTo>
                    <a:lnTo>
                      <a:pt x="386" y="140"/>
                    </a:lnTo>
                    <a:lnTo>
                      <a:pt x="404" y="87"/>
                    </a:lnTo>
                    <a:lnTo>
                      <a:pt x="419" y="119"/>
                    </a:lnTo>
                    <a:lnTo>
                      <a:pt x="434" y="77"/>
                    </a:lnTo>
                    <a:lnTo>
                      <a:pt x="450" y="94"/>
                    </a:lnTo>
                    <a:lnTo>
                      <a:pt x="465" y="25"/>
                    </a:lnTo>
                    <a:lnTo>
                      <a:pt x="481" y="108"/>
                    </a:lnTo>
                    <a:lnTo>
                      <a:pt x="496" y="60"/>
                    </a:lnTo>
                    <a:lnTo>
                      <a:pt x="511" y="37"/>
                    </a:lnTo>
                    <a:lnTo>
                      <a:pt x="527" y="69"/>
                    </a:lnTo>
                    <a:lnTo>
                      <a:pt x="542" y="69"/>
                    </a:lnTo>
                    <a:lnTo>
                      <a:pt x="557" y="87"/>
                    </a:lnTo>
                    <a:lnTo>
                      <a:pt x="573" y="111"/>
                    </a:lnTo>
                    <a:lnTo>
                      <a:pt x="588" y="161"/>
                    </a:lnTo>
                    <a:lnTo>
                      <a:pt x="603" y="135"/>
                    </a:lnTo>
                    <a:lnTo>
                      <a:pt x="619" y="110"/>
                    </a:lnTo>
                    <a:lnTo>
                      <a:pt x="634" y="133"/>
                    </a:lnTo>
                    <a:lnTo>
                      <a:pt x="649" y="81"/>
                    </a:lnTo>
                    <a:lnTo>
                      <a:pt x="665" y="136"/>
                    </a:lnTo>
                    <a:lnTo>
                      <a:pt x="680" y="46"/>
                    </a:lnTo>
                    <a:lnTo>
                      <a:pt x="696" y="62"/>
                    </a:lnTo>
                    <a:lnTo>
                      <a:pt x="711" y="121"/>
                    </a:lnTo>
                    <a:lnTo>
                      <a:pt x="728" y="83"/>
                    </a:lnTo>
                    <a:lnTo>
                      <a:pt x="744" y="102"/>
                    </a:lnTo>
                    <a:lnTo>
                      <a:pt x="759" y="67"/>
                    </a:lnTo>
                    <a:lnTo>
                      <a:pt x="774" y="177"/>
                    </a:lnTo>
                    <a:lnTo>
                      <a:pt x="790" y="69"/>
                    </a:lnTo>
                    <a:lnTo>
                      <a:pt x="805" y="127"/>
                    </a:lnTo>
                    <a:lnTo>
                      <a:pt x="820" y="38"/>
                    </a:lnTo>
                    <a:lnTo>
                      <a:pt x="836" y="204"/>
                    </a:lnTo>
                    <a:lnTo>
                      <a:pt x="851" y="0"/>
                    </a:lnTo>
                    <a:lnTo>
                      <a:pt x="866" y="129"/>
                    </a:lnTo>
                    <a:lnTo>
                      <a:pt x="882" y="154"/>
                    </a:lnTo>
                    <a:lnTo>
                      <a:pt x="897" y="88"/>
                    </a:lnTo>
                    <a:lnTo>
                      <a:pt x="913" y="79"/>
                    </a:lnTo>
                    <a:lnTo>
                      <a:pt x="928" y="98"/>
                    </a:lnTo>
                    <a:lnTo>
                      <a:pt x="943" y="98"/>
                    </a:lnTo>
                    <a:lnTo>
                      <a:pt x="959" y="90"/>
                    </a:lnTo>
                    <a:lnTo>
                      <a:pt x="974" y="92"/>
                    </a:lnTo>
                    <a:lnTo>
                      <a:pt x="989" y="92"/>
                    </a:lnTo>
                    <a:lnTo>
                      <a:pt x="1005" y="35"/>
                    </a:lnTo>
                    <a:lnTo>
                      <a:pt x="1020" y="81"/>
                    </a:lnTo>
                    <a:lnTo>
                      <a:pt x="1035" y="113"/>
                    </a:lnTo>
                    <a:lnTo>
                      <a:pt x="1053" y="123"/>
                    </a:lnTo>
                    <a:lnTo>
                      <a:pt x="1068" y="152"/>
                    </a:lnTo>
                    <a:lnTo>
                      <a:pt x="1083" y="75"/>
                    </a:lnTo>
                    <a:lnTo>
                      <a:pt x="1099" y="94"/>
                    </a:lnTo>
                    <a:lnTo>
                      <a:pt x="1114" y="63"/>
                    </a:lnTo>
                    <a:lnTo>
                      <a:pt x="1130" y="108"/>
                    </a:lnTo>
                    <a:lnTo>
                      <a:pt x="1145" y="233"/>
                    </a:lnTo>
                    <a:lnTo>
                      <a:pt x="1160" y="48"/>
                    </a:lnTo>
                    <a:lnTo>
                      <a:pt x="1176" y="92"/>
                    </a:lnTo>
                    <a:lnTo>
                      <a:pt x="1191" y="119"/>
                    </a:lnTo>
                    <a:lnTo>
                      <a:pt x="1206" y="192"/>
                    </a:lnTo>
                    <a:lnTo>
                      <a:pt x="1222" y="90"/>
                    </a:lnTo>
                    <a:lnTo>
                      <a:pt x="1237" y="135"/>
                    </a:lnTo>
                    <a:lnTo>
                      <a:pt x="1252" y="79"/>
                    </a:lnTo>
                    <a:lnTo>
                      <a:pt x="1268" y="88"/>
                    </a:lnTo>
                    <a:lnTo>
                      <a:pt x="1283" y="135"/>
                    </a:lnTo>
                    <a:lnTo>
                      <a:pt x="1299" y="119"/>
                    </a:lnTo>
                    <a:lnTo>
                      <a:pt x="1314" y="167"/>
                    </a:lnTo>
                    <a:lnTo>
                      <a:pt x="1329" y="50"/>
                    </a:lnTo>
                    <a:lnTo>
                      <a:pt x="1345" y="98"/>
                    </a:lnTo>
                    <a:lnTo>
                      <a:pt x="1360" y="186"/>
                    </a:lnTo>
                    <a:lnTo>
                      <a:pt x="1377" y="123"/>
                    </a:lnTo>
                    <a:lnTo>
                      <a:pt x="1393" y="181"/>
                    </a:lnTo>
                    <a:lnTo>
                      <a:pt x="1408" y="211"/>
                    </a:lnTo>
                    <a:lnTo>
                      <a:pt x="1423" y="102"/>
                    </a:lnTo>
                    <a:lnTo>
                      <a:pt x="1439" y="179"/>
                    </a:lnTo>
                    <a:lnTo>
                      <a:pt x="1454" y="173"/>
                    </a:lnTo>
                    <a:lnTo>
                      <a:pt x="1469" y="136"/>
                    </a:lnTo>
                    <a:lnTo>
                      <a:pt x="1485" y="204"/>
                    </a:lnTo>
                    <a:lnTo>
                      <a:pt x="1500" y="129"/>
                    </a:lnTo>
                    <a:lnTo>
                      <a:pt x="1515" y="173"/>
                    </a:lnTo>
                    <a:lnTo>
                      <a:pt x="1531" y="106"/>
                    </a:lnTo>
                    <a:lnTo>
                      <a:pt x="1546" y="140"/>
                    </a:lnTo>
                    <a:lnTo>
                      <a:pt x="1562" y="146"/>
                    </a:lnTo>
                    <a:lnTo>
                      <a:pt x="1577" y="156"/>
                    </a:lnTo>
                    <a:lnTo>
                      <a:pt x="1592" y="148"/>
                    </a:lnTo>
                    <a:lnTo>
                      <a:pt x="1608" y="129"/>
                    </a:lnTo>
                    <a:lnTo>
                      <a:pt x="1623" y="206"/>
                    </a:lnTo>
                    <a:lnTo>
                      <a:pt x="1638" y="150"/>
                    </a:lnTo>
                    <a:lnTo>
                      <a:pt x="1654" y="156"/>
                    </a:lnTo>
                    <a:lnTo>
                      <a:pt x="1669" y="169"/>
                    </a:lnTo>
                    <a:lnTo>
                      <a:pt x="1684" y="267"/>
                    </a:lnTo>
                    <a:lnTo>
                      <a:pt x="1702" y="115"/>
                    </a:lnTo>
                    <a:lnTo>
                      <a:pt x="1717" y="181"/>
                    </a:lnTo>
                    <a:lnTo>
                      <a:pt x="1732" y="179"/>
                    </a:lnTo>
                    <a:lnTo>
                      <a:pt x="1748" y="173"/>
                    </a:lnTo>
                    <a:lnTo>
                      <a:pt x="1763" y="129"/>
                    </a:lnTo>
                    <a:lnTo>
                      <a:pt x="1779" y="148"/>
                    </a:lnTo>
                    <a:lnTo>
                      <a:pt x="1794" y="236"/>
                    </a:lnTo>
                    <a:lnTo>
                      <a:pt x="1809" y="200"/>
                    </a:lnTo>
                    <a:lnTo>
                      <a:pt x="1825" y="213"/>
                    </a:lnTo>
                    <a:lnTo>
                      <a:pt x="1840" y="238"/>
                    </a:lnTo>
                    <a:lnTo>
                      <a:pt x="1855" y="152"/>
                    </a:lnTo>
                    <a:lnTo>
                      <a:pt x="1871" y="281"/>
                    </a:lnTo>
                    <a:lnTo>
                      <a:pt x="1886" y="271"/>
                    </a:lnTo>
                    <a:lnTo>
                      <a:pt x="1901" y="283"/>
                    </a:lnTo>
                    <a:lnTo>
                      <a:pt x="1917" y="252"/>
                    </a:lnTo>
                    <a:lnTo>
                      <a:pt x="1932" y="286"/>
                    </a:lnTo>
                    <a:lnTo>
                      <a:pt x="1948" y="284"/>
                    </a:lnTo>
                    <a:lnTo>
                      <a:pt x="1963" y="256"/>
                    </a:lnTo>
                    <a:lnTo>
                      <a:pt x="1978" y="286"/>
                    </a:lnTo>
                    <a:lnTo>
                      <a:pt x="1994" y="229"/>
                    </a:lnTo>
                    <a:lnTo>
                      <a:pt x="2009" y="240"/>
                    </a:lnTo>
                    <a:lnTo>
                      <a:pt x="2026" y="246"/>
                    </a:lnTo>
                    <a:lnTo>
                      <a:pt x="2042" y="133"/>
                    </a:lnTo>
                    <a:lnTo>
                      <a:pt x="2057" y="265"/>
                    </a:lnTo>
                    <a:lnTo>
                      <a:pt x="2072" y="286"/>
                    </a:lnTo>
                    <a:lnTo>
                      <a:pt x="2088" y="286"/>
                    </a:lnTo>
                    <a:lnTo>
                      <a:pt x="2103" y="286"/>
                    </a:lnTo>
                    <a:lnTo>
                      <a:pt x="2118" y="286"/>
                    </a:lnTo>
                    <a:lnTo>
                      <a:pt x="2134" y="261"/>
                    </a:lnTo>
                    <a:lnTo>
                      <a:pt x="2149" y="286"/>
                    </a:lnTo>
                    <a:lnTo>
                      <a:pt x="2164" y="259"/>
                    </a:lnTo>
                    <a:lnTo>
                      <a:pt x="2180" y="263"/>
                    </a:lnTo>
                    <a:lnTo>
                      <a:pt x="2195" y="246"/>
                    </a:lnTo>
                    <a:lnTo>
                      <a:pt x="2211" y="286"/>
                    </a:lnTo>
                    <a:lnTo>
                      <a:pt x="2226" y="286"/>
                    </a:lnTo>
                    <a:lnTo>
                      <a:pt x="2241" y="283"/>
                    </a:lnTo>
                    <a:lnTo>
                      <a:pt x="2257" y="275"/>
                    </a:lnTo>
                    <a:lnTo>
                      <a:pt x="2272" y="286"/>
                    </a:lnTo>
                    <a:lnTo>
                      <a:pt x="2287" y="286"/>
                    </a:lnTo>
                    <a:lnTo>
                      <a:pt x="2303" y="286"/>
                    </a:lnTo>
                    <a:lnTo>
                      <a:pt x="2318" y="254"/>
                    </a:lnTo>
                    <a:lnTo>
                      <a:pt x="2333" y="252"/>
                    </a:lnTo>
                    <a:lnTo>
                      <a:pt x="2351" y="275"/>
                    </a:lnTo>
                    <a:lnTo>
                      <a:pt x="2366" y="225"/>
                    </a:lnTo>
                    <a:lnTo>
                      <a:pt x="2381" y="275"/>
                    </a:lnTo>
                    <a:lnTo>
                      <a:pt x="2397" y="175"/>
                    </a:lnTo>
                    <a:lnTo>
                      <a:pt x="2412" y="254"/>
                    </a:lnTo>
                    <a:lnTo>
                      <a:pt x="2428" y="242"/>
                    </a:lnTo>
                    <a:lnTo>
                      <a:pt x="2443" y="267"/>
                    </a:lnTo>
                    <a:lnTo>
                      <a:pt x="2458" y="198"/>
                    </a:lnTo>
                    <a:lnTo>
                      <a:pt x="2474" y="281"/>
                    </a:lnTo>
                    <a:lnTo>
                      <a:pt x="2489" y="209"/>
                    </a:lnTo>
                    <a:lnTo>
                      <a:pt x="2504" y="204"/>
                    </a:lnTo>
                    <a:lnTo>
                      <a:pt x="2520" y="242"/>
                    </a:lnTo>
                    <a:lnTo>
                      <a:pt x="2535" y="286"/>
                    </a:lnTo>
                    <a:lnTo>
                      <a:pt x="2550" y="281"/>
                    </a:lnTo>
                    <a:lnTo>
                      <a:pt x="2566" y="269"/>
                    </a:lnTo>
                    <a:lnTo>
                      <a:pt x="2581" y="221"/>
                    </a:lnTo>
                    <a:lnTo>
                      <a:pt x="2597" y="211"/>
                    </a:lnTo>
                    <a:lnTo>
                      <a:pt x="2612" y="244"/>
                    </a:lnTo>
                    <a:lnTo>
                      <a:pt x="2627" y="269"/>
                    </a:lnTo>
                    <a:lnTo>
                      <a:pt x="2643" y="240"/>
                    </a:lnTo>
                    <a:lnTo>
                      <a:pt x="2658" y="284"/>
                    </a:lnTo>
                    <a:lnTo>
                      <a:pt x="2675" y="284"/>
                    </a:lnTo>
                    <a:lnTo>
                      <a:pt x="2691" y="286"/>
                    </a:lnTo>
                    <a:lnTo>
                      <a:pt x="2706" y="177"/>
                    </a:lnTo>
                    <a:lnTo>
                      <a:pt x="2721" y="211"/>
                    </a:lnTo>
                    <a:lnTo>
                      <a:pt x="2737" y="286"/>
                    </a:lnTo>
                    <a:lnTo>
                      <a:pt x="2752" y="286"/>
                    </a:lnTo>
                    <a:lnTo>
                      <a:pt x="2767" y="286"/>
                    </a:lnTo>
                    <a:lnTo>
                      <a:pt x="2783" y="286"/>
                    </a:lnTo>
                    <a:lnTo>
                      <a:pt x="2798" y="286"/>
                    </a:lnTo>
                    <a:lnTo>
                      <a:pt x="2813" y="286"/>
                    </a:lnTo>
                    <a:lnTo>
                      <a:pt x="2829" y="259"/>
                    </a:lnTo>
                    <a:lnTo>
                      <a:pt x="2844" y="286"/>
                    </a:lnTo>
                    <a:lnTo>
                      <a:pt x="2860" y="286"/>
                    </a:lnTo>
                    <a:lnTo>
                      <a:pt x="2875" y="286"/>
                    </a:lnTo>
                    <a:lnTo>
                      <a:pt x="2890" y="286"/>
                    </a:lnTo>
                    <a:lnTo>
                      <a:pt x="2906" y="286"/>
                    </a:lnTo>
                    <a:lnTo>
                      <a:pt x="2921" y="286"/>
                    </a:lnTo>
                    <a:lnTo>
                      <a:pt x="2936" y="286"/>
                    </a:lnTo>
                    <a:lnTo>
                      <a:pt x="2952" y="286"/>
                    </a:lnTo>
                    <a:lnTo>
                      <a:pt x="2967" y="286"/>
                    </a:lnTo>
                    <a:lnTo>
                      <a:pt x="2982" y="286"/>
                    </a:lnTo>
                    <a:lnTo>
                      <a:pt x="3000" y="286"/>
                    </a:lnTo>
                    <a:lnTo>
                      <a:pt x="3015" y="286"/>
                    </a:lnTo>
                    <a:lnTo>
                      <a:pt x="3030" y="286"/>
                    </a:lnTo>
                    <a:lnTo>
                      <a:pt x="3046" y="286"/>
                    </a:lnTo>
                    <a:lnTo>
                      <a:pt x="3061" y="286"/>
                    </a:lnTo>
                    <a:lnTo>
                      <a:pt x="3077" y="286"/>
                    </a:lnTo>
                    <a:lnTo>
                      <a:pt x="3092" y="286"/>
                    </a:lnTo>
                    <a:lnTo>
                      <a:pt x="3107" y="286"/>
                    </a:lnTo>
                    <a:lnTo>
                      <a:pt x="3123" y="258"/>
                    </a:lnTo>
                    <a:lnTo>
                      <a:pt x="3138" y="286"/>
                    </a:lnTo>
                    <a:lnTo>
                      <a:pt x="3153" y="286"/>
                    </a:lnTo>
                    <a:lnTo>
                      <a:pt x="3169" y="252"/>
                    </a:lnTo>
                    <a:lnTo>
                      <a:pt x="3184" y="275"/>
                    </a:lnTo>
                    <a:lnTo>
                      <a:pt x="3199" y="267"/>
                    </a:lnTo>
                    <a:lnTo>
                      <a:pt x="3215" y="281"/>
                    </a:lnTo>
                    <a:lnTo>
                      <a:pt x="3230" y="261"/>
                    </a:lnTo>
                    <a:lnTo>
                      <a:pt x="3246" y="286"/>
                    </a:lnTo>
                    <a:lnTo>
                      <a:pt x="3261" y="279"/>
                    </a:lnTo>
                    <a:lnTo>
                      <a:pt x="3276" y="283"/>
                    </a:lnTo>
                    <a:lnTo>
                      <a:pt x="3292" y="267"/>
                    </a:lnTo>
                    <a:lnTo>
                      <a:pt x="3307" y="286"/>
                    </a:lnTo>
                    <a:lnTo>
                      <a:pt x="3324" y="286"/>
                    </a:lnTo>
                    <a:lnTo>
                      <a:pt x="3340" y="244"/>
                    </a:lnTo>
                    <a:lnTo>
                      <a:pt x="3355" y="179"/>
                    </a:lnTo>
                    <a:lnTo>
                      <a:pt x="3370" y="275"/>
                    </a:lnTo>
                    <a:lnTo>
                      <a:pt x="3386" y="217"/>
                    </a:lnTo>
                    <a:lnTo>
                      <a:pt x="3401" y="286"/>
                    </a:lnTo>
                    <a:lnTo>
                      <a:pt x="3416" y="286"/>
                    </a:lnTo>
                    <a:lnTo>
                      <a:pt x="3432" y="190"/>
                    </a:lnTo>
                    <a:lnTo>
                      <a:pt x="3447" y="286"/>
                    </a:lnTo>
                    <a:lnTo>
                      <a:pt x="3462" y="286"/>
                    </a:lnTo>
                    <a:lnTo>
                      <a:pt x="3478" y="165"/>
                    </a:lnTo>
                    <a:lnTo>
                      <a:pt x="3493" y="283"/>
                    </a:lnTo>
                    <a:lnTo>
                      <a:pt x="3509" y="281"/>
                    </a:lnTo>
                    <a:lnTo>
                      <a:pt x="3524" y="281"/>
                    </a:lnTo>
                    <a:lnTo>
                      <a:pt x="3539" y="286"/>
                    </a:lnTo>
                    <a:lnTo>
                      <a:pt x="3555" y="286"/>
                    </a:lnTo>
                    <a:lnTo>
                      <a:pt x="3570" y="286"/>
                    </a:lnTo>
                    <a:lnTo>
                      <a:pt x="3585" y="281"/>
                    </a:lnTo>
                    <a:lnTo>
                      <a:pt x="3601" y="256"/>
                    </a:lnTo>
                    <a:lnTo>
                      <a:pt x="3616" y="242"/>
                    </a:lnTo>
                    <a:lnTo>
                      <a:pt x="3631" y="286"/>
                    </a:lnTo>
                    <a:lnTo>
                      <a:pt x="3649" y="259"/>
                    </a:lnTo>
                    <a:lnTo>
                      <a:pt x="3664" y="286"/>
                    </a:lnTo>
                    <a:lnTo>
                      <a:pt x="3679" y="286"/>
                    </a:lnTo>
                    <a:lnTo>
                      <a:pt x="3695" y="286"/>
                    </a:lnTo>
                    <a:lnTo>
                      <a:pt x="3710" y="286"/>
                    </a:lnTo>
                    <a:lnTo>
                      <a:pt x="3726" y="271"/>
                    </a:lnTo>
                    <a:lnTo>
                      <a:pt x="3741" y="261"/>
                    </a:lnTo>
                    <a:lnTo>
                      <a:pt x="3756" y="265"/>
                    </a:lnTo>
                    <a:lnTo>
                      <a:pt x="3772" y="286"/>
                    </a:lnTo>
                    <a:lnTo>
                      <a:pt x="3787" y="204"/>
                    </a:lnTo>
                    <a:lnTo>
                      <a:pt x="3802" y="211"/>
                    </a:lnTo>
                    <a:lnTo>
                      <a:pt x="3818" y="204"/>
                    </a:lnTo>
                    <a:lnTo>
                      <a:pt x="3833" y="238"/>
                    </a:lnTo>
                    <a:lnTo>
                      <a:pt x="3848" y="165"/>
                    </a:lnTo>
                    <a:lnTo>
                      <a:pt x="3864" y="284"/>
                    </a:lnTo>
                    <a:lnTo>
                      <a:pt x="3879" y="281"/>
                    </a:lnTo>
                    <a:lnTo>
                      <a:pt x="3895" y="286"/>
                    </a:lnTo>
                    <a:lnTo>
                      <a:pt x="3910" y="286"/>
                    </a:lnTo>
                    <a:lnTo>
                      <a:pt x="3925" y="186"/>
                    </a:lnTo>
                    <a:lnTo>
                      <a:pt x="3941" y="281"/>
                    </a:lnTo>
                    <a:lnTo>
                      <a:pt x="3956" y="248"/>
                    </a:lnTo>
                    <a:lnTo>
                      <a:pt x="3973" y="286"/>
                    </a:lnTo>
                    <a:lnTo>
                      <a:pt x="3989" y="286"/>
                    </a:lnTo>
                    <a:lnTo>
                      <a:pt x="4004" y="286"/>
                    </a:lnTo>
                    <a:lnTo>
                      <a:pt x="4019" y="263"/>
                    </a:lnTo>
                    <a:lnTo>
                      <a:pt x="4035" y="286"/>
                    </a:lnTo>
                    <a:lnTo>
                      <a:pt x="4050" y="256"/>
                    </a:lnTo>
                    <a:lnTo>
                      <a:pt x="4065" y="246"/>
                    </a:lnTo>
                    <a:lnTo>
                      <a:pt x="4081" y="263"/>
                    </a:lnTo>
                    <a:lnTo>
                      <a:pt x="4096" y="244"/>
                    </a:lnTo>
                    <a:lnTo>
                      <a:pt x="4111" y="271"/>
                    </a:lnTo>
                    <a:lnTo>
                      <a:pt x="4127" y="196"/>
                    </a:lnTo>
                    <a:lnTo>
                      <a:pt x="4142" y="173"/>
                    </a:lnTo>
                    <a:lnTo>
                      <a:pt x="4158" y="246"/>
                    </a:lnTo>
                    <a:lnTo>
                      <a:pt x="4173" y="188"/>
                    </a:lnTo>
                    <a:lnTo>
                      <a:pt x="4188" y="240"/>
                    </a:lnTo>
                    <a:lnTo>
                      <a:pt x="4204" y="213"/>
                    </a:lnTo>
                    <a:lnTo>
                      <a:pt x="4219" y="209"/>
                    </a:lnTo>
                    <a:lnTo>
                      <a:pt x="4234" y="111"/>
                    </a:lnTo>
                    <a:lnTo>
                      <a:pt x="4250" y="242"/>
                    </a:lnTo>
                    <a:lnTo>
                      <a:pt x="4265" y="208"/>
                    </a:lnTo>
                    <a:lnTo>
                      <a:pt x="4280" y="135"/>
                    </a:lnTo>
                    <a:lnTo>
                      <a:pt x="4298" y="227"/>
                    </a:lnTo>
                    <a:lnTo>
                      <a:pt x="4313" y="229"/>
                    </a:lnTo>
                    <a:lnTo>
                      <a:pt x="4328" y="173"/>
                    </a:lnTo>
                    <a:lnTo>
                      <a:pt x="4344" y="188"/>
                    </a:lnTo>
                    <a:lnTo>
                      <a:pt x="4359" y="163"/>
                    </a:lnTo>
                    <a:lnTo>
                      <a:pt x="4375" y="136"/>
                    </a:lnTo>
                    <a:lnTo>
                      <a:pt x="4390" y="225"/>
                    </a:lnTo>
                    <a:lnTo>
                      <a:pt x="4405" y="188"/>
                    </a:lnTo>
                    <a:lnTo>
                      <a:pt x="4421" y="238"/>
                    </a:lnTo>
                    <a:lnTo>
                      <a:pt x="4436" y="279"/>
                    </a:lnTo>
                    <a:lnTo>
                      <a:pt x="4451" y="167"/>
                    </a:lnTo>
                    <a:lnTo>
                      <a:pt x="4467" y="169"/>
                    </a:lnTo>
                    <a:lnTo>
                      <a:pt x="4482" y="286"/>
                    </a:lnTo>
                    <a:lnTo>
                      <a:pt x="4497" y="217"/>
                    </a:lnTo>
                    <a:lnTo>
                      <a:pt x="4513" y="125"/>
                    </a:lnTo>
                    <a:lnTo>
                      <a:pt x="4528" y="233"/>
                    </a:lnTo>
                    <a:lnTo>
                      <a:pt x="4544" y="186"/>
                    </a:lnTo>
                    <a:lnTo>
                      <a:pt x="4559" y="117"/>
                    </a:lnTo>
                    <a:lnTo>
                      <a:pt x="4574" y="133"/>
                    </a:lnTo>
                    <a:lnTo>
                      <a:pt x="4590" y="94"/>
                    </a:lnTo>
                    <a:lnTo>
                      <a:pt x="4605" y="240"/>
                    </a:lnTo>
                    <a:lnTo>
                      <a:pt x="4622" y="111"/>
                    </a:lnTo>
                    <a:lnTo>
                      <a:pt x="4638" y="238"/>
                    </a:lnTo>
                    <a:lnTo>
                      <a:pt x="4653" y="62"/>
                    </a:lnTo>
                    <a:lnTo>
                      <a:pt x="4668" y="104"/>
                    </a:lnTo>
                    <a:lnTo>
                      <a:pt x="4684" y="79"/>
                    </a:lnTo>
                    <a:lnTo>
                      <a:pt x="4699" y="111"/>
                    </a:lnTo>
                    <a:lnTo>
                      <a:pt x="4714" y="40"/>
                    </a:lnTo>
                    <a:lnTo>
                      <a:pt x="4730" y="42"/>
                    </a:lnTo>
                    <a:lnTo>
                      <a:pt x="4745" y="98"/>
                    </a:lnTo>
                    <a:lnTo>
                      <a:pt x="4761" y="179"/>
                    </a:lnTo>
                    <a:lnTo>
                      <a:pt x="4776" y="87"/>
                    </a:lnTo>
                    <a:lnTo>
                      <a:pt x="4791" y="88"/>
                    </a:lnTo>
                    <a:lnTo>
                      <a:pt x="4807" y="133"/>
                    </a:lnTo>
                    <a:lnTo>
                      <a:pt x="4822" y="165"/>
                    </a:lnTo>
                    <a:lnTo>
                      <a:pt x="4837" y="192"/>
                    </a:lnTo>
                    <a:lnTo>
                      <a:pt x="4853" y="177"/>
                    </a:lnTo>
                    <a:lnTo>
                      <a:pt x="4868" y="19"/>
                    </a:lnTo>
                    <a:lnTo>
                      <a:pt x="4883" y="75"/>
                    </a:lnTo>
                    <a:lnTo>
                      <a:pt x="4899" y="154"/>
                    </a:lnTo>
                    <a:lnTo>
                      <a:pt x="4914" y="90"/>
                    </a:lnTo>
                    <a:lnTo>
                      <a:pt x="4929" y="54"/>
                    </a:lnTo>
                    <a:lnTo>
                      <a:pt x="4947" y="98"/>
                    </a:lnTo>
                    <a:lnTo>
                      <a:pt x="4962" y="87"/>
                    </a:lnTo>
                    <a:lnTo>
                      <a:pt x="4977" y="46"/>
                    </a:lnTo>
                    <a:lnTo>
                      <a:pt x="4993" y="102"/>
                    </a:lnTo>
                    <a:lnTo>
                      <a:pt x="5008" y="136"/>
                    </a:lnTo>
                    <a:lnTo>
                      <a:pt x="5024" y="104"/>
                    </a:lnTo>
                    <a:lnTo>
                      <a:pt x="5039" y="111"/>
                    </a:lnTo>
                    <a:lnTo>
                      <a:pt x="5054" y="44"/>
                    </a:lnTo>
                    <a:lnTo>
                      <a:pt x="5070" y="102"/>
                    </a:lnTo>
                    <a:lnTo>
                      <a:pt x="5085" y="90"/>
                    </a:lnTo>
                    <a:lnTo>
                      <a:pt x="5100" y="83"/>
                    </a:lnTo>
                    <a:lnTo>
                      <a:pt x="5116" y="102"/>
                    </a:lnTo>
                    <a:lnTo>
                      <a:pt x="5131" y="121"/>
                    </a:lnTo>
                    <a:lnTo>
                      <a:pt x="5146" y="77"/>
                    </a:lnTo>
                    <a:lnTo>
                      <a:pt x="5162" y="98"/>
                    </a:lnTo>
                    <a:lnTo>
                      <a:pt x="5177" y="63"/>
                    </a:lnTo>
                    <a:lnTo>
                      <a:pt x="5193" y="152"/>
                    </a:lnTo>
                    <a:lnTo>
                      <a:pt x="5208" y="77"/>
                    </a:lnTo>
                    <a:lnTo>
                      <a:pt x="5223" y="98"/>
                    </a:lnTo>
                    <a:lnTo>
                      <a:pt x="5239" y="150"/>
                    </a:lnTo>
                    <a:lnTo>
                      <a:pt x="5254" y="146"/>
                    </a:lnTo>
                    <a:lnTo>
                      <a:pt x="5271" y="71"/>
                    </a:lnTo>
                    <a:lnTo>
                      <a:pt x="5287" y="113"/>
                    </a:lnTo>
                    <a:lnTo>
                      <a:pt x="5302" y="144"/>
                    </a:lnTo>
                    <a:lnTo>
                      <a:pt x="5317" y="135"/>
                    </a:lnTo>
                    <a:lnTo>
                      <a:pt x="5333" y="142"/>
                    </a:lnTo>
                    <a:lnTo>
                      <a:pt x="5348" y="92"/>
                    </a:lnTo>
                    <a:lnTo>
                      <a:pt x="5363" y="27"/>
                    </a:lnTo>
                    <a:lnTo>
                      <a:pt x="5379" y="121"/>
                    </a:lnTo>
                    <a:lnTo>
                      <a:pt x="5394" y="192"/>
                    </a:lnTo>
                    <a:lnTo>
                      <a:pt x="5410" y="171"/>
                    </a:lnTo>
                    <a:lnTo>
                      <a:pt x="5410" y="286"/>
                    </a:lnTo>
                    <a:lnTo>
                      <a:pt x="5394" y="286"/>
                    </a:lnTo>
                    <a:lnTo>
                      <a:pt x="5379" y="286"/>
                    </a:lnTo>
                    <a:lnTo>
                      <a:pt x="5363" y="286"/>
                    </a:lnTo>
                    <a:lnTo>
                      <a:pt x="5348" y="286"/>
                    </a:lnTo>
                    <a:lnTo>
                      <a:pt x="5333" y="286"/>
                    </a:lnTo>
                    <a:lnTo>
                      <a:pt x="5317" y="286"/>
                    </a:lnTo>
                    <a:lnTo>
                      <a:pt x="5302" y="286"/>
                    </a:lnTo>
                    <a:lnTo>
                      <a:pt x="5287" y="286"/>
                    </a:lnTo>
                    <a:lnTo>
                      <a:pt x="5271" y="286"/>
                    </a:lnTo>
                    <a:lnTo>
                      <a:pt x="5254" y="286"/>
                    </a:lnTo>
                    <a:lnTo>
                      <a:pt x="5239" y="286"/>
                    </a:lnTo>
                    <a:lnTo>
                      <a:pt x="5223" y="286"/>
                    </a:lnTo>
                    <a:lnTo>
                      <a:pt x="5208" y="286"/>
                    </a:lnTo>
                    <a:lnTo>
                      <a:pt x="5193" y="286"/>
                    </a:lnTo>
                    <a:lnTo>
                      <a:pt x="5177" y="286"/>
                    </a:lnTo>
                    <a:lnTo>
                      <a:pt x="5162" y="286"/>
                    </a:lnTo>
                    <a:lnTo>
                      <a:pt x="5146" y="286"/>
                    </a:lnTo>
                    <a:lnTo>
                      <a:pt x="5131" y="286"/>
                    </a:lnTo>
                    <a:lnTo>
                      <a:pt x="5116" y="286"/>
                    </a:lnTo>
                    <a:lnTo>
                      <a:pt x="5100" y="286"/>
                    </a:lnTo>
                    <a:lnTo>
                      <a:pt x="5085" y="286"/>
                    </a:lnTo>
                    <a:lnTo>
                      <a:pt x="5070" y="286"/>
                    </a:lnTo>
                    <a:lnTo>
                      <a:pt x="5054" y="286"/>
                    </a:lnTo>
                    <a:lnTo>
                      <a:pt x="5039" y="286"/>
                    </a:lnTo>
                    <a:lnTo>
                      <a:pt x="5024" y="286"/>
                    </a:lnTo>
                    <a:lnTo>
                      <a:pt x="5008" y="286"/>
                    </a:lnTo>
                    <a:lnTo>
                      <a:pt x="4993" y="286"/>
                    </a:lnTo>
                    <a:lnTo>
                      <a:pt x="4977" y="286"/>
                    </a:lnTo>
                    <a:lnTo>
                      <a:pt x="4962" y="286"/>
                    </a:lnTo>
                    <a:lnTo>
                      <a:pt x="4947" y="286"/>
                    </a:lnTo>
                    <a:lnTo>
                      <a:pt x="4929" y="286"/>
                    </a:lnTo>
                    <a:lnTo>
                      <a:pt x="4914" y="286"/>
                    </a:lnTo>
                    <a:lnTo>
                      <a:pt x="4899" y="286"/>
                    </a:lnTo>
                    <a:lnTo>
                      <a:pt x="4883" y="286"/>
                    </a:lnTo>
                    <a:lnTo>
                      <a:pt x="4868" y="286"/>
                    </a:lnTo>
                    <a:lnTo>
                      <a:pt x="4853" y="286"/>
                    </a:lnTo>
                    <a:lnTo>
                      <a:pt x="4837" y="286"/>
                    </a:lnTo>
                    <a:lnTo>
                      <a:pt x="4822" y="286"/>
                    </a:lnTo>
                    <a:lnTo>
                      <a:pt x="4807" y="286"/>
                    </a:lnTo>
                    <a:lnTo>
                      <a:pt x="4791" y="286"/>
                    </a:lnTo>
                    <a:lnTo>
                      <a:pt x="4776" y="286"/>
                    </a:lnTo>
                    <a:lnTo>
                      <a:pt x="4761" y="286"/>
                    </a:lnTo>
                    <a:lnTo>
                      <a:pt x="4745" y="286"/>
                    </a:lnTo>
                    <a:lnTo>
                      <a:pt x="4730" y="286"/>
                    </a:lnTo>
                    <a:lnTo>
                      <a:pt x="4714" y="286"/>
                    </a:lnTo>
                    <a:lnTo>
                      <a:pt x="4699" y="286"/>
                    </a:lnTo>
                    <a:lnTo>
                      <a:pt x="4684" y="286"/>
                    </a:lnTo>
                    <a:lnTo>
                      <a:pt x="4668" y="286"/>
                    </a:lnTo>
                    <a:lnTo>
                      <a:pt x="4653" y="286"/>
                    </a:lnTo>
                    <a:lnTo>
                      <a:pt x="4638" y="286"/>
                    </a:lnTo>
                    <a:lnTo>
                      <a:pt x="4622" y="286"/>
                    </a:lnTo>
                    <a:lnTo>
                      <a:pt x="4605" y="286"/>
                    </a:lnTo>
                    <a:lnTo>
                      <a:pt x="4590" y="286"/>
                    </a:lnTo>
                    <a:lnTo>
                      <a:pt x="4574" y="286"/>
                    </a:lnTo>
                    <a:lnTo>
                      <a:pt x="4559" y="286"/>
                    </a:lnTo>
                    <a:lnTo>
                      <a:pt x="4544" y="286"/>
                    </a:lnTo>
                    <a:lnTo>
                      <a:pt x="4528" y="286"/>
                    </a:lnTo>
                    <a:lnTo>
                      <a:pt x="4513" y="286"/>
                    </a:lnTo>
                    <a:lnTo>
                      <a:pt x="4497" y="286"/>
                    </a:lnTo>
                    <a:lnTo>
                      <a:pt x="4482" y="286"/>
                    </a:lnTo>
                    <a:lnTo>
                      <a:pt x="4467" y="286"/>
                    </a:lnTo>
                    <a:lnTo>
                      <a:pt x="4451" y="286"/>
                    </a:lnTo>
                    <a:lnTo>
                      <a:pt x="4436" y="286"/>
                    </a:lnTo>
                    <a:lnTo>
                      <a:pt x="4421" y="286"/>
                    </a:lnTo>
                    <a:lnTo>
                      <a:pt x="4405" y="286"/>
                    </a:lnTo>
                    <a:lnTo>
                      <a:pt x="4390" y="286"/>
                    </a:lnTo>
                    <a:lnTo>
                      <a:pt x="4375" y="286"/>
                    </a:lnTo>
                    <a:lnTo>
                      <a:pt x="4359" y="286"/>
                    </a:lnTo>
                    <a:lnTo>
                      <a:pt x="4344" y="286"/>
                    </a:lnTo>
                    <a:lnTo>
                      <a:pt x="4328" y="286"/>
                    </a:lnTo>
                    <a:lnTo>
                      <a:pt x="4313" y="286"/>
                    </a:lnTo>
                    <a:lnTo>
                      <a:pt x="4298" y="286"/>
                    </a:lnTo>
                    <a:lnTo>
                      <a:pt x="4280" y="286"/>
                    </a:lnTo>
                    <a:lnTo>
                      <a:pt x="4265" y="286"/>
                    </a:lnTo>
                    <a:lnTo>
                      <a:pt x="4250" y="286"/>
                    </a:lnTo>
                    <a:lnTo>
                      <a:pt x="4234" y="286"/>
                    </a:lnTo>
                    <a:lnTo>
                      <a:pt x="4219" y="286"/>
                    </a:lnTo>
                    <a:lnTo>
                      <a:pt x="4204" y="286"/>
                    </a:lnTo>
                    <a:lnTo>
                      <a:pt x="4188" y="286"/>
                    </a:lnTo>
                    <a:lnTo>
                      <a:pt x="4173" y="286"/>
                    </a:lnTo>
                    <a:lnTo>
                      <a:pt x="4158" y="286"/>
                    </a:lnTo>
                    <a:lnTo>
                      <a:pt x="4142" y="286"/>
                    </a:lnTo>
                    <a:lnTo>
                      <a:pt x="4127" y="286"/>
                    </a:lnTo>
                    <a:lnTo>
                      <a:pt x="4111" y="286"/>
                    </a:lnTo>
                    <a:lnTo>
                      <a:pt x="4096" y="286"/>
                    </a:lnTo>
                    <a:lnTo>
                      <a:pt x="4081" y="286"/>
                    </a:lnTo>
                    <a:lnTo>
                      <a:pt x="4065" y="286"/>
                    </a:lnTo>
                    <a:lnTo>
                      <a:pt x="4050" y="286"/>
                    </a:lnTo>
                    <a:lnTo>
                      <a:pt x="4035" y="286"/>
                    </a:lnTo>
                    <a:lnTo>
                      <a:pt x="4019" y="286"/>
                    </a:lnTo>
                    <a:lnTo>
                      <a:pt x="4004" y="286"/>
                    </a:lnTo>
                    <a:lnTo>
                      <a:pt x="3989" y="286"/>
                    </a:lnTo>
                    <a:lnTo>
                      <a:pt x="3973" y="286"/>
                    </a:lnTo>
                    <a:lnTo>
                      <a:pt x="3956" y="286"/>
                    </a:lnTo>
                    <a:lnTo>
                      <a:pt x="3941" y="286"/>
                    </a:lnTo>
                    <a:lnTo>
                      <a:pt x="3925" y="286"/>
                    </a:lnTo>
                    <a:lnTo>
                      <a:pt x="3910" y="286"/>
                    </a:lnTo>
                    <a:lnTo>
                      <a:pt x="3895" y="286"/>
                    </a:lnTo>
                    <a:lnTo>
                      <a:pt x="3879" y="286"/>
                    </a:lnTo>
                    <a:lnTo>
                      <a:pt x="3864" y="286"/>
                    </a:lnTo>
                    <a:lnTo>
                      <a:pt x="3848" y="286"/>
                    </a:lnTo>
                    <a:lnTo>
                      <a:pt x="3833" y="286"/>
                    </a:lnTo>
                    <a:lnTo>
                      <a:pt x="3818" y="286"/>
                    </a:lnTo>
                    <a:lnTo>
                      <a:pt x="3802" y="286"/>
                    </a:lnTo>
                    <a:lnTo>
                      <a:pt x="3787" y="286"/>
                    </a:lnTo>
                    <a:lnTo>
                      <a:pt x="3772" y="286"/>
                    </a:lnTo>
                    <a:lnTo>
                      <a:pt x="3756" y="286"/>
                    </a:lnTo>
                    <a:lnTo>
                      <a:pt x="3741" y="286"/>
                    </a:lnTo>
                    <a:lnTo>
                      <a:pt x="3726" y="286"/>
                    </a:lnTo>
                    <a:lnTo>
                      <a:pt x="3710" y="286"/>
                    </a:lnTo>
                    <a:lnTo>
                      <a:pt x="3695" y="286"/>
                    </a:lnTo>
                    <a:lnTo>
                      <a:pt x="3679" y="286"/>
                    </a:lnTo>
                    <a:lnTo>
                      <a:pt x="3664" y="286"/>
                    </a:lnTo>
                    <a:lnTo>
                      <a:pt x="3649" y="286"/>
                    </a:lnTo>
                    <a:lnTo>
                      <a:pt x="3631" y="286"/>
                    </a:lnTo>
                    <a:lnTo>
                      <a:pt x="3616" y="286"/>
                    </a:lnTo>
                    <a:lnTo>
                      <a:pt x="3601" y="286"/>
                    </a:lnTo>
                    <a:lnTo>
                      <a:pt x="3585" y="286"/>
                    </a:lnTo>
                    <a:lnTo>
                      <a:pt x="3570" y="286"/>
                    </a:lnTo>
                    <a:lnTo>
                      <a:pt x="3555" y="286"/>
                    </a:lnTo>
                    <a:lnTo>
                      <a:pt x="3539" y="286"/>
                    </a:lnTo>
                    <a:lnTo>
                      <a:pt x="3524" y="286"/>
                    </a:lnTo>
                    <a:lnTo>
                      <a:pt x="3509" y="286"/>
                    </a:lnTo>
                    <a:lnTo>
                      <a:pt x="3493" y="286"/>
                    </a:lnTo>
                    <a:lnTo>
                      <a:pt x="3478" y="286"/>
                    </a:lnTo>
                    <a:lnTo>
                      <a:pt x="3462" y="286"/>
                    </a:lnTo>
                    <a:lnTo>
                      <a:pt x="3447" y="286"/>
                    </a:lnTo>
                    <a:lnTo>
                      <a:pt x="3432" y="286"/>
                    </a:lnTo>
                    <a:lnTo>
                      <a:pt x="3416" y="286"/>
                    </a:lnTo>
                    <a:lnTo>
                      <a:pt x="3401" y="286"/>
                    </a:lnTo>
                    <a:lnTo>
                      <a:pt x="3386" y="286"/>
                    </a:lnTo>
                    <a:lnTo>
                      <a:pt x="3370" y="286"/>
                    </a:lnTo>
                    <a:lnTo>
                      <a:pt x="3355" y="286"/>
                    </a:lnTo>
                    <a:lnTo>
                      <a:pt x="3340" y="286"/>
                    </a:lnTo>
                    <a:lnTo>
                      <a:pt x="3324" y="286"/>
                    </a:lnTo>
                    <a:lnTo>
                      <a:pt x="3307" y="286"/>
                    </a:lnTo>
                    <a:lnTo>
                      <a:pt x="3292" y="286"/>
                    </a:lnTo>
                    <a:lnTo>
                      <a:pt x="3276" y="286"/>
                    </a:lnTo>
                    <a:lnTo>
                      <a:pt x="3261" y="286"/>
                    </a:lnTo>
                    <a:lnTo>
                      <a:pt x="3246" y="286"/>
                    </a:lnTo>
                    <a:lnTo>
                      <a:pt x="3230" y="286"/>
                    </a:lnTo>
                    <a:lnTo>
                      <a:pt x="3215" y="286"/>
                    </a:lnTo>
                    <a:lnTo>
                      <a:pt x="3199" y="286"/>
                    </a:lnTo>
                    <a:lnTo>
                      <a:pt x="3184" y="286"/>
                    </a:lnTo>
                    <a:lnTo>
                      <a:pt x="3169" y="286"/>
                    </a:lnTo>
                    <a:lnTo>
                      <a:pt x="3153" y="286"/>
                    </a:lnTo>
                    <a:lnTo>
                      <a:pt x="3138" y="286"/>
                    </a:lnTo>
                    <a:lnTo>
                      <a:pt x="3123" y="286"/>
                    </a:lnTo>
                    <a:lnTo>
                      <a:pt x="3107" y="286"/>
                    </a:lnTo>
                    <a:lnTo>
                      <a:pt x="3092" y="286"/>
                    </a:lnTo>
                    <a:lnTo>
                      <a:pt x="3077" y="286"/>
                    </a:lnTo>
                    <a:lnTo>
                      <a:pt x="3061" y="286"/>
                    </a:lnTo>
                    <a:lnTo>
                      <a:pt x="3046" y="286"/>
                    </a:lnTo>
                    <a:lnTo>
                      <a:pt x="3030" y="286"/>
                    </a:lnTo>
                    <a:lnTo>
                      <a:pt x="3015" y="286"/>
                    </a:lnTo>
                    <a:lnTo>
                      <a:pt x="3000" y="286"/>
                    </a:lnTo>
                    <a:lnTo>
                      <a:pt x="2982" y="286"/>
                    </a:lnTo>
                    <a:lnTo>
                      <a:pt x="2967" y="286"/>
                    </a:lnTo>
                    <a:lnTo>
                      <a:pt x="2952" y="286"/>
                    </a:lnTo>
                    <a:lnTo>
                      <a:pt x="2936" y="286"/>
                    </a:lnTo>
                    <a:lnTo>
                      <a:pt x="2921" y="286"/>
                    </a:lnTo>
                    <a:lnTo>
                      <a:pt x="2906" y="286"/>
                    </a:lnTo>
                    <a:lnTo>
                      <a:pt x="2890" y="286"/>
                    </a:lnTo>
                    <a:lnTo>
                      <a:pt x="2875" y="286"/>
                    </a:lnTo>
                    <a:lnTo>
                      <a:pt x="2860" y="286"/>
                    </a:lnTo>
                    <a:lnTo>
                      <a:pt x="2844" y="286"/>
                    </a:lnTo>
                    <a:lnTo>
                      <a:pt x="2829" y="286"/>
                    </a:lnTo>
                    <a:lnTo>
                      <a:pt x="2813" y="286"/>
                    </a:lnTo>
                    <a:lnTo>
                      <a:pt x="2798" y="286"/>
                    </a:lnTo>
                    <a:lnTo>
                      <a:pt x="2783" y="286"/>
                    </a:lnTo>
                    <a:lnTo>
                      <a:pt x="2767" y="286"/>
                    </a:lnTo>
                    <a:lnTo>
                      <a:pt x="2752" y="286"/>
                    </a:lnTo>
                    <a:lnTo>
                      <a:pt x="2737" y="286"/>
                    </a:lnTo>
                    <a:lnTo>
                      <a:pt x="2721" y="286"/>
                    </a:lnTo>
                    <a:lnTo>
                      <a:pt x="2706" y="286"/>
                    </a:lnTo>
                    <a:lnTo>
                      <a:pt x="2691" y="286"/>
                    </a:lnTo>
                    <a:lnTo>
                      <a:pt x="2675" y="286"/>
                    </a:lnTo>
                    <a:lnTo>
                      <a:pt x="2658" y="286"/>
                    </a:lnTo>
                    <a:lnTo>
                      <a:pt x="2643" y="286"/>
                    </a:lnTo>
                    <a:lnTo>
                      <a:pt x="2627" y="286"/>
                    </a:lnTo>
                    <a:lnTo>
                      <a:pt x="2612" y="286"/>
                    </a:lnTo>
                    <a:lnTo>
                      <a:pt x="2597" y="286"/>
                    </a:lnTo>
                    <a:lnTo>
                      <a:pt x="2581" y="286"/>
                    </a:lnTo>
                    <a:lnTo>
                      <a:pt x="2566" y="286"/>
                    </a:lnTo>
                    <a:lnTo>
                      <a:pt x="2550" y="286"/>
                    </a:lnTo>
                    <a:lnTo>
                      <a:pt x="2535" y="286"/>
                    </a:lnTo>
                    <a:lnTo>
                      <a:pt x="2520" y="286"/>
                    </a:lnTo>
                    <a:lnTo>
                      <a:pt x="2504" y="286"/>
                    </a:lnTo>
                    <a:lnTo>
                      <a:pt x="2489" y="286"/>
                    </a:lnTo>
                    <a:lnTo>
                      <a:pt x="2474" y="286"/>
                    </a:lnTo>
                    <a:lnTo>
                      <a:pt x="2458" y="286"/>
                    </a:lnTo>
                    <a:lnTo>
                      <a:pt x="2443" y="286"/>
                    </a:lnTo>
                    <a:lnTo>
                      <a:pt x="2428" y="286"/>
                    </a:lnTo>
                    <a:lnTo>
                      <a:pt x="2412" y="286"/>
                    </a:lnTo>
                    <a:lnTo>
                      <a:pt x="2397" y="286"/>
                    </a:lnTo>
                    <a:lnTo>
                      <a:pt x="2381" y="286"/>
                    </a:lnTo>
                    <a:lnTo>
                      <a:pt x="2366" y="286"/>
                    </a:lnTo>
                    <a:lnTo>
                      <a:pt x="2351" y="286"/>
                    </a:lnTo>
                    <a:lnTo>
                      <a:pt x="2333" y="286"/>
                    </a:lnTo>
                    <a:lnTo>
                      <a:pt x="2318" y="286"/>
                    </a:lnTo>
                    <a:lnTo>
                      <a:pt x="2303" y="286"/>
                    </a:lnTo>
                    <a:lnTo>
                      <a:pt x="2287" y="286"/>
                    </a:lnTo>
                    <a:lnTo>
                      <a:pt x="2272" y="286"/>
                    </a:lnTo>
                    <a:lnTo>
                      <a:pt x="2257" y="286"/>
                    </a:lnTo>
                    <a:lnTo>
                      <a:pt x="2241" y="286"/>
                    </a:lnTo>
                    <a:lnTo>
                      <a:pt x="2226" y="286"/>
                    </a:lnTo>
                    <a:lnTo>
                      <a:pt x="2211" y="286"/>
                    </a:lnTo>
                    <a:lnTo>
                      <a:pt x="2195" y="286"/>
                    </a:lnTo>
                    <a:lnTo>
                      <a:pt x="2180" y="286"/>
                    </a:lnTo>
                    <a:lnTo>
                      <a:pt x="2164" y="286"/>
                    </a:lnTo>
                    <a:lnTo>
                      <a:pt x="2149" y="286"/>
                    </a:lnTo>
                    <a:lnTo>
                      <a:pt x="2134" y="286"/>
                    </a:lnTo>
                    <a:lnTo>
                      <a:pt x="2118" y="286"/>
                    </a:lnTo>
                    <a:lnTo>
                      <a:pt x="2103" y="286"/>
                    </a:lnTo>
                    <a:lnTo>
                      <a:pt x="2088" y="286"/>
                    </a:lnTo>
                    <a:lnTo>
                      <a:pt x="2072" y="286"/>
                    </a:lnTo>
                    <a:lnTo>
                      <a:pt x="2057" y="286"/>
                    </a:lnTo>
                    <a:lnTo>
                      <a:pt x="2042" y="286"/>
                    </a:lnTo>
                    <a:lnTo>
                      <a:pt x="2026" y="286"/>
                    </a:lnTo>
                    <a:lnTo>
                      <a:pt x="2009" y="286"/>
                    </a:lnTo>
                    <a:lnTo>
                      <a:pt x="1994" y="286"/>
                    </a:lnTo>
                    <a:lnTo>
                      <a:pt x="1978" y="286"/>
                    </a:lnTo>
                    <a:lnTo>
                      <a:pt x="1963" y="286"/>
                    </a:lnTo>
                    <a:lnTo>
                      <a:pt x="1948" y="286"/>
                    </a:lnTo>
                    <a:lnTo>
                      <a:pt x="1932" y="286"/>
                    </a:lnTo>
                    <a:lnTo>
                      <a:pt x="1917" y="286"/>
                    </a:lnTo>
                    <a:lnTo>
                      <a:pt x="1901" y="286"/>
                    </a:lnTo>
                    <a:lnTo>
                      <a:pt x="1886" y="286"/>
                    </a:lnTo>
                    <a:lnTo>
                      <a:pt x="1871" y="286"/>
                    </a:lnTo>
                    <a:lnTo>
                      <a:pt x="1855" y="286"/>
                    </a:lnTo>
                    <a:lnTo>
                      <a:pt x="1840" y="286"/>
                    </a:lnTo>
                    <a:lnTo>
                      <a:pt x="1825" y="286"/>
                    </a:lnTo>
                    <a:lnTo>
                      <a:pt x="1809" y="286"/>
                    </a:lnTo>
                    <a:lnTo>
                      <a:pt x="1794" y="286"/>
                    </a:lnTo>
                    <a:lnTo>
                      <a:pt x="1779" y="286"/>
                    </a:lnTo>
                    <a:lnTo>
                      <a:pt x="1763" y="286"/>
                    </a:lnTo>
                    <a:lnTo>
                      <a:pt x="1748" y="286"/>
                    </a:lnTo>
                    <a:lnTo>
                      <a:pt x="1732" y="286"/>
                    </a:lnTo>
                    <a:lnTo>
                      <a:pt x="1717" y="286"/>
                    </a:lnTo>
                    <a:lnTo>
                      <a:pt x="1702" y="286"/>
                    </a:lnTo>
                    <a:lnTo>
                      <a:pt x="1684" y="286"/>
                    </a:lnTo>
                    <a:lnTo>
                      <a:pt x="1669" y="286"/>
                    </a:lnTo>
                    <a:lnTo>
                      <a:pt x="1654" y="286"/>
                    </a:lnTo>
                    <a:lnTo>
                      <a:pt x="1638" y="286"/>
                    </a:lnTo>
                    <a:lnTo>
                      <a:pt x="1623" y="286"/>
                    </a:lnTo>
                    <a:lnTo>
                      <a:pt x="1608" y="286"/>
                    </a:lnTo>
                    <a:lnTo>
                      <a:pt x="1592" y="286"/>
                    </a:lnTo>
                    <a:lnTo>
                      <a:pt x="1577" y="286"/>
                    </a:lnTo>
                    <a:lnTo>
                      <a:pt x="1562" y="286"/>
                    </a:lnTo>
                    <a:lnTo>
                      <a:pt x="1546" y="286"/>
                    </a:lnTo>
                    <a:lnTo>
                      <a:pt x="1531" y="286"/>
                    </a:lnTo>
                    <a:lnTo>
                      <a:pt x="1515" y="286"/>
                    </a:lnTo>
                    <a:lnTo>
                      <a:pt x="1500" y="286"/>
                    </a:lnTo>
                    <a:lnTo>
                      <a:pt x="1485" y="286"/>
                    </a:lnTo>
                    <a:lnTo>
                      <a:pt x="1469" y="286"/>
                    </a:lnTo>
                    <a:lnTo>
                      <a:pt x="1454" y="286"/>
                    </a:lnTo>
                    <a:lnTo>
                      <a:pt x="1439" y="286"/>
                    </a:lnTo>
                    <a:lnTo>
                      <a:pt x="1423" y="286"/>
                    </a:lnTo>
                    <a:lnTo>
                      <a:pt x="1408" y="286"/>
                    </a:lnTo>
                    <a:lnTo>
                      <a:pt x="1393" y="286"/>
                    </a:lnTo>
                    <a:lnTo>
                      <a:pt x="1377" y="286"/>
                    </a:lnTo>
                    <a:lnTo>
                      <a:pt x="1360" y="286"/>
                    </a:lnTo>
                    <a:lnTo>
                      <a:pt x="1345" y="286"/>
                    </a:lnTo>
                    <a:lnTo>
                      <a:pt x="1329" y="286"/>
                    </a:lnTo>
                    <a:lnTo>
                      <a:pt x="1314" y="286"/>
                    </a:lnTo>
                    <a:lnTo>
                      <a:pt x="1299" y="286"/>
                    </a:lnTo>
                    <a:lnTo>
                      <a:pt x="1283" y="286"/>
                    </a:lnTo>
                    <a:lnTo>
                      <a:pt x="1268" y="286"/>
                    </a:lnTo>
                    <a:lnTo>
                      <a:pt x="1252" y="286"/>
                    </a:lnTo>
                    <a:lnTo>
                      <a:pt x="1237" y="286"/>
                    </a:lnTo>
                    <a:lnTo>
                      <a:pt x="1222" y="286"/>
                    </a:lnTo>
                    <a:lnTo>
                      <a:pt x="1206" y="286"/>
                    </a:lnTo>
                    <a:lnTo>
                      <a:pt x="1191" y="286"/>
                    </a:lnTo>
                    <a:lnTo>
                      <a:pt x="1176" y="286"/>
                    </a:lnTo>
                    <a:lnTo>
                      <a:pt x="1160" y="286"/>
                    </a:lnTo>
                    <a:lnTo>
                      <a:pt x="1145" y="286"/>
                    </a:lnTo>
                    <a:lnTo>
                      <a:pt x="1130" y="286"/>
                    </a:lnTo>
                    <a:lnTo>
                      <a:pt x="1114" y="286"/>
                    </a:lnTo>
                    <a:lnTo>
                      <a:pt x="1099" y="286"/>
                    </a:lnTo>
                    <a:lnTo>
                      <a:pt x="1083" y="286"/>
                    </a:lnTo>
                    <a:lnTo>
                      <a:pt x="1068" y="286"/>
                    </a:lnTo>
                    <a:lnTo>
                      <a:pt x="1053" y="286"/>
                    </a:lnTo>
                    <a:lnTo>
                      <a:pt x="1035" y="286"/>
                    </a:lnTo>
                    <a:lnTo>
                      <a:pt x="1020" y="286"/>
                    </a:lnTo>
                    <a:lnTo>
                      <a:pt x="1005" y="286"/>
                    </a:lnTo>
                    <a:lnTo>
                      <a:pt x="989" y="286"/>
                    </a:lnTo>
                    <a:lnTo>
                      <a:pt x="974" y="286"/>
                    </a:lnTo>
                    <a:lnTo>
                      <a:pt x="959" y="286"/>
                    </a:lnTo>
                    <a:lnTo>
                      <a:pt x="943" y="286"/>
                    </a:lnTo>
                    <a:lnTo>
                      <a:pt x="928" y="286"/>
                    </a:lnTo>
                    <a:lnTo>
                      <a:pt x="913" y="286"/>
                    </a:lnTo>
                    <a:lnTo>
                      <a:pt x="897" y="286"/>
                    </a:lnTo>
                    <a:lnTo>
                      <a:pt x="882" y="286"/>
                    </a:lnTo>
                    <a:lnTo>
                      <a:pt x="866" y="286"/>
                    </a:lnTo>
                    <a:lnTo>
                      <a:pt x="851" y="286"/>
                    </a:lnTo>
                    <a:lnTo>
                      <a:pt x="836" y="286"/>
                    </a:lnTo>
                    <a:lnTo>
                      <a:pt x="820" y="286"/>
                    </a:lnTo>
                    <a:lnTo>
                      <a:pt x="805" y="286"/>
                    </a:lnTo>
                    <a:lnTo>
                      <a:pt x="790" y="286"/>
                    </a:lnTo>
                    <a:lnTo>
                      <a:pt x="774" y="286"/>
                    </a:lnTo>
                    <a:lnTo>
                      <a:pt x="759" y="286"/>
                    </a:lnTo>
                    <a:lnTo>
                      <a:pt x="744" y="286"/>
                    </a:lnTo>
                    <a:lnTo>
                      <a:pt x="728" y="286"/>
                    </a:lnTo>
                    <a:lnTo>
                      <a:pt x="711" y="286"/>
                    </a:lnTo>
                    <a:lnTo>
                      <a:pt x="696" y="286"/>
                    </a:lnTo>
                    <a:lnTo>
                      <a:pt x="680" y="286"/>
                    </a:lnTo>
                    <a:lnTo>
                      <a:pt x="665" y="286"/>
                    </a:lnTo>
                    <a:lnTo>
                      <a:pt x="649" y="286"/>
                    </a:lnTo>
                    <a:lnTo>
                      <a:pt x="634" y="286"/>
                    </a:lnTo>
                    <a:lnTo>
                      <a:pt x="619" y="286"/>
                    </a:lnTo>
                    <a:lnTo>
                      <a:pt x="603" y="286"/>
                    </a:lnTo>
                    <a:lnTo>
                      <a:pt x="588" y="286"/>
                    </a:lnTo>
                    <a:lnTo>
                      <a:pt x="573" y="286"/>
                    </a:lnTo>
                    <a:lnTo>
                      <a:pt x="557" y="286"/>
                    </a:lnTo>
                    <a:lnTo>
                      <a:pt x="542" y="286"/>
                    </a:lnTo>
                    <a:lnTo>
                      <a:pt x="527" y="286"/>
                    </a:lnTo>
                    <a:lnTo>
                      <a:pt x="511" y="286"/>
                    </a:lnTo>
                    <a:lnTo>
                      <a:pt x="496" y="286"/>
                    </a:lnTo>
                    <a:lnTo>
                      <a:pt x="481" y="286"/>
                    </a:lnTo>
                    <a:lnTo>
                      <a:pt x="465" y="286"/>
                    </a:lnTo>
                    <a:lnTo>
                      <a:pt x="450" y="286"/>
                    </a:lnTo>
                    <a:lnTo>
                      <a:pt x="434" y="286"/>
                    </a:lnTo>
                    <a:lnTo>
                      <a:pt x="419" y="286"/>
                    </a:lnTo>
                    <a:lnTo>
                      <a:pt x="404" y="286"/>
                    </a:lnTo>
                    <a:lnTo>
                      <a:pt x="386" y="286"/>
                    </a:lnTo>
                    <a:lnTo>
                      <a:pt x="371" y="286"/>
                    </a:lnTo>
                    <a:lnTo>
                      <a:pt x="356" y="286"/>
                    </a:lnTo>
                    <a:lnTo>
                      <a:pt x="340" y="286"/>
                    </a:lnTo>
                    <a:lnTo>
                      <a:pt x="325" y="286"/>
                    </a:lnTo>
                    <a:lnTo>
                      <a:pt x="310" y="286"/>
                    </a:lnTo>
                    <a:lnTo>
                      <a:pt x="294" y="286"/>
                    </a:lnTo>
                    <a:lnTo>
                      <a:pt x="279" y="286"/>
                    </a:lnTo>
                    <a:lnTo>
                      <a:pt x="264" y="286"/>
                    </a:lnTo>
                    <a:lnTo>
                      <a:pt x="248" y="286"/>
                    </a:lnTo>
                    <a:lnTo>
                      <a:pt x="233" y="286"/>
                    </a:lnTo>
                    <a:lnTo>
                      <a:pt x="217" y="286"/>
                    </a:lnTo>
                    <a:lnTo>
                      <a:pt x="202" y="286"/>
                    </a:lnTo>
                    <a:lnTo>
                      <a:pt x="187" y="286"/>
                    </a:lnTo>
                    <a:lnTo>
                      <a:pt x="171" y="286"/>
                    </a:lnTo>
                    <a:lnTo>
                      <a:pt x="156" y="286"/>
                    </a:lnTo>
                    <a:lnTo>
                      <a:pt x="141" y="286"/>
                    </a:lnTo>
                    <a:lnTo>
                      <a:pt x="125" y="286"/>
                    </a:lnTo>
                    <a:lnTo>
                      <a:pt x="110" y="286"/>
                    </a:lnTo>
                    <a:lnTo>
                      <a:pt x="95" y="286"/>
                    </a:lnTo>
                    <a:lnTo>
                      <a:pt x="79" y="286"/>
                    </a:lnTo>
                    <a:lnTo>
                      <a:pt x="62" y="286"/>
                    </a:lnTo>
                    <a:lnTo>
                      <a:pt x="47" y="286"/>
                    </a:lnTo>
                    <a:lnTo>
                      <a:pt x="31" y="286"/>
                    </a:lnTo>
                    <a:lnTo>
                      <a:pt x="16" y="286"/>
                    </a:lnTo>
                    <a:lnTo>
                      <a:pt x="0" y="286"/>
                    </a:lnTo>
                    <a:lnTo>
                      <a:pt x="0" y="236"/>
                    </a:ln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/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grpSp>
            <p:nvGrpSpPr>
              <p:cNvPr id="42" name="Groupe 41"/>
              <p:cNvGrpSpPr/>
              <p:nvPr/>
            </p:nvGrpSpPr>
            <p:grpSpPr>
              <a:xfrm>
                <a:off x="8001710" y="900693"/>
                <a:ext cx="818762" cy="5126276"/>
                <a:chOff x="7929702" y="1149408"/>
                <a:chExt cx="818762" cy="5126276"/>
              </a:xfrm>
            </p:grpSpPr>
            <p:grpSp>
              <p:nvGrpSpPr>
                <p:cNvPr id="43" name="Groupe 42"/>
                <p:cNvGrpSpPr/>
                <p:nvPr/>
              </p:nvGrpSpPr>
              <p:grpSpPr>
                <a:xfrm>
                  <a:off x="7929702" y="1323443"/>
                  <a:ext cx="120736" cy="4780634"/>
                  <a:chOff x="8820472" y="313469"/>
                  <a:chExt cx="144016" cy="5702400"/>
                </a:xfrm>
              </p:grpSpPr>
              <p:cxnSp>
                <p:nvCxnSpPr>
                  <p:cNvPr id="49" name="Connecteur droit 48"/>
                  <p:cNvCxnSpPr/>
                  <p:nvPr/>
                </p:nvCxnSpPr>
                <p:spPr>
                  <a:xfrm>
                    <a:off x="8820472" y="313469"/>
                    <a:ext cx="0" cy="57024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0" name="Connecteur droit 49"/>
                  <p:cNvCxnSpPr/>
                  <p:nvPr/>
                </p:nvCxnSpPr>
                <p:spPr>
                  <a:xfrm>
                    <a:off x="8820472" y="319139"/>
                    <a:ext cx="144016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Connecteur droit 50"/>
                  <p:cNvCxnSpPr/>
                  <p:nvPr/>
                </p:nvCxnSpPr>
                <p:spPr>
                  <a:xfrm>
                    <a:off x="8820472" y="1738906"/>
                    <a:ext cx="144016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" name="Connecteur droit 51"/>
                  <p:cNvCxnSpPr/>
                  <p:nvPr/>
                </p:nvCxnSpPr>
                <p:spPr>
                  <a:xfrm>
                    <a:off x="8820472" y="3164778"/>
                    <a:ext cx="144016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" name="Connecteur droit 52"/>
                  <p:cNvCxnSpPr/>
                  <p:nvPr/>
                </p:nvCxnSpPr>
                <p:spPr>
                  <a:xfrm>
                    <a:off x="8820472" y="4590652"/>
                    <a:ext cx="144016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Connecteur droit 53"/>
                  <p:cNvCxnSpPr/>
                  <p:nvPr/>
                </p:nvCxnSpPr>
                <p:spPr>
                  <a:xfrm>
                    <a:off x="8820472" y="6011764"/>
                    <a:ext cx="144016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4" name="ZoneTexte 410"/>
                <p:cNvSpPr txBox="1"/>
                <p:nvPr/>
              </p:nvSpPr>
              <p:spPr>
                <a:xfrm>
                  <a:off x="7967921" y="1149408"/>
                  <a:ext cx="670353" cy="3595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fr-FR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fr-FR" sz="1200" b="1" dirty="0" smtClean="0"/>
                    <a:t>0 Mb</a:t>
                  </a:r>
                  <a:endParaRPr lang="fr-FR" sz="1200" b="1" dirty="0"/>
                </a:p>
              </p:txBody>
            </p:sp>
            <p:sp>
              <p:nvSpPr>
                <p:cNvPr id="45" name="ZoneTexte 470"/>
                <p:cNvSpPr txBox="1"/>
                <p:nvPr/>
              </p:nvSpPr>
              <p:spPr>
                <a:xfrm>
                  <a:off x="7976164" y="2329711"/>
                  <a:ext cx="772300" cy="3595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fr-FR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fr-FR" sz="1200" b="1" dirty="0" smtClean="0"/>
                    <a:t>10 Mb</a:t>
                  </a:r>
                  <a:endParaRPr lang="fr-FR" sz="1200" b="1" dirty="0"/>
                </a:p>
              </p:txBody>
            </p:sp>
            <p:sp>
              <p:nvSpPr>
                <p:cNvPr id="46" name="ZoneTexte 471"/>
                <p:cNvSpPr txBox="1"/>
                <p:nvPr/>
              </p:nvSpPr>
              <p:spPr>
                <a:xfrm>
                  <a:off x="7976164" y="3520590"/>
                  <a:ext cx="772300" cy="3595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fr-FR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fr-FR" sz="1200" b="1" dirty="0" smtClean="0"/>
                    <a:t>20 Mb</a:t>
                  </a:r>
                  <a:endParaRPr lang="fr-FR" sz="1200" b="1" dirty="0"/>
                </a:p>
              </p:txBody>
            </p:sp>
            <p:sp>
              <p:nvSpPr>
                <p:cNvPr id="47" name="ZoneTexte 472"/>
                <p:cNvSpPr txBox="1"/>
                <p:nvPr/>
              </p:nvSpPr>
              <p:spPr>
                <a:xfrm>
                  <a:off x="7976164" y="4726949"/>
                  <a:ext cx="772300" cy="3595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fr-FR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fr-FR" sz="1200" b="1" dirty="0" smtClean="0"/>
                    <a:t>30 Mb</a:t>
                  </a:r>
                  <a:endParaRPr lang="fr-FR" sz="1200" b="1" dirty="0"/>
                </a:p>
              </p:txBody>
            </p:sp>
            <p:sp>
              <p:nvSpPr>
                <p:cNvPr id="48" name="ZoneTexte 473"/>
                <p:cNvSpPr txBox="1"/>
                <p:nvPr/>
              </p:nvSpPr>
              <p:spPr>
                <a:xfrm>
                  <a:off x="7976164" y="5916165"/>
                  <a:ext cx="772300" cy="3595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fr-FR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fr-FR" sz="1200" b="1" dirty="0" smtClean="0"/>
                    <a:t>40 Mb</a:t>
                  </a:r>
                  <a:endParaRPr lang="fr-FR" sz="1200" b="1" dirty="0"/>
                </a:p>
              </p:txBody>
            </p:sp>
          </p:grpSp>
        </p:grpSp>
        <p:pic>
          <p:nvPicPr>
            <p:cNvPr id="422" name="Image 42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-1736480" y="519839"/>
              <a:ext cx="3478433" cy="180000"/>
            </a:xfrm>
            <a:prstGeom prst="rect">
              <a:avLst/>
            </a:prstGeom>
          </p:spPr>
        </p:pic>
        <p:pic>
          <p:nvPicPr>
            <p:cNvPr id="423" name="Image 42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-1084960" y="546440"/>
              <a:ext cx="3502708" cy="180000"/>
            </a:xfrm>
            <a:prstGeom prst="rect">
              <a:avLst/>
            </a:prstGeom>
          </p:spPr>
        </p:pic>
        <p:pic>
          <p:nvPicPr>
            <p:cNvPr id="424" name="Image 42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-763870" y="878582"/>
              <a:ext cx="4183071" cy="180000"/>
            </a:xfrm>
            <a:prstGeom prst="rect">
              <a:avLst/>
            </a:prstGeom>
          </p:spPr>
        </p:pic>
        <p:pic>
          <p:nvPicPr>
            <p:cNvPr id="425" name="Image 42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-212458" y="1007793"/>
              <a:ext cx="4418704" cy="180000"/>
            </a:xfrm>
            <a:prstGeom prst="rect">
              <a:avLst/>
            </a:prstGeom>
          </p:spPr>
        </p:pic>
        <p:pic>
          <p:nvPicPr>
            <p:cNvPr id="426" name="Image 42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57431" y="1284849"/>
              <a:ext cx="5001472" cy="180000"/>
            </a:xfrm>
            <a:prstGeom prst="rect">
              <a:avLst/>
            </a:prstGeom>
          </p:spPr>
        </p:pic>
        <p:pic>
          <p:nvPicPr>
            <p:cNvPr id="427" name="Image 42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080120" y="1028857"/>
              <a:ext cx="4479373" cy="180000"/>
            </a:xfrm>
            <a:prstGeom prst="rect">
              <a:avLst/>
            </a:prstGeom>
          </p:spPr>
        </p:pic>
        <p:pic>
          <p:nvPicPr>
            <p:cNvPr id="428" name="Image 42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888883" y="877557"/>
              <a:ext cx="4185126" cy="180000"/>
            </a:xfrm>
            <a:prstGeom prst="rect">
              <a:avLst/>
            </a:prstGeom>
          </p:spPr>
        </p:pic>
        <p:pic>
          <p:nvPicPr>
            <p:cNvPr id="429" name="Image 42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961598" y="1463070"/>
              <a:ext cx="5370279" cy="180000"/>
            </a:xfrm>
            <a:prstGeom prst="rect">
              <a:avLst/>
            </a:prstGeom>
          </p:spPr>
        </p:pic>
        <p:pic>
          <p:nvPicPr>
            <p:cNvPr id="430" name="Image 42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885533" y="1256137"/>
              <a:ext cx="4926954" cy="180000"/>
            </a:xfrm>
            <a:prstGeom prst="rect">
              <a:avLst/>
            </a:prstGeom>
          </p:spPr>
        </p:pic>
        <p:pic>
          <p:nvPicPr>
            <p:cNvPr id="431" name="Image 430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757274" y="1033989"/>
              <a:ext cx="4501539" cy="180000"/>
            </a:xfrm>
            <a:prstGeom prst="rect">
              <a:avLst/>
            </a:prstGeom>
          </p:spPr>
        </p:pic>
        <p:pic>
          <p:nvPicPr>
            <p:cNvPr id="432" name="Image 431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5001387" y="456607"/>
              <a:ext cx="3339912" cy="180000"/>
            </a:xfrm>
            <a:prstGeom prst="rect">
              <a:avLst/>
            </a:prstGeom>
          </p:spPr>
        </p:pic>
      </p:grpSp>
      <p:grpSp>
        <p:nvGrpSpPr>
          <p:cNvPr id="438" name="Groupe 437"/>
          <p:cNvGrpSpPr>
            <a:grpSpLocks noChangeAspect="1"/>
          </p:cNvGrpSpPr>
          <p:nvPr/>
        </p:nvGrpSpPr>
        <p:grpSpPr>
          <a:xfrm>
            <a:off x="52703" y="297912"/>
            <a:ext cx="6103826" cy="3024000"/>
            <a:chOff x="7589" y="3711668"/>
            <a:chExt cx="8311453" cy="4117967"/>
          </a:xfrm>
        </p:grpSpPr>
        <p:pic>
          <p:nvPicPr>
            <p:cNvPr id="436" name="Image 435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89" y="3711668"/>
              <a:ext cx="4117975" cy="4117967"/>
            </a:xfrm>
            <a:prstGeom prst="rect">
              <a:avLst/>
            </a:prstGeom>
          </p:spPr>
        </p:pic>
        <p:pic>
          <p:nvPicPr>
            <p:cNvPr id="437" name="Image 436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01067" y="3711668"/>
              <a:ext cx="4117975" cy="4117967"/>
            </a:xfrm>
            <a:prstGeom prst="rect">
              <a:avLst/>
            </a:prstGeom>
          </p:spPr>
        </p:pic>
      </p:grpSp>
      <p:sp>
        <p:nvSpPr>
          <p:cNvPr id="439" name="ZoneTexte 438"/>
          <p:cNvSpPr txBox="1"/>
          <p:nvPr/>
        </p:nvSpPr>
        <p:spPr>
          <a:xfrm>
            <a:off x="3034641" y="-26345"/>
            <a:ext cx="314509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b="1" dirty="0" smtClean="0"/>
              <a:t>B</a:t>
            </a:r>
            <a:endParaRPr lang="fr-FR" sz="1200" b="1" dirty="0"/>
          </a:p>
        </p:txBody>
      </p:sp>
      <p:sp>
        <p:nvSpPr>
          <p:cNvPr id="440" name="ZoneTexte 439"/>
          <p:cNvSpPr txBox="1"/>
          <p:nvPr/>
        </p:nvSpPr>
        <p:spPr>
          <a:xfrm>
            <a:off x="-18627" y="3327785"/>
            <a:ext cx="30649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b="1" dirty="0" smtClean="0"/>
              <a:t>C</a:t>
            </a:r>
            <a:endParaRPr lang="fr-FR" sz="1200" b="1" dirty="0"/>
          </a:p>
        </p:txBody>
      </p:sp>
      <p:sp>
        <p:nvSpPr>
          <p:cNvPr id="441" name="ZoneTexte 440"/>
          <p:cNvSpPr txBox="1"/>
          <p:nvPr/>
        </p:nvSpPr>
        <p:spPr>
          <a:xfrm>
            <a:off x="-32978" y="-9277"/>
            <a:ext cx="335196" cy="33519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b="1" dirty="0" smtClean="0"/>
              <a:t>A</a:t>
            </a:r>
            <a:endParaRPr lang="fr-FR" sz="1200" b="1" dirty="0"/>
          </a:p>
        </p:txBody>
      </p:sp>
      <p:sp>
        <p:nvSpPr>
          <p:cNvPr id="442" name="ZoneTexte 441"/>
          <p:cNvSpPr txBox="1"/>
          <p:nvPr/>
        </p:nvSpPr>
        <p:spPr>
          <a:xfrm>
            <a:off x="-50675" y="7946312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</a:t>
            </a:r>
            <a:r>
              <a:rPr lang="fr-FR" dirty="0"/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4231288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ésentation1" id="{73C8887B-0EB9-4F85-94F0-A6912946C4AE}" vid="{33BCC8B2-B507-434A-99DC-0B1A1E141DE8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figure_AnnalsOfBotany</Template>
  <TotalTime>236</TotalTime>
  <Words>33</Words>
  <Application>Microsoft Office PowerPoint</Application>
  <PresentationFormat>Personnalisé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upouy</dc:creator>
  <cp:lastModifiedBy>dupouy</cp:lastModifiedBy>
  <cp:revision>10</cp:revision>
  <dcterms:created xsi:type="dcterms:W3CDTF">2018-11-30T08:46:36Z</dcterms:created>
  <dcterms:modified xsi:type="dcterms:W3CDTF">2019-02-08T08:59:04Z</dcterms:modified>
</cp:coreProperties>
</file>